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notesMasterIdLst>
    <p:notesMasterId r:id="rId8"/>
  </p:notesMasterIdLst>
  <p:sldIdLst>
    <p:sldId id="269" r:id="rId5"/>
    <p:sldId id="388" r:id="rId6"/>
    <p:sldId id="389" r:id="rId7"/>
  </p:sldIdLst>
  <p:sldSz cx="12192000" cy="6858000"/>
  <p:notesSz cx="6950075" cy="923607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Warner,Jeffrey Barr" initials="WB" lastIdx="5" clrIdx="0">
    <p:extLst>
      <p:ext uri="{19B8F6BF-5375-455C-9EA6-DF929625EA0E}">
        <p15:presenceInfo xmlns:p15="http://schemas.microsoft.com/office/powerpoint/2012/main" userId="Warner,Jeffrey Barr" providerId="None"/>
      </p:ext>
    </p:extLst>
  </p:cmAuthor>
  <p:cmAuthor id="2" name="Warner,Jeffrey Barr" initials="WB [2]" lastIdx="10" clrIdx="1">
    <p:extLst>
      <p:ext uri="{19B8F6BF-5375-455C-9EA6-DF929625EA0E}">
        <p15:presenceInfo xmlns:p15="http://schemas.microsoft.com/office/powerpoint/2012/main" userId="S::jbwarn01@louisville.edu::7360d018-3b8a-4d6d-8136-e4d170e1e616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6603"/>
    <a:srgbClr val="991100"/>
    <a:srgbClr val="001999"/>
    <a:srgbClr val="993299"/>
    <a:srgbClr val="119966"/>
    <a:srgbClr val="D45A00"/>
    <a:srgbClr val="11FCCD"/>
    <a:srgbClr val="CC79A7"/>
    <a:srgbClr val="0972B2"/>
    <a:srgbClr val="F0E44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D4807F30-5863-4A06-8EED-66FA02898782}" v="3" dt="2021-12-16T23:03:18.955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472" autoAdjust="0"/>
    <p:restoredTop sz="94242" autoAdjust="0"/>
  </p:normalViewPr>
  <p:slideViewPr>
    <p:cSldViewPr snapToGrid="0">
      <p:cViewPr varScale="1">
        <p:scale>
          <a:sx n="161" d="100"/>
          <a:sy n="161" d="100"/>
        </p:scale>
        <p:origin x="492" y="15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13" Type="http://schemas.openxmlformats.org/officeDocument/2006/relationships/tableStyles" Target="tableStyles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theme" Target="theme/theme1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viewProps" Target="viewProps.xml"/><Relationship Id="rId5" Type="http://schemas.openxmlformats.org/officeDocument/2006/relationships/slide" Target="slides/slide1.xml"/><Relationship Id="rId15" Type="http://schemas.microsoft.com/office/2015/10/relationships/revisionInfo" Target="revisionInfo.xml"/><Relationship Id="rId10" Type="http://schemas.openxmlformats.org/officeDocument/2006/relationships/presProps" Target="presProps.xml"/><Relationship Id="rId4" Type="http://schemas.openxmlformats.org/officeDocument/2006/relationships/slideMaster" Target="slideMasters/slideMaster1.xml"/><Relationship Id="rId9" Type="http://schemas.openxmlformats.org/officeDocument/2006/relationships/commentAuthors" Target="commentAuthors.xml"/><Relationship Id="rId14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Warner,Jeffrey Barr" userId="7360d018-3b8a-4d6d-8136-e4d170e1e616" providerId="ADAL" clId="{E1317903-0E43-4FAC-A900-4D6121109CB5}"/>
    <pc:docChg chg="undo redo custSel addSld delSld modSld">
      <pc:chgData name="Warner,Jeffrey Barr" userId="7360d018-3b8a-4d6d-8136-e4d170e1e616" providerId="ADAL" clId="{E1317903-0E43-4FAC-A900-4D6121109CB5}" dt="2021-05-20T17:02:12.570" v="8169" actId="20577"/>
      <pc:docMkLst>
        <pc:docMk/>
      </pc:docMkLst>
      <pc:sldChg chg="addSp delSp modSp mod addCm delCm modCm">
        <pc:chgData name="Warner,Jeffrey Barr" userId="7360d018-3b8a-4d6d-8136-e4d170e1e616" providerId="ADAL" clId="{E1317903-0E43-4FAC-A900-4D6121109CB5}" dt="2021-05-20T17:01:46.778" v="8128" actId="20577"/>
        <pc:sldMkLst>
          <pc:docMk/>
          <pc:sldMk cId="3815654910" sldId="259"/>
        </pc:sldMkLst>
        <pc:spChg chg="mod">
          <ac:chgData name="Warner,Jeffrey Barr" userId="7360d018-3b8a-4d6d-8136-e4d170e1e616" providerId="ADAL" clId="{E1317903-0E43-4FAC-A900-4D6121109CB5}" dt="2021-05-19T17:08:47.538" v="7934" actId="20577"/>
          <ac:spMkLst>
            <pc:docMk/>
            <pc:sldMk cId="3815654910" sldId="259"/>
            <ac:spMk id="14" creationId="{C22E5819-A4F3-9F42-BEF3-FB33CAA48410}"/>
          </ac:spMkLst>
        </pc:spChg>
        <pc:spChg chg="mod">
          <ac:chgData name="Warner,Jeffrey Barr" userId="7360d018-3b8a-4d6d-8136-e4d170e1e616" providerId="ADAL" clId="{E1317903-0E43-4FAC-A900-4D6121109CB5}" dt="2021-04-22T20:28:43.552" v="1978" actId="1035"/>
          <ac:spMkLst>
            <pc:docMk/>
            <pc:sldMk cId="3815654910" sldId="259"/>
            <ac:spMk id="15" creationId="{ED350E54-6677-7849-BEAE-23AB35701C14}"/>
          </ac:spMkLst>
        </pc:spChg>
        <pc:spChg chg="mod">
          <ac:chgData name="Warner,Jeffrey Barr" userId="7360d018-3b8a-4d6d-8136-e4d170e1e616" providerId="ADAL" clId="{E1317903-0E43-4FAC-A900-4D6121109CB5}" dt="2021-04-22T20:28:43.552" v="1978" actId="1035"/>
          <ac:spMkLst>
            <pc:docMk/>
            <pc:sldMk cId="3815654910" sldId="259"/>
            <ac:spMk id="16" creationId="{7A89FB48-89A8-A143-9C4A-2A8E7C67BC35}"/>
          </ac:spMkLst>
        </pc:spChg>
        <pc:spChg chg="mod">
          <ac:chgData name="Warner,Jeffrey Barr" userId="7360d018-3b8a-4d6d-8136-e4d170e1e616" providerId="ADAL" clId="{E1317903-0E43-4FAC-A900-4D6121109CB5}" dt="2021-04-22T20:28:43.552" v="1978" actId="1035"/>
          <ac:spMkLst>
            <pc:docMk/>
            <pc:sldMk cId="3815654910" sldId="259"/>
            <ac:spMk id="17" creationId="{31B3A69F-4C3F-414C-A7FD-B900FDFA6233}"/>
          </ac:spMkLst>
        </pc:spChg>
        <pc:spChg chg="mod">
          <ac:chgData name="Warner,Jeffrey Barr" userId="7360d018-3b8a-4d6d-8136-e4d170e1e616" providerId="ADAL" clId="{E1317903-0E43-4FAC-A900-4D6121109CB5}" dt="2021-05-03T19:23:09.122" v="3183" actId="12788"/>
          <ac:spMkLst>
            <pc:docMk/>
            <pc:sldMk cId="3815654910" sldId="259"/>
            <ac:spMk id="18" creationId="{5879D3F2-0BFB-1A4C-85AF-252A1AF2ACB6}"/>
          </ac:spMkLst>
        </pc:spChg>
        <pc:spChg chg="mod">
          <ac:chgData name="Warner,Jeffrey Barr" userId="7360d018-3b8a-4d6d-8136-e4d170e1e616" providerId="ADAL" clId="{E1317903-0E43-4FAC-A900-4D6121109CB5}" dt="2021-05-12T18:49:57.416" v="5970" actId="165"/>
          <ac:spMkLst>
            <pc:docMk/>
            <pc:sldMk cId="3815654910" sldId="259"/>
            <ac:spMk id="33" creationId="{2E70191B-24CA-E14D-8A99-2F0F92292247}"/>
          </ac:spMkLst>
        </pc:spChg>
        <pc:spChg chg="mod">
          <ac:chgData name="Warner,Jeffrey Barr" userId="7360d018-3b8a-4d6d-8136-e4d170e1e616" providerId="ADAL" clId="{E1317903-0E43-4FAC-A900-4D6121109CB5}" dt="2021-05-19T17:08:54.763" v="7946" actId="20577"/>
          <ac:spMkLst>
            <pc:docMk/>
            <pc:sldMk cId="3815654910" sldId="259"/>
            <ac:spMk id="34" creationId="{D6AB7928-B93E-B641-B782-69D67DE55D7C}"/>
          </ac:spMkLst>
        </pc:spChg>
        <pc:spChg chg="mod topLvl">
          <ac:chgData name="Warner,Jeffrey Barr" userId="7360d018-3b8a-4d6d-8136-e4d170e1e616" providerId="ADAL" clId="{E1317903-0E43-4FAC-A900-4D6121109CB5}" dt="2021-05-12T18:49:57.416" v="5970" actId="165"/>
          <ac:spMkLst>
            <pc:docMk/>
            <pc:sldMk cId="3815654910" sldId="259"/>
            <ac:spMk id="37" creationId="{FD5EBD31-A174-634E-B256-18AFD873E5CA}"/>
          </ac:spMkLst>
        </pc:spChg>
        <pc:spChg chg="mod">
          <ac:chgData name="Warner,Jeffrey Barr" userId="7360d018-3b8a-4d6d-8136-e4d170e1e616" providerId="ADAL" clId="{E1317903-0E43-4FAC-A900-4D6121109CB5}" dt="2021-04-22T20:28:49.247" v="2000" actId="1036"/>
          <ac:spMkLst>
            <pc:docMk/>
            <pc:sldMk cId="3815654910" sldId="259"/>
            <ac:spMk id="38" creationId="{7BA4FAF3-CD45-4362-82B1-E2E97E9FADD1}"/>
          </ac:spMkLst>
        </pc:spChg>
        <pc:spChg chg="mod">
          <ac:chgData name="Warner,Jeffrey Barr" userId="7360d018-3b8a-4d6d-8136-e4d170e1e616" providerId="ADAL" clId="{E1317903-0E43-4FAC-A900-4D6121109CB5}" dt="2021-04-22T20:28:54.304" v="2014" actId="1036"/>
          <ac:spMkLst>
            <pc:docMk/>
            <pc:sldMk cId="3815654910" sldId="259"/>
            <ac:spMk id="41" creationId="{8D431A23-8B43-4024-AA6A-2449506A1EC0}"/>
          </ac:spMkLst>
        </pc:spChg>
        <pc:spChg chg="add mod">
          <ac:chgData name="Warner,Jeffrey Barr" userId="7360d018-3b8a-4d6d-8136-e4d170e1e616" providerId="ADAL" clId="{E1317903-0E43-4FAC-A900-4D6121109CB5}" dt="2021-05-12T18:53:43.420" v="6278" actId="164"/>
          <ac:spMkLst>
            <pc:docMk/>
            <pc:sldMk cId="3815654910" sldId="259"/>
            <ac:spMk id="42" creationId="{42FF527E-707F-49F6-A78A-060657D51230}"/>
          </ac:spMkLst>
        </pc:spChg>
        <pc:spChg chg="mod topLvl">
          <ac:chgData name="Warner,Jeffrey Barr" userId="7360d018-3b8a-4d6d-8136-e4d170e1e616" providerId="ADAL" clId="{E1317903-0E43-4FAC-A900-4D6121109CB5}" dt="2021-05-12T18:49:59.419" v="5971" actId="165"/>
          <ac:spMkLst>
            <pc:docMk/>
            <pc:sldMk cId="3815654910" sldId="259"/>
            <ac:spMk id="48" creationId="{74EA99B9-3233-C840-8634-E6E5DF5A0759}"/>
          </ac:spMkLst>
        </pc:spChg>
        <pc:spChg chg="mod">
          <ac:chgData name="Warner,Jeffrey Barr" userId="7360d018-3b8a-4d6d-8136-e4d170e1e616" providerId="ADAL" clId="{E1317903-0E43-4FAC-A900-4D6121109CB5}" dt="2021-05-12T18:49:59.419" v="5971" actId="165"/>
          <ac:spMkLst>
            <pc:docMk/>
            <pc:sldMk cId="3815654910" sldId="259"/>
            <ac:spMk id="53" creationId="{20A9299F-0979-D24D-938E-D9C6CA0A2D67}"/>
          </ac:spMkLst>
        </pc:spChg>
        <pc:spChg chg="mod">
          <ac:chgData name="Warner,Jeffrey Barr" userId="7360d018-3b8a-4d6d-8136-e4d170e1e616" providerId="ADAL" clId="{E1317903-0E43-4FAC-A900-4D6121109CB5}" dt="2021-05-19T17:08:59.586" v="7952" actId="20577"/>
          <ac:spMkLst>
            <pc:docMk/>
            <pc:sldMk cId="3815654910" sldId="259"/>
            <ac:spMk id="54" creationId="{9BE8C3BC-D3C5-FC41-A674-052183AD20F8}"/>
          </ac:spMkLst>
        </pc:spChg>
        <pc:spChg chg="del mod">
          <ac:chgData name="Warner,Jeffrey Barr" userId="7360d018-3b8a-4d6d-8136-e4d170e1e616" providerId="ADAL" clId="{E1317903-0E43-4FAC-A900-4D6121109CB5}" dt="2021-05-20T16:57:05.328" v="8025" actId="478"/>
          <ac:spMkLst>
            <pc:docMk/>
            <pc:sldMk cId="3815654910" sldId="259"/>
            <ac:spMk id="61" creationId="{82ADA693-A8D9-8246-97DD-D744CAC4ADB8}"/>
          </ac:spMkLst>
        </pc:spChg>
        <pc:spChg chg="mod">
          <ac:chgData name="Warner,Jeffrey Barr" userId="7360d018-3b8a-4d6d-8136-e4d170e1e616" providerId="ADAL" clId="{E1317903-0E43-4FAC-A900-4D6121109CB5}" dt="2021-04-22T20:28:52.222" v="2012" actId="1036"/>
          <ac:spMkLst>
            <pc:docMk/>
            <pc:sldMk cId="3815654910" sldId="259"/>
            <ac:spMk id="62" creationId="{B6417B22-27DE-274C-92BD-FB621E5951DC}"/>
          </ac:spMkLst>
        </pc:spChg>
        <pc:spChg chg="add mod">
          <ac:chgData name="Warner,Jeffrey Barr" userId="7360d018-3b8a-4d6d-8136-e4d170e1e616" providerId="ADAL" clId="{E1317903-0E43-4FAC-A900-4D6121109CB5}" dt="2021-05-12T18:53:43.420" v="6278" actId="164"/>
          <ac:spMkLst>
            <pc:docMk/>
            <pc:sldMk cId="3815654910" sldId="259"/>
            <ac:spMk id="64" creationId="{158FF225-6142-4F63-85D8-3BF401F0CF99}"/>
          </ac:spMkLst>
        </pc:spChg>
        <pc:spChg chg="add mod">
          <ac:chgData name="Warner,Jeffrey Barr" userId="7360d018-3b8a-4d6d-8136-e4d170e1e616" providerId="ADAL" clId="{E1317903-0E43-4FAC-A900-4D6121109CB5}" dt="2021-05-12T18:53:45.795" v="6279" actId="164"/>
          <ac:spMkLst>
            <pc:docMk/>
            <pc:sldMk cId="3815654910" sldId="259"/>
            <ac:spMk id="65" creationId="{659F19F9-4B25-412A-AB80-54FF7451D883}"/>
          </ac:spMkLst>
        </pc:spChg>
        <pc:spChg chg="add mod">
          <ac:chgData name="Warner,Jeffrey Barr" userId="7360d018-3b8a-4d6d-8136-e4d170e1e616" providerId="ADAL" clId="{E1317903-0E43-4FAC-A900-4D6121109CB5}" dt="2021-05-12T18:53:45.795" v="6279" actId="164"/>
          <ac:spMkLst>
            <pc:docMk/>
            <pc:sldMk cId="3815654910" sldId="259"/>
            <ac:spMk id="66" creationId="{59E48F58-17E3-4EEF-8614-B0DF1990F5E1}"/>
          </ac:spMkLst>
        </pc:spChg>
        <pc:spChg chg="add mod">
          <ac:chgData name="Warner,Jeffrey Barr" userId="7360d018-3b8a-4d6d-8136-e4d170e1e616" providerId="ADAL" clId="{E1317903-0E43-4FAC-A900-4D6121109CB5}" dt="2021-05-12T18:53:47.582" v="6280" actId="164"/>
          <ac:spMkLst>
            <pc:docMk/>
            <pc:sldMk cId="3815654910" sldId="259"/>
            <ac:spMk id="67" creationId="{AFCF7758-9647-4352-8A4F-BD95E95F2336}"/>
          </ac:spMkLst>
        </pc:spChg>
        <pc:spChg chg="add mod">
          <ac:chgData name="Warner,Jeffrey Barr" userId="7360d018-3b8a-4d6d-8136-e4d170e1e616" providerId="ADAL" clId="{E1317903-0E43-4FAC-A900-4D6121109CB5}" dt="2021-05-12T18:53:47.582" v="6280" actId="164"/>
          <ac:spMkLst>
            <pc:docMk/>
            <pc:sldMk cId="3815654910" sldId="259"/>
            <ac:spMk id="68" creationId="{3ADA8937-CFE2-4F70-BC2A-B0D83F5782FE}"/>
          </ac:spMkLst>
        </pc:spChg>
        <pc:spChg chg="add mod">
          <ac:chgData name="Warner,Jeffrey Barr" userId="7360d018-3b8a-4d6d-8136-e4d170e1e616" providerId="ADAL" clId="{E1317903-0E43-4FAC-A900-4D6121109CB5}" dt="2021-05-12T18:53:47.582" v="6280" actId="164"/>
          <ac:spMkLst>
            <pc:docMk/>
            <pc:sldMk cId="3815654910" sldId="259"/>
            <ac:spMk id="69" creationId="{F2B6AAF0-C01F-45B3-B74B-03E04C1C7861}"/>
          </ac:spMkLst>
        </pc:spChg>
        <pc:spChg chg="add mod">
          <ac:chgData name="Warner,Jeffrey Barr" userId="7360d018-3b8a-4d6d-8136-e4d170e1e616" providerId="ADAL" clId="{E1317903-0E43-4FAC-A900-4D6121109CB5}" dt="2021-05-12T18:53:45.795" v="6279" actId="164"/>
          <ac:spMkLst>
            <pc:docMk/>
            <pc:sldMk cId="3815654910" sldId="259"/>
            <ac:spMk id="70" creationId="{333D3469-C641-43A8-B250-97D7DDD0835F}"/>
          </ac:spMkLst>
        </pc:spChg>
        <pc:spChg chg="add mod">
          <ac:chgData name="Warner,Jeffrey Barr" userId="7360d018-3b8a-4d6d-8136-e4d170e1e616" providerId="ADAL" clId="{E1317903-0E43-4FAC-A900-4D6121109CB5}" dt="2021-05-12T18:53:43.420" v="6278" actId="164"/>
          <ac:spMkLst>
            <pc:docMk/>
            <pc:sldMk cId="3815654910" sldId="259"/>
            <ac:spMk id="71" creationId="{241F8C69-FECC-4F3F-9572-A8C70E354D1E}"/>
          </ac:spMkLst>
        </pc:spChg>
        <pc:spChg chg="add mod">
          <ac:chgData name="Warner,Jeffrey Barr" userId="7360d018-3b8a-4d6d-8136-e4d170e1e616" providerId="ADAL" clId="{E1317903-0E43-4FAC-A900-4D6121109CB5}" dt="2021-05-12T18:53:43.420" v="6278" actId="164"/>
          <ac:spMkLst>
            <pc:docMk/>
            <pc:sldMk cId="3815654910" sldId="259"/>
            <ac:spMk id="72" creationId="{DAD1FF92-84EE-441B-B736-01298B91086E}"/>
          </ac:spMkLst>
        </pc:spChg>
        <pc:spChg chg="add mod">
          <ac:chgData name="Warner,Jeffrey Barr" userId="7360d018-3b8a-4d6d-8136-e4d170e1e616" providerId="ADAL" clId="{E1317903-0E43-4FAC-A900-4D6121109CB5}" dt="2021-05-12T18:53:45.795" v="6279" actId="164"/>
          <ac:spMkLst>
            <pc:docMk/>
            <pc:sldMk cId="3815654910" sldId="259"/>
            <ac:spMk id="73" creationId="{A0E77195-2D45-4FE9-A333-FE0CAF30C4AB}"/>
          </ac:spMkLst>
        </pc:spChg>
        <pc:spChg chg="add mod">
          <ac:chgData name="Warner,Jeffrey Barr" userId="7360d018-3b8a-4d6d-8136-e4d170e1e616" providerId="ADAL" clId="{E1317903-0E43-4FAC-A900-4D6121109CB5}" dt="2021-05-12T18:53:47.582" v="6280" actId="164"/>
          <ac:spMkLst>
            <pc:docMk/>
            <pc:sldMk cId="3815654910" sldId="259"/>
            <ac:spMk id="74" creationId="{B9FA4C0F-61A9-4CDB-AEF2-BC87BBFB42CB}"/>
          </ac:spMkLst>
        </pc:spChg>
        <pc:spChg chg="add mod">
          <ac:chgData name="Warner,Jeffrey Barr" userId="7360d018-3b8a-4d6d-8136-e4d170e1e616" providerId="ADAL" clId="{E1317903-0E43-4FAC-A900-4D6121109CB5}" dt="2021-05-20T17:01:46.778" v="8128" actId="20577"/>
          <ac:spMkLst>
            <pc:docMk/>
            <pc:sldMk cId="3815654910" sldId="259"/>
            <ac:spMk id="75" creationId="{10A180C6-EDEB-44FB-832C-B6AE8CE84668}"/>
          </ac:spMkLst>
        </pc:spChg>
        <pc:spChg chg="add mod">
          <ac:chgData name="Warner,Jeffrey Barr" userId="7360d018-3b8a-4d6d-8136-e4d170e1e616" providerId="ADAL" clId="{E1317903-0E43-4FAC-A900-4D6121109CB5}" dt="2021-05-12T18:55:04.702" v="6311" actId="164"/>
          <ac:spMkLst>
            <pc:docMk/>
            <pc:sldMk cId="3815654910" sldId="259"/>
            <ac:spMk id="75" creationId="{219816A3-74C6-4F19-A9DF-46669F68A227}"/>
          </ac:spMkLst>
        </pc:spChg>
        <pc:spChg chg="add mod">
          <ac:chgData name="Warner,Jeffrey Barr" userId="7360d018-3b8a-4d6d-8136-e4d170e1e616" providerId="ADAL" clId="{E1317903-0E43-4FAC-A900-4D6121109CB5}" dt="2021-05-12T19:07:21.185" v="6555" actId="1076"/>
          <ac:spMkLst>
            <pc:docMk/>
            <pc:sldMk cId="3815654910" sldId="259"/>
            <ac:spMk id="76" creationId="{E4001425-A57B-4AF0-9310-8484DC667ABA}"/>
          </ac:spMkLst>
        </pc:spChg>
        <pc:spChg chg="add mod">
          <ac:chgData name="Warner,Jeffrey Barr" userId="7360d018-3b8a-4d6d-8136-e4d170e1e616" providerId="ADAL" clId="{E1317903-0E43-4FAC-A900-4D6121109CB5}" dt="2021-05-12T18:55:08.125" v="6312" actId="164"/>
          <ac:spMkLst>
            <pc:docMk/>
            <pc:sldMk cId="3815654910" sldId="259"/>
            <ac:spMk id="77" creationId="{F12857E8-BE40-4B2D-9490-9D6F61A6645C}"/>
          </ac:spMkLst>
        </pc:spChg>
        <pc:spChg chg="add mod">
          <ac:chgData name="Warner,Jeffrey Barr" userId="7360d018-3b8a-4d6d-8136-e4d170e1e616" providerId="ADAL" clId="{E1317903-0E43-4FAC-A900-4D6121109CB5}" dt="2021-05-12T19:07:09.130" v="6551" actId="1076"/>
          <ac:spMkLst>
            <pc:docMk/>
            <pc:sldMk cId="3815654910" sldId="259"/>
            <ac:spMk id="78" creationId="{0A3CC6DB-709D-4AAD-9377-7F7987EBB84C}"/>
          </ac:spMkLst>
        </pc:spChg>
        <pc:spChg chg="add mod">
          <ac:chgData name="Warner,Jeffrey Barr" userId="7360d018-3b8a-4d6d-8136-e4d170e1e616" providerId="ADAL" clId="{E1317903-0E43-4FAC-A900-4D6121109CB5}" dt="2021-05-12T19:20:35.052" v="6960" actId="1076"/>
          <ac:spMkLst>
            <pc:docMk/>
            <pc:sldMk cId="3815654910" sldId="259"/>
            <ac:spMk id="79" creationId="{9493FDCC-4D79-4047-BD03-99384EDC9D6E}"/>
          </ac:spMkLst>
        </pc:spChg>
        <pc:spChg chg="add mod">
          <ac:chgData name="Warner,Jeffrey Barr" userId="7360d018-3b8a-4d6d-8136-e4d170e1e616" providerId="ADAL" clId="{E1317903-0E43-4FAC-A900-4D6121109CB5}" dt="2021-05-12T18:55:15.515" v="6313" actId="164"/>
          <ac:spMkLst>
            <pc:docMk/>
            <pc:sldMk cId="3815654910" sldId="259"/>
            <ac:spMk id="80" creationId="{05D1B08A-91D3-4525-BA48-EF77E1992781}"/>
          </ac:spMkLst>
        </pc:spChg>
        <pc:spChg chg="add mod">
          <ac:chgData name="Warner,Jeffrey Barr" userId="7360d018-3b8a-4d6d-8136-e4d170e1e616" providerId="ADAL" clId="{E1317903-0E43-4FAC-A900-4D6121109CB5}" dt="2021-05-12T18:55:04.702" v="6311" actId="164"/>
          <ac:spMkLst>
            <pc:docMk/>
            <pc:sldMk cId="3815654910" sldId="259"/>
            <ac:spMk id="81" creationId="{6A1FB9C4-2368-4AA7-BC85-23D90C872F08}"/>
          </ac:spMkLst>
        </pc:spChg>
        <pc:spChg chg="add mod">
          <ac:chgData name="Warner,Jeffrey Barr" userId="7360d018-3b8a-4d6d-8136-e4d170e1e616" providerId="ADAL" clId="{E1317903-0E43-4FAC-A900-4D6121109CB5}" dt="2021-05-12T19:07:28.212" v="6560" actId="1076"/>
          <ac:spMkLst>
            <pc:docMk/>
            <pc:sldMk cId="3815654910" sldId="259"/>
            <ac:spMk id="82" creationId="{2FB7C7E3-0C03-493E-9CD3-F72EA821C5D6}"/>
          </ac:spMkLst>
        </pc:spChg>
        <pc:spChg chg="add mod">
          <ac:chgData name="Warner,Jeffrey Barr" userId="7360d018-3b8a-4d6d-8136-e4d170e1e616" providerId="ADAL" clId="{E1317903-0E43-4FAC-A900-4D6121109CB5}" dt="2021-05-12T19:07:10.982" v="6552" actId="1076"/>
          <ac:spMkLst>
            <pc:docMk/>
            <pc:sldMk cId="3815654910" sldId="259"/>
            <ac:spMk id="83" creationId="{D55F193C-EC0D-4100-8C84-ABAB3DE6F48E}"/>
          </ac:spMkLst>
        </pc:spChg>
        <pc:spChg chg="add mod">
          <ac:chgData name="Warner,Jeffrey Barr" userId="7360d018-3b8a-4d6d-8136-e4d170e1e616" providerId="ADAL" clId="{E1317903-0E43-4FAC-A900-4D6121109CB5}" dt="2021-05-12T19:20:37.951" v="6961" actId="1076"/>
          <ac:spMkLst>
            <pc:docMk/>
            <pc:sldMk cId="3815654910" sldId="259"/>
            <ac:spMk id="84" creationId="{6AD87AB0-A7B5-4A22-965D-82A3E4B7C401}"/>
          </ac:spMkLst>
        </pc:spChg>
        <pc:spChg chg="add mod">
          <ac:chgData name="Warner,Jeffrey Barr" userId="7360d018-3b8a-4d6d-8136-e4d170e1e616" providerId="ADAL" clId="{E1317903-0E43-4FAC-A900-4D6121109CB5}" dt="2021-05-12T18:55:15.515" v="6313" actId="164"/>
          <ac:spMkLst>
            <pc:docMk/>
            <pc:sldMk cId="3815654910" sldId="259"/>
            <ac:spMk id="85" creationId="{B141351D-B98D-4C7B-8639-1007ACAA6417}"/>
          </ac:spMkLst>
        </pc:spChg>
        <pc:spChg chg="add mod">
          <ac:chgData name="Warner,Jeffrey Barr" userId="7360d018-3b8a-4d6d-8136-e4d170e1e616" providerId="ADAL" clId="{E1317903-0E43-4FAC-A900-4D6121109CB5}" dt="2021-05-12T18:55:08.125" v="6312" actId="164"/>
          <ac:spMkLst>
            <pc:docMk/>
            <pc:sldMk cId="3815654910" sldId="259"/>
            <ac:spMk id="86" creationId="{AEF13304-A67D-4860-A683-7AECB4FD4780}"/>
          </ac:spMkLst>
        </pc:spChg>
        <pc:spChg chg="add del mod">
          <ac:chgData name="Warner,Jeffrey Barr" userId="7360d018-3b8a-4d6d-8136-e4d170e1e616" providerId="ADAL" clId="{E1317903-0E43-4FAC-A900-4D6121109CB5}" dt="2021-05-12T19:01:45.049" v="6477" actId="478"/>
          <ac:spMkLst>
            <pc:docMk/>
            <pc:sldMk cId="3815654910" sldId="259"/>
            <ac:spMk id="93" creationId="{FC906E7A-F8E2-40C4-843F-EA106DF915DE}"/>
          </ac:spMkLst>
        </pc:spChg>
        <pc:grpChg chg="mod">
          <ac:chgData name="Warner,Jeffrey Barr" userId="7360d018-3b8a-4d6d-8136-e4d170e1e616" providerId="ADAL" clId="{E1317903-0E43-4FAC-A900-4D6121109CB5}" dt="2021-04-22T20:28:26.450" v="1961" actId="1035"/>
          <ac:grpSpMkLst>
            <pc:docMk/>
            <pc:sldMk cId="3815654910" sldId="259"/>
            <ac:grpSpMk id="2" creationId="{1DBFAC85-9881-42D0-9396-17363D5ABE56}"/>
          </ac:grpSpMkLst>
        </pc:grpChg>
        <pc:grpChg chg="add del mod">
          <ac:chgData name="Warner,Jeffrey Barr" userId="7360d018-3b8a-4d6d-8136-e4d170e1e616" providerId="ADAL" clId="{E1317903-0E43-4FAC-A900-4D6121109CB5}" dt="2021-05-12T18:49:59.419" v="5971" actId="165"/>
          <ac:grpSpMkLst>
            <pc:docMk/>
            <pc:sldMk cId="3815654910" sldId="259"/>
            <ac:grpSpMk id="3" creationId="{6143B91B-56BB-4F2F-9C84-720BD867FAD3}"/>
          </ac:grpSpMkLst>
        </pc:grpChg>
        <pc:grpChg chg="add del mod ord">
          <ac:chgData name="Warner,Jeffrey Barr" userId="7360d018-3b8a-4d6d-8136-e4d170e1e616" providerId="ADAL" clId="{E1317903-0E43-4FAC-A900-4D6121109CB5}" dt="2021-05-12T18:49:57.416" v="5970" actId="165"/>
          <ac:grpSpMkLst>
            <pc:docMk/>
            <pc:sldMk cId="3815654910" sldId="259"/>
            <ac:grpSpMk id="9" creationId="{B6E683DB-69EE-4372-9864-9D494695E24B}"/>
          </ac:grpSpMkLst>
        </pc:grpChg>
        <pc:grpChg chg="mod topLvl">
          <ac:chgData name="Warner,Jeffrey Barr" userId="7360d018-3b8a-4d6d-8136-e4d170e1e616" providerId="ADAL" clId="{E1317903-0E43-4FAC-A900-4D6121109CB5}" dt="2021-05-12T18:49:57.416" v="5970" actId="165"/>
          <ac:grpSpMkLst>
            <pc:docMk/>
            <pc:sldMk cId="3815654910" sldId="259"/>
            <ac:grpSpMk id="19" creationId="{3D5E7A80-2F40-4BFD-939F-E75C94018F0B}"/>
          </ac:grpSpMkLst>
        </pc:grpChg>
        <pc:grpChg chg="mod topLvl">
          <ac:chgData name="Warner,Jeffrey Barr" userId="7360d018-3b8a-4d6d-8136-e4d170e1e616" providerId="ADAL" clId="{E1317903-0E43-4FAC-A900-4D6121109CB5}" dt="2021-05-12T18:49:59.419" v="5971" actId="165"/>
          <ac:grpSpMkLst>
            <pc:docMk/>
            <pc:sldMk cId="3815654910" sldId="259"/>
            <ac:grpSpMk id="20" creationId="{2F0DC15B-31BD-4627-A928-E9FE5F6E7981}"/>
          </ac:grpSpMkLst>
        </pc:grpChg>
        <pc:grpChg chg="mod">
          <ac:chgData name="Warner,Jeffrey Barr" userId="7360d018-3b8a-4d6d-8136-e4d170e1e616" providerId="ADAL" clId="{E1317903-0E43-4FAC-A900-4D6121109CB5}" dt="2021-05-12T18:49:57.416" v="5970" actId="165"/>
          <ac:grpSpMkLst>
            <pc:docMk/>
            <pc:sldMk cId="3815654910" sldId="259"/>
            <ac:grpSpMk id="32" creationId="{A929A274-EF66-4E4B-95B1-302F7233B5A8}"/>
          </ac:grpSpMkLst>
        </pc:grpChg>
        <pc:grpChg chg="add mod">
          <ac:chgData name="Warner,Jeffrey Barr" userId="7360d018-3b8a-4d6d-8136-e4d170e1e616" providerId="ADAL" clId="{E1317903-0E43-4FAC-A900-4D6121109CB5}" dt="2021-05-12T18:53:43.420" v="6278" actId="164"/>
          <ac:grpSpMkLst>
            <pc:docMk/>
            <pc:sldMk cId="3815654910" sldId="259"/>
            <ac:grpSpMk id="43" creationId="{B7B9B980-EF36-4DFB-8C9F-716B2CCC1EC2}"/>
          </ac:grpSpMkLst>
        </pc:grpChg>
        <pc:grpChg chg="add mod">
          <ac:chgData name="Warner,Jeffrey Barr" userId="7360d018-3b8a-4d6d-8136-e4d170e1e616" providerId="ADAL" clId="{E1317903-0E43-4FAC-A900-4D6121109CB5}" dt="2021-05-12T18:53:45.795" v="6279" actId="164"/>
          <ac:grpSpMkLst>
            <pc:docMk/>
            <pc:sldMk cId="3815654910" sldId="259"/>
            <ac:grpSpMk id="44" creationId="{65453D5A-F03B-499E-9B32-2E36D466CC58}"/>
          </ac:grpSpMkLst>
        </pc:grpChg>
        <pc:grpChg chg="add mod">
          <ac:chgData name="Warner,Jeffrey Barr" userId="7360d018-3b8a-4d6d-8136-e4d170e1e616" providerId="ADAL" clId="{E1317903-0E43-4FAC-A900-4D6121109CB5}" dt="2021-05-12T18:53:47.582" v="6280" actId="164"/>
          <ac:grpSpMkLst>
            <pc:docMk/>
            <pc:sldMk cId="3815654910" sldId="259"/>
            <ac:grpSpMk id="45" creationId="{70294F26-A102-4C92-A26C-46FC2C1E487B}"/>
          </ac:grpSpMkLst>
        </pc:grpChg>
        <pc:grpChg chg="add del mod">
          <ac:chgData name="Warner,Jeffrey Barr" userId="7360d018-3b8a-4d6d-8136-e4d170e1e616" providerId="ADAL" clId="{E1317903-0E43-4FAC-A900-4D6121109CB5}" dt="2021-05-12T19:18:41.810" v="6671" actId="478"/>
          <ac:grpSpMkLst>
            <pc:docMk/>
            <pc:sldMk cId="3815654910" sldId="259"/>
            <ac:grpSpMk id="50" creationId="{0DB152B6-7C3B-4032-9FA8-84942BAD0CF7}"/>
          </ac:grpSpMkLst>
        </pc:grpChg>
        <pc:grpChg chg="add del mod">
          <ac:chgData name="Warner,Jeffrey Barr" userId="7360d018-3b8a-4d6d-8136-e4d170e1e616" providerId="ADAL" clId="{E1317903-0E43-4FAC-A900-4D6121109CB5}" dt="2021-05-12T19:12:52.578" v="6568" actId="478"/>
          <ac:grpSpMkLst>
            <pc:docMk/>
            <pc:sldMk cId="3815654910" sldId="259"/>
            <ac:grpSpMk id="51" creationId="{51083A66-D39A-450F-994E-967D49647551}"/>
          </ac:grpSpMkLst>
        </pc:grpChg>
        <pc:grpChg chg="add mod">
          <ac:chgData name="Warner,Jeffrey Barr" userId="7360d018-3b8a-4d6d-8136-e4d170e1e616" providerId="ADAL" clId="{E1317903-0E43-4FAC-A900-4D6121109CB5}" dt="2021-05-12T19:19:39.672" v="6733" actId="1035"/>
          <ac:grpSpMkLst>
            <pc:docMk/>
            <pc:sldMk cId="3815654910" sldId="259"/>
            <ac:grpSpMk id="52" creationId="{9111029F-B663-4C1A-9671-A90BB15AAFAC}"/>
          </ac:grpSpMkLst>
        </pc:grpChg>
        <pc:graphicFrameChg chg="mod">
          <ac:chgData name="Warner,Jeffrey Barr" userId="7360d018-3b8a-4d6d-8136-e4d170e1e616" providerId="ADAL" clId="{E1317903-0E43-4FAC-A900-4D6121109CB5}" dt="2021-05-19T17:50:48.173" v="7992"/>
          <ac:graphicFrameMkLst>
            <pc:docMk/>
            <pc:sldMk cId="3815654910" sldId="259"/>
            <ac:graphicFrameMk id="4" creationId="{228CF895-0658-A047-9ED8-B4BF91FF9E9C}"/>
          </ac:graphicFrameMkLst>
        </pc:graphicFrameChg>
        <pc:graphicFrameChg chg="mod topLvl">
          <ac:chgData name="Warner,Jeffrey Barr" userId="7360d018-3b8a-4d6d-8136-e4d170e1e616" providerId="ADAL" clId="{E1317903-0E43-4FAC-A900-4D6121109CB5}" dt="2021-05-20T16:59:13.373" v="8030"/>
          <ac:graphicFrameMkLst>
            <pc:docMk/>
            <pc:sldMk cId="3815654910" sldId="259"/>
            <ac:graphicFrameMk id="5" creationId="{02742EB6-9F02-1E47-B8CF-0E67B2BDA7FE}"/>
          </ac:graphicFrameMkLst>
        </pc:graphicFrameChg>
        <pc:graphicFrameChg chg="mod topLvl">
          <ac:chgData name="Warner,Jeffrey Barr" userId="7360d018-3b8a-4d6d-8136-e4d170e1e616" providerId="ADAL" clId="{E1317903-0E43-4FAC-A900-4D6121109CB5}" dt="2021-05-19T17:51:06.148" v="7996"/>
          <ac:graphicFrameMkLst>
            <pc:docMk/>
            <pc:sldMk cId="3815654910" sldId="259"/>
            <ac:graphicFrameMk id="47" creationId="{501B4390-F038-B643-8E3B-9F6F8C548934}"/>
          </ac:graphicFrameMkLst>
        </pc:graphicFrameChg>
        <pc:picChg chg="mod">
          <ac:chgData name="Warner,Jeffrey Barr" userId="7360d018-3b8a-4d6d-8136-e4d170e1e616" providerId="ADAL" clId="{E1317903-0E43-4FAC-A900-4D6121109CB5}" dt="2021-05-12T18:55:08.125" v="6312" actId="164"/>
          <ac:picMkLst>
            <pc:docMk/>
            <pc:sldMk cId="3815654910" sldId="259"/>
            <ac:picMk id="6" creationId="{CA8399B9-7B21-8347-8A54-F7EC890C98D5}"/>
          </ac:picMkLst>
        </pc:picChg>
        <pc:picChg chg="mod">
          <ac:chgData name="Warner,Jeffrey Barr" userId="7360d018-3b8a-4d6d-8136-e4d170e1e616" providerId="ADAL" clId="{E1317903-0E43-4FAC-A900-4D6121109CB5}" dt="2021-05-12T18:55:15.515" v="6313" actId="164"/>
          <ac:picMkLst>
            <pc:docMk/>
            <pc:sldMk cId="3815654910" sldId="259"/>
            <ac:picMk id="7" creationId="{9C7B7D67-69AB-854A-BB49-A56DE7A7E3D4}"/>
          </ac:picMkLst>
        </pc:picChg>
        <pc:picChg chg="mod">
          <ac:chgData name="Warner,Jeffrey Barr" userId="7360d018-3b8a-4d6d-8136-e4d170e1e616" providerId="ADAL" clId="{E1317903-0E43-4FAC-A900-4D6121109CB5}" dt="2021-05-12T18:55:04.702" v="6311" actId="164"/>
          <ac:picMkLst>
            <pc:docMk/>
            <pc:sldMk cId="3815654910" sldId="259"/>
            <ac:picMk id="8" creationId="{F0FE3857-FCAB-1A4F-BB7D-F45FA0BC0EA5}"/>
          </ac:picMkLst>
        </pc:picChg>
        <pc:picChg chg="add mod ord modCrop">
          <ac:chgData name="Warner,Jeffrey Barr" userId="7360d018-3b8a-4d6d-8136-e4d170e1e616" providerId="ADAL" clId="{E1317903-0E43-4FAC-A900-4D6121109CB5}" dt="2021-05-12T19:20:08.672" v="6823" actId="14100"/>
          <ac:picMkLst>
            <pc:docMk/>
            <pc:sldMk cId="3815654910" sldId="259"/>
            <ac:picMk id="22" creationId="{87723243-F888-40E7-8EE8-5D1997860A19}"/>
          </ac:picMkLst>
        </pc:picChg>
        <pc:picChg chg="add del mod topLvl">
          <ac:chgData name="Warner,Jeffrey Barr" userId="7360d018-3b8a-4d6d-8136-e4d170e1e616" providerId="ADAL" clId="{E1317903-0E43-4FAC-A900-4D6121109CB5}" dt="2021-05-12T18:51:27.036" v="6156" actId="478"/>
          <ac:picMkLst>
            <pc:docMk/>
            <pc:sldMk cId="3815654910" sldId="259"/>
            <ac:picMk id="23" creationId="{C4F8A680-81CE-B04B-B6FA-74D16318A9BF}"/>
          </ac:picMkLst>
        </pc:picChg>
        <pc:picChg chg="add del mod modCrop">
          <ac:chgData name="Warner,Jeffrey Barr" userId="7360d018-3b8a-4d6d-8136-e4d170e1e616" providerId="ADAL" clId="{E1317903-0E43-4FAC-A900-4D6121109CB5}" dt="2021-05-12T18:51:30.780" v="6170" actId="478"/>
          <ac:picMkLst>
            <pc:docMk/>
            <pc:sldMk cId="3815654910" sldId="259"/>
            <ac:picMk id="25" creationId="{19EBADA5-55D5-43AC-95FC-C4C72EB97579}"/>
          </ac:picMkLst>
        </pc:picChg>
        <pc:picChg chg="del mod">
          <ac:chgData name="Warner,Jeffrey Barr" userId="7360d018-3b8a-4d6d-8136-e4d170e1e616" providerId="ADAL" clId="{E1317903-0E43-4FAC-A900-4D6121109CB5}" dt="2021-05-12T18:49:56.276" v="5969" actId="478"/>
          <ac:picMkLst>
            <pc:docMk/>
            <pc:sldMk cId="3815654910" sldId="259"/>
            <ac:picMk id="27" creationId="{531059A6-CA47-F345-8298-41477228FC79}"/>
          </ac:picMkLst>
        </pc:picChg>
        <pc:picChg chg="add del mod ord modCrop">
          <ac:chgData name="Warner,Jeffrey Barr" userId="7360d018-3b8a-4d6d-8136-e4d170e1e616" providerId="ADAL" clId="{E1317903-0E43-4FAC-A900-4D6121109CB5}" dt="2021-05-12T18:52:08.560" v="6210" actId="478"/>
          <ac:picMkLst>
            <pc:docMk/>
            <pc:sldMk cId="3815654910" sldId="259"/>
            <ac:picMk id="28" creationId="{C4E1765C-09BA-4D54-B76F-BE20CF449A17}"/>
          </ac:picMkLst>
        </pc:picChg>
        <pc:picChg chg="add del mod topLvl">
          <ac:chgData name="Warner,Jeffrey Barr" userId="7360d018-3b8a-4d6d-8136-e4d170e1e616" providerId="ADAL" clId="{E1317903-0E43-4FAC-A900-4D6121109CB5}" dt="2021-05-12T18:51:30.241" v="6168" actId="478"/>
          <ac:picMkLst>
            <pc:docMk/>
            <pc:sldMk cId="3815654910" sldId="259"/>
            <ac:picMk id="29" creationId="{065A9AE1-480D-A641-9DB6-EEFAF214525A}"/>
          </ac:picMkLst>
        </pc:picChg>
        <pc:picChg chg="add mod ord modCrop">
          <ac:chgData name="Warner,Jeffrey Barr" userId="7360d018-3b8a-4d6d-8136-e4d170e1e616" providerId="ADAL" clId="{E1317903-0E43-4FAC-A900-4D6121109CB5}" dt="2021-05-12T19:20:23.846" v="6959" actId="1036"/>
          <ac:picMkLst>
            <pc:docMk/>
            <pc:sldMk cId="3815654910" sldId="259"/>
            <ac:picMk id="31" creationId="{8BE84686-15E3-4E96-9DD3-9A1233B5578D}"/>
          </ac:picMkLst>
        </pc:picChg>
        <pc:picChg chg="add mod ord modCrop">
          <ac:chgData name="Warner,Jeffrey Barr" userId="7360d018-3b8a-4d6d-8136-e4d170e1e616" providerId="ADAL" clId="{E1317903-0E43-4FAC-A900-4D6121109CB5}" dt="2021-05-12T18:52:16.124" v="6248" actId="1038"/>
          <ac:picMkLst>
            <pc:docMk/>
            <pc:sldMk cId="3815654910" sldId="259"/>
            <ac:picMk id="40" creationId="{52816370-2327-4106-9F9C-AE9CBCE5A661}"/>
          </ac:picMkLst>
        </pc:picChg>
        <pc:picChg chg="add del">
          <ac:chgData name="Warner,Jeffrey Barr" userId="7360d018-3b8a-4d6d-8136-e4d170e1e616" providerId="ADAL" clId="{E1317903-0E43-4FAC-A900-4D6121109CB5}" dt="2021-05-12T18:53:51.559" v="6282" actId="22"/>
          <ac:picMkLst>
            <pc:docMk/>
            <pc:sldMk cId="3815654910" sldId="259"/>
            <ac:picMk id="49" creationId="{F7EA84F3-28D1-4853-B60E-02316B99DFE9}"/>
          </ac:picMkLst>
        </pc:picChg>
        <pc:picChg chg="mod topLvl">
          <ac:chgData name="Warner,Jeffrey Barr" userId="7360d018-3b8a-4d6d-8136-e4d170e1e616" providerId="ADAL" clId="{E1317903-0E43-4FAC-A900-4D6121109CB5}" dt="2021-05-12T18:53:43.420" v="6278" actId="164"/>
          <ac:picMkLst>
            <pc:docMk/>
            <pc:sldMk cId="3815654910" sldId="259"/>
            <ac:picMk id="57" creationId="{30EA0DBE-91E8-C44D-A2A4-EAB275DEF1DC}"/>
          </ac:picMkLst>
        </pc:picChg>
        <pc:picChg chg="mod topLvl">
          <ac:chgData name="Warner,Jeffrey Barr" userId="7360d018-3b8a-4d6d-8136-e4d170e1e616" providerId="ADAL" clId="{E1317903-0E43-4FAC-A900-4D6121109CB5}" dt="2021-05-12T18:53:45.795" v="6279" actId="164"/>
          <ac:picMkLst>
            <pc:docMk/>
            <pc:sldMk cId="3815654910" sldId="259"/>
            <ac:picMk id="58" creationId="{DCDB4A7D-678E-0F49-8B85-6FA9A8591CD7}"/>
          </ac:picMkLst>
        </pc:picChg>
        <pc:picChg chg="mod topLvl">
          <ac:chgData name="Warner,Jeffrey Barr" userId="7360d018-3b8a-4d6d-8136-e4d170e1e616" providerId="ADAL" clId="{E1317903-0E43-4FAC-A900-4D6121109CB5}" dt="2021-05-12T18:53:47.582" v="6280" actId="164"/>
          <ac:picMkLst>
            <pc:docMk/>
            <pc:sldMk cId="3815654910" sldId="259"/>
            <ac:picMk id="59" creationId="{07AB1396-C191-B44C-A30F-89A107105244}"/>
          </ac:picMkLst>
        </pc:picChg>
        <pc:picChg chg="add del mod modCrop">
          <ac:chgData name="Warner,Jeffrey Barr" userId="7360d018-3b8a-4d6d-8136-e4d170e1e616" providerId="ADAL" clId="{E1317903-0E43-4FAC-A900-4D6121109CB5}" dt="2021-05-12T19:18:47.973" v="6674" actId="478"/>
          <ac:picMkLst>
            <pc:docMk/>
            <pc:sldMk cId="3815654910" sldId="259"/>
            <ac:picMk id="92" creationId="{495C3775-10F1-449A-A52B-3164CAE59CB5}"/>
          </ac:picMkLst>
        </pc:picChg>
        <pc:picChg chg="add mod">
          <ac:chgData name="Warner,Jeffrey Barr" userId="7360d018-3b8a-4d6d-8136-e4d170e1e616" providerId="ADAL" clId="{E1317903-0E43-4FAC-A900-4D6121109CB5}" dt="2021-05-12T19:13:02.349" v="6581" actId="1038"/>
          <ac:picMkLst>
            <pc:docMk/>
            <pc:sldMk cId="3815654910" sldId="259"/>
            <ac:picMk id="98" creationId="{68080CF5-D4B2-4E33-94DC-751F514EFDC6}"/>
          </ac:picMkLst>
        </pc:picChg>
        <pc:picChg chg="add mod ord">
          <ac:chgData name="Warner,Jeffrey Barr" userId="7360d018-3b8a-4d6d-8136-e4d170e1e616" providerId="ADAL" clId="{E1317903-0E43-4FAC-A900-4D6121109CB5}" dt="2021-05-12T19:18:43.450" v="6673" actId="1035"/>
          <ac:picMkLst>
            <pc:docMk/>
            <pc:sldMk cId="3815654910" sldId="259"/>
            <ac:picMk id="101" creationId="{109759D2-330F-4C7E-B9C4-126A87336362}"/>
          </ac:picMkLst>
        </pc:picChg>
        <pc:cxnChg chg="mod">
          <ac:chgData name="Warner,Jeffrey Barr" userId="7360d018-3b8a-4d6d-8136-e4d170e1e616" providerId="ADAL" clId="{E1317903-0E43-4FAC-A900-4D6121109CB5}" dt="2021-05-12T18:49:57.416" v="5970" actId="165"/>
          <ac:cxnSpMkLst>
            <pc:docMk/>
            <pc:sldMk cId="3815654910" sldId="259"/>
            <ac:cxnSpMk id="35" creationId="{C9128A05-2A6E-0747-82C8-E95F52427A48}"/>
          </ac:cxnSpMkLst>
        </pc:cxnChg>
        <pc:cxnChg chg="mod">
          <ac:chgData name="Warner,Jeffrey Barr" userId="7360d018-3b8a-4d6d-8136-e4d170e1e616" providerId="ADAL" clId="{E1317903-0E43-4FAC-A900-4D6121109CB5}" dt="2021-05-12T18:49:57.416" v="5970" actId="165"/>
          <ac:cxnSpMkLst>
            <pc:docMk/>
            <pc:sldMk cId="3815654910" sldId="259"/>
            <ac:cxnSpMk id="36" creationId="{C4C955C3-EF93-E849-AB9D-74A1CE5C8592}"/>
          </ac:cxnSpMkLst>
        </pc:cxnChg>
        <pc:cxnChg chg="mod">
          <ac:chgData name="Warner,Jeffrey Barr" userId="7360d018-3b8a-4d6d-8136-e4d170e1e616" providerId="ADAL" clId="{E1317903-0E43-4FAC-A900-4D6121109CB5}" dt="2021-05-12T18:49:59.419" v="5971" actId="165"/>
          <ac:cxnSpMkLst>
            <pc:docMk/>
            <pc:sldMk cId="3815654910" sldId="259"/>
            <ac:cxnSpMk id="55" creationId="{111A4D04-FBDA-3046-9A39-D7DE40DC779C}"/>
          </ac:cxnSpMkLst>
        </pc:cxnChg>
        <pc:cxnChg chg="mod">
          <ac:chgData name="Warner,Jeffrey Barr" userId="7360d018-3b8a-4d6d-8136-e4d170e1e616" providerId="ADAL" clId="{E1317903-0E43-4FAC-A900-4D6121109CB5}" dt="2021-05-12T18:49:59.419" v="5971" actId="165"/>
          <ac:cxnSpMkLst>
            <pc:docMk/>
            <pc:sldMk cId="3815654910" sldId="259"/>
            <ac:cxnSpMk id="56" creationId="{990BB11B-507A-704D-AF7D-317748576450}"/>
          </ac:cxnSpMkLst>
        </pc:cxnChg>
        <pc:cxnChg chg="add mod">
          <ac:chgData name="Warner,Jeffrey Barr" userId="7360d018-3b8a-4d6d-8136-e4d170e1e616" providerId="ADAL" clId="{E1317903-0E43-4FAC-A900-4D6121109CB5}" dt="2021-05-12T19:19:35.123" v="6730" actId="1036"/>
          <ac:cxnSpMkLst>
            <pc:docMk/>
            <pc:sldMk cId="3815654910" sldId="259"/>
            <ac:cxnSpMk id="88" creationId="{11E12F56-DD42-435D-A66C-6F464AA09565}"/>
          </ac:cxnSpMkLst>
        </pc:cxnChg>
        <pc:cxnChg chg="add del mod">
          <ac:chgData name="Warner,Jeffrey Barr" userId="7360d018-3b8a-4d6d-8136-e4d170e1e616" providerId="ADAL" clId="{E1317903-0E43-4FAC-A900-4D6121109CB5}" dt="2021-05-12T19:18:48.976" v="6675" actId="478"/>
          <ac:cxnSpMkLst>
            <pc:docMk/>
            <pc:sldMk cId="3815654910" sldId="259"/>
            <ac:cxnSpMk id="89" creationId="{ECB467B9-075A-40B4-A718-2B98F67E97CB}"/>
          </ac:cxnSpMkLst>
        </pc:cxnChg>
        <pc:cxnChg chg="add del mod">
          <ac:chgData name="Warner,Jeffrey Barr" userId="7360d018-3b8a-4d6d-8136-e4d170e1e616" providerId="ADAL" clId="{E1317903-0E43-4FAC-A900-4D6121109CB5}" dt="2021-05-12T19:01:01.618" v="6461" actId="478"/>
          <ac:cxnSpMkLst>
            <pc:docMk/>
            <pc:sldMk cId="3815654910" sldId="259"/>
            <ac:cxnSpMk id="90" creationId="{36EA951C-90AD-48E0-B5E0-A8B66E097D63}"/>
          </ac:cxnSpMkLst>
        </pc:cxnChg>
        <pc:cxnChg chg="add del mod">
          <ac:chgData name="Warner,Jeffrey Barr" userId="7360d018-3b8a-4d6d-8136-e4d170e1e616" providerId="ADAL" clId="{E1317903-0E43-4FAC-A900-4D6121109CB5}" dt="2021-05-12T19:18:47.973" v="6674" actId="478"/>
          <ac:cxnSpMkLst>
            <pc:docMk/>
            <pc:sldMk cId="3815654910" sldId="259"/>
            <ac:cxnSpMk id="95" creationId="{2274BA1C-CCEB-4CD6-A625-A156EADB94C4}"/>
          </ac:cxnSpMkLst>
        </pc:cxnChg>
        <pc:cxnChg chg="add del mod">
          <ac:chgData name="Warner,Jeffrey Barr" userId="7360d018-3b8a-4d6d-8136-e4d170e1e616" providerId="ADAL" clId="{E1317903-0E43-4FAC-A900-4D6121109CB5}" dt="2021-05-12T19:18:47.973" v="6674" actId="478"/>
          <ac:cxnSpMkLst>
            <pc:docMk/>
            <pc:sldMk cId="3815654910" sldId="259"/>
            <ac:cxnSpMk id="96" creationId="{67BF95C0-1DA9-409B-BCE9-565123AE92EF}"/>
          </ac:cxnSpMkLst>
        </pc:cxnChg>
        <pc:cxnChg chg="add del mod">
          <ac:chgData name="Warner,Jeffrey Barr" userId="7360d018-3b8a-4d6d-8136-e4d170e1e616" providerId="ADAL" clId="{E1317903-0E43-4FAC-A900-4D6121109CB5}" dt="2021-05-12T19:19:36.912" v="6731" actId="1036"/>
          <ac:cxnSpMkLst>
            <pc:docMk/>
            <pc:sldMk cId="3815654910" sldId="259"/>
            <ac:cxnSpMk id="99" creationId="{7F612567-5B67-4C36-90AA-6604BFD51283}"/>
          </ac:cxnSpMkLst>
        </pc:cxnChg>
      </pc:sldChg>
      <pc:sldChg chg="addSp delSp modSp mod delCm modNotesTx">
        <pc:chgData name="Warner,Jeffrey Barr" userId="7360d018-3b8a-4d6d-8136-e4d170e1e616" providerId="ADAL" clId="{E1317903-0E43-4FAC-A900-4D6121109CB5}" dt="2021-05-20T17:01:38.167" v="8121" actId="20577"/>
        <pc:sldMkLst>
          <pc:docMk/>
          <pc:sldMk cId="1676406075" sldId="264"/>
        </pc:sldMkLst>
        <pc:spChg chg="del mod">
          <ac:chgData name="Warner,Jeffrey Barr" userId="7360d018-3b8a-4d6d-8136-e4d170e1e616" providerId="ADAL" clId="{E1317903-0E43-4FAC-A900-4D6121109CB5}" dt="2021-05-20T16:56:54.437" v="8022" actId="478"/>
          <ac:spMkLst>
            <pc:docMk/>
            <pc:sldMk cId="1676406075" sldId="264"/>
            <ac:spMk id="4" creationId="{6CE1CE08-652B-4B7D-B206-C5ED4D590728}"/>
          </ac:spMkLst>
        </pc:spChg>
        <pc:spChg chg="mod">
          <ac:chgData name="Warner,Jeffrey Barr" userId="7360d018-3b8a-4d6d-8136-e4d170e1e616" providerId="ADAL" clId="{E1317903-0E43-4FAC-A900-4D6121109CB5}" dt="2021-05-10T15:40:44.397" v="4630" actId="12789"/>
          <ac:spMkLst>
            <pc:docMk/>
            <pc:sldMk cId="1676406075" sldId="264"/>
            <ac:spMk id="20" creationId="{2A9FFDA7-3CAF-4C76-86F0-BEFF756F76F5}"/>
          </ac:spMkLst>
        </pc:spChg>
        <pc:spChg chg="mod">
          <ac:chgData name="Warner,Jeffrey Barr" userId="7360d018-3b8a-4d6d-8136-e4d170e1e616" providerId="ADAL" clId="{E1317903-0E43-4FAC-A900-4D6121109CB5}" dt="2021-05-10T15:40:44.397" v="4630" actId="12789"/>
          <ac:spMkLst>
            <pc:docMk/>
            <pc:sldMk cId="1676406075" sldId="264"/>
            <ac:spMk id="21" creationId="{0ABF7C55-2B99-40C0-BBE1-D0A4DECA3A94}"/>
          </ac:spMkLst>
        </pc:spChg>
        <pc:spChg chg="mod">
          <ac:chgData name="Warner,Jeffrey Barr" userId="7360d018-3b8a-4d6d-8136-e4d170e1e616" providerId="ADAL" clId="{E1317903-0E43-4FAC-A900-4D6121109CB5}" dt="2021-05-10T15:40:44.397" v="4630" actId="12789"/>
          <ac:spMkLst>
            <pc:docMk/>
            <pc:sldMk cId="1676406075" sldId="264"/>
            <ac:spMk id="22" creationId="{2A9FFDA7-3CAF-4C76-86F0-BEFF756F76F5}"/>
          </ac:spMkLst>
        </pc:spChg>
        <pc:spChg chg="mod">
          <ac:chgData name="Warner,Jeffrey Barr" userId="7360d018-3b8a-4d6d-8136-e4d170e1e616" providerId="ADAL" clId="{E1317903-0E43-4FAC-A900-4D6121109CB5}" dt="2021-04-26T16:11:27.074" v="2045" actId="1036"/>
          <ac:spMkLst>
            <pc:docMk/>
            <pc:sldMk cId="1676406075" sldId="264"/>
            <ac:spMk id="34" creationId="{493DE474-6D0C-4C01-9820-29DC68078BE7}"/>
          </ac:spMkLst>
        </pc:spChg>
        <pc:spChg chg="mod">
          <ac:chgData name="Warner,Jeffrey Barr" userId="7360d018-3b8a-4d6d-8136-e4d170e1e616" providerId="ADAL" clId="{E1317903-0E43-4FAC-A900-4D6121109CB5}" dt="2021-04-26T16:11:23.912" v="2041" actId="1035"/>
          <ac:spMkLst>
            <pc:docMk/>
            <pc:sldMk cId="1676406075" sldId="264"/>
            <ac:spMk id="35" creationId="{30A5B9E2-F5EB-48DE-8F80-55018A035586}"/>
          </ac:spMkLst>
        </pc:spChg>
        <pc:spChg chg="mod">
          <ac:chgData name="Warner,Jeffrey Barr" userId="7360d018-3b8a-4d6d-8136-e4d170e1e616" providerId="ADAL" clId="{E1317903-0E43-4FAC-A900-4D6121109CB5}" dt="2021-04-22T16:37:03.533" v="326" actId="404"/>
          <ac:spMkLst>
            <pc:docMk/>
            <pc:sldMk cId="1676406075" sldId="264"/>
            <ac:spMk id="42" creationId="{E369D0D2-9E3D-4130-A13B-F3029ADF6DAD}"/>
          </ac:spMkLst>
        </pc:spChg>
        <pc:spChg chg="mod">
          <ac:chgData name="Warner,Jeffrey Barr" userId="7360d018-3b8a-4d6d-8136-e4d170e1e616" providerId="ADAL" clId="{E1317903-0E43-4FAC-A900-4D6121109CB5}" dt="2021-04-26T16:11:27.074" v="2045" actId="1036"/>
          <ac:spMkLst>
            <pc:docMk/>
            <pc:sldMk cId="1676406075" sldId="264"/>
            <ac:spMk id="53" creationId="{3EE73B98-9BDE-45AC-9F50-B7B08724047A}"/>
          </ac:spMkLst>
        </pc:spChg>
        <pc:spChg chg="add mod">
          <ac:chgData name="Warner,Jeffrey Barr" userId="7360d018-3b8a-4d6d-8136-e4d170e1e616" providerId="ADAL" clId="{E1317903-0E43-4FAC-A900-4D6121109CB5}" dt="2021-05-20T17:01:38.167" v="8121" actId="20577"/>
          <ac:spMkLst>
            <pc:docMk/>
            <pc:sldMk cId="1676406075" sldId="264"/>
            <ac:spMk id="73" creationId="{F76E79E0-2EC2-413A-B598-3020DFDFA7CB}"/>
          </ac:spMkLst>
        </pc:spChg>
        <pc:spChg chg="mod">
          <ac:chgData name="Warner,Jeffrey Barr" userId="7360d018-3b8a-4d6d-8136-e4d170e1e616" providerId="ADAL" clId="{E1317903-0E43-4FAC-A900-4D6121109CB5}" dt="2021-04-26T16:11:03.680" v="2022" actId="1036"/>
          <ac:spMkLst>
            <pc:docMk/>
            <pc:sldMk cId="1676406075" sldId="264"/>
            <ac:spMk id="91" creationId="{AA9460DB-155A-424D-BFEB-2899BEADE7BB}"/>
          </ac:spMkLst>
        </pc:spChg>
        <pc:spChg chg="mod">
          <ac:chgData name="Warner,Jeffrey Barr" userId="7360d018-3b8a-4d6d-8136-e4d170e1e616" providerId="ADAL" clId="{E1317903-0E43-4FAC-A900-4D6121109CB5}" dt="2021-04-26T16:11:23.912" v="2041" actId="1035"/>
          <ac:spMkLst>
            <pc:docMk/>
            <pc:sldMk cId="1676406075" sldId="264"/>
            <ac:spMk id="97" creationId="{9C0562E0-B7AE-4DE4-A4CC-B2CF6E5D81B6}"/>
          </ac:spMkLst>
        </pc:spChg>
        <pc:grpChg chg="mod">
          <ac:chgData name="Warner,Jeffrey Barr" userId="7360d018-3b8a-4d6d-8136-e4d170e1e616" providerId="ADAL" clId="{E1317903-0E43-4FAC-A900-4D6121109CB5}" dt="2021-05-10T15:40:35.081" v="4628" actId="164"/>
          <ac:grpSpMkLst>
            <pc:docMk/>
            <pc:sldMk cId="1676406075" sldId="264"/>
            <ac:grpSpMk id="2" creationId="{0AC71098-AB6F-4AE9-A5FB-971169296D18}"/>
          </ac:grpSpMkLst>
        </pc:grpChg>
        <pc:grpChg chg="mod">
          <ac:chgData name="Warner,Jeffrey Barr" userId="7360d018-3b8a-4d6d-8136-e4d170e1e616" providerId="ADAL" clId="{E1317903-0E43-4FAC-A900-4D6121109CB5}" dt="2021-05-10T15:40:30.508" v="4625" actId="164"/>
          <ac:grpSpMkLst>
            <pc:docMk/>
            <pc:sldMk cId="1676406075" sldId="264"/>
            <ac:grpSpMk id="6" creationId="{00000000-0000-0000-0000-000000000000}"/>
          </ac:grpSpMkLst>
        </pc:grpChg>
        <pc:grpChg chg="mod">
          <ac:chgData name="Warner,Jeffrey Barr" userId="7360d018-3b8a-4d6d-8136-e4d170e1e616" providerId="ADAL" clId="{E1317903-0E43-4FAC-A900-4D6121109CB5}" dt="2021-05-10T15:40:36.688" v="4629" actId="164"/>
          <ac:grpSpMkLst>
            <pc:docMk/>
            <pc:sldMk cId="1676406075" sldId="264"/>
            <ac:grpSpMk id="8" creationId="{EC75526C-F117-4E59-993B-68A0E92B1EF7}"/>
          </ac:grpSpMkLst>
        </pc:grpChg>
        <pc:grpChg chg="mod">
          <ac:chgData name="Warner,Jeffrey Barr" userId="7360d018-3b8a-4d6d-8136-e4d170e1e616" providerId="ADAL" clId="{E1317903-0E43-4FAC-A900-4D6121109CB5}" dt="2021-05-10T15:40:28.804" v="4622" actId="164"/>
          <ac:grpSpMkLst>
            <pc:docMk/>
            <pc:sldMk cId="1676406075" sldId="264"/>
            <ac:grpSpMk id="9" creationId="{C6776A6C-9407-477E-90C9-8A0BFDAFBEB3}"/>
          </ac:grpSpMkLst>
        </pc:grpChg>
        <pc:grpChg chg="mod">
          <ac:chgData name="Warner,Jeffrey Barr" userId="7360d018-3b8a-4d6d-8136-e4d170e1e616" providerId="ADAL" clId="{E1317903-0E43-4FAC-A900-4D6121109CB5}" dt="2021-05-10T15:40:32.111" v="4626" actId="164"/>
          <ac:grpSpMkLst>
            <pc:docMk/>
            <pc:sldMk cId="1676406075" sldId="264"/>
            <ac:grpSpMk id="10" creationId="{ADCF4C66-D672-474D-B921-06D041A7A8F4}"/>
          </ac:grpSpMkLst>
        </pc:grpChg>
        <pc:grpChg chg="add mod">
          <ac:chgData name="Warner,Jeffrey Barr" userId="7360d018-3b8a-4d6d-8136-e4d170e1e616" providerId="ADAL" clId="{E1317903-0E43-4FAC-A900-4D6121109CB5}" dt="2021-05-10T15:40:24.278" v="4619" actId="164"/>
          <ac:grpSpMkLst>
            <pc:docMk/>
            <pc:sldMk cId="1676406075" sldId="264"/>
            <ac:grpSpMk id="30" creationId="{A5DB7A82-A2AB-424E-A148-73E2806EE92C}"/>
          </ac:grpSpMkLst>
        </pc:grpChg>
        <pc:grpChg chg="add mod">
          <ac:chgData name="Warner,Jeffrey Barr" userId="7360d018-3b8a-4d6d-8136-e4d170e1e616" providerId="ADAL" clId="{E1317903-0E43-4FAC-A900-4D6121109CB5}" dt="2021-05-10T15:40:26.014" v="4620" actId="164"/>
          <ac:grpSpMkLst>
            <pc:docMk/>
            <pc:sldMk cId="1676406075" sldId="264"/>
            <ac:grpSpMk id="31" creationId="{5B7357CE-0392-414D-BE21-9502E92EFDB3}"/>
          </ac:grpSpMkLst>
        </pc:grpChg>
        <pc:grpChg chg="add mod">
          <ac:chgData name="Warner,Jeffrey Barr" userId="7360d018-3b8a-4d6d-8136-e4d170e1e616" providerId="ADAL" clId="{E1317903-0E43-4FAC-A900-4D6121109CB5}" dt="2021-05-10T15:40:27.315" v="4621" actId="164"/>
          <ac:grpSpMkLst>
            <pc:docMk/>
            <pc:sldMk cId="1676406075" sldId="264"/>
            <ac:grpSpMk id="32" creationId="{81B29B28-C709-4B92-BE6D-64E4ED274989}"/>
          </ac:grpSpMkLst>
        </pc:grpChg>
        <pc:grpChg chg="add mod">
          <ac:chgData name="Warner,Jeffrey Barr" userId="7360d018-3b8a-4d6d-8136-e4d170e1e616" providerId="ADAL" clId="{E1317903-0E43-4FAC-A900-4D6121109CB5}" dt="2021-05-10T15:40:28.804" v="4622" actId="164"/>
          <ac:grpSpMkLst>
            <pc:docMk/>
            <pc:sldMk cId="1676406075" sldId="264"/>
            <ac:grpSpMk id="37" creationId="{78D50694-6D7B-4556-AA47-FB9A3CD21FF3}"/>
          </ac:grpSpMkLst>
        </pc:grpChg>
        <pc:grpChg chg="add mod">
          <ac:chgData name="Warner,Jeffrey Barr" userId="7360d018-3b8a-4d6d-8136-e4d170e1e616" providerId="ADAL" clId="{E1317903-0E43-4FAC-A900-4D6121109CB5}" dt="2021-05-10T15:40:30.508" v="4625" actId="164"/>
          <ac:grpSpMkLst>
            <pc:docMk/>
            <pc:sldMk cId="1676406075" sldId="264"/>
            <ac:grpSpMk id="38" creationId="{F138C15C-38D7-493F-A387-AC8707A784E4}"/>
          </ac:grpSpMkLst>
        </pc:grpChg>
        <pc:grpChg chg="add mod">
          <ac:chgData name="Warner,Jeffrey Barr" userId="7360d018-3b8a-4d6d-8136-e4d170e1e616" providerId="ADAL" clId="{E1317903-0E43-4FAC-A900-4D6121109CB5}" dt="2021-05-10T15:40:32.111" v="4626" actId="164"/>
          <ac:grpSpMkLst>
            <pc:docMk/>
            <pc:sldMk cId="1676406075" sldId="264"/>
            <ac:grpSpMk id="39" creationId="{F2FC571D-A671-4585-9967-A0C6A061E414}"/>
          </ac:grpSpMkLst>
        </pc:grpChg>
        <pc:grpChg chg="add mod">
          <ac:chgData name="Warner,Jeffrey Barr" userId="7360d018-3b8a-4d6d-8136-e4d170e1e616" providerId="ADAL" clId="{E1317903-0E43-4FAC-A900-4D6121109CB5}" dt="2021-05-10T15:40:33.547" v="4627" actId="164"/>
          <ac:grpSpMkLst>
            <pc:docMk/>
            <pc:sldMk cId="1676406075" sldId="264"/>
            <ac:grpSpMk id="40" creationId="{7E6D4F68-0D0D-4ABD-891A-AF0AF61027FC}"/>
          </ac:grpSpMkLst>
        </pc:grpChg>
        <pc:grpChg chg="add mod">
          <ac:chgData name="Warner,Jeffrey Barr" userId="7360d018-3b8a-4d6d-8136-e4d170e1e616" providerId="ADAL" clId="{E1317903-0E43-4FAC-A900-4D6121109CB5}" dt="2021-05-10T15:40:35.081" v="4628" actId="164"/>
          <ac:grpSpMkLst>
            <pc:docMk/>
            <pc:sldMk cId="1676406075" sldId="264"/>
            <ac:grpSpMk id="41" creationId="{E397320E-5A09-4237-A97C-83BD9E50CA8C}"/>
          </ac:grpSpMkLst>
        </pc:grpChg>
        <pc:grpChg chg="add mod">
          <ac:chgData name="Warner,Jeffrey Barr" userId="7360d018-3b8a-4d6d-8136-e4d170e1e616" providerId="ADAL" clId="{E1317903-0E43-4FAC-A900-4D6121109CB5}" dt="2021-05-10T15:40:36.688" v="4629" actId="164"/>
          <ac:grpSpMkLst>
            <pc:docMk/>
            <pc:sldMk cId="1676406075" sldId="264"/>
            <ac:grpSpMk id="43" creationId="{253F6DAF-1611-463B-BB10-ECA8AB4EFDC9}"/>
          </ac:grpSpMkLst>
        </pc:grpChg>
        <pc:graphicFrameChg chg="mod">
          <ac:chgData name="Warner,Jeffrey Barr" userId="7360d018-3b8a-4d6d-8136-e4d170e1e616" providerId="ADAL" clId="{E1317903-0E43-4FAC-A900-4D6121109CB5}" dt="2021-05-19T17:47:11.330" v="7959"/>
          <ac:graphicFrameMkLst>
            <pc:docMk/>
            <pc:sldMk cId="1676406075" sldId="264"/>
            <ac:graphicFrameMk id="14" creationId="{8048C2FF-230B-4B41-89D8-142C4B115A2A}"/>
          </ac:graphicFrameMkLst>
        </pc:graphicFrameChg>
        <pc:graphicFrameChg chg="mod">
          <ac:chgData name="Warner,Jeffrey Barr" userId="7360d018-3b8a-4d6d-8136-e4d170e1e616" providerId="ADAL" clId="{E1317903-0E43-4FAC-A900-4D6121109CB5}" dt="2021-04-26T16:11:23.912" v="2041" actId="1035"/>
          <ac:graphicFrameMkLst>
            <pc:docMk/>
            <pc:sldMk cId="1676406075" sldId="264"/>
            <ac:graphicFrameMk id="19" creationId="{7A4DB3C0-1D5F-4DFC-A09B-5AB96B482DF4}"/>
          </ac:graphicFrameMkLst>
        </pc:graphicFrameChg>
        <pc:graphicFrameChg chg="mod">
          <ac:chgData name="Warner,Jeffrey Barr" userId="7360d018-3b8a-4d6d-8136-e4d170e1e616" providerId="ADAL" clId="{E1317903-0E43-4FAC-A900-4D6121109CB5}" dt="2021-05-19T17:47:19.015" v="7962"/>
          <ac:graphicFrameMkLst>
            <pc:docMk/>
            <pc:sldMk cId="1676406075" sldId="264"/>
            <ac:graphicFrameMk id="66" creationId="{0CFAA7AB-533D-4D41-BF56-149CBCDBA37A}"/>
          </ac:graphicFrameMkLst>
        </pc:graphicFrameChg>
        <pc:graphicFrameChg chg="mod">
          <ac:chgData name="Warner,Jeffrey Barr" userId="7360d018-3b8a-4d6d-8136-e4d170e1e616" providerId="ADAL" clId="{E1317903-0E43-4FAC-A900-4D6121109CB5}" dt="2021-05-19T17:47:04.315" v="7957"/>
          <ac:graphicFrameMkLst>
            <pc:docMk/>
            <pc:sldMk cId="1676406075" sldId="264"/>
            <ac:graphicFrameMk id="85" creationId="{0B2014FC-B360-4155-9057-F1975B5CEC61}"/>
          </ac:graphicFrameMkLst>
        </pc:graphicFrameChg>
        <pc:picChg chg="mod">
          <ac:chgData name="Warner,Jeffrey Barr" userId="7360d018-3b8a-4d6d-8136-e4d170e1e616" providerId="ADAL" clId="{E1317903-0E43-4FAC-A900-4D6121109CB5}" dt="2021-05-10T15:40:24.278" v="4619" actId="164"/>
          <ac:picMkLst>
            <pc:docMk/>
            <pc:sldMk cId="1676406075" sldId="264"/>
            <ac:picMk id="3" creationId="{00000000-0000-0000-0000-000000000000}"/>
          </ac:picMkLst>
        </pc:picChg>
        <pc:picChg chg="del mod">
          <ac:chgData name="Warner,Jeffrey Barr" userId="7360d018-3b8a-4d6d-8136-e4d170e1e616" providerId="ADAL" clId="{E1317903-0E43-4FAC-A900-4D6121109CB5}" dt="2021-05-10T15:28:11.022" v="4519" actId="478"/>
          <ac:picMkLst>
            <pc:docMk/>
            <pc:sldMk cId="1676406075" sldId="264"/>
            <ac:picMk id="5" creationId="{00000000-0000-0000-0000-000000000000}"/>
          </ac:picMkLst>
        </pc:picChg>
        <pc:picChg chg="mod">
          <ac:chgData name="Warner,Jeffrey Barr" userId="7360d018-3b8a-4d6d-8136-e4d170e1e616" providerId="ADAL" clId="{E1317903-0E43-4FAC-A900-4D6121109CB5}" dt="2021-05-10T15:40:26.014" v="4620" actId="164"/>
          <ac:picMkLst>
            <pc:docMk/>
            <pc:sldMk cId="1676406075" sldId="264"/>
            <ac:picMk id="7" creationId="{00000000-0000-0000-0000-000000000000}"/>
          </ac:picMkLst>
        </pc:picChg>
        <pc:picChg chg="add del mod">
          <ac:chgData name="Warner,Jeffrey Barr" userId="7360d018-3b8a-4d6d-8136-e4d170e1e616" providerId="ADAL" clId="{E1317903-0E43-4FAC-A900-4D6121109CB5}" dt="2021-05-10T15:24:18.667" v="4496" actId="478"/>
          <ac:picMkLst>
            <pc:docMk/>
            <pc:sldMk cId="1676406075" sldId="264"/>
            <ac:picMk id="12" creationId="{48A254A9-D573-4985-A0BE-D439D37F8A1E}"/>
          </ac:picMkLst>
        </pc:picChg>
        <pc:picChg chg="add del mod modCrop">
          <ac:chgData name="Warner,Jeffrey Barr" userId="7360d018-3b8a-4d6d-8136-e4d170e1e616" providerId="ADAL" clId="{E1317903-0E43-4FAC-A900-4D6121109CB5}" dt="2021-05-10T15:40:27.315" v="4621" actId="164"/>
          <ac:picMkLst>
            <pc:docMk/>
            <pc:sldMk cId="1676406075" sldId="264"/>
            <ac:picMk id="18" creationId="{85BD3BB8-D353-443C-A0F9-6C72E3BFA17E}"/>
          </ac:picMkLst>
        </pc:picChg>
        <pc:picChg chg="add del mod">
          <ac:chgData name="Warner,Jeffrey Barr" userId="7360d018-3b8a-4d6d-8136-e4d170e1e616" providerId="ADAL" clId="{E1317903-0E43-4FAC-A900-4D6121109CB5}" dt="2021-05-10T15:36:38.551" v="4539" actId="478"/>
          <ac:picMkLst>
            <pc:docMk/>
            <pc:sldMk cId="1676406075" sldId="264"/>
            <ac:picMk id="24" creationId="{26E803FE-2CD0-4C45-83E5-79CD9A4BC8F2}"/>
          </ac:picMkLst>
        </pc:picChg>
        <pc:picChg chg="add del mod">
          <ac:chgData name="Warner,Jeffrey Barr" userId="7360d018-3b8a-4d6d-8136-e4d170e1e616" providerId="ADAL" clId="{E1317903-0E43-4FAC-A900-4D6121109CB5}" dt="2021-05-10T15:37:39.158" v="4554" actId="478"/>
          <ac:picMkLst>
            <pc:docMk/>
            <pc:sldMk cId="1676406075" sldId="264"/>
            <ac:picMk id="29" creationId="{58D0ED69-62D9-48DC-93A4-B94D3BBDAF2E}"/>
          </ac:picMkLst>
        </pc:picChg>
        <pc:picChg chg="mod">
          <ac:chgData name="Warner,Jeffrey Barr" userId="7360d018-3b8a-4d6d-8136-e4d170e1e616" providerId="ADAL" clId="{E1317903-0E43-4FAC-A900-4D6121109CB5}" dt="2021-05-10T15:40:33.547" v="4627" actId="164"/>
          <ac:picMkLst>
            <pc:docMk/>
            <pc:sldMk cId="1676406075" sldId="264"/>
            <ac:picMk id="49" creationId="{C870FE34-4D1A-4F78-B8D7-DDB1759AACC4}"/>
          </ac:picMkLst>
        </pc:picChg>
        <pc:cxnChg chg="add mod">
          <ac:chgData name="Warner,Jeffrey Barr" userId="7360d018-3b8a-4d6d-8136-e4d170e1e616" providerId="ADAL" clId="{E1317903-0E43-4FAC-A900-4D6121109CB5}" dt="2021-05-10T15:40:27.315" v="4621" actId="164"/>
          <ac:cxnSpMkLst>
            <pc:docMk/>
            <pc:sldMk cId="1676406075" sldId="264"/>
            <ac:cxnSpMk id="26" creationId="{B3F6A479-DD36-48CE-BF35-791AC50FAE55}"/>
          </ac:cxnSpMkLst>
        </pc:cxnChg>
        <pc:cxnChg chg="add mod">
          <ac:chgData name="Warner,Jeffrey Barr" userId="7360d018-3b8a-4d6d-8136-e4d170e1e616" providerId="ADAL" clId="{E1317903-0E43-4FAC-A900-4D6121109CB5}" dt="2021-05-10T15:40:26.014" v="4620" actId="164"/>
          <ac:cxnSpMkLst>
            <pc:docMk/>
            <pc:sldMk cId="1676406075" sldId="264"/>
            <ac:cxnSpMk id="51" creationId="{23FF3D9F-A07D-4BAD-8EC3-95757A138C88}"/>
          </ac:cxnSpMkLst>
        </pc:cxnChg>
        <pc:cxnChg chg="add mod">
          <ac:chgData name="Warner,Jeffrey Barr" userId="7360d018-3b8a-4d6d-8136-e4d170e1e616" providerId="ADAL" clId="{E1317903-0E43-4FAC-A900-4D6121109CB5}" dt="2021-05-10T15:40:24.278" v="4619" actId="164"/>
          <ac:cxnSpMkLst>
            <pc:docMk/>
            <pc:sldMk cId="1676406075" sldId="264"/>
            <ac:cxnSpMk id="52" creationId="{F963100A-C718-4B85-AF78-DB70A97B8C4A}"/>
          </ac:cxnSpMkLst>
        </pc:cxnChg>
        <pc:cxnChg chg="mod">
          <ac:chgData name="Warner,Jeffrey Barr" userId="7360d018-3b8a-4d6d-8136-e4d170e1e616" providerId="ADAL" clId="{E1317903-0E43-4FAC-A900-4D6121109CB5}" dt="2021-05-19T18:19:27.756" v="8016" actId="1037"/>
          <ac:cxnSpMkLst>
            <pc:docMk/>
            <pc:sldMk cId="1676406075" sldId="264"/>
            <ac:cxnSpMk id="56" creationId="{8019C99D-A6D7-46C1-B186-99F130892ED0}"/>
          </ac:cxnSpMkLst>
        </pc:cxnChg>
        <pc:cxnChg chg="mod">
          <ac:chgData name="Warner,Jeffrey Barr" userId="7360d018-3b8a-4d6d-8136-e4d170e1e616" providerId="ADAL" clId="{E1317903-0E43-4FAC-A900-4D6121109CB5}" dt="2021-05-19T18:19:32.486" v="8019" actId="1037"/>
          <ac:cxnSpMkLst>
            <pc:docMk/>
            <pc:sldMk cId="1676406075" sldId="264"/>
            <ac:cxnSpMk id="59" creationId="{EAA9DCB2-1522-4CE2-98EF-6DC771088D9A}"/>
          </ac:cxnSpMkLst>
        </pc:cxnChg>
        <pc:cxnChg chg="add mod">
          <ac:chgData name="Warner,Jeffrey Barr" userId="7360d018-3b8a-4d6d-8136-e4d170e1e616" providerId="ADAL" clId="{E1317903-0E43-4FAC-A900-4D6121109CB5}" dt="2021-05-10T15:40:32.111" v="4626" actId="164"/>
          <ac:cxnSpMkLst>
            <pc:docMk/>
            <pc:sldMk cId="1676406075" sldId="264"/>
            <ac:cxnSpMk id="67" creationId="{4F997667-21F2-4BD4-B61C-87C651B38E89}"/>
          </ac:cxnSpMkLst>
        </pc:cxnChg>
        <pc:cxnChg chg="add mod">
          <ac:chgData name="Warner,Jeffrey Barr" userId="7360d018-3b8a-4d6d-8136-e4d170e1e616" providerId="ADAL" clId="{E1317903-0E43-4FAC-A900-4D6121109CB5}" dt="2021-05-10T15:40:30.508" v="4625" actId="164"/>
          <ac:cxnSpMkLst>
            <pc:docMk/>
            <pc:sldMk cId="1676406075" sldId="264"/>
            <ac:cxnSpMk id="68" creationId="{C7C557D0-98EB-4BF2-8F6F-E6E6FE64DD40}"/>
          </ac:cxnSpMkLst>
        </pc:cxnChg>
        <pc:cxnChg chg="add mod">
          <ac:chgData name="Warner,Jeffrey Barr" userId="7360d018-3b8a-4d6d-8136-e4d170e1e616" providerId="ADAL" clId="{E1317903-0E43-4FAC-A900-4D6121109CB5}" dt="2021-05-10T15:40:28.804" v="4622" actId="164"/>
          <ac:cxnSpMkLst>
            <pc:docMk/>
            <pc:sldMk cId="1676406075" sldId="264"/>
            <ac:cxnSpMk id="69" creationId="{D8152388-1C19-4992-B8D1-53A7EBF0D5CE}"/>
          </ac:cxnSpMkLst>
        </pc:cxnChg>
        <pc:cxnChg chg="add mod">
          <ac:chgData name="Warner,Jeffrey Barr" userId="7360d018-3b8a-4d6d-8136-e4d170e1e616" providerId="ADAL" clId="{E1317903-0E43-4FAC-A900-4D6121109CB5}" dt="2021-05-10T15:40:33.547" v="4627" actId="164"/>
          <ac:cxnSpMkLst>
            <pc:docMk/>
            <pc:sldMk cId="1676406075" sldId="264"/>
            <ac:cxnSpMk id="70" creationId="{3DD70E43-8920-42D0-BAC5-A4E666A6C62C}"/>
          </ac:cxnSpMkLst>
        </pc:cxnChg>
        <pc:cxnChg chg="add mod">
          <ac:chgData name="Warner,Jeffrey Barr" userId="7360d018-3b8a-4d6d-8136-e4d170e1e616" providerId="ADAL" clId="{E1317903-0E43-4FAC-A900-4D6121109CB5}" dt="2021-05-10T15:40:35.081" v="4628" actId="164"/>
          <ac:cxnSpMkLst>
            <pc:docMk/>
            <pc:sldMk cId="1676406075" sldId="264"/>
            <ac:cxnSpMk id="71" creationId="{DC5DF556-ABEE-410C-B5EB-DE68CBB99109}"/>
          </ac:cxnSpMkLst>
        </pc:cxnChg>
        <pc:cxnChg chg="add mod">
          <ac:chgData name="Warner,Jeffrey Barr" userId="7360d018-3b8a-4d6d-8136-e4d170e1e616" providerId="ADAL" clId="{E1317903-0E43-4FAC-A900-4D6121109CB5}" dt="2021-05-10T15:40:36.688" v="4629" actId="164"/>
          <ac:cxnSpMkLst>
            <pc:docMk/>
            <pc:sldMk cId="1676406075" sldId="264"/>
            <ac:cxnSpMk id="72" creationId="{6D419767-622D-4A81-9AB8-72DC5A2AAD33}"/>
          </ac:cxnSpMkLst>
        </pc:cxnChg>
      </pc:sldChg>
      <pc:sldChg chg="addSp delSp modSp mod">
        <pc:chgData name="Warner,Jeffrey Barr" userId="7360d018-3b8a-4d6d-8136-e4d170e1e616" providerId="ADAL" clId="{E1317903-0E43-4FAC-A900-4D6121109CB5}" dt="2021-05-20T17:02:04.783" v="8161" actId="20577"/>
        <pc:sldMkLst>
          <pc:docMk/>
          <pc:sldMk cId="3319412604" sldId="269"/>
        </pc:sldMkLst>
        <pc:spChg chg="del">
          <ac:chgData name="Warner,Jeffrey Barr" userId="7360d018-3b8a-4d6d-8136-e4d170e1e616" providerId="ADAL" clId="{E1317903-0E43-4FAC-A900-4D6121109CB5}" dt="2021-05-20T16:59:47.960" v="8038" actId="478"/>
          <ac:spMkLst>
            <pc:docMk/>
            <pc:sldMk cId="3319412604" sldId="269"/>
            <ac:spMk id="4" creationId="{802A17AF-DF8A-4FCA-87A2-708400DA8281}"/>
          </ac:spMkLst>
        </pc:spChg>
        <pc:spChg chg="mod">
          <ac:chgData name="Warner,Jeffrey Barr" userId="7360d018-3b8a-4d6d-8136-e4d170e1e616" providerId="ADAL" clId="{E1317903-0E43-4FAC-A900-4D6121109CB5}" dt="2021-05-19T17:09:07.633" v="7955" actId="20577"/>
          <ac:spMkLst>
            <pc:docMk/>
            <pc:sldMk cId="3319412604" sldId="269"/>
            <ac:spMk id="35" creationId="{C22E5819-A4F3-9F42-BEF3-FB33CAA48410}"/>
          </ac:spMkLst>
        </pc:spChg>
        <pc:spChg chg="mod">
          <ac:chgData name="Warner,Jeffrey Barr" userId="7360d018-3b8a-4d6d-8136-e4d170e1e616" providerId="ADAL" clId="{E1317903-0E43-4FAC-A900-4D6121109CB5}" dt="2021-05-12T16:57:20.092" v="5855" actId="1037"/>
          <ac:spMkLst>
            <pc:docMk/>
            <pc:sldMk cId="3319412604" sldId="269"/>
            <ac:spMk id="86" creationId="{8E3D3354-2658-D445-BB0B-A10480161FF9}"/>
          </ac:spMkLst>
        </pc:spChg>
        <pc:spChg chg="del">
          <ac:chgData name="Warner,Jeffrey Barr" userId="7360d018-3b8a-4d6d-8136-e4d170e1e616" providerId="ADAL" clId="{E1317903-0E43-4FAC-A900-4D6121109CB5}" dt="2021-04-28T19:36:55.985" v="2349" actId="478"/>
          <ac:spMkLst>
            <pc:docMk/>
            <pc:sldMk cId="3319412604" sldId="269"/>
            <ac:spMk id="91" creationId="{D4231E41-2146-8B47-946F-47CFD0A54E50}"/>
          </ac:spMkLst>
        </pc:spChg>
        <pc:spChg chg="del mod topLvl">
          <ac:chgData name="Warner,Jeffrey Barr" userId="7360d018-3b8a-4d6d-8136-e4d170e1e616" providerId="ADAL" clId="{E1317903-0E43-4FAC-A900-4D6121109CB5}" dt="2021-04-28T19:38:07.978" v="2535" actId="478"/>
          <ac:spMkLst>
            <pc:docMk/>
            <pc:sldMk cId="3319412604" sldId="269"/>
            <ac:spMk id="92" creationId="{B90DC2E3-1037-7441-A804-A6FABCAE89E4}"/>
          </ac:spMkLst>
        </pc:spChg>
        <pc:spChg chg="mod">
          <ac:chgData name="Warner,Jeffrey Barr" userId="7360d018-3b8a-4d6d-8136-e4d170e1e616" providerId="ADAL" clId="{E1317903-0E43-4FAC-A900-4D6121109CB5}" dt="2021-04-28T19:36:26.022" v="2220" actId="1037"/>
          <ac:spMkLst>
            <pc:docMk/>
            <pc:sldMk cId="3319412604" sldId="269"/>
            <ac:spMk id="107" creationId="{66112512-961A-EE4D-88A1-0FA292877BC2}"/>
          </ac:spMkLst>
        </pc:spChg>
        <pc:spChg chg="mod">
          <ac:chgData name="Warner,Jeffrey Barr" userId="7360d018-3b8a-4d6d-8136-e4d170e1e616" providerId="ADAL" clId="{E1317903-0E43-4FAC-A900-4D6121109CB5}" dt="2021-04-28T19:36:31.011" v="2235" actId="1036"/>
          <ac:spMkLst>
            <pc:docMk/>
            <pc:sldMk cId="3319412604" sldId="269"/>
            <ac:spMk id="108" creationId="{E59A60BE-E3EB-5341-8DC4-C370438AE9C9}"/>
          </ac:spMkLst>
        </pc:spChg>
        <pc:spChg chg="mod">
          <ac:chgData name="Warner,Jeffrey Barr" userId="7360d018-3b8a-4d6d-8136-e4d170e1e616" providerId="ADAL" clId="{E1317903-0E43-4FAC-A900-4D6121109CB5}" dt="2021-04-28T19:36:52.305" v="2347" actId="1035"/>
          <ac:spMkLst>
            <pc:docMk/>
            <pc:sldMk cId="3319412604" sldId="269"/>
            <ac:spMk id="115" creationId="{4CBE988E-DD17-BE47-AE53-C22A0EE93681}"/>
          </ac:spMkLst>
        </pc:spChg>
        <pc:spChg chg="mod">
          <ac:chgData name="Warner,Jeffrey Barr" userId="7360d018-3b8a-4d6d-8136-e4d170e1e616" providerId="ADAL" clId="{E1317903-0E43-4FAC-A900-4D6121109CB5}" dt="2021-04-28T19:36:52.305" v="2347" actId="1035"/>
          <ac:spMkLst>
            <pc:docMk/>
            <pc:sldMk cId="3319412604" sldId="269"/>
            <ac:spMk id="116" creationId="{11AC39DB-BB4B-0748-9D0E-FAE6024CDE3C}"/>
          </ac:spMkLst>
        </pc:spChg>
        <pc:spChg chg="add mod">
          <ac:chgData name="Warner,Jeffrey Barr" userId="7360d018-3b8a-4d6d-8136-e4d170e1e616" providerId="ADAL" clId="{E1317903-0E43-4FAC-A900-4D6121109CB5}" dt="2021-04-28T19:38:21.087" v="2545" actId="164"/>
          <ac:spMkLst>
            <pc:docMk/>
            <pc:sldMk cId="3319412604" sldId="269"/>
            <ac:spMk id="118" creationId="{1D18C378-047F-4C8D-9D27-84F483F5A6F7}"/>
          </ac:spMkLst>
        </pc:spChg>
        <pc:spChg chg="add mod">
          <ac:chgData name="Warner,Jeffrey Barr" userId="7360d018-3b8a-4d6d-8136-e4d170e1e616" providerId="ADAL" clId="{E1317903-0E43-4FAC-A900-4D6121109CB5}" dt="2021-04-28T19:38:21.087" v="2545" actId="164"/>
          <ac:spMkLst>
            <pc:docMk/>
            <pc:sldMk cId="3319412604" sldId="269"/>
            <ac:spMk id="120" creationId="{E0C0F77B-9098-4BE1-BE0F-A5367C7E7A72}"/>
          </ac:spMkLst>
        </pc:spChg>
        <pc:spChg chg="add mod">
          <ac:chgData name="Warner,Jeffrey Barr" userId="7360d018-3b8a-4d6d-8136-e4d170e1e616" providerId="ADAL" clId="{E1317903-0E43-4FAC-A900-4D6121109CB5}" dt="2021-05-20T17:02:04.783" v="8161" actId="20577"/>
          <ac:spMkLst>
            <pc:docMk/>
            <pc:sldMk cId="3319412604" sldId="269"/>
            <ac:spMk id="122" creationId="{BFB7B06D-321A-48F5-A81A-FB9F0DF99572}"/>
          </ac:spMkLst>
        </pc:spChg>
        <pc:spChg chg="mod">
          <ac:chgData name="Warner,Jeffrey Barr" userId="7360d018-3b8a-4d6d-8136-e4d170e1e616" providerId="ADAL" clId="{E1317903-0E43-4FAC-A900-4D6121109CB5}" dt="2021-04-28T19:37:36.958" v="2490" actId="1037"/>
          <ac:spMkLst>
            <pc:docMk/>
            <pc:sldMk cId="3319412604" sldId="269"/>
            <ac:spMk id="125" creationId="{BDC72A60-D8E2-EC40-82D6-5452FF75028D}"/>
          </ac:spMkLst>
        </pc:spChg>
        <pc:spChg chg="mod">
          <ac:chgData name="Warner,Jeffrey Barr" userId="7360d018-3b8a-4d6d-8136-e4d170e1e616" providerId="ADAL" clId="{E1317903-0E43-4FAC-A900-4D6121109CB5}" dt="2021-04-28T19:37:36.958" v="2490" actId="1037"/>
          <ac:spMkLst>
            <pc:docMk/>
            <pc:sldMk cId="3319412604" sldId="269"/>
            <ac:spMk id="126" creationId="{EBC9E293-6AEA-2F4B-A79A-4866F6A31B24}"/>
          </ac:spMkLst>
        </pc:spChg>
        <pc:grpChg chg="add mod">
          <ac:chgData name="Warner,Jeffrey Barr" userId="7360d018-3b8a-4d6d-8136-e4d170e1e616" providerId="ADAL" clId="{E1317903-0E43-4FAC-A900-4D6121109CB5}" dt="2021-04-28T19:38:29.752" v="2584" actId="1038"/>
          <ac:grpSpMkLst>
            <pc:docMk/>
            <pc:sldMk cId="3319412604" sldId="269"/>
            <ac:grpSpMk id="2" creationId="{DAD73332-844B-4896-AED2-5E6E4DCAD59A}"/>
          </ac:grpSpMkLst>
        </pc:grpChg>
        <pc:grpChg chg="del mod">
          <ac:chgData name="Warner,Jeffrey Barr" userId="7360d018-3b8a-4d6d-8136-e4d170e1e616" providerId="ADAL" clId="{E1317903-0E43-4FAC-A900-4D6121109CB5}" dt="2021-04-28T19:38:07.978" v="2535" actId="478"/>
          <ac:grpSpMkLst>
            <pc:docMk/>
            <pc:sldMk cId="3319412604" sldId="269"/>
            <ac:grpSpMk id="5" creationId="{4737109D-5834-974B-8DE3-9CF9D176BF7A}"/>
          </ac:grpSpMkLst>
        </pc:grpChg>
        <pc:grpChg chg="mod">
          <ac:chgData name="Warner,Jeffrey Barr" userId="7360d018-3b8a-4d6d-8136-e4d170e1e616" providerId="ADAL" clId="{E1317903-0E43-4FAC-A900-4D6121109CB5}" dt="2021-04-28T19:35:48.067" v="2098" actId="1076"/>
          <ac:grpSpMkLst>
            <pc:docMk/>
            <pc:sldMk cId="3319412604" sldId="269"/>
            <ac:grpSpMk id="12" creationId="{73F9E966-1F4A-CF4B-A47E-FE7A17B63724}"/>
          </ac:grpSpMkLst>
        </pc:grpChg>
        <pc:grpChg chg="mod">
          <ac:chgData name="Warner,Jeffrey Barr" userId="7360d018-3b8a-4d6d-8136-e4d170e1e616" providerId="ADAL" clId="{E1317903-0E43-4FAC-A900-4D6121109CB5}" dt="2021-04-28T19:37:44.984" v="2526" actId="1038"/>
          <ac:grpSpMkLst>
            <pc:docMk/>
            <pc:sldMk cId="3319412604" sldId="269"/>
            <ac:grpSpMk id="25" creationId="{BFAC175D-035D-4947-A0CA-5C157036FBA6}"/>
          </ac:grpSpMkLst>
        </pc:grpChg>
        <pc:grpChg chg="del">
          <ac:chgData name="Warner,Jeffrey Barr" userId="7360d018-3b8a-4d6d-8136-e4d170e1e616" providerId="ADAL" clId="{E1317903-0E43-4FAC-A900-4D6121109CB5}" dt="2021-04-28T19:38:05.661" v="2533" actId="478"/>
          <ac:grpSpMkLst>
            <pc:docMk/>
            <pc:sldMk cId="3319412604" sldId="269"/>
            <ac:grpSpMk id="87" creationId="{AC979FD2-72D7-C045-9584-1E3D13F3AB63}"/>
          </ac:grpSpMkLst>
        </pc:grpChg>
        <pc:picChg chg="mod ord topLvl">
          <ac:chgData name="Warner,Jeffrey Barr" userId="7360d018-3b8a-4d6d-8136-e4d170e1e616" providerId="ADAL" clId="{E1317903-0E43-4FAC-A900-4D6121109CB5}" dt="2021-04-28T19:38:21.087" v="2545" actId="164"/>
          <ac:picMkLst>
            <pc:docMk/>
            <pc:sldMk cId="3319412604" sldId="269"/>
            <ac:picMk id="3" creationId="{A1F379E0-23AE-FA44-BDE9-B93C59231D0D}"/>
          </ac:picMkLst>
        </pc:picChg>
        <pc:cxnChg chg="del mod">
          <ac:chgData name="Warner,Jeffrey Barr" userId="7360d018-3b8a-4d6d-8136-e4d170e1e616" providerId="ADAL" clId="{E1317903-0E43-4FAC-A900-4D6121109CB5}" dt="2021-04-28T19:38:05.661" v="2533" actId="478"/>
          <ac:cxnSpMkLst>
            <pc:docMk/>
            <pc:sldMk cId="3319412604" sldId="269"/>
            <ac:cxnSpMk id="89" creationId="{34A85B02-FCF0-FC4D-B317-2859EE7D5E0A}"/>
          </ac:cxnSpMkLst>
        </pc:cxnChg>
        <pc:cxnChg chg="del">
          <ac:chgData name="Warner,Jeffrey Barr" userId="7360d018-3b8a-4d6d-8136-e4d170e1e616" providerId="ADAL" clId="{E1317903-0E43-4FAC-A900-4D6121109CB5}" dt="2021-04-28T19:36:54.048" v="2348" actId="478"/>
          <ac:cxnSpMkLst>
            <pc:docMk/>
            <pc:sldMk cId="3319412604" sldId="269"/>
            <ac:cxnSpMk id="90" creationId="{4A4C1ABE-254F-D448-A16A-1FC431DF4A82}"/>
          </ac:cxnSpMkLst>
        </pc:cxnChg>
        <pc:cxnChg chg="mod">
          <ac:chgData name="Warner,Jeffrey Barr" userId="7360d018-3b8a-4d6d-8136-e4d170e1e616" providerId="ADAL" clId="{E1317903-0E43-4FAC-A900-4D6121109CB5}" dt="2021-04-28T19:36:03.249" v="2172" actId="1038"/>
          <ac:cxnSpMkLst>
            <pc:docMk/>
            <pc:sldMk cId="3319412604" sldId="269"/>
            <ac:cxnSpMk id="105" creationId="{C5CA79BE-ED02-EE47-A507-78BDFE6F3846}"/>
          </ac:cxnSpMkLst>
        </pc:cxnChg>
        <pc:cxnChg chg="mod">
          <ac:chgData name="Warner,Jeffrey Barr" userId="7360d018-3b8a-4d6d-8136-e4d170e1e616" providerId="ADAL" clId="{E1317903-0E43-4FAC-A900-4D6121109CB5}" dt="2021-04-28T19:36:14.779" v="2193" actId="1038"/>
          <ac:cxnSpMkLst>
            <pc:docMk/>
            <pc:sldMk cId="3319412604" sldId="269"/>
            <ac:cxnSpMk id="106" creationId="{0D425780-F170-F54F-BCBA-4BD7ABB4F793}"/>
          </ac:cxnSpMkLst>
        </pc:cxnChg>
        <pc:cxnChg chg="add mod">
          <ac:chgData name="Warner,Jeffrey Barr" userId="7360d018-3b8a-4d6d-8136-e4d170e1e616" providerId="ADAL" clId="{E1317903-0E43-4FAC-A900-4D6121109CB5}" dt="2021-04-28T19:38:21.087" v="2545" actId="164"/>
          <ac:cxnSpMkLst>
            <pc:docMk/>
            <pc:sldMk cId="3319412604" sldId="269"/>
            <ac:cxnSpMk id="110" creationId="{ECE72DB3-52AF-47C9-A155-915BADC11A75}"/>
          </ac:cxnSpMkLst>
        </pc:cxnChg>
        <pc:cxnChg chg="add mod">
          <ac:chgData name="Warner,Jeffrey Barr" userId="7360d018-3b8a-4d6d-8136-e4d170e1e616" providerId="ADAL" clId="{E1317903-0E43-4FAC-A900-4D6121109CB5}" dt="2021-04-28T19:38:21.087" v="2545" actId="164"/>
          <ac:cxnSpMkLst>
            <pc:docMk/>
            <pc:sldMk cId="3319412604" sldId="269"/>
            <ac:cxnSpMk id="112" creationId="{1217D959-AFB3-4406-A9C4-887EC7F3285C}"/>
          </ac:cxnSpMkLst>
        </pc:cxnChg>
        <pc:cxnChg chg="mod">
          <ac:chgData name="Warner,Jeffrey Barr" userId="7360d018-3b8a-4d6d-8136-e4d170e1e616" providerId="ADAL" clId="{E1317903-0E43-4FAC-A900-4D6121109CB5}" dt="2021-04-28T19:36:52.305" v="2347" actId="1035"/>
          <ac:cxnSpMkLst>
            <pc:docMk/>
            <pc:sldMk cId="3319412604" sldId="269"/>
            <ac:cxnSpMk id="113" creationId="{2B24ECE6-3737-9143-B46D-1EBCAC2E3568}"/>
          </ac:cxnSpMkLst>
        </pc:cxnChg>
        <pc:cxnChg chg="mod">
          <ac:chgData name="Warner,Jeffrey Barr" userId="7360d018-3b8a-4d6d-8136-e4d170e1e616" providerId="ADAL" clId="{E1317903-0E43-4FAC-A900-4D6121109CB5}" dt="2021-04-28T19:36:52.305" v="2347" actId="1035"/>
          <ac:cxnSpMkLst>
            <pc:docMk/>
            <pc:sldMk cId="3319412604" sldId="269"/>
            <ac:cxnSpMk id="114" creationId="{002AF725-441A-C34C-9F25-626BF1243E37}"/>
          </ac:cxnSpMkLst>
        </pc:cxnChg>
        <pc:cxnChg chg="mod">
          <ac:chgData name="Warner,Jeffrey Barr" userId="7360d018-3b8a-4d6d-8136-e4d170e1e616" providerId="ADAL" clId="{E1317903-0E43-4FAC-A900-4D6121109CB5}" dt="2021-04-28T19:37:36.958" v="2490" actId="1037"/>
          <ac:cxnSpMkLst>
            <pc:docMk/>
            <pc:sldMk cId="3319412604" sldId="269"/>
            <ac:cxnSpMk id="123" creationId="{F0C36C43-423A-3549-9F05-A75C6BFAAE91}"/>
          </ac:cxnSpMkLst>
        </pc:cxnChg>
        <pc:cxnChg chg="mod">
          <ac:chgData name="Warner,Jeffrey Barr" userId="7360d018-3b8a-4d6d-8136-e4d170e1e616" providerId="ADAL" clId="{E1317903-0E43-4FAC-A900-4D6121109CB5}" dt="2021-04-28T19:37:36.958" v="2490" actId="1037"/>
          <ac:cxnSpMkLst>
            <pc:docMk/>
            <pc:sldMk cId="3319412604" sldId="269"/>
            <ac:cxnSpMk id="124" creationId="{FCA48754-9260-0E4E-A69F-AA7C5EFB989F}"/>
          </ac:cxnSpMkLst>
        </pc:cxnChg>
      </pc:sldChg>
      <pc:sldChg chg="del modNotesTx">
        <pc:chgData name="Warner,Jeffrey Barr" userId="7360d018-3b8a-4d6d-8136-e4d170e1e616" providerId="ADAL" clId="{E1317903-0E43-4FAC-A900-4D6121109CB5}" dt="2021-05-10T16:45:18.026" v="5681" actId="47"/>
        <pc:sldMkLst>
          <pc:docMk/>
          <pc:sldMk cId="3673886697" sldId="330"/>
        </pc:sldMkLst>
      </pc:sldChg>
      <pc:sldChg chg="addSp delSp modSp mod modNotesTx">
        <pc:chgData name="Warner,Jeffrey Barr" userId="7360d018-3b8a-4d6d-8136-e4d170e1e616" providerId="ADAL" clId="{E1317903-0E43-4FAC-A900-4D6121109CB5}" dt="2021-05-20T17:01:44.178" v="8126" actId="20577"/>
        <pc:sldMkLst>
          <pc:docMk/>
          <pc:sldMk cId="2515056989" sldId="337"/>
        </pc:sldMkLst>
        <pc:spChg chg="mod topLvl">
          <ac:chgData name="Warner,Jeffrey Barr" userId="7360d018-3b8a-4d6d-8136-e4d170e1e616" providerId="ADAL" clId="{E1317903-0E43-4FAC-A900-4D6121109CB5}" dt="2021-04-22T16:37:32.225" v="333" actId="12788"/>
          <ac:spMkLst>
            <pc:docMk/>
            <pc:sldMk cId="2515056989" sldId="337"/>
            <ac:spMk id="2" creationId="{7545EF24-25FF-4216-818A-A4E70C07B228}"/>
          </ac:spMkLst>
        </pc:spChg>
        <pc:spChg chg="del mod">
          <ac:chgData name="Warner,Jeffrey Barr" userId="7360d018-3b8a-4d6d-8136-e4d170e1e616" providerId="ADAL" clId="{E1317903-0E43-4FAC-A900-4D6121109CB5}" dt="2021-05-20T16:56:58.466" v="8024" actId="478"/>
          <ac:spMkLst>
            <pc:docMk/>
            <pc:sldMk cId="2515056989" sldId="337"/>
            <ac:spMk id="4" creationId="{06FA9ED6-C703-435C-BBEB-258AA280A9A4}"/>
          </ac:spMkLst>
        </pc:spChg>
        <pc:spChg chg="add mod">
          <ac:chgData name="Warner,Jeffrey Barr" userId="7360d018-3b8a-4d6d-8136-e4d170e1e616" providerId="ADAL" clId="{E1317903-0E43-4FAC-A900-4D6121109CB5}" dt="2021-05-20T17:01:44.178" v="8126" actId="20577"/>
          <ac:spMkLst>
            <pc:docMk/>
            <pc:sldMk cId="2515056989" sldId="337"/>
            <ac:spMk id="7" creationId="{7BBBE655-BFC6-44F9-913E-EC48B0143865}"/>
          </ac:spMkLst>
        </pc:spChg>
        <pc:spChg chg="mod topLvl">
          <ac:chgData name="Warner,Jeffrey Barr" userId="7360d018-3b8a-4d6d-8136-e4d170e1e616" providerId="ADAL" clId="{E1317903-0E43-4FAC-A900-4D6121109CB5}" dt="2021-04-22T16:37:35.880" v="334" actId="12788"/>
          <ac:spMkLst>
            <pc:docMk/>
            <pc:sldMk cId="2515056989" sldId="337"/>
            <ac:spMk id="20" creationId="{4A6B56DE-E3EF-41AC-933B-D3AFE149021A}"/>
          </ac:spMkLst>
        </pc:spChg>
        <pc:spChg chg="mod topLvl">
          <ac:chgData name="Warner,Jeffrey Barr" userId="7360d018-3b8a-4d6d-8136-e4d170e1e616" providerId="ADAL" clId="{E1317903-0E43-4FAC-A900-4D6121109CB5}" dt="2021-04-22T16:37:35.880" v="334" actId="12788"/>
          <ac:spMkLst>
            <pc:docMk/>
            <pc:sldMk cId="2515056989" sldId="337"/>
            <ac:spMk id="21" creationId="{C7F342A5-BA8C-4073-BE0D-8FD66949D558}"/>
          </ac:spMkLst>
        </pc:spChg>
        <pc:spChg chg="add del mod">
          <ac:chgData name="Warner,Jeffrey Barr" userId="7360d018-3b8a-4d6d-8136-e4d170e1e616" providerId="ADAL" clId="{E1317903-0E43-4FAC-A900-4D6121109CB5}" dt="2021-05-20T17:01:42.273" v="8125" actId="478"/>
          <ac:spMkLst>
            <pc:docMk/>
            <pc:sldMk cId="2515056989" sldId="337"/>
            <ac:spMk id="24" creationId="{E498672E-DFAE-43AE-8D79-9302D16DF325}"/>
          </ac:spMkLst>
        </pc:spChg>
        <pc:spChg chg="mod topLvl">
          <ac:chgData name="Warner,Jeffrey Barr" userId="7360d018-3b8a-4d6d-8136-e4d170e1e616" providerId="ADAL" clId="{E1317903-0E43-4FAC-A900-4D6121109CB5}" dt="2021-04-22T16:38:11.006" v="444" actId="12789"/>
          <ac:spMkLst>
            <pc:docMk/>
            <pc:sldMk cId="2515056989" sldId="337"/>
            <ac:spMk id="25" creationId="{3D30627C-1050-41D4-808F-31362B6F5E5D}"/>
          </ac:spMkLst>
        </pc:spChg>
        <pc:spChg chg="mod topLvl">
          <ac:chgData name="Warner,Jeffrey Barr" userId="7360d018-3b8a-4d6d-8136-e4d170e1e616" providerId="ADAL" clId="{E1317903-0E43-4FAC-A900-4D6121109CB5}" dt="2021-04-22T16:37:32.225" v="333" actId="12788"/>
          <ac:spMkLst>
            <pc:docMk/>
            <pc:sldMk cId="2515056989" sldId="337"/>
            <ac:spMk id="29" creationId="{4DBFA108-2E8C-438A-9025-DFDB2C452819}"/>
          </ac:spMkLst>
        </pc:spChg>
        <pc:spChg chg="mod topLvl">
          <ac:chgData name="Warner,Jeffrey Barr" userId="7360d018-3b8a-4d6d-8136-e4d170e1e616" providerId="ADAL" clId="{E1317903-0E43-4FAC-A900-4D6121109CB5}" dt="2021-04-22T16:38:21.758" v="482" actId="1037"/>
          <ac:spMkLst>
            <pc:docMk/>
            <pc:sldMk cId="2515056989" sldId="337"/>
            <ac:spMk id="37" creationId="{DCEA6C6F-D6C9-4FE9-A8BD-A373E02F94A5}"/>
          </ac:spMkLst>
        </pc:spChg>
        <pc:spChg chg="mod topLvl">
          <ac:chgData name="Warner,Jeffrey Barr" userId="7360d018-3b8a-4d6d-8136-e4d170e1e616" providerId="ADAL" clId="{E1317903-0E43-4FAC-A900-4D6121109CB5}" dt="2021-04-22T16:38:21.758" v="482" actId="1037"/>
          <ac:spMkLst>
            <pc:docMk/>
            <pc:sldMk cId="2515056989" sldId="337"/>
            <ac:spMk id="52" creationId="{333CFC8A-95CF-46AF-9BEC-C0233FB36B44}"/>
          </ac:spMkLst>
        </pc:spChg>
        <pc:spChg chg="mod topLvl">
          <ac:chgData name="Warner,Jeffrey Barr" userId="7360d018-3b8a-4d6d-8136-e4d170e1e616" providerId="ADAL" clId="{E1317903-0E43-4FAC-A900-4D6121109CB5}" dt="2021-04-22T16:38:08.031" v="443" actId="12789"/>
          <ac:spMkLst>
            <pc:docMk/>
            <pc:sldMk cId="2515056989" sldId="337"/>
            <ac:spMk id="53" creationId="{7996AB56-25D0-4A89-8CE3-9B4CE4FB6C66}"/>
          </ac:spMkLst>
        </pc:spChg>
        <pc:grpChg chg="mod topLvl">
          <ac:chgData name="Warner,Jeffrey Barr" userId="7360d018-3b8a-4d6d-8136-e4d170e1e616" providerId="ADAL" clId="{E1317903-0E43-4FAC-A900-4D6121109CB5}" dt="2021-04-22T16:37:27.345" v="332" actId="165"/>
          <ac:grpSpMkLst>
            <pc:docMk/>
            <pc:sldMk cId="2515056989" sldId="337"/>
            <ac:grpSpMk id="3" creationId="{66164B02-8013-431F-9DF8-43083C24701C}"/>
          </ac:grpSpMkLst>
        </pc:grpChg>
        <pc:grpChg chg="mod topLvl">
          <ac:chgData name="Warner,Jeffrey Barr" userId="7360d018-3b8a-4d6d-8136-e4d170e1e616" providerId="ADAL" clId="{E1317903-0E43-4FAC-A900-4D6121109CB5}" dt="2021-04-22T16:37:27.345" v="332" actId="165"/>
          <ac:grpSpMkLst>
            <pc:docMk/>
            <pc:sldMk cId="2515056989" sldId="337"/>
            <ac:grpSpMk id="5" creationId="{7B9B65FA-654C-4748-A5B8-41462E1C7CAB}"/>
          </ac:grpSpMkLst>
        </pc:grpChg>
        <pc:grpChg chg="mod topLvl">
          <ac:chgData name="Warner,Jeffrey Barr" userId="7360d018-3b8a-4d6d-8136-e4d170e1e616" providerId="ADAL" clId="{E1317903-0E43-4FAC-A900-4D6121109CB5}" dt="2021-04-22T16:39:01.096" v="624" actId="1037"/>
          <ac:grpSpMkLst>
            <pc:docMk/>
            <pc:sldMk cId="2515056989" sldId="337"/>
            <ac:grpSpMk id="6" creationId="{374C7E33-FD57-4AFB-9736-D0677D60EDF2}"/>
          </ac:grpSpMkLst>
        </pc:grpChg>
        <pc:grpChg chg="del">
          <ac:chgData name="Warner,Jeffrey Barr" userId="7360d018-3b8a-4d6d-8136-e4d170e1e616" providerId="ADAL" clId="{E1317903-0E43-4FAC-A900-4D6121109CB5}" dt="2021-04-22T16:37:27.345" v="332" actId="165"/>
          <ac:grpSpMkLst>
            <pc:docMk/>
            <pc:sldMk cId="2515056989" sldId="337"/>
            <ac:grpSpMk id="7" creationId="{31E129A4-FDC6-43DE-84E7-DFDC80ED9B1A}"/>
          </ac:grpSpMkLst>
        </pc:grpChg>
        <pc:grpChg chg="mod topLvl">
          <ac:chgData name="Warner,Jeffrey Barr" userId="7360d018-3b8a-4d6d-8136-e4d170e1e616" providerId="ADAL" clId="{E1317903-0E43-4FAC-A900-4D6121109CB5}" dt="2021-04-22T16:37:27.345" v="332" actId="165"/>
          <ac:grpSpMkLst>
            <pc:docMk/>
            <pc:sldMk cId="2515056989" sldId="337"/>
            <ac:grpSpMk id="40" creationId="{2D872996-E41A-4E88-BB7A-80642C0258A2}"/>
          </ac:grpSpMkLst>
        </pc:grpChg>
        <pc:graphicFrameChg chg="mod">
          <ac:chgData name="Warner,Jeffrey Barr" userId="7360d018-3b8a-4d6d-8136-e4d170e1e616" providerId="ADAL" clId="{E1317903-0E43-4FAC-A900-4D6121109CB5}" dt="2021-05-19T17:50:24.937" v="7987"/>
          <ac:graphicFrameMkLst>
            <pc:docMk/>
            <pc:sldMk cId="2515056989" sldId="337"/>
            <ac:graphicFrameMk id="22" creationId="{7EF0D639-FFEC-4EDE-AF27-B5F85A10FD87}"/>
          </ac:graphicFrameMkLst>
        </pc:graphicFrameChg>
        <pc:graphicFrameChg chg="mod">
          <ac:chgData name="Warner,Jeffrey Barr" userId="7360d018-3b8a-4d6d-8136-e4d170e1e616" providerId="ADAL" clId="{E1317903-0E43-4FAC-A900-4D6121109CB5}" dt="2021-05-19T17:50:39.739" v="7990"/>
          <ac:graphicFrameMkLst>
            <pc:docMk/>
            <pc:sldMk cId="2515056989" sldId="337"/>
            <ac:graphicFrameMk id="23" creationId="{5F4FD40E-321C-44AE-BA43-C17DE73D182C}"/>
          </ac:graphicFrameMkLst>
        </pc:graphicFrameChg>
        <pc:graphicFrameChg chg="mod">
          <ac:chgData name="Warner,Jeffrey Barr" userId="7360d018-3b8a-4d6d-8136-e4d170e1e616" providerId="ADAL" clId="{E1317903-0E43-4FAC-A900-4D6121109CB5}" dt="2021-05-19T17:49:42.097" v="7976"/>
          <ac:graphicFrameMkLst>
            <pc:docMk/>
            <pc:sldMk cId="2515056989" sldId="337"/>
            <ac:graphicFrameMk id="26" creationId="{480B0AD6-ACAE-4829-9CBA-EAB73A271E8F}"/>
          </ac:graphicFrameMkLst>
        </pc:graphicFrameChg>
        <pc:graphicFrameChg chg="mod">
          <ac:chgData name="Warner,Jeffrey Barr" userId="7360d018-3b8a-4d6d-8136-e4d170e1e616" providerId="ADAL" clId="{E1317903-0E43-4FAC-A900-4D6121109CB5}" dt="2021-05-19T17:49:49.366" v="7978"/>
          <ac:graphicFrameMkLst>
            <pc:docMk/>
            <pc:sldMk cId="2515056989" sldId="337"/>
            <ac:graphicFrameMk id="27" creationId="{28CFC53E-BDE3-4C57-A86C-EE05730EB730}"/>
          </ac:graphicFrameMkLst>
        </pc:graphicFrameChg>
        <pc:graphicFrameChg chg="mod">
          <ac:chgData name="Warner,Jeffrey Barr" userId="7360d018-3b8a-4d6d-8136-e4d170e1e616" providerId="ADAL" clId="{E1317903-0E43-4FAC-A900-4D6121109CB5}" dt="2021-05-19T17:49:27.417" v="7972"/>
          <ac:graphicFrameMkLst>
            <pc:docMk/>
            <pc:sldMk cId="2515056989" sldId="337"/>
            <ac:graphicFrameMk id="41" creationId="{0E1D8059-A1C8-48DA-8418-0DE9A315E59D}"/>
          </ac:graphicFrameMkLst>
        </pc:graphicFrameChg>
        <pc:graphicFrameChg chg="mod">
          <ac:chgData name="Warner,Jeffrey Barr" userId="7360d018-3b8a-4d6d-8136-e4d170e1e616" providerId="ADAL" clId="{E1317903-0E43-4FAC-A900-4D6121109CB5}" dt="2021-05-19T17:49:34.694" v="7974"/>
          <ac:graphicFrameMkLst>
            <pc:docMk/>
            <pc:sldMk cId="2515056989" sldId="337"/>
            <ac:graphicFrameMk id="50" creationId="{CEAD69D7-DAE8-424F-B7C4-1DFE57C12031}"/>
          </ac:graphicFrameMkLst>
        </pc:graphicFrameChg>
        <pc:graphicFrameChg chg="mod">
          <ac:chgData name="Warner,Jeffrey Barr" userId="7360d018-3b8a-4d6d-8136-e4d170e1e616" providerId="ADAL" clId="{E1317903-0E43-4FAC-A900-4D6121109CB5}" dt="2021-05-19T17:50:00.135" v="7980"/>
          <ac:graphicFrameMkLst>
            <pc:docMk/>
            <pc:sldMk cId="2515056989" sldId="337"/>
            <ac:graphicFrameMk id="71" creationId="{7BC3708C-2942-49B8-9DBB-195A66EF97A6}"/>
          </ac:graphicFrameMkLst>
        </pc:graphicFrameChg>
        <pc:graphicFrameChg chg="mod">
          <ac:chgData name="Warner,Jeffrey Barr" userId="7360d018-3b8a-4d6d-8136-e4d170e1e616" providerId="ADAL" clId="{E1317903-0E43-4FAC-A900-4D6121109CB5}" dt="2021-05-19T17:50:15.833" v="7985"/>
          <ac:graphicFrameMkLst>
            <pc:docMk/>
            <pc:sldMk cId="2515056989" sldId="337"/>
            <ac:graphicFrameMk id="74" creationId="{DD53C923-A884-4836-9319-F8F4614BA5F6}"/>
          </ac:graphicFrameMkLst>
        </pc:graphicFrameChg>
      </pc:sldChg>
      <pc:sldChg chg="addSp delSp modSp mod delCm modNotesTx">
        <pc:chgData name="Warner,Jeffrey Barr" userId="7360d018-3b8a-4d6d-8136-e4d170e1e616" providerId="ADAL" clId="{E1317903-0E43-4FAC-A900-4D6121109CB5}" dt="2021-05-20T17:01:40.051" v="8123" actId="20577"/>
        <pc:sldMkLst>
          <pc:docMk/>
          <pc:sldMk cId="3797510600" sldId="339"/>
        </pc:sldMkLst>
        <pc:spChg chg="del mod">
          <ac:chgData name="Warner,Jeffrey Barr" userId="7360d018-3b8a-4d6d-8136-e4d170e1e616" providerId="ADAL" clId="{E1317903-0E43-4FAC-A900-4D6121109CB5}" dt="2021-05-20T16:56:55.776" v="8023" actId="478"/>
          <ac:spMkLst>
            <pc:docMk/>
            <pc:sldMk cId="3797510600" sldId="339"/>
            <ac:spMk id="4" creationId="{01C8F9CF-409F-C64C-9F6E-41E1F8972559}"/>
          </ac:spMkLst>
        </pc:spChg>
        <pc:spChg chg="mod topLvl">
          <ac:chgData name="Warner,Jeffrey Barr" userId="7360d018-3b8a-4d6d-8136-e4d170e1e616" providerId="ADAL" clId="{E1317903-0E43-4FAC-A900-4D6121109CB5}" dt="2021-04-22T16:37:19.548" v="331" actId="165"/>
          <ac:spMkLst>
            <pc:docMk/>
            <pc:sldMk cId="3797510600" sldId="339"/>
            <ac:spMk id="5" creationId="{0312510B-E50F-4059-ABDE-A5F32D378697}"/>
          </ac:spMkLst>
        </pc:spChg>
        <pc:spChg chg="mod topLvl">
          <ac:chgData name="Warner,Jeffrey Barr" userId="7360d018-3b8a-4d6d-8136-e4d170e1e616" providerId="ADAL" clId="{E1317903-0E43-4FAC-A900-4D6121109CB5}" dt="2021-05-10T15:43:34.603" v="4890" actId="164"/>
          <ac:spMkLst>
            <pc:docMk/>
            <pc:sldMk cId="3797510600" sldId="339"/>
            <ac:spMk id="18" creationId="{2A9FFDA7-3CAF-4C76-86F0-BEFF756F76F5}"/>
          </ac:spMkLst>
        </pc:spChg>
        <pc:spChg chg="mod topLvl">
          <ac:chgData name="Warner,Jeffrey Barr" userId="7360d018-3b8a-4d6d-8136-e4d170e1e616" providerId="ADAL" clId="{E1317903-0E43-4FAC-A900-4D6121109CB5}" dt="2021-05-10T15:43:34.603" v="4890" actId="164"/>
          <ac:spMkLst>
            <pc:docMk/>
            <pc:sldMk cId="3797510600" sldId="339"/>
            <ac:spMk id="19" creationId="{0ABF7C55-2B99-40C0-BBE1-D0A4DECA3A94}"/>
          </ac:spMkLst>
        </pc:spChg>
        <pc:spChg chg="mod topLvl">
          <ac:chgData name="Warner,Jeffrey Barr" userId="7360d018-3b8a-4d6d-8136-e4d170e1e616" providerId="ADAL" clId="{E1317903-0E43-4FAC-A900-4D6121109CB5}" dt="2021-05-10T15:43:34.603" v="4890" actId="164"/>
          <ac:spMkLst>
            <pc:docMk/>
            <pc:sldMk cId="3797510600" sldId="339"/>
            <ac:spMk id="22" creationId="{AA9460DB-155A-424D-BFEB-2899BEADE7BB}"/>
          </ac:spMkLst>
        </pc:spChg>
        <pc:spChg chg="mod topLvl">
          <ac:chgData name="Warner,Jeffrey Barr" userId="7360d018-3b8a-4d6d-8136-e4d170e1e616" providerId="ADAL" clId="{E1317903-0E43-4FAC-A900-4D6121109CB5}" dt="2021-05-10T15:43:31.342" v="4888" actId="164"/>
          <ac:spMkLst>
            <pc:docMk/>
            <pc:sldMk cId="3797510600" sldId="339"/>
            <ac:spMk id="24" creationId="{9C0562E0-B7AE-4DE4-A4CC-B2CF6E5D81B6}"/>
          </ac:spMkLst>
        </pc:spChg>
        <pc:spChg chg="mod topLvl">
          <ac:chgData name="Warner,Jeffrey Barr" userId="7360d018-3b8a-4d6d-8136-e4d170e1e616" providerId="ADAL" clId="{E1317903-0E43-4FAC-A900-4D6121109CB5}" dt="2021-05-10T15:43:28.820" v="4886" actId="164"/>
          <ac:spMkLst>
            <pc:docMk/>
            <pc:sldMk cId="3797510600" sldId="339"/>
            <ac:spMk id="35" creationId="{C2E9BAD9-95A6-40D7-9009-D9B1F9D360BD}"/>
          </ac:spMkLst>
        </pc:spChg>
        <pc:spChg chg="mod topLvl">
          <ac:chgData name="Warner,Jeffrey Barr" userId="7360d018-3b8a-4d6d-8136-e4d170e1e616" providerId="ADAL" clId="{E1317903-0E43-4FAC-A900-4D6121109CB5}" dt="2021-05-10T15:43:31.342" v="4888" actId="164"/>
          <ac:spMkLst>
            <pc:docMk/>
            <pc:sldMk cId="3797510600" sldId="339"/>
            <ac:spMk id="45" creationId="{EE21CE19-3063-4B37-AD58-8313926A6F18}"/>
          </ac:spMkLst>
        </pc:spChg>
        <pc:spChg chg="mod topLvl">
          <ac:chgData name="Warner,Jeffrey Barr" userId="7360d018-3b8a-4d6d-8136-e4d170e1e616" providerId="ADAL" clId="{E1317903-0E43-4FAC-A900-4D6121109CB5}" dt="2021-05-10T15:43:31.342" v="4888" actId="164"/>
          <ac:spMkLst>
            <pc:docMk/>
            <pc:sldMk cId="3797510600" sldId="339"/>
            <ac:spMk id="50" creationId="{3CBDB1BD-CC48-4B21-84CF-DE7157D6F2E8}"/>
          </ac:spMkLst>
        </pc:spChg>
        <pc:spChg chg="mod topLvl">
          <ac:chgData name="Warner,Jeffrey Barr" userId="7360d018-3b8a-4d6d-8136-e4d170e1e616" providerId="ADAL" clId="{E1317903-0E43-4FAC-A900-4D6121109CB5}" dt="2021-05-10T15:43:28.820" v="4886" actId="164"/>
          <ac:spMkLst>
            <pc:docMk/>
            <pc:sldMk cId="3797510600" sldId="339"/>
            <ac:spMk id="51" creationId="{01C623DA-258F-4EA3-9222-E00C3714EBE7}"/>
          </ac:spMkLst>
        </pc:spChg>
        <pc:spChg chg="mod topLvl">
          <ac:chgData name="Warner,Jeffrey Barr" userId="7360d018-3b8a-4d6d-8136-e4d170e1e616" providerId="ADAL" clId="{E1317903-0E43-4FAC-A900-4D6121109CB5}" dt="2021-05-10T15:43:28.820" v="4886" actId="164"/>
          <ac:spMkLst>
            <pc:docMk/>
            <pc:sldMk cId="3797510600" sldId="339"/>
            <ac:spMk id="52" creationId="{6D6835F8-5DC5-4645-8F21-A84EFF3D06E9}"/>
          </ac:spMkLst>
        </pc:spChg>
        <pc:spChg chg="mod topLvl">
          <ac:chgData name="Warner,Jeffrey Barr" userId="7360d018-3b8a-4d6d-8136-e4d170e1e616" providerId="ADAL" clId="{E1317903-0E43-4FAC-A900-4D6121109CB5}" dt="2021-04-22T16:37:19.548" v="331" actId="165"/>
          <ac:spMkLst>
            <pc:docMk/>
            <pc:sldMk cId="3797510600" sldId="339"/>
            <ac:spMk id="54" creationId="{1C1B3389-C0D9-483C-9FD8-99C8626A3F6B}"/>
          </ac:spMkLst>
        </pc:spChg>
        <pc:spChg chg="mod topLvl">
          <ac:chgData name="Warner,Jeffrey Barr" userId="7360d018-3b8a-4d6d-8136-e4d170e1e616" providerId="ADAL" clId="{E1317903-0E43-4FAC-A900-4D6121109CB5}" dt="2021-04-22T16:37:19.548" v="331" actId="165"/>
          <ac:spMkLst>
            <pc:docMk/>
            <pc:sldMk cId="3797510600" sldId="339"/>
            <ac:spMk id="55" creationId="{13B9AD39-731D-4D6F-BD26-1C517C409F26}"/>
          </ac:spMkLst>
        </pc:spChg>
        <pc:spChg chg="mod topLvl">
          <ac:chgData name="Warner,Jeffrey Barr" userId="7360d018-3b8a-4d6d-8136-e4d170e1e616" providerId="ADAL" clId="{E1317903-0E43-4FAC-A900-4D6121109CB5}" dt="2021-04-22T16:37:19.548" v="331" actId="165"/>
          <ac:spMkLst>
            <pc:docMk/>
            <pc:sldMk cId="3797510600" sldId="339"/>
            <ac:spMk id="56" creationId="{635EAD64-BA53-4DA7-865E-B812085D688C}"/>
          </ac:spMkLst>
        </pc:spChg>
        <pc:spChg chg="mod topLvl">
          <ac:chgData name="Warner,Jeffrey Barr" userId="7360d018-3b8a-4d6d-8136-e4d170e1e616" providerId="ADAL" clId="{E1317903-0E43-4FAC-A900-4D6121109CB5}" dt="2021-04-22T16:37:19.548" v="331" actId="165"/>
          <ac:spMkLst>
            <pc:docMk/>
            <pc:sldMk cId="3797510600" sldId="339"/>
            <ac:spMk id="57" creationId="{5582CFAD-9CCB-4C55-9BBA-B95B39AD2DB6}"/>
          </ac:spMkLst>
        </pc:spChg>
        <pc:spChg chg="add mod">
          <ac:chgData name="Warner,Jeffrey Barr" userId="7360d018-3b8a-4d6d-8136-e4d170e1e616" providerId="ADAL" clId="{E1317903-0E43-4FAC-A900-4D6121109CB5}" dt="2021-05-20T17:01:40.051" v="8123" actId="20577"/>
          <ac:spMkLst>
            <pc:docMk/>
            <pc:sldMk cId="3797510600" sldId="339"/>
            <ac:spMk id="59" creationId="{79ED029E-DACD-4007-9CBD-D9CC25AD536D}"/>
          </ac:spMkLst>
        </pc:spChg>
        <pc:grpChg chg="del mod topLvl">
          <ac:chgData name="Warner,Jeffrey Barr" userId="7360d018-3b8a-4d6d-8136-e4d170e1e616" providerId="ADAL" clId="{E1317903-0E43-4FAC-A900-4D6121109CB5}" dt="2021-05-10T15:43:24.841" v="4885" actId="165"/>
          <ac:grpSpMkLst>
            <pc:docMk/>
            <pc:sldMk cId="3797510600" sldId="339"/>
            <ac:grpSpMk id="2" creationId="{DB9D96CD-176A-4CFE-9F62-AE393D3CE9A6}"/>
          </ac:grpSpMkLst>
        </pc:grpChg>
        <pc:grpChg chg="del mod topLvl">
          <ac:chgData name="Warner,Jeffrey Barr" userId="7360d018-3b8a-4d6d-8136-e4d170e1e616" providerId="ADAL" clId="{E1317903-0E43-4FAC-A900-4D6121109CB5}" dt="2021-05-10T15:43:17.959" v="4882" actId="165"/>
          <ac:grpSpMkLst>
            <pc:docMk/>
            <pc:sldMk cId="3797510600" sldId="339"/>
            <ac:grpSpMk id="3" creationId="{14097FB6-1B97-4429-B00F-CE1B0CA92F44}"/>
          </ac:grpSpMkLst>
        </pc:grpChg>
        <pc:grpChg chg="add del mod">
          <ac:chgData name="Warner,Jeffrey Barr" userId="7360d018-3b8a-4d6d-8136-e4d170e1e616" providerId="ADAL" clId="{E1317903-0E43-4FAC-A900-4D6121109CB5}" dt="2021-05-10T15:43:11.150" v="4879" actId="165"/>
          <ac:grpSpMkLst>
            <pc:docMk/>
            <pc:sldMk cId="3797510600" sldId="339"/>
            <ac:grpSpMk id="6" creationId="{40B411A5-7CAE-49BD-8ECB-97317208D641}"/>
          </ac:grpSpMkLst>
        </pc:grpChg>
        <pc:grpChg chg="add del mod">
          <ac:chgData name="Warner,Jeffrey Barr" userId="7360d018-3b8a-4d6d-8136-e4d170e1e616" providerId="ADAL" clId="{E1317903-0E43-4FAC-A900-4D6121109CB5}" dt="2021-04-22T16:37:19.548" v="331" actId="165"/>
          <ac:grpSpMkLst>
            <pc:docMk/>
            <pc:sldMk cId="3797510600" sldId="339"/>
            <ac:grpSpMk id="6" creationId="{5BE658CA-DFAB-4C22-8609-572B1F0A8473}"/>
          </ac:grpSpMkLst>
        </pc:grpChg>
        <pc:grpChg chg="add del mod">
          <ac:chgData name="Warner,Jeffrey Barr" userId="7360d018-3b8a-4d6d-8136-e4d170e1e616" providerId="ADAL" clId="{E1317903-0E43-4FAC-A900-4D6121109CB5}" dt="2021-05-10T15:43:32.545" v="4889" actId="165"/>
          <ac:grpSpMkLst>
            <pc:docMk/>
            <pc:sldMk cId="3797510600" sldId="339"/>
            <ac:grpSpMk id="7" creationId="{53C6C1A8-0D20-4FC3-A35E-0B10B40F7AF2}"/>
          </ac:grpSpMkLst>
        </pc:grpChg>
        <pc:grpChg chg="add del mod">
          <ac:chgData name="Warner,Jeffrey Barr" userId="7360d018-3b8a-4d6d-8136-e4d170e1e616" providerId="ADAL" clId="{E1317903-0E43-4FAC-A900-4D6121109CB5}" dt="2021-05-10T15:43:29.606" v="4887" actId="165"/>
          <ac:grpSpMkLst>
            <pc:docMk/>
            <pc:sldMk cId="3797510600" sldId="339"/>
            <ac:grpSpMk id="8" creationId="{4ADEE533-49EC-4AD2-A2C1-38314215B1FC}"/>
          </ac:grpSpMkLst>
        </pc:grpChg>
        <pc:grpChg chg="add mod">
          <ac:chgData name="Warner,Jeffrey Barr" userId="7360d018-3b8a-4d6d-8136-e4d170e1e616" providerId="ADAL" clId="{E1317903-0E43-4FAC-A900-4D6121109CB5}" dt="2021-05-10T15:43:28.820" v="4886" actId="164"/>
          <ac:grpSpMkLst>
            <pc:docMk/>
            <pc:sldMk cId="3797510600" sldId="339"/>
            <ac:grpSpMk id="9" creationId="{2BDDD110-6045-4801-8D71-692E16FE86D1}"/>
          </ac:grpSpMkLst>
        </pc:grpChg>
        <pc:grpChg chg="del mod topLvl">
          <ac:chgData name="Warner,Jeffrey Barr" userId="7360d018-3b8a-4d6d-8136-e4d170e1e616" providerId="ADAL" clId="{E1317903-0E43-4FAC-A900-4D6121109CB5}" dt="2021-05-10T15:43:11.883" v="4880" actId="165"/>
          <ac:grpSpMkLst>
            <pc:docMk/>
            <pc:sldMk cId="3797510600" sldId="339"/>
            <ac:grpSpMk id="10" creationId="{364ED230-B8F8-4189-8C96-DDA041ADC61C}"/>
          </ac:grpSpMkLst>
        </pc:grpChg>
        <pc:grpChg chg="del mod topLvl">
          <ac:chgData name="Warner,Jeffrey Barr" userId="7360d018-3b8a-4d6d-8136-e4d170e1e616" providerId="ADAL" clId="{E1317903-0E43-4FAC-A900-4D6121109CB5}" dt="2021-05-10T15:40:53.485" v="4632" actId="165"/>
          <ac:grpSpMkLst>
            <pc:docMk/>
            <pc:sldMk cId="3797510600" sldId="339"/>
            <ac:grpSpMk id="11" creationId="{EB4C7631-8FBC-49CE-9316-476D2A8162AA}"/>
          </ac:grpSpMkLst>
        </pc:grpChg>
        <pc:grpChg chg="del mod topLvl">
          <ac:chgData name="Warner,Jeffrey Barr" userId="7360d018-3b8a-4d6d-8136-e4d170e1e616" providerId="ADAL" clId="{E1317903-0E43-4FAC-A900-4D6121109CB5}" dt="2021-05-10T15:43:22.089" v="4884" actId="165"/>
          <ac:grpSpMkLst>
            <pc:docMk/>
            <pc:sldMk cId="3797510600" sldId="339"/>
            <ac:grpSpMk id="12" creationId="{651B0822-ABD1-4057-8E6B-4063B333A7D3}"/>
          </ac:grpSpMkLst>
        </pc:grpChg>
        <pc:grpChg chg="del mod topLvl">
          <ac:chgData name="Warner,Jeffrey Barr" userId="7360d018-3b8a-4d6d-8136-e4d170e1e616" providerId="ADAL" clId="{E1317903-0E43-4FAC-A900-4D6121109CB5}" dt="2021-05-10T15:40:54.125" v="4633" actId="165"/>
          <ac:grpSpMkLst>
            <pc:docMk/>
            <pc:sldMk cId="3797510600" sldId="339"/>
            <ac:grpSpMk id="13" creationId="{0D711B07-28FF-42CD-A422-434D82EAEBA6}"/>
          </ac:grpSpMkLst>
        </pc:grpChg>
        <pc:grpChg chg="del mod topLvl">
          <ac:chgData name="Warner,Jeffrey Barr" userId="7360d018-3b8a-4d6d-8136-e4d170e1e616" providerId="ADAL" clId="{E1317903-0E43-4FAC-A900-4D6121109CB5}" dt="2021-05-10T15:40:52.722" v="4631" actId="165"/>
          <ac:grpSpMkLst>
            <pc:docMk/>
            <pc:sldMk cId="3797510600" sldId="339"/>
            <ac:grpSpMk id="14" creationId="{B4C27648-452C-413B-BB0C-EEE300B20DE5}"/>
          </ac:grpSpMkLst>
        </pc:grpChg>
        <pc:grpChg chg="add mod">
          <ac:chgData name="Warner,Jeffrey Barr" userId="7360d018-3b8a-4d6d-8136-e4d170e1e616" providerId="ADAL" clId="{E1317903-0E43-4FAC-A900-4D6121109CB5}" dt="2021-05-10T15:43:31.342" v="4888" actId="164"/>
          <ac:grpSpMkLst>
            <pc:docMk/>
            <pc:sldMk cId="3797510600" sldId="339"/>
            <ac:grpSpMk id="15" creationId="{015C6767-4095-4A5C-8CC5-F67352D23020}"/>
          </ac:grpSpMkLst>
        </pc:grpChg>
        <pc:grpChg chg="add mod">
          <ac:chgData name="Warner,Jeffrey Barr" userId="7360d018-3b8a-4d6d-8136-e4d170e1e616" providerId="ADAL" clId="{E1317903-0E43-4FAC-A900-4D6121109CB5}" dt="2021-05-10T15:43:34.603" v="4890" actId="164"/>
          <ac:grpSpMkLst>
            <pc:docMk/>
            <pc:sldMk cId="3797510600" sldId="339"/>
            <ac:grpSpMk id="16" creationId="{4D2440DF-A56F-4357-B3C1-95685C077444}"/>
          </ac:grpSpMkLst>
        </pc:grpChg>
        <pc:graphicFrameChg chg="mod topLvl">
          <ac:chgData name="Warner,Jeffrey Barr" userId="7360d018-3b8a-4d6d-8136-e4d170e1e616" providerId="ADAL" clId="{E1317903-0E43-4FAC-A900-4D6121109CB5}" dt="2021-05-19T17:49:11.289" v="7970"/>
          <ac:graphicFrameMkLst>
            <pc:docMk/>
            <pc:sldMk cId="3797510600" sldId="339"/>
            <ac:graphicFrameMk id="44" creationId="{CF896330-5753-4B3A-B081-A7D3AD32FC14}"/>
          </ac:graphicFrameMkLst>
        </pc:graphicFrameChg>
        <pc:graphicFrameChg chg="mod topLvl">
          <ac:chgData name="Warner,Jeffrey Barr" userId="7360d018-3b8a-4d6d-8136-e4d170e1e616" providerId="ADAL" clId="{E1317903-0E43-4FAC-A900-4D6121109CB5}" dt="2021-05-19T17:47:29.972" v="7964"/>
          <ac:graphicFrameMkLst>
            <pc:docMk/>
            <pc:sldMk cId="3797510600" sldId="339"/>
            <ac:graphicFrameMk id="131" creationId="{6B4BE97B-68D1-49A7-8C45-83D0B39F3D67}"/>
          </ac:graphicFrameMkLst>
        </pc:graphicFrameChg>
        <pc:graphicFrameChg chg="mod topLvl">
          <ac:chgData name="Warner,Jeffrey Barr" userId="7360d018-3b8a-4d6d-8136-e4d170e1e616" providerId="ADAL" clId="{E1317903-0E43-4FAC-A900-4D6121109CB5}" dt="2021-05-19T17:47:40.954" v="7966"/>
          <ac:graphicFrameMkLst>
            <pc:docMk/>
            <pc:sldMk cId="3797510600" sldId="339"/>
            <ac:graphicFrameMk id="137" creationId="{B59EE25D-3C25-47BD-9A2C-B39F6BD0C045}"/>
          </ac:graphicFrameMkLst>
        </pc:graphicFrameChg>
        <pc:graphicFrameChg chg="mod topLvl">
          <ac:chgData name="Warner,Jeffrey Barr" userId="7360d018-3b8a-4d6d-8136-e4d170e1e616" providerId="ADAL" clId="{E1317903-0E43-4FAC-A900-4D6121109CB5}" dt="2021-05-19T17:49:04.291" v="7968"/>
          <ac:graphicFrameMkLst>
            <pc:docMk/>
            <pc:sldMk cId="3797510600" sldId="339"/>
            <ac:graphicFrameMk id="145" creationId="{809516D3-05A8-4A83-873D-58013774EA85}"/>
          </ac:graphicFrameMkLst>
        </pc:graphicFrameChg>
        <pc:picChg chg="mod topLvl">
          <ac:chgData name="Warner,Jeffrey Barr" userId="7360d018-3b8a-4d6d-8136-e4d170e1e616" providerId="ADAL" clId="{E1317903-0E43-4FAC-A900-4D6121109CB5}" dt="2021-05-10T15:43:28.820" v="4886" actId="164"/>
          <ac:picMkLst>
            <pc:docMk/>
            <pc:sldMk cId="3797510600" sldId="339"/>
            <ac:picMk id="36" creationId="{A23D6DDC-CA0B-4695-B545-533A5CC7D684}"/>
          </ac:picMkLst>
        </pc:picChg>
        <pc:picChg chg="mod topLvl">
          <ac:chgData name="Warner,Jeffrey Barr" userId="7360d018-3b8a-4d6d-8136-e4d170e1e616" providerId="ADAL" clId="{E1317903-0E43-4FAC-A900-4D6121109CB5}" dt="2021-05-10T15:43:28.820" v="4886" actId="164"/>
          <ac:picMkLst>
            <pc:docMk/>
            <pc:sldMk cId="3797510600" sldId="339"/>
            <ac:picMk id="39" creationId="{15009A56-F468-456B-A9F4-290299CB2298}"/>
          </ac:picMkLst>
        </pc:picChg>
        <pc:picChg chg="mod topLvl">
          <ac:chgData name="Warner,Jeffrey Barr" userId="7360d018-3b8a-4d6d-8136-e4d170e1e616" providerId="ADAL" clId="{E1317903-0E43-4FAC-A900-4D6121109CB5}" dt="2021-05-10T15:43:34.603" v="4890" actId="164"/>
          <ac:picMkLst>
            <pc:docMk/>
            <pc:sldMk cId="3797510600" sldId="339"/>
            <ac:picMk id="134" creationId="{F818D841-7602-4433-95CD-893094F31596}"/>
          </ac:picMkLst>
        </pc:picChg>
        <pc:picChg chg="mod topLvl">
          <ac:chgData name="Warner,Jeffrey Barr" userId="7360d018-3b8a-4d6d-8136-e4d170e1e616" providerId="ADAL" clId="{E1317903-0E43-4FAC-A900-4D6121109CB5}" dt="2021-05-10T15:43:34.603" v="4890" actId="164"/>
          <ac:picMkLst>
            <pc:docMk/>
            <pc:sldMk cId="3797510600" sldId="339"/>
            <ac:picMk id="135" creationId="{AF093CDD-E2A2-431D-B25C-2D9FF0DC9399}"/>
          </ac:picMkLst>
        </pc:picChg>
        <pc:picChg chg="mod topLvl">
          <ac:chgData name="Warner,Jeffrey Barr" userId="7360d018-3b8a-4d6d-8136-e4d170e1e616" providerId="ADAL" clId="{E1317903-0E43-4FAC-A900-4D6121109CB5}" dt="2021-05-10T15:43:31.342" v="4888" actId="164"/>
          <ac:picMkLst>
            <pc:docMk/>
            <pc:sldMk cId="3797510600" sldId="339"/>
            <ac:picMk id="142" creationId="{0FC6DBFA-FC9C-42F4-9E21-C8EE407058BC}"/>
          </ac:picMkLst>
        </pc:picChg>
        <pc:picChg chg="mod topLvl">
          <ac:chgData name="Warner,Jeffrey Barr" userId="7360d018-3b8a-4d6d-8136-e4d170e1e616" providerId="ADAL" clId="{E1317903-0E43-4FAC-A900-4D6121109CB5}" dt="2021-05-10T15:43:31.342" v="4888" actId="164"/>
          <ac:picMkLst>
            <pc:docMk/>
            <pc:sldMk cId="3797510600" sldId="339"/>
            <ac:picMk id="143" creationId="{F990A367-7C33-457B-9A52-8C01897AE613}"/>
          </ac:picMkLst>
        </pc:picChg>
        <pc:cxnChg chg="mod topLvl">
          <ac:chgData name="Warner,Jeffrey Barr" userId="7360d018-3b8a-4d6d-8136-e4d170e1e616" providerId="ADAL" clId="{E1317903-0E43-4FAC-A900-4D6121109CB5}" dt="2021-05-10T15:43:31.342" v="4888" actId="164"/>
          <ac:cxnSpMkLst>
            <pc:docMk/>
            <pc:sldMk cId="3797510600" sldId="339"/>
            <ac:cxnSpMk id="23" creationId="{00000000-0000-0000-0000-000000000000}"/>
          </ac:cxnSpMkLst>
        </pc:cxnChg>
        <pc:cxnChg chg="mod topLvl">
          <ac:chgData name="Warner,Jeffrey Barr" userId="7360d018-3b8a-4d6d-8136-e4d170e1e616" providerId="ADAL" clId="{E1317903-0E43-4FAC-A900-4D6121109CB5}" dt="2021-05-10T15:43:31.342" v="4888" actId="164"/>
          <ac:cxnSpMkLst>
            <pc:docMk/>
            <pc:sldMk cId="3797510600" sldId="339"/>
            <ac:cxnSpMk id="27" creationId="{00000000-0000-0000-0000-000000000000}"/>
          </ac:cxnSpMkLst>
        </pc:cxnChg>
        <pc:cxnChg chg="mod topLvl">
          <ac:chgData name="Warner,Jeffrey Barr" userId="7360d018-3b8a-4d6d-8136-e4d170e1e616" providerId="ADAL" clId="{E1317903-0E43-4FAC-A900-4D6121109CB5}" dt="2021-05-10T15:43:31.342" v="4888" actId="164"/>
          <ac:cxnSpMkLst>
            <pc:docMk/>
            <pc:sldMk cId="3797510600" sldId="339"/>
            <ac:cxnSpMk id="28" creationId="{00000000-0000-0000-0000-000000000000}"/>
          </ac:cxnSpMkLst>
        </pc:cxnChg>
        <pc:cxnChg chg="mod topLvl">
          <ac:chgData name="Warner,Jeffrey Barr" userId="7360d018-3b8a-4d6d-8136-e4d170e1e616" providerId="ADAL" clId="{E1317903-0E43-4FAC-A900-4D6121109CB5}" dt="2021-05-10T15:43:31.342" v="4888" actId="164"/>
          <ac:cxnSpMkLst>
            <pc:docMk/>
            <pc:sldMk cId="3797510600" sldId="339"/>
            <ac:cxnSpMk id="29" creationId="{00000000-0000-0000-0000-000000000000}"/>
          </ac:cxnSpMkLst>
        </pc:cxnChg>
        <pc:cxnChg chg="mod topLvl">
          <ac:chgData name="Warner,Jeffrey Barr" userId="7360d018-3b8a-4d6d-8136-e4d170e1e616" providerId="ADAL" clId="{E1317903-0E43-4FAC-A900-4D6121109CB5}" dt="2021-05-10T15:43:31.342" v="4888" actId="164"/>
          <ac:cxnSpMkLst>
            <pc:docMk/>
            <pc:sldMk cId="3797510600" sldId="339"/>
            <ac:cxnSpMk id="31" creationId="{00000000-0000-0000-0000-000000000000}"/>
          </ac:cxnSpMkLst>
        </pc:cxnChg>
        <pc:cxnChg chg="mod topLvl">
          <ac:chgData name="Warner,Jeffrey Barr" userId="7360d018-3b8a-4d6d-8136-e4d170e1e616" providerId="ADAL" clId="{E1317903-0E43-4FAC-A900-4D6121109CB5}" dt="2021-05-10T15:43:28.820" v="4886" actId="164"/>
          <ac:cxnSpMkLst>
            <pc:docMk/>
            <pc:sldMk cId="3797510600" sldId="339"/>
            <ac:cxnSpMk id="37" creationId="{159630D4-B2FF-4BFF-908D-F6935E6C0E10}"/>
          </ac:cxnSpMkLst>
        </pc:cxnChg>
        <pc:cxnChg chg="mod topLvl">
          <ac:chgData name="Warner,Jeffrey Barr" userId="7360d018-3b8a-4d6d-8136-e4d170e1e616" providerId="ADAL" clId="{E1317903-0E43-4FAC-A900-4D6121109CB5}" dt="2021-05-10T15:43:28.820" v="4886" actId="164"/>
          <ac:cxnSpMkLst>
            <pc:docMk/>
            <pc:sldMk cId="3797510600" sldId="339"/>
            <ac:cxnSpMk id="38" creationId="{F57E461B-A3DF-42CD-854B-4972D9B05B97}"/>
          </ac:cxnSpMkLst>
        </pc:cxnChg>
        <pc:cxnChg chg="mod topLvl">
          <ac:chgData name="Warner,Jeffrey Barr" userId="7360d018-3b8a-4d6d-8136-e4d170e1e616" providerId="ADAL" clId="{E1317903-0E43-4FAC-A900-4D6121109CB5}" dt="2021-05-10T15:43:28.820" v="4886" actId="164"/>
          <ac:cxnSpMkLst>
            <pc:docMk/>
            <pc:sldMk cId="3797510600" sldId="339"/>
            <ac:cxnSpMk id="40" creationId="{774CAD6D-78FF-41D6-9BE9-6BE99BBC6AD6}"/>
          </ac:cxnSpMkLst>
        </pc:cxnChg>
        <pc:cxnChg chg="mod topLvl">
          <ac:chgData name="Warner,Jeffrey Barr" userId="7360d018-3b8a-4d6d-8136-e4d170e1e616" providerId="ADAL" clId="{E1317903-0E43-4FAC-A900-4D6121109CB5}" dt="2021-05-10T15:43:28.820" v="4886" actId="164"/>
          <ac:cxnSpMkLst>
            <pc:docMk/>
            <pc:sldMk cId="3797510600" sldId="339"/>
            <ac:cxnSpMk id="41" creationId="{C8A731EA-5533-4989-89F0-39D30863C37D}"/>
          </ac:cxnSpMkLst>
        </pc:cxnChg>
        <pc:cxnChg chg="mod topLvl">
          <ac:chgData name="Warner,Jeffrey Barr" userId="7360d018-3b8a-4d6d-8136-e4d170e1e616" providerId="ADAL" clId="{E1317903-0E43-4FAC-A900-4D6121109CB5}" dt="2021-05-10T15:43:28.820" v="4886" actId="164"/>
          <ac:cxnSpMkLst>
            <pc:docMk/>
            <pc:sldMk cId="3797510600" sldId="339"/>
            <ac:cxnSpMk id="42" creationId="{F4AF57FC-6F92-4467-9895-5AB1A52F665D}"/>
          </ac:cxnSpMkLst>
        </pc:cxnChg>
        <pc:cxnChg chg="mod topLvl">
          <ac:chgData name="Warner,Jeffrey Barr" userId="7360d018-3b8a-4d6d-8136-e4d170e1e616" providerId="ADAL" clId="{E1317903-0E43-4FAC-A900-4D6121109CB5}" dt="2021-05-10T15:43:28.820" v="4886" actId="164"/>
          <ac:cxnSpMkLst>
            <pc:docMk/>
            <pc:sldMk cId="3797510600" sldId="339"/>
            <ac:cxnSpMk id="43" creationId="{AF16F8CA-CA6B-4630-B230-21195C365CE0}"/>
          </ac:cxnSpMkLst>
        </pc:cxnChg>
        <pc:cxnChg chg="add mod topLvl">
          <ac:chgData name="Warner,Jeffrey Barr" userId="7360d018-3b8a-4d6d-8136-e4d170e1e616" providerId="ADAL" clId="{E1317903-0E43-4FAC-A900-4D6121109CB5}" dt="2021-05-10T15:43:34.603" v="4890" actId="164"/>
          <ac:cxnSpMkLst>
            <pc:docMk/>
            <pc:sldMk cId="3797510600" sldId="339"/>
            <ac:cxnSpMk id="46" creationId="{9CF9CAEC-C43D-4945-B71F-332618BF03A0}"/>
          </ac:cxnSpMkLst>
        </pc:cxnChg>
        <pc:cxnChg chg="add mod topLvl">
          <ac:chgData name="Warner,Jeffrey Barr" userId="7360d018-3b8a-4d6d-8136-e4d170e1e616" providerId="ADAL" clId="{E1317903-0E43-4FAC-A900-4D6121109CB5}" dt="2021-05-10T15:43:34.603" v="4890" actId="164"/>
          <ac:cxnSpMkLst>
            <pc:docMk/>
            <pc:sldMk cId="3797510600" sldId="339"/>
            <ac:cxnSpMk id="47" creationId="{1DF92CFA-0758-40C0-BA3B-A2F080378986}"/>
          </ac:cxnSpMkLst>
        </pc:cxnChg>
        <pc:cxnChg chg="add mod">
          <ac:chgData name="Warner,Jeffrey Barr" userId="7360d018-3b8a-4d6d-8136-e4d170e1e616" providerId="ADAL" clId="{E1317903-0E43-4FAC-A900-4D6121109CB5}" dt="2021-05-10T15:43:46.723" v="4892" actId="1035"/>
          <ac:cxnSpMkLst>
            <pc:docMk/>
            <pc:sldMk cId="3797510600" sldId="339"/>
            <ac:cxnSpMk id="48" creationId="{EEF75BF7-872E-4D7F-BAF0-5D8CA8C3B6FC}"/>
          </ac:cxnSpMkLst>
        </pc:cxnChg>
        <pc:cxnChg chg="add mod">
          <ac:chgData name="Warner,Jeffrey Barr" userId="7360d018-3b8a-4d6d-8136-e4d170e1e616" providerId="ADAL" clId="{E1317903-0E43-4FAC-A900-4D6121109CB5}" dt="2021-05-10T15:43:28.820" v="4886" actId="164"/>
          <ac:cxnSpMkLst>
            <pc:docMk/>
            <pc:sldMk cId="3797510600" sldId="339"/>
            <ac:cxnSpMk id="49" creationId="{18929DA9-A742-4132-A66E-78DF6B1A23C4}"/>
          </ac:cxnSpMkLst>
        </pc:cxnChg>
        <pc:cxnChg chg="add mod">
          <ac:chgData name="Warner,Jeffrey Barr" userId="7360d018-3b8a-4d6d-8136-e4d170e1e616" providerId="ADAL" clId="{E1317903-0E43-4FAC-A900-4D6121109CB5}" dt="2021-05-10T15:52:44.186" v="4896" actId="1035"/>
          <ac:cxnSpMkLst>
            <pc:docMk/>
            <pc:sldMk cId="3797510600" sldId="339"/>
            <ac:cxnSpMk id="53" creationId="{0B039635-650C-4D0F-9FB0-7DBAB6195E01}"/>
          </ac:cxnSpMkLst>
        </pc:cxnChg>
        <pc:cxnChg chg="add mod">
          <ac:chgData name="Warner,Jeffrey Barr" userId="7360d018-3b8a-4d6d-8136-e4d170e1e616" providerId="ADAL" clId="{E1317903-0E43-4FAC-A900-4D6121109CB5}" dt="2021-05-10T15:43:28.820" v="4886" actId="164"/>
          <ac:cxnSpMkLst>
            <pc:docMk/>
            <pc:sldMk cId="3797510600" sldId="339"/>
            <ac:cxnSpMk id="58" creationId="{D59FB68F-2500-46AE-B47B-70026296F56D}"/>
          </ac:cxnSpMkLst>
        </pc:cxnChg>
      </pc:sldChg>
      <pc:sldChg chg="addSp delSp modSp mod delCm modNotesTx">
        <pc:chgData name="Warner,Jeffrey Barr" userId="7360d018-3b8a-4d6d-8136-e4d170e1e616" providerId="ADAL" clId="{E1317903-0E43-4FAC-A900-4D6121109CB5}" dt="2021-05-20T17:01:51.271" v="8132" actId="20577"/>
        <pc:sldMkLst>
          <pc:docMk/>
          <pc:sldMk cId="2788620995" sldId="356"/>
        </pc:sldMkLst>
        <pc:spChg chg="mod topLvl">
          <ac:chgData name="Warner,Jeffrey Barr" userId="7360d018-3b8a-4d6d-8136-e4d170e1e616" providerId="ADAL" clId="{E1317903-0E43-4FAC-A900-4D6121109CB5}" dt="2021-05-19T16:08:24.246" v="7562" actId="165"/>
          <ac:spMkLst>
            <pc:docMk/>
            <pc:sldMk cId="2788620995" sldId="356"/>
            <ac:spMk id="2" creationId="{A4FFFDC7-F928-4ACA-BC57-5AA588B55A23}"/>
          </ac:spMkLst>
        </pc:spChg>
        <pc:spChg chg="add mod">
          <ac:chgData name="Warner,Jeffrey Barr" userId="7360d018-3b8a-4d6d-8136-e4d170e1e616" providerId="ADAL" clId="{E1317903-0E43-4FAC-A900-4D6121109CB5}" dt="2021-05-10T16:14:32.822" v="5200" actId="164"/>
          <ac:spMkLst>
            <pc:docMk/>
            <pc:sldMk cId="2788620995" sldId="356"/>
            <ac:spMk id="12" creationId="{B9270687-B324-42A3-88B7-F4D913E8324C}"/>
          </ac:spMkLst>
        </pc:spChg>
        <pc:spChg chg="mod topLvl">
          <ac:chgData name="Warner,Jeffrey Barr" userId="7360d018-3b8a-4d6d-8136-e4d170e1e616" providerId="ADAL" clId="{E1317903-0E43-4FAC-A900-4D6121109CB5}" dt="2021-05-19T16:11:48.980" v="7892" actId="164"/>
          <ac:spMkLst>
            <pc:docMk/>
            <pc:sldMk cId="2788620995" sldId="356"/>
            <ac:spMk id="20" creationId="{46D8F1B1-4947-6B4A-843C-BFEDBD0820D1}"/>
          </ac:spMkLst>
        </pc:spChg>
        <pc:spChg chg="mod">
          <ac:chgData name="Warner,Jeffrey Barr" userId="7360d018-3b8a-4d6d-8136-e4d170e1e616" providerId="ADAL" clId="{E1317903-0E43-4FAC-A900-4D6121109CB5}" dt="2021-05-10T16:23:44.598" v="5602" actId="164"/>
          <ac:spMkLst>
            <pc:docMk/>
            <pc:sldMk cId="2788620995" sldId="356"/>
            <ac:spMk id="21" creationId="{09E8C363-39BE-4AB2-8754-0F4356228855}"/>
          </ac:spMkLst>
        </pc:spChg>
        <pc:spChg chg="mod">
          <ac:chgData name="Warner,Jeffrey Barr" userId="7360d018-3b8a-4d6d-8136-e4d170e1e616" providerId="ADAL" clId="{E1317903-0E43-4FAC-A900-4D6121109CB5}" dt="2021-05-10T16:23:50.446" v="5630" actId="1037"/>
          <ac:spMkLst>
            <pc:docMk/>
            <pc:sldMk cId="2788620995" sldId="356"/>
            <ac:spMk id="22" creationId="{D5A1509D-632A-4C06-916E-53ED0AA287F9}"/>
          </ac:spMkLst>
        </pc:spChg>
        <pc:spChg chg="mod topLvl">
          <ac:chgData name="Warner,Jeffrey Barr" userId="7360d018-3b8a-4d6d-8136-e4d170e1e616" providerId="ADAL" clId="{E1317903-0E43-4FAC-A900-4D6121109CB5}" dt="2021-05-19T16:08:24.246" v="7562" actId="165"/>
          <ac:spMkLst>
            <pc:docMk/>
            <pc:sldMk cId="2788620995" sldId="356"/>
            <ac:spMk id="24" creationId="{70BE6337-1186-6C47-9EFB-60B64ED0F2F2}"/>
          </ac:spMkLst>
        </pc:spChg>
        <pc:spChg chg="mod topLvl">
          <ac:chgData name="Warner,Jeffrey Barr" userId="7360d018-3b8a-4d6d-8136-e4d170e1e616" providerId="ADAL" clId="{E1317903-0E43-4FAC-A900-4D6121109CB5}" dt="2021-05-19T16:08:24.246" v="7562" actId="165"/>
          <ac:spMkLst>
            <pc:docMk/>
            <pc:sldMk cId="2788620995" sldId="356"/>
            <ac:spMk id="25" creationId="{1298824D-B7C9-F64D-B8AA-9D387CB12FA7}"/>
          </ac:spMkLst>
        </pc:spChg>
        <pc:spChg chg="del mod">
          <ac:chgData name="Warner,Jeffrey Barr" userId="7360d018-3b8a-4d6d-8136-e4d170e1e616" providerId="ADAL" clId="{E1317903-0E43-4FAC-A900-4D6121109CB5}" dt="2021-05-20T16:57:10.371" v="8027" actId="478"/>
          <ac:spMkLst>
            <pc:docMk/>
            <pc:sldMk cId="2788620995" sldId="356"/>
            <ac:spMk id="26" creationId="{DF4E3E5D-9EC3-4AE5-A5EF-597F02C742E5}"/>
          </ac:spMkLst>
        </pc:spChg>
        <pc:spChg chg="mod">
          <ac:chgData name="Warner,Jeffrey Barr" userId="7360d018-3b8a-4d6d-8136-e4d170e1e616" providerId="ADAL" clId="{E1317903-0E43-4FAC-A900-4D6121109CB5}" dt="2021-05-10T16:23:12.690" v="5594" actId="165"/>
          <ac:spMkLst>
            <pc:docMk/>
            <pc:sldMk cId="2788620995" sldId="356"/>
            <ac:spMk id="40" creationId="{79E07317-065B-E34D-9379-B56338B084AD}"/>
          </ac:spMkLst>
        </pc:spChg>
        <pc:spChg chg="mod">
          <ac:chgData name="Warner,Jeffrey Barr" userId="7360d018-3b8a-4d6d-8136-e4d170e1e616" providerId="ADAL" clId="{E1317903-0E43-4FAC-A900-4D6121109CB5}" dt="2021-05-10T16:23:12.690" v="5594" actId="165"/>
          <ac:spMkLst>
            <pc:docMk/>
            <pc:sldMk cId="2788620995" sldId="356"/>
            <ac:spMk id="42" creationId="{C9E207BA-6A6F-5446-A1A9-04DB3CE2B260}"/>
          </ac:spMkLst>
        </pc:spChg>
        <pc:spChg chg="mod">
          <ac:chgData name="Warner,Jeffrey Barr" userId="7360d018-3b8a-4d6d-8136-e4d170e1e616" providerId="ADAL" clId="{E1317903-0E43-4FAC-A900-4D6121109CB5}" dt="2021-05-10T16:23:12.690" v="5594" actId="165"/>
          <ac:spMkLst>
            <pc:docMk/>
            <pc:sldMk cId="2788620995" sldId="356"/>
            <ac:spMk id="43" creationId="{F959E105-AD77-6847-B2DC-8836AC4DFCC4}"/>
          </ac:spMkLst>
        </pc:spChg>
        <pc:spChg chg="mod">
          <ac:chgData name="Warner,Jeffrey Barr" userId="7360d018-3b8a-4d6d-8136-e4d170e1e616" providerId="ADAL" clId="{E1317903-0E43-4FAC-A900-4D6121109CB5}" dt="2021-05-10T16:23:12.690" v="5594" actId="165"/>
          <ac:spMkLst>
            <pc:docMk/>
            <pc:sldMk cId="2788620995" sldId="356"/>
            <ac:spMk id="44" creationId="{A1C055AD-8205-414D-950C-6AD476A2E39B}"/>
          </ac:spMkLst>
        </pc:spChg>
        <pc:spChg chg="mod topLvl">
          <ac:chgData name="Warner,Jeffrey Barr" userId="7360d018-3b8a-4d6d-8136-e4d170e1e616" providerId="ADAL" clId="{E1317903-0E43-4FAC-A900-4D6121109CB5}" dt="2021-05-10T16:23:53.113" v="5631" actId="164"/>
          <ac:spMkLst>
            <pc:docMk/>
            <pc:sldMk cId="2788620995" sldId="356"/>
            <ac:spMk id="45" creationId="{8F0E005B-BC21-B14D-991E-0080BEBAE7C9}"/>
          </ac:spMkLst>
        </pc:spChg>
        <pc:spChg chg="mod">
          <ac:chgData name="Warner,Jeffrey Barr" userId="7360d018-3b8a-4d6d-8136-e4d170e1e616" providerId="ADAL" clId="{E1317903-0E43-4FAC-A900-4D6121109CB5}" dt="2021-05-10T15:53:18.854" v="4898" actId="571"/>
          <ac:spMkLst>
            <pc:docMk/>
            <pc:sldMk cId="2788620995" sldId="356"/>
            <ac:spMk id="52" creationId="{E5E123DB-1729-409A-8FA5-7079AC06D2EB}"/>
          </ac:spMkLst>
        </pc:spChg>
        <pc:spChg chg="mod">
          <ac:chgData name="Warner,Jeffrey Barr" userId="7360d018-3b8a-4d6d-8136-e4d170e1e616" providerId="ADAL" clId="{E1317903-0E43-4FAC-A900-4D6121109CB5}" dt="2021-05-10T15:53:18.854" v="4898" actId="571"/>
          <ac:spMkLst>
            <pc:docMk/>
            <pc:sldMk cId="2788620995" sldId="356"/>
            <ac:spMk id="53" creationId="{1949A692-B888-43FD-824B-C1008CF0F62F}"/>
          </ac:spMkLst>
        </pc:spChg>
        <pc:spChg chg="mod">
          <ac:chgData name="Warner,Jeffrey Barr" userId="7360d018-3b8a-4d6d-8136-e4d170e1e616" providerId="ADAL" clId="{E1317903-0E43-4FAC-A900-4D6121109CB5}" dt="2021-05-10T15:53:18.854" v="4898" actId="571"/>
          <ac:spMkLst>
            <pc:docMk/>
            <pc:sldMk cId="2788620995" sldId="356"/>
            <ac:spMk id="54" creationId="{49B35A09-B465-45F4-AE61-D3AA839DBA7C}"/>
          </ac:spMkLst>
        </pc:spChg>
        <pc:spChg chg="mod">
          <ac:chgData name="Warner,Jeffrey Barr" userId="7360d018-3b8a-4d6d-8136-e4d170e1e616" providerId="ADAL" clId="{E1317903-0E43-4FAC-A900-4D6121109CB5}" dt="2021-05-10T15:53:18.854" v="4898" actId="571"/>
          <ac:spMkLst>
            <pc:docMk/>
            <pc:sldMk cId="2788620995" sldId="356"/>
            <ac:spMk id="55" creationId="{D941F2DC-20F6-4BAA-B72B-7A64D4F5DBE2}"/>
          </ac:spMkLst>
        </pc:spChg>
        <pc:spChg chg="mod">
          <ac:chgData name="Warner,Jeffrey Barr" userId="7360d018-3b8a-4d6d-8136-e4d170e1e616" providerId="ADAL" clId="{E1317903-0E43-4FAC-A900-4D6121109CB5}" dt="2021-05-10T15:53:18.854" v="4898" actId="571"/>
          <ac:spMkLst>
            <pc:docMk/>
            <pc:sldMk cId="2788620995" sldId="356"/>
            <ac:spMk id="56" creationId="{A62BBECE-53EA-490C-BE6E-5D29361CF40C}"/>
          </ac:spMkLst>
        </pc:spChg>
        <pc:spChg chg="mod">
          <ac:chgData name="Warner,Jeffrey Barr" userId="7360d018-3b8a-4d6d-8136-e4d170e1e616" providerId="ADAL" clId="{E1317903-0E43-4FAC-A900-4D6121109CB5}" dt="2021-05-10T15:53:18.854" v="4898" actId="571"/>
          <ac:spMkLst>
            <pc:docMk/>
            <pc:sldMk cId="2788620995" sldId="356"/>
            <ac:spMk id="57" creationId="{36DE2BFF-6C64-4694-89E1-D3EB496A7D39}"/>
          </ac:spMkLst>
        </pc:spChg>
        <pc:spChg chg="mod">
          <ac:chgData name="Warner,Jeffrey Barr" userId="7360d018-3b8a-4d6d-8136-e4d170e1e616" providerId="ADAL" clId="{E1317903-0E43-4FAC-A900-4D6121109CB5}" dt="2021-05-10T15:53:18.854" v="4898" actId="571"/>
          <ac:spMkLst>
            <pc:docMk/>
            <pc:sldMk cId="2788620995" sldId="356"/>
            <ac:spMk id="58" creationId="{8A9FAFA1-86DC-433A-A3CC-1D1A6A8BE247}"/>
          </ac:spMkLst>
        </pc:spChg>
        <pc:spChg chg="mod">
          <ac:chgData name="Warner,Jeffrey Barr" userId="7360d018-3b8a-4d6d-8136-e4d170e1e616" providerId="ADAL" clId="{E1317903-0E43-4FAC-A900-4D6121109CB5}" dt="2021-05-10T15:53:18.854" v="4898" actId="571"/>
          <ac:spMkLst>
            <pc:docMk/>
            <pc:sldMk cId="2788620995" sldId="356"/>
            <ac:spMk id="59" creationId="{432A5D65-0E0C-4577-95EB-6C3E16F55D63}"/>
          </ac:spMkLst>
        </pc:spChg>
        <pc:spChg chg="mod">
          <ac:chgData name="Warner,Jeffrey Barr" userId="7360d018-3b8a-4d6d-8136-e4d170e1e616" providerId="ADAL" clId="{E1317903-0E43-4FAC-A900-4D6121109CB5}" dt="2021-05-10T15:53:18.854" v="4898" actId="571"/>
          <ac:spMkLst>
            <pc:docMk/>
            <pc:sldMk cId="2788620995" sldId="356"/>
            <ac:spMk id="60" creationId="{6479444F-A668-4B68-B2E3-760EDD7850BE}"/>
          </ac:spMkLst>
        </pc:spChg>
        <pc:spChg chg="mod">
          <ac:chgData name="Warner,Jeffrey Barr" userId="7360d018-3b8a-4d6d-8136-e4d170e1e616" providerId="ADAL" clId="{E1317903-0E43-4FAC-A900-4D6121109CB5}" dt="2021-05-10T15:53:18.854" v="4898" actId="571"/>
          <ac:spMkLst>
            <pc:docMk/>
            <pc:sldMk cId="2788620995" sldId="356"/>
            <ac:spMk id="61" creationId="{17B3EECE-00F2-4343-899A-E8F3D75F598C}"/>
          </ac:spMkLst>
        </pc:spChg>
        <pc:spChg chg="mod">
          <ac:chgData name="Warner,Jeffrey Barr" userId="7360d018-3b8a-4d6d-8136-e4d170e1e616" providerId="ADAL" clId="{E1317903-0E43-4FAC-A900-4D6121109CB5}" dt="2021-05-10T15:53:18.854" v="4898" actId="571"/>
          <ac:spMkLst>
            <pc:docMk/>
            <pc:sldMk cId="2788620995" sldId="356"/>
            <ac:spMk id="62" creationId="{B1BE90A8-0EA7-4B5E-9358-295B98ED4DB7}"/>
          </ac:spMkLst>
        </pc:spChg>
        <pc:spChg chg="mod">
          <ac:chgData name="Warner,Jeffrey Barr" userId="7360d018-3b8a-4d6d-8136-e4d170e1e616" providerId="ADAL" clId="{E1317903-0E43-4FAC-A900-4D6121109CB5}" dt="2021-05-10T15:53:18.854" v="4898" actId="571"/>
          <ac:spMkLst>
            <pc:docMk/>
            <pc:sldMk cId="2788620995" sldId="356"/>
            <ac:spMk id="63" creationId="{6B21BBB6-D8DA-4EFA-B192-E72300DD8EE0}"/>
          </ac:spMkLst>
        </pc:spChg>
        <pc:spChg chg="mod">
          <ac:chgData name="Warner,Jeffrey Barr" userId="7360d018-3b8a-4d6d-8136-e4d170e1e616" providerId="ADAL" clId="{E1317903-0E43-4FAC-A900-4D6121109CB5}" dt="2021-05-10T15:53:18.854" v="4898" actId="571"/>
          <ac:spMkLst>
            <pc:docMk/>
            <pc:sldMk cId="2788620995" sldId="356"/>
            <ac:spMk id="64" creationId="{73D16645-3A73-4038-A241-0B01881E51D9}"/>
          </ac:spMkLst>
        </pc:spChg>
        <pc:spChg chg="mod">
          <ac:chgData name="Warner,Jeffrey Barr" userId="7360d018-3b8a-4d6d-8136-e4d170e1e616" providerId="ADAL" clId="{E1317903-0E43-4FAC-A900-4D6121109CB5}" dt="2021-05-10T15:53:18.854" v="4898" actId="571"/>
          <ac:spMkLst>
            <pc:docMk/>
            <pc:sldMk cId="2788620995" sldId="356"/>
            <ac:spMk id="65" creationId="{50C2F8EF-4322-403D-BF98-C3E29980F876}"/>
          </ac:spMkLst>
        </pc:spChg>
        <pc:spChg chg="mod">
          <ac:chgData name="Warner,Jeffrey Barr" userId="7360d018-3b8a-4d6d-8136-e4d170e1e616" providerId="ADAL" clId="{E1317903-0E43-4FAC-A900-4D6121109CB5}" dt="2021-05-10T15:53:18.854" v="4898" actId="571"/>
          <ac:spMkLst>
            <pc:docMk/>
            <pc:sldMk cId="2788620995" sldId="356"/>
            <ac:spMk id="66" creationId="{80EF6BBA-1A5E-450B-8236-62D8A8C640E0}"/>
          </ac:spMkLst>
        </pc:spChg>
        <pc:spChg chg="mod">
          <ac:chgData name="Warner,Jeffrey Barr" userId="7360d018-3b8a-4d6d-8136-e4d170e1e616" providerId="ADAL" clId="{E1317903-0E43-4FAC-A900-4D6121109CB5}" dt="2021-05-10T15:53:18.854" v="4898" actId="571"/>
          <ac:spMkLst>
            <pc:docMk/>
            <pc:sldMk cId="2788620995" sldId="356"/>
            <ac:spMk id="67" creationId="{F11F542D-8C8C-4B03-87AD-7A2F29348AB0}"/>
          </ac:spMkLst>
        </pc:spChg>
        <pc:spChg chg="mod">
          <ac:chgData name="Warner,Jeffrey Barr" userId="7360d018-3b8a-4d6d-8136-e4d170e1e616" providerId="ADAL" clId="{E1317903-0E43-4FAC-A900-4D6121109CB5}" dt="2021-05-10T15:53:18.854" v="4898" actId="571"/>
          <ac:spMkLst>
            <pc:docMk/>
            <pc:sldMk cId="2788620995" sldId="356"/>
            <ac:spMk id="68" creationId="{F807B936-B674-467E-8022-90C5C2C6DB34}"/>
          </ac:spMkLst>
        </pc:spChg>
        <pc:spChg chg="mod">
          <ac:chgData name="Warner,Jeffrey Barr" userId="7360d018-3b8a-4d6d-8136-e4d170e1e616" providerId="ADAL" clId="{E1317903-0E43-4FAC-A900-4D6121109CB5}" dt="2021-05-10T15:53:18.854" v="4898" actId="571"/>
          <ac:spMkLst>
            <pc:docMk/>
            <pc:sldMk cId="2788620995" sldId="356"/>
            <ac:spMk id="69" creationId="{A79F84D2-CC2C-4819-9DD0-7EBF3A8E291F}"/>
          </ac:spMkLst>
        </pc:spChg>
        <pc:spChg chg="mod">
          <ac:chgData name="Warner,Jeffrey Barr" userId="7360d018-3b8a-4d6d-8136-e4d170e1e616" providerId="ADAL" clId="{E1317903-0E43-4FAC-A900-4D6121109CB5}" dt="2021-05-10T15:53:18.854" v="4898" actId="571"/>
          <ac:spMkLst>
            <pc:docMk/>
            <pc:sldMk cId="2788620995" sldId="356"/>
            <ac:spMk id="70" creationId="{3B626086-0470-434E-9CC5-7A5810636ADA}"/>
          </ac:spMkLst>
        </pc:spChg>
        <pc:spChg chg="mod">
          <ac:chgData name="Warner,Jeffrey Barr" userId="7360d018-3b8a-4d6d-8136-e4d170e1e616" providerId="ADAL" clId="{E1317903-0E43-4FAC-A900-4D6121109CB5}" dt="2021-05-10T15:53:18.854" v="4898" actId="571"/>
          <ac:spMkLst>
            <pc:docMk/>
            <pc:sldMk cId="2788620995" sldId="356"/>
            <ac:spMk id="71" creationId="{CF59F8CD-10AD-40D8-9099-0E5E85FB6997}"/>
          </ac:spMkLst>
        </pc:spChg>
        <pc:spChg chg="mod">
          <ac:chgData name="Warner,Jeffrey Barr" userId="7360d018-3b8a-4d6d-8136-e4d170e1e616" providerId="ADAL" clId="{E1317903-0E43-4FAC-A900-4D6121109CB5}" dt="2021-05-10T15:53:18.854" v="4898" actId="571"/>
          <ac:spMkLst>
            <pc:docMk/>
            <pc:sldMk cId="2788620995" sldId="356"/>
            <ac:spMk id="73" creationId="{BBE6EE05-937F-474B-BEEE-4985A0B37ABE}"/>
          </ac:spMkLst>
        </pc:spChg>
        <pc:spChg chg="mod">
          <ac:chgData name="Warner,Jeffrey Barr" userId="7360d018-3b8a-4d6d-8136-e4d170e1e616" providerId="ADAL" clId="{E1317903-0E43-4FAC-A900-4D6121109CB5}" dt="2021-05-10T15:53:18.854" v="4898" actId="571"/>
          <ac:spMkLst>
            <pc:docMk/>
            <pc:sldMk cId="2788620995" sldId="356"/>
            <ac:spMk id="74" creationId="{D9B369F1-99FC-4A56-BC00-077EFFCD2DA4}"/>
          </ac:spMkLst>
        </pc:spChg>
        <pc:spChg chg="mod">
          <ac:chgData name="Warner,Jeffrey Barr" userId="7360d018-3b8a-4d6d-8136-e4d170e1e616" providerId="ADAL" clId="{E1317903-0E43-4FAC-A900-4D6121109CB5}" dt="2021-05-10T15:53:18.854" v="4898" actId="571"/>
          <ac:spMkLst>
            <pc:docMk/>
            <pc:sldMk cId="2788620995" sldId="356"/>
            <ac:spMk id="75" creationId="{13439079-CA65-4DB0-B817-2DE6E5629287}"/>
          </ac:spMkLst>
        </pc:spChg>
        <pc:spChg chg="mod">
          <ac:chgData name="Warner,Jeffrey Barr" userId="7360d018-3b8a-4d6d-8136-e4d170e1e616" providerId="ADAL" clId="{E1317903-0E43-4FAC-A900-4D6121109CB5}" dt="2021-04-22T16:44:24.170" v="900" actId="20577"/>
          <ac:spMkLst>
            <pc:docMk/>
            <pc:sldMk cId="2788620995" sldId="356"/>
            <ac:spMk id="93" creationId="{71459341-A513-4EB8-8790-15DBD0FFFEE8}"/>
          </ac:spMkLst>
        </pc:spChg>
        <pc:spChg chg="mod">
          <ac:chgData name="Warner,Jeffrey Barr" userId="7360d018-3b8a-4d6d-8136-e4d170e1e616" providerId="ADAL" clId="{E1317903-0E43-4FAC-A900-4D6121109CB5}" dt="2021-04-22T16:47:21.604" v="1045" actId="20577"/>
          <ac:spMkLst>
            <pc:docMk/>
            <pc:sldMk cId="2788620995" sldId="356"/>
            <ac:spMk id="117" creationId="{BB1461BB-5DF5-403B-8CC6-DC6115F740A9}"/>
          </ac:spMkLst>
        </pc:spChg>
        <pc:spChg chg="add mod">
          <ac:chgData name="Warner,Jeffrey Barr" userId="7360d018-3b8a-4d6d-8136-e4d170e1e616" providerId="ADAL" clId="{E1317903-0E43-4FAC-A900-4D6121109CB5}" dt="2021-05-10T15:53:18.854" v="4898" actId="571"/>
          <ac:spMkLst>
            <pc:docMk/>
            <pc:sldMk cId="2788620995" sldId="356"/>
            <ac:spMk id="152" creationId="{DF010BA8-7672-4159-9E61-8FB056651DA2}"/>
          </ac:spMkLst>
        </pc:spChg>
        <pc:spChg chg="add mod">
          <ac:chgData name="Warner,Jeffrey Barr" userId="7360d018-3b8a-4d6d-8136-e4d170e1e616" providerId="ADAL" clId="{E1317903-0E43-4FAC-A900-4D6121109CB5}" dt="2021-05-10T16:15:05.049" v="5204" actId="313"/>
          <ac:spMkLst>
            <pc:docMk/>
            <pc:sldMk cId="2788620995" sldId="356"/>
            <ac:spMk id="155" creationId="{177AA70D-A9E9-46E2-8767-59C5D2B218FC}"/>
          </ac:spMkLst>
        </pc:spChg>
        <pc:spChg chg="add mod">
          <ac:chgData name="Warner,Jeffrey Barr" userId="7360d018-3b8a-4d6d-8136-e4d170e1e616" providerId="ADAL" clId="{E1317903-0E43-4FAC-A900-4D6121109CB5}" dt="2021-05-10T16:14:32.822" v="5200" actId="164"/>
          <ac:spMkLst>
            <pc:docMk/>
            <pc:sldMk cId="2788620995" sldId="356"/>
            <ac:spMk id="156" creationId="{732308B7-1E4E-44FF-ACE6-346CF51E13DD}"/>
          </ac:spMkLst>
        </pc:spChg>
        <pc:spChg chg="add mod">
          <ac:chgData name="Warner,Jeffrey Barr" userId="7360d018-3b8a-4d6d-8136-e4d170e1e616" providerId="ADAL" clId="{E1317903-0E43-4FAC-A900-4D6121109CB5}" dt="2021-05-10T16:14:32.822" v="5200" actId="164"/>
          <ac:spMkLst>
            <pc:docMk/>
            <pc:sldMk cId="2788620995" sldId="356"/>
            <ac:spMk id="157" creationId="{A8FCB0AF-1BD3-4FC1-91AD-FBD8475CABAA}"/>
          </ac:spMkLst>
        </pc:spChg>
        <pc:spChg chg="add mod">
          <ac:chgData name="Warner,Jeffrey Barr" userId="7360d018-3b8a-4d6d-8136-e4d170e1e616" providerId="ADAL" clId="{E1317903-0E43-4FAC-A900-4D6121109CB5}" dt="2021-05-10T16:14:32.822" v="5200" actId="164"/>
          <ac:spMkLst>
            <pc:docMk/>
            <pc:sldMk cId="2788620995" sldId="356"/>
            <ac:spMk id="158" creationId="{C3B76FA7-EC95-4D48-8E62-C09C1243E3E0}"/>
          </ac:spMkLst>
        </pc:spChg>
        <pc:spChg chg="add mod">
          <ac:chgData name="Warner,Jeffrey Barr" userId="7360d018-3b8a-4d6d-8136-e4d170e1e616" providerId="ADAL" clId="{E1317903-0E43-4FAC-A900-4D6121109CB5}" dt="2021-05-10T16:14:32.822" v="5200" actId="164"/>
          <ac:spMkLst>
            <pc:docMk/>
            <pc:sldMk cId="2788620995" sldId="356"/>
            <ac:spMk id="159" creationId="{6E4AD7B1-CA20-445D-BC5D-05DB9F2E5E7C}"/>
          </ac:spMkLst>
        </pc:spChg>
        <pc:spChg chg="add mod">
          <ac:chgData name="Warner,Jeffrey Barr" userId="7360d018-3b8a-4d6d-8136-e4d170e1e616" providerId="ADAL" clId="{E1317903-0E43-4FAC-A900-4D6121109CB5}" dt="2021-05-10T16:14:32.822" v="5200" actId="164"/>
          <ac:spMkLst>
            <pc:docMk/>
            <pc:sldMk cId="2788620995" sldId="356"/>
            <ac:spMk id="160" creationId="{69384358-B78C-4E09-9FF1-AE07753CAD72}"/>
          </ac:spMkLst>
        </pc:spChg>
        <pc:spChg chg="add mod">
          <ac:chgData name="Warner,Jeffrey Barr" userId="7360d018-3b8a-4d6d-8136-e4d170e1e616" providerId="ADAL" clId="{E1317903-0E43-4FAC-A900-4D6121109CB5}" dt="2021-05-10T16:14:32.822" v="5200" actId="164"/>
          <ac:spMkLst>
            <pc:docMk/>
            <pc:sldMk cId="2788620995" sldId="356"/>
            <ac:spMk id="161" creationId="{E786B3F1-D2FC-4D43-AA31-A678C0D66E4D}"/>
          </ac:spMkLst>
        </pc:spChg>
        <pc:spChg chg="add mod">
          <ac:chgData name="Warner,Jeffrey Barr" userId="7360d018-3b8a-4d6d-8136-e4d170e1e616" providerId="ADAL" clId="{E1317903-0E43-4FAC-A900-4D6121109CB5}" dt="2021-05-10T16:14:32.822" v="5200" actId="164"/>
          <ac:spMkLst>
            <pc:docMk/>
            <pc:sldMk cId="2788620995" sldId="356"/>
            <ac:spMk id="162" creationId="{35DFBC76-6914-4ABF-A75A-FB9E387BEEA9}"/>
          </ac:spMkLst>
        </pc:spChg>
        <pc:spChg chg="add mod">
          <ac:chgData name="Warner,Jeffrey Barr" userId="7360d018-3b8a-4d6d-8136-e4d170e1e616" providerId="ADAL" clId="{E1317903-0E43-4FAC-A900-4D6121109CB5}" dt="2021-05-10T16:14:32.822" v="5200" actId="164"/>
          <ac:spMkLst>
            <pc:docMk/>
            <pc:sldMk cId="2788620995" sldId="356"/>
            <ac:spMk id="163" creationId="{D7A6BA0D-D8A8-4135-AFF2-97FF51F3B02C}"/>
          </ac:spMkLst>
        </pc:spChg>
        <pc:spChg chg="add mod">
          <ac:chgData name="Warner,Jeffrey Barr" userId="7360d018-3b8a-4d6d-8136-e4d170e1e616" providerId="ADAL" clId="{E1317903-0E43-4FAC-A900-4D6121109CB5}" dt="2021-05-10T16:14:32.822" v="5200" actId="164"/>
          <ac:spMkLst>
            <pc:docMk/>
            <pc:sldMk cId="2788620995" sldId="356"/>
            <ac:spMk id="164" creationId="{A4A4170C-D2E3-4ED1-8F1E-5B38677DABBD}"/>
          </ac:spMkLst>
        </pc:spChg>
        <pc:spChg chg="add mod">
          <ac:chgData name="Warner,Jeffrey Barr" userId="7360d018-3b8a-4d6d-8136-e4d170e1e616" providerId="ADAL" clId="{E1317903-0E43-4FAC-A900-4D6121109CB5}" dt="2021-05-10T16:14:32.822" v="5200" actId="164"/>
          <ac:spMkLst>
            <pc:docMk/>
            <pc:sldMk cId="2788620995" sldId="356"/>
            <ac:spMk id="165" creationId="{20C322B9-0BA7-4AF4-9ABE-4B8BF03C90CF}"/>
          </ac:spMkLst>
        </pc:spChg>
        <pc:spChg chg="mod topLvl">
          <ac:chgData name="Warner,Jeffrey Barr" userId="7360d018-3b8a-4d6d-8136-e4d170e1e616" providerId="ADAL" clId="{E1317903-0E43-4FAC-A900-4D6121109CB5}" dt="2021-05-10T16:24:28.087" v="5663" actId="404"/>
          <ac:spMkLst>
            <pc:docMk/>
            <pc:sldMk cId="2788620995" sldId="356"/>
            <ac:spMk id="167" creationId="{0C22F3BB-4F1A-4153-A104-71E6E3E31BD3}"/>
          </ac:spMkLst>
        </pc:spChg>
        <pc:spChg chg="mod topLvl">
          <ac:chgData name="Warner,Jeffrey Barr" userId="7360d018-3b8a-4d6d-8136-e4d170e1e616" providerId="ADAL" clId="{E1317903-0E43-4FAC-A900-4D6121109CB5}" dt="2021-05-10T16:23:05.560" v="5591" actId="164"/>
          <ac:spMkLst>
            <pc:docMk/>
            <pc:sldMk cId="2788620995" sldId="356"/>
            <ac:spMk id="168" creationId="{9118CE32-5E91-4617-8E43-1DFF7798D71F}"/>
          </ac:spMkLst>
        </pc:spChg>
        <pc:spChg chg="mod topLvl">
          <ac:chgData name="Warner,Jeffrey Barr" userId="7360d018-3b8a-4d6d-8136-e4d170e1e616" providerId="ADAL" clId="{E1317903-0E43-4FAC-A900-4D6121109CB5}" dt="2021-05-10T16:23:05.560" v="5591" actId="164"/>
          <ac:spMkLst>
            <pc:docMk/>
            <pc:sldMk cId="2788620995" sldId="356"/>
            <ac:spMk id="169" creationId="{06394330-8621-41FC-A4B0-1E38846C4067}"/>
          </ac:spMkLst>
        </pc:spChg>
        <pc:spChg chg="mod topLvl">
          <ac:chgData name="Warner,Jeffrey Barr" userId="7360d018-3b8a-4d6d-8136-e4d170e1e616" providerId="ADAL" clId="{E1317903-0E43-4FAC-A900-4D6121109CB5}" dt="2021-05-10T16:23:05.560" v="5591" actId="164"/>
          <ac:spMkLst>
            <pc:docMk/>
            <pc:sldMk cId="2788620995" sldId="356"/>
            <ac:spMk id="170" creationId="{C256A15C-38A5-4866-958C-D08401E98841}"/>
          </ac:spMkLst>
        </pc:spChg>
        <pc:spChg chg="mod topLvl">
          <ac:chgData name="Warner,Jeffrey Barr" userId="7360d018-3b8a-4d6d-8136-e4d170e1e616" providerId="ADAL" clId="{E1317903-0E43-4FAC-A900-4D6121109CB5}" dt="2021-05-10T16:23:05.560" v="5591" actId="164"/>
          <ac:spMkLst>
            <pc:docMk/>
            <pc:sldMk cId="2788620995" sldId="356"/>
            <ac:spMk id="171" creationId="{AC00E3D7-2471-4397-B327-C3232C79C852}"/>
          </ac:spMkLst>
        </pc:spChg>
        <pc:spChg chg="mod topLvl">
          <ac:chgData name="Warner,Jeffrey Barr" userId="7360d018-3b8a-4d6d-8136-e4d170e1e616" providerId="ADAL" clId="{E1317903-0E43-4FAC-A900-4D6121109CB5}" dt="2021-05-10T16:23:05.560" v="5591" actId="164"/>
          <ac:spMkLst>
            <pc:docMk/>
            <pc:sldMk cId="2788620995" sldId="356"/>
            <ac:spMk id="172" creationId="{4514891E-7B2C-4D21-854A-93F9DDDB2E2F}"/>
          </ac:spMkLst>
        </pc:spChg>
        <pc:spChg chg="mod topLvl">
          <ac:chgData name="Warner,Jeffrey Barr" userId="7360d018-3b8a-4d6d-8136-e4d170e1e616" providerId="ADAL" clId="{E1317903-0E43-4FAC-A900-4D6121109CB5}" dt="2021-05-10T16:23:05.560" v="5591" actId="164"/>
          <ac:spMkLst>
            <pc:docMk/>
            <pc:sldMk cId="2788620995" sldId="356"/>
            <ac:spMk id="173" creationId="{D88F5B9D-F4AF-4D78-B786-281D1ED3A3C7}"/>
          </ac:spMkLst>
        </pc:spChg>
        <pc:spChg chg="mod topLvl">
          <ac:chgData name="Warner,Jeffrey Barr" userId="7360d018-3b8a-4d6d-8136-e4d170e1e616" providerId="ADAL" clId="{E1317903-0E43-4FAC-A900-4D6121109CB5}" dt="2021-05-10T16:23:05.560" v="5591" actId="164"/>
          <ac:spMkLst>
            <pc:docMk/>
            <pc:sldMk cId="2788620995" sldId="356"/>
            <ac:spMk id="174" creationId="{DC3D3549-5A66-470D-AE1B-C903E10B561B}"/>
          </ac:spMkLst>
        </pc:spChg>
        <pc:spChg chg="mod topLvl">
          <ac:chgData name="Warner,Jeffrey Barr" userId="7360d018-3b8a-4d6d-8136-e4d170e1e616" providerId="ADAL" clId="{E1317903-0E43-4FAC-A900-4D6121109CB5}" dt="2021-05-10T16:23:05.560" v="5591" actId="164"/>
          <ac:spMkLst>
            <pc:docMk/>
            <pc:sldMk cId="2788620995" sldId="356"/>
            <ac:spMk id="175" creationId="{AE15CE98-4954-46C6-B443-160841309FCE}"/>
          </ac:spMkLst>
        </pc:spChg>
        <pc:spChg chg="mod topLvl">
          <ac:chgData name="Warner,Jeffrey Barr" userId="7360d018-3b8a-4d6d-8136-e4d170e1e616" providerId="ADAL" clId="{E1317903-0E43-4FAC-A900-4D6121109CB5}" dt="2021-05-10T16:23:05.560" v="5591" actId="164"/>
          <ac:spMkLst>
            <pc:docMk/>
            <pc:sldMk cId="2788620995" sldId="356"/>
            <ac:spMk id="176" creationId="{09752759-5285-4A33-A27A-2F42B407478A}"/>
          </ac:spMkLst>
        </pc:spChg>
        <pc:spChg chg="mod topLvl">
          <ac:chgData name="Warner,Jeffrey Barr" userId="7360d018-3b8a-4d6d-8136-e4d170e1e616" providerId="ADAL" clId="{E1317903-0E43-4FAC-A900-4D6121109CB5}" dt="2021-05-10T16:23:05.560" v="5591" actId="164"/>
          <ac:spMkLst>
            <pc:docMk/>
            <pc:sldMk cId="2788620995" sldId="356"/>
            <ac:spMk id="177" creationId="{3F48684E-1988-4B6F-AFFD-5427E743016D}"/>
          </ac:spMkLst>
        </pc:spChg>
        <pc:spChg chg="mod topLvl">
          <ac:chgData name="Warner,Jeffrey Barr" userId="7360d018-3b8a-4d6d-8136-e4d170e1e616" providerId="ADAL" clId="{E1317903-0E43-4FAC-A900-4D6121109CB5}" dt="2021-05-10T16:23:05.560" v="5591" actId="164"/>
          <ac:spMkLst>
            <pc:docMk/>
            <pc:sldMk cId="2788620995" sldId="356"/>
            <ac:spMk id="178" creationId="{7D08A7D9-A07D-4B22-BDFD-694C465E7275}"/>
          </ac:spMkLst>
        </pc:spChg>
        <pc:spChg chg="mod topLvl">
          <ac:chgData name="Warner,Jeffrey Barr" userId="7360d018-3b8a-4d6d-8136-e4d170e1e616" providerId="ADAL" clId="{E1317903-0E43-4FAC-A900-4D6121109CB5}" dt="2021-05-10T16:23:05.560" v="5591" actId="164"/>
          <ac:spMkLst>
            <pc:docMk/>
            <pc:sldMk cId="2788620995" sldId="356"/>
            <ac:spMk id="180" creationId="{FB96F411-F170-4729-A628-D73C5C111DEF}"/>
          </ac:spMkLst>
        </pc:spChg>
        <pc:spChg chg="mod topLvl">
          <ac:chgData name="Warner,Jeffrey Barr" userId="7360d018-3b8a-4d6d-8136-e4d170e1e616" providerId="ADAL" clId="{E1317903-0E43-4FAC-A900-4D6121109CB5}" dt="2021-05-10T16:23:05.560" v="5591" actId="164"/>
          <ac:spMkLst>
            <pc:docMk/>
            <pc:sldMk cId="2788620995" sldId="356"/>
            <ac:spMk id="181" creationId="{31BAD405-4733-4068-BF38-AF5842DB6913}"/>
          </ac:spMkLst>
        </pc:spChg>
        <pc:spChg chg="mod topLvl">
          <ac:chgData name="Warner,Jeffrey Barr" userId="7360d018-3b8a-4d6d-8136-e4d170e1e616" providerId="ADAL" clId="{E1317903-0E43-4FAC-A900-4D6121109CB5}" dt="2021-05-10T16:23:05.560" v="5591" actId="164"/>
          <ac:spMkLst>
            <pc:docMk/>
            <pc:sldMk cId="2788620995" sldId="356"/>
            <ac:spMk id="182" creationId="{7C496E65-4A5A-49BC-959E-997A14738119}"/>
          </ac:spMkLst>
        </pc:spChg>
        <pc:spChg chg="mod topLvl">
          <ac:chgData name="Warner,Jeffrey Barr" userId="7360d018-3b8a-4d6d-8136-e4d170e1e616" providerId="ADAL" clId="{E1317903-0E43-4FAC-A900-4D6121109CB5}" dt="2021-05-10T16:23:05.560" v="5591" actId="164"/>
          <ac:spMkLst>
            <pc:docMk/>
            <pc:sldMk cId="2788620995" sldId="356"/>
            <ac:spMk id="183" creationId="{B7042086-ABAB-4350-A412-9E3B68671AC1}"/>
          </ac:spMkLst>
        </pc:spChg>
        <pc:spChg chg="mod topLvl">
          <ac:chgData name="Warner,Jeffrey Barr" userId="7360d018-3b8a-4d6d-8136-e4d170e1e616" providerId="ADAL" clId="{E1317903-0E43-4FAC-A900-4D6121109CB5}" dt="2021-05-10T16:23:05.560" v="5591" actId="164"/>
          <ac:spMkLst>
            <pc:docMk/>
            <pc:sldMk cId="2788620995" sldId="356"/>
            <ac:spMk id="184" creationId="{F7136D49-228F-4D0A-91C7-178E89919A79}"/>
          </ac:spMkLst>
        </pc:spChg>
        <pc:spChg chg="del mod">
          <ac:chgData name="Warner,Jeffrey Barr" userId="7360d018-3b8a-4d6d-8136-e4d170e1e616" providerId="ADAL" clId="{E1317903-0E43-4FAC-A900-4D6121109CB5}" dt="2021-05-10T16:22:15.896" v="5503" actId="478"/>
          <ac:spMkLst>
            <pc:docMk/>
            <pc:sldMk cId="2788620995" sldId="356"/>
            <ac:spMk id="185" creationId="{3D33A1B8-AE82-4099-AF5D-1C155E5096FE}"/>
          </ac:spMkLst>
        </pc:spChg>
        <pc:spChg chg="add mod">
          <ac:chgData name="Warner,Jeffrey Barr" userId="7360d018-3b8a-4d6d-8136-e4d170e1e616" providerId="ADAL" clId="{E1317903-0E43-4FAC-A900-4D6121109CB5}" dt="2021-05-19T16:10:39.248" v="7793" actId="1038"/>
          <ac:spMkLst>
            <pc:docMk/>
            <pc:sldMk cId="2788620995" sldId="356"/>
            <ac:spMk id="185" creationId="{861A10C3-2DDD-4787-931A-7AFA776E0121}"/>
          </ac:spMkLst>
        </pc:spChg>
        <pc:spChg chg="add mod">
          <ac:chgData name="Warner,Jeffrey Barr" userId="7360d018-3b8a-4d6d-8136-e4d170e1e616" providerId="ADAL" clId="{E1317903-0E43-4FAC-A900-4D6121109CB5}" dt="2021-05-19T16:10:39.248" v="7793" actId="1038"/>
          <ac:spMkLst>
            <pc:docMk/>
            <pc:sldMk cId="2788620995" sldId="356"/>
            <ac:spMk id="186" creationId="{4DB0E556-0A74-406D-8AA7-01E8F86872C8}"/>
          </ac:spMkLst>
        </pc:spChg>
        <pc:spChg chg="del mod">
          <ac:chgData name="Warner,Jeffrey Barr" userId="7360d018-3b8a-4d6d-8136-e4d170e1e616" providerId="ADAL" clId="{E1317903-0E43-4FAC-A900-4D6121109CB5}" dt="2021-05-10T16:22:11.086" v="5502" actId="478"/>
          <ac:spMkLst>
            <pc:docMk/>
            <pc:sldMk cId="2788620995" sldId="356"/>
            <ac:spMk id="186" creationId="{ABDAF5BE-548E-4FE0-902F-904030CA5C2D}"/>
          </ac:spMkLst>
        </pc:spChg>
        <pc:spChg chg="del mod">
          <ac:chgData name="Warner,Jeffrey Barr" userId="7360d018-3b8a-4d6d-8136-e4d170e1e616" providerId="ADAL" clId="{E1317903-0E43-4FAC-A900-4D6121109CB5}" dt="2021-05-10T16:22:09.583" v="5501" actId="478"/>
          <ac:spMkLst>
            <pc:docMk/>
            <pc:sldMk cId="2788620995" sldId="356"/>
            <ac:spMk id="187" creationId="{082E27C4-76F7-473B-9E34-6C0523E5E492}"/>
          </ac:spMkLst>
        </pc:spChg>
        <pc:spChg chg="add mod">
          <ac:chgData name="Warner,Jeffrey Barr" userId="7360d018-3b8a-4d6d-8136-e4d170e1e616" providerId="ADAL" clId="{E1317903-0E43-4FAC-A900-4D6121109CB5}" dt="2021-05-19T16:11:57.028" v="7910" actId="1038"/>
          <ac:spMkLst>
            <pc:docMk/>
            <pc:sldMk cId="2788620995" sldId="356"/>
            <ac:spMk id="187" creationId="{C68D1229-5D09-46A8-81AD-72CC37EFC312}"/>
          </ac:spMkLst>
        </pc:spChg>
        <pc:spChg chg="del mod">
          <ac:chgData name="Warner,Jeffrey Barr" userId="7360d018-3b8a-4d6d-8136-e4d170e1e616" providerId="ADAL" clId="{E1317903-0E43-4FAC-A900-4D6121109CB5}" dt="2021-05-10T16:22:08.750" v="5500" actId="478"/>
          <ac:spMkLst>
            <pc:docMk/>
            <pc:sldMk cId="2788620995" sldId="356"/>
            <ac:spMk id="188" creationId="{43B8F5A6-40BA-41EF-9D6E-11EB649D6E50}"/>
          </ac:spMkLst>
        </pc:spChg>
        <pc:spChg chg="add mod">
          <ac:chgData name="Warner,Jeffrey Barr" userId="7360d018-3b8a-4d6d-8136-e4d170e1e616" providerId="ADAL" clId="{E1317903-0E43-4FAC-A900-4D6121109CB5}" dt="2021-05-19T16:11:57.028" v="7910" actId="1038"/>
          <ac:spMkLst>
            <pc:docMk/>
            <pc:sldMk cId="2788620995" sldId="356"/>
            <ac:spMk id="188" creationId="{BF40DAC4-5982-44CC-8BD1-48EC83418DF6}"/>
          </ac:spMkLst>
        </pc:spChg>
        <pc:spChg chg="del mod">
          <ac:chgData name="Warner,Jeffrey Barr" userId="7360d018-3b8a-4d6d-8136-e4d170e1e616" providerId="ADAL" clId="{E1317903-0E43-4FAC-A900-4D6121109CB5}" dt="2021-05-10T16:22:06.492" v="5499" actId="478"/>
          <ac:spMkLst>
            <pc:docMk/>
            <pc:sldMk cId="2788620995" sldId="356"/>
            <ac:spMk id="189" creationId="{078AFE7F-7682-47C7-ADE2-0B1362B0F4B1}"/>
          </ac:spMkLst>
        </pc:spChg>
        <pc:spChg chg="add mod">
          <ac:chgData name="Warner,Jeffrey Barr" userId="7360d018-3b8a-4d6d-8136-e4d170e1e616" providerId="ADAL" clId="{E1317903-0E43-4FAC-A900-4D6121109CB5}" dt="2021-05-20T17:01:51.271" v="8132" actId="20577"/>
          <ac:spMkLst>
            <pc:docMk/>
            <pc:sldMk cId="2788620995" sldId="356"/>
            <ac:spMk id="189" creationId="{30DAD9EB-8A51-4F23-AE4A-4ED466361138}"/>
          </ac:spMkLst>
        </pc:spChg>
        <pc:spChg chg="add mod">
          <ac:chgData name="Warner,Jeffrey Barr" userId="7360d018-3b8a-4d6d-8136-e4d170e1e616" providerId="ADAL" clId="{E1317903-0E43-4FAC-A900-4D6121109CB5}" dt="2021-05-19T16:10:50.868" v="7807" actId="571"/>
          <ac:spMkLst>
            <pc:docMk/>
            <pc:sldMk cId="2788620995" sldId="356"/>
            <ac:spMk id="189" creationId="{877F3552-F64D-4E70-96AE-1DC6287A3B26}"/>
          </ac:spMkLst>
        </pc:spChg>
        <pc:spChg chg="add mod">
          <ac:chgData name="Warner,Jeffrey Barr" userId="7360d018-3b8a-4d6d-8136-e4d170e1e616" providerId="ADAL" clId="{E1317903-0E43-4FAC-A900-4D6121109CB5}" dt="2021-05-19T16:10:50.868" v="7807" actId="571"/>
          <ac:spMkLst>
            <pc:docMk/>
            <pc:sldMk cId="2788620995" sldId="356"/>
            <ac:spMk id="190" creationId="{3C78AE1E-4829-47BB-9713-C232D09D338C}"/>
          </ac:spMkLst>
        </pc:spChg>
        <pc:spChg chg="del mod">
          <ac:chgData name="Warner,Jeffrey Barr" userId="7360d018-3b8a-4d6d-8136-e4d170e1e616" providerId="ADAL" clId="{E1317903-0E43-4FAC-A900-4D6121109CB5}" dt="2021-05-10T16:22:05.559" v="5498" actId="478"/>
          <ac:spMkLst>
            <pc:docMk/>
            <pc:sldMk cId="2788620995" sldId="356"/>
            <ac:spMk id="190" creationId="{3DD2FAB0-FCE6-4C2E-839F-631C1D0274CA}"/>
          </ac:spMkLst>
        </pc:spChg>
        <pc:spChg chg="del mod">
          <ac:chgData name="Warner,Jeffrey Barr" userId="7360d018-3b8a-4d6d-8136-e4d170e1e616" providerId="ADAL" clId="{E1317903-0E43-4FAC-A900-4D6121109CB5}" dt="2021-05-10T16:21:13.906" v="5487" actId="478"/>
          <ac:spMkLst>
            <pc:docMk/>
            <pc:sldMk cId="2788620995" sldId="356"/>
            <ac:spMk id="191" creationId="{7C902101-B2EA-40BE-AEC8-8AAD67195156}"/>
          </ac:spMkLst>
        </pc:spChg>
        <pc:spChg chg="add mod">
          <ac:chgData name="Warner,Jeffrey Barr" userId="7360d018-3b8a-4d6d-8136-e4d170e1e616" providerId="ADAL" clId="{E1317903-0E43-4FAC-A900-4D6121109CB5}" dt="2021-05-19T16:11:57.028" v="7910" actId="1038"/>
          <ac:spMkLst>
            <pc:docMk/>
            <pc:sldMk cId="2788620995" sldId="356"/>
            <ac:spMk id="191" creationId="{A2C8776A-AAE1-40C1-AB6C-FCE10197D9B5}"/>
          </ac:spMkLst>
        </pc:spChg>
        <pc:grpChg chg="add mod">
          <ac:chgData name="Warner,Jeffrey Barr" userId="7360d018-3b8a-4d6d-8136-e4d170e1e616" providerId="ADAL" clId="{E1317903-0E43-4FAC-A900-4D6121109CB5}" dt="2021-05-19T16:11:48.980" v="7892" actId="164"/>
          <ac:grpSpMkLst>
            <pc:docMk/>
            <pc:sldMk cId="2788620995" sldId="356"/>
            <ac:grpSpMk id="3" creationId="{0A727395-F5BA-40DA-9CE0-611197077742}"/>
          </ac:grpSpMkLst>
        </pc:grpChg>
        <pc:grpChg chg="del mod topLvl">
          <ac:chgData name="Warner,Jeffrey Barr" userId="7360d018-3b8a-4d6d-8136-e4d170e1e616" providerId="ADAL" clId="{E1317903-0E43-4FAC-A900-4D6121109CB5}" dt="2021-05-19T16:11:44.303" v="7891" actId="165"/>
          <ac:grpSpMkLst>
            <pc:docMk/>
            <pc:sldMk cId="2788620995" sldId="356"/>
            <ac:grpSpMk id="4" creationId="{45455BA5-EC6C-44A0-BA71-839D133A9FBA}"/>
          </ac:grpSpMkLst>
        </pc:grpChg>
        <pc:grpChg chg="mod">
          <ac:chgData name="Warner,Jeffrey Barr" userId="7360d018-3b8a-4d6d-8136-e4d170e1e616" providerId="ADAL" clId="{E1317903-0E43-4FAC-A900-4D6121109CB5}" dt="2021-05-10T16:23:12.690" v="5594" actId="165"/>
          <ac:grpSpMkLst>
            <pc:docMk/>
            <pc:sldMk cId="2788620995" sldId="356"/>
            <ac:grpSpMk id="13" creationId="{5A03F5BC-3E15-344E-BD8C-E34BA431FE14}"/>
          </ac:grpSpMkLst>
        </pc:grpChg>
        <pc:grpChg chg="add mod">
          <ac:chgData name="Warner,Jeffrey Barr" userId="7360d018-3b8a-4d6d-8136-e4d170e1e616" providerId="ADAL" clId="{E1317903-0E43-4FAC-A900-4D6121109CB5}" dt="2021-05-10T16:23:44.598" v="5602" actId="164"/>
          <ac:grpSpMkLst>
            <pc:docMk/>
            <pc:sldMk cId="2788620995" sldId="356"/>
            <ac:grpSpMk id="14" creationId="{0FD88506-6013-4EEB-A922-FE679FDDD2C3}"/>
          </ac:grpSpMkLst>
        </pc:grpChg>
        <pc:grpChg chg="mod topLvl">
          <ac:chgData name="Warner,Jeffrey Barr" userId="7360d018-3b8a-4d6d-8136-e4d170e1e616" providerId="ADAL" clId="{E1317903-0E43-4FAC-A900-4D6121109CB5}" dt="2021-05-10T16:23:53.113" v="5631" actId="164"/>
          <ac:grpSpMkLst>
            <pc:docMk/>
            <pc:sldMk cId="2788620995" sldId="356"/>
            <ac:grpSpMk id="15" creationId="{267F4BD0-DA30-194B-8D0C-A82614A4BC2C}"/>
          </ac:grpSpMkLst>
        </pc:grpChg>
        <pc:grpChg chg="del">
          <ac:chgData name="Warner,Jeffrey Barr" userId="7360d018-3b8a-4d6d-8136-e4d170e1e616" providerId="ADAL" clId="{E1317903-0E43-4FAC-A900-4D6121109CB5}" dt="2021-05-19T16:08:24.246" v="7562" actId="165"/>
          <ac:grpSpMkLst>
            <pc:docMk/>
            <pc:sldMk cId="2788620995" sldId="356"/>
            <ac:grpSpMk id="16" creationId="{B45A7147-7FEE-C442-BAEF-2B8920AED965}"/>
          </ac:grpSpMkLst>
        </pc:grpChg>
        <pc:grpChg chg="add mod">
          <ac:chgData name="Warner,Jeffrey Barr" userId="7360d018-3b8a-4d6d-8136-e4d170e1e616" providerId="ADAL" clId="{E1317903-0E43-4FAC-A900-4D6121109CB5}" dt="2021-05-10T16:23:53.113" v="5631" actId="164"/>
          <ac:grpSpMkLst>
            <pc:docMk/>
            <pc:sldMk cId="2788620995" sldId="356"/>
            <ac:grpSpMk id="17" creationId="{4050E2A1-846B-4221-9DBB-90068D9F03FC}"/>
          </ac:grpSpMkLst>
        </pc:grpChg>
        <pc:grpChg chg="del mod">
          <ac:chgData name="Warner,Jeffrey Barr" userId="7360d018-3b8a-4d6d-8136-e4d170e1e616" providerId="ADAL" clId="{E1317903-0E43-4FAC-A900-4D6121109CB5}" dt="2021-05-10T16:23:12.690" v="5594" actId="165"/>
          <ac:grpSpMkLst>
            <pc:docMk/>
            <pc:sldMk cId="2788620995" sldId="356"/>
            <ac:grpSpMk id="18" creationId="{D0344D46-7B3A-3D45-B042-1EBB8FA7614D}"/>
          </ac:grpSpMkLst>
        </pc:grpChg>
        <pc:grpChg chg="add mod">
          <ac:chgData name="Warner,Jeffrey Barr" userId="7360d018-3b8a-4d6d-8136-e4d170e1e616" providerId="ADAL" clId="{E1317903-0E43-4FAC-A900-4D6121109CB5}" dt="2021-05-10T16:23:48.589" v="5620" actId="1037"/>
          <ac:grpSpMkLst>
            <pc:docMk/>
            <pc:sldMk cId="2788620995" sldId="356"/>
            <ac:grpSpMk id="19" creationId="{F7006E7D-D7E9-4DA5-909F-800E5A964AEC}"/>
          </ac:grpSpMkLst>
        </pc:grpChg>
        <pc:grpChg chg="add mod">
          <ac:chgData name="Warner,Jeffrey Barr" userId="7360d018-3b8a-4d6d-8136-e4d170e1e616" providerId="ADAL" clId="{E1317903-0E43-4FAC-A900-4D6121109CB5}" dt="2021-05-10T16:23:57.623" v="5657" actId="1038"/>
          <ac:grpSpMkLst>
            <pc:docMk/>
            <pc:sldMk cId="2788620995" sldId="356"/>
            <ac:grpSpMk id="46" creationId="{C47BB9BE-6598-4A93-9D2C-C791BD76B665}"/>
          </ac:grpSpMkLst>
        </pc:grpChg>
        <pc:grpChg chg="mod">
          <ac:chgData name="Warner,Jeffrey Barr" userId="7360d018-3b8a-4d6d-8136-e4d170e1e616" providerId="ADAL" clId="{E1317903-0E43-4FAC-A900-4D6121109CB5}" dt="2021-05-10T16:23:44.598" v="5602" actId="164"/>
          <ac:grpSpMkLst>
            <pc:docMk/>
            <pc:sldMk cId="2788620995" sldId="356"/>
            <ac:grpSpMk id="50" creationId="{2CBFDF7F-D481-48D6-A5C4-0019F56B0BEB}"/>
          </ac:grpSpMkLst>
        </pc:grpChg>
        <pc:grpChg chg="mod">
          <ac:chgData name="Warner,Jeffrey Barr" userId="7360d018-3b8a-4d6d-8136-e4d170e1e616" providerId="ADAL" clId="{E1317903-0E43-4FAC-A900-4D6121109CB5}" dt="2021-05-10T15:53:18.854" v="4898" actId="571"/>
          <ac:grpSpMkLst>
            <pc:docMk/>
            <pc:sldMk cId="2788620995" sldId="356"/>
            <ac:grpSpMk id="154" creationId="{AF7E3DFD-76E4-432A-9A01-9096E86BCFCA}"/>
          </ac:grpSpMkLst>
        </pc:grpChg>
        <pc:grpChg chg="add del mod">
          <ac:chgData name="Warner,Jeffrey Barr" userId="7360d018-3b8a-4d6d-8136-e4d170e1e616" providerId="ADAL" clId="{E1317903-0E43-4FAC-A900-4D6121109CB5}" dt="2021-05-10T16:22:59.862" v="5588" actId="165"/>
          <ac:grpSpMkLst>
            <pc:docMk/>
            <pc:sldMk cId="2788620995" sldId="356"/>
            <ac:grpSpMk id="166" creationId="{91565B51-546B-4390-BC34-60D881655772}"/>
          </ac:grpSpMkLst>
        </pc:grpChg>
        <pc:grpChg chg="add del mod">
          <ac:chgData name="Warner,Jeffrey Barr" userId="7360d018-3b8a-4d6d-8136-e4d170e1e616" providerId="ADAL" clId="{E1317903-0E43-4FAC-A900-4D6121109CB5}" dt="2021-05-10T16:22:59.862" v="5588" actId="165"/>
          <ac:grpSpMkLst>
            <pc:docMk/>
            <pc:sldMk cId="2788620995" sldId="356"/>
            <ac:grpSpMk id="179" creationId="{6AEE780E-9FC2-42A6-950D-C4EFAD49211D}"/>
          </ac:grpSpMkLst>
        </pc:grpChg>
        <pc:graphicFrameChg chg="mod">
          <ac:chgData name="Warner,Jeffrey Barr" userId="7360d018-3b8a-4d6d-8136-e4d170e1e616" providerId="ADAL" clId="{E1317903-0E43-4FAC-A900-4D6121109CB5}" dt="2021-05-19T17:51:19.876" v="7998"/>
          <ac:graphicFrameMkLst>
            <pc:docMk/>
            <pc:sldMk cId="2788620995" sldId="356"/>
            <ac:graphicFrameMk id="18" creationId="{B75DE5DD-FD29-49E6-A2BF-B6684FF7A27F}"/>
          </ac:graphicFrameMkLst>
        </pc:graphicFrameChg>
        <pc:picChg chg="mod">
          <ac:chgData name="Warner,Jeffrey Barr" userId="7360d018-3b8a-4d6d-8136-e4d170e1e616" providerId="ADAL" clId="{E1317903-0E43-4FAC-A900-4D6121109CB5}" dt="2021-05-10T16:23:50.446" v="5630" actId="1037"/>
          <ac:picMkLst>
            <pc:docMk/>
            <pc:sldMk cId="2788620995" sldId="356"/>
            <ac:picMk id="3" creationId="{D78F7D62-C386-A84F-B1CA-3E9190A3876D}"/>
          </ac:picMkLst>
        </pc:picChg>
        <pc:picChg chg="del">
          <ac:chgData name="Warner,Jeffrey Barr" userId="7360d018-3b8a-4d6d-8136-e4d170e1e616" providerId="ADAL" clId="{E1317903-0E43-4FAC-A900-4D6121109CB5}" dt="2021-05-19T16:08:12.206" v="7557" actId="478"/>
          <ac:picMkLst>
            <pc:docMk/>
            <pc:sldMk cId="2788620995" sldId="356"/>
            <ac:picMk id="6" creationId="{3D3DCE79-2987-4A39-A210-E8D2178CB06D}"/>
          </ac:picMkLst>
        </pc:picChg>
        <pc:picChg chg="mod ord topLvl">
          <ac:chgData name="Warner,Jeffrey Barr" userId="7360d018-3b8a-4d6d-8136-e4d170e1e616" providerId="ADAL" clId="{E1317903-0E43-4FAC-A900-4D6121109CB5}" dt="2021-05-19T16:11:48.980" v="7892" actId="164"/>
          <ac:picMkLst>
            <pc:docMk/>
            <pc:sldMk cId="2788620995" sldId="356"/>
            <ac:picMk id="7" creationId="{3E0EF9A8-8FAE-4473-BA10-69EC2DE98E5F}"/>
          </ac:picMkLst>
        </pc:picChg>
        <pc:picChg chg="del">
          <ac:chgData name="Warner,Jeffrey Barr" userId="7360d018-3b8a-4d6d-8136-e4d170e1e616" providerId="ADAL" clId="{E1317903-0E43-4FAC-A900-4D6121109CB5}" dt="2021-05-10T16:14:24.836" v="5197" actId="478"/>
          <ac:picMkLst>
            <pc:docMk/>
            <pc:sldMk cId="2788620995" sldId="356"/>
            <ac:picMk id="28" creationId="{E5EEFB1D-CF4A-7944-B89E-AC9DC8257696}"/>
          </ac:picMkLst>
        </pc:picChg>
        <pc:picChg chg="mod topLvl modCrop">
          <ac:chgData name="Warner,Jeffrey Barr" userId="7360d018-3b8a-4d6d-8136-e4d170e1e616" providerId="ADAL" clId="{E1317903-0E43-4FAC-A900-4D6121109CB5}" dt="2021-05-19T16:11:57.028" v="7910" actId="1038"/>
          <ac:picMkLst>
            <pc:docMk/>
            <pc:sldMk cId="2788620995" sldId="356"/>
            <ac:picMk id="29" creationId="{6505D113-EB02-418A-A41A-48D1A9BDE880}"/>
          </ac:picMkLst>
        </pc:picChg>
        <pc:picChg chg="mod">
          <ac:chgData name="Warner,Jeffrey Barr" userId="7360d018-3b8a-4d6d-8136-e4d170e1e616" providerId="ADAL" clId="{E1317903-0E43-4FAC-A900-4D6121109CB5}" dt="2021-05-10T16:23:12.690" v="5594" actId="165"/>
          <ac:picMkLst>
            <pc:docMk/>
            <pc:sldMk cId="2788620995" sldId="356"/>
            <ac:picMk id="35" creationId="{49950007-4BB1-2D40-81A3-0512BF573CC5}"/>
          </ac:picMkLst>
        </pc:picChg>
        <pc:picChg chg="mod modCrop">
          <ac:chgData name="Warner,Jeffrey Barr" userId="7360d018-3b8a-4d6d-8136-e4d170e1e616" providerId="ADAL" clId="{E1317903-0E43-4FAC-A900-4D6121109CB5}" dt="2021-05-10T16:23:12.690" v="5594" actId="165"/>
          <ac:picMkLst>
            <pc:docMk/>
            <pc:sldMk cId="2788620995" sldId="356"/>
            <ac:picMk id="36" creationId="{A9A5893C-6E76-49E2-B6A4-F075FCA5B565}"/>
          </ac:picMkLst>
        </pc:picChg>
        <pc:picChg chg="del">
          <ac:chgData name="Warner,Jeffrey Barr" userId="7360d018-3b8a-4d6d-8136-e4d170e1e616" providerId="ADAL" clId="{E1317903-0E43-4FAC-A900-4D6121109CB5}" dt="2021-05-10T16:23:10.919" v="5593" actId="478"/>
          <ac:picMkLst>
            <pc:docMk/>
            <pc:sldMk cId="2788620995" sldId="356"/>
            <ac:picMk id="39" creationId="{FB267FE2-78B4-914F-97C1-94C012388DB8}"/>
          </ac:picMkLst>
        </pc:picChg>
        <pc:picChg chg="mod">
          <ac:chgData name="Warner,Jeffrey Barr" userId="7360d018-3b8a-4d6d-8136-e4d170e1e616" providerId="ADAL" clId="{E1317903-0E43-4FAC-A900-4D6121109CB5}" dt="2021-05-10T16:23:12.690" v="5594" actId="165"/>
          <ac:picMkLst>
            <pc:docMk/>
            <pc:sldMk cId="2788620995" sldId="356"/>
            <ac:picMk id="41" creationId="{9AB9709F-867C-AD40-A2BF-DEBAE9AF2966}"/>
          </ac:picMkLst>
        </pc:picChg>
        <pc:picChg chg="add mod ord modCrop">
          <ac:chgData name="Warner,Jeffrey Barr" userId="7360d018-3b8a-4d6d-8136-e4d170e1e616" providerId="ADAL" clId="{E1317903-0E43-4FAC-A900-4D6121109CB5}" dt="2021-05-19T16:08:08.460" v="7556" actId="167"/>
          <ac:picMkLst>
            <pc:docMk/>
            <pc:sldMk cId="2788620995" sldId="356"/>
            <ac:picMk id="166" creationId="{0B5AC522-2449-4FB7-BA89-00DD13F11F91}"/>
          </ac:picMkLst>
        </pc:picChg>
        <pc:picChg chg="add mod modCrop">
          <ac:chgData name="Warner,Jeffrey Barr" userId="7360d018-3b8a-4d6d-8136-e4d170e1e616" providerId="ADAL" clId="{E1317903-0E43-4FAC-A900-4D6121109CB5}" dt="2021-05-19T16:10:39.248" v="7793" actId="1038"/>
          <ac:picMkLst>
            <pc:docMk/>
            <pc:sldMk cId="2788620995" sldId="356"/>
            <ac:picMk id="179" creationId="{51901799-8AC5-460E-B536-80A1208DF165}"/>
          </ac:picMkLst>
        </pc:picChg>
      </pc:sldChg>
      <pc:sldChg chg="addSp delSp modSp mod">
        <pc:chgData name="Warner,Jeffrey Barr" userId="7360d018-3b8a-4d6d-8136-e4d170e1e616" providerId="ADAL" clId="{E1317903-0E43-4FAC-A900-4D6121109CB5}" dt="2021-05-20T17:02:12.570" v="8169" actId="20577"/>
        <pc:sldMkLst>
          <pc:docMk/>
          <pc:sldMk cId="53146747" sldId="357"/>
        </pc:sldMkLst>
        <pc:spChg chg="add mod">
          <ac:chgData name="Warner,Jeffrey Barr" userId="7360d018-3b8a-4d6d-8136-e4d170e1e616" providerId="ADAL" clId="{E1317903-0E43-4FAC-A900-4D6121109CB5}" dt="2021-05-20T17:02:12.570" v="8169" actId="20577"/>
          <ac:spMkLst>
            <pc:docMk/>
            <pc:sldMk cId="53146747" sldId="357"/>
            <ac:spMk id="5" creationId="{68142842-A8D1-45F2-B118-10F5A96DD0BB}"/>
          </ac:spMkLst>
        </pc:spChg>
        <pc:spChg chg="del mod">
          <ac:chgData name="Warner,Jeffrey Barr" userId="7360d018-3b8a-4d6d-8136-e4d170e1e616" providerId="ADAL" clId="{E1317903-0E43-4FAC-A900-4D6121109CB5}" dt="2021-05-20T17:00:40.041" v="8065" actId="478"/>
          <ac:spMkLst>
            <pc:docMk/>
            <pc:sldMk cId="53146747" sldId="357"/>
            <ac:spMk id="6" creationId="{361BD047-A6BF-46B6-864C-DDAD7889FB72}"/>
          </ac:spMkLst>
        </pc:spChg>
        <pc:graphicFrameChg chg="mod">
          <ac:chgData name="Warner,Jeffrey Barr" userId="7360d018-3b8a-4d6d-8136-e4d170e1e616" providerId="ADAL" clId="{E1317903-0E43-4FAC-A900-4D6121109CB5}" dt="2021-05-19T17:53:53.766" v="8013"/>
          <ac:graphicFrameMkLst>
            <pc:docMk/>
            <pc:sldMk cId="53146747" sldId="357"/>
            <ac:graphicFrameMk id="4" creationId="{C3D75B9A-3A8C-4FD7-935D-38924F5A93C1}"/>
          </ac:graphicFrameMkLst>
        </pc:graphicFrameChg>
      </pc:sldChg>
      <pc:sldChg chg="del">
        <pc:chgData name="Warner,Jeffrey Barr" userId="7360d018-3b8a-4d6d-8136-e4d170e1e616" providerId="ADAL" clId="{E1317903-0E43-4FAC-A900-4D6121109CB5}" dt="2021-05-10T16:45:18.026" v="5681" actId="47"/>
        <pc:sldMkLst>
          <pc:docMk/>
          <pc:sldMk cId="2624015114" sldId="360"/>
        </pc:sldMkLst>
      </pc:sldChg>
      <pc:sldChg chg="del">
        <pc:chgData name="Warner,Jeffrey Barr" userId="7360d018-3b8a-4d6d-8136-e4d170e1e616" providerId="ADAL" clId="{E1317903-0E43-4FAC-A900-4D6121109CB5}" dt="2021-05-10T16:45:18.026" v="5681" actId="47"/>
        <pc:sldMkLst>
          <pc:docMk/>
          <pc:sldMk cId="3711558352" sldId="361"/>
        </pc:sldMkLst>
      </pc:sldChg>
      <pc:sldChg chg="del">
        <pc:chgData name="Warner,Jeffrey Barr" userId="7360d018-3b8a-4d6d-8136-e4d170e1e616" providerId="ADAL" clId="{E1317903-0E43-4FAC-A900-4D6121109CB5}" dt="2021-05-10T16:45:18.026" v="5681" actId="47"/>
        <pc:sldMkLst>
          <pc:docMk/>
          <pc:sldMk cId="1695659152" sldId="362"/>
        </pc:sldMkLst>
      </pc:sldChg>
      <pc:sldChg chg="del">
        <pc:chgData name="Warner,Jeffrey Barr" userId="7360d018-3b8a-4d6d-8136-e4d170e1e616" providerId="ADAL" clId="{E1317903-0E43-4FAC-A900-4D6121109CB5}" dt="2021-05-10T16:45:18.026" v="5681" actId="47"/>
        <pc:sldMkLst>
          <pc:docMk/>
          <pc:sldMk cId="2512159804" sldId="363"/>
        </pc:sldMkLst>
      </pc:sldChg>
      <pc:sldChg chg="del">
        <pc:chgData name="Warner,Jeffrey Barr" userId="7360d018-3b8a-4d6d-8136-e4d170e1e616" providerId="ADAL" clId="{E1317903-0E43-4FAC-A900-4D6121109CB5}" dt="2021-05-10T16:45:18.026" v="5681" actId="47"/>
        <pc:sldMkLst>
          <pc:docMk/>
          <pc:sldMk cId="2634941530" sldId="364"/>
        </pc:sldMkLst>
      </pc:sldChg>
      <pc:sldChg chg="del modNotesTx">
        <pc:chgData name="Warner,Jeffrey Barr" userId="7360d018-3b8a-4d6d-8136-e4d170e1e616" providerId="ADAL" clId="{E1317903-0E43-4FAC-A900-4D6121109CB5}" dt="2021-05-10T16:45:18.026" v="5681" actId="47"/>
        <pc:sldMkLst>
          <pc:docMk/>
          <pc:sldMk cId="765555922" sldId="365"/>
        </pc:sldMkLst>
      </pc:sldChg>
      <pc:sldChg chg="del modNotesTx">
        <pc:chgData name="Warner,Jeffrey Barr" userId="7360d018-3b8a-4d6d-8136-e4d170e1e616" providerId="ADAL" clId="{E1317903-0E43-4FAC-A900-4D6121109CB5}" dt="2021-05-10T16:45:18.026" v="5681" actId="47"/>
        <pc:sldMkLst>
          <pc:docMk/>
          <pc:sldMk cId="865920250" sldId="367"/>
        </pc:sldMkLst>
      </pc:sldChg>
      <pc:sldChg chg="del">
        <pc:chgData name="Warner,Jeffrey Barr" userId="7360d018-3b8a-4d6d-8136-e4d170e1e616" providerId="ADAL" clId="{E1317903-0E43-4FAC-A900-4D6121109CB5}" dt="2021-05-10T16:45:18.026" v="5681" actId="47"/>
        <pc:sldMkLst>
          <pc:docMk/>
          <pc:sldMk cId="188745765" sldId="368"/>
        </pc:sldMkLst>
      </pc:sldChg>
      <pc:sldChg chg="del">
        <pc:chgData name="Warner,Jeffrey Barr" userId="7360d018-3b8a-4d6d-8136-e4d170e1e616" providerId="ADAL" clId="{E1317903-0E43-4FAC-A900-4D6121109CB5}" dt="2021-05-10T16:45:18.026" v="5681" actId="47"/>
        <pc:sldMkLst>
          <pc:docMk/>
          <pc:sldMk cId="331617767" sldId="369"/>
        </pc:sldMkLst>
      </pc:sldChg>
      <pc:sldChg chg="addSp delSp del mod addCm delCm modCm">
        <pc:chgData name="Warner,Jeffrey Barr" userId="7360d018-3b8a-4d6d-8136-e4d170e1e616" providerId="ADAL" clId="{E1317903-0E43-4FAC-A900-4D6121109CB5}" dt="2021-05-20T16:56:22.361" v="8020" actId="2696"/>
        <pc:sldMkLst>
          <pc:docMk/>
          <pc:sldMk cId="195968458" sldId="370"/>
        </pc:sldMkLst>
        <pc:picChg chg="add del">
          <ac:chgData name="Warner,Jeffrey Barr" userId="7360d018-3b8a-4d6d-8136-e4d170e1e616" providerId="ADAL" clId="{E1317903-0E43-4FAC-A900-4D6121109CB5}" dt="2021-05-03T19:22:24.547" v="3159" actId="478"/>
          <ac:picMkLst>
            <pc:docMk/>
            <pc:sldMk cId="195968458" sldId="370"/>
            <ac:picMk id="2" creationId="{31B98F44-CCE9-4EEE-A51F-2D2F278E35C6}"/>
          </ac:picMkLst>
        </pc:picChg>
        <pc:picChg chg="add del">
          <ac:chgData name="Warner,Jeffrey Barr" userId="7360d018-3b8a-4d6d-8136-e4d170e1e616" providerId="ADAL" clId="{E1317903-0E43-4FAC-A900-4D6121109CB5}" dt="2021-05-06T20:38:37.241" v="4486" actId="478"/>
          <ac:picMkLst>
            <pc:docMk/>
            <pc:sldMk cId="195968458" sldId="370"/>
            <ac:picMk id="2" creationId="{43160348-52DB-45BD-BEBE-DDA46DB16169}"/>
          </ac:picMkLst>
        </pc:picChg>
        <pc:picChg chg="add del">
          <ac:chgData name="Warner,Jeffrey Barr" userId="7360d018-3b8a-4d6d-8136-e4d170e1e616" providerId="ADAL" clId="{E1317903-0E43-4FAC-A900-4D6121109CB5}" dt="2021-05-06T20:38:31.847" v="4484" actId="478"/>
          <ac:picMkLst>
            <pc:docMk/>
            <pc:sldMk cId="195968458" sldId="370"/>
            <ac:picMk id="3" creationId="{486B20C8-970A-4AA6-893F-DC2C88617C16}"/>
          </ac:picMkLst>
        </pc:picChg>
        <pc:picChg chg="add">
          <ac:chgData name="Warner,Jeffrey Barr" userId="7360d018-3b8a-4d6d-8136-e4d170e1e616" providerId="ADAL" clId="{E1317903-0E43-4FAC-A900-4D6121109CB5}" dt="2021-05-06T20:38:52.983" v="4487"/>
          <ac:picMkLst>
            <pc:docMk/>
            <pc:sldMk cId="195968458" sldId="370"/>
            <ac:picMk id="5" creationId="{38242CC6-2D05-49E3-B4E1-0F15459CD5E6}"/>
          </ac:picMkLst>
        </pc:picChg>
        <pc:picChg chg="del">
          <ac:chgData name="Warner,Jeffrey Barr" userId="7360d018-3b8a-4d6d-8136-e4d170e1e616" providerId="ADAL" clId="{E1317903-0E43-4FAC-A900-4D6121109CB5}" dt="2021-04-22T17:15:11.323" v="1088" actId="478"/>
          <ac:picMkLst>
            <pc:docMk/>
            <pc:sldMk cId="195968458" sldId="370"/>
            <ac:picMk id="7" creationId="{509BA469-8470-489B-A1AC-DE08E370D104}"/>
          </ac:picMkLst>
        </pc:picChg>
      </pc:sldChg>
      <pc:sldChg chg="del">
        <pc:chgData name="Warner,Jeffrey Barr" userId="7360d018-3b8a-4d6d-8136-e4d170e1e616" providerId="ADAL" clId="{E1317903-0E43-4FAC-A900-4D6121109CB5}" dt="2021-05-10T16:45:18.026" v="5681" actId="47"/>
        <pc:sldMkLst>
          <pc:docMk/>
          <pc:sldMk cId="3224176347" sldId="371"/>
        </pc:sldMkLst>
      </pc:sldChg>
      <pc:sldChg chg="del">
        <pc:chgData name="Warner,Jeffrey Barr" userId="7360d018-3b8a-4d6d-8136-e4d170e1e616" providerId="ADAL" clId="{E1317903-0E43-4FAC-A900-4D6121109CB5}" dt="2021-05-10T16:45:18.026" v="5681" actId="47"/>
        <pc:sldMkLst>
          <pc:docMk/>
          <pc:sldMk cId="2439303368" sldId="372"/>
        </pc:sldMkLst>
      </pc:sldChg>
      <pc:sldChg chg="del modNotesTx">
        <pc:chgData name="Warner,Jeffrey Barr" userId="7360d018-3b8a-4d6d-8136-e4d170e1e616" providerId="ADAL" clId="{E1317903-0E43-4FAC-A900-4D6121109CB5}" dt="2021-05-10T16:45:18.026" v="5681" actId="47"/>
        <pc:sldMkLst>
          <pc:docMk/>
          <pc:sldMk cId="3286936023" sldId="373"/>
        </pc:sldMkLst>
      </pc:sldChg>
      <pc:sldChg chg="del modNotesTx">
        <pc:chgData name="Warner,Jeffrey Barr" userId="7360d018-3b8a-4d6d-8136-e4d170e1e616" providerId="ADAL" clId="{E1317903-0E43-4FAC-A900-4D6121109CB5}" dt="2021-05-10T16:45:18.026" v="5681" actId="47"/>
        <pc:sldMkLst>
          <pc:docMk/>
          <pc:sldMk cId="696100002" sldId="374"/>
        </pc:sldMkLst>
      </pc:sldChg>
      <pc:sldChg chg="del">
        <pc:chgData name="Warner,Jeffrey Barr" userId="7360d018-3b8a-4d6d-8136-e4d170e1e616" providerId="ADAL" clId="{E1317903-0E43-4FAC-A900-4D6121109CB5}" dt="2021-05-10T16:45:18.026" v="5681" actId="47"/>
        <pc:sldMkLst>
          <pc:docMk/>
          <pc:sldMk cId="1449251688" sldId="375"/>
        </pc:sldMkLst>
      </pc:sldChg>
      <pc:sldChg chg="del">
        <pc:chgData name="Warner,Jeffrey Barr" userId="7360d018-3b8a-4d6d-8136-e4d170e1e616" providerId="ADAL" clId="{E1317903-0E43-4FAC-A900-4D6121109CB5}" dt="2021-05-20T16:56:22.361" v="8020" actId="2696"/>
        <pc:sldMkLst>
          <pc:docMk/>
          <pc:sldMk cId="3200190074" sldId="376"/>
        </pc:sldMkLst>
      </pc:sldChg>
      <pc:sldChg chg="del">
        <pc:chgData name="Warner,Jeffrey Barr" userId="7360d018-3b8a-4d6d-8136-e4d170e1e616" providerId="ADAL" clId="{E1317903-0E43-4FAC-A900-4D6121109CB5}" dt="2021-05-10T16:45:18.026" v="5681" actId="47"/>
        <pc:sldMkLst>
          <pc:docMk/>
          <pc:sldMk cId="1498579683" sldId="377"/>
        </pc:sldMkLst>
      </pc:sldChg>
      <pc:sldChg chg="addSp delSp modSp mod addCm delCm modCm modNotesTx">
        <pc:chgData name="Warner,Jeffrey Barr" userId="7360d018-3b8a-4d6d-8136-e4d170e1e616" providerId="ADAL" clId="{E1317903-0E43-4FAC-A900-4D6121109CB5}" dt="2021-05-20T17:01:35.290" v="8119"/>
        <pc:sldMkLst>
          <pc:docMk/>
          <pc:sldMk cId="2894237854" sldId="378"/>
        </pc:sldMkLst>
        <pc:spChg chg="del">
          <ac:chgData name="Warner,Jeffrey Barr" userId="7360d018-3b8a-4d6d-8136-e4d170e1e616" providerId="ADAL" clId="{E1317903-0E43-4FAC-A900-4D6121109CB5}" dt="2021-05-19T15:52:28.738" v="7082" actId="478"/>
          <ac:spMkLst>
            <pc:docMk/>
            <pc:sldMk cId="2894237854" sldId="378"/>
            <ac:spMk id="3" creationId="{01621D3B-EDAF-4791-A422-6CA1DCC83B1E}"/>
          </ac:spMkLst>
        </pc:spChg>
        <pc:spChg chg="del mod">
          <ac:chgData name="Warner,Jeffrey Barr" userId="7360d018-3b8a-4d6d-8136-e4d170e1e616" providerId="ADAL" clId="{E1317903-0E43-4FAC-A900-4D6121109CB5}" dt="2021-05-20T16:56:51.816" v="8021" actId="478"/>
          <ac:spMkLst>
            <pc:docMk/>
            <pc:sldMk cId="2894237854" sldId="378"/>
            <ac:spMk id="4" creationId="{E9CB1FB8-D5B0-490C-8487-92DCDD4CDBE9}"/>
          </ac:spMkLst>
        </pc:spChg>
        <pc:spChg chg="add mod topLvl">
          <ac:chgData name="Warner,Jeffrey Barr" userId="7360d018-3b8a-4d6d-8136-e4d170e1e616" providerId="ADAL" clId="{E1317903-0E43-4FAC-A900-4D6121109CB5}" dt="2021-05-19T16:00:02.403" v="7494" actId="165"/>
          <ac:spMkLst>
            <pc:docMk/>
            <pc:sldMk cId="2894237854" sldId="378"/>
            <ac:spMk id="7" creationId="{BE95CD1F-406F-4B0C-BAB8-654A5B45500A}"/>
          </ac:spMkLst>
        </pc:spChg>
        <pc:spChg chg="mod">
          <ac:chgData name="Warner,Jeffrey Barr" userId="7360d018-3b8a-4d6d-8136-e4d170e1e616" providerId="ADAL" clId="{E1317903-0E43-4FAC-A900-4D6121109CB5}" dt="2021-05-19T16:00:02.403" v="7494" actId="165"/>
          <ac:spMkLst>
            <pc:docMk/>
            <pc:sldMk cId="2894237854" sldId="378"/>
            <ac:spMk id="8" creationId="{62D65E68-C00A-4107-A739-DB0B62953F85}"/>
          </ac:spMkLst>
        </pc:spChg>
        <pc:spChg chg="mod">
          <ac:chgData name="Warner,Jeffrey Barr" userId="7360d018-3b8a-4d6d-8136-e4d170e1e616" providerId="ADAL" clId="{E1317903-0E43-4FAC-A900-4D6121109CB5}" dt="2021-05-19T16:00:02.403" v="7494" actId="165"/>
          <ac:spMkLst>
            <pc:docMk/>
            <pc:sldMk cId="2894237854" sldId="378"/>
            <ac:spMk id="9" creationId="{15E3D589-DCC5-497C-92B5-030239440E18}"/>
          </ac:spMkLst>
        </pc:spChg>
        <pc:spChg chg="mod topLvl">
          <ac:chgData name="Warner,Jeffrey Barr" userId="7360d018-3b8a-4d6d-8136-e4d170e1e616" providerId="ADAL" clId="{E1317903-0E43-4FAC-A900-4D6121109CB5}" dt="2021-05-04T15:33:00.428" v="4251" actId="164"/>
          <ac:spMkLst>
            <pc:docMk/>
            <pc:sldMk cId="2894237854" sldId="378"/>
            <ac:spMk id="12" creationId="{F5C0041D-F0ED-4445-B9BD-DBF1A86F4DF4}"/>
          </ac:spMkLst>
        </pc:spChg>
        <pc:spChg chg="mod">
          <ac:chgData name="Warner,Jeffrey Barr" userId="7360d018-3b8a-4d6d-8136-e4d170e1e616" providerId="ADAL" clId="{E1317903-0E43-4FAC-A900-4D6121109CB5}" dt="2021-05-19T16:00:02.403" v="7494" actId="165"/>
          <ac:spMkLst>
            <pc:docMk/>
            <pc:sldMk cId="2894237854" sldId="378"/>
            <ac:spMk id="18" creationId="{901798EE-A30B-4F8D-A82A-9AD1E5A2D4FD}"/>
          </ac:spMkLst>
        </pc:spChg>
        <pc:spChg chg="mod">
          <ac:chgData name="Warner,Jeffrey Barr" userId="7360d018-3b8a-4d6d-8136-e4d170e1e616" providerId="ADAL" clId="{E1317903-0E43-4FAC-A900-4D6121109CB5}" dt="2021-05-19T16:00:02.403" v="7494" actId="165"/>
          <ac:spMkLst>
            <pc:docMk/>
            <pc:sldMk cId="2894237854" sldId="378"/>
            <ac:spMk id="20" creationId="{B59AAD97-8E76-4693-93C9-BFA0CE4D6266}"/>
          </ac:spMkLst>
        </pc:spChg>
        <pc:spChg chg="mod">
          <ac:chgData name="Warner,Jeffrey Barr" userId="7360d018-3b8a-4d6d-8136-e4d170e1e616" providerId="ADAL" clId="{E1317903-0E43-4FAC-A900-4D6121109CB5}" dt="2021-05-19T16:00:02.403" v="7494" actId="165"/>
          <ac:spMkLst>
            <pc:docMk/>
            <pc:sldMk cId="2894237854" sldId="378"/>
            <ac:spMk id="21" creationId="{6B503B11-B434-45AE-8282-E2BAA512BD33}"/>
          </ac:spMkLst>
        </pc:spChg>
        <pc:spChg chg="mod">
          <ac:chgData name="Warner,Jeffrey Barr" userId="7360d018-3b8a-4d6d-8136-e4d170e1e616" providerId="ADAL" clId="{E1317903-0E43-4FAC-A900-4D6121109CB5}" dt="2021-05-19T16:00:02.403" v="7494" actId="165"/>
          <ac:spMkLst>
            <pc:docMk/>
            <pc:sldMk cId="2894237854" sldId="378"/>
            <ac:spMk id="22" creationId="{814807B6-5D64-478C-A6A4-5E852B28D5F5}"/>
          </ac:spMkLst>
        </pc:spChg>
        <pc:spChg chg="mod">
          <ac:chgData name="Warner,Jeffrey Barr" userId="7360d018-3b8a-4d6d-8136-e4d170e1e616" providerId="ADAL" clId="{E1317903-0E43-4FAC-A900-4D6121109CB5}" dt="2021-05-19T16:00:02.403" v="7494" actId="165"/>
          <ac:spMkLst>
            <pc:docMk/>
            <pc:sldMk cId="2894237854" sldId="378"/>
            <ac:spMk id="23" creationId="{4CF13C58-294C-4A22-9741-36E401BDD2FF}"/>
          </ac:spMkLst>
        </pc:spChg>
        <pc:spChg chg="mod">
          <ac:chgData name="Warner,Jeffrey Barr" userId="7360d018-3b8a-4d6d-8136-e4d170e1e616" providerId="ADAL" clId="{E1317903-0E43-4FAC-A900-4D6121109CB5}" dt="2021-05-19T16:00:02.403" v="7494" actId="165"/>
          <ac:spMkLst>
            <pc:docMk/>
            <pc:sldMk cId="2894237854" sldId="378"/>
            <ac:spMk id="24" creationId="{D5FD6073-240D-492E-BE9E-C7BF4AD4150C}"/>
          </ac:spMkLst>
        </pc:spChg>
        <pc:spChg chg="mod">
          <ac:chgData name="Warner,Jeffrey Barr" userId="7360d018-3b8a-4d6d-8136-e4d170e1e616" providerId="ADAL" clId="{E1317903-0E43-4FAC-A900-4D6121109CB5}" dt="2021-05-19T16:00:02.403" v="7494" actId="165"/>
          <ac:spMkLst>
            <pc:docMk/>
            <pc:sldMk cId="2894237854" sldId="378"/>
            <ac:spMk id="25" creationId="{BD22D5DF-A610-4A28-B592-F89934FE5C68}"/>
          </ac:spMkLst>
        </pc:spChg>
        <pc:spChg chg="mod">
          <ac:chgData name="Warner,Jeffrey Barr" userId="7360d018-3b8a-4d6d-8136-e4d170e1e616" providerId="ADAL" clId="{E1317903-0E43-4FAC-A900-4D6121109CB5}" dt="2021-05-19T16:00:02.403" v="7494" actId="165"/>
          <ac:spMkLst>
            <pc:docMk/>
            <pc:sldMk cId="2894237854" sldId="378"/>
            <ac:spMk id="26" creationId="{27955448-56C7-4C80-9D37-9914B5C38B62}"/>
          </ac:spMkLst>
        </pc:spChg>
        <pc:spChg chg="mod">
          <ac:chgData name="Warner,Jeffrey Barr" userId="7360d018-3b8a-4d6d-8136-e4d170e1e616" providerId="ADAL" clId="{E1317903-0E43-4FAC-A900-4D6121109CB5}" dt="2021-05-19T16:00:02.403" v="7494" actId="165"/>
          <ac:spMkLst>
            <pc:docMk/>
            <pc:sldMk cId="2894237854" sldId="378"/>
            <ac:spMk id="27" creationId="{1ABB47BD-0A0F-4439-817C-FBA621CF131F}"/>
          </ac:spMkLst>
        </pc:spChg>
        <pc:spChg chg="mod">
          <ac:chgData name="Warner,Jeffrey Barr" userId="7360d018-3b8a-4d6d-8136-e4d170e1e616" providerId="ADAL" clId="{E1317903-0E43-4FAC-A900-4D6121109CB5}" dt="2021-05-19T16:00:02.403" v="7494" actId="165"/>
          <ac:spMkLst>
            <pc:docMk/>
            <pc:sldMk cId="2894237854" sldId="378"/>
            <ac:spMk id="28" creationId="{8A284606-2B76-4BFD-B948-E8D89E5A2AEF}"/>
          </ac:spMkLst>
        </pc:spChg>
        <pc:spChg chg="mod">
          <ac:chgData name="Warner,Jeffrey Barr" userId="7360d018-3b8a-4d6d-8136-e4d170e1e616" providerId="ADAL" clId="{E1317903-0E43-4FAC-A900-4D6121109CB5}" dt="2021-05-19T16:00:02.403" v="7494" actId="165"/>
          <ac:spMkLst>
            <pc:docMk/>
            <pc:sldMk cId="2894237854" sldId="378"/>
            <ac:spMk id="29" creationId="{D58160FF-4F4C-40D0-9810-76965B44D486}"/>
          </ac:spMkLst>
        </pc:spChg>
        <pc:spChg chg="mod">
          <ac:chgData name="Warner,Jeffrey Barr" userId="7360d018-3b8a-4d6d-8136-e4d170e1e616" providerId="ADAL" clId="{E1317903-0E43-4FAC-A900-4D6121109CB5}" dt="2021-05-19T16:00:02.403" v="7494" actId="165"/>
          <ac:spMkLst>
            <pc:docMk/>
            <pc:sldMk cId="2894237854" sldId="378"/>
            <ac:spMk id="30" creationId="{62ADA072-8458-4ABD-8290-85D7260B11B2}"/>
          </ac:spMkLst>
        </pc:spChg>
        <pc:spChg chg="mod">
          <ac:chgData name="Warner,Jeffrey Barr" userId="7360d018-3b8a-4d6d-8136-e4d170e1e616" providerId="ADAL" clId="{E1317903-0E43-4FAC-A900-4D6121109CB5}" dt="2021-05-19T16:00:02.403" v="7494" actId="165"/>
          <ac:spMkLst>
            <pc:docMk/>
            <pc:sldMk cId="2894237854" sldId="378"/>
            <ac:spMk id="31" creationId="{D21512A0-6F97-4431-969B-832957D7BD84}"/>
          </ac:spMkLst>
        </pc:spChg>
        <pc:spChg chg="mod">
          <ac:chgData name="Warner,Jeffrey Barr" userId="7360d018-3b8a-4d6d-8136-e4d170e1e616" providerId="ADAL" clId="{E1317903-0E43-4FAC-A900-4D6121109CB5}" dt="2021-05-19T16:00:02.403" v="7494" actId="165"/>
          <ac:spMkLst>
            <pc:docMk/>
            <pc:sldMk cId="2894237854" sldId="378"/>
            <ac:spMk id="32" creationId="{5AB1677A-6870-4561-A740-88474BE18313}"/>
          </ac:spMkLst>
        </pc:spChg>
        <pc:spChg chg="mod">
          <ac:chgData name="Warner,Jeffrey Barr" userId="7360d018-3b8a-4d6d-8136-e4d170e1e616" providerId="ADAL" clId="{E1317903-0E43-4FAC-A900-4D6121109CB5}" dt="2021-05-19T16:00:02.403" v="7494" actId="165"/>
          <ac:spMkLst>
            <pc:docMk/>
            <pc:sldMk cId="2894237854" sldId="378"/>
            <ac:spMk id="33" creationId="{ED5F0CC4-54CA-49B0-9D6E-7AEFCCB67412}"/>
          </ac:spMkLst>
        </pc:spChg>
        <pc:spChg chg="mod">
          <ac:chgData name="Warner,Jeffrey Barr" userId="7360d018-3b8a-4d6d-8136-e4d170e1e616" providerId="ADAL" clId="{E1317903-0E43-4FAC-A900-4D6121109CB5}" dt="2021-05-19T16:00:02.403" v="7494" actId="165"/>
          <ac:spMkLst>
            <pc:docMk/>
            <pc:sldMk cId="2894237854" sldId="378"/>
            <ac:spMk id="34" creationId="{BCE1124F-C42A-431C-B672-47DACE4E414B}"/>
          </ac:spMkLst>
        </pc:spChg>
        <pc:spChg chg="mod">
          <ac:chgData name="Warner,Jeffrey Barr" userId="7360d018-3b8a-4d6d-8136-e4d170e1e616" providerId="ADAL" clId="{E1317903-0E43-4FAC-A900-4D6121109CB5}" dt="2021-05-19T16:00:02.403" v="7494" actId="165"/>
          <ac:spMkLst>
            <pc:docMk/>
            <pc:sldMk cId="2894237854" sldId="378"/>
            <ac:spMk id="35" creationId="{CBDD886F-4DF3-4B6F-A0FD-F5BB4C8D6B03}"/>
          </ac:spMkLst>
        </pc:spChg>
        <pc:spChg chg="mod">
          <ac:chgData name="Warner,Jeffrey Barr" userId="7360d018-3b8a-4d6d-8136-e4d170e1e616" providerId="ADAL" clId="{E1317903-0E43-4FAC-A900-4D6121109CB5}" dt="2021-05-19T16:00:02.403" v="7494" actId="165"/>
          <ac:spMkLst>
            <pc:docMk/>
            <pc:sldMk cId="2894237854" sldId="378"/>
            <ac:spMk id="36" creationId="{6A50A5AE-4E51-431B-A8D3-C8E12541504F}"/>
          </ac:spMkLst>
        </pc:spChg>
        <pc:spChg chg="mod">
          <ac:chgData name="Warner,Jeffrey Barr" userId="7360d018-3b8a-4d6d-8136-e4d170e1e616" providerId="ADAL" clId="{E1317903-0E43-4FAC-A900-4D6121109CB5}" dt="2021-05-19T16:00:02.403" v="7494" actId="165"/>
          <ac:spMkLst>
            <pc:docMk/>
            <pc:sldMk cId="2894237854" sldId="378"/>
            <ac:spMk id="37" creationId="{85EE1438-6C3D-450F-A762-CFAD6F4212A5}"/>
          </ac:spMkLst>
        </pc:spChg>
        <pc:spChg chg="mod">
          <ac:chgData name="Warner,Jeffrey Barr" userId="7360d018-3b8a-4d6d-8136-e4d170e1e616" providerId="ADAL" clId="{E1317903-0E43-4FAC-A900-4D6121109CB5}" dt="2021-05-19T16:00:02.403" v="7494" actId="165"/>
          <ac:spMkLst>
            <pc:docMk/>
            <pc:sldMk cId="2894237854" sldId="378"/>
            <ac:spMk id="38" creationId="{2A29DFAC-A273-49AC-82D8-8BCF2C477D83}"/>
          </ac:spMkLst>
        </pc:spChg>
        <pc:spChg chg="mod">
          <ac:chgData name="Warner,Jeffrey Barr" userId="7360d018-3b8a-4d6d-8136-e4d170e1e616" providerId="ADAL" clId="{E1317903-0E43-4FAC-A900-4D6121109CB5}" dt="2021-05-19T16:00:02.403" v="7494" actId="165"/>
          <ac:spMkLst>
            <pc:docMk/>
            <pc:sldMk cId="2894237854" sldId="378"/>
            <ac:spMk id="39" creationId="{09936C11-C4D4-4D67-ADDD-868A198D9849}"/>
          </ac:spMkLst>
        </pc:spChg>
        <pc:spChg chg="mod">
          <ac:chgData name="Warner,Jeffrey Barr" userId="7360d018-3b8a-4d6d-8136-e4d170e1e616" providerId="ADAL" clId="{E1317903-0E43-4FAC-A900-4D6121109CB5}" dt="2021-05-19T16:00:02.403" v="7494" actId="165"/>
          <ac:spMkLst>
            <pc:docMk/>
            <pc:sldMk cId="2894237854" sldId="378"/>
            <ac:spMk id="40" creationId="{A9635E88-99F9-471C-BDF0-5BCA3B7AFB4C}"/>
          </ac:spMkLst>
        </pc:spChg>
        <pc:spChg chg="mod">
          <ac:chgData name="Warner,Jeffrey Barr" userId="7360d018-3b8a-4d6d-8136-e4d170e1e616" providerId="ADAL" clId="{E1317903-0E43-4FAC-A900-4D6121109CB5}" dt="2021-05-19T16:00:02.403" v="7494" actId="165"/>
          <ac:spMkLst>
            <pc:docMk/>
            <pc:sldMk cId="2894237854" sldId="378"/>
            <ac:spMk id="41" creationId="{31E92B81-991E-4621-BA7D-69CBF0E6817D}"/>
          </ac:spMkLst>
        </pc:spChg>
        <pc:spChg chg="mod">
          <ac:chgData name="Warner,Jeffrey Barr" userId="7360d018-3b8a-4d6d-8136-e4d170e1e616" providerId="ADAL" clId="{E1317903-0E43-4FAC-A900-4D6121109CB5}" dt="2021-05-19T16:00:02.403" v="7494" actId="165"/>
          <ac:spMkLst>
            <pc:docMk/>
            <pc:sldMk cId="2894237854" sldId="378"/>
            <ac:spMk id="42" creationId="{4C6C386B-94E4-4A2F-AFB1-8FC46F5E4684}"/>
          </ac:spMkLst>
        </pc:spChg>
        <pc:spChg chg="mod">
          <ac:chgData name="Warner,Jeffrey Barr" userId="7360d018-3b8a-4d6d-8136-e4d170e1e616" providerId="ADAL" clId="{E1317903-0E43-4FAC-A900-4D6121109CB5}" dt="2021-05-19T16:00:02.403" v="7494" actId="165"/>
          <ac:spMkLst>
            <pc:docMk/>
            <pc:sldMk cId="2894237854" sldId="378"/>
            <ac:spMk id="43" creationId="{1D06417D-3472-4A74-81EF-E021E490401F}"/>
          </ac:spMkLst>
        </pc:spChg>
        <pc:spChg chg="mod">
          <ac:chgData name="Warner,Jeffrey Barr" userId="7360d018-3b8a-4d6d-8136-e4d170e1e616" providerId="ADAL" clId="{E1317903-0E43-4FAC-A900-4D6121109CB5}" dt="2021-05-19T16:00:02.403" v="7494" actId="165"/>
          <ac:spMkLst>
            <pc:docMk/>
            <pc:sldMk cId="2894237854" sldId="378"/>
            <ac:spMk id="44" creationId="{FE5876D2-6B74-4265-810B-FCDB4290AE93}"/>
          </ac:spMkLst>
        </pc:spChg>
        <pc:spChg chg="mod">
          <ac:chgData name="Warner,Jeffrey Barr" userId="7360d018-3b8a-4d6d-8136-e4d170e1e616" providerId="ADAL" clId="{E1317903-0E43-4FAC-A900-4D6121109CB5}" dt="2021-05-19T16:00:02.403" v="7494" actId="165"/>
          <ac:spMkLst>
            <pc:docMk/>
            <pc:sldMk cId="2894237854" sldId="378"/>
            <ac:spMk id="45" creationId="{A24CFB4E-AD50-4669-A38F-02BD198866F4}"/>
          </ac:spMkLst>
        </pc:spChg>
        <pc:spChg chg="mod">
          <ac:chgData name="Warner,Jeffrey Barr" userId="7360d018-3b8a-4d6d-8136-e4d170e1e616" providerId="ADAL" clId="{E1317903-0E43-4FAC-A900-4D6121109CB5}" dt="2021-05-19T16:00:02.403" v="7494" actId="165"/>
          <ac:spMkLst>
            <pc:docMk/>
            <pc:sldMk cId="2894237854" sldId="378"/>
            <ac:spMk id="46" creationId="{257826AA-CDD8-49C6-AF6F-572210B22EE1}"/>
          </ac:spMkLst>
        </pc:spChg>
        <pc:spChg chg="mod">
          <ac:chgData name="Warner,Jeffrey Barr" userId="7360d018-3b8a-4d6d-8136-e4d170e1e616" providerId="ADAL" clId="{E1317903-0E43-4FAC-A900-4D6121109CB5}" dt="2021-05-19T16:00:02.403" v="7494" actId="165"/>
          <ac:spMkLst>
            <pc:docMk/>
            <pc:sldMk cId="2894237854" sldId="378"/>
            <ac:spMk id="47" creationId="{4526230A-6A56-41F7-92E7-A18264886BCD}"/>
          </ac:spMkLst>
        </pc:spChg>
        <pc:spChg chg="mod">
          <ac:chgData name="Warner,Jeffrey Barr" userId="7360d018-3b8a-4d6d-8136-e4d170e1e616" providerId="ADAL" clId="{E1317903-0E43-4FAC-A900-4D6121109CB5}" dt="2021-05-19T16:00:02.403" v="7494" actId="165"/>
          <ac:spMkLst>
            <pc:docMk/>
            <pc:sldMk cId="2894237854" sldId="378"/>
            <ac:spMk id="48" creationId="{15256448-CCF4-46EE-8467-EFF16AEF9A08}"/>
          </ac:spMkLst>
        </pc:spChg>
        <pc:spChg chg="mod">
          <ac:chgData name="Warner,Jeffrey Barr" userId="7360d018-3b8a-4d6d-8136-e4d170e1e616" providerId="ADAL" clId="{E1317903-0E43-4FAC-A900-4D6121109CB5}" dt="2021-05-19T16:00:02.403" v="7494" actId="165"/>
          <ac:spMkLst>
            <pc:docMk/>
            <pc:sldMk cId="2894237854" sldId="378"/>
            <ac:spMk id="49" creationId="{6DE76C3B-62D1-4BA1-BC39-16E06A4F99A3}"/>
          </ac:spMkLst>
        </pc:spChg>
        <pc:spChg chg="mod">
          <ac:chgData name="Warner,Jeffrey Barr" userId="7360d018-3b8a-4d6d-8136-e4d170e1e616" providerId="ADAL" clId="{E1317903-0E43-4FAC-A900-4D6121109CB5}" dt="2021-05-19T16:00:02.403" v="7494" actId="165"/>
          <ac:spMkLst>
            <pc:docMk/>
            <pc:sldMk cId="2894237854" sldId="378"/>
            <ac:spMk id="50" creationId="{8AE379CE-6254-4AAE-A2E1-70E91C80DE7E}"/>
          </ac:spMkLst>
        </pc:spChg>
        <pc:spChg chg="mod">
          <ac:chgData name="Warner,Jeffrey Barr" userId="7360d018-3b8a-4d6d-8136-e4d170e1e616" providerId="ADAL" clId="{E1317903-0E43-4FAC-A900-4D6121109CB5}" dt="2021-05-19T16:00:02.403" v="7494" actId="165"/>
          <ac:spMkLst>
            <pc:docMk/>
            <pc:sldMk cId="2894237854" sldId="378"/>
            <ac:spMk id="51" creationId="{E1C7CC3B-8561-450C-A798-EC6BB6E195A4}"/>
          </ac:spMkLst>
        </pc:spChg>
        <pc:spChg chg="mod">
          <ac:chgData name="Warner,Jeffrey Barr" userId="7360d018-3b8a-4d6d-8136-e4d170e1e616" providerId="ADAL" clId="{E1317903-0E43-4FAC-A900-4D6121109CB5}" dt="2021-05-19T16:00:02.403" v="7494" actId="165"/>
          <ac:spMkLst>
            <pc:docMk/>
            <pc:sldMk cId="2894237854" sldId="378"/>
            <ac:spMk id="52" creationId="{0E93D2BF-D6BD-43A9-85CA-8C3D459E9CAB}"/>
          </ac:spMkLst>
        </pc:spChg>
        <pc:spChg chg="mod">
          <ac:chgData name="Warner,Jeffrey Barr" userId="7360d018-3b8a-4d6d-8136-e4d170e1e616" providerId="ADAL" clId="{E1317903-0E43-4FAC-A900-4D6121109CB5}" dt="2021-05-19T16:00:02.403" v="7494" actId="165"/>
          <ac:spMkLst>
            <pc:docMk/>
            <pc:sldMk cId="2894237854" sldId="378"/>
            <ac:spMk id="53" creationId="{9D514C7C-A46A-45EC-8B4A-D55A4D6CBCC9}"/>
          </ac:spMkLst>
        </pc:spChg>
        <pc:spChg chg="mod">
          <ac:chgData name="Warner,Jeffrey Barr" userId="7360d018-3b8a-4d6d-8136-e4d170e1e616" providerId="ADAL" clId="{E1317903-0E43-4FAC-A900-4D6121109CB5}" dt="2021-05-19T16:00:02.403" v="7494" actId="165"/>
          <ac:spMkLst>
            <pc:docMk/>
            <pc:sldMk cId="2894237854" sldId="378"/>
            <ac:spMk id="54" creationId="{CD36E827-5783-45B7-A048-7938776AB4D5}"/>
          </ac:spMkLst>
        </pc:spChg>
        <pc:spChg chg="mod">
          <ac:chgData name="Warner,Jeffrey Barr" userId="7360d018-3b8a-4d6d-8136-e4d170e1e616" providerId="ADAL" clId="{E1317903-0E43-4FAC-A900-4D6121109CB5}" dt="2021-05-19T16:00:02.403" v="7494" actId="165"/>
          <ac:spMkLst>
            <pc:docMk/>
            <pc:sldMk cId="2894237854" sldId="378"/>
            <ac:spMk id="55" creationId="{F5654D98-F412-4F91-94AA-7AC8A7447B16}"/>
          </ac:spMkLst>
        </pc:spChg>
        <pc:spChg chg="mod">
          <ac:chgData name="Warner,Jeffrey Barr" userId="7360d018-3b8a-4d6d-8136-e4d170e1e616" providerId="ADAL" clId="{E1317903-0E43-4FAC-A900-4D6121109CB5}" dt="2021-05-19T16:00:02.403" v="7494" actId="165"/>
          <ac:spMkLst>
            <pc:docMk/>
            <pc:sldMk cId="2894237854" sldId="378"/>
            <ac:spMk id="56" creationId="{5F6BED2C-06D0-4AC8-A175-45214B5EF582}"/>
          </ac:spMkLst>
        </pc:spChg>
        <pc:spChg chg="add mod">
          <ac:chgData name="Warner,Jeffrey Barr" userId="7360d018-3b8a-4d6d-8136-e4d170e1e616" providerId="ADAL" clId="{E1317903-0E43-4FAC-A900-4D6121109CB5}" dt="2021-05-19T16:00:02.403" v="7494" actId="165"/>
          <ac:spMkLst>
            <pc:docMk/>
            <pc:sldMk cId="2894237854" sldId="378"/>
            <ac:spMk id="59" creationId="{958A706C-CA22-41B7-9FA7-A5AB46E91A89}"/>
          </ac:spMkLst>
        </pc:spChg>
        <pc:spChg chg="mod topLvl">
          <ac:chgData name="Warner,Jeffrey Barr" userId="7360d018-3b8a-4d6d-8136-e4d170e1e616" providerId="ADAL" clId="{E1317903-0E43-4FAC-A900-4D6121109CB5}" dt="2021-05-04T15:33:00.428" v="4251" actId="164"/>
          <ac:spMkLst>
            <pc:docMk/>
            <pc:sldMk cId="2894237854" sldId="378"/>
            <ac:spMk id="61" creationId="{838598AE-9BF8-4B63-B3D0-0E1BF8BAE2B1}"/>
          </ac:spMkLst>
        </pc:spChg>
        <pc:spChg chg="mod topLvl">
          <ac:chgData name="Warner,Jeffrey Barr" userId="7360d018-3b8a-4d6d-8136-e4d170e1e616" providerId="ADAL" clId="{E1317903-0E43-4FAC-A900-4D6121109CB5}" dt="2021-05-04T15:33:00.428" v="4251" actId="164"/>
          <ac:spMkLst>
            <pc:docMk/>
            <pc:sldMk cId="2894237854" sldId="378"/>
            <ac:spMk id="62" creationId="{40844577-6DD8-40BF-BABB-D4BD7AF66D6A}"/>
          </ac:spMkLst>
        </pc:spChg>
        <pc:spChg chg="mod topLvl">
          <ac:chgData name="Warner,Jeffrey Barr" userId="7360d018-3b8a-4d6d-8136-e4d170e1e616" providerId="ADAL" clId="{E1317903-0E43-4FAC-A900-4D6121109CB5}" dt="2021-05-04T15:33:00.428" v="4251" actId="164"/>
          <ac:spMkLst>
            <pc:docMk/>
            <pc:sldMk cId="2894237854" sldId="378"/>
            <ac:spMk id="63" creationId="{396AF8A6-5B0E-463F-95CE-CAAD5AD99F44}"/>
          </ac:spMkLst>
        </pc:spChg>
        <pc:spChg chg="del">
          <ac:chgData name="Warner,Jeffrey Barr" userId="7360d018-3b8a-4d6d-8136-e4d170e1e616" providerId="ADAL" clId="{E1317903-0E43-4FAC-A900-4D6121109CB5}" dt="2021-05-19T15:49:31.486" v="6968" actId="478"/>
          <ac:spMkLst>
            <pc:docMk/>
            <pc:sldMk cId="2894237854" sldId="378"/>
            <ac:spMk id="64" creationId="{80F1F01C-0CC7-43C7-B956-12B2FBBB2CB2}"/>
          </ac:spMkLst>
        </pc:spChg>
        <pc:spChg chg="add mod">
          <ac:chgData name="Warner,Jeffrey Barr" userId="7360d018-3b8a-4d6d-8136-e4d170e1e616" providerId="ADAL" clId="{E1317903-0E43-4FAC-A900-4D6121109CB5}" dt="2021-05-19T15:52:22.872" v="7081" actId="164"/>
          <ac:spMkLst>
            <pc:docMk/>
            <pc:sldMk cId="2894237854" sldId="378"/>
            <ac:spMk id="66" creationId="{A178164B-536B-4204-ADF7-3F2440B0249F}"/>
          </ac:spMkLst>
        </pc:spChg>
        <pc:spChg chg="add mod">
          <ac:chgData name="Warner,Jeffrey Barr" userId="7360d018-3b8a-4d6d-8136-e4d170e1e616" providerId="ADAL" clId="{E1317903-0E43-4FAC-A900-4D6121109CB5}" dt="2021-05-19T15:52:22.872" v="7081" actId="164"/>
          <ac:spMkLst>
            <pc:docMk/>
            <pc:sldMk cId="2894237854" sldId="378"/>
            <ac:spMk id="67" creationId="{0A08C465-FCF3-4C42-963E-416ABE203066}"/>
          </ac:spMkLst>
        </pc:spChg>
        <pc:spChg chg="add mod">
          <ac:chgData name="Warner,Jeffrey Barr" userId="7360d018-3b8a-4d6d-8136-e4d170e1e616" providerId="ADAL" clId="{E1317903-0E43-4FAC-A900-4D6121109CB5}" dt="2021-05-19T15:52:22.872" v="7081" actId="164"/>
          <ac:spMkLst>
            <pc:docMk/>
            <pc:sldMk cId="2894237854" sldId="378"/>
            <ac:spMk id="68" creationId="{17DC749C-ACC0-4F69-AA20-5B840B6CA0F4}"/>
          </ac:spMkLst>
        </pc:spChg>
        <pc:spChg chg="add mod">
          <ac:chgData name="Warner,Jeffrey Barr" userId="7360d018-3b8a-4d6d-8136-e4d170e1e616" providerId="ADAL" clId="{E1317903-0E43-4FAC-A900-4D6121109CB5}" dt="2021-05-19T15:52:22.872" v="7081" actId="164"/>
          <ac:spMkLst>
            <pc:docMk/>
            <pc:sldMk cId="2894237854" sldId="378"/>
            <ac:spMk id="69" creationId="{B673F747-4C32-42F3-AA6A-C5E400D9A13B}"/>
          </ac:spMkLst>
        </pc:spChg>
        <pc:spChg chg="add mod">
          <ac:chgData name="Warner,Jeffrey Barr" userId="7360d018-3b8a-4d6d-8136-e4d170e1e616" providerId="ADAL" clId="{E1317903-0E43-4FAC-A900-4D6121109CB5}" dt="2021-05-19T15:52:22.872" v="7081" actId="164"/>
          <ac:spMkLst>
            <pc:docMk/>
            <pc:sldMk cId="2894237854" sldId="378"/>
            <ac:spMk id="70" creationId="{CACB5484-F733-444C-AC64-11B3EA7D0B74}"/>
          </ac:spMkLst>
        </pc:spChg>
        <pc:spChg chg="add del mod">
          <ac:chgData name="Warner,Jeffrey Barr" userId="7360d018-3b8a-4d6d-8136-e4d170e1e616" providerId="ADAL" clId="{E1317903-0E43-4FAC-A900-4D6121109CB5}" dt="2021-05-19T15:52:56.529" v="7090"/>
          <ac:spMkLst>
            <pc:docMk/>
            <pc:sldMk cId="2894237854" sldId="378"/>
            <ac:spMk id="71" creationId="{9C2D2982-A4EE-478E-9F88-6BEC4CBA00A5}"/>
          </ac:spMkLst>
        </pc:spChg>
        <pc:spChg chg="add del mod">
          <ac:chgData name="Warner,Jeffrey Barr" userId="7360d018-3b8a-4d6d-8136-e4d170e1e616" providerId="ADAL" clId="{E1317903-0E43-4FAC-A900-4D6121109CB5}" dt="2021-05-19T15:52:56.529" v="7090"/>
          <ac:spMkLst>
            <pc:docMk/>
            <pc:sldMk cId="2894237854" sldId="378"/>
            <ac:spMk id="72" creationId="{A69413F2-F775-4888-B9D3-07A72C6845E8}"/>
          </ac:spMkLst>
        </pc:spChg>
        <pc:spChg chg="add mod">
          <ac:chgData name="Warner,Jeffrey Barr" userId="7360d018-3b8a-4d6d-8136-e4d170e1e616" providerId="ADAL" clId="{E1317903-0E43-4FAC-A900-4D6121109CB5}" dt="2021-05-20T17:01:35.290" v="8119"/>
          <ac:spMkLst>
            <pc:docMk/>
            <pc:sldMk cId="2894237854" sldId="378"/>
            <ac:spMk id="75" creationId="{4617EA2D-320D-41C0-843F-429E25D8A30D}"/>
          </ac:spMkLst>
        </pc:spChg>
        <pc:spChg chg="mod">
          <ac:chgData name="Warner,Jeffrey Barr" userId="7360d018-3b8a-4d6d-8136-e4d170e1e616" providerId="ADAL" clId="{E1317903-0E43-4FAC-A900-4D6121109CB5}" dt="2021-05-19T15:52:57.989" v="7092" actId="571"/>
          <ac:spMkLst>
            <pc:docMk/>
            <pc:sldMk cId="2894237854" sldId="378"/>
            <ac:spMk id="75" creationId="{4C07B7DA-A576-45EF-9DBC-0D1D259D304E}"/>
          </ac:spMkLst>
        </pc:spChg>
        <pc:spChg chg="mod">
          <ac:chgData name="Warner,Jeffrey Barr" userId="7360d018-3b8a-4d6d-8136-e4d170e1e616" providerId="ADAL" clId="{E1317903-0E43-4FAC-A900-4D6121109CB5}" dt="2021-05-19T15:52:57.989" v="7092" actId="571"/>
          <ac:spMkLst>
            <pc:docMk/>
            <pc:sldMk cId="2894237854" sldId="378"/>
            <ac:spMk id="76" creationId="{30762034-64BF-4D1E-B44E-EC6BCA903395}"/>
          </ac:spMkLst>
        </pc:spChg>
        <pc:spChg chg="mod">
          <ac:chgData name="Warner,Jeffrey Barr" userId="7360d018-3b8a-4d6d-8136-e4d170e1e616" providerId="ADAL" clId="{E1317903-0E43-4FAC-A900-4D6121109CB5}" dt="2021-05-19T15:52:57.989" v="7092" actId="571"/>
          <ac:spMkLst>
            <pc:docMk/>
            <pc:sldMk cId="2894237854" sldId="378"/>
            <ac:spMk id="77" creationId="{8D6D1ABA-1C68-43FE-9FAF-298A624BD326}"/>
          </ac:spMkLst>
        </pc:spChg>
        <pc:spChg chg="mod">
          <ac:chgData name="Warner,Jeffrey Barr" userId="7360d018-3b8a-4d6d-8136-e4d170e1e616" providerId="ADAL" clId="{E1317903-0E43-4FAC-A900-4D6121109CB5}" dt="2021-05-19T15:52:57.989" v="7092" actId="571"/>
          <ac:spMkLst>
            <pc:docMk/>
            <pc:sldMk cId="2894237854" sldId="378"/>
            <ac:spMk id="78" creationId="{7A22D0CF-8346-4DB6-90EE-1F68ACB67E02}"/>
          </ac:spMkLst>
        </pc:spChg>
        <pc:spChg chg="mod">
          <ac:chgData name="Warner,Jeffrey Barr" userId="7360d018-3b8a-4d6d-8136-e4d170e1e616" providerId="ADAL" clId="{E1317903-0E43-4FAC-A900-4D6121109CB5}" dt="2021-05-19T15:52:57.989" v="7092" actId="571"/>
          <ac:spMkLst>
            <pc:docMk/>
            <pc:sldMk cId="2894237854" sldId="378"/>
            <ac:spMk id="79" creationId="{FA56ECCA-F29D-4D31-8C5F-6E798A47775E}"/>
          </ac:spMkLst>
        </pc:spChg>
        <pc:spChg chg="add mod topLvl">
          <ac:chgData name="Warner,Jeffrey Barr" userId="7360d018-3b8a-4d6d-8136-e4d170e1e616" providerId="ADAL" clId="{E1317903-0E43-4FAC-A900-4D6121109CB5}" dt="2021-05-19T16:00:02.403" v="7494" actId="165"/>
          <ac:spMkLst>
            <pc:docMk/>
            <pc:sldMk cId="2894237854" sldId="378"/>
            <ac:spMk id="80" creationId="{B69461FD-4793-48F1-99D5-77B068EB852D}"/>
          </ac:spMkLst>
        </pc:spChg>
        <pc:spChg chg="add mod topLvl">
          <ac:chgData name="Warner,Jeffrey Barr" userId="7360d018-3b8a-4d6d-8136-e4d170e1e616" providerId="ADAL" clId="{E1317903-0E43-4FAC-A900-4D6121109CB5}" dt="2021-05-19T16:00:02.403" v="7494" actId="165"/>
          <ac:spMkLst>
            <pc:docMk/>
            <pc:sldMk cId="2894237854" sldId="378"/>
            <ac:spMk id="83" creationId="{0A936DF7-7C34-40A2-A6AC-74E31D69542A}"/>
          </ac:spMkLst>
        </pc:spChg>
        <pc:spChg chg="add mod topLvl">
          <ac:chgData name="Warner,Jeffrey Barr" userId="7360d018-3b8a-4d6d-8136-e4d170e1e616" providerId="ADAL" clId="{E1317903-0E43-4FAC-A900-4D6121109CB5}" dt="2021-05-19T16:00:02.403" v="7494" actId="165"/>
          <ac:spMkLst>
            <pc:docMk/>
            <pc:sldMk cId="2894237854" sldId="378"/>
            <ac:spMk id="84" creationId="{8AD2D3C2-5C0B-4042-8F5A-2B979ED3C102}"/>
          </ac:spMkLst>
        </pc:spChg>
        <pc:spChg chg="add del mod">
          <ac:chgData name="Warner,Jeffrey Barr" userId="7360d018-3b8a-4d6d-8136-e4d170e1e616" providerId="ADAL" clId="{E1317903-0E43-4FAC-A900-4D6121109CB5}" dt="2021-05-19T15:56:16.606" v="7180" actId="478"/>
          <ac:spMkLst>
            <pc:docMk/>
            <pc:sldMk cId="2894237854" sldId="378"/>
            <ac:spMk id="85" creationId="{5C1FBD9B-128E-4B89-A209-594F9F3688D5}"/>
          </ac:spMkLst>
        </pc:spChg>
        <pc:spChg chg="add del mod">
          <ac:chgData name="Warner,Jeffrey Barr" userId="7360d018-3b8a-4d6d-8136-e4d170e1e616" providerId="ADAL" clId="{E1317903-0E43-4FAC-A900-4D6121109CB5}" dt="2021-05-19T15:56:16.606" v="7180" actId="478"/>
          <ac:spMkLst>
            <pc:docMk/>
            <pc:sldMk cId="2894237854" sldId="378"/>
            <ac:spMk id="86" creationId="{81585E8B-C713-4267-B2F9-CEDEFDC579E9}"/>
          </ac:spMkLst>
        </pc:spChg>
        <pc:spChg chg="add mod topLvl">
          <ac:chgData name="Warner,Jeffrey Barr" userId="7360d018-3b8a-4d6d-8136-e4d170e1e616" providerId="ADAL" clId="{E1317903-0E43-4FAC-A900-4D6121109CB5}" dt="2021-05-19T16:00:02.403" v="7494" actId="165"/>
          <ac:spMkLst>
            <pc:docMk/>
            <pc:sldMk cId="2894237854" sldId="378"/>
            <ac:spMk id="88" creationId="{738A9372-4B42-47F2-BE0D-BEFC0F3F02A0}"/>
          </ac:spMkLst>
        </pc:spChg>
        <pc:spChg chg="add mod topLvl">
          <ac:chgData name="Warner,Jeffrey Barr" userId="7360d018-3b8a-4d6d-8136-e4d170e1e616" providerId="ADAL" clId="{E1317903-0E43-4FAC-A900-4D6121109CB5}" dt="2021-05-19T16:00:02.403" v="7494" actId="165"/>
          <ac:spMkLst>
            <pc:docMk/>
            <pc:sldMk cId="2894237854" sldId="378"/>
            <ac:spMk id="90" creationId="{95B3E2E9-3F0C-4B95-8125-A6398367D7D0}"/>
          </ac:spMkLst>
        </pc:spChg>
        <pc:spChg chg="add mod topLvl">
          <ac:chgData name="Warner,Jeffrey Barr" userId="7360d018-3b8a-4d6d-8136-e4d170e1e616" providerId="ADAL" clId="{E1317903-0E43-4FAC-A900-4D6121109CB5}" dt="2021-05-19T16:00:02.403" v="7494" actId="165"/>
          <ac:spMkLst>
            <pc:docMk/>
            <pc:sldMk cId="2894237854" sldId="378"/>
            <ac:spMk id="91" creationId="{D16951CC-FA0A-4D6B-90CB-5EB543232930}"/>
          </ac:spMkLst>
        </pc:spChg>
        <pc:spChg chg="add mod">
          <ac:chgData name="Warner,Jeffrey Barr" userId="7360d018-3b8a-4d6d-8136-e4d170e1e616" providerId="ADAL" clId="{E1317903-0E43-4FAC-A900-4D6121109CB5}" dt="2021-05-19T16:00:02.403" v="7494" actId="165"/>
          <ac:spMkLst>
            <pc:docMk/>
            <pc:sldMk cId="2894237854" sldId="378"/>
            <ac:spMk id="95" creationId="{44229F84-0F7D-483A-B246-4FE313E25F5A}"/>
          </ac:spMkLst>
        </pc:spChg>
        <pc:spChg chg="add mod">
          <ac:chgData name="Warner,Jeffrey Barr" userId="7360d018-3b8a-4d6d-8136-e4d170e1e616" providerId="ADAL" clId="{E1317903-0E43-4FAC-A900-4D6121109CB5}" dt="2021-05-19T16:00:02.403" v="7494" actId="165"/>
          <ac:spMkLst>
            <pc:docMk/>
            <pc:sldMk cId="2894237854" sldId="378"/>
            <ac:spMk id="96" creationId="{8F4792C2-FDF4-4833-80A7-27D871953AD5}"/>
          </ac:spMkLst>
        </pc:spChg>
        <pc:spChg chg="add mod">
          <ac:chgData name="Warner,Jeffrey Barr" userId="7360d018-3b8a-4d6d-8136-e4d170e1e616" providerId="ADAL" clId="{E1317903-0E43-4FAC-A900-4D6121109CB5}" dt="2021-05-19T16:00:02.403" v="7494" actId="165"/>
          <ac:spMkLst>
            <pc:docMk/>
            <pc:sldMk cId="2894237854" sldId="378"/>
            <ac:spMk id="97" creationId="{84BB3614-EFE4-490C-BE66-CFB14B08C432}"/>
          </ac:spMkLst>
        </pc:spChg>
        <pc:spChg chg="del mod">
          <ac:chgData name="Warner,Jeffrey Barr" userId="7360d018-3b8a-4d6d-8136-e4d170e1e616" providerId="ADAL" clId="{E1317903-0E43-4FAC-A900-4D6121109CB5}" dt="2021-05-19T16:12:52.484" v="7918" actId="478"/>
          <ac:spMkLst>
            <pc:docMk/>
            <pc:sldMk cId="2894237854" sldId="378"/>
            <ac:spMk id="103" creationId="{5323A57F-F304-49FC-ACE5-12045D65CC14}"/>
          </ac:spMkLst>
        </pc:spChg>
        <pc:spChg chg="mod">
          <ac:chgData name="Warner,Jeffrey Barr" userId="7360d018-3b8a-4d6d-8136-e4d170e1e616" providerId="ADAL" clId="{E1317903-0E43-4FAC-A900-4D6121109CB5}" dt="2021-05-19T16:12:44.237" v="7911"/>
          <ac:spMkLst>
            <pc:docMk/>
            <pc:sldMk cId="2894237854" sldId="378"/>
            <ac:spMk id="105" creationId="{47048BCF-4BE4-4B5D-A04A-30E43452980A}"/>
          </ac:spMkLst>
        </pc:spChg>
        <pc:spChg chg="mod">
          <ac:chgData name="Warner,Jeffrey Barr" userId="7360d018-3b8a-4d6d-8136-e4d170e1e616" providerId="ADAL" clId="{E1317903-0E43-4FAC-A900-4D6121109CB5}" dt="2021-05-19T16:12:44.237" v="7911"/>
          <ac:spMkLst>
            <pc:docMk/>
            <pc:sldMk cId="2894237854" sldId="378"/>
            <ac:spMk id="106" creationId="{472C3EE8-FCA3-4B4D-BDC7-257758CD2BC1}"/>
          </ac:spMkLst>
        </pc:spChg>
        <pc:spChg chg="mod">
          <ac:chgData name="Warner,Jeffrey Barr" userId="7360d018-3b8a-4d6d-8136-e4d170e1e616" providerId="ADAL" clId="{E1317903-0E43-4FAC-A900-4D6121109CB5}" dt="2021-05-19T16:12:44.237" v="7911"/>
          <ac:spMkLst>
            <pc:docMk/>
            <pc:sldMk cId="2894237854" sldId="378"/>
            <ac:spMk id="107" creationId="{1ACFD095-1C52-41F6-B44A-E2A67E2E6030}"/>
          </ac:spMkLst>
        </pc:spChg>
        <pc:spChg chg="mod">
          <ac:chgData name="Warner,Jeffrey Barr" userId="7360d018-3b8a-4d6d-8136-e4d170e1e616" providerId="ADAL" clId="{E1317903-0E43-4FAC-A900-4D6121109CB5}" dt="2021-05-19T16:12:44.237" v="7911"/>
          <ac:spMkLst>
            <pc:docMk/>
            <pc:sldMk cId="2894237854" sldId="378"/>
            <ac:spMk id="108" creationId="{024C2F43-31E4-4862-A97D-AB14435E2585}"/>
          </ac:spMkLst>
        </pc:spChg>
        <pc:spChg chg="mod">
          <ac:chgData name="Warner,Jeffrey Barr" userId="7360d018-3b8a-4d6d-8136-e4d170e1e616" providerId="ADAL" clId="{E1317903-0E43-4FAC-A900-4D6121109CB5}" dt="2021-05-19T16:12:44.237" v="7911"/>
          <ac:spMkLst>
            <pc:docMk/>
            <pc:sldMk cId="2894237854" sldId="378"/>
            <ac:spMk id="109" creationId="{DAE76013-121C-46A3-88D2-28A08C04FAD4}"/>
          </ac:spMkLst>
        </pc:spChg>
        <pc:spChg chg="mod">
          <ac:chgData name="Warner,Jeffrey Barr" userId="7360d018-3b8a-4d6d-8136-e4d170e1e616" providerId="ADAL" clId="{E1317903-0E43-4FAC-A900-4D6121109CB5}" dt="2021-05-19T16:12:44.237" v="7911"/>
          <ac:spMkLst>
            <pc:docMk/>
            <pc:sldMk cId="2894237854" sldId="378"/>
            <ac:spMk id="110" creationId="{C45FDCF6-0814-42FE-8C1D-99AA8E558F10}"/>
          </ac:spMkLst>
        </pc:spChg>
        <pc:spChg chg="mod">
          <ac:chgData name="Warner,Jeffrey Barr" userId="7360d018-3b8a-4d6d-8136-e4d170e1e616" providerId="ADAL" clId="{E1317903-0E43-4FAC-A900-4D6121109CB5}" dt="2021-05-19T16:12:44.237" v="7911"/>
          <ac:spMkLst>
            <pc:docMk/>
            <pc:sldMk cId="2894237854" sldId="378"/>
            <ac:spMk id="111" creationId="{7DDB1B67-BAEB-4505-BB68-BFF93B04B30E}"/>
          </ac:spMkLst>
        </pc:spChg>
        <pc:spChg chg="mod topLvl">
          <ac:chgData name="Warner,Jeffrey Barr" userId="7360d018-3b8a-4d6d-8136-e4d170e1e616" providerId="ADAL" clId="{E1317903-0E43-4FAC-A900-4D6121109CB5}" dt="2021-05-19T16:13:17.994" v="7931" actId="1035"/>
          <ac:spMkLst>
            <pc:docMk/>
            <pc:sldMk cId="2894237854" sldId="378"/>
            <ac:spMk id="112" creationId="{87DBCD17-5877-4F64-8234-EDE677CCDF5C}"/>
          </ac:spMkLst>
        </pc:spChg>
        <pc:spChg chg="mod topLvl">
          <ac:chgData name="Warner,Jeffrey Barr" userId="7360d018-3b8a-4d6d-8136-e4d170e1e616" providerId="ADAL" clId="{E1317903-0E43-4FAC-A900-4D6121109CB5}" dt="2021-05-19T16:13:17.994" v="7931" actId="1035"/>
          <ac:spMkLst>
            <pc:docMk/>
            <pc:sldMk cId="2894237854" sldId="378"/>
            <ac:spMk id="113" creationId="{9F50A1E3-E37B-4D94-B34F-6F1ADEB105E1}"/>
          </ac:spMkLst>
        </pc:spChg>
        <pc:spChg chg="mod topLvl">
          <ac:chgData name="Warner,Jeffrey Barr" userId="7360d018-3b8a-4d6d-8136-e4d170e1e616" providerId="ADAL" clId="{E1317903-0E43-4FAC-A900-4D6121109CB5}" dt="2021-05-19T16:00:02.403" v="7494" actId="165"/>
          <ac:spMkLst>
            <pc:docMk/>
            <pc:sldMk cId="2894237854" sldId="378"/>
            <ac:spMk id="114" creationId="{D38FC863-A878-4573-B57C-AEB8FF6024BF}"/>
          </ac:spMkLst>
        </pc:spChg>
        <pc:spChg chg="mod">
          <ac:chgData name="Warner,Jeffrey Barr" userId="7360d018-3b8a-4d6d-8136-e4d170e1e616" providerId="ADAL" clId="{E1317903-0E43-4FAC-A900-4D6121109CB5}" dt="2021-05-19T16:12:44.237" v="7911"/>
          <ac:spMkLst>
            <pc:docMk/>
            <pc:sldMk cId="2894237854" sldId="378"/>
            <ac:spMk id="115" creationId="{8856B3FF-EF86-415B-8A26-DE5B4D6CA29D}"/>
          </ac:spMkLst>
        </pc:spChg>
        <pc:spChg chg="mod">
          <ac:chgData name="Warner,Jeffrey Barr" userId="7360d018-3b8a-4d6d-8136-e4d170e1e616" providerId="ADAL" clId="{E1317903-0E43-4FAC-A900-4D6121109CB5}" dt="2021-05-19T16:12:44.237" v="7911"/>
          <ac:spMkLst>
            <pc:docMk/>
            <pc:sldMk cId="2894237854" sldId="378"/>
            <ac:spMk id="116" creationId="{A05509DA-F209-46A9-BABD-C0ECFB9CBC79}"/>
          </ac:spMkLst>
        </pc:spChg>
        <pc:spChg chg="mod">
          <ac:chgData name="Warner,Jeffrey Barr" userId="7360d018-3b8a-4d6d-8136-e4d170e1e616" providerId="ADAL" clId="{E1317903-0E43-4FAC-A900-4D6121109CB5}" dt="2021-05-19T16:12:44.237" v="7911"/>
          <ac:spMkLst>
            <pc:docMk/>
            <pc:sldMk cId="2894237854" sldId="378"/>
            <ac:spMk id="117" creationId="{16CFC20F-A4CB-46EE-B646-D487D2CCCBD3}"/>
          </ac:spMkLst>
        </pc:spChg>
        <pc:spChg chg="mod">
          <ac:chgData name="Warner,Jeffrey Barr" userId="7360d018-3b8a-4d6d-8136-e4d170e1e616" providerId="ADAL" clId="{E1317903-0E43-4FAC-A900-4D6121109CB5}" dt="2021-05-19T16:12:44.237" v="7911"/>
          <ac:spMkLst>
            <pc:docMk/>
            <pc:sldMk cId="2894237854" sldId="378"/>
            <ac:spMk id="118" creationId="{01FF3DD0-508D-482A-9B1B-61FC1E022063}"/>
          </ac:spMkLst>
        </pc:spChg>
        <pc:spChg chg="mod">
          <ac:chgData name="Warner,Jeffrey Barr" userId="7360d018-3b8a-4d6d-8136-e4d170e1e616" providerId="ADAL" clId="{E1317903-0E43-4FAC-A900-4D6121109CB5}" dt="2021-05-19T16:12:44.237" v="7911"/>
          <ac:spMkLst>
            <pc:docMk/>
            <pc:sldMk cId="2894237854" sldId="378"/>
            <ac:spMk id="119" creationId="{FAE12AD1-65D6-4B7A-A585-A452A2F7C98C}"/>
          </ac:spMkLst>
        </pc:spChg>
        <pc:spChg chg="mod">
          <ac:chgData name="Warner,Jeffrey Barr" userId="7360d018-3b8a-4d6d-8136-e4d170e1e616" providerId="ADAL" clId="{E1317903-0E43-4FAC-A900-4D6121109CB5}" dt="2021-05-19T16:12:44.237" v="7911"/>
          <ac:spMkLst>
            <pc:docMk/>
            <pc:sldMk cId="2894237854" sldId="378"/>
            <ac:spMk id="120" creationId="{581E963F-D121-4787-8483-DB5CF5A14676}"/>
          </ac:spMkLst>
        </pc:spChg>
        <pc:spChg chg="mod">
          <ac:chgData name="Warner,Jeffrey Barr" userId="7360d018-3b8a-4d6d-8136-e4d170e1e616" providerId="ADAL" clId="{E1317903-0E43-4FAC-A900-4D6121109CB5}" dt="2021-05-19T16:12:44.237" v="7911"/>
          <ac:spMkLst>
            <pc:docMk/>
            <pc:sldMk cId="2894237854" sldId="378"/>
            <ac:spMk id="121" creationId="{A214A2AD-FA2D-4B6B-B62D-D5CD0DC23FE5}"/>
          </ac:spMkLst>
        </pc:spChg>
        <pc:spChg chg="mod">
          <ac:chgData name="Warner,Jeffrey Barr" userId="7360d018-3b8a-4d6d-8136-e4d170e1e616" providerId="ADAL" clId="{E1317903-0E43-4FAC-A900-4D6121109CB5}" dt="2021-05-19T16:12:44.237" v="7911"/>
          <ac:spMkLst>
            <pc:docMk/>
            <pc:sldMk cId="2894237854" sldId="378"/>
            <ac:spMk id="122" creationId="{A63FD554-0260-4AE3-A815-6E4270983F78}"/>
          </ac:spMkLst>
        </pc:spChg>
        <pc:spChg chg="mod">
          <ac:chgData name="Warner,Jeffrey Barr" userId="7360d018-3b8a-4d6d-8136-e4d170e1e616" providerId="ADAL" clId="{E1317903-0E43-4FAC-A900-4D6121109CB5}" dt="2021-05-19T16:12:44.237" v="7911"/>
          <ac:spMkLst>
            <pc:docMk/>
            <pc:sldMk cId="2894237854" sldId="378"/>
            <ac:spMk id="124" creationId="{733B0864-2532-4A38-9EE4-D4FC435D9572}"/>
          </ac:spMkLst>
        </pc:spChg>
        <pc:spChg chg="mod">
          <ac:chgData name="Warner,Jeffrey Barr" userId="7360d018-3b8a-4d6d-8136-e4d170e1e616" providerId="ADAL" clId="{E1317903-0E43-4FAC-A900-4D6121109CB5}" dt="2021-05-19T16:12:44.237" v="7911"/>
          <ac:spMkLst>
            <pc:docMk/>
            <pc:sldMk cId="2894237854" sldId="378"/>
            <ac:spMk id="125" creationId="{CD3CE06E-CB4C-4105-AAB1-8E3FA900BBDB}"/>
          </ac:spMkLst>
        </pc:spChg>
        <pc:spChg chg="mod topLvl">
          <ac:chgData name="Warner,Jeffrey Barr" userId="7360d018-3b8a-4d6d-8136-e4d170e1e616" providerId="ADAL" clId="{E1317903-0E43-4FAC-A900-4D6121109CB5}" dt="2021-05-19T16:00:02.403" v="7494" actId="165"/>
          <ac:spMkLst>
            <pc:docMk/>
            <pc:sldMk cId="2894237854" sldId="378"/>
            <ac:spMk id="127" creationId="{316C4A25-D3F8-4412-9A2C-2A63971BFAB0}"/>
          </ac:spMkLst>
        </pc:spChg>
        <pc:spChg chg="mod topLvl">
          <ac:chgData name="Warner,Jeffrey Barr" userId="7360d018-3b8a-4d6d-8136-e4d170e1e616" providerId="ADAL" clId="{E1317903-0E43-4FAC-A900-4D6121109CB5}" dt="2021-05-19T16:00:02.403" v="7494" actId="165"/>
          <ac:spMkLst>
            <pc:docMk/>
            <pc:sldMk cId="2894237854" sldId="378"/>
            <ac:spMk id="128" creationId="{0A78F162-921B-4523-9AC5-1FDC016AD6AA}"/>
          </ac:spMkLst>
        </pc:spChg>
        <pc:spChg chg="del mod">
          <ac:chgData name="Warner,Jeffrey Barr" userId="7360d018-3b8a-4d6d-8136-e4d170e1e616" providerId="ADAL" clId="{E1317903-0E43-4FAC-A900-4D6121109CB5}" dt="2021-05-19T16:12:53.586" v="7919" actId="478"/>
          <ac:spMkLst>
            <pc:docMk/>
            <pc:sldMk cId="2894237854" sldId="378"/>
            <ac:spMk id="129" creationId="{B10123F1-301B-41FF-8EDF-E41B0F128D2C}"/>
          </ac:spMkLst>
        </pc:spChg>
        <pc:spChg chg="del mod">
          <ac:chgData name="Warner,Jeffrey Barr" userId="7360d018-3b8a-4d6d-8136-e4d170e1e616" providerId="ADAL" clId="{E1317903-0E43-4FAC-A900-4D6121109CB5}" dt="2021-05-19T16:12:51.099" v="7917" actId="478"/>
          <ac:spMkLst>
            <pc:docMk/>
            <pc:sldMk cId="2894237854" sldId="378"/>
            <ac:spMk id="131" creationId="{DF729421-01A4-4BCC-BC10-43121F39DF55}"/>
          </ac:spMkLst>
        </pc:spChg>
        <pc:spChg chg="del mod">
          <ac:chgData name="Warner,Jeffrey Barr" userId="7360d018-3b8a-4d6d-8136-e4d170e1e616" providerId="ADAL" clId="{E1317903-0E43-4FAC-A900-4D6121109CB5}" dt="2021-05-19T16:12:50.197" v="7916" actId="478"/>
          <ac:spMkLst>
            <pc:docMk/>
            <pc:sldMk cId="2894237854" sldId="378"/>
            <ac:spMk id="132" creationId="{D54DA29E-958C-4E35-9DA8-9C5193FC589C}"/>
          </ac:spMkLst>
        </pc:spChg>
        <pc:spChg chg="del mod topLvl">
          <ac:chgData name="Warner,Jeffrey Barr" userId="7360d018-3b8a-4d6d-8136-e4d170e1e616" providerId="ADAL" clId="{E1317903-0E43-4FAC-A900-4D6121109CB5}" dt="2021-05-19T16:12:54.373" v="7920" actId="478"/>
          <ac:spMkLst>
            <pc:docMk/>
            <pc:sldMk cId="2894237854" sldId="378"/>
            <ac:spMk id="135" creationId="{610340DC-3E3D-4B4A-8EC9-0B97618194B0}"/>
          </ac:spMkLst>
        </pc:spChg>
        <pc:grpChg chg="add del mod">
          <ac:chgData name="Warner,Jeffrey Barr" userId="7360d018-3b8a-4d6d-8136-e4d170e1e616" providerId="ADAL" clId="{E1317903-0E43-4FAC-A900-4D6121109CB5}" dt="2021-04-22T16:33:15.383" v="323" actId="165"/>
          <ac:grpSpMkLst>
            <pc:docMk/>
            <pc:sldMk cId="2894237854" sldId="378"/>
            <ac:grpSpMk id="3" creationId="{F1021A29-7666-48BC-88BA-22C1E97003B6}"/>
          </ac:grpSpMkLst>
        </pc:grpChg>
        <pc:grpChg chg="del mod topLvl">
          <ac:chgData name="Warner,Jeffrey Barr" userId="7360d018-3b8a-4d6d-8136-e4d170e1e616" providerId="ADAL" clId="{E1317903-0E43-4FAC-A900-4D6121109CB5}" dt="2021-05-04T15:33:21.556" v="4261" actId="165"/>
          <ac:grpSpMkLst>
            <pc:docMk/>
            <pc:sldMk cId="2894237854" sldId="378"/>
            <ac:grpSpMk id="5" creationId="{96A9996D-3992-46E2-A878-1040C6E2AF2E}"/>
          </ac:grpSpMkLst>
        </pc:grpChg>
        <pc:grpChg chg="add mod">
          <ac:chgData name="Warner,Jeffrey Barr" userId="7360d018-3b8a-4d6d-8136-e4d170e1e616" providerId="ADAL" clId="{E1317903-0E43-4FAC-A900-4D6121109CB5}" dt="2021-05-19T16:13:17.994" v="7931" actId="1035"/>
          <ac:grpSpMkLst>
            <pc:docMk/>
            <pc:sldMk cId="2894237854" sldId="378"/>
            <ac:grpSpMk id="5" creationId="{D7BDF586-8F99-4644-9C9E-D04595647978}"/>
          </ac:grpSpMkLst>
        </pc:grpChg>
        <pc:grpChg chg="add del mod">
          <ac:chgData name="Warner,Jeffrey Barr" userId="7360d018-3b8a-4d6d-8136-e4d170e1e616" providerId="ADAL" clId="{E1317903-0E43-4FAC-A900-4D6121109CB5}" dt="2021-05-19T15:52:53.740" v="7088" actId="165"/>
          <ac:grpSpMkLst>
            <pc:docMk/>
            <pc:sldMk cId="2894237854" sldId="378"/>
            <ac:grpSpMk id="6" creationId="{3A446E8D-C1A2-4F27-8FBD-BA5A4E536C26}"/>
          </ac:grpSpMkLst>
        </pc:grpChg>
        <pc:grpChg chg="add del mod topLvl">
          <ac:chgData name="Warner,Jeffrey Barr" userId="7360d018-3b8a-4d6d-8136-e4d170e1e616" providerId="ADAL" clId="{E1317903-0E43-4FAC-A900-4D6121109CB5}" dt="2021-05-04T15:32:57.840" v="4249" actId="165"/>
          <ac:grpSpMkLst>
            <pc:docMk/>
            <pc:sldMk cId="2894237854" sldId="378"/>
            <ac:grpSpMk id="6" creationId="{B6BC5FF2-8820-4290-8C44-DBAFD2947B03}"/>
          </ac:grpSpMkLst>
        </pc:grpChg>
        <pc:grpChg chg="add del mod topLvl">
          <ac:chgData name="Warner,Jeffrey Barr" userId="7360d018-3b8a-4d6d-8136-e4d170e1e616" providerId="ADAL" clId="{E1317903-0E43-4FAC-A900-4D6121109CB5}" dt="2021-05-04T15:32:57.840" v="4249" actId="165"/>
          <ac:grpSpMkLst>
            <pc:docMk/>
            <pc:sldMk cId="2894237854" sldId="378"/>
            <ac:grpSpMk id="7" creationId="{1B080CB3-B55A-46B2-87A3-AD84D50FED90}"/>
          </ac:grpSpMkLst>
        </pc:grpChg>
        <pc:grpChg chg="mod topLvl">
          <ac:chgData name="Warner,Jeffrey Barr" userId="7360d018-3b8a-4d6d-8136-e4d170e1e616" providerId="ADAL" clId="{E1317903-0E43-4FAC-A900-4D6121109CB5}" dt="2021-05-19T16:00:02.403" v="7494" actId="165"/>
          <ac:grpSpMkLst>
            <pc:docMk/>
            <pc:sldMk cId="2894237854" sldId="378"/>
            <ac:grpSpMk id="10" creationId="{83212962-8050-47CD-9285-663E085CF81F}"/>
          </ac:grpSpMkLst>
        </pc:grpChg>
        <pc:grpChg chg="mod topLvl">
          <ac:chgData name="Warner,Jeffrey Barr" userId="7360d018-3b8a-4d6d-8136-e4d170e1e616" providerId="ADAL" clId="{E1317903-0E43-4FAC-A900-4D6121109CB5}" dt="2021-05-19T16:00:02.403" v="7494" actId="165"/>
          <ac:grpSpMkLst>
            <pc:docMk/>
            <pc:sldMk cId="2894237854" sldId="378"/>
            <ac:grpSpMk id="11" creationId="{FFA5EDA9-0C6A-4CD6-89DE-FB20C7C9E015}"/>
          </ac:grpSpMkLst>
        </pc:grpChg>
        <pc:grpChg chg="del mod topLvl">
          <ac:chgData name="Warner,Jeffrey Barr" userId="7360d018-3b8a-4d6d-8136-e4d170e1e616" providerId="ADAL" clId="{E1317903-0E43-4FAC-A900-4D6121109CB5}" dt="2021-05-04T15:32:58.148" v="4250" actId="165"/>
          <ac:grpSpMkLst>
            <pc:docMk/>
            <pc:sldMk cId="2894237854" sldId="378"/>
            <ac:grpSpMk id="14" creationId="{228B1148-9B8E-49F2-868D-E986DC4564CC}"/>
          </ac:grpSpMkLst>
        </pc:grpChg>
        <pc:grpChg chg="add del mod topLvl">
          <ac:chgData name="Warner,Jeffrey Barr" userId="7360d018-3b8a-4d6d-8136-e4d170e1e616" providerId="ADAL" clId="{E1317903-0E43-4FAC-A900-4D6121109CB5}" dt="2021-05-19T15:57:43.871" v="7321" actId="165"/>
          <ac:grpSpMkLst>
            <pc:docMk/>
            <pc:sldMk cId="2894237854" sldId="378"/>
            <ac:grpSpMk id="14" creationId="{4B0F30C8-6E7F-45A1-A64F-F96C48AB5A8F}"/>
          </ac:grpSpMkLst>
        </pc:grpChg>
        <pc:grpChg chg="add del mod topLvl">
          <ac:chgData name="Warner,Jeffrey Barr" userId="7360d018-3b8a-4d6d-8136-e4d170e1e616" providerId="ADAL" clId="{E1317903-0E43-4FAC-A900-4D6121109CB5}" dt="2021-05-19T15:57:43.239" v="7320" actId="165"/>
          <ac:grpSpMkLst>
            <pc:docMk/>
            <pc:sldMk cId="2894237854" sldId="378"/>
            <ac:grpSpMk id="15" creationId="{71AD3861-DC7A-4462-8A56-72E3F41B3D37}"/>
          </ac:grpSpMkLst>
        </pc:grpChg>
        <pc:grpChg chg="add del mod">
          <ac:chgData name="Warner,Jeffrey Barr" userId="7360d018-3b8a-4d6d-8136-e4d170e1e616" providerId="ADAL" clId="{E1317903-0E43-4FAC-A900-4D6121109CB5}" dt="2021-05-04T15:32:57.315" v="4248" actId="165"/>
          <ac:grpSpMkLst>
            <pc:docMk/>
            <pc:sldMk cId="2894237854" sldId="378"/>
            <ac:grpSpMk id="15" creationId="{EA61667D-3C35-4349-968D-3145BD4764AB}"/>
          </ac:grpSpMkLst>
        </pc:grpChg>
        <pc:grpChg chg="add del mod">
          <ac:chgData name="Warner,Jeffrey Barr" userId="7360d018-3b8a-4d6d-8136-e4d170e1e616" providerId="ADAL" clId="{E1317903-0E43-4FAC-A900-4D6121109CB5}" dt="2021-05-19T15:49:39.233" v="6971" actId="478"/>
          <ac:grpSpMkLst>
            <pc:docMk/>
            <pc:sldMk cId="2894237854" sldId="378"/>
            <ac:grpSpMk id="16" creationId="{BBC881AD-EA93-4534-8B77-9A803FF9A357}"/>
          </ac:grpSpMkLst>
        </pc:grpChg>
        <pc:grpChg chg="add del mod">
          <ac:chgData name="Warner,Jeffrey Barr" userId="7360d018-3b8a-4d6d-8136-e4d170e1e616" providerId="ADAL" clId="{E1317903-0E43-4FAC-A900-4D6121109CB5}" dt="2021-05-04T15:33:41.371" v="4321" actId="165"/>
          <ac:grpSpMkLst>
            <pc:docMk/>
            <pc:sldMk cId="2894237854" sldId="378"/>
            <ac:grpSpMk id="17" creationId="{5FBB1DFA-0EE6-49D7-ACFF-37B767345D7B}"/>
          </ac:grpSpMkLst>
        </pc:grpChg>
        <pc:grpChg chg="add del mod">
          <ac:chgData name="Warner,Jeffrey Barr" userId="7360d018-3b8a-4d6d-8136-e4d170e1e616" providerId="ADAL" clId="{E1317903-0E43-4FAC-A900-4D6121109CB5}" dt="2021-05-19T15:57:42.354" v="7319" actId="165"/>
          <ac:grpSpMkLst>
            <pc:docMk/>
            <pc:sldMk cId="2894237854" sldId="378"/>
            <ac:grpSpMk id="17" creationId="{EDA78BDF-3CE8-4B69-8B79-FFFBB359C679}"/>
          </ac:grpSpMkLst>
        </pc:grpChg>
        <pc:grpChg chg="add mod topLvl">
          <ac:chgData name="Warner,Jeffrey Barr" userId="7360d018-3b8a-4d6d-8136-e4d170e1e616" providerId="ADAL" clId="{E1317903-0E43-4FAC-A900-4D6121109CB5}" dt="2021-05-19T16:00:02.403" v="7494" actId="165"/>
          <ac:grpSpMkLst>
            <pc:docMk/>
            <pc:sldMk cId="2894237854" sldId="378"/>
            <ac:grpSpMk id="19" creationId="{6776551C-ABC0-4460-B4CD-3B1A220BFD01}"/>
          </ac:grpSpMkLst>
        </pc:grpChg>
        <pc:grpChg chg="add del mod">
          <ac:chgData name="Warner,Jeffrey Barr" userId="7360d018-3b8a-4d6d-8136-e4d170e1e616" providerId="ADAL" clId="{E1317903-0E43-4FAC-A900-4D6121109CB5}" dt="2021-05-19T15:58:34.181" v="7429" actId="165"/>
          <ac:grpSpMkLst>
            <pc:docMk/>
            <pc:sldMk cId="2894237854" sldId="378"/>
            <ac:grpSpMk id="57" creationId="{DD328E91-61AD-40DA-A87F-A7CCF6C80490}"/>
          </ac:grpSpMkLst>
        </pc:grpChg>
        <pc:grpChg chg="add del mod">
          <ac:chgData name="Warner,Jeffrey Barr" userId="7360d018-3b8a-4d6d-8136-e4d170e1e616" providerId="ADAL" clId="{E1317903-0E43-4FAC-A900-4D6121109CB5}" dt="2021-05-19T15:59:26.315" v="7485" actId="165"/>
          <ac:grpSpMkLst>
            <pc:docMk/>
            <pc:sldMk cId="2894237854" sldId="378"/>
            <ac:grpSpMk id="58" creationId="{99DFFFE0-3D3E-41CC-B300-5692AA2C7AD9}"/>
          </ac:grpSpMkLst>
        </pc:grpChg>
        <pc:grpChg chg="add mod topLvl">
          <ac:chgData name="Warner,Jeffrey Barr" userId="7360d018-3b8a-4d6d-8136-e4d170e1e616" providerId="ADAL" clId="{E1317903-0E43-4FAC-A900-4D6121109CB5}" dt="2021-05-19T16:00:02.403" v="7494" actId="165"/>
          <ac:grpSpMkLst>
            <pc:docMk/>
            <pc:sldMk cId="2894237854" sldId="378"/>
            <ac:grpSpMk id="60" creationId="{A5BAC891-7C65-409E-B58A-F066F66ABEB7}"/>
          </ac:grpSpMkLst>
        </pc:grpChg>
        <pc:grpChg chg="add mod">
          <ac:chgData name="Warner,Jeffrey Barr" userId="7360d018-3b8a-4d6d-8136-e4d170e1e616" providerId="ADAL" clId="{E1317903-0E43-4FAC-A900-4D6121109CB5}" dt="2021-05-19T15:52:57.989" v="7092" actId="571"/>
          <ac:grpSpMkLst>
            <pc:docMk/>
            <pc:sldMk cId="2894237854" sldId="378"/>
            <ac:grpSpMk id="73" creationId="{E851FBC2-F489-406A-9175-C8BBD42C67F4}"/>
          </ac:grpSpMkLst>
        </pc:grpChg>
        <pc:grpChg chg="add mod topLvl">
          <ac:chgData name="Warner,Jeffrey Barr" userId="7360d018-3b8a-4d6d-8136-e4d170e1e616" providerId="ADAL" clId="{E1317903-0E43-4FAC-A900-4D6121109CB5}" dt="2021-05-19T16:00:02.403" v="7494" actId="165"/>
          <ac:grpSpMkLst>
            <pc:docMk/>
            <pc:sldMk cId="2894237854" sldId="378"/>
            <ac:grpSpMk id="87" creationId="{94FAA5C9-0986-42A8-9BF1-8D2D2B22329B}"/>
          </ac:grpSpMkLst>
        </pc:grpChg>
        <pc:grpChg chg="add del mod">
          <ac:chgData name="Warner,Jeffrey Barr" userId="7360d018-3b8a-4d6d-8136-e4d170e1e616" providerId="ADAL" clId="{E1317903-0E43-4FAC-A900-4D6121109CB5}" dt="2021-05-19T16:00:02.403" v="7494" actId="165"/>
          <ac:grpSpMkLst>
            <pc:docMk/>
            <pc:sldMk cId="2894237854" sldId="378"/>
            <ac:grpSpMk id="89" creationId="{349C39E1-2B15-4A45-B7BC-068995B192B4}"/>
          </ac:grpSpMkLst>
        </pc:grpChg>
        <pc:grpChg chg="add del mod">
          <ac:chgData name="Warner,Jeffrey Barr" userId="7360d018-3b8a-4d6d-8136-e4d170e1e616" providerId="ADAL" clId="{E1317903-0E43-4FAC-A900-4D6121109CB5}" dt="2021-05-19T16:12:54.373" v="7920" actId="478"/>
          <ac:grpSpMkLst>
            <pc:docMk/>
            <pc:sldMk cId="2894237854" sldId="378"/>
            <ac:grpSpMk id="101" creationId="{2B4CDF5C-2D6C-4759-96F8-34294145B375}"/>
          </ac:grpSpMkLst>
        </pc:grpChg>
        <pc:grpChg chg="del mod">
          <ac:chgData name="Warner,Jeffrey Barr" userId="7360d018-3b8a-4d6d-8136-e4d170e1e616" providerId="ADAL" clId="{E1317903-0E43-4FAC-A900-4D6121109CB5}" dt="2021-05-19T16:12:53.586" v="7919" actId="478"/>
          <ac:grpSpMkLst>
            <pc:docMk/>
            <pc:sldMk cId="2894237854" sldId="378"/>
            <ac:grpSpMk id="102" creationId="{85F3132A-08F7-44AF-AEF7-09221E06DBB8}"/>
          </ac:grpSpMkLst>
        </pc:grpChg>
        <pc:grpChg chg="del mod topLvl">
          <ac:chgData name="Warner,Jeffrey Barr" userId="7360d018-3b8a-4d6d-8136-e4d170e1e616" providerId="ADAL" clId="{E1317903-0E43-4FAC-A900-4D6121109CB5}" dt="2021-05-19T16:13:02.621" v="7922" actId="478"/>
          <ac:grpSpMkLst>
            <pc:docMk/>
            <pc:sldMk cId="2894237854" sldId="378"/>
            <ac:grpSpMk id="104" creationId="{EAA95993-9E8A-4291-95F0-10CFBFE34FEF}"/>
          </ac:grpSpMkLst>
        </pc:grpChg>
        <pc:grpChg chg="del mod">
          <ac:chgData name="Warner,Jeffrey Barr" userId="7360d018-3b8a-4d6d-8136-e4d170e1e616" providerId="ADAL" clId="{E1317903-0E43-4FAC-A900-4D6121109CB5}" dt="2021-05-19T16:12:49.248" v="7915" actId="478"/>
          <ac:grpSpMkLst>
            <pc:docMk/>
            <pc:sldMk cId="2894237854" sldId="378"/>
            <ac:grpSpMk id="130" creationId="{453C7F45-44A0-41CD-B7CA-94B9E4AE256F}"/>
          </ac:grpSpMkLst>
        </pc:grpChg>
        <pc:graphicFrameChg chg="mod topLvl">
          <ac:chgData name="Warner,Jeffrey Barr" userId="7360d018-3b8a-4d6d-8136-e4d170e1e616" providerId="ADAL" clId="{E1317903-0E43-4FAC-A900-4D6121109CB5}" dt="2021-05-04T15:33:00.428" v="4251" actId="164"/>
          <ac:graphicFrameMkLst>
            <pc:docMk/>
            <pc:sldMk cId="2894237854" sldId="378"/>
            <ac:graphicFrameMk id="13" creationId="{0CE65638-3E52-4D10-8675-160C1447ECE8}"/>
          </ac:graphicFrameMkLst>
        </pc:graphicFrameChg>
        <pc:picChg chg="add mod">
          <ac:chgData name="Warner,Jeffrey Barr" userId="7360d018-3b8a-4d6d-8136-e4d170e1e616" providerId="ADAL" clId="{E1317903-0E43-4FAC-A900-4D6121109CB5}" dt="2021-05-19T16:13:17.994" v="7931" actId="1035"/>
          <ac:picMkLst>
            <pc:docMk/>
            <pc:sldMk cId="2894237854" sldId="378"/>
            <ac:picMk id="2" creationId="{5BB582AB-99E5-4EF2-A5B0-A1ACD630996E}"/>
          </ac:picMkLst>
        </pc:picChg>
        <pc:picChg chg="del mod topLvl">
          <ac:chgData name="Warner,Jeffrey Barr" userId="7360d018-3b8a-4d6d-8136-e4d170e1e616" providerId="ADAL" clId="{E1317903-0E43-4FAC-A900-4D6121109CB5}" dt="2021-05-03T17:19:09.223" v="3125" actId="478"/>
          <ac:picMkLst>
            <pc:docMk/>
            <pc:sldMk cId="2894237854" sldId="378"/>
            <ac:picMk id="2" creationId="{7B54F9D2-E1A0-49BE-82BF-DE55F709B834}"/>
          </ac:picMkLst>
        </pc:picChg>
        <pc:picChg chg="add del mod">
          <ac:chgData name="Warner,Jeffrey Barr" userId="7360d018-3b8a-4d6d-8136-e4d170e1e616" providerId="ADAL" clId="{E1317903-0E43-4FAC-A900-4D6121109CB5}" dt="2021-05-04T15:32:38.244" v="4238" actId="478"/>
          <ac:picMkLst>
            <pc:docMk/>
            <pc:sldMk cId="2894237854" sldId="378"/>
            <ac:picMk id="2" creationId="{BE0561D7-C15D-4F13-B0FA-0D159FDBB06D}"/>
          </ac:picMkLst>
        </pc:picChg>
        <pc:picChg chg="add del mod ord">
          <ac:chgData name="Warner,Jeffrey Barr" userId="7360d018-3b8a-4d6d-8136-e4d170e1e616" providerId="ADAL" clId="{E1317903-0E43-4FAC-A900-4D6121109CB5}" dt="2021-05-03T18:46:22.260" v="3140" actId="478"/>
          <ac:picMkLst>
            <pc:docMk/>
            <pc:sldMk cId="2894237854" sldId="378"/>
            <ac:picMk id="3" creationId="{0DCDCDD7-5200-4235-8C95-CA9FAEFA1DEF}"/>
          </ac:picMkLst>
        </pc:picChg>
        <pc:picChg chg="add del mod topLvl">
          <ac:chgData name="Warner,Jeffrey Barr" userId="7360d018-3b8a-4d6d-8136-e4d170e1e616" providerId="ADAL" clId="{E1317903-0E43-4FAC-A900-4D6121109CB5}" dt="2021-05-06T20:28:55.992" v="4477" actId="478"/>
          <ac:picMkLst>
            <pc:docMk/>
            <pc:sldMk cId="2894237854" sldId="378"/>
            <ac:picMk id="3" creationId="{BA76A234-4E04-4534-B3B8-2300832D873F}"/>
          </ac:picMkLst>
        </pc:picChg>
        <pc:picChg chg="add mod modCrop">
          <ac:chgData name="Warner,Jeffrey Barr" userId="7360d018-3b8a-4d6d-8136-e4d170e1e616" providerId="ADAL" clId="{E1317903-0E43-4FAC-A900-4D6121109CB5}" dt="2021-05-19T15:52:22.872" v="7081" actId="164"/>
          <ac:picMkLst>
            <pc:docMk/>
            <pc:sldMk cId="2894237854" sldId="378"/>
            <ac:picMk id="65" creationId="{2FF0C3E5-B7A4-4E14-93DC-A6151A3D358F}"/>
          </ac:picMkLst>
        </pc:picChg>
        <pc:picChg chg="mod">
          <ac:chgData name="Warner,Jeffrey Barr" userId="7360d018-3b8a-4d6d-8136-e4d170e1e616" providerId="ADAL" clId="{E1317903-0E43-4FAC-A900-4D6121109CB5}" dt="2021-05-19T15:52:57.989" v="7092" actId="571"/>
          <ac:picMkLst>
            <pc:docMk/>
            <pc:sldMk cId="2894237854" sldId="378"/>
            <ac:picMk id="74" creationId="{EF76477D-B79E-4A7F-AF50-EBD7C6B293C1}"/>
          </ac:picMkLst>
        </pc:picChg>
        <pc:picChg chg="add mod topLvl modCrop">
          <ac:chgData name="Warner,Jeffrey Barr" userId="7360d018-3b8a-4d6d-8136-e4d170e1e616" providerId="ADAL" clId="{E1317903-0E43-4FAC-A900-4D6121109CB5}" dt="2021-05-19T16:00:02.403" v="7494" actId="165"/>
          <ac:picMkLst>
            <pc:docMk/>
            <pc:sldMk cId="2894237854" sldId="378"/>
            <ac:picMk id="81" creationId="{4AF946A9-EC4E-465D-A126-F4C6ED1FBD4F}"/>
          </ac:picMkLst>
        </pc:picChg>
        <pc:picChg chg="add mod topLvl modCrop">
          <ac:chgData name="Warner,Jeffrey Barr" userId="7360d018-3b8a-4d6d-8136-e4d170e1e616" providerId="ADAL" clId="{E1317903-0E43-4FAC-A900-4D6121109CB5}" dt="2021-05-19T16:00:02.403" v="7494" actId="165"/>
          <ac:picMkLst>
            <pc:docMk/>
            <pc:sldMk cId="2894237854" sldId="378"/>
            <ac:picMk id="82" creationId="{837BDFBD-652C-48B3-BAAE-57532DB50F5D}"/>
          </ac:picMkLst>
        </pc:picChg>
        <pc:picChg chg="mod topLvl">
          <ac:chgData name="Warner,Jeffrey Barr" userId="7360d018-3b8a-4d6d-8136-e4d170e1e616" providerId="ADAL" clId="{E1317903-0E43-4FAC-A900-4D6121109CB5}" dt="2021-05-19T16:00:02.403" v="7494" actId="165"/>
          <ac:picMkLst>
            <pc:docMk/>
            <pc:sldMk cId="2894237854" sldId="378"/>
            <ac:picMk id="123" creationId="{4718C890-240F-4F3D-9F48-4B83EB72514B}"/>
          </ac:picMkLst>
        </pc:picChg>
        <pc:picChg chg="del mod">
          <ac:chgData name="Warner,Jeffrey Barr" userId="7360d018-3b8a-4d6d-8136-e4d170e1e616" providerId="ADAL" clId="{E1317903-0E43-4FAC-A900-4D6121109CB5}" dt="2021-05-19T16:12:48.378" v="7914" actId="478"/>
          <ac:picMkLst>
            <pc:docMk/>
            <pc:sldMk cId="2894237854" sldId="378"/>
            <ac:picMk id="126" creationId="{DCD4177A-8849-45F8-B5BC-010A43DFF422}"/>
          </ac:picMkLst>
        </pc:picChg>
        <pc:picChg chg="del mod">
          <ac:chgData name="Warner,Jeffrey Barr" userId="7360d018-3b8a-4d6d-8136-e4d170e1e616" providerId="ADAL" clId="{E1317903-0E43-4FAC-A900-4D6121109CB5}" dt="2021-05-19T16:12:49.248" v="7915" actId="478"/>
          <ac:picMkLst>
            <pc:docMk/>
            <pc:sldMk cId="2894237854" sldId="378"/>
            <ac:picMk id="133" creationId="{EA74F8AD-AF48-4081-A91C-458C47304CB2}"/>
          </ac:picMkLst>
        </pc:picChg>
        <pc:picChg chg="del mod">
          <ac:chgData name="Warner,Jeffrey Barr" userId="7360d018-3b8a-4d6d-8136-e4d170e1e616" providerId="ADAL" clId="{E1317903-0E43-4FAC-A900-4D6121109CB5}" dt="2021-05-19T16:12:47.376" v="7913" actId="478"/>
          <ac:picMkLst>
            <pc:docMk/>
            <pc:sldMk cId="2894237854" sldId="378"/>
            <ac:picMk id="134" creationId="{225DD348-1EA1-405C-83E2-D7453C7C35C2}"/>
          </ac:picMkLst>
        </pc:picChg>
      </pc:sldChg>
      <pc:sldChg chg="del modNotesTx">
        <pc:chgData name="Warner,Jeffrey Barr" userId="7360d018-3b8a-4d6d-8136-e4d170e1e616" providerId="ADAL" clId="{E1317903-0E43-4FAC-A900-4D6121109CB5}" dt="2021-05-10T16:45:18.026" v="5681" actId="47"/>
        <pc:sldMkLst>
          <pc:docMk/>
          <pc:sldMk cId="3804116424" sldId="380"/>
        </pc:sldMkLst>
      </pc:sldChg>
      <pc:sldChg chg="addSp delSp del mod">
        <pc:chgData name="Warner,Jeffrey Barr" userId="7360d018-3b8a-4d6d-8136-e4d170e1e616" providerId="ADAL" clId="{E1317903-0E43-4FAC-A900-4D6121109CB5}" dt="2021-05-20T16:56:22.361" v="8020" actId="2696"/>
        <pc:sldMkLst>
          <pc:docMk/>
          <pc:sldMk cId="3412200218" sldId="381"/>
        </pc:sldMkLst>
        <pc:spChg chg="add del">
          <ac:chgData name="Warner,Jeffrey Barr" userId="7360d018-3b8a-4d6d-8136-e4d170e1e616" providerId="ADAL" clId="{E1317903-0E43-4FAC-A900-4D6121109CB5}" dt="2021-05-04T17:59:39.572" v="4325" actId="22"/>
          <ac:spMkLst>
            <pc:docMk/>
            <pc:sldMk cId="3412200218" sldId="381"/>
            <ac:spMk id="5" creationId="{C0F20E73-9B20-472A-93C5-880EAB90C61B}"/>
          </ac:spMkLst>
        </pc:spChg>
        <pc:spChg chg="add del">
          <ac:chgData name="Warner,Jeffrey Barr" userId="7360d018-3b8a-4d6d-8136-e4d170e1e616" providerId="ADAL" clId="{E1317903-0E43-4FAC-A900-4D6121109CB5}" dt="2021-05-04T17:59:41.328" v="4327" actId="22"/>
          <ac:spMkLst>
            <pc:docMk/>
            <pc:sldMk cId="3412200218" sldId="381"/>
            <ac:spMk id="7" creationId="{611D3DFF-34D6-4C27-9C9B-30417DAA5E51}"/>
          </ac:spMkLst>
        </pc:spChg>
        <pc:picChg chg="del">
          <ac:chgData name="Warner,Jeffrey Barr" userId="7360d018-3b8a-4d6d-8136-e4d170e1e616" providerId="ADAL" clId="{E1317903-0E43-4FAC-A900-4D6121109CB5}" dt="2021-04-26T16:10:48.579" v="2015" actId="478"/>
          <ac:picMkLst>
            <pc:docMk/>
            <pc:sldMk cId="3412200218" sldId="381"/>
            <ac:picMk id="3" creationId="{7D809DC1-C353-4B28-ABD4-AFCD7C0F6DA8}"/>
          </ac:picMkLst>
        </pc:picChg>
        <pc:picChg chg="add del">
          <ac:chgData name="Warner,Jeffrey Barr" userId="7360d018-3b8a-4d6d-8136-e4d170e1e616" providerId="ADAL" clId="{E1317903-0E43-4FAC-A900-4D6121109CB5}" dt="2021-05-04T17:59:37.120" v="4323" actId="478"/>
          <ac:picMkLst>
            <pc:docMk/>
            <pc:sldMk cId="3412200218" sldId="381"/>
            <ac:picMk id="4" creationId="{93EC016B-0BA0-48F8-85DE-1F3D58F3FB1E}"/>
          </ac:picMkLst>
        </pc:picChg>
        <pc:picChg chg="add">
          <ac:chgData name="Warner,Jeffrey Barr" userId="7360d018-3b8a-4d6d-8136-e4d170e1e616" providerId="ADAL" clId="{E1317903-0E43-4FAC-A900-4D6121109CB5}" dt="2021-05-04T17:59:56.298" v="4328"/>
          <ac:picMkLst>
            <pc:docMk/>
            <pc:sldMk cId="3412200218" sldId="381"/>
            <ac:picMk id="8" creationId="{20B568C4-FE16-4D33-9930-B9E13FE04F12}"/>
          </ac:picMkLst>
        </pc:picChg>
      </pc:sldChg>
      <pc:sldChg chg="del">
        <pc:chgData name="Warner,Jeffrey Barr" userId="7360d018-3b8a-4d6d-8136-e4d170e1e616" providerId="ADAL" clId="{E1317903-0E43-4FAC-A900-4D6121109CB5}" dt="2021-05-20T16:56:22.361" v="8020" actId="2696"/>
        <pc:sldMkLst>
          <pc:docMk/>
          <pc:sldMk cId="578729457" sldId="383"/>
        </pc:sldMkLst>
      </pc:sldChg>
      <pc:sldChg chg="del">
        <pc:chgData name="Warner,Jeffrey Barr" userId="7360d018-3b8a-4d6d-8136-e4d170e1e616" providerId="ADAL" clId="{E1317903-0E43-4FAC-A900-4D6121109CB5}" dt="2021-05-10T16:45:18.026" v="5681" actId="47"/>
        <pc:sldMkLst>
          <pc:docMk/>
          <pc:sldMk cId="355849778" sldId="384"/>
        </pc:sldMkLst>
      </pc:sldChg>
      <pc:sldChg chg="del">
        <pc:chgData name="Warner,Jeffrey Barr" userId="7360d018-3b8a-4d6d-8136-e4d170e1e616" providerId="ADAL" clId="{E1317903-0E43-4FAC-A900-4D6121109CB5}" dt="2021-05-10T16:45:18.026" v="5681" actId="47"/>
        <pc:sldMkLst>
          <pc:docMk/>
          <pc:sldMk cId="3337703086" sldId="385"/>
        </pc:sldMkLst>
      </pc:sldChg>
      <pc:sldChg chg="addSp delSp modSp mod delCm">
        <pc:chgData name="Warner,Jeffrey Barr" userId="7360d018-3b8a-4d6d-8136-e4d170e1e616" providerId="ADAL" clId="{E1317903-0E43-4FAC-A900-4D6121109CB5}" dt="2021-05-20T17:01:54.647" v="8134" actId="20577"/>
        <pc:sldMkLst>
          <pc:docMk/>
          <pc:sldMk cId="2823416257" sldId="386"/>
        </pc:sldMkLst>
        <pc:spChg chg="del mod">
          <ac:chgData name="Warner,Jeffrey Barr" userId="7360d018-3b8a-4d6d-8136-e4d170e1e616" providerId="ADAL" clId="{E1317903-0E43-4FAC-A900-4D6121109CB5}" dt="2021-05-20T16:57:08.767" v="8026" actId="478"/>
          <ac:spMkLst>
            <pc:docMk/>
            <pc:sldMk cId="2823416257" sldId="386"/>
            <ac:spMk id="4" creationId="{1FFDC7BE-AE0B-A147-8969-5948A176CA10}"/>
          </ac:spMkLst>
        </pc:spChg>
        <pc:spChg chg="mod topLvl">
          <ac:chgData name="Warner,Jeffrey Barr" userId="7360d018-3b8a-4d6d-8136-e4d170e1e616" providerId="ADAL" clId="{E1317903-0E43-4FAC-A900-4D6121109CB5}" dt="2021-05-10T17:10:48.128" v="5810" actId="165"/>
          <ac:spMkLst>
            <pc:docMk/>
            <pc:sldMk cId="2823416257" sldId="386"/>
            <ac:spMk id="10" creationId="{769D35D3-9431-4C91-9BC4-051B93ABC7AD}"/>
          </ac:spMkLst>
        </pc:spChg>
        <pc:spChg chg="mod topLvl">
          <ac:chgData name="Warner,Jeffrey Barr" userId="7360d018-3b8a-4d6d-8136-e4d170e1e616" providerId="ADAL" clId="{E1317903-0E43-4FAC-A900-4D6121109CB5}" dt="2021-05-10T17:10:48.128" v="5810" actId="165"/>
          <ac:spMkLst>
            <pc:docMk/>
            <pc:sldMk cId="2823416257" sldId="386"/>
            <ac:spMk id="11" creationId="{464F6F2E-F016-42EA-8069-E8C19FFCFE46}"/>
          </ac:spMkLst>
        </pc:spChg>
        <pc:spChg chg="mod topLvl">
          <ac:chgData name="Warner,Jeffrey Barr" userId="7360d018-3b8a-4d6d-8136-e4d170e1e616" providerId="ADAL" clId="{E1317903-0E43-4FAC-A900-4D6121109CB5}" dt="2021-05-10T17:10:48.128" v="5810" actId="165"/>
          <ac:spMkLst>
            <pc:docMk/>
            <pc:sldMk cId="2823416257" sldId="386"/>
            <ac:spMk id="12" creationId="{53D2622A-68CC-4624-95F0-6200F063020B}"/>
          </ac:spMkLst>
        </pc:spChg>
        <pc:spChg chg="mod topLvl">
          <ac:chgData name="Warner,Jeffrey Barr" userId="7360d018-3b8a-4d6d-8136-e4d170e1e616" providerId="ADAL" clId="{E1317903-0E43-4FAC-A900-4D6121109CB5}" dt="2021-05-10T17:10:48.128" v="5810" actId="165"/>
          <ac:spMkLst>
            <pc:docMk/>
            <pc:sldMk cId="2823416257" sldId="386"/>
            <ac:spMk id="13" creationId="{419CA558-8D2F-4529-B459-497BC5A490A1}"/>
          </ac:spMkLst>
        </pc:spChg>
        <pc:spChg chg="mod topLvl">
          <ac:chgData name="Warner,Jeffrey Barr" userId="7360d018-3b8a-4d6d-8136-e4d170e1e616" providerId="ADAL" clId="{E1317903-0E43-4FAC-A900-4D6121109CB5}" dt="2021-05-10T17:10:48.128" v="5810" actId="165"/>
          <ac:spMkLst>
            <pc:docMk/>
            <pc:sldMk cId="2823416257" sldId="386"/>
            <ac:spMk id="14" creationId="{102A5AA5-7643-4EF9-9778-E6A4F61D4868}"/>
          </ac:spMkLst>
        </pc:spChg>
        <pc:spChg chg="mod topLvl">
          <ac:chgData name="Warner,Jeffrey Barr" userId="7360d018-3b8a-4d6d-8136-e4d170e1e616" providerId="ADAL" clId="{E1317903-0E43-4FAC-A900-4D6121109CB5}" dt="2021-05-10T17:10:48.128" v="5810" actId="165"/>
          <ac:spMkLst>
            <pc:docMk/>
            <pc:sldMk cId="2823416257" sldId="386"/>
            <ac:spMk id="15" creationId="{F370090F-7C32-4DF7-9684-91587FC4DD4D}"/>
          </ac:spMkLst>
        </pc:spChg>
        <pc:spChg chg="mod topLvl">
          <ac:chgData name="Warner,Jeffrey Barr" userId="7360d018-3b8a-4d6d-8136-e4d170e1e616" providerId="ADAL" clId="{E1317903-0E43-4FAC-A900-4D6121109CB5}" dt="2021-05-10T17:10:48.128" v="5810" actId="165"/>
          <ac:spMkLst>
            <pc:docMk/>
            <pc:sldMk cId="2823416257" sldId="386"/>
            <ac:spMk id="16" creationId="{D91C37EB-EAE9-431E-97F5-FA7B8263556D}"/>
          </ac:spMkLst>
        </pc:spChg>
        <pc:spChg chg="add mod">
          <ac:chgData name="Warner,Jeffrey Barr" userId="7360d018-3b8a-4d6d-8136-e4d170e1e616" providerId="ADAL" clId="{E1317903-0E43-4FAC-A900-4D6121109CB5}" dt="2021-05-20T17:01:54.647" v="8134" actId="20577"/>
          <ac:spMkLst>
            <pc:docMk/>
            <pc:sldMk cId="2823416257" sldId="386"/>
            <ac:spMk id="17" creationId="{5D10D50E-92FA-464A-901B-0A6FBBD00F74}"/>
          </ac:spMkLst>
        </pc:spChg>
        <pc:grpChg chg="add del mod">
          <ac:chgData name="Warner,Jeffrey Barr" userId="7360d018-3b8a-4d6d-8136-e4d170e1e616" providerId="ADAL" clId="{E1317903-0E43-4FAC-A900-4D6121109CB5}" dt="2021-05-10T17:10:48.128" v="5810" actId="165"/>
          <ac:grpSpMkLst>
            <pc:docMk/>
            <pc:sldMk cId="2823416257" sldId="386"/>
            <ac:grpSpMk id="2" creationId="{10C0BCA8-BC3F-485F-8870-7155641F138D}"/>
          </ac:grpSpMkLst>
        </pc:grpChg>
        <pc:grpChg chg="del">
          <ac:chgData name="Warner,Jeffrey Barr" userId="7360d018-3b8a-4d6d-8136-e4d170e1e616" providerId="ADAL" clId="{E1317903-0E43-4FAC-A900-4D6121109CB5}" dt="2021-05-10T17:09:49.312" v="5699" actId="478"/>
          <ac:grpSpMkLst>
            <pc:docMk/>
            <pc:sldMk cId="2823416257" sldId="386"/>
            <ac:grpSpMk id="5" creationId="{7E9EF5B5-AC8A-4C7A-854F-692A5EF6CF41}"/>
          </ac:grpSpMkLst>
        </pc:grpChg>
        <pc:graphicFrameChg chg="add del mod topLvl">
          <ac:chgData name="Warner,Jeffrey Barr" userId="7360d018-3b8a-4d6d-8136-e4d170e1e616" providerId="ADAL" clId="{E1317903-0E43-4FAC-A900-4D6121109CB5}" dt="2021-05-19T17:52:03.532" v="8000"/>
          <ac:graphicFrameMkLst>
            <pc:docMk/>
            <pc:sldMk cId="2823416257" sldId="386"/>
            <ac:graphicFrameMk id="3" creationId="{0C9BD14C-B8F5-486E-AE0C-616CEA8325E0}"/>
          </ac:graphicFrameMkLst>
        </pc:graphicFrameChg>
      </pc:sldChg>
      <pc:sldChg chg="addSp delSp modSp new mod">
        <pc:chgData name="Warner,Jeffrey Barr" userId="7360d018-3b8a-4d6d-8136-e4d170e1e616" providerId="ADAL" clId="{E1317903-0E43-4FAC-A900-4D6121109CB5}" dt="2021-05-20T17:01:59.487" v="8138" actId="20577"/>
        <pc:sldMkLst>
          <pc:docMk/>
          <pc:sldMk cId="500895388" sldId="387"/>
        </pc:sldMkLst>
        <pc:spChg chg="del">
          <ac:chgData name="Warner,Jeffrey Barr" userId="7360d018-3b8a-4d6d-8136-e4d170e1e616" providerId="ADAL" clId="{E1317903-0E43-4FAC-A900-4D6121109CB5}" dt="2021-04-22T16:47:38.054" v="1048" actId="478"/>
          <ac:spMkLst>
            <pc:docMk/>
            <pc:sldMk cId="500895388" sldId="387"/>
            <ac:spMk id="2" creationId="{8EDB7C20-D78A-4CFF-81FE-5590E1958916}"/>
          </ac:spMkLst>
        </pc:spChg>
        <pc:spChg chg="del">
          <ac:chgData name="Warner,Jeffrey Barr" userId="7360d018-3b8a-4d6d-8136-e4d170e1e616" providerId="ADAL" clId="{E1317903-0E43-4FAC-A900-4D6121109CB5}" dt="2021-04-22T16:47:38.486" v="1049" actId="478"/>
          <ac:spMkLst>
            <pc:docMk/>
            <pc:sldMk cId="500895388" sldId="387"/>
            <ac:spMk id="3" creationId="{907D1928-EC38-4987-8A49-E7E227213AAC}"/>
          </ac:spMkLst>
        </pc:spChg>
        <pc:spChg chg="add del mod">
          <ac:chgData name="Warner,Jeffrey Barr" userId="7360d018-3b8a-4d6d-8136-e4d170e1e616" providerId="ADAL" clId="{E1317903-0E43-4FAC-A900-4D6121109CB5}" dt="2021-05-20T16:59:34.453" v="8031" actId="478"/>
          <ac:spMkLst>
            <pc:docMk/>
            <pc:sldMk cId="500895388" sldId="387"/>
            <ac:spMk id="4" creationId="{3D8F291D-DFAD-46E7-A1B0-9A87B59D0FC0}"/>
          </ac:spMkLst>
        </pc:spChg>
        <pc:spChg chg="mod topLvl">
          <ac:chgData name="Warner,Jeffrey Barr" userId="7360d018-3b8a-4d6d-8136-e4d170e1e616" providerId="ADAL" clId="{E1317903-0E43-4FAC-A900-4D6121109CB5}" dt="2021-05-20T17:00:35.430" v="8063" actId="165"/>
          <ac:spMkLst>
            <pc:docMk/>
            <pc:sldMk cId="500895388" sldId="387"/>
            <ac:spMk id="20" creationId="{D5F2EBD1-A40F-4C3E-B966-62F068799F84}"/>
          </ac:spMkLst>
        </pc:spChg>
        <pc:spChg chg="mod topLvl">
          <ac:chgData name="Warner,Jeffrey Barr" userId="7360d018-3b8a-4d6d-8136-e4d170e1e616" providerId="ADAL" clId="{E1317903-0E43-4FAC-A900-4D6121109CB5}" dt="2021-05-20T17:00:35.430" v="8063" actId="165"/>
          <ac:spMkLst>
            <pc:docMk/>
            <pc:sldMk cId="500895388" sldId="387"/>
            <ac:spMk id="23" creationId="{F4D122E1-2D35-4330-8C12-32BEE8F651D2}"/>
          </ac:spMkLst>
        </pc:spChg>
        <pc:spChg chg="mod topLvl">
          <ac:chgData name="Warner,Jeffrey Barr" userId="7360d018-3b8a-4d6d-8136-e4d170e1e616" providerId="ADAL" clId="{E1317903-0E43-4FAC-A900-4D6121109CB5}" dt="2021-05-20T17:00:35.430" v="8063" actId="165"/>
          <ac:spMkLst>
            <pc:docMk/>
            <pc:sldMk cId="500895388" sldId="387"/>
            <ac:spMk id="26" creationId="{A899D248-E465-4E69-BCF7-37B2EA89BE59}"/>
          </ac:spMkLst>
        </pc:spChg>
        <pc:spChg chg="mod topLvl">
          <ac:chgData name="Warner,Jeffrey Barr" userId="7360d018-3b8a-4d6d-8136-e4d170e1e616" providerId="ADAL" clId="{E1317903-0E43-4FAC-A900-4D6121109CB5}" dt="2021-05-20T17:00:35.430" v="8063" actId="165"/>
          <ac:spMkLst>
            <pc:docMk/>
            <pc:sldMk cId="500895388" sldId="387"/>
            <ac:spMk id="27" creationId="{EA363D24-F46D-4BCA-9F29-31125FDB59B9}"/>
          </ac:spMkLst>
        </pc:spChg>
        <pc:spChg chg="mod topLvl">
          <ac:chgData name="Warner,Jeffrey Barr" userId="7360d018-3b8a-4d6d-8136-e4d170e1e616" providerId="ADAL" clId="{E1317903-0E43-4FAC-A900-4D6121109CB5}" dt="2021-05-20T17:00:35.430" v="8063" actId="165"/>
          <ac:spMkLst>
            <pc:docMk/>
            <pc:sldMk cId="500895388" sldId="387"/>
            <ac:spMk id="32" creationId="{55314C5A-69BD-47E5-B562-70A86A9F7033}"/>
          </ac:spMkLst>
        </pc:spChg>
        <pc:spChg chg="mod topLvl">
          <ac:chgData name="Warner,Jeffrey Barr" userId="7360d018-3b8a-4d6d-8136-e4d170e1e616" providerId="ADAL" clId="{E1317903-0E43-4FAC-A900-4D6121109CB5}" dt="2021-05-20T17:00:35.430" v="8063" actId="165"/>
          <ac:spMkLst>
            <pc:docMk/>
            <pc:sldMk cId="500895388" sldId="387"/>
            <ac:spMk id="33" creationId="{0990AD1F-3F99-41EA-BD73-CCF27691F7C6}"/>
          </ac:spMkLst>
        </pc:spChg>
        <pc:spChg chg="add del mod">
          <ac:chgData name="Warner,Jeffrey Barr" userId="7360d018-3b8a-4d6d-8136-e4d170e1e616" providerId="ADAL" clId="{E1317903-0E43-4FAC-A900-4D6121109CB5}" dt="2021-05-20T17:01:56.898" v="8136"/>
          <ac:spMkLst>
            <pc:docMk/>
            <pc:sldMk cId="500895388" sldId="387"/>
            <ac:spMk id="34" creationId="{AD93AF46-5165-4FF5-A14E-2363A47C657C}"/>
          </ac:spMkLst>
        </pc:spChg>
        <pc:spChg chg="add mod">
          <ac:chgData name="Warner,Jeffrey Barr" userId="7360d018-3b8a-4d6d-8136-e4d170e1e616" providerId="ADAL" clId="{E1317903-0E43-4FAC-A900-4D6121109CB5}" dt="2021-05-20T17:01:59.487" v="8138" actId="20577"/>
          <ac:spMkLst>
            <pc:docMk/>
            <pc:sldMk cId="500895388" sldId="387"/>
            <ac:spMk id="36" creationId="{93E99861-F1D9-4357-BC92-3B6086E6C9CD}"/>
          </ac:spMkLst>
        </pc:spChg>
        <pc:spChg chg="add mod topLvl">
          <ac:chgData name="Warner,Jeffrey Barr" userId="7360d018-3b8a-4d6d-8136-e4d170e1e616" providerId="ADAL" clId="{E1317903-0E43-4FAC-A900-4D6121109CB5}" dt="2021-05-20T17:00:35.430" v="8063" actId="165"/>
          <ac:spMkLst>
            <pc:docMk/>
            <pc:sldMk cId="500895388" sldId="387"/>
            <ac:spMk id="38" creationId="{85F52613-BFCE-4902-BDE8-EA4E928C8BFB}"/>
          </ac:spMkLst>
        </pc:spChg>
        <pc:spChg chg="add mod topLvl">
          <ac:chgData name="Warner,Jeffrey Barr" userId="7360d018-3b8a-4d6d-8136-e4d170e1e616" providerId="ADAL" clId="{E1317903-0E43-4FAC-A900-4D6121109CB5}" dt="2021-05-20T17:00:35.430" v="8063" actId="165"/>
          <ac:spMkLst>
            <pc:docMk/>
            <pc:sldMk cId="500895388" sldId="387"/>
            <ac:spMk id="39" creationId="{EC358F75-276E-439A-8994-677D5EC79E0A}"/>
          </ac:spMkLst>
        </pc:spChg>
        <pc:grpChg chg="add del mod">
          <ac:chgData name="Warner,Jeffrey Barr" userId="7360d018-3b8a-4d6d-8136-e4d170e1e616" providerId="ADAL" clId="{E1317903-0E43-4FAC-A900-4D6121109CB5}" dt="2021-05-20T17:00:35.430" v="8063" actId="165"/>
          <ac:grpSpMkLst>
            <pc:docMk/>
            <pc:sldMk cId="500895388" sldId="387"/>
            <ac:grpSpMk id="2" creationId="{E9742882-3C6D-45A3-B9FB-AB3C651F9E80}"/>
          </ac:grpSpMkLst>
        </pc:grpChg>
        <pc:grpChg chg="add del mod">
          <ac:chgData name="Warner,Jeffrey Barr" userId="7360d018-3b8a-4d6d-8136-e4d170e1e616" providerId="ADAL" clId="{E1317903-0E43-4FAC-A900-4D6121109CB5}" dt="2021-04-22T16:52:48.516" v="1068" actId="165"/>
          <ac:grpSpMkLst>
            <pc:docMk/>
            <pc:sldMk cId="500895388" sldId="387"/>
            <ac:grpSpMk id="5" creationId="{E99C0D90-7B79-4AAD-91D9-F2B621371008}"/>
          </ac:grpSpMkLst>
        </pc:grpChg>
        <pc:grpChg chg="del mod">
          <ac:chgData name="Warner,Jeffrey Barr" userId="7360d018-3b8a-4d6d-8136-e4d170e1e616" providerId="ADAL" clId="{E1317903-0E43-4FAC-A900-4D6121109CB5}" dt="2021-04-22T16:52:46.649" v="1067" actId="478"/>
          <ac:grpSpMkLst>
            <pc:docMk/>
            <pc:sldMk cId="500895388" sldId="387"/>
            <ac:grpSpMk id="7" creationId="{32F2EE57-AAB9-4139-80EA-57DEB10E7B59}"/>
          </ac:grpSpMkLst>
        </pc:grpChg>
        <pc:grpChg chg="del mod">
          <ac:chgData name="Warner,Jeffrey Barr" userId="7360d018-3b8a-4d6d-8136-e4d170e1e616" providerId="ADAL" clId="{E1317903-0E43-4FAC-A900-4D6121109CB5}" dt="2021-04-22T16:52:45.878" v="1066" actId="478"/>
          <ac:grpSpMkLst>
            <pc:docMk/>
            <pc:sldMk cId="500895388" sldId="387"/>
            <ac:grpSpMk id="8" creationId="{3538E4C3-1EC8-49C6-8F5C-58E53662C22C}"/>
          </ac:grpSpMkLst>
        </pc:grpChg>
        <pc:grpChg chg="add del mod">
          <ac:chgData name="Warner,Jeffrey Barr" userId="7360d018-3b8a-4d6d-8136-e4d170e1e616" providerId="ADAL" clId="{E1317903-0E43-4FAC-A900-4D6121109CB5}" dt="2021-04-22T16:54:46.828" v="1087" actId="165"/>
          <ac:grpSpMkLst>
            <pc:docMk/>
            <pc:sldMk cId="500895388" sldId="387"/>
            <ac:grpSpMk id="40" creationId="{D76B42DE-7EF4-485F-AF48-015C16A6C04C}"/>
          </ac:grpSpMkLst>
        </pc:grpChg>
        <pc:picChg chg="del mod">
          <ac:chgData name="Warner,Jeffrey Barr" userId="7360d018-3b8a-4d6d-8136-e4d170e1e616" providerId="ADAL" clId="{E1317903-0E43-4FAC-A900-4D6121109CB5}" dt="2021-04-22T16:52:45.878" v="1066" actId="478"/>
          <ac:picMkLst>
            <pc:docMk/>
            <pc:sldMk cId="500895388" sldId="387"/>
            <ac:picMk id="34" creationId="{8645572D-F0BC-416B-9F07-42E90AE6165A}"/>
          </ac:picMkLst>
        </pc:picChg>
        <pc:picChg chg="mod topLvl">
          <ac:chgData name="Warner,Jeffrey Barr" userId="7360d018-3b8a-4d6d-8136-e4d170e1e616" providerId="ADAL" clId="{E1317903-0E43-4FAC-A900-4D6121109CB5}" dt="2021-05-20T17:00:35.430" v="8063" actId="165"/>
          <ac:picMkLst>
            <pc:docMk/>
            <pc:sldMk cId="500895388" sldId="387"/>
            <ac:picMk id="35" creationId="{3AADA615-2C7D-4049-9F67-79DE2EA3F73E}"/>
          </ac:picMkLst>
        </pc:picChg>
        <pc:picChg chg="del mod">
          <ac:chgData name="Warner,Jeffrey Barr" userId="7360d018-3b8a-4d6d-8136-e4d170e1e616" providerId="ADAL" clId="{E1317903-0E43-4FAC-A900-4D6121109CB5}" dt="2021-04-22T16:52:46.649" v="1067" actId="478"/>
          <ac:picMkLst>
            <pc:docMk/>
            <pc:sldMk cId="500895388" sldId="387"/>
            <ac:picMk id="36" creationId="{A4FE986B-A7C2-4B7A-BA40-169227714B45}"/>
          </ac:picMkLst>
        </pc:picChg>
        <pc:picChg chg="mod topLvl">
          <ac:chgData name="Warner,Jeffrey Barr" userId="7360d018-3b8a-4d6d-8136-e4d170e1e616" providerId="ADAL" clId="{E1317903-0E43-4FAC-A900-4D6121109CB5}" dt="2021-05-20T17:00:35.430" v="8063" actId="165"/>
          <ac:picMkLst>
            <pc:docMk/>
            <pc:sldMk cId="500895388" sldId="387"/>
            <ac:picMk id="37" creationId="{599F067C-687A-437F-BAA7-BC472C98C2C8}"/>
          </ac:picMkLst>
        </pc:picChg>
        <pc:cxnChg chg="mod topLvl">
          <ac:chgData name="Warner,Jeffrey Barr" userId="7360d018-3b8a-4d6d-8136-e4d170e1e616" providerId="ADAL" clId="{E1317903-0E43-4FAC-A900-4D6121109CB5}" dt="2021-05-20T17:00:35.430" v="8063" actId="165"/>
          <ac:cxnSpMkLst>
            <pc:docMk/>
            <pc:sldMk cId="500895388" sldId="387"/>
            <ac:cxnSpMk id="6" creationId="{395B6ED9-7DA4-4366-A837-AFE63DC12B40}"/>
          </ac:cxnSpMkLst>
        </pc:cxnChg>
        <pc:cxnChg chg="mod topLvl">
          <ac:chgData name="Warner,Jeffrey Barr" userId="7360d018-3b8a-4d6d-8136-e4d170e1e616" providerId="ADAL" clId="{E1317903-0E43-4FAC-A900-4D6121109CB5}" dt="2021-05-20T17:00:35.430" v="8063" actId="165"/>
          <ac:cxnSpMkLst>
            <pc:docMk/>
            <pc:sldMk cId="500895388" sldId="387"/>
            <ac:cxnSpMk id="9" creationId="{6A15EC55-02EE-4D9F-B9DA-6DD97C91BFEF}"/>
          </ac:cxnSpMkLst>
        </pc:cxnChg>
        <pc:cxnChg chg="mod topLvl">
          <ac:chgData name="Warner,Jeffrey Barr" userId="7360d018-3b8a-4d6d-8136-e4d170e1e616" providerId="ADAL" clId="{E1317903-0E43-4FAC-A900-4D6121109CB5}" dt="2021-05-20T17:00:35.430" v="8063" actId="165"/>
          <ac:cxnSpMkLst>
            <pc:docMk/>
            <pc:sldMk cId="500895388" sldId="387"/>
            <ac:cxnSpMk id="10" creationId="{8D1B4E2B-7115-48A0-A29E-69633013A0F0}"/>
          </ac:cxnSpMkLst>
        </pc:cxnChg>
        <pc:cxnChg chg="mod topLvl">
          <ac:chgData name="Warner,Jeffrey Barr" userId="7360d018-3b8a-4d6d-8136-e4d170e1e616" providerId="ADAL" clId="{E1317903-0E43-4FAC-A900-4D6121109CB5}" dt="2021-05-20T17:00:35.430" v="8063" actId="165"/>
          <ac:cxnSpMkLst>
            <pc:docMk/>
            <pc:sldMk cId="500895388" sldId="387"/>
            <ac:cxnSpMk id="11" creationId="{6D02F568-6BA8-48B6-9BDB-EF0FF4B58354}"/>
          </ac:cxnSpMkLst>
        </pc:cxnChg>
        <pc:cxnChg chg="mod topLvl">
          <ac:chgData name="Warner,Jeffrey Barr" userId="7360d018-3b8a-4d6d-8136-e4d170e1e616" providerId="ADAL" clId="{E1317903-0E43-4FAC-A900-4D6121109CB5}" dt="2021-05-20T17:00:35.430" v="8063" actId="165"/>
          <ac:cxnSpMkLst>
            <pc:docMk/>
            <pc:sldMk cId="500895388" sldId="387"/>
            <ac:cxnSpMk id="12" creationId="{D76ED3C3-C5A1-49C6-9758-C471F1EE88CE}"/>
          </ac:cxnSpMkLst>
        </pc:cxnChg>
        <pc:cxnChg chg="mod topLvl">
          <ac:chgData name="Warner,Jeffrey Barr" userId="7360d018-3b8a-4d6d-8136-e4d170e1e616" providerId="ADAL" clId="{E1317903-0E43-4FAC-A900-4D6121109CB5}" dt="2021-05-20T17:00:35.430" v="8063" actId="165"/>
          <ac:cxnSpMkLst>
            <pc:docMk/>
            <pc:sldMk cId="500895388" sldId="387"/>
            <ac:cxnSpMk id="13" creationId="{338AE405-8908-4FE4-938F-84176CA9AD2F}"/>
          </ac:cxnSpMkLst>
        </pc:cxnChg>
        <pc:cxnChg chg="mod topLvl">
          <ac:chgData name="Warner,Jeffrey Barr" userId="7360d018-3b8a-4d6d-8136-e4d170e1e616" providerId="ADAL" clId="{E1317903-0E43-4FAC-A900-4D6121109CB5}" dt="2021-05-20T17:00:35.430" v="8063" actId="165"/>
          <ac:cxnSpMkLst>
            <pc:docMk/>
            <pc:sldMk cId="500895388" sldId="387"/>
            <ac:cxnSpMk id="14" creationId="{E97228CE-B501-4E46-A4A8-2F7A3471A60A}"/>
          </ac:cxnSpMkLst>
        </pc:cxnChg>
        <pc:cxnChg chg="mod topLvl">
          <ac:chgData name="Warner,Jeffrey Barr" userId="7360d018-3b8a-4d6d-8136-e4d170e1e616" providerId="ADAL" clId="{E1317903-0E43-4FAC-A900-4D6121109CB5}" dt="2021-05-20T17:00:35.430" v="8063" actId="165"/>
          <ac:cxnSpMkLst>
            <pc:docMk/>
            <pc:sldMk cId="500895388" sldId="387"/>
            <ac:cxnSpMk id="15" creationId="{59CFF1C0-658A-4E1E-9ADF-CD9DFEB43E63}"/>
          </ac:cxnSpMkLst>
        </pc:cxnChg>
        <pc:cxnChg chg="mod topLvl">
          <ac:chgData name="Warner,Jeffrey Barr" userId="7360d018-3b8a-4d6d-8136-e4d170e1e616" providerId="ADAL" clId="{E1317903-0E43-4FAC-A900-4D6121109CB5}" dt="2021-05-20T17:00:35.430" v="8063" actId="165"/>
          <ac:cxnSpMkLst>
            <pc:docMk/>
            <pc:sldMk cId="500895388" sldId="387"/>
            <ac:cxnSpMk id="16" creationId="{76CC09E9-D02C-425F-9337-E04D702F9BD8}"/>
          </ac:cxnSpMkLst>
        </pc:cxnChg>
        <pc:cxnChg chg="mod topLvl">
          <ac:chgData name="Warner,Jeffrey Barr" userId="7360d018-3b8a-4d6d-8136-e4d170e1e616" providerId="ADAL" clId="{E1317903-0E43-4FAC-A900-4D6121109CB5}" dt="2021-05-20T17:00:35.430" v="8063" actId="165"/>
          <ac:cxnSpMkLst>
            <pc:docMk/>
            <pc:sldMk cId="500895388" sldId="387"/>
            <ac:cxnSpMk id="17" creationId="{142140F6-BF1E-4EBC-B9FA-3767EC13EF89}"/>
          </ac:cxnSpMkLst>
        </pc:cxnChg>
        <pc:cxnChg chg="mod topLvl">
          <ac:chgData name="Warner,Jeffrey Barr" userId="7360d018-3b8a-4d6d-8136-e4d170e1e616" providerId="ADAL" clId="{E1317903-0E43-4FAC-A900-4D6121109CB5}" dt="2021-05-20T17:00:35.430" v="8063" actId="165"/>
          <ac:cxnSpMkLst>
            <pc:docMk/>
            <pc:sldMk cId="500895388" sldId="387"/>
            <ac:cxnSpMk id="18" creationId="{0A30C435-3102-4ACB-9467-62CC473C044C}"/>
          </ac:cxnSpMkLst>
        </pc:cxnChg>
        <pc:cxnChg chg="mod topLvl">
          <ac:chgData name="Warner,Jeffrey Barr" userId="7360d018-3b8a-4d6d-8136-e4d170e1e616" providerId="ADAL" clId="{E1317903-0E43-4FAC-A900-4D6121109CB5}" dt="2021-05-20T17:00:35.430" v="8063" actId="165"/>
          <ac:cxnSpMkLst>
            <pc:docMk/>
            <pc:sldMk cId="500895388" sldId="387"/>
            <ac:cxnSpMk id="19" creationId="{F2120FD0-7445-4A91-AF59-51049EF867E9}"/>
          </ac:cxnSpMkLst>
        </pc:cxnChg>
        <pc:cxnChg chg="mod topLvl">
          <ac:chgData name="Warner,Jeffrey Barr" userId="7360d018-3b8a-4d6d-8136-e4d170e1e616" providerId="ADAL" clId="{E1317903-0E43-4FAC-A900-4D6121109CB5}" dt="2021-05-20T17:00:35.430" v="8063" actId="165"/>
          <ac:cxnSpMkLst>
            <pc:docMk/>
            <pc:sldMk cId="500895388" sldId="387"/>
            <ac:cxnSpMk id="21" creationId="{84DE7BA6-7013-4D40-8932-DA76D745E644}"/>
          </ac:cxnSpMkLst>
        </pc:cxnChg>
        <pc:cxnChg chg="mod topLvl">
          <ac:chgData name="Warner,Jeffrey Barr" userId="7360d018-3b8a-4d6d-8136-e4d170e1e616" providerId="ADAL" clId="{E1317903-0E43-4FAC-A900-4D6121109CB5}" dt="2021-05-20T17:00:35.430" v="8063" actId="165"/>
          <ac:cxnSpMkLst>
            <pc:docMk/>
            <pc:sldMk cId="500895388" sldId="387"/>
            <ac:cxnSpMk id="22" creationId="{9797CBF6-F506-45AA-AC2A-A4F663FCE1AC}"/>
          </ac:cxnSpMkLst>
        </pc:cxnChg>
        <pc:cxnChg chg="mod topLvl">
          <ac:chgData name="Warner,Jeffrey Barr" userId="7360d018-3b8a-4d6d-8136-e4d170e1e616" providerId="ADAL" clId="{E1317903-0E43-4FAC-A900-4D6121109CB5}" dt="2021-05-20T17:00:35.430" v="8063" actId="165"/>
          <ac:cxnSpMkLst>
            <pc:docMk/>
            <pc:sldMk cId="500895388" sldId="387"/>
            <ac:cxnSpMk id="24" creationId="{A3B27491-29AE-432D-8B99-600155DA71E1}"/>
          </ac:cxnSpMkLst>
        </pc:cxnChg>
        <pc:cxnChg chg="mod topLvl">
          <ac:chgData name="Warner,Jeffrey Barr" userId="7360d018-3b8a-4d6d-8136-e4d170e1e616" providerId="ADAL" clId="{E1317903-0E43-4FAC-A900-4D6121109CB5}" dt="2021-05-20T17:00:35.430" v="8063" actId="165"/>
          <ac:cxnSpMkLst>
            <pc:docMk/>
            <pc:sldMk cId="500895388" sldId="387"/>
            <ac:cxnSpMk id="25" creationId="{6C0259AF-6B97-49EE-8B7B-442B3295D1EC}"/>
          </ac:cxnSpMkLst>
        </pc:cxnChg>
        <pc:cxnChg chg="mod topLvl">
          <ac:chgData name="Warner,Jeffrey Barr" userId="7360d018-3b8a-4d6d-8136-e4d170e1e616" providerId="ADAL" clId="{E1317903-0E43-4FAC-A900-4D6121109CB5}" dt="2021-05-20T17:00:35.430" v="8063" actId="165"/>
          <ac:cxnSpMkLst>
            <pc:docMk/>
            <pc:sldMk cId="500895388" sldId="387"/>
            <ac:cxnSpMk id="28" creationId="{F35E8952-6D2A-4DA5-A4E5-CE310699DACF}"/>
          </ac:cxnSpMkLst>
        </pc:cxnChg>
        <pc:cxnChg chg="mod topLvl">
          <ac:chgData name="Warner,Jeffrey Barr" userId="7360d018-3b8a-4d6d-8136-e4d170e1e616" providerId="ADAL" clId="{E1317903-0E43-4FAC-A900-4D6121109CB5}" dt="2021-05-20T17:00:35.430" v="8063" actId="165"/>
          <ac:cxnSpMkLst>
            <pc:docMk/>
            <pc:sldMk cId="500895388" sldId="387"/>
            <ac:cxnSpMk id="29" creationId="{EA493C78-98D4-436E-B212-B750682CCB18}"/>
          </ac:cxnSpMkLst>
        </pc:cxnChg>
        <pc:cxnChg chg="mod topLvl">
          <ac:chgData name="Warner,Jeffrey Barr" userId="7360d018-3b8a-4d6d-8136-e4d170e1e616" providerId="ADAL" clId="{E1317903-0E43-4FAC-A900-4D6121109CB5}" dt="2021-05-20T17:00:35.430" v="8063" actId="165"/>
          <ac:cxnSpMkLst>
            <pc:docMk/>
            <pc:sldMk cId="500895388" sldId="387"/>
            <ac:cxnSpMk id="30" creationId="{64B2CAE6-25FF-4CB1-B8AE-E3F5ADCA59E3}"/>
          </ac:cxnSpMkLst>
        </pc:cxnChg>
        <pc:cxnChg chg="mod topLvl">
          <ac:chgData name="Warner,Jeffrey Barr" userId="7360d018-3b8a-4d6d-8136-e4d170e1e616" providerId="ADAL" clId="{E1317903-0E43-4FAC-A900-4D6121109CB5}" dt="2021-05-20T17:00:35.430" v="8063" actId="165"/>
          <ac:cxnSpMkLst>
            <pc:docMk/>
            <pc:sldMk cId="500895388" sldId="387"/>
            <ac:cxnSpMk id="31" creationId="{F7EF77F0-ED27-4C8E-BCA8-CB9228C555BE}"/>
          </ac:cxnSpMkLst>
        </pc:cxnChg>
      </pc:sldChg>
      <pc:sldChg chg="addSp delSp modSp new mod addCm delCm modCm">
        <pc:chgData name="Warner,Jeffrey Barr" userId="7360d018-3b8a-4d6d-8136-e4d170e1e616" providerId="ADAL" clId="{E1317903-0E43-4FAC-A900-4D6121109CB5}" dt="2021-05-20T17:02:09.262" v="8166" actId="20577"/>
        <pc:sldMkLst>
          <pc:docMk/>
          <pc:sldMk cId="3345563794" sldId="388"/>
        </pc:sldMkLst>
        <pc:spChg chg="del">
          <ac:chgData name="Warner,Jeffrey Barr" userId="7360d018-3b8a-4d6d-8136-e4d170e1e616" providerId="ADAL" clId="{E1317903-0E43-4FAC-A900-4D6121109CB5}" dt="2021-04-22T19:41:50.336" v="1091" actId="478"/>
          <ac:spMkLst>
            <pc:docMk/>
            <pc:sldMk cId="3345563794" sldId="388"/>
            <ac:spMk id="2" creationId="{2B63F14D-E9BA-4B2E-BC27-E4A012BEDFB3}"/>
          </ac:spMkLst>
        </pc:spChg>
        <pc:spChg chg="del">
          <ac:chgData name="Warner,Jeffrey Barr" userId="7360d018-3b8a-4d6d-8136-e4d170e1e616" providerId="ADAL" clId="{E1317903-0E43-4FAC-A900-4D6121109CB5}" dt="2021-04-22T19:41:50.336" v="1091" actId="478"/>
          <ac:spMkLst>
            <pc:docMk/>
            <pc:sldMk cId="3345563794" sldId="388"/>
            <ac:spMk id="3" creationId="{E04CF5A5-D19A-4126-9E1B-F0E2CB0E54FB}"/>
          </ac:spMkLst>
        </pc:spChg>
        <pc:spChg chg="add del mod">
          <ac:chgData name="Warner,Jeffrey Barr" userId="7360d018-3b8a-4d6d-8136-e4d170e1e616" providerId="ADAL" clId="{E1317903-0E43-4FAC-A900-4D6121109CB5}" dt="2021-05-20T17:00:39.120" v="8064" actId="478"/>
          <ac:spMkLst>
            <pc:docMk/>
            <pc:sldMk cId="3345563794" sldId="388"/>
            <ac:spMk id="4" creationId="{5766E436-5B58-464C-AD1B-ACB425347FEC}"/>
          </ac:spMkLst>
        </pc:spChg>
        <pc:spChg chg="add mod topLvl">
          <ac:chgData name="Warner,Jeffrey Barr" userId="7360d018-3b8a-4d6d-8136-e4d170e1e616" providerId="ADAL" clId="{E1317903-0E43-4FAC-A900-4D6121109CB5}" dt="2021-05-10T16:45:29.074" v="5684" actId="165"/>
          <ac:spMkLst>
            <pc:docMk/>
            <pc:sldMk cId="3345563794" sldId="388"/>
            <ac:spMk id="6" creationId="{8A937648-27BE-40CC-8EFD-491C953B9C1C}"/>
          </ac:spMkLst>
        </pc:spChg>
        <pc:spChg chg="add mod topLvl">
          <ac:chgData name="Warner,Jeffrey Barr" userId="7360d018-3b8a-4d6d-8136-e4d170e1e616" providerId="ADAL" clId="{E1317903-0E43-4FAC-A900-4D6121109CB5}" dt="2021-05-12T16:57:30.414" v="5858" actId="20577"/>
          <ac:spMkLst>
            <pc:docMk/>
            <pc:sldMk cId="3345563794" sldId="388"/>
            <ac:spMk id="7" creationId="{355BEFE0-0ABF-4781-9612-476264E8162F}"/>
          </ac:spMkLst>
        </pc:spChg>
        <pc:spChg chg="add mod topLvl">
          <ac:chgData name="Warner,Jeffrey Barr" userId="7360d018-3b8a-4d6d-8136-e4d170e1e616" providerId="ADAL" clId="{E1317903-0E43-4FAC-A900-4D6121109CB5}" dt="2021-05-10T16:45:29.074" v="5684" actId="165"/>
          <ac:spMkLst>
            <pc:docMk/>
            <pc:sldMk cId="3345563794" sldId="388"/>
            <ac:spMk id="8" creationId="{7B415037-4F39-4666-B746-AAC8D2EC843D}"/>
          </ac:spMkLst>
        </pc:spChg>
        <pc:spChg chg="add mod topLvl">
          <ac:chgData name="Warner,Jeffrey Barr" userId="7360d018-3b8a-4d6d-8136-e4d170e1e616" providerId="ADAL" clId="{E1317903-0E43-4FAC-A900-4D6121109CB5}" dt="2021-05-10T16:45:29.074" v="5684" actId="165"/>
          <ac:spMkLst>
            <pc:docMk/>
            <pc:sldMk cId="3345563794" sldId="388"/>
            <ac:spMk id="9" creationId="{49B3F6DE-0B60-45C4-9DB3-DBCD82F74FA2}"/>
          </ac:spMkLst>
        </pc:spChg>
        <pc:spChg chg="add del mod">
          <ac:chgData name="Warner,Jeffrey Barr" userId="7360d018-3b8a-4d6d-8136-e4d170e1e616" providerId="ADAL" clId="{E1317903-0E43-4FAC-A900-4D6121109CB5}" dt="2021-05-04T18:16:27.450" v="4333" actId="478"/>
          <ac:spMkLst>
            <pc:docMk/>
            <pc:sldMk cId="3345563794" sldId="388"/>
            <ac:spMk id="13" creationId="{C6CFF56F-EEBA-4D1B-92E9-B7345BACB3F7}"/>
          </ac:spMkLst>
        </pc:spChg>
        <pc:spChg chg="add mod topLvl">
          <ac:chgData name="Warner,Jeffrey Barr" userId="7360d018-3b8a-4d6d-8136-e4d170e1e616" providerId="ADAL" clId="{E1317903-0E43-4FAC-A900-4D6121109CB5}" dt="2021-05-10T16:45:29.074" v="5684" actId="165"/>
          <ac:spMkLst>
            <pc:docMk/>
            <pc:sldMk cId="3345563794" sldId="388"/>
            <ac:spMk id="14" creationId="{CEF5900F-9532-4C78-938F-73F271FEE374}"/>
          </ac:spMkLst>
        </pc:spChg>
        <pc:spChg chg="add mod topLvl">
          <ac:chgData name="Warner,Jeffrey Barr" userId="7360d018-3b8a-4d6d-8136-e4d170e1e616" providerId="ADAL" clId="{E1317903-0E43-4FAC-A900-4D6121109CB5}" dt="2021-05-10T16:45:29.074" v="5684" actId="165"/>
          <ac:spMkLst>
            <pc:docMk/>
            <pc:sldMk cId="3345563794" sldId="388"/>
            <ac:spMk id="15" creationId="{326F2845-DF0C-4302-8EF9-E5FC7B0528E8}"/>
          </ac:spMkLst>
        </pc:spChg>
        <pc:spChg chg="add mod topLvl">
          <ac:chgData name="Warner,Jeffrey Barr" userId="7360d018-3b8a-4d6d-8136-e4d170e1e616" providerId="ADAL" clId="{E1317903-0E43-4FAC-A900-4D6121109CB5}" dt="2021-05-10T16:45:29.074" v="5684" actId="165"/>
          <ac:spMkLst>
            <pc:docMk/>
            <pc:sldMk cId="3345563794" sldId="388"/>
            <ac:spMk id="16" creationId="{0161239A-9BE4-47C7-8F66-AC0FCF056FE6}"/>
          </ac:spMkLst>
        </pc:spChg>
        <pc:spChg chg="add mod topLvl">
          <ac:chgData name="Warner,Jeffrey Barr" userId="7360d018-3b8a-4d6d-8136-e4d170e1e616" providerId="ADAL" clId="{E1317903-0E43-4FAC-A900-4D6121109CB5}" dt="2021-05-10T16:45:29.074" v="5684" actId="165"/>
          <ac:spMkLst>
            <pc:docMk/>
            <pc:sldMk cId="3345563794" sldId="388"/>
            <ac:spMk id="17" creationId="{8A0BB93C-7E19-4BB9-9316-7B92C54C9158}"/>
          </ac:spMkLst>
        </pc:spChg>
        <pc:spChg chg="add mod topLvl">
          <ac:chgData name="Warner,Jeffrey Barr" userId="7360d018-3b8a-4d6d-8136-e4d170e1e616" providerId="ADAL" clId="{E1317903-0E43-4FAC-A900-4D6121109CB5}" dt="2021-05-10T16:45:29.074" v="5684" actId="165"/>
          <ac:spMkLst>
            <pc:docMk/>
            <pc:sldMk cId="3345563794" sldId="388"/>
            <ac:spMk id="18" creationId="{B24BBD92-BA3B-4119-BC86-8FFEB076B5DF}"/>
          </ac:spMkLst>
        </pc:spChg>
        <pc:spChg chg="add mod">
          <ac:chgData name="Warner,Jeffrey Barr" userId="7360d018-3b8a-4d6d-8136-e4d170e1e616" providerId="ADAL" clId="{E1317903-0E43-4FAC-A900-4D6121109CB5}" dt="2021-05-20T17:02:09.262" v="8166" actId="20577"/>
          <ac:spMkLst>
            <pc:docMk/>
            <pc:sldMk cId="3345563794" sldId="388"/>
            <ac:spMk id="19" creationId="{92B4F0E4-FD60-461F-830E-2F787B9D39D5}"/>
          </ac:spMkLst>
        </pc:spChg>
        <pc:spChg chg="add del mod">
          <ac:chgData name="Warner,Jeffrey Barr" userId="7360d018-3b8a-4d6d-8136-e4d170e1e616" providerId="ADAL" clId="{E1317903-0E43-4FAC-A900-4D6121109CB5}" dt="2021-05-03T19:53:13.196" v="4145" actId="478"/>
          <ac:spMkLst>
            <pc:docMk/>
            <pc:sldMk cId="3345563794" sldId="388"/>
            <ac:spMk id="19" creationId="{CA9C62AD-20D7-4C4B-B04F-0CB3E777FEEA}"/>
          </ac:spMkLst>
        </pc:spChg>
        <pc:spChg chg="add del mod">
          <ac:chgData name="Warner,Jeffrey Barr" userId="7360d018-3b8a-4d6d-8136-e4d170e1e616" providerId="ADAL" clId="{E1317903-0E43-4FAC-A900-4D6121109CB5}" dt="2021-05-04T18:16:27.450" v="4333" actId="478"/>
          <ac:spMkLst>
            <pc:docMk/>
            <pc:sldMk cId="3345563794" sldId="388"/>
            <ac:spMk id="20" creationId="{D4E4E6F9-73D2-475C-826B-34A6BB4280A7}"/>
          </ac:spMkLst>
        </pc:spChg>
        <pc:spChg chg="add del mod">
          <ac:chgData name="Warner,Jeffrey Barr" userId="7360d018-3b8a-4d6d-8136-e4d170e1e616" providerId="ADAL" clId="{E1317903-0E43-4FAC-A900-4D6121109CB5}" dt="2021-05-03T19:54:47.607" v="4222" actId="478"/>
          <ac:spMkLst>
            <pc:docMk/>
            <pc:sldMk cId="3345563794" sldId="388"/>
            <ac:spMk id="21" creationId="{E9F581C9-4576-4BEB-B73F-7E9F9192A64A}"/>
          </ac:spMkLst>
        </pc:spChg>
        <pc:spChg chg="mod topLvl">
          <ac:chgData name="Warner,Jeffrey Barr" userId="7360d018-3b8a-4d6d-8136-e4d170e1e616" providerId="ADAL" clId="{E1317903-0E43-4FAC-A900-4D6121109CB5}" dt="2021-05-10T16:45:29.074" v="5684" actId="165"/>
          <ac:spMkLst>
            <pc:docMk/>
            <pc:sldMk cId="3345563794" sldId="388"/>
            <ac:spMk id="22" creationId="{FB36D9B7-A6AC-411C-93B6-1A576F417288}"/>
          </ac:spMkLst>
        </pc:spChg>
        <pc:spChg chg="mod topLvl">
          <ac:chgData name="Warner,Jeffrey Barr" userId="7360d018-3b8a-4d6d-8136-e4d170e1e616" providerId="ADAL" clId="{E1317903-0E43-4FAC-A900-4D6121109CB5}" dt="2021-05-10T16:45:29.074" v="5684" actId="165"/>
          <ac:spMkLst>
            <pc:docMk/>
            <pc:sldMk cId="3345563794" sldId="388"/>
            <ac:spMk id="23" creationId="{CD44D0FD-7EB4-49E3-8908-45EF2D16999F}"/>
          </ac:spMkLst>
        </pc:spChg>
        <pc:spChg chg="del">
          <ac:chgData name="Warner,Jeffrey Barr" userId="7360d018-3b8a-4d6d-8136-e4d170e1e616" providerId="ADAL" clId="{E1317903-0E43-4FAC-A900-4D6121109CB5}" dt="2021-05-04T18:16:27.450" v="4333" actId="478"/>
          <ac:spMkLst>
            <pc:docMk/>
            <pc:sldMk cId="3345563794" sldId="388"/>
            <ac:spMk id="24" creationId="{2BF8B10B-8E2D-44A7-8DB9-8ED5492859D0}"/>
          </ac:spMkLst>
        </pc:spChg>
        <pc:grpChg chg="add del mod">
          <ac:chgData name="Warner,Jeffrey Barr" userId="7360d018-3b8a-4d6d-8136-e4d170e1e616" providerId="ADAL" clId="{E1317903-0E43-4FAC-A900-4D6121109CB5}" dt="2021-05-10T16:45:29.074" v="5684" actId="165"/>
          <ac:grpSpMkLst>
            <pc:docMk/>
            <pc:sldMk cId="3345563794" sldId="388"/>
            <ac:grpSpMk id="2" creationId="{3977FD04-682E-41DD-8190-B0D898F20AC7}"/>
          </ac:grpSpMkLst>
        </pc:grpChg>
        <pc:graphicFrameChg chg="add mod topLvl">
          <ac:chgData name="Warner,Jeffrey Barr" userId="7360d018-3b8a-4d6d-8136-e4d170e1e616" providerId="ADAL" clId="{E1317903-0E43-4FAC-A900-4D6121109CB5}" dt="2021-05-19T17:52:31.121" v="8002"/>
          <ac:graphicFrameMkLst>
            <pc:docMk/>
            <pc:sldMk cId="3345563794" sldId="388"/>
            <ac:graphicFrameMk id="5" creationId="{CB54D22E-FEB0-4C5E-9C74-471EABDFD0CD}"/>
          </ac:graphicFrameMkLst>
        </pc:graphicFrameChg>
        <pc:graphicFrameChg chg="add mod topLvl">
          <ac:chgData name="Warner,Jeffrey Barr" userId="7360d018-3b8a-4d6d-8136-e4d170e1e616" providerId="ADAL" clId="{E1317903-0E43-4FAC-A900-4D6121109CB5}" dt="2021-05-19T17:52:49.222" v="8004"/>
          <ac:graphicFrameMkLst>
            <pc:docMk/>
            <pc:sldMk cId="3345563794" sldId="388"/>
            <ac:graphicFrameMk id="10" creationId="{05D20F71-7B16-4A5A-8365-0082898DF956}"/>
          </ac:graphicFrameMkLst>
        </pc:graphicFrameChg>
        <pc:graphicFrameChg chg="add mod topLvl">
          <ac:chgData name="Warner,Jeffrey Barr" userId="7360d018-3b8a-4d6d-8136-e4d170e1e616" providerId="ADAL" clId="{E1317903-0E43-4FAC-A900-4D6121109CB5}" dt="2021-05-19T17:53:22.677" v="8008"/>
          <ac:graphicFrameMkLst>
            <pc:docMk/>
            <pc:sldMk cId="3345563794" sldId="388"/>
            <ac:graphicFrameMk id="11" creationId="{3033C1BE-8F89-4D09-9A8F-F2C8DE770C87}"/>
          </ac:graphicFrameMkLst>
        </pc:graphicFrameChg>
        <pc:graphicFrameChg chg="add del mod">
          <ac:chgData name="Warner,Jeffrey Barr" userId="7360d018-3b8a-4d6d-8136-e4d170e1e616" providerId="ADAL" clId="{E1317903-0E43-4FAC-A900-4D6121109CB5}" dt="2021-05-04T18:16:27.450" v="4333" actId="478"/>
          <ac:graphicFrameMkLst>
            <pc:docMk/>
            <pc:sldMk cId="3345563794" sldId="388"/>
            <ac:graphicFrameMk id="12" creationId="{2608FC58-8C3F-4ACD-909B-6C249761DB9A}"/>
          </ac:graphicFrameMkLst>
        </pc:graphicFrameChg>
        <pc:graphicFrameChg chg="add mod topLvl">
          <ac:chgData name="Warner,Jeffrey Barr" userId="7360d018-3b8a-4d6d-8136-e4d170e1e616" providerId="ADAL" clId="{E1317903-0E43-4FAC-A900-4D6121109CB5}" dt="2021-05-19T17:53:06.042" v="8006"/>
          <ac:graphicFrameMkLst>
            <pc:docMk/>
            <pc:sldMk cId="3345563794" sldId="388"/>
            <ac:graphicFrameMk id="25" creationId="{AF44CE8B-DFB0-4FA8-AAD0-A916B354C02A}"/>
          </ac:graphicFrameMkLst>
        </pc:graphicFrameChg>
        <pc:graphicFrameChg chg="add mod topLvl">
          <ac:chgData name="Warner,Jeffrey Barr" userId="7360d018-3b8a-4d6d-8136-e4d170e1e616" providerId="ADAL" clId="{E1317903-0E43-4FAC-A900-4D6121109CB5}" dt="2021-05-19T17:53:40.600" v="8010"/>
          <ac:graphicFrameMkLst>
            <pc:docMk/>
            <pc:sldMk cId="3345563794" sldId="388"/>
            <ac:graphicFrameMk id="26" creationId="{011B732D-C5BA-481C-95E1-674A26CB9416}"/>
          </ac:graphicFrameMkLst>
        </pc:graphicFrameChg>
        <pc:graphicFrameChg chg="add del mod">
          <ac:chgData name="Warner,Jeffrey Barr" userId="7360d018-3b8a-4d6d-8136-e4d170e1e616" providerId="ADAL" clId="{E1317903-0E43-4FAC-A900-4D6121109CB5}" dt="2021-05-03T19:51:27.893" v="3854" actId="478"/>
          <ac:graphicFrameMkLst>
            <pc:docMk/>
            <pc:sldMk cId="3345563794" sldId="388"/>
            <ac:graphicFrameMk id="27" creationId="{D4D5D1A6-9A68-4966-841C-97A090AF1F0C}"/>
          </ac:graphicFrameMkLst>
        </pc:graphicFrameChg>
        <pc:graphicFrameChg chg="add del mod">
          <ac:chgData name="Warner,Jeffrey Barr" userId="7360d018-3b8a-4d6d-8136-e4d170e1e616" providerId="ADAL" clId="{E1317903-0E43-4FAC-A900-4D6121109CB5}" dt="2021-05-03T19:53:11.978" v="4143" actId="478"/>
          <ac:graphicFrameMkLst>
            <pc:docMk/>
            <pc:sldMk cId="3345563794" sldId="388"/>
            <ac:graphicFrameMk id="28" creationId="{A2E1F653-CCDA-43FD-B1C4-3BA3090A7D6B}"/>
          </ac:graphicFrameMkLst>
        </pc:graphicFrameChg>
      </pc:sldChg>
      <pc:sldChg chg="addSp delSp modSp new del mod">
        <pc:chgData name="Warner,Jeffrey Barr" userId="7360d018-3b8a-4d6d-8136-e4d170e1e616" providerId="ADAL" clId="{E1317903-0E43-4FAC-A900-4D6121109CB5}" dt="2021-05-10T16:45:18.026" v="5681" actId="47"/>
        <pc:sldMkLst>
          <pc:docMk/>
          <pc:sldMk cId="2331476235" sldId="389"/>
        </pc:sldMkLst>
        <pc:spChg chg="mod topLvl">
          <ac:chgData name="Warner,Jeffrey Barr" userId="7360d018-3b8a-4d6d-8136-e4d170e1e616" providerId="ADAL" clId="{E1317903-0E43-4FAC-A900-4D6121109CB5}" dt="2021-05-03T16:47:37.534" v="2734" actId="1035"/>
          <ac:spMkLst>
            <pc:docMk/>
            <pc:sldMk cId="2331476235" sldId="389"/>
            <ac:spMk id="3" creationId="{B4A5513E-3A43-4CF6-9887-B5A32120EE36}"/>
          </ac:spMkLst>
        </pc:spChg>
        <pc:spChg chg="add del mod topLvl">
          <ac:chgData name="Warner,Jeffrey Barr" userId="7360d018-3b8a-4d6d-8136-e4d170e1e616" providerId="ADAL" clId="{E1317903-0E43-4FAC-A900-4D6121109CB5}" dt="2021-05-06T20:27:57.969" v="4383" actId="478"/>
          <ac:spMkLst>
            <pc:docMk/>
            <pc:sldMk cId="2331476235" sldId="389"/>
            <ac:spMk id="4" creationId="{2494B3B2-9494-4845-B94F-D4CAA76B800F}"/>
          </ac:spMkLst>
        </pc:spChg>
        <pc:spChg chg="mod topLvl">
          <ac:chgData name="Warner,Jeffrey Barr" userId="7360d018-3b8a-4d6d-8136-e4d170e1e616" providerId="ADAL" clId="{E1317903-0E43-4FAC-A900-4D6121109CB5}" dt="2021-05-03T16:49:35.068" v="2921" actId="1035"/>
          <ac:spMkLst>
            <pc:docMk/>
            <pc:sldMk cId="2331476235" sldId="389"/>
            <ac:spMk id="6" creationId="{FA5E0E58-2808-4BB8-89CB-1CA418FA59E1}"/>
          </ac:spMkLst>
        </pc:spChg>
        <pc:spChg chg="mod topLvl">
          <ac:chgData name="Warner,Jeffrey Barr" userId="7360d018-3b8a-4d6d-8136-e4d170e1e616" providerId="ADAL" clId="{E1317903-0E43-4FAC-A900-4D6121109CB5}" dt="2021-05-03T16:49:35.068" v="2921" actId="1035"/>
          <ac:spMkLst>
            <pc:docMk/>
            <pc:sldMk cId="2331476235" sldId="389"/>
            <ac:spMk id="7" creationId="{659ECF39-10B2-42EC-B0B6-47F619CACEFD}"/>
          </ac:spMkLst>
        </pc:spChg>
        <pc:spChg chg="del mod topLvl">
          <ac:chgData name="Warner,Jeffrey Barr" userId="7360d018-3b8a-4d6d-8136-e4d170e1e616" providerId="ADAL" clId="{E1317903-0E43-4FAC-A900-4D6121109CB5}" dt="2021-05-06T20:27:59.140" v="4384" actId="478"/>
          <ac:spMkLst>
            <pc:docMk/>
            <pc:sldMk cId="2331476235" sldId="389"/>
            <ac:spMk id="8" creationId="{07E76E44-42C4-4915-A553-84183B8349A9}"/>
          </ac:spMkLst>
        </pc:spChg>
        <pc:spChg chg="mod topLvl">
          <ac:chgData name="Warner,Jeffrey Barr" userId="7360d018-3b8a-4d6d-8136-e4d170e1e616" providerId="ADAL" clId="{E1317903-0E43-4FAC-A900-4D6121109CB5}" dt="2021-05-03T16:47:11.841" v="2651" actId="165"/>
          <ac:spMkLst>
            <pc:docMk/>
            <pc:sldMk cId="2331476235" sldId="389"/>
            <ac:spMk id="9" creationId="{BE41DE4C-F45E-4A38-BC03-13861B1CC2EC}"/>
          </ac:spMkLst>
        </pc:spChg>
        <pc:spChg chg="mod topLvl">
          <ac:chgData name="Warner,Jeffrey Barr" userId="7360d018-3b8a-4d6d-8136-e4d170e1e616" providerId="ADAL" clId="{E1317903-0E43-4FAC-A900-4D6121109CB5}" dt="2021-05-03T16:56:13.018" v="3038" actId="207"/>
          <ac:spMkLst>
            <pc:docMk/>
            <pc:sldMk cId="2331476235" sldId="389"/>
            <ac:spMk id="10" creationId="{ACB0268D-EBE0-4471-B04F-2712E53E6F2F}"/>
          </ac:spMkLst>
        </pc:spChg>
        <pc:spChg chg="mod topLvl">
          <ac:chgData name="Warner,Jeffrey Barr" userId="7360d018-3b8a-4d6d-8136-e4d170e1e616" providerId="ADAL" clId="{E1317903-0E43-4FAC-A900-4D6121109CB5}" dt="2021-05-03T16:49:35.068" v="2921" actId="1035"/>
          <ac:spMkLst>
            <pc:docMk/>
            <pc:sldMk cId="2331476235" sldId="389"/>
            <ac:spMk id="13" creationId="{04BBBABC-8757-4D95-A1D4-BB9F12E19C93}"/>
          </ac:spMkLst>
        </pc:spChg>
        <pc:spChg chg="mod topLvl">
          <ac:chgData name="Warner,Jeffrey Barr" userId="7360d018-3b8a-4d6d-8136-e4d170e1e616" providerId="ADAL" clId="{E1317903-0E43-4FAC-A900-4D6121109CB5}" dt="2021-05-03T16:56:13.018" v="3038" actId="207"/>
          <ac:spMkLst>
            <pc:docMk/>
            <pc:sldMk cId="2331476235" sldId="389"/>
            <ac:spMk id="14" creationId="{0523CBFE-4050-41F6-B602-931F95BE8465}"/>
          </ac:spMkLst>
        </pc:spChg>
        <pc:spChg chg="mod topLvl">
          <ac:chgData name="Warner,Jeffrey Barr" userId="7360d018-3b8a-4d6d-8136-e4d170e1e616" providerId="ADAL" clId="{E1317903-0E43-4FAC-A900-4D6121109CB5}" dt="2021-05-03T16:49:35.068" v="2921" actId="1035"/>
          <ac:spMkLst>
            <pc:docMk/>
            <pc:sldMk cId="2331476235" sldId="389"/>
            <ac:spMk id="17" creationId="{D618C66B-C997-44B1-970F-AD4AF913C4B6}"/>
          </ac:spMkLst>
        </pc:spChg>
        <pc:spChg chg="mod topLvl">
          <ac:chgData name="Warner,Jeffrey Barr" userId="7360d018-3b8a-4d6d-8136-e4d170e1e616" providerId="ADAL" clId="{E1317903-0E43-4FAC-A900-4D6121109CB5}" dt="2021-05-03T16:56:13.018" v="3038" actId="207"/>
          <ac:spMkLst>
            <pc:docMk/>
            <pc:sldMk cId="2331476235" sldId="389"/>
            <ac:spMk id="18" creationId="{C9E5A9B4-A21B-48AE-9B6F-3720CF859012}"/>
          </ac:spMkLst>
        </pc:spChg>
        <pc:spChg chg="mod topLvl">
          <ac:chgData name="Warner,Jeffrey Barr" userId="7360d018-3b8a-4d6d-8136-e4d170e1e616" providerId="ADAL" clId="{E1317903-0E43-4FAC-A900-4D6121109CB5}" dt="2021-05-03T16:49:35.068" v="2921" actId="1035"/>
          <ac:spMkLst>
            <pc:docMk/>
            <pc:sldMk cId="2331476235" sldId="389"/>
            <ac:spMk id="21" creationId="{F7C37821-118D-424C-9DA5-83D8EE95BC75}"/>
          </ac:spMkLst>
        </pc:spChg>
        <pc:spChg chg="mod topLvl">
          <ac:chgData name="Warner,Jeffrey Barr" userId="7360d018-3b8a-4d6d-8136-e4d170e1e616" providerId="ADAL" clId="{E1317903-0E43-4FAC-A900-4D6121109CB5}" dt="2021-05-03T17:17:32.250" v="3089" actId="12788"/>
          <ac:spMkLst>
            <pc:docMk/>
            <pc:sldMk cId="2331476235" sldId="389"/>
            <ac:spMk id="22" creationId="{37681AF7-C3D7-496D-96B9-804862929678}"/>
          </ac:spMkLst>
        </pc:spChg>
        <pc:spChg chg="mod topLvl">
          <ac:chgData name="Warner,Jeffrey Barr" userId="7360d018-3b8a-4d6d-8136-e4d170e1e616" providerId="ADAL" clId="{E1317903-0E43-4FAC-A900-4D6121109CB5}" dt="2021-05-03T16:49:35.068" v="2921" actId="1035"/>
          <ac:spMkLst>
            <pc:docMk/>
            <pc:sldMk cId="2331476235" sldId="389"/>
            <ac:spMk id="25" creationId="{81255CF8-7066-4D57-AB26-A90AB91C636F}"/>
          </ac:spMkLst>
        </pc:spChg>
        <pc:spChg chg="del mod topLvl">
          <ac:chgData name="Warner,Jeffrey Barr" userId="7360d018-3b8a-4d6d-8136-e4d170e1e616" providerId="ADAL" clId="{E1317903-0E43-4FAC-A900-4D6121109CB5}" dt="2021-05-03T16:54:28.247" v="3017" actId="478"/>
          <ac:spMkLst>
            <pc:docMk/>
            <pc:sldMk cId="2331476235" sldId="389"/>
            <ac:spMk id="26" creationId="{8E16F019-5160-407A-9E86-D401EEABC68D}"/>
          </ac:spMkLst>
        </pc:spChg>
        <pc:spChg chg="del mod topLvl">
          <ac:chgData name="Warner,Jeffrey Barr" userId="7360d018-3b8a-4d6d-8136-e4d170e1e616" providerId="ADAL" clId="{E1317903-0E43-4FAC-A900-4D6121109CB5}" dt="2021-05-03T16:54:27.514" v="3016" actId="478"/>
          <ac:spMkLst>
            <pc:docMk/>
            <pc:sldMk cId="2331476235" sldId="389"/>
            <ac:spMk id="27" creationId="{01D6BB7E-9B26-4DDB-B2E9-2472B8BDFF11}"/>
          </ac:spMkLst>
        </pc:spChg>
        <pc:spChg chg="del mod topLvl">
          <ac:chgData name="Warner,Jeffrey Barr" userId="7360d018-3b8a-4d6d-8136-e4d170e1e616" providerId="ADAL" clId="{E1317903-0E43-4FAC-A900-4D6121109CB5}" dt="2021-05-03T16:54:37.052" v="3023" actId="478"/>
          <ac:spMkLst>
            <pc:docMk/>
            <pc:sldMk cId="2331476235" sldId="389"/>
            <ac:spMk id="28" creationId="{B3023B9F-01F8-4675-8F5C-E30EFE2C9170}"/>
          </ac:spMkLst>
        </pc:spChg>
        <pc:spChg chg="del mod topLvl">
          <ac:chgData name="Warner,Jeffrey Barr" userId="7360d018-3b8a-4d6d-8136-e4d170e1e616" providerId="ADAL" clId="{E1317903-0E43-4FAC-A900-4D6121109CB5}" dt="2021-05-06T20:28:49.423" v="4476" actId="478"/>
          <ac:spMkLst>
            <pc:docMk/>
            <pc:sldMk cId="2331476235" sldId="389"/>
            <ac:spMk id="29" creationId="{620BF5DA-567D-435E-AFB5-CC77B3524B79}"/>
          </ac:spMkLst>
        </pc:spChg>
        <pc:spChg chg="del mod topLvl">
          <ac:chgData name="Warner,Jeffrey Barr" userId="7360d018-3b8a-4d6d-8136-e4d170e1e616" providerId="ADAL" clId="{E1317903-0E43-4FAC-A900-4D6121109CB5}" dt="2021-05-06T20:28:48.375" v="4475" actId="478"/>
          <ac:spMkLst>
            <pc:docMk/>
            <pc:sldMk cId="2331476235" sldId="389"/>
            <ac:spMk id="30" creationId="{F1FBB68B-BCBB-49FD-A569-C24050C482DD}"/>
          </ac:spMkLst>
        </pc:spChg>
        <pc:spChg chg="del mod topLvl">
          <ac:chgData name="Warner,Jeffrey Barr" userId="7360d018-3b8a-4d6d-8136-e4d170e1e616" providerId="ADAL" clId="{E1317903-0E43-4FAC-A900-4D6121109CB5}" dt="2021-05-06T20:28:47.258" v="4474" actId="478"/>
          <ac:spMkLst>
            <pc:docMk/>
            <pc:sldMk cId="2331476235" sldId="389"/>
            <ac:spMk id="31" creationId="{AF7DE4F8-249D-4A35-8A23-1F10FF409E76}"/>
          </ac:spMkLst>
        </pc:spChg>
        <pc:spChg chg="mod topLvl">
          <ac:chgData name="Warner,Jeffrey Barr" userId="7360d018-3b8a-4d6d-8136-e4d170e1e616" providerId="ADAL" clId="{E1317903-0E43-4FAC-A900-4D6121109CB5}" dt="2021-05-03T16:51:48.871" v="2978" actId="14100"/>
          <ac:spMkLst>
            <pc:docMk/>
            <pc:sldMk cId="2331476235" sldId="389"/>
            <ac:spMk id="32" creationId="{223638BF-9F47-4FF7-BD83-9994848B9A9E}"/>
          </ac:spMkLst>
        </pc:spChg>
        <pc:spChg chg="del mod topLvl">
          <ac:chgData name="Warner,Jeffrey Barr" userId="7360d018-3b8a-4d6d-8136-e4d170e1e616" providerId="ADAL" clId="{E1317903-0E43-4FAC-A900-4D6121109CB5}" dt="2021-05-03T17:18:27.349" v="3110" actId="478"/>
          <ac:spMkLst>
            <pc:docMk/>
            <pc:sldMk cId="2331476235" sldId="389"/>
            <ac:spMk id="33" creationId="{B9D877A1-D412-41F9-8862-5258BB096608}"/>
          </ac:spMkLst>
        </pc:spChg>
        <pc:spChg chg="mod topLvl">
          <ac:chgData name="Warner,Jeffrey Barr" userId="7360d018-3b8a-4d6d-8136-e4d170e1e616" providerId="ADAL" clId="{E1317903-0E43-4FAC-A900-4D6121109CB5}" dt="2021-05-06T20:28:45.724" v="4473" actId="1036"/>
          <ac:spMkLst>
            <pc:docMk/>
            <pc:sldMk cId="2331476235" sldId="389"/>
            <ac:spMk id="41" creationId="{A3D0D859-172F-4FC4-8699-30F3720EBD93}"/>
          </ac:spMkLst>
        </pc:spChg>
        <pc:spChg chg="mod topLvl">
          <ac:chgData name="Warner,Jeffrey Barr" userId="7360d018-3b8a-4d6d-8136-e4d170e1e616" providerId="ADAL" clId="{E1317903-0E43-4FAC-A900-4D6121109CB5}" dt="2021-05-06T20:28:45.724" v="4473" actId="1036"/>
          <ac:spMkLst>
            <pc:docMk/>
            <pc:sldMk cId="2331476235" sldId="389"/>
            <ac:spMk id="46" creationId="{F84B384D-1D8C-4289-85A3-8726114E7689}"/>
          </ac:spMkLst>
        </pc:spChg>
        <pc:spChg chg="mod topLvl">
          <ac:chgData name="Warner,Jeffrey Barr" userId="7360d018-3b8a-4d6d-8136-e4d170e1e616" providerId="ADAL" clId="{E1317903-0E43-4FAC-A900-4D6121109CB5}" dt="2021-05-06T20:28:45.724" v="4473" actId="1036"/>
          <ac:spMkLst>
            <pc:docMk/>
            <pc:sldMk cId="2331476235" sldId="389"/>
            <ac:spMk id="47" creationId="{97E40411-773F-48AC-AA31-79C94AF2BD8E}"/>
          </ac:spMkLst>
        </pc:spChg>
        <pc:spChg chg="mod topLvl">
          <ac:chgData name="Warner,Jeffrey Barr" userId="7360d018-3b8a-4d6d-8136-e4d170e1e616" providerId="ADAL" clId="{E1317903-0E43-4FAC-A900-4D6121109CB5}" dt="2021-05-06T20:28:45.724" v="4473" actId="1036"/>
          <ac:spMkLst>
            <pc:docMk/>
            <pc:sldMk cId="2331476235" sldId="389"/>
            <ac:spMk id="48" creationId="{99646531-EDC2-4780-88AD-181F320FDEA9}"/>
          </ac:spMkLst>
        </pc:spChg>
        <pc:spChg chg="mod topLvl">
          <ac:chgData name="Warner,Jeffrey Barr" userId="7360d018-3b8a-4d6d-8136-e4d170e1e616" providerId="ADAL" clId="{E1317903-0E43-4FAC-A900-4D6121109CB5}" dt="2021-05-03T16:52:42.829" v="2984" actId="207"/>
          <ac:spMkLst>
            <pc:docMk/>
            <pc:sldMk cId="2331476235" sldId="389"/>
            <ac:spMk id="49" creationId="{9BB1A864-D47E-4AB1-8991-B2279217C082}"/>
          </ac:spMkLst>
        </pc:spChg>
        <pc:spChg chg="mod topLvl">
          <ac:chgData name="Warner,Jeffrey Barr" userId="7360d018-3b8a-4d6d-8136-e4d170e1e616" providerId="ADAL" clId="{E1317903-0E43-4FAC-A900-4D6121109CB5}" dt="2021-05-03T16:52:42.829" v="2984" actId="207"/>
          <ac:spMkLst>
            <pc:docMk/>
            <pc:sldMk cId="2331476235" sldId="389"/>
            <ac:spMk id="50" creationId="{CEF5D7B2-78EF-4920-AFBA-37835324668A}"/>
          </ac:spMkLst>
        </pc:spChg>
        <pc:spChg chg="mod topLvl">
          <ac:chgData name="Warner,Jeffrey Barr" userId="7360d018-3b8a-4d6d-8136-e4d170e1e616" providerId="ADAL" clId="{E1317903-0E43-4FAC-A900-4D6121109CB5}" dt="2021-05-03T16:52:42.829" v="2984" actId="207"/>
          <ac:spMkLst>
            <pc:docMk/>
            <pc:sldMk cId="2331476235" sldId="389"/>
            <ac:spMk id="51" creationId="{2A3990FC-D2EB-4107-B3B1-1F510AE8636E}"/>
          </ac:spMkLst>
        </pc:spChg>
        <pc:spChg chg="mod topLvl">
          <ac:chgData name="Warner,Jeffrey Barr" userId="7360d018-3b8a-4d6d-8136-e4d170e1e616" providerId="ADAL" clId="{E1317903-0E43-4FAC-A900-4D6121109CB5}" dt="2021-05-03T16:52:42.829" v="2984" actId="207"/>
          <ac:spMkLst>
            <pc:docMk/>
            <pc:sldMk cId="2331476235" sldId="389"/>
            <ac:spMk id="52" creationId="{446A9F69-9B0F-4E31-BE57-FF3B5A65FF0F}"/>
          </ac:spMkLst>
        </pc:spChg>
        <pc:spChg chg="mod topLvl">
          <ac:chgData name="Warner,Jeffrey Barr" userId="7360d018-3b8a-4d6d-8136-e4d170e1e616" providerId="ADAL" clId="{E1317903-0E43-4FAC-A900-4D6121109CB5}" dt="2021-05-03T16:52:42.829" v="2984" actId="207"/>
          <ac:spMkLst>
            <pc:docMk/>
            <pc:sldMk cId="2331476235" sldId="389"/>
            <ac:spMk id="53" creationId="{76E96F86-CDC3-4411-94BC-BC2FFB0E34EB}"/>
          </ac:spMkLst>
        </pc:spChg>
        <pc:spChg chg="mod topLvl">
          <ac:chgData name="Warner,Jeffrey Barr" userId="7360d018-3b8a-4d6d-8136-e4d170e1e616" providerId="ADAL" clId="{E1317903-0E43-4FAC-A900-4D6121109CB5}" dt="2021-05-03T16:52:42.829" v="2984" actId="207"/>
          <ac:spMkLst>
            <pc:docMk/>
            <pc:sldMk cId="2331476235" sldId="389"/>
            <ac:spMk id="54" creationId="{C4B3E3AD-38F6-4B77-8F66-07886CE5CDB2}"/>
          </ac:spMkLst>
        </pc:spChg>
        <pc:spChg chg="mod topLvl">
          <ac:chgData name="Warner,Jeffrey Barr" userId="7360d018-3b8a-4d6d-8136-e4d170e1e616" providerId="ADAL" clId="{E1317903-0E43-4FAC-A900-4D6121109CB5}" dt="2021-05-03T16:52:42.829" v="2984" actId="207"/>
          <ac:spMkLst>
            <pc:docMk/>
            <pc:sldMk cId="2331476235" sldId="389"/>
            <ac:spMk id="55" creationId="{F75676CF-9C2D-47CE-87EF-714E3C443AD0}"/>
          </ac:spMkLst>
        </pc:spChg>
        <pc:spChg chg="mod topLvl">
          <ac:chgData name="Warner,Jeffrey Barr" userId="7360d018-3b8a-4d6d-8136-e4d170e1e616" providerId="ADAL" clId="{E1317903-0E43-4FAC-A900-4D6121109CB5}" dt="2021-05-03T16:47:37.534" v="2734" actId="1035"/>
          <ac:spMkLst>
            <pc:docMk/>
            <pc:sldMk cId="2331476235" sldId="389"/>
            <ac:spMk id="56" creationId="{6E7881F6-BEC2-427D-85F7-662636200BF4}"/>
          </ac:spMkLst>
        </pc:spChg>
        <pc:spChg chg="mod">
          <ac:chgData name="Warner,Jeffrey Barr" userId="7360d018-3b8a-4d6d-8136-e4d170e1e616" providerId="ADAL" clId="{E1317903-0E43-4FAC-A900-4D6121109CB5}" dt="2021-05-04T15:32:25.936" v="4234" actId="20577"/>
          <ac:spMkLst>
            <pc:docMk/>
            <pc:sldMk cId="2331476235" sldId="389"/>
            <ac:spMk id="61" creationId="{63B0C520-A443-45AA-AD94-47C8DC5D3793}"/>
          </ac:spMkLst>
        </pc:spChg>
        <pc:spChg chg="add mod">
          <ac:chgData name="Warner,Jeffrey Barr" userId="7360d018-3b8a-4d6d-8136-e4d170e1e616" providerId="ADAL" clId="{E1317903-0E43-4FAC-A900-4D6121109CB5}" dt="2021-05-03T16:51:07.331" v="2926" actId="14100"/>
          <ac:spMkLst>
            <pc:docMk/>
            <pc:sldMk cId="2331476235" sldId="389"/>
            <ac:spMk id="62" creationId="{3F3DCD30-6C2F-4412-B521-435D7921517E}"/>
          </ac:spMkLst>
        </pc:spChg>
        <pc:spChg chg="add mod">
          <ac:chgData name="Warner,Jeffrey Barr" userId="7360d018-3b8a-4d6d-8136-e4d170e1e616" providerId="ADAL" clId="{E1317903-0E43-4FAC-A900-4D6121109CB5}" dt="2021-05-06T20:28:20.580" v="4453" actId="1035"/>
          <ac:spMkLst>
            <pc:docMk/>
            <pc:sldMk cId="2331476235" sldId="389"/>
            <ac:spMk id="63" creationId="{2E5041D1-C313-4493-B575-8D46B36AA3E0}"/>
          </ac:spMkLst>
        </pc:spChg>
        <pc:spChg chg="add mod">
          <ac:chgData name="Warner,Jeffrey Barr" userId="7360d018-3b8a-4d6d-8136-e4d170e1e616" providerId="ADAL" clId="{E1317903-0E43-4FAC-A900-4D6121109CB5}" dt="2021-05-06T20:28:20.580" v="4453" actId="1035"/>
          <ac:spMkLst>
            <pc:docMk/>
            <pc:sldMk cId="2331476235" sldId="389"/>
            <ac:spMk id="64" creationId="{B09CDE2F-DCC0-4BA8-9BB0-A90B0B46EE66}"/>
          </ac:spMkLst>
        </pc:spChg>
        <pc:spChg chg="add mod">
          <ac:chgData name="Warner,Jeffrey Barr" userId="7360d018-3b8a-4d6d-8136-e4d170e1e616" providerId="ADAL" clId="{E1317903-0E43-4FAC-A900-4D6121109CB5}" dt="2021-05-06T20:28:20.580" v="4453" actId="1035"/>
          <ac:spMkLst>
            <pc:docMk/>
            <pc:sldMk cId="2331476235" sldId="389"/>
            <ac:spMk id="65" creationId="{188BC792-4F75-497F-9F51-6F7D2D61EB8A}"/>
          </ac:spMkLst>
        </pc:spChg>
        <pc:spChg chg="add mod">
          <ac:chgData name="Warner,Jeffrey Barr" userId="7360d018-3b8a-4d6d-8136-e4d170e1e616" providerId="ADAL" clId="{E1317903-0E43-4FAC-A900-4D6121109CB5}" dt="2021-05-06T20:28:20.580" v="4453" actId="1035"/>
          <ac:spMkLst>
            <pc:docMk/>
            <pc:sldMk cId="2331476235" sldId="389"/>
            <ac:spMk id="66" creationId="{628680AC-DC04-49A7-B169-C690218C7C82}"/>
          </ac:spMkLst>
        </pc:spChg>
        <pc:spChg chg="add mod">
          <ac:chgData name="Warner,Jeffrey Barr" userId="7360d018-3b8a-4d6d-8136-e4d170e1e616" providerId="ADAL" clId="{E1317903-0E43-4FAC-A900-4D6121109CB5}" dt="2021-05-06T20:28:20.580" v="4453" actId="1035"/>
          <ac:spMkLst>
            <pc:docMk/>
            <pc:sldMk cId="2331476235" sldId="389"/>
            <ac:spMk id="67" creationId="{30291E94-296C-4278-9B4A-F96BD5B5B4B1}"/>
          </ac:spMkLst>
        </pc:spChg>
        <pc:spChg chg="add mod">
          <ac:chgData name="Warner,Jeffrey Barr" userId="7360d018-3b8a-4d6d-8136-e4d170e1e616" providerId="ADAL" clId="{E1317903-0E43-4FAC-A900-4D6121109CB5}" dt="2021-05-06T20:28:20.580" v="4453" actId="1035"/>
          <ac:spMkLst>
            <pc:docMk/>
            <pc:sldMk cId="2331476235" sldId="389"/>
            <ac:spMk id="68" creationId="{AD1F41D6-EA04-4940-8F6E-BD9B79CD7D5D}"/>
          </ac:spMkLst>
        </pc:spChg>
        <pc:spChg chg="add mod">
          <ac:chgData name="Warner,Jeffrey Barr" userId="7360d018-3b8a-4d6d-8136-e4d170e1e616" providerId="ADAL" clId="{E1317903-0E43-4FAC-A900-4D6121109CB5}" dt="2021-05-06T20:28:20.580" v="4453" actId="1035"/>
          <ac:spMkLst>
            <pc:docMk/>
            <pc:sldMk cId="2331476235" sldId="389"/>
            <ac:spMk id="69" creationId="{17AE6270-28D5-4EEC-B53E-8F49EB1C8746}"/>
          </ac:spMkLst>
        </pc:spChg>
        <pc:spChg chg="add mod">
          <ac:chgData name="Warner,Jeffrey Barr" userId="7360d018-3b8a-4d6d-8136-e4d170e1e616" providerId="ADAL" clId="{E1317903-0E43-4FAC-A900-4D6121109CB5}" dt="2021-05-03T16:49:35.068" v="2921" actId="1035"/>
          <ac:spMkLst>
            <pc:docMk/>
            <pc:sldMk cId="2331476235" sldId="389"/>
            <ac:spMk id="70" creationId="{22F29A02-6F1D-4F82-8E8F-73613142A572}"/>
          </ac:spMkLst>
        </pc:spChg>
        <pc:spChg chg="add mod">
          <ac:chgData name="Warner,Jeffrey Barr" userId="7360d018-3b8a-4d6d-8136-e4d170e1e616" providerId="ADAL" clId="{E1317903-0E43-4FAC-A900-4D6121109CB5}" dt="2021-05-03T16:49:35.068" v="2921" actId="1035"/>
          <ac:spMkLst>
            <pc:docMk/>
            <pc:sldMk cId="2331476235" sldId="389"/>
            <ac:spMk id="71" creationId="{A109F9C4-74D7-4129-91A3-101A13495EFB}"/>
          </ac:spMkLst>
        </pc:spChg>
        <pc:spChg chg="add mod">
          <ac:chgData name="Warner,Jeffrey Barr" userId="7360d018-3b8a-4d6d-8136-e4d170e1e616" providerId="ADAL" clId="{E1317903-0E43-4FAC-A900-4D6121109CB5}" dt="2021-05-03T16:49:35.068" v="2921" actId="1035"/>
          <ac:spMkLst>
            <pc:docMk/>
            <pc:sldMk cId="2331476235" sldId="389"/>
            <ac:spMk id="72" creationId="{C580E4DF-C287-4E2C-9933-7154AEE207FA}"/>
          </ac:spMkLst>
        </pc:spChg>
        <pc:spChg chg="add mod">
          <ac:chgData name="Warner,Jeffrey Barr" userId="7360d018-3b8a-4d6d-8136-e4d170e1e616" providerId="ADAL" clId="{E1317903-0E43-4FAC-A900-4D6121109CB5}" dt="2021-05-03T16:49:35.068" v="2921" actId="1035"/>
          <ac:spMkLst>
            <pc:docMk/>
            <pc:sldMk cId="2331476235" sldId="389"/>
            <ac:spMk id="73" creationId="{84F08C19-558F-4FBB-9C3E-EC9ED88FBD18}"/>
          </ac:spMkLst>
        </pc:spChg>
        <pc:spChg chg="add mod">
          <ac:chgData name="Warner,Jeffrey Barr" userId="7360d018-3b8a-4d6d-8136-e4d170e1e616" providerId="ADAL" clId="{E1317903-0E43-4FAC-A900-4D6121109CB5}" dt="2021-05-03T16:49:35.068" v="2921" actId="1035"/>
          <ac:spMkLst>
            <pc:docMk/>
            <pc:sldMk cId="2331476235" sldId="389"/>
            <ac:spMk id="74" creationId="{358B4CC8-87C5-4B9C-9ECD-D33976F3A020}"/>
          </ac:spMkLst>
        </pc:spChg>
        <pc:spChg chg="add mod">
          <ac:chgData name="Warner,Jeffrey Barr" userId="7360d018-3b8a-4d6d-8136-e4d170e1e616" providerId="ADAL" clId="{E1317903-0E43-4FAC-A900-4D6121109CB5}" dt="2021-05-03T16:49:35.068" v="2921" actId="1035"/>
          <ac:spMkLst>
            <pc:docMk/>
            <pc:sldMk cId="2331476235" sldId="389"/>
            <ac:spMk id="75" creationId="{9FE08E09-95B8-42C8-AD0A-098B606AB4D6}"/>
          </ac:spMkLst>
        </pc:spChg>
        <pc:spChg chg="add mod">
          <ac:chgData name="Warner,Jeffrey Barr" userId="7360d018-3b8a-4d6d-8136-e4d170e1e616" providerId="ADAL" clId="{E1317903-0E43-4FAC-A900-4D6121109CB5}" dt="2021-05-03T16:49:35.068" v="2921" actId="1035"/>
          <ac:spMkLst>
            <pc:docMk/>
            <pc:sldMk cId="2331476235" sldId="389"/>
            <ac:spMk id="76" creationId="{461E40FF-94D8-4038-B1CB-BECC8EEA8E85}"/>
          </ac:spMkLst>
        </pc:spChg>
        <pc:spChg chg="add mod">
          <ac:chgData name="Warner,Jeffrey Barr" userId="7360d018-3b8a-4d6d-8136-e4d170e1e616" providerId="ADAL" clId="{E1317903-0E43-4FAC-A900-4D6121109CB5}" dt="2021-05-03T17:16:56.907" v="3048" actId="207"/>
          <ac:spMkLst>
            <pc:docMk/>
            <pc:sldMk cId="2331476235" sldId="389"/>
            <ac:spMk id="77" creationId="{A67A0CEE-51DA-453B-900A-8BCB26F5CB8E}"/>
          </ac:spMkLst>
        </pc:spChg>
        <pc:spChg chg="add mod">
          <ac:chgData name="Warner,Jeffrey Barr" userId="7360d018-3b8a-4d6d-8136-e4d170e1e616" providerId="ADAL" clId="{E1317903-0E43-4FAC-A900-4D6121109CB5}" dt="2021-05-03T17:16:56.907" v="3048" actId="207"/>
          <ac:spMkLst>
            <pc:docMk/>
            <pc:sldMk cId="2331476235" sldId="389"/>
            <ac:spMk id="78" creationId="{02220EC9-3031-4A52-BB23-C26BC7AB3400}"/>
          </ac:spMkLst>
        </pc:spChg>
        <pc:spChg chg="add mod">
          <ac:chgData name="Warner,Jeffrey Barr" userId="7360d018-3b8a-4d6d-8136-e4d170e1e616" providerId="ADAL" clId="{E1317903-0E43-4FAC-A900-4D6121109CB5}" dt="2021-05-03T17:16:56.907" v="3048" actId="207"/>
          <ac:spMkLst>
            <pc:docMk/>
            <pc:sldMk cId="2331476235" sldId="389"/>
            <ac:spMk id="79" creationId="{8549E9F9-1837-427F-BC8F-10827E344461}"/>
          </ac:spMkLst>
        </pc:spChg>
        <pc:spChg chg="add mod">
          <ac:chgData name="Warner,Jeffrey Barr" userId="7360d018-3b8a-4d6d-8136-e4d170e1e616" providerId="ADAL" clId="{E1317903-0E43-4FAC-A900-4D6121109CB5}" dt="2021-05-03T17:17:32.250" v="3089" actId="12788"/>
          <ac:spMkLst>
            <pc:docMk/>
            <pc:sldMk cId="2331476235" sldId="389"/>
            <ac:spMk id="80" creationId="{17C9DAAD-A2A7-4278-8FF9-0E99F9C8BC0D}"/>
          </ac:spMkLst>
        </pc:spChg>
        <pc:spChg chg="add mod">
          <ac:chgData name="Warner,Jeffrey Barr" userId="7360d018-3b8a-4d6d-8136-e4d170e1e616" providerId="ADAL" clId="{E1317903-0E43-4FAC-A900-4D6121109CB5}" dt="2021-05-06T20:28:20.580" v="4453" actId="1035"/>
          <ac:spMkLst>
            <pc:docMk/>
            <pc:sldMk cId="2331476235" sldId="389"/>
            <ac:spMk id="81" creationId="{3A27E542-CEF9-4F6D-9526-DC6493CAF876}"/>
          </ac:spMkLst>
        </pc:spChg>
        <pc:spChg chg="add del mod">
          <ac:chgData name="Warner,Jeffrey Barr" userId="7360d018-3b8a-4d6d-8136-e4d170e1e616" providerId="ADAL" clId="{E1317903-0E43-4FAC-A900-4D6121109CB5}" dt="2021-05-03T16:55:04.120" v="3033" actId="478"/>
          <ac:spMkLst>
            <pc:docMk/>
            <pc:sldMk cId="2331476235" sldId="389"/>
            <ac:spMk id="81" creationId="{8E343E4F-1715-47F8-A112-2BE4082ECE42}"/>
          </ac:spMkLst>
        </pc:spChg>
        <pc:spChg chg="add del mod">
          <ac:chgData name="Warner,Jeffrey Barr" userId="7360d018-3b8a-4d6d-8136-e4d170e1e616" providerId="ADAL" clId="{E1317903-0E43-4FAC-A900-4D6121109CB5}" dt="2021-05-03T16:54:58.353" v="3030" actId="478"/>
          <ac:spMkLst>
            <pc:docMk/>
            <pc:sldMk cId="2331476235" sldId="389"/>
            <ac:spMk id="82" creationId="{D93660FC-CD33-4B99-A98C-43A60CBD89A1}"/>
          </ac:spMkLst>
        </pc:spChg>
        <pc:spChg chg="add del mod">
          <ac:chgData name="Warner,Jeffrey Barr" userId="7360d018-3b8a-4d6d-8136-e4d170e1e616" providerId="ADAL" clId="{E1317903-0E43-4FAC-A900-4D6121109CB5}" dt="2021-05-03T16:55:04.120" v="3033" actId="478"/>
          <ac:spMkLst>
            <pc:docMk/>
            <pc:sldMk cId="2331476235" sldId="389"/>
            <ac:spMk id="83" creationId="{C2CFE19E-F7EF-454C-B272-81B2C0524E14}"/>
          </ac:spMkLst>
        </pc:spChg>
        <pc:spChg chg="add del mod">
          <ac:chgData name="Warner,Jeffrey Barr" userId="7360d018-3b8a-4d6d-8136-e4d170e1e616" providerId="ADAL" clId="{E1317903-0E43-4FAC-A900-4D6121109CB5}" dt="2021-05-03T16:54:58.353" v="3030" actId="478"/>
          <ac:spMkLst>
            <pc:docMk/>
            <pc:sldMk cId="2331476235" sldId="389"/>
            <ac:spMk id="84" creationId="{7B3DF1CE-4759-45CA-8114-E2CA4752ECFC}"/>
          </ac:spMkLst>
        </pc:spChg>
        <pc:spChg chg="add del mod">
          <ac:chgData name="Warner,Jeffrey Barr" userId="7360d018-3b8a-4d6d-8136-e4d170e1e616" providerId="ADAL" clId="{E1317903-0E43-4FAC-A900-4D6121109CB5}" dt="2021-05-06T20:27:54.646" v="4380" actId="478"/>
          <ac:spMkLst>
            <pc:docMk/>
            <pc:sldMk cId="2331476235" sldId="389"/>
            <ac:spMk id="85" creationId="{0B9D1939-A936-45FE-AD47-A73329BCFC33}"/>
          </ac:spMkLst>
        </pc:spChg>
        <pc:spChg chg="add del mod">
          <ac:chgData name="Warner,Jeffrey Barr" userId="7360d018-3b8a-4d6d-8136-e4d170e1e616" providerId="ADAL" clId="{E1317903-0E43-4FAC-A900-4D6121109CB5}" dt="2021-05-03T16:54:58.353" v="3030" actId="478"/>
          <ac:spMkLst>
            <pc:docMk/>
            <pc:sldMk cId="2331476235" sldId="389"/>
            <ac:spMk id="86" creationId="{DF699E47-33D2-465A-A869-4E815B3D7E98}"/>
          </ac:spMkLst>
        </pc:spChg>
        <pc:spChg chg="add del mod">
          <ac:chgData name="Warner,Jeffrey Barr" userId="7360d018-3b8a-4d6d-8136-e4d170e1e616" providerId="ADAL" clId="{E1317903-0E43-4FAC-A900-4D6121109CB5}" dt="2021-05-06T20:27:55.532" v="4381" actId="478"/>
          <ac:spMkLst>
            <pc:docMk/>
            <pc:sldMk cId="2331476235" sldId="389"/>
            <ac:spMk id="87" creationId="{544213CF-04CD-4D76-B675-EBA05D547041}"/>
          </ac:spMkLst>
        </pc:spChg>
        <pc:spChg chg="add mod ord">
          <ac:chgData name="Warner,Jeffrey Barr" userId="7360d018-3b8a-4d6d-8136-e4d170e1e616" providerId="ADAL" clId="{E1317903-0E43-4FAC-A900-4D6121109CB5}" dt="2021-05-03T17:18:26.095" v="3109" actId="167"/>
          <ac:spMkLst>
            <pc:docMk/>
            <pc:sldMk cId="2331476235" sldId="389"/>
            <ac:spMk id="93" creationId="{5C6459F8-50E5-469B-8CC8-9EA8E1E34B10}"/>
          </ac:spMkLst>
        </pc:spChg>
        <pc:grpChg chg="add del mod">
          <ac:chgData name="Warner,Jeffrey Barr" userId="7360d018-3b8a-4d6d-8136-e4d170e1e616" providerId="ADAL" clId="{E1317903-0E43-4FAC-A900-4D6121109CB5}" dt="2021-05-03T16:47:11.841" v="2651" actId="165"/>
          <ac:grpSpMkLst>
            <pc:docMk/>
            <pc:sldMk cId="2331476235" sldId="389"/>
            <ac:grpSpMk id="2" creationId="{70D9BCBD-8727-4BB4-9236-A437A26794EF}"/>
          </ac:grpSpMkLst>
        </pc:grpChg>
        <pc:grpChg chg="mod topLvl">
          <ac:chgData name="Warner,Jeffrey Barr" userId="7360d018-3b8a-4d6d-8136-e4d170e1e616" providerId="ADAL" clId="{E1317903-0E43-4FAC-A900-4D6121109CB5}" dt="2021-05-03T17:04:30.803" v="3042" actId="1076"/>
          <ac:grpSpMkLst>
            <pc:docMk/>
            <pc:sldMk cId="2331476235" sldId="389"/>
            <ac:grpSpMk id="5" creationId="{86E00201-5463-4D35-883A-0CF50F3A7823}"/>
          </ac:grpSpMkLst>
        </pc:grpChg>
        <pc:picChg chg="mod">
          <ac:chgData name="Warner,Jeffrey Barr" userId="7360d018-3b8a-4d6d-8136-e4d170e1e616" providerId="ADAL" clId="{E1317903-0E43-4FAC-A900-4D6121109CB5}" dt="2021-05-03T16:47:11.841" v="2651" actId="165"/>
          <ac:picMkLst>
            <pc:docMk/>
            <pc:sldMk cId="2331476235" sldId="389"/>
            <ac:picMk id="60" creationId="{98CEED80-C0E1-4CBA-9BBB-D7B967ACFB0A}"/>
          </ac:picMkLst>
        </pc:picChg>
        <pc:cxnChg chg="del mod topLvl">
          <ac:chgData name="Warner,Jeffrey Barr" userId="7360d018-3b8a-4d6d-8136-e4d170e1e616" providerId="ADAL" clId="{E1317903-0E43-4FAC-A900-4D6121109CB5}" dt="2021-05-03T16:54:29.998" v="3019" actId="478"/>
          <ac:cxnSpMkLst>
            <pc:docMk/>
            <pc:sldMk cId="2331476235" sldId="389"/>
            <ac:cxnSpMk id="11" creationId="{9B4DE10D-11F8-4491-86C0-81D6B7FA4743}"/>
          </ac:cxnSpMkLst>
        </pc:cxnChg>
        <pc:cxnChg chg="mod topLvl">
          <ac:chgData name="Warner,Jeffrey Barr" userId="7360d018-3b8a-4d6d-8136-e4d170e1e616" providerId="ADAL" clId="{E1317903-0E43-4FAC-A900-4D6121109CB5}" dt="2021-05-03T16:49:35.068" v="2921" actId="1035"/>
          <ac:cxnSpMkLst>
            <pc:docMk/>
            <pc:sldMk cId="2331476235" sldId="389"/>
            <ac:cxnSpMk id="12" creationId="{3B1B8CD3-4BED-4AA5-8F5B-CC9DEDC16B38}"/>
          </ac:cxnSpMkLst>
        </pc:cxnChg>
        <pc:cxnChg chg="del mod topLvl">
          <ac:chgData name="Warner,Jeffrey Barr" userId="7360d018-3b8a-4d6d-8136-e4d170e1e616" providerId="ADAL" clId="{E1317903-0E43-4FAC-A900-4D6121109CB5}" dt="2021-05-03T16:54:28.917" v="3018" actId="478"/>
          <ac:cxnSpMkLst>
            <pc:docMk/>
            <pc:sldMk cId="2331476235" sldId="389"/>
            <ac:cxnSpMk id="15" creationId="{99D8DAE3-9DED-4E63-B03B-5BB55AEB03C3}"/>
          </ac:cxnSpMkLst>
        </pc:cxnChg>
        <pc:cxnChg chg="mod topLvl">
          <ac:chgData name="Warner,Jeffrey Barr" userId="7360d018-3b8a-4d6d-8136-e4d170e1e616" providerId="ADAL" clId="{E1317903-0E43-4FAC-A900-4D6121109CB5}" dt="2021-05-03T16:49:35.068" v="2921" actId="1035"/>
          <ac:cxnSpMkLst>
            <pc:docMk/>
            <pc:sldMk cId="2331476235" sldId="389"/>
            <ac:cxnSpMk id="16" creationId="{499784DB-4BC2-446D-BB29-11B7B7F8BE49}"/>
          </ac:cxnSpMkLst>
        </pc:cxnChg>
        <pc:cxnChg chg="add del mod topLvl">
          <ac:chgData name="Warner,Jeffrey Barr" userId="7360d018-3b8a-4d6d-8136-e4d170e1e616" providerId="ADAL" clId="{E1317903-0E43-4FAC-A900-4D6121109CB5}" dt="2021-05-06T20:27:56.481" v="4382" actId="478"/>
          <ac:cxnSpMkLst>
            <pc:docMk/>
            <pc:sldMk cId="2331476235" sldId="389"/>
            <ac:cxnSpMk id="19" creationId="{A3AC10B6-4308-417E-B19D-24EEE5D881AB}"/>
          </ac:cxnSpMkLst>
        </pc:cxnChg>
        <pc:cxnChg chg="mod topLvl">
          <ac:chgData name="Warner,Jeffrey Barr" userId="7360d018-3b8a-4d6d-8136-e4d170e1e616" providerId="ADAL" clId="{E1317903-0E43-4FAC-A900-4D6121109CB5}" dt="2021-05-03T16:49:35.068" v="2921" actId="1035"/>
          <ac:cxnSpMkLst>
            <pc:docMk/>
            <pc:sldMk cId="2331476235" sldId="389"/>
            <ac:cxnSpMk id="20" creationId="{F62C4A24-4CB8-4DF4-8706-2DB35BF57E90}"/>
          </ac:cxnSpMkLst>
        </pc:cxnChg>
        <pc:cxnChg chg="del mod topLvl">
          <ac:chgData name="Warner,Jeffrey Barr" userId="7360d018-3b8a-4d6d-8136-e4d170e1e616" providerId="ADAL" clId="{E1317903-0E43-4FAC-A900-4D6121109CB5}" dt="2021-05-03T16:54:35.132" v="3021" actId="478"/>
          <ac:cxnSpMkLst>
            <pc:docMk/>
            <pc:sldMk cId="2331476235" sldId="389"/>
            <ac:cxnSpMk id="23" creationId="{CB47ED4B-946B-47A9-8E3C-848E69657B49}"/>
          </ac:cxnSpMkLst>
        </pc:cxnChg>
        <pc:cxnChg chg="mod topLvl">
          <ac:chgData name="Warner,Jeffrey Barr" userId="7360d018-3b8a-4d6d-8136-e4d170e1e616" providerId="ADAL" clId="{E1317903-0E43-4FAC-A900-4D6121109CB5}" dt="2021-05-03T17:17:32.250" v="3089" actId="12788"/>
          <ac:cxnSpMkLst>
            <pc:docMk/>
            <pc:sldMk cId="2331476235" sldId="389"/>
            <ac:cxnSpMk id="24" creationId="{E28D5BF8-A20E-47E3-A925-29991FD0FCC9}"/>
          </ac:cxnSpMkLst>
        </pc:cxnChg>
        <pc:cxnChg chg="del mod topLvl">
          <ac:chgData name="Warner,Jeffrey Barr" userId="7360d018-3b8a-4d6d-8136-e4d170e1e616" providerId="ADAL" clId="{E1317903-0E43-4FAC-A900-4D6121109CB5}" dt="2021-05-03T17:18:03.035" v="3098" actId="478"/>
          <ac:cxnSpMkLst>
            <pc:docMk/>
            <pc:sldMk cId="2331476235" sldId="389"/>
            <ac:cxnSpMk id="34" creationId="{0C3CFE9C-2ECD-4AD7-B717-B0E84E6A8210}"/>
          </ac:cxnSpMkLst>
        </pc:cxnChg>
        <pc:cxnChg chg="del mod topLvl">
          <ac:chgData name="Warner,Jeffrey Barr" userId="7360d018-3b8a-4d6d-8136-e4d170e1e616" providerId="ADAL" clId="{E1317903-0E43-4FAC-A900-4D6121109CB5}" dt="2021-05-03T17:18:03.035" v="3098" actId="478"/>
          <ac:cxnSpMkLst>
            <pc:docMk/>
            <pc:sldMk cId="2331476235" sldId="389"/>
            <ac:cxnSpMk id="35" creationId="{6ED5C401-1A3E-42BE-9136-3FEFB0F83F20}"/>
          </ac:cxnSpMkLst>
        </pc:cxnChg>
        <pc:cxnChg chg="del mod topLvl">
          <ac:chgData name="Warner,Jeffrey Barr" userId="7360d018-3b8a-4d6d-8136-e4d170e1e616" providerId="ADAL" clId="{E1317903-0E43-4FAC-A900-4D6121109CB5}" dt="2021-05-03T17:18:03.035" v="3098" actId="478"/>
          <ac:cxnSpMkLst>
            <pc:docMk/>
            <pc:sldMk cId="2331476235" sldId="389"/>
            <ac:cxnSpMk id="36" creationId="{5DBDF664-BD54-48EB-A54A-F5F9C63918AF}"/>
          </ac:cxnSpMkLst>
        </pc:cxnChg>
        <pc:cxnChg chg="del mod topLvl">
          <ac:chgData name="Warner,Jeffrey Barr" userId="7360d018-3b8a-4d6d-8136-e4d170e1e616" providerId="ADAL" clId="{E1317903-0E43-4FAC-A900-4D6121109CB5}" dt="2021-05-03T17:18:03.035" v="3098" actId="478"/>
          <ac:cxnSpMkLst>
            <pc:docMk/>
            <pc:sldMk cId="2331476235" sldId="389"/>
            <ac:cxnSpMk id="37" creationId="{24F4FD8A-3021-40E2-9DFA-72645D3A5F03}"/>
          </ac:cxnSpMkLst>
        </pc:cxnChg>
        <pc:cxnChg chg="del mod topLvl">
          <ac:chgData name="Warner,Jeffrey Barr" userId="7360d018-3b8a-4d6d-8136-e4d170e1e616" providerId="ADAL" clId="{E1317903-0E43-4FAC-A900-4D6121109CB5}" dt="2021-05-03T17:18:03.035" v="3098" actId="478"/>
          <ac:cxnSpMkLst>
            <pc:docMk/>
            <pc:sldMk cId="2331476235" sldId="389"/>
            <ac:cxnSpMk id="38" creationId="{6D6007A9-EF32-4CCC-8FF4-538DA2050700}"/>
          </ac:cxnSpMkLst>
        </pc:cxnChg>
        <pc:cxnChg chg="del mod topLvl">
          <ac:chgData name="Warner,Jeffrey Barr" userId="7360d018-3b8a-4d6d-8136-e4d170e1e616" providerId="ADAL" clId="{E1317903-0E43-4FAC-A900-4D6121109CB5}" dt="2021-05-03T17:18:03.035" v="3098" actId="478"/>
          <ac:cxnSpMkLst>
            <pc:docMk/>
            <pc:sldMk cId="2331476235" sldId="389"/>
            <ac:cxnSpMk id="39" creationId="{28AEAC36-2FA5-416E-B3AA-4BEB61ED38F1}"/>
          </ac:cxnSpMkLst>
        </pc:cxnChg>
        <pc:cxnChg chg="del mod topLvl">
          <ac:chgData name="Warner,Jeffrey Barr" userId="7360d018-3b8a-4d6d-8136-e4d170e1e616" providerId="ADAL" clId="{E1317903-0E43-4FAC-A900-4D6121109CB5}" dt="2021-05-03T17:18:03.035" v="3098" actId="478"/>
          <ac:cxnSpMkLst>
            <pc:docMk/>
            <pc:sldMk cId="2331476235" sldId="389"/>
            <ac:cxnSpMk id="40" creationId="{9375752F-6A89-4E5C-8B44-C43CA7B7C254}"/>
          </ac:cxnSpMkLst>
        </pc:cxnChg>
        <pc:cxnChg chg="mod topLvl">
          <ac:chgData name="Warner,Jeffrey Barr" userId="7360d018-3b8a-4d6d-8136-e4d170e1e616" providerId="ADAL" clId="{E1317903-0E43-4FAC-A900-4D6121109CB5}" dt="2021-05-03T16:47:11.841" v="2651" actId="165"/>
          <ac:cxnSpMkLst>
            <pc:docMk/>
            <pc:sldMk cId="2331476235" sldId="389"/>
            <ac:cxnSpMk id="42" creationId="{42A2DF3A-1A3A-43B6-96D4-72BFBA1C5C31}"/>
          </ac:cxnSpMkLst>
        </pc:cxnChg>
        <pc:cxnChg chg="mod topLvl">
          <ac:chgData name="Warner,Jeffrey Barr" userId="7360d018-3b8a-4d6d-8136-e4d170e1e616" providerId="ADAL" clId="{E1317903-0E43-4FAC-A900-4D6121109CB5}" dt="2021-05-03T16:47:11.841" v="2651" actId="165"/>
          <ac:cxnSpMkLst>
            <pc:docMk/>
            <pc:sldMk cId="2331476235" sldId="389"/>
            <ac:cxnSpMk id="43" creationId="{85A2D645-D319-40CA-945A-C777D20CF57F}"/>
          </ac:cxnSpMkLst>
        </pc:cxnChg>
        <pc:cxnChg chg="mod topLvl">
          <ac:chgData name="Warner,Jeffrey Barr" userId="7360d018-3b8a-4d6d-8136-e4d170e1e616" providerId="ADAL" clId="{E1317903-0E43-4FAC-A900-4D6121109CB5}" dt="2021-05-03T16:47:11.841" v="2651" actId="165"/>
          <ac:cxnSpMkLst>
            <pc:docMk/>
            <pc:sldMk cId="2331476235" sldId="389"/>
            <ac:cxnSpMk id="44" creationId="{694AEF16-58E9-4F55-92C3-C98F533AF077}"/>
          </ac:cxnSpMkLst>
        </pc:cxnChg>
        <pc:cxnChg chg="mod topLvl">
          <ac:chgData name="Warner,Jeffrey Barr" userId="7360d018-3b8a-4d6d-8136-e4d170e1e616" providerId="ADAL" clId="{E1317903-0E43-4FAC-A900-4D6121109CB5}" dt="2021-05-03T17:17:32.250" v="3089" actId="12788"/>
          <ac:cxnSpMkLst>
            <pc:docMk/>
            <pc:sldMk cId="2331476235" sldId="389"/>
            <ac:cxnSpMk id="45" creationId="{BA6966B0-09D7-4D20-BD1A-A3FA2148E67F}"/>
          </ac:cxnSpMkLst>
        </pc:cxnChg>
        <pc:cxnChg chg="mod topLvl">
          <ac:chgData name="Warner,Jeffrey Barr" userId="7360d018-3b8a-4d6d-8136-e4d170e1e616" providerId="ADAL" clId="{E1317903-0E43-4FAC-A900-4D6121109CB5}" dt="2021-05-03T17:16:52.065" v="3047" actId="14100"/>
          <ac:cxnSpMkLst>
            <pc:docMk/>
            <pc:sldMk cId="2331476235" sldId="389"/>
            <ac:cxnSpMk id="57" creationId="{983B8926-CBFB-42DA-B5CC-0477C6AD23DD}"/>
          </ac:cxnSpMkLst>
        </pc:cxnChg>
        <pc:cxnChg chg="mod topLvl">
          <ac:chgData name="Warner,Jeffrey Barr" userId="7360d018-3b8a-4d6d-8136-e4d170e1e616" providerId="ADAL" clId="{E1317903-0E43-4FAC-A900-4D6121109CB5}" dt="2021-05-03T17:16:42.128" v="3044" actId="1076"/>
          <ac:cxnSpMkLst>
            <pc:docMk/>
            <pc:sldMk cId="2331476235" sldId="389"/>
            <ac:cxnSpMk id="58" creationId="{CB4AE224-50EC-48FA-AB58-87B403A50865}"/>
          </ac:cxnSpMkLst>
        </pc:cxnChg>
        <pc:cxnChg chg="mod topLvl">
          <ac:chgData name="Warner,Jeffrey Barr" userId="7360d018-3b8a-4d6d-8136-e4d170e1e616" providerId="ADAL" clId="{E1317903-0E43-4FAC-A900-4D6121109CB5}" dt="2021-05-03T17:16:48.458" v="3046" actId="14100"/>
          <ac:cxnSpMkLst>
            <pc:docMk/>
            <pc:sldMk cId="2331476235" sldId="389"/>
            <ac:cxnSpMk id="59" creationId="{814A35B7-57B7-4B59-B836-FEFB0915284B}"/>
          </ac:cxnSpMkLst>
        </pc:cxnChg>
        <pc:cxnChg chg="add del mod">
          <ac:chgData name="Warner,Jeffrey Barr" userId="7360d018-3b8a-4d6d-8136-e4d170e1e616" providerId="ADAL" clId="{E1317903-0E43-4FAC-A900-4D6121109CB5}" dt="2021-05-03T17:18:04.609" v="3099" actId="478"/>
          <ac:cxnSpMkLst>
            <pc:docMk/>
            <pc:sldMk cId="2331476235" sldId="389"/>
            <ac:cxnSpMk id="63" creationId="{3C302613-4C78-41DF-B482-9AF98394B9D1}"/>
          </ac:cxnSpMkLst>
        </pc:cxnChg>
        <pc:cxnChg chg="add del mod">
          <ac:chgData name="Warner,Jeffrey Barr" userId="7360d018-3b8a-4d6d-8136-e4d170e1e616" providerId="ADAL" clId="{E1317903-0E43-4FAC-A900-4D6121109CB5}" dt="2021-05-03T17:18:04.609" v="3099" actId="478"/>
          <ac:cxnSpMkLst>
            <pc:docMk/>
            <pc:sldMk cId="2331476235" sldId="389"/>
            <ac:cxnSpMk id="64" creationId="{47F4D9DA-4F4C-4C98-9086-E2CB4BFE1131}"/>
          </ac:cxnSpMkLst>
        </pc:cxnChg>
        <pc:cxnChg chg="add del mod">
          <ac:chgData name="Warner,Jeffrey Barr" userId="7360d018-3b8a-4d6d-8136-e4d170e1e616" providerId="ADAL" clId="{E1317903-0E43-4FAC-A900-4D6121109CB5}" dt="2021-05-03T17:18:04.609" v="3099" actId="478"/>
          <ac:cxnSpMkLst>
            <pc:docMk/>
            <pc:sldMk cId="2331476235" sldId="389"/>
            <ac:cxnSpMk id="65" creationId="{FFDB8947-AF4F-4E88-B24B-BE7ED8149F63}"/>
          </ac:cxnSpMkLst>
        </pc:cxnChg>
        <pc:cxnChg chg="add del mod">
          <ac:chgData name="Warner,Jeffrey Barr" userId="7360d018-3b8a-4d6d-8136-e4d170e1e616" providerId="ADAL" clId="{E1317903-0E43-4FAC-A900-4D6121109CB5}" dt="2021-05-03T17:18:04.609" v="3099" actId="478"/>
          <ac:cxnSpMkLst>
            <pc:docMk/>
            <pc:sldMk cId="2331476235" sldId="389"/>
            <ac:cxnSpMk id="66" creationId="{74E283AA-19A8-49CC-BCEA-E029B24E0828}"/>
          </ac:cxnSpMkLst>
        </pc:cxnChg>
        <pc:cxnChg chg="add del mod">
          <ac:chgData name="Warner,Jeffrey Barr" userId="7360d018-3b8a-4d6d-8136-e4d170e1e616" providerId="ADAL" clId="{E1317903-0E43-4FAC-A900-4D6121109CB5}" dt="2021-05-03T17:18:04.609" v="3099" actId="478"/>
          <ac:cxnSpMkLst>
            <pc:docMk/>
            <pc:sldMk cId="2331476235" sldId="389"/>
            <ac:cxnSpMk id="67" creationId="{7EAA4F2B-B9B0-4F67-B437-7C301E81CD63}"/>
          </ac:cxnSpMkLst>
        </pc:cxnChg>
        <pc:cxnChg chg="add del mod">
          <ac:chgData name="Warner,Jeffrey Barr" userId="7360d018-3b8a-4d6d-8136-e4d170e1e616" providerId="ADAL" clId="{E1317903-0E43-4FAC-A900-4D6121109CB5}" dt="2021-05-03T17:18:04.609" v="3099" actId="478"/>
          <ac:cxnSpMkLst>
            <pc:docMk/>
            <pc:sldMk cId="2331476235" sldId="389"/>
            <ac:cxnSpMk id="68" creationId="{CCFAA414-F6BA-4D6A-9421-C55E8E7A04D3}"/>
          </ac:cxnSpMkLst>
        </pc:cxnChg>
        <pc:cxnChg chg="add del mod">
          <ac:chgData name="Warner,Jeffrey Barr" userId="7360d018-3b8a-4d6d-8136-e4d170e1e616" providerId="ADAL" clId="{E1317903-0E43-4FAC-A900-4D6121109CB5}" dt="2021-05-03T17:18:04.609" v="3099" actId="478"/>
          <ac:cxnSpMkLst>
            <pc:docMk/>
            <pc:sldMk cId="2331476235" sldId="389"/>
            <ac:cxnSpMk id="69" creationId="{C10FEC39-23DF-471B-96AA-5F57B5CF6E4C}"/>
          </ac:cxnSpMkLst>
        </pc:cxnChg>
      </pc:sldChg>
      <pc:sldChg chg="addSp delSp modSp add del mod">
        <pc:chgData name="Warner,Jeffrey Barr" userId="7360d018-3b8a-4d6d-8136-e4d170e1e616" providerId="ADAL" clId="{E1317903-0E43-4FAC-A900-4D6121109CB5}" dt="2021-05-20T16:56:22.361" v="8020" actId="2696"/>
        <pc:sldMkLst>
          <pc:docMk/>
          <pc:sldMk cId="1233331720" sldId="390"/>
        </pc:sldMkLst>
        <pc:spChg chg="mod">
          <ac:chgData name="Warner,Jeffrey Barr" userId="7360d018-3b8a-4d6d-8136-e4d170e1e616" providerId="ADAL" clId="{E1317903-0E43-4FAC-A900-4D6121109CB5}" dt="2021-05-05T19:54:08.257" v="4370" actId="20577"/>
          <ac:spMkLst>
            <pc:docMk/>
            <pc:sldMk cId="1233331720" sldId="390"/>
            <ac:spMk id="4" creationId="{CA669703-3265-42A6-8F53-7EBFB34CAC02}"/>
          </ac:spMkLst>
        </pc:spChg>
        <pc:graphicFrameChg chg="add del mod">
          <ac:chgData name="Warner,Jeffrey Barr" userId="7360d018-3b8a-4d6d-8136-e4d170e1e616" providerId="ADAL" clId="{E1317903-0E43-4FAC-A900-4D6121109CB5}" dt="2021-05-05T19:53:33.889" v="4337"/>
          <ac:graphicFrameMkLst>
            <pc:docMk/>
            <pc:sldMk cId="1233331720" sldId="390"/>
            <ac:graphicFrameMk id="3" creationId="{575627DD-306C-4786-84C5-7ED474D947A5}"/>
          </ac:graphicFrameMkLst>
        </pc:graphicFrameChg>
        <pc:picChg chg="del">
          <ac:chgData name="Warner,Jeffrey Barr" userId="7360d018-3b8a-4d6d-8136-e4d170e1e616" providerId="ADAL" clId="{E1317903-0E43-4FAC-A900-4D6121109CB5}" dt="2021-05-05T19:53:31.116" v="4335" actId="478"/>
          <ac:picMkLst>
            <pc:docMk/>
            <pc:sldMk cId="1233331720" sldId="390"/>
            <ac:picMk id="2" creationId="{05B0D1F0-95C5-41CE-AE96-624B41566894}"/>
          </ac:picMkLst>
        </pc:picChg>
        <pc:picChg chg="add del">
          <ac:chgData name="Warner,Jeffrey Barr" userId="7360d018-3b8a-4d6d-8136-e4d170e1e616" providerId="ADAL" clId="{E1317903-0E43-4FAC-A900-4D6121109CB5}" dt="2021-05-05T19:53:39.903" v="4339" actId="478"/>
          <ac:picMkLst>
            <pc:docMk/>
            <pc:sldMk cId="1233331720" sldId="390"/>
            <ac:picMk id="5" creationId="{B827146D-3CC1-4B5A-85D2-87CE90A90AE8}"/>
          </ac:picMkLst>
        </pc:picChg>
        <pc:picChg chg="add del">
          <ac:chgData name="Warner,Jeffrey Barr" userId="7360d018-3b8a-4d6d-8136-e4d170e1e616" providerId="ADAL" clId="{E1317903-0E43-4FAC-A900-4D6121109CB5}" dt="2021-05-05T19:53:56.897" v="4341" actId="478"/>
          <ac:picMkLst>
            <pc:docMk/>
            <pc:sldMk cId="1233331720" sldId="390"/>
            <ac:picMk id="6" creationId="{B9BDB163-FA13-4961-BFED-2E65EBDBFCDE}"/>
          </ac:picMkLst>
        </pc:picChg>
        <pc:picChg chg="add">
          <ac:chgData name="Warner,Jeffrey Barr" userId="7360d018-3b8a-4d6d-8136-e4d170e1e616" providerId="ADAL" clId="{E1317903-0E43-4FAC-A900-4D6121109CB5}" dt="2021-05-05T19:53:58.046" v="4342"/>
          <ac:picMkLst>
            <pc:docMk/>
            <pc:sldMk cId="1233331720" sldId="390"/>
            <ac:picMk id="7" creationId="{054272B8-334B-4E72-8B2A-1AE3D7965D22}"/>
          </ac:picMkLst>
        </pc:picChg>
      </pc:sldChg>
    </pc:docChg>
  </pc:docChgLst>
  <pc:docChgLst>
    <pc:chgData name="Warner,Jeffrey Barr" userId="7360d018-3b8a-4d6d-8136-e4d170e1e616" providerId="ADAL" clId="{72BFBB82-3181-4CD8-8DCF-90D87118004C}"/>
    <pc:docChg chg="custSel modSld">
      <pc:chgData name="Warner,Jeffrey Barr" userId="7360d018-3b8a-4d6d-8136-e4d170e1e616" providerId="ADAL" clId="{72BFBB82-3181-4CD8-8DCF-90D87118004C}" dt="2021-11-10T16:21:05.751" v="7" actId="478"/>
      <pc:docMkLst>
        <pc:docMk/>
      </pc:docMkLst>
      <pc:sldChg chg="delSp mod">
        <pc:chgData name="Warner,Jeffrey Barr" userId="7360d018-3b8a-4d6d-8136-e4d170e1e616" providerId="ADAL" clId="{72BFBB82-3181-4CD8-8DCF-90D87118004C}" dt="2021-11-10T16:19:59.662" v="4" actId="478"/>
        <pc:sldMkLst>
          <pc:docMk/>
          <pc:sldMk cId="3815654910" sldId="259"/>
        </pc:sldMkLst>
        <pc:spChg chg="del">
          <ac:chgData name="Warner,Jeffrey Barr" userId="7360d018-3b8a-4d6d-8136-e4d170e1e616" providerId="ADAL" clId="{72BFBB82-3181-4CD8-8DCF-90D87118004C}" dt="2021-11-10T16:19:59.662" v="4" actId="478"/>
          <ac:spMkLst>
            <pc:docMk/>
            <pc:sldMk cId="3815654910" sldId="259"/>
            <ac:spMk id="75" creationId="{10A180C6-EDEB-44FB-832C-B6AE8CE84668}"/>
          </ac:spMkLst>
        </pc:spChg>
      </pc:sldChg>
      <pc:sldChg chg="delSp mod">
        <pc:chgData name="Warner,Jeffrey Barr" userId="7360d018-3b8a-4d6d-8136-e4d170e1e616" providerId="ADAL" clId="{72BFBB82-3181-4CD8-8DCF-90D87118004C}" dt="2021-11-10T16:17:07.408" v="1" actId="478"/>
        <pc:sldMkLst>
          <pc:docMk/>
          <pc:sldMk cId="1676406075" sldId="264"/>
        </pc:sldMkLst>
        <pc:spChg chg="del">
          <ac:chgData name="Warner,Jeffrey Barr" userId="7360d018-3b8a-4d6d-8136-e4d170e1e616" providerId="ADAL" clId="{72BFBB82-3181-4CD8-8DCF-90D87118004C}" dt="2021-11-10T16:17:07.408" v="1" actId="478"/>
          <ac:spMkLst>
            <pc:docMk/>
            <pc:sldMk cId="1676406075" sldId="264"/>
            <ac:spMk id="73" creationId="{F76E79E0-2EC2-413A-B598-3020DFDFA7CB}"/>
          </ac:spMkLst>
        </pc:spChg>
      </pc:sldChg>
      <pc:sldChg chg="delSp mod">
        <pc:chgData name="Warner,Jeffrey Barr" userId="7360d018-3b8a-4d6d-8136-e4d170e1e616" providerId="ADAL" clId="{72BFBB82-3181-4CD8-8DCF-90D87118004C}" dt="2021-11-10T16:19:38.689" v="3" actId="478"/>
        <pc:sldMkLst>
          <pc:docMk/>
          <pc:sldMk cId="2515056989" sldId="337"/>
        </pc:sldMkLst>
        <pc:spChg chg="del">
          <ac:chgData name="Warner,Jeffrey Barr" userId="7360d018-3b8a-4d6d-8136-e4d170e1e616" providerId="ADAL" clId="{72BFBB82-3181-4CD8-8DCF-90D87118004C}" dt="2021-11-10T16:19:38.689" v="3" actId="478"/>
          <ac:spMkLst>
            <pc:docMk/>
            <pc:sldMk cId="2515056989" sldId="337"/>
            <ac:spMk id="7" creationId="{7BBBE655-BFC6-44F9-913E-EC48B0143865}"/>
          </ac:spMkLst>
        </pc:spChg>
      </pc:sldChg>
      <pc:sldChg chg="delSp mod">
        <pc:chgData name="Warner,Jeffrey Barr" userId="7360d018-3b8a-4d6d-8136-e4d170e1e616" providerId="ADAL" clId="{72BFBB82-3181-4CD8-8DCF-90D87118004C}" dt="2021-11-10T16:17:44.937" v="2" actId="478"/>
        <pc:sldMkLst>
          <pc:docMk/>
          <pc:sldMk cId="3797510600" sldId="339"/>
        </pc:sldMkLst>
        <pc:spChg chg="del">
          <ac:chgData name="Warner,Jeffrey Barr" userId="7360d018-3b8a-4d6d-8136-e4d170e1e616" providerId="ADAL" clId="{72BFBB82-3181-4CD8-8DCF-90D87118004C}" dt="2021-11-10T16:17:44.937" v="2" actId="478"/>
          <ac:spMkLst>
            <pc:docMk/>
            <pc:sldMk cId="3797510600" sldId="339"/>
            <ac:spMk id="59" creationId="{79ED029E-DACD-4007-9CBD-D9CC25AD536D}"/>
          </ac:spMkLst>
        </pc:spChg>
      </pc:sldChg>
      <pc:sldChg chg="delSp mod">
        <pc:chgData name="Warner,Jeffrey Barr" userId="7360d018-3b8a-4d6d-8136-e4d170e1e616" providerId="ADAL" clId="{72BFBB82-3181-4CD8-8DCF-90D87118004C}" dt="2021-11-10T16:20:21.921" v="5" actId="478"/>
        <pc:sldMkLst>
          <pc:docMk/>
          <pc:sldMk cId="2788620995" sldId="356"/>
        </pc:sldMkLst>
        <pc:spChg chg="del">
          <ac:chgData name="Warner,Jeffrey Barr" userId="7360d018-3b8a-4d6d-8136-e4d170e1e616" providerId="ADAL" clId="{72BFBB82-3181-4CD8-8DCF-90D87118004C}" dt="2021-11-10T16:20:21.921" v="5" actId="478"/>
          <ac:spMkLst>
            <pc:docMk/>
            <pc:sldMk cId="2788620995" sldId="356"/>
            <ac:spMk id="189" creationId="{30DAD9EB-8A51-4F23-AE4A-4ED466361138}"/>
          </ac:spMkLst>
        </pc:spChg>
      </pc:sldChg>
      <pc:sldChg chg="delSp mod">
        <pc:chgData name="Warner,Jeffrey Barr" userId="7360d018-3b8a-4d6d-8136-e4d170e1e616" providerId="ADAL" clId="{72BFBB82-3181-4CD8-8DCF-90D87118004C}" dt="2021-11-10T16:16:23.099" v="0" actId="478"/>
        <pc:sldMkLst>
          <pc:docMk/>
          <pc:sldMk cId="2894237854" sldId="378"/>
        </pc:sldMkLst>
        <pc:spChg chg="del">
          <ac:chgData name="Warner,Jeffrey Barr" userId="7360d018-3b8a-4d6d-8136-e4d170e1e616" providerId="ADAL" clId="{72BFBB82-3181-4CD8-8DCF-90D87118004C}" dt="2021-11-10T16:16:23.099" v="0" actId="478"/>
          <ac:spMkLst>
            <pc:docMk/>
            <pc:sldMk cId="2894237854" sldId="378"/>
            <ac:spMk id="75" creationId="{4617EA2D-320D-41C0-843F-429E25D8A30D}"/>
          </ac:spMkLst>
        </pc:spChg>
      </pc:sldChg>
      <pc:sldChg chg="delSp mod">
        <pc:chgData name="Warner,Jeffrey Barr" userId="7360d018-3b8a-4d6d-8136-e4d170e1e616" providerId="ADAL" clId="{72BFBB82-3181-4CD8-8DCF-90D87118004C}" dt="2021-11-10T16:21:05.751" v="7" actId="478"/>
        <pc:sldMkLst>
          <pc:docMk/>
          <pc:sldMk cId="500895388" sldId="387"/>
        </pc:sldMkLst>
        <pc:spChg chg="del">
          <ac:chgData name="Warner,Jeffrey Barr" userId="7360d018-3b8a-4d6d-8136-e4d170e1e616" providerId="ADAL" clId="{72BFBB82-3181-4CD8-8DCF-90D87118004C}" dt="2021-11-10T16:21:05.751" v="7" actId="478"/>
          <ac:spMkLst>
            <pc:docMk/>
            <pc:sldMk cId="500895388" sldId="387"/>
            <ac:spMk id="36" creationId="{93E99861-F1D9-4357-BC92-3B6086E6C9CD}"/>
          </ac:spMkLst>
        </pc:spChg>
      </pc:sldChg>
      <pc:sldChg chg="delSp mod">
        <pc:chgData name="Warner,Jeffrey Barr" userId="7360d018-3b8a-4d6d-8136-e4d170e1e616" providerId="ADAL" clId="{72BFBB82-3181-4CD8-8DCF-90D87118004C}" dt="2021-11-10T16:20:43.983" v="6" actId="478"/>
        <pc:sldMkLst>
          <pc:docMk/>
          <pc:sldMk cId="3719077622" sldId="389"/>
        </pc:sldMkLst>
        <pc:spChg chg="del">
          <ac:chgData name="Warner,Jeffrey Barr" userId="7360d018-3b8a-4d6d-8136-e4d170e1e616" providerId="ADAL" clId="{72BFBB82-3181-4CD8-8DCF-90D87118004C}" dt="2021-11-10T16:20:43.983" v="6" actId="478"/>
          <ac:spMkLst>
            <pc:docMk/>
            <pc:sldMk cId="3719077622" sldId="389"/>
            <ac:spMk id="17" creationId="{5D10D50E-92FA-464A-901B-0A6FBBD00F74}"/>
          </ac:spMkLst>
        </pc:spChg>
      </pc:sldChg>
    </pc:docChg>
  </pc:docChgLst>
  <pc:docChgLst>
    <pc:chgData name="Warner,Jeffrey Barr" userId="7360d018-3b8a-4d6d-8136-e4d170e1e616" providerId="ADAL" clId="{80816FA7-34D3-4241-B642-1465F17EAD18}"/>
    <pc:docChg chg="custSel delSld modSld">
      <pc:chgData name="Warner,Jeffrey Barr" userId="7360d018-3b8a-4d6d-8136-e4d170e1e616" providerId="ADAL" clId="{80816FA7-34D3-4241-B642-1465F17EAD18}" dt="2021-11-10T16:32:49.699" v="79" actId="1076"/>
      <pc:docMkLst>
        <pc:docMk/>
      </pc:docMkLst>
      <pc:sldChg chg="del">
        <pc:chgData name="Warner,Jeffrey Barr" userId="7360d018-3b8a-4d6d-8136-e4d170e1e616" providerId="ADAL" clId="{80816FA7-34D3-4241-B642-1465F17EAD18}" dt="2021-11-10T16:29:30.803" v="0" actId="2696"/>
        <pc:sldMkLst>
          <pc:docMk/>
          <pc:sldMk cId="3815654910" sldId="259"/>
        </pc:sldMkLst>
      </pc:sldChg>
      <pc:sldChg chg="del">
        <pc:chgData name="Warner,Jeffrey Barr" userId="7360d018-3b8a-4d6d-8136-e4d170e1e616" providerId="ADAL" clId="{80816FA7-34D3-4241-B642-1465F17EAD18}" dt="2021-11-10T16:29:30.803" v="0" actId="2696"/>
        <pc:sldMkLst>
          <pc:docMk/>
          <pc:sldMk cId="1676406075" sldId="264"/>
        </pc:sldMkLst>
      </pc:sldChg>
      <pc:sldChg chg="addSp delSp modSp mod">
        <pc:chgData name="Warner,Jeffrey Barr" userId="7360d018-3b8a-4d6d-8136-e4d170e1e616" providerId="ADAL" clId="{80816FA7-34D3-4241-B642-1465F17EAD18}" dt="2021-11-10T16:32:33.055" v="71" actId="1036"/>
        <pc:sldMkLst>
          <pc:docMk/>
          <pc:sldMk cId="3319412604" sldId="269"/>
        </pc:sldMkLst>
        <pc:spChg chg="mod">
          <ac:chgData name="Warner,Jeffrey Barr" userId="7360d018-3b8a-4d6d-8136-e4d170e1e616" providerId="ADAL" clId="{80816FA7-34D3-4241-B642-1465F17EAD18}" dt="2021-11-10T16:32:31.125" v="67" actId="1036"/>
          <ac:spMkLst>
            <pc:docMk/>
            <pc:sldMk cId="3319412604" sldId="269"/>
            <ac:spMk id="18" creationId="{00000000-0000-0000-0000-000000000000}"/>
          </ac:spMkLst>
        </pc:spChg>
        <pc:spChg chg="mod">
          <ac:chgData name="Warner,Jeffrey Barr" userId="7360d018-3b8a-4d6d-8136-e4d170e1e616" providerId="ADAL" clId="{80816FA7-34D3-4241-B642-1465F17EAD18}" dt="2021-11-10T16:32:31.125" v="67" actId="1036"/>
          <ac:spMkLst>
            <pc:docMk/>
            <pc:sldMk cId="3319412604" sldId="269"/>
            <ac:spMk id="23" creationId="{00000000-0000-0000-0000-000000000000}"/>
          </ac:spMkLst>
        </pc:spChg>
        <pc:spChg chg="mod">
          <ac:chgData name="Warner,Jeffrey Barr" userId="7360d018-3b8a-4d6d-8136-e4d170e1e616" providerId="ADAL" clId="{80816FA7-34D3-4241-B642-1465F17EAD18}" dt="2021-11-10T16:32:31.125" v="67" actId="1036"/>
          <ac:spMkLst>
            <pc:docMk/>
            <pc:sldMk cId="3319412604" sldId="269"/>
            <ac:spMk id="28" creationId="{00000000-0000-0000-0000-000000000000}"/>
          </ac:spMkLst>
        </pc:spChg>
        <pc:spChg chg="mod">
          <ac:chgData name="Warner,Jeffrey Barr" userId="7360d018-3b8a-4d6d-8136-e4d170e1e616" providerId="ADAL" clId="{80816FA7-34D3-4241-B642-1465F17EAD18}" dt="2021-11-10T16:32:31.125" v="67" actId="1036"/>
          <ac:spMkLst>
            <pc:docMk/>
            <pc:sldMk cId="3319412604" sldId="269"/>
            <ac:spMk id="30" creationId="{00000000-0000-0000-0000-000000000000}"/>
          </ac:spMkLst>
        </pc:spChg>
        <pc:spChg chg="mod">
          <ac:chgData name="Warner,Jeffrey Barr" userId="7360d018-3b8a-4d6d-8136-e4d170e1e616" providerId="ADAL" clId="{80816FA7-34D3-4241-B642-1465F17EAD18}" dt="2021-11-10T16:32:31.125" v="67" actId="1036"/>
          <ac:spMkLst>
            <pc:docMk/>
            <pc:sldMk cId="3319412604" sldId="269"/>
            <ac:spMk id="74" creationId="{88592D39-C555-8240-88B1-922E066C394A}"/>
          </ac:spMkLst>
        </pc:spChg>
        <pc:spChg chg="mod">
          <ac:chgData name="Warner,Jeffrey Barr" userId="7360d018-3b8a-4d6d-8136-e4d170e1e616" providerId="ADAL" clId="{80816FA7-34D3-4241-B642-1465F17EAD18}" dt="2021-11-10T16:32:31.125" v="67" actId="1036"/>
          <ac:spMkLst>
            <pc:docMk/>
            <pc:sldMk cId="3319412604" sldId="269"/>
            <ac:spMk id="86" creationId="{8E3D3354-2658-D445-BB0B-A10480161FF9}"/>
          </ac:spMkLst>
        </pc:spChg>
        <pc:spChg chg="mod">
          <ac:chgData name="Warner,Jeffrey Barr" userId="7360d018-3b8a-4d6d-8136-e4d170e1e616" providerId="ADAL" clId="{80816FA7-34D3-4241-B642-1465F17EAD18}" dt="2021-11-10T16:32:31.125" v="67" actId="1036"/>
          <ac:spMkLst>
            <pc:docMk/>
            <pc:sldMk cId="3319412604" sldId="269"/>
            <ac:spMk id="94" creationId="{A0D49CBF-CA7E-4D47-A1B8-BEC3B9466D17}"/>
          </ac:spMkLst>
        </pc:spChg>
        <pc:spChg chg="mod">
          <ac:chgData name="Warner,Jeffrey Barr" userId="7360d018-3b8a-4d6d-8136-e4d170e1e616" providerId="ADAL" clId="{80816FA7-34D3-4241-B642-1465F17EAD18}" dt="2021-11-10T16:32:31.125" v="67" actId="1036"/>
          <ac:spMkLst>
            <pc:docMk/>
            <pc:sldMk cId="3319412604" sldId="269"/>
            <ac:spMk id="109" creationId="{D79900F8-5AC4-BF43-B918-69555FEF9FB5}"/>
          </ac:spMkLst>
        </pc:spChg>
        <pc:spChg chg="mod">
          <ac:chgData name="Warner,Jeffrey Barr" userId="7360d018-3b8a-4d6d-8136-e4d170e1e616" providerId="ADAL" clId="{80816FA7-34D3-4241-B642-1465F17EAD18}" dt="2021-11-10T16:32:31.125" v="67" actId="1036"/>
          <ac:spMkLst>
            <pc:docMk/>
            <pc:sldMk cId="3319412604" sldId="269"/>
            <ac:spMk id="117" creationId="{F74A7890-6EB6-7342-9206-4CB82D70EFAB}"/>
          </ac:spMkLst>
        </pc:spChg>
        <pc:spChg chg="del">
          <ac:chgData name="Warner,Jeffrey Barr" userId="7360d018-3b8a-4d6d-8136-e4d170e1e616" providerId="ADAL" clId="{80816FA7-34D3-4241-B642-1465F17EAD18}" dt="2021-11-10T16:31:14.428" v="2" actId="478"/>
          <ac:spMkLst>
            <pc:docMk/>
            <pc:sldMk cId="3319412604" sldId="269"/>
            <ac:spMk id="122" creationId="{BFB7B06D-321A-48F5-A81A-FB9F0DF99572}"/>
          </ac:spMkLst>
        </pc:spChg>
        <pc:spChg chg="mod">
          <ac:chgData name="Warner,Jeffrey Barr" userId="7360d018-3b8a-4d6d-8136-e4d170e1e616" providerId="ADAL" clId="{80816FA7-34D3-4241-B642-1465F17EAD18}" dt="2021-11-10T16:32:31.125" v="67" actId="1036"/>
          <ac:spMkLst>
            <pc:docMk/>
            <pc:sldMk cId="3319412604" sldId="269"/>
            <ac:spMk id="127" creationId="{2B511B88-B828-E440-906F-567BCF8E1D39}"/>
          </ac:spMkLst>
        </pc:spChg>
        <pc:spChg chg="add mod">
          <ac:chgData name="Warner,Jeffrey Barr" userId="7360d018-3b8a-4d6d-8136-e4d170e1e616" providerId="ADAL" clId="{80816FA7-34D3-4241-B642-1465F17EAD18}" dt="2021-11-10T16:32:33.055" v="71" actId="1036"/>
          <ac:spMkLst>
            <pc:docMk/>
            <pc:sldMk cId="3319412604" sldId="269"/>
            <ac:spMk id="128" creationId="{D227381F-F7CB-4F63-AF60-786ACB994F02}"/>
          </ac:spMkLst>
        </pc:spChg>
        <pc:grpChg chg="mod">
          <ac:chgData name="Warner,Jeffrey Barr" userId="7360d018-3b8a-4d6d-8136-e4d170e1e616" providerId="ADAL" clId="{80816FA7-34D3-4241-B642-1465F17EAD18}" dt="2021-11-10T16:32:31.125" v="67" actId="1036"/>
          <ac:grpSpMkLst>
            <pc:docMk/>
            <pc:sldMk cId="3319412604" sldId="269"/>
            <ac:grpSpMk id="2" creationId="{DAD73332-844B-4896-AED2-5E6E4DCAD59A}"/>
          </ac:grpSpMkLst>
        </pc:grpChg>
        <pc:grpChg chg="mod">
          <ac:chgData name="Warner,Jeffrey Barr" userId="7360d018-3b8a-4d6d-8136-e4d170e1e616" providerId="ADAL" clId="{80816FA7-34D3-4241-B642-1465F17EAD18}" dt="2021-11-10T16:32:31.125" v="67" actId="1036"/>
          <ac:grpSpMkLst>
            <pc:docMk/>
            <pc:sldMk cId="3319412604" sldId="269"/>
            <ac:grpSpMk id="9" creationId="{BFCF1B8C-9DAA-624C-80DB-AF05FE6E9010}"/>
          </ac:grpSpMkLst>
        </pc:grpChg>
        <pc:grpChg chg="mod">
          <ac:chgData name="Warner,Jeffrey Barr" userId="7360d018-3b8a-4d6d-8136-e4d170e1e616" providerId="ADAL" clId="{80816FA7-34D3-4241-B642-1465F17EAD18}" dt="2021-11-10T16:32:31.125" v="67" actId="1036"/>
          <ac:grpSpMkLst>
            <pc:docMk/>
            <pc:sldMk cId="3319412604" sldId="269"/>
            <ac:grpSpMk id="12" creationId="{73F9E966-1F4A-CF4B-A47E-FE7A17B63724}"/>
          </ac:grpSpMkLst>
        </pc:grpChg>
        <pc:grpChg chg="mod">
          <ac:chgData name="Warner,Jeffrey Barr" userId="7360d018-3b8a-4d6d-8136-e4d170e1e616" providerId="ADAL" clId="{80816FA7-34D3-4241-B642-1465F17EAD18}" dt="2021-11-10T16:32:31.125" v="67" actId="1036"/>
          <ac:grpSpMkLst>
            <pc:docMk/>
            <pc:sldMk cId="3319412604" sldId="269"/>
            <ac:grpSpMk id="19" creationId="{00000000-0000-0000-0000-000000000000}"/>
          </ac:grpSpMkLst>
        </pc:grpChg>
        <pc:grpChg chg="mod">
          <ac:chgData name="Warner,Jeffrey Barr" userId="7360d018-3b8a-4d6d-8136-e4d170e1e616" providerId="ADAL" clId="{80816FA7-34D3-4241-B642-1465F17EAD18}" dt="2021-11-10T16:32:31.125" v="67" actId="1036"/>
          <ac:grpSpMkLst>
            <pc:docMk/>
            <pc:sldMk cId="3319412604" sldId="269"/>
            <ac:grpSpMk id="20" creationId="{00000000-0000-0000-0000-000000000000}"/>
          </ac:grpSpMkLst>
        </pc:grpChg>
        <pc:grpChg chg="mod">
          <ac:chgData name="Warner,Jeffrey Barr" userId="7360d018-3b8a-4d6d-8136-e4d170e1e616" providerId="ADAL" clId="{80816FA7-34D3-4241-B642-1465F17EAD18}" dt="2021-11-10T16:32:31.125" v="67" actId="1036"/>
          <ac:grpSpMkLst>
            <pc:docMk/>
            <pc:sldMk cId="3319412604" sldId="269"/>
            <ac:grpSpMk id="21" creationId="{00000000-0000-0000-0000-000000000000}"/>
          </ac:grpSpMkLst>
        </pc:grpChg>
        <pc:grpChg chg="mod">
          <ac:chgData name="Warner,Jeffrey Barr" userId="7360d018-3b8a-4d6d-8136-e4d170e1e616" providerId="ADAL" clId="{80816FA7-34D3-4241-B642-1465F17EAD18}" dt="2021-11-10T16:32:31.125" v="67" actId="1036"/>
          <ac:grpSpMkLst>
            <pc:docMk/>
            <pc:sldMk cId="3319412604" sldId="269"/>
            <ac:grpSpMk id="22" creationId="{00000000-0000-0000-0000-000000000000}"/>
          </ac:grpSpMkLst>
        </pc:grpChg>
        <pc:grpChg chg="mod">
          <ac:chgData name="Warner,Jeffrey Barr" userId="7360d018-3b8a-4d6d-8136-e4d170e1e616" providerId="ADAL" clId="{80816FA7-34D3-4241-B642-1465F17EAD18}" dt="2021-11-10T16:32:31.125" v="67" actId="1036"/>
          <ac:grpSpMkLst>
            <pc:docMk/>
            <pc:sldMk cId="3319412604" sldId="269"/>
            <ac:grpSpMk id="25" creationId="{BFAC175D-035D-4947-A0CA-5C157036FBA6}"/>
          </ac:grpSpMkLst>
        </pc:grpChg>
        <pc:grpChg chg="mod">
          <ac:chgData name="Warner,Jeffrey Barr" userId="7360d018-3b8a-4d6d-8136-e4d170e1e616" providerId="ADAL" clId="{80816FA7-34D3-4241-B642-1465F17EAD18}" dt="2021-11-10T16:32:31.125" v="67" actId="1036"/>
          <ac:grpSpMkLst>
            <pc:docMk/>
            <pc:sldMk cId="3319412604" sldId="269"/>
            <ac:grpSpMk id="63" creationId="{D4B32422-2920-3A42-8161-F88FED598818}"/>
          </ac:grpSpMkLst>
        </pc:grpChg>
        <pc:grpChg chg="mod">
          <ac:chgData name="Warner,Jeffrey Barr" userId="7360d018-3b8a-4d6d-8136-e4d170e1e616" providerId="ADAL" clId="{80816FA7-34D3-4241-B642-1465F17EAD18}" dt="2021-11-10T16:32:31.125" v="67" actId="1036"/>
          <ac:grpSpMkLst>
            <pc:docMk/>
            <pc:sldMk cId="3319412604" sldId="269"/>
            <ac:grpSpMk id="77" creationId="{D372E56B-4C7F-B442-A2C4-8AE9034B2AF9}"/>
          </ac:grpSpMkLst>
        </pc:grpChg>
        <pc:grpChg chg="mod">
          <ac:chgData name="Warner,Jeffrey Barr" userId="7360d018-3b8a-4d6d-8136-e4d170e1e616" providerId="ADAL" clId="{80816FA7-34D3-4241-B642-1465F17EAD18}" dt="2021-11-10T16:32:31.125" v="67" actId="1036"/>
          <ac:grpSpMkLst>
            <pc:docMk/>
            <pc:sldMk cId="3319412604" sldId="269"/>
            <ac:grpSpMk id="130" creationId="{EDF174FB-3B34-6A46-AB9F-B2651DA912D1}"/>
          </ac:grpSpMkLst>
        </pc:grpChg>
        <pc:grpChg chg="mod">
          <ac:chgData name="Warner,Jeffrey Barr" userId="7360d018-3b8a-4d6d-8136-e4d170e1e616" providerId="ADAL" clId="{80816FA7-34D3-4241-B642-1465F17EAD18}" dt="2021-11-10T16:32:31.125" v="67" actId="1036"/>
          <ac:grpSpMkLst>
            <pc:docMk/>
            <pc:sldMk cId="3319412604" sldId="269"/>
            <ac:grpSpMk id="131" creationId="{42C15BD5-6AB4-744E-954E-12121FA138B7}"/>
          </ac:grpSpMkLst>
        </pc:grpChg>
        <pc:cxnChg chg="mod">
          <ac:chgData name="Warner,Jeffrey Barr" userId="7360d018-3b8a-4d6d-8136-e4d170e1e616" providerId="ADAL" clId="{80816FA7-34D3-4241-B642-1465F17EAD18}" dt="2021-11-10T16:32:31.125" v="67" actId="1036"/>
          <ac:cxnSpMkLst>
            <pc:docMk/>
            <pc:sldMk cId="3319412604" sldId="269"/>
            <ac:cxnSpMk id="7" creationId="{00000000-0000-0000-0000-000000000000}"/>
          </ac:cxnSpMkLst>
        </pc:cxnChg>
        <pc:cxnChg chg="mod">
          <ac:chgData name="Warner,Jeffrey Barr" userId="7360d018-3b8a-4d6d-8136-e4d170e1e616" providerId="ADAL" clId="{80816FA7-34D3-4241-B642-1465F17EAD18}" dt="2021-11-10T16:32:31.125" v="67" actId="1036"/>
          <ac:cxnSpMkLst>
            <pc:docMk/>
            <pc:sldMk cId="3319412604" sldId="269"/>
            <ac:cxnSpMk id="24" creationId="{00000000-0000-0000-0000-000000000000}"/>
          </ac:cxnSpMkLst>
        </pc:cxnChg>
        <pc:cxnChg chg="mod">
          <ac:chgData name="Warner,Jeffrey Barr" userId="7360d018-3b8a-4d6d-8136-e4d170e1e616" providerId="ADAL" clId="{80816FA7-34D3-4241-B642-1465F17EAD18}" dt="2021-11-10T16:32:31.125" v="67" actId="1036"/>
          <ac:cxnSpMkLst>
            <pc:docMk/>
            <pc:sldMk cId="3319412604" sldId="269"/>
            <ac:cxnSpMk id="29" creationId="{00000000-0000-0000-0000-000000000000}"/>
          </ac:cxnSpMkLst>
        </pc:cxnChg>
        <pc:cxnChg chg="mod">
          <ac:chgData name="Warner,Jeffrey Barr" userId="7360d018-3b8a-4d6d-8136-e4d170e1e616" providerId="ADAL" clId="{80816FA7-34D3-4241-B642-1465F17EAD18}" dt="2021-11-10T16:32:31.125" v="67" actId="1036"/>
          <ac:cxnSpMkLst>
            <pc:docMk/>
            <pc:sldMk cId="3319412604" sldId="269"/>
            <ac:cxnSpMk id="62" creationId="{72E9EE8C-8EEC-4445-8CE7-108A1F23BF04}"/>
          </ac:cxnSpMkLst>
        </pc:cxnChg>
        <pc:cxnChg chg="mod">
          <ac:chgData name="Warner,Jeffrey Barr" userId="7360d018-3b8a-4d6d-8136-e4d170e1e616" providerId="ADAL" clId="{80816FA7-34D3-4241-B642-1465F17EAD18}" dt="2021-11-10T16:32:31.125" v="67" actId="1036"/>
          <ac:cxnSpMkLst>
            <pc:docMk/>
            <pc:sldMk cId="3319412604" sldId="269"/>
            <ac:cxnSpMk id="72" creationId="{342BA422-9503-A442-8C30-76E37E7604F8}"/>
          </ac:cxnSpMkLst>
        </pc:cxnChg>
        <pc:cxnChg chg="mod">
          <ac:chgData name="Warner,Jeffrey Barr" userId="7360d018-3b8a-4d6d-8136-e4d170e1e616" providerId="ADAL" clId="{80816FA7-34D3-4241-B642-1465F17EAD18}" dt="2021-11-10T16:32:31.125" v="67" actId="1036"/>
          <ac:cxnSpMkLst>
            <pc:docMk/>
            <pc:sldMk cId="3319412604" sldId="269"/>
            <ac:cxnSpMk id="75" creationId="{ABC9AE3B-9A15-D744-880B-E34C3925B121}"/>
          </ac:cxnSpMkLst>
        </pc:cxnChg>
        <pc:cxnChg chg="mod">
          <ac:chgData name="Warner,Jeffrey Barr" userId="7360d018-3b8a-4d6d-8136-e4d170e1e616" providerId="ADAL" clId="{80816FA7-34D3-4241-B642-1465F17EAD18}" dt="2021-11-10T16:32:31.125" v="67" actId="1036"/>
          <ac:cxnSpMkLst>
            <pc:docMk/>
            <pc:sldMk cId="3319412604" sldId="269"/>
            <ac:cxnSpMk id="95" creationId="{60A5390B-209B-6649-98AC-3D465EDAD499}"/>
          </ac:cxnSpMkLst>
        </pc:cxnChg>
        <pc:cxnChg chg="mod">
          <ac:chgData name="Warner,Jeffrey Barr" userId="7360d018-3b8a-4d6d-8136-e4d170e1e616" providerId="ADAL" clId="{80816FA7-34D3-4241-B642-1465F17EAD18}" dt="2021-11-10T16:32:31.125" v="67" actId="1036"/>
          <ac:cxnSpMkLst>
            <pc:docMk/>
            <pc:sldMk cId="3319412604" sldId="269"/>
            <ac:cxnSpMk id="98" creationId="{3C1B1F6F-E4C8-554D-9A1A-D1E602849009}"/>
          </ac:cxnSpMkLst>
        </pc:cxnChg>
        <pc:cxnChg chg="mod">
          <ac:chgData name="Warner,Jeffrey Barr" userId="7360d018-3b8a-4d6d-8136-e4d170e1e616" providerId="ADAL" clId="{80816FA7-34D3-4241-B642-1465F17EAD18}" dt="2021-11-10T16:32:31.125" v="67" actId="1036"/>
          <ac:cxnSpMkLst>
            <pc:docMk/>
            <pc:sldMk cId="3319412604" sldId="269"/>
            <ac:cxnSpMk id="99" creationId="{FF236E01-10D8-1F4B-82AC-A69B33C258F9}"/>
          </ac:cxnSpMkLst>
        </pc:cxnChg>
        <pc:cxnChg chg="mod">
          <ac:chgData name="Warner,Jeffrey Barr" userId="7360d018-3b8a-4d6d-8136-e4d170e1e616" providerId="ADAL" clId="{80816FA7-34D3-4241-B642-1465F17EAD18}" dt="2021-11-10T16:32:31.125" v="67" actId="1036"/>
          <ac:cxnSpMkLst>
            <pc:docMk/>
            <pc:sldMk cId="3319412604" sldId="269"/>
            <ac:cxnSpMk id="119" creationId="{FCBDDB18-6BF9-DE4C-B37C-6E68DB65C3AD}"/>
          </ac:cxnSpMkLst>
        </pc:cxnChg>
      </pc:sldChg>
      <pc:sldChg chg="del">
        <pc:chgData name="Warner,Jeffrey Barr" userId="7360d018-3b8a-4d6d-8136-e4d170e1e616" providerId="ADAL" clId="{80816FA7-34D3-4241-B642-1465F17EAD18}" dt="2021-11-10T16:29:30.803" v="0" actId="2696"/>
        <pc:sldMkLst>
          <pc:docMk/>
          <pc:sldMk cId="2515056989" sldId="337"/>
        </pc:sldMkLst>
      </pc:sldChg>
      <pc:sldChg chg="del">
        <pc:chgData name="Warner,Jeffrey Barr" userId="7360d018-3b8a-4d6d-8136-e4d170e1e616" providerId="ADAL" clId="{80816FA7-34D3-4241-B642-1465F17EAD18}" dt="2021-11-10T16:29:30.803" v="0" actId="2696"/>
        <pc:sldMkLst>
          <pc:docMk/>
          <pc:sldMk cId="3797510600" sldId="339"/>
        </pc:sldMkLst>
      </pc:sldChg>
      <pc:sldChg chg="del">
        <pc:chgData name="Warner,Jeffrey Barr" userId="7360d018-3b8a-4d6d-8136-e4d170e1e616" providerId="ADAL" clId="{80816FA7-34D3-4241-B642-1465F17EAD18}" dt="2021-11-10T16:29:30.803" v="0" actId="2696"/>
        <pc:sldMkLst>
          <pc:docMk/>
          <pc:sldMk cId="2788620995" sldId="356"/>
        </pc:sldMkLst>
      </pc:sldChg>
      <pc:sldChg chg="addSp delSp modSp mod">
        <pc:chgData name="Warner,Jeffrey Barr" userId="7360d018-3b8a-4d6d-8136-e4d170e1e616" providerId="ADAL" clId="{80816FA7-34D3-4241-B642-1465F17EAD18}" dt="2021-11-10T16:32:49.699" v="79" actId="1076"/>
        <pc:sldMkLst>
          <pc:docMk/>
          <pc:sldMk cId="53146747" sldId="357"/>
        </pc:sldMkLst>
        <pc:spChg chg="del">
          <ac:chgData name="Warner,Jeffrey Barr" userId="7360d018-3b8a-4d6d-8136-e4d170e1e616" providerId="ADAL" clId="{80816FA7-34D3-4241-B642-1465F17EAD18}" dt="2021-11-10T16:32:39.053" v="72" actId="478"/>
          <ac:spMkLst>
            <pc:docMk/>
            <pc:sldMk cId="53146747" sldId="357"/>
            <ac:spMk id="5" creationId="{68142842-A8D1-45F2-B118-10F5A96DD0BB}"/>
          </ac:spMkLst>
        </pc:spChg>
        <pc:spChg chg="add mod">
          <ac:chgData name="Warner,Jeffrey Barr" userId="7360d018-3b8a-4d6d-8136-e4d170e1e616" providerId="ADAL" clId="{80816FA7-34D3-4241-B642-1465F17EAD18}" dt="2021-11-10T16:32:49.699" v="79" actId="1076"/>
          <ac:spMkLst>
            <pc:docMk/>
            <pc:sldMk cId="53146747" sldId="357"/>
            <ac:spMk id="6" creationId="{CB9E60BB-F3D9-45B3-BF5D-06E36A398E03}"/>
          </ac:spMkLst>
        </pc:spChg>
      </pc:sldChg>
      <pc:sldChg chg="del">
        <pc:chgData name="Warner,Jeffrey Barr" userId="7360d018-3b8a-4d6d-8136-e4d170e1e616" providerId="ADAL" clId="{80816FA7-34D3-4241-B642-1465F17EAD18}" dt="2021-11-10T16:29:30.803" v="0" actId="2696"/>
        <pc:sldMkLst>
          <pc:docMk/>
          <pc:sldMk cId="2894237854" sldId="378"/>
        </pc:sldMkLst>
      </pc:sldChg>
      <pc:sldChg chg="del">
        <pc:chgData name="Warner,Jeffrey Barr" userId="7360d018-3b8a-4d6d-8136-e4d170e1e616" providerId="ADAL" clId="{80816FA7-34D3-4241-B642-1465F17EAD18}" dt="2021-11-10T16:29:30.803" v="0" actId="2696"/>
        <pc:sldMkLst>
          <pc:docMk/>
          <pc:sldMk cId="500895388" sldId="387"/>
        </pc:sldMkLst>
      </pc:sldChg>
      <pc:sldChg chg="addSp delSp modSp mod">
        <pc:chgData name="Warner,Jeffrey Barr" userId="7360d018-3b8a-4d6d-8136-e4d170e1e616" providerId="ADAL" clId="{80816FA7-34D3-4241-B642-1465F17EAD18}" dt="2021-11-10T16:32:09.299" v="40" actId="1036"/>
        <pc:sldMkLst>
          <pc:docMk/>
          <pc:sldMk cId="3345563794" sldId="388"/>
        </pc:sldMkLst>
        <pc:spChg chg="mod">
          <ac:chgData name="Warner,Jeffrey Barr" userId="7360d018-3b8a-4d6d-8136-e4d170e1e616" providerId="ADAL" clId="{80816FA7-34D3-4241-B642-1465F17EAD18}" dt="2021-11-10T16:32:06.320" v="36" actId="1036"/>
          <ac:spMkLst>
            <pc:docMk/>
            <pc:sldMk cId="3345563794" sldId="388"/>
            <ac:spMk id="6" creationId="{8A937648-27BE-40CC-8EFD-491C953B9C1C}"/>
          </ac:spMkLst>
        </pc:spChg>
        <pc:spChg chg="mod">
          <ac:chgData name="Warner,Jeffrey Barr" userId="7360d018-3b8a-4d6d-8136-e4d170e1e616" providerId="ADAL" clId="{80816FA7-34D3-4241-B642-1465F17EAD18}" dt="2021-11-10T16:32:06.320" v="36" actId="1036"/>
          <ac:spMkLst>
            <pc:docMk/>
            <pc:sldMk cId="3345563794" sldId="388"/>
            <ac:spMk id="7" creationId="{355BEFE0-0ABF-4781-9612-476264E8162F}"/>
          </ac:spMkLst>
        </pc:spChg>
        <pc:spChg chg="mod">
          <ac:chgData name="Warner,Jeffrey Barr" userId="7360d018-3b8a-4d6d-8136-e4d170e1e616" providerId="ADAL" clId="{80816FA7-34D3-4241-B642-1465F17EAD18}" dt="2021-11-10T16:32:06.320" v="36" actId="1036"/>
          <ac:spMkLst>
            <pc:docMk/>
            <pc:sldMk cId="3345563794" sldId="388"/>
            <ac:spMk id="8" creationId="{7B415037-4F39-4666-B746-AAC8D2EC843D}"/>
          </ac:spMkLst>
        </pc:spChg>
        <pc:spChg chg="mod">
          <ac:chgData name="Warner,Jeffrey Barr" userId="7360d018-3b8a-4d6d-8136-e4d170e1e616" providerId="ADAL" clId="{80816FA7-34D3-4241-B642-1465F17EAD18}" dt="2021-11-10T16:32:06.320" v="36" actId="1036"/>
          <ac:spMkLst>
            <pc:docMk/>
            <pc:sldMk cId="3345563794" sldId="388"/>
            <ac:spMk id="9" creationId="{49B3F6DE-0B60-45C4-9DB3-DBCD82F74FA2}"/>
          </ac:spMkLst>
        </pc:spChg>
        <pc:spChg chg="mod">
          <ac:chgData name="Warner,Jeffrey Barr" userId="7360d018-3b8a-4d6d-8136-e4d170e1e616" providerId="ADAL" clId="{80816FA7-34D3-4241-B642-1465F17EAD18}" dt="2021-11-10T16:32:06.320" v="36" actId="1036"/>
          <ac:spMkLst>
            <pc:docMk/>
            <pc:sldMk cId="3345563794" sldId="388"/>
            <ac:spMk id="14" creationId="{CEF5900F-9532-4C78-938F-73F271FEE374}"/>
          </ac:spMkLst>
        </pc:spChg>
        <pc:spChg chg="mod">
          <ac:chgData name="Warner,Jeffrey Barr" userId="7360d018-3b8a-4d6d-8136-e4d170e1e616" providerId="ADAL" clId="{80816FA7-34D3-4241-B642-1465F17EAD18}" dt="2021-11-10T16:32:06.320" v="36" actId="1036"/>
          <ac:spMkLst>
            <pc:docMk/>
            <pc:sldMk cId="3345563794" sldId="388"/>
            <ac:spMk id="15" creationId="{326F2845-DF0C-4302-8EF9-E5FC7B0528E8}"/>
          </ac:spMkLst>
        </pc:spChg>
        <pc:spChg chg="mod">
          <ac:chgData name="Warner,Jeffrey Barr" userId="7360d018-3b8a-4d6d-8136-e4d170e1e616" providerId="ADAL" clId="{80816FA7-34D3-4241-B642-1465F17EAD18}" dt="2021-11-10T16:32:06.320" v="36" actId="1036"/>
          <ac:spMkLst>
            <pc:docMk/>
            <pc:sldMk cId="3345563794" sldId="388"/>
            <ac:spMk id="16" creationId="{0161239A-9BE4-47C7-8F66-AC0FCF056FE6}"/>
          </ac:spMkLst>
        </pc:spChg>
        <pc:spChg chg="mod">
          <ac:chgData name="Warner,Jeffrey Barr" userId="7360d018-3b8a-4d6d-8136-e4d170e1e616" providerId="ADAL" clId="{80816FA7-34D3-4241-B642-1465F17EAD18}" dt="2021-11-10T16:32:06.320" v="36" actId="1036"/>
          <ac:spMkLst>
            <pc:docMk/>
            <pc:sldMk cId="3345563794" sldId="388"/>
            <ac:spMk id="17" creationId="{8A0BB93C-7E19-4BB9-9316-7B92C54C9158}"/>
          </ac:spMkLst>
        </pc:spChg>
        <pc:spChg chg="mod">
          <ac:chgData name="Warner,Jeffrey Barr" userId="7360d018-3b8a-4d6d-8136-e4d170e1e616" providerId="ADAL" clId="{80816FA7-34D3-4241-B642-1465F17EAD18}" dt="2021-11-10T16:32:06.320" v="36" actId="1036"/>
          <ac:spMkLst>
            <pc:docMk/>
            <pc:sldMk cId="3345563794" sldId="388"/>
            <ac:spMk id="18" creationId="{B24BBD92-BA3B-4119-BC86-8FFEB076B5DF}"/>
          </ac:spMkLst>
        </pc:spChg>
        <pc:spChg chg="del">
          <ac:chgData name="Warner,Jeffrey Barr" userId="7360d018-3b8a-4d6d-8136-e4d170e1e616" providerId="ADAL" clId="{80816FA7-34D3-4241-B642-1465F17EAD18}" dt="2021-11-10T16:31:52.523" v="19" actId="478"/>
          <ac:spMkLst>
            <pc:docMk/>
            <pc:sldMk cId="3345563794" sldId="388"/>
            <ac:spMk id="19" creationId="{92B4F0E4-FD60-461F-830E-2F787B9D39D5}"/>
          </ac:spMkLst>
        </pc:spChg>
        <pc:spChg chg="add mod">
          <ac:chgData name="Warner,Jeffrey Barr" userId="7360d018-3b8a-4d6d-8136-e4d170e1e616" providerId="ADAL" clId="{80816FA7-34D3-4241-B642-1465F17EAD18}" dt="2021-11-10T16:32:09.299" v="40" actId="1036"/>
          <ac:spMkLst>
            <pc:docMk/>
            <pc:sldMk cId="3345563794" sldId="388"/>
            <ac:spMk id="20" creationId="{2F01141C-080A-4DDE-93BA-AE7A97B09212}"/>
          </ac:spMkLst>
        </pc:spChg>
        <pc:spChg chg="mod">
          <ac:chgData name="Warner,Jeffrey Barr" userId="7360d018-3b8a-4d6d-8136-e4d170e1e616" providerId="ADAL" clId="{80816FA7-34D3-4241-B642-1465F17EAD18}" dt="2021-11-10T16:32:06.320" v="36" actId="1036"/>
          <ac:spMkLst>
            <pc:docMk/>
            <pc:sldMk cId="3345563794" sldId="388"/>
            <ac:spMk id="22" creationId="{FB36D9B7-A6AC-411C-93B6-1A576F417288}"/>
          </ac:spMkLst>
        </pc:spChg>
        <pc:spChg chg="mod">
          <ac:chgData name="Warner,Jeffrey Barr" userId="7360d018-3b8a-4d6d-8136-e4d170e1e616" providerId="ADAL" clId="{80816FA7-34D3-4241-B642-1465F17EAD18}" dt="2021-11-10T16:32:06.320" v="36" actId="1036"/>
          <ac:spMkLst>
            <pc:docMk/>
            <pc:sldMk cId="3345563794" sldId="388"/>
            <ac:spMk id="23" creationId="{CD44D0FD-7EB4-49E3-8908-45EF2D16999F}"/>
          </ac:spMkLst>
        </pc:spChg>
        <pc:graphicFrameChg chg="mod">
          <ac:chgData name="Warner,Jeffrey Barr" userId="7360d018-3b8a-4d6d-8136-e4d170e1e616" providerId="ADAL" clId="{80816FA7-34D3-4241-B642-1465F17EAD18}" dt="2021-11-10T16:32:06.320" v="36" actId="1036"/>
          <ac:graphicFrameMkLst>
            <pc:docMk/>
            <pc:sldMk cId="3345563794" sldId="388"/>
            <ac:graphicFrameMk id="5" creationId="{CB54D22E-FEB0-4C5E-9C74-471EABDFD0CD}"/>
          </ac:graphicFrameMkLst>
        </pc:graphicFrameChg>
        <pc:graphicFrameChg chg="mod">
          <ac:chgData name="Warner,Jeffrey Barr" userId="7360d018-3b8a-4d6d-8136-e4d170e1e616" providerId="ADAL" clId="{80816FA7-34D3-4241-B642-1465F17EAD18}" dt="2021-11-10T16:32:06.320" v="36" actId="1036"/>
          <ac:graphicFrameMkLst>
            <pc:docMk/>
            <pc:sldMk cId="3345563794" sldId="388"/>
            <ac:graphicFrameMk id="10" creationId="{05D20F71-7B16-4A5A-8365-0082898DF956}"/>
          </ac:graphicFrameMkLst>
        </pc:graphicFrameChg>
        <pc:graphicFrameChg chg="mod">
          <ac:chgData name="Warner,Jeffrey Barr" userId="7360d018-3b8a-4d6d-8136-e4d170e1e616" providerId="ADAL" clId="{80816FA7-34D3-4241-B642-1465F17EAD18}" dt="2021-11-10T16:32:06.320" v="36" actId="1036"/>
          <ac:graphicFrameMkLst>
            <pc:docMk/>
            <pc:sldMk cId="3345563794" sldId="388"/>
            <ac:graphicFrameMk id="11" creationId="{3033C1BE-8F89-4D09-9A8F-F2C8DE770C87}"/>
          </ac:graphicFrameMkLst>
        </pc:graphicFrameChg>
        <pc:graphicFrameChg chg="mod">
          <ac:chgData name="Warner,Jeffrey Barr" userId="7360d018-3b8a-4d6d-8136-e4d170e1e616" providerId="ADAL" clId="{80816FA7-34D3-4241-B642-1465F17EAD18}" dt="2021-11-10T16:32:06.320" v="36" actId="1036"/>
          <ac:graphicFrameMkLst>
            <pc:docMk/>
            <pc:sldMk cId="3345563794" sldId="388"/>
            <ac:graphicFrameMk id="25" creationId="{AF44CE8B-DFB0-4FA8-AAD0-A916B354C02A}"/>
          </ac:graphicFrameMkLst>
        </pc:graphicFrameChg>
        <pc:graphicFrameChg chg="mod">
          <ac:chgData name="Warner,Jeffrey Barr" userId="7360d018-3b8a-4d6d-8136-e4d170e1e616" providerId="ADAL" clId="{80816FA7-34D3-4241-B642-1465F17EAD18}" dt="2021-11-10T16:32:06.320" v="36" actId="1036"/>
          <ac:graphicFrameMkLst>
            <pc:docMk/>
            <pc:sldMk cId="3345563794" sldId="388"/>
            <ac:graphicFrameMk id="26" creationId="{011B732D-C5BA-481C-95E1-674A26CB9416}"/>
          </ac:graphicFrameMkLst>
        </pc:graphicFrameChg>
      </pc:sldChg>
      <pc:sldChg chg="del">
        <pc:chgData name="Warner,Jeffrey Barr" userId="7360d018-3b8a-4d6d-8136-e4d170e1e616" providerId="ADAL" clId="{80816FA7-34D3-4241-B642-1465F17EAD18}" dt="2021-11-10T16:29:30.803" v="0" actId="2696"/>
        <pc:sldMkLst>
          <pc:docMk/>
          <pc:sldMk cId="3719077622" sldId="389"/>
        </pc:sldMkLst>
      </pc:sldChg>
    </pc:docChg>
  </pc:docChgLst>
  <pc:docChgLst>
    <pc:chgData name="Warner,Jeffrey Barr" userId="7360d018-3b8a-4d6d-8136-e4d170e1e616" providerId="ADAL" clId="{3EFCE212-E637-1B4A-ADC8-D0BA86B19564}"/>
    <pc:docChg chg="undo custSel modSld">
      <pc:chgData name="Warner,Jeffrey Barr" userId="7360d018-3b8a-4d6d-8136-e4d170e1e616" providerId="ADAL" clId="{3EFCE212-E637-1B4A-ADC8-D0BA86B19564}" dt="2021-04-23T19:49:57.077" v="419" actId="164"/>
      <pc:docMkLst>
        <pc:docMk/>
      </pc:docMkLst>
      <pc:sldChg chg="modSp mod">
        <pc:chgData name="Warner,Jeffrey Barr" userId="7360d018-3b8a-4d6d-8136-e4d170e1e616" providerId="ADAL" clId="{3EFCE212-E637-1B4A-ADC8-D0BA86B19564}" dt="2021-04-23T19:34:34.700" v="290" actId="1035"/>
        <pc:sldMkLst>
          <pc:docMk/>
          <pc:sldMk cId="1676406075" sldId="264"/>
        </pc:sldMkLst>
        <pc:spChg chg="mod">
          <ac:chgData name="Warner,Jeffrey Barr" userId="7360d018-3b8a-4d6d-8136-e4d170e1e616" providerId="ADAL" clId="{3EFCE212-E637-1B4A-ADC8-D0BA86B19564}" dt="2021-04-23T19:34:34.700" v="290" actId="1035"/>
          <ac:spMkLst>
            <pc:docMk/>
            <pc:sldMk cId="1676406075" sldId="264"/>
            <ac:spMk id="97" creationId="{9C0562E0-B7AE-4DE4-A4CC-B2CF6E5D81B6}"/>
          </ac:spMkLst>
        </pc:spChg>
      </pc:sldChg>
      <pc:sldChg chg="addSp delSp modSp mod">
        <pc:chgData name="Warner,Jeffrey Barr" userId="7360d018-3b8a-4d6d-8136-e4d170e1e616" providerId="ADAL" clId="{3EFCE212-E637-1B4A-ADC8-D0BA86B19564}" dt="2021-04-23T19:49:57.077" v="419" actId="164"/>
        <pc:sldMkLst>
          <pc:docMk/>
          <pc:sldMk cId="3319412604" sldId="269"/>
        </pc:sldMkLst>
        <pc:spChg chg="del">
          <ac:chgData name="Warner,Jeffrey Barr" userId="7360d018-3b8a-4d6d-8136-e4d170e1e616" providerId="ADAL" clId="{3EFCE212-E637-1B4A-ADC8-D0BA86B19564}" dt="2021-04-23T16:32:40.327" v="236" actId="478"/>
          <ac:spMkLst>
            <pc:docMk/>
            <pc:sldMk cId="3319412604" sldId="269"/>
            <ac:spMk id="5" creationId="{00000000-0000-0000-0000-000000000000}"/>
          </ac:spMkLst>
        </pc:spChg>
        <pc:spChg chg="add del">
          <ac:chgData name="Warner,Jeffrey Barr" userId="7360d018-3b8a-4d6d-8136-e4d170e1e616" providerId="ADAL" clId="{3EFCE212-E637-1B4A-ADC8-D0BA86B19564}" dt="2021-04-23T16:32:53.918" v="241" actId="478"/>
          <ac:spMkLst>
            <pc:docMk/>
            <pc:sldMk cId="3319412604" sldId="269"/>
            <ac:spMk id="12" creationId="{00000000-0000-0000-0000-000000000000}"/>
          </ac:spMkLst>
        </pc:spChg>
        <pc:spChg chg="mod">
          <ac:chgData name="Warner,Jeffrey Barr" userId="7360d018-3b8a-4d6d-8136-e4d170e1e616" providerId="ADAL" clId="{3EFCE212-E637-1B4A-ADC8-D0BA86B19564}" dt="2021-04-23T16:32:26.754" v="220" actId="164"/>
          <ac:spMkLst>
            <pc:docMk/>
            <pc:sldMk cId="3319412604" sldId="269"/>
            <ac:spMk id="15" creationId="{00000000-0000-0000-0000-000000000000}"/>
          </ac:spMkLst>
        </pc:spChg>
        <pc:spChg chg="mod">
          <ac:chgData name="Warner,Jeffrey Barr" userId="7360d018-3b8a-4d6d-8136-e4d170e1e616" providerId="ADAL" clId="{3EFCE212-E637-1B4A-ADC8-D0BA86B19564}" dt="2021-04-23T16:32:26.754" v="220" actId="164"/>
          <ac:spMkLst>
            <pc:docMk/>
            <pc:sldMk cId="3319412604" sldId="269"/>
            <ac:spMk id="16" creationId="{00000000-0000-0000-0000-000000000000}"/>
          </ac:spMkLst>
        </pc:spChg>
        <pc:spChg chg="mod">
          <ac:chgData name="Warner,Jeffrey Barr" userId="7360d018-3b8a-4d6d-8136-e4d170e1e616" providerId="ADAL" clId="{3EFCE212-E637-1B4A-ADC8-D0BA86B19564}" dt="2021-04-23T16:32:26.754" v="220" actId="164"/>
          <ac:spMkLst>
            <pc:docMk/>
            <pc:sldMk cId="3319412604" sldId="269"/>
            <ac:spMk id="17" creationId="{00000000-0000-0000-0000-000000000000}"/>
          </ac:spMkLst>
        </pc:spChg>
        <pc:spChg chg="mod">
          <ac:chgData name="Warner,Jeffrey Barr" userId="7360d018-3b8a-4d6d-8136-e4d170e1e616" providerId="ADAL" clId="{3EFCE212-E637-1B4A-ADC8-D0BA86B19564}" dt="2021-04-23T16:25:56.749" v="2" actId="1076"/>
          <ac:spMkLst>
            <pc:docMk/>
            <pc:sldMk cId="3319412604" sldId="269"/>
            <ac:spMk id="30" creationId="{00000000-0000-0000-0000-000000000000}"/>
          </ac:spMkLst>
        </pc:spChg>
        <pc:spChg chg="mod">
          <ac:chgData name="Warner,Jeffrey Barr" userId="7360d018-3b8a-4d6d-8136-e4d170e1e616" providerId="ADAL" clId="{3EFCE212-E637-1B4A-ADC8-D0BA86B19564}" dt="2021-04-23T16:26:13.126" v="5" actId="571"/>
          <ac:spMkLst>
            <pc:docMk/>
            <pc:sldMk cId="3319412604" sldId="269"/>
            <ac:spMk id="67" creationId="{29779D33-E5CC-F54C-91D8-D650D5C32792}"/>
          </ac:spMkLst>
        </pc:spChg>
        <pc:spChg chg="mod">
          <ac:chgData name="Warner,Jeffrey Barr" userId="7360d018-3b8a-4d6d-8136-e4d170e1e616" providerId="ADAL" clId="{3EFCE212-E637-1B4A-ADC8-D0BA86B19564}" dt="2021-04-23T16:27:26.420" v="25" actId="20577"/>
          <ac:spMkLst>
            <pc:docMk/>
            <pc:sldMk cId="3319412604" sldId="269"/>
            <ac:spMk id="68" creationId="{4EF26F96-868D-5947-84C5-B7F6A443048E}"/>
          </ac:spMkLst>
        </pc:spChg>
        <pc:spChg chg="mod">
          <ac:chgData name="Warner,Jeffrey Barr" userId="7360d018-3b8a-4d6d-8136-e4d170e1e616" providerId="ADAL" clId="{3EFCE212-E637-1B4A-ADC8-D0BA86B19564}" dt="2021-04-23T16:26:13.126" v="5" actId="571"/>
          <ac:spMkLst>
            <pc:docMk/>
            <pc:sldMk cId="3319412604" sldId="269"/>
            <ac:spMk id="70" creationId="{5EC1458C-3FB0-4C4F-A0AE-50E68E69FCB8}"/>
          </ac:spMkLst>
        </pc:spChg>
        <pc:spChg chg="mod">
          <ac:chgData name="Warner,Jeffrey Barr" userId="7360d018-3b8a-4d6d-8136-e4d170e1e616" providerId="ADAL" clId="{3EFCE212-E637-1B4A-ADC8-D0BA86B19564}" dt="2021-04-23T16:26:13.126" v="5" actId="571"/>
          <ac:spMkLst>
            <pc:docMk/>
            <pc:sldMk cId="3319412604" sldId="269"/>
            <ac:spMk id="71" creationId="{56099CDC-F923-A74F-94A8-A8C8545DA354}"/>
          </ac:spMkLst>
        </pc:spChg>
        <pc:spChg chg="add mod">
          <ac:chgData name="Warner,Jeffrey Barr" userId="7360d018-3b8a-4d6d-8136-e4d170e1e616" providerId="ADAL" clId="{3EFCE212-E637-1B4A-ADC8-D0BA86B19564}" dt="2021-04-23T16:27:35.929" v="30" actId="20577"/>
          <ac:spMkLst>
            <pc:docMk/>
            <pc:sldMk cId="3319412604" sldId="269"/>
            <ac:spMk id="74" creationId="{88592D39-C555-8240-88B1-922E066C394A}"/>
          </ac:spMkLst>
        </pc:spChg>
        <pc:spChg chg="mod">
          <ac:chgData name="Warner,Jeffrey Barr" userId="7360d018-3b8a-4d6d-8136-e4d170e1e616" providerId="ADAL" clId="{3EFCE212-E637-1B4A-ADC8-D0BA86B19564}" dt="2021-04-23T16:27:47.103" v="34"/>
          <ac:spMkLst>
            <pc:docMk/>
            <pc:sldMk cId="3319412604" sldId="269"/>
            <ac:spMk id="81" creationId="{1394250F-5201-DC48-AA44-7099A6DB906F}"/>
          </ac:spMkLst>
        </pc:spChg>
        <pc:spChg chg="mod">
          <ac:chgData name="Warner,Jeffrey Barr" userId="7360d018-3b8a-4d6d-8136-e4d170e1e616" providerId="ADAL" clId="{3EFCE212-E637-1B4A-ADC8-D0BA86B19564}" dt="2021-04-23T16:29:44.905" v="79" actId="20577"/>
          <ac:spMkLst>
            <pc:docMk/>
            <pc:sldMk cId="3319412604" sldId="269"/>
            <ac:spMk id="82" creationId="{0C4A7AC9-8D78-524F-942D-46D557E6032E}"/>
          </ac:spMkLst>
        </pc:spChg>
        <pc:spChg chg="mod">
          <ac:chgData name="Warner,Jeffrey Barr" userId="7360d018-3b8a-4d6d-8136-e4d170e1e616" providerId="ADAL" clId="{3EFCE212-E637-1B4A-ADC8-D0BA86B19564}" dt="2021-04-23T16:27:47.103" v="34"/>
          <ac:spMkLst>
            <pc:docMk/>
            <pc:sldMk cId="3319412604" sldId="269"/>
            <ac:spMk id="84" creationId="{CC512F96-4BF6-4844-B73F-E5823603B7EF}"/>
          </ac:spMkLst>
        </pc:spChg>
        <pc:spChg chg="mod">
          <ac:chgData name="Warner,Jeffrey Barr" userId="7360d018-3b8a-4d6d-8136-e4d170e1e616" providerId="ADAL" clId="{3EFCE212-E637-1B4A-ADC8-D0BA86B19564}" dt="2021-04-23T16:27:47.103" v="34"/>
          <ac:spMkLst>
            <pc:docMk/>
            <pc:sldMk cId="3319412604" sldId="269"/>
            <ac:spMk id="85" creationId="{29ACEB12-71E7-264A-BE80-A21E31BD54C5}"/>
          </ac:spMkLst>
        </pc:spChg>
        <pc:spChg chg="add mod">
          <ac:chgData name="Warner,Jeffrey Barr" userId="7360d018-3b8a-4d6d-8136-e4d170e1e616" providerId="ADAL" clId="{3EFCE212-E637-1B4A-ADC8-D0BA86B19564}" dt="2021-04-23T16:27:57.479" v="38" actId="20577"/>
          <ac:spMkLst>
            <pc:docMk/>
            <pc:sldMk cId="3319412604" sldId="269"/>
            <ac:spMk id="86" creationId="{8E3D3354-2658-D445-BB0B-A10480161FF9}"/>
          </ac:spMkLst>
        </pc:spChg>
        <pc:spChg chg="mod">
          <ac:chgData name="Warner,Jeffrey Barr" userId="7360d018-3b8a-4d6d-8136-e4d170e1e616" providerId="ADAL" clId="{3EFCE212-E637-1B4A-ADC8-D0BA86B19564}" dt="2021-04-23T16:29:39.525" v="73" actId="20577"/>
          <ac:spMkLst>
            <pc:docMk/>
            <pc:sldMk cId="3319412604" sldId="269"/>
            <ac:spMk id="91" creationId="{D4231E41-2146-8B47-946F-47CFD0A54E50}"/>
          </ac:spMkLst>
        </pc:spChg>
        <pc:spChg chg="mod">
          <ac:chgData name="Warner,Jeffrey Barr" userId="7360d018-3b8a-4d6d-8136-e4d170e1e616" providerId="ADAL" clId="{3EFCE212-E637-1B4A-ADC8-D0BA86B19564}" dt="2021-04-23T16:28:20.333" v="39"/>
          <ac:spMkLst>
            <pc:docMk/>
            <pc:sldMk cId="3319412604" sldId="269"/>
            <ac:spMk id="92" creationId="{B90DC2E3-1037-7441-A804-A6FABCAE89E4}"/>
          </ac:spMkLst>
        </pc:spChg>
        <pc:spChg chg="add mod">
          <ac:chgData name="Warner,Jeffrey Barr" userId="7360d018-3b8a-4d6d-8136-e4d170e1e616" providerId="ADAL" clId="{3EFCE212-E637-1B4A-ADC8-D0BA86B19564}" dt="2021-04-23T16:29:00.094" v="56" actId="20577"/>
          <ac:spMkLst>
            <pc:docMk/>
            <pc:sldMk cId="3319412604" sldId="269"/>
            <ac:spMk id="94" creationId="{A0D49CBF-CA7E-4D47-A1B8-BEC3B9466D17}"/>
          </ac:spMkLst>
        </pc:spChg>
        <pc:spChg chg="add del mod">
          <ac:chgData name="Warner,Jeffrey Barr" userId="7360d018-3b8a-4d6d-8136-e4d170e1e616" providerId="ADAL" clId="{3EFCE212-E637-1B4A-ADC8-D0BA86B19564}" dt="2021-04-23T16:30:22.686" v="103"/>
          <ac:spMkLst>
            <pc:docMk/>
            <pc:sldMk cId="3319412604" sldId="269"/>
            <ac:spMk id="97" creationId="{DC745EF4-69A9-2142-ADE3-AAC23A3A0764}"/>
          </ac:spMkLst>
        </pc:spChg>
        <pc:spChg chg="mod">
          <ac:chgData name="Warner,Jeffrey Barr" userId="7360d018-3b8a-4d6d-8136-e4d170e1e616" providerId="ADAL" clId="{3EFCE212-E637-1B4A-ADC8-D0BA86B19564}" dt="2021-04-23T16:30:00.830" v="91" actId="20577"/>
          <ac:spMkLst>
            <pc:docMk/>
            <pc:sldMk cId="3319412604" sldId="269"/>
            <ac:spMk id="107" creationId="{66112512-961A-EE4D-88A1-0FA292877BC2}"/>
          </ac:spMkLst>
        </pc:spChg>
        <pc:spChg chg="mod">
          <ac:chgData name="Warner,Jeffrey Barr" userId="7360d018-3b8a-4d6d-8136-e4d170e1e616" providerId="ADAL" clId="{3EFCE212-E637-1B4A-ADC8-D0BA86B19564}" dt="2021-04-23T16:30:04.001" v="94" actId="20577"/>
          <ac:spMkLst>
            <pc:docMk/>
            <pc:sldMk cId="3319412604" sldId="269"/>
            <ac:spMk id="108" creationId="{E59A60BE-E3EB-5341-8DC4-C370438AE9C9}"/>
          </ac:spMkLst>
        </pc:spChg>
        <pc:spChg chg="add mod">
          <ac:chgData name="Warner,Jeffrey Barr" userId="7360d018-3b8a-4d6d-8136-e4d170e1e616" providerId="ADAL" clId="{3EFCE212-E637-1B4A-ADC8-D0BA86B19564}" dt="2021-04-23T16:29:55.313" v="87" actId="20577"/>
          <ac:spMkLst>
            <pc:docMk/>
            <pc:sldMk cId="3319412604" sldId="269"/>
            <ac:spMk id="109" creationId="{D79900F8-5AC4-BF43-B918-69555FEF9FB5}"/>
          </ac:spMkLst>
        </pc:spChg>
        <pc:spChg chg="mod">
          <ac:chgData name="Warner,Jeffrey Barr" userId="7360d018-3b8a-4d6d-8136-e4d170e1e616" providerId="ADAL" clId="{3EFCE212-E637-1B4A-ADC8-D0BA86B19564}" dt="2021-04-23T16:30:14.973" v="98"/>
          <ac:spMkLst>
            <pc:docMk/>
            <pc:sldMk cId="3319412604" sldId="269"/>
            <ac:spMk id="115" creationId="{4CBE988E-DD17-BE47-AE53-C22A0EE93681}"/>
          </ac:spMkLst>
        </pc:spChg>
        <pc:spChg chg="mod">
          <ac:chgData name="Warner,Jeffrey Barr" userId="7360d018-3b8a-4d6d-8136-e4d170e1e616" providerId="ADAL" clId="{3EFCE212-E637-1B4A-ADC8-D0BA86B19564}" dt="2021-04-23T16:30:27.877" v="109" actId="20577"/>
          <ac:spMkLst>
            <pc:docMk/>
            <pc:sldMk cId="3319412604" sldId="269"/>
            <ac:spMk id="116" creationId="{11AC39DB-BB4B-0748-9D0E-FAE6024CDE3C}"/>
          </ac:spMkLst>
        </pc:spChg>
        <pc:spChg chg="add mod">
          <ac:chgData name="Warner,Jeffrey Barr" userId="7360d018-3b8a-4d6d-8136-e4d170e1e616" providerId="ADAL" clId="{3EFCE212-E637-1B4A-ADC8-D0BA86B19564}" dt="2021-04-23T16:30:23.615" v="104" actId="20577"/>
          <ac:spMkLst>
            <pc:docMk/>
            <pc:sldMk cId="3319412604" sldId="269"/>
            <ac:spMk id="117" creationId="{F74A7890-6EB6-7342-9206-4CB82D70EFAB}"/>
          </ac:spMkLst>
        </pc:spChg>
        <pc:spChg chg="mod">
          <ac:chgData name="Warner,Jeffrey Barr" userId="7360d018-3b8a-4d6d-8136-e4d170e1e616" providerId="ADAL" clId="{3EFCE212-E637-1B4A-ADC8-D0BA86B19564}" dt="2021-04-23T16:31:48.665" v="205" actId="20577"/>
          <ac:spMkLst>
            <pc:docMk/>
            <pc:sldMk cId="3319412604" sldId="269"/>
            <ac:spMk id="125" creationId="{BDC72A60-D8E2-EC40-82D6-5452FF75028D}"/>
          </ac:spMkLst>
        </pc:spChg>
        <pc:spChg chg="mod">
          <ac:chgData name="Warner,Jeffrey Barr" userId="7360d018-3b8a-4d6d-8136-e4d170e1e616" providerId="ADAL" clId="{3EFCE212-E637-1B4A-ADC8-D0BA86B19564}" dt="2021-04-23T16:31:52.651" v="209" actId="20577"/>
          <ac:spMkLst>
            <pc:docMk/>
            <pc:sldMk cId="3319412604" sldId="269"/>
            <ac:spMk id="126" creationId="{EBC9E293-6AEA-2F4B-A79A-4866F6A31B24}"/>
          </ac:spMkLst>
        </pc:spChg>
        <pc:spChg chg="add mod">
          <ac:chgData name="Warner,Jeffrey Barr" userId="7360d018-3b8a-4d6d-8136-e4d170e1e616" providerId="ADAL" clId="{3EFCE212-E637-1B4A-ADC8-D0BA86B19564}" dt="2021-04-23T16:31:38.163" v="195" actId="1038"/>
          <ac:spMkLst>
            <pc:docMk/>
            <pc:sldMk cId="3319412604" sldId="269"/>
            <ac:spMk id="127" creationId="{2B511B88-B828-E440-906F-567BCF8E1D39}"/>
          </ac:spMkLst>
        </pc:spChg>
        <pc:spChg chg="add mod">
          <ac:chgData name="Warner,Jeffrey Barr" userId="7360d018-3b8a-4d6d-8136-e4d170e1e616" providerId="ADAL" clId="{3EFCE212-E637-1B4A-ADC8-D0BA86B19564}" dt="2021-04-23T16:32:26.754" v="220" actId="164"/>
          <ac:spMkLst>
            <pc:docMk/>
            <pc:sldMk cId="3319412604" sldId="269"/>
            <ac:spMk id="129" creationId="{BFA5A1EF-1C6C-A340-8E1A-15086C9A3FEC}"/>
          </ac:spMkLst>
        </pc:spChg>
        <pc:spChg chg="mod">
          <ac:chgData name="Warner,Jeffrey Barr" userId="7360d018-3b8a-4d6d-8136-e4d170e1e616" providerId="ADAL" clId="{3EFCE212-E637-1B4A-ADC8-D0BA86B19564}" dt="2021-04-23T16:33:31.647" v="287" actId="14100"/>
          <ac:spMkLst>
            <pc:docMk/>
            <pc:sldMk cId="3319412604" sldId="269"/>
            <ac:spMk id="132" creationId="{0F6E04AB-649E-CA43-AEDD-1403EE144CD5}"/>
          </ac:spMkLst>
        </pc:spChg>
        <pc:spChg chg="del mod">
          <ac:chgData name="Warner,Jeffrey Barr" userId="7360d018-3b8a-4d6d-8136-e4d170e1e616" providerId="ADAL" clId="{3EFCE212-E637-1B4A-ADC8-D0BA86B19564}" dt="2021-04-23T16:33:13.647" v="250" actId="478"/>
          <ac:spMkLst>
            <pc:docMk/>
            <pc:sldMk cId="3319412604" sldId="269"/>
            <ac:spMk id="133" creationId="{AD83FA35-7958-EE4C-B2F6-8FA9138868DC}"/>
          </ac:spMkLst>
        </pc:spChg>
        <pc:spChg chg="del mod">
          <ac:chgData name="Warner,Jeffrey Barr" userId="7360d018-3b8a-4d6d-8136-e4d170e1e616" providerId="ADAL" clId="{3EFCE212-E637-1B4A-ADC8-D0BA86B19564}" dt="2021-04-23T16:33:12.077" v="249" actId="478"/>
          <ac:spMkLst>
            <pc:docMk/>
            <pc:sldMk cId="3319412604" sldId="269"/>
            <ac:spMk id="134" creationId="{0EC1C670-5521-A142-A658-2596E64B2B8D}"/>
          </ac:spMkLst>
        </pc:spChg>
        <pc:spChg chg="mod">
          <ac:chgData name="Warner,Jeffrey Barr" userId="7360d018-3b8a-4d6d-8136-e4d170e1e616" providerId="ADAL" clId="{3EFCE212-E637-1B4A-ADC8-D0BA86B19564}" dt="2021-04-23T16:33:23.665" v="284" actId="14100"/>
          <ac:spMkLst>
            <pc:docMk/>
            <pc:sldMk cId="3319412604" sldId="269"/>
            <ac:spMk id="135" creationId="{49993907-56B2-7343-88DE-3B0F18CCA69E}"/>
          </ac:spMkLst>
        </pc:spChg>
        <pc:grpChg chg="add mod">
          <ac:chgData name="Warner,Jeffrey Barr" userId="7360d018-3b8a-4d6d-8136-e4d170e1e616" providerId="ADAL" clId="{3EFCE212-E637-1B4A-ADC8-D0BA86B19564}" dt="2021-04-23T19:46:15.160" v="314" actId="164"/>
          <ac:grpSpMkLst>
            <pc:docMk/>
            <pc:sldMk cId="3319412604" sldId="269"/>
            <ac:grpSpMk id="5" creationId="{4737109D-5834-974B-8DE3-9CF9D176BF7A}"/>
          </ac:grpSpMkLst>
        </pc:grpChg>
        <pc:grpChg chg="del">
          <ac:chgData name="Warner,Jeffrey Barr" userId="7360d018-3b8a-4d6d-8136-e4d170e1e616" providerId="ADAL" clId="{3EFCE212-E637-1B4A-ADC8-D0BA86B19564}" dt="2021-04-23T16:32:55.918" v="242" actId="478"/>
          <ac:grpSpMkLst>
            <pc:docMk/>
            <pc:sldMk cId="3319412604" sldId="269"/>
            <ac:grpSpMk id="8" creationId="{00000000-0000-0000-0000-000000000000}"/>
          </ac:grpSpMkLst>
        </pc:grpChg>
        <pc:grpChg chg="add mod">
          <ac:chgData name="Warner,Jeffrey Barr" userId="7360d018-3b8a-4d6d-8136-e4d170e1e616" providerId="ADAL" clId="{3EFCE212-E637-1B4A-ADC8-D0BA86B19564}" dt="2021-04-23T19:47:26.060" v="390" actId="164"/>
          <ac:grpSpMkLst>
            <pc:docMk/>
            <pc:sldMk cId="3319412604" sldId="269"/>
            <ac:grpSpMk id="9" creationId="{BFCF1B8C-9DAA-624C-80DB-AF05FE6E9010}"/>
          </ac:grpSpMkLst>
        </pc:grpChg>
        <pc:grpChg chg="add mod">
          <ac:chgData name="Warner,Jeffrey Barr" userId="7360d018-3b8a-4d6d-8136-e4d170e1e616" providerId="ADAL" clId="{3EFCE212-E637-1B4A-ADC8-D0BA86B19564}" dt="2021-04-23T19:48:13.559" v="404" actId="164"/>
          <ac:grpSpMkLst>
            <pc:docMk/>
            <pc:sldMk cId="3319412604" sldId="269"/>
            <ac:grpSpMk id="12" creationId="{73F9E966-1F4A-CF4B-A47E-FE7A17B63724}"/>
          </ac:grpSpMkLst>
        </pc:grpChg>
        <pc:grpChg chg="add del">
          <ac:chgData name="Warner,Jeffrey Barr" userId="7360d018-3b8a-4d6d-8136-e4d170e1e616" providerId="ADAL" clId="{3EFCE212-E637-1B4A-ADC8-D0BA86B19564}" dt="2021-04-23T16:32:56.876" v="243" actId="478"/>
          <ac:grpSpMkLst>
            <pc:docMk/>
            <pc:sldMk cId="3319412604" sldId="269"/>
            <ac:grpSpMk id="13" creationId="{00000000-0000-0000-0000-000000000000}"/>
          </ac:grpSpMkLst>
        </pc:grpChg>
        <pc:grpChg chg="mod">
          <ac:chgData name="Warner,Jeffrey Barr" userId="7360d018-3b8a-4d6d-8136-e4d170e1e616" providerId="ADAL" clId="{3EFCE212-E637-1B4A-ADC8-D0BA86B19564}" dt="2021-04-23T16:25:56.749" v="2" actId="1076"/>
          <ac:grpSpMkLst>
            <pc:docMk/>
            <pc:sldMk cId="3319412604" sldId="269"/>
            <ac:grpSpMk id="22" creationId="{00000000-0000-0000-0000-000000000000}"/>
          </ac:grpSpMkLst>
        </pc:grpChg>
        <pc:grpChg chg="add mod">
          <ac:chgData name="Warner,Jeffrey Barr" userId="7360d018-3b8a-4d6d-8136-e4d170e1e616" providerId="ADAL" clId="{3EFCE212-E637-1B4A-ADC8-D0BA86B19564}" dt="2021-04-23T19:49:57.077" v="419" actId="164"/>
          <ac:grpSpMkLst>
            <pc:docMk/>
            <pc:sldMk cId="3319412604" sldId="269"/>
            <ac:grpSpMk id="25" creationId="{BFAC175D-035D-4947-A0CA-5C157036FBA6}"/>
          </ac:grpSpMkLst>
        </pc:grpChg>
        <pc:grpChg chg="add mod">
          <ac:chgData name="Warner,Jeffrey Barr" userId="7360d018-3b8a-4d6d-8136-e4d170e1e616" providerId="ADAL" clId="{3EFCE212-E637-1B4A-ADC8-D0BA86B19564}" dt="2021-04-23T16:26:47.161" v="17" actId="1076"/>
          <ac:grpSpMkLst>
            <pc:docMk/>
            <pc:sldMk cId="3319412604" sldId="269"/>
            <ac:grpSpMk id="63" creationId="{D4B32422-2920-3A42-8161-F88FED598818}"/>
          </ac:grpSpMkLst>
        </pc:grpChg>
        <pc:grpChg chg="mod">
          <ac:chgData name="Warner,Jeffrey Barr" userId="7360d018-3b8a-4d6d-8136-e4d170e1e616" providerId="ADAL" clId="{3EFCE212-E637-1B4A-ADC8-D0BA86B19564}" dt="2021-04-23T16:26:13.126" v="5" actId="571"/>
          <ac:grpSpMkLst>
            <pc:docMk/>
            <pc:sldMk cId="3319412604" sldId="269"/>
            <ac:grpSpMk id="64" creationId="{776E9AAF-0012-1547-9884-6392E103E82D}"/>
          </ac:grpSpMkLst>
        </pc:grpChg>
        <pc:grpChg chg="add mod">
          <ac:chgData name="Warner,Jeffrey Barr" userId="7360d018-3b8a-4d6d-8136-e4d170e1e616" providerId="ADAL" clId="{3EFCE212-E637-1B4A-ADC8-D0BA86B19564}" dt="2021-04-23T16:27:54.280" v="35" actId="1076"/>
          <ac:grpSpMkLst>
            <pc:docMk/>
            <pc:sldMk cId="3319412604" sldId="269"/>
            <ac:grpSpMk id="77" creationId="{D372E56B-4C7F-B442-A2C4-8AE9034B2AF9}"/>
          </ac:grpSpMkLst>
        </pc:grpChg>
        <pc:grpChg chg="mod">
          <ac:chgData name="Warner,Jeffrey Barr" userId="7360d018-3b8a-4d6d-8136-e4d170e1e616" providerId="ADAL" clId="{3EFCE212-E637-1B4A-ADC8-D0BA86B19564}" dt="2021-04-23T16:27:47.103" v="34"/>
          <ac:grpSpMkLst>
            <pc:docMk/>
            <pc:sldMk cId="3319412604" sldId="269"/>
            <ac:grpSpMk id="78" creationId="{49AD1D91-7EFF-5E4A-B8BD-9CCA07A57388}"/>
          </ac:grpSpMkLst>
        </pc:grpChg>
        <pc:grpChg chg="add mod">
          <ac:chgData name="Warner,Jeffrey Barr" userId="7360d018-3b8a-4d6d-8136-e4d170e1e616" providerId="ADAL" clId="{3EFCE212-E637-1B4A-ADC8-D0BA86B19564}" dt="2021-04-23T19:46:15.160" v="314" actId="164"/>
          <ac:grpSpMkLst>
            <pc:docMk/>
            <pc:sldMk cId="3319412604" sldId="269"/>
            <ac:grpSpMk id="87" creationId="{AC979FD2-72D7-C045-9584-1E3D13F3AB63}"/>
          </ac:grpSpMkLst>
        </pc:grpChg>
        <pc:grpChg chg="add mod">
          <ac:chgData name="Warner,Jeffrey Barr" userId="7360d018-3b8a-4d6d-8136-e4d170e1e616" providerId="ADAL" clId="{3EFCE212-E637-1B4A-ADC8-D0BA86B19564}" dt="2021-04-23T19:48:13.559" v="404" actId="164"/>
          <ac:grpSpMkLst>
            <pc:docMk/>
            <pc:sldMk cId="3319412604" sldId="269"/>
            <ac:grpSpMk id="103" creationId="{88EEBD05-D4F6-1C44-B129-D1DB244ACE0C}"/>
          </ac:grpSpMkLst>
        </pc:grpChg>
        <pc:grpChg chg="add del mod">
          <ac:chgData name="Warner,Jeffrey Barr" userId="7360d018-3b8a-4d6d-8136-e4d170e1e616" providerId="ADAL" clId="{3EFCE212-E637-1B4A-ADC8-D0BA86B19564}" dt="2021-04-23T19:47:26.060" v="390" actId="164"/>
          <ac:grpSpMkLst>
            <pc:docMk/>
            <pc:sldMk cId="3319412604" sldId="269"/>
            <ac:grpSpMk id="111" creationId="{550324BD-423F-354C-AA39-AD7FDBE58FE4}"/>
          </ac:grpSpMkLst>
        </pc:grpChg>
        <pc:grpChg chg="add mod">
          <ac:chgData name="Warner,Jeffrey Barr" userId="7360d018-3b8a-4d6d-8136-e4d170e1e616" providerId="ADAL" clId="{3EFCE212-E637-1B4A-ADC8-D0BA86B19564}" dt="2021-04-23T19:49:57.077" v="419" actId="164"/>
          <ac:grpSpMkLst>
            <pc:docMk/>
            <pc:sldMk cId="3319412604" sldId="269"/>
            <ac:grpSpMk id="121" creationId="{DC976817-1556-DE45-AE36-36BCF5E58EBD}"/>
          </ac:grpSpMkLst>
        </pc:grpChg>
        <pc:grpChg chg="add mod">
          <ac:chgData name="Warner,Jeffrey Barr" userId="7360d018-3b8a-4d6d-8136-e4d170e1e616" providerId="ADAL" clId="{3EFCE212-E637-1B4A-ADC8-D0BA86B19564}" dt="2021-04-23T16:32:29.870" v="234" actId="1036"/>
          <ac:grpSpMkLst>
            <pc:docMk/>
            <pc:sldMk cId="3319412604" sldId="269"/>
            <ac:grpSpMk id="130" creationId="{EDF174FB-3B34-6A46-AB9F-B2651DA912D1}"/>
          </ac:grpSpMkLst>
        </pc:grpChg>
        <pc:grpChg chg="add mod">
          <ac:chgData name="Warner,Jeffrey Barr" userId="7360d018-3b8a-4d6d-8136-e4d170e1e616" providerId="ADAL" clId="{3EFCE212-E637-1B4A-ADC8-D0BA86B19564}" dt="2021-04-23T16:33:35.673" v="288" actId="1076"/>
          <ac:grpSpMkLst>
            <pc:docMk/>
            <pc:sldMk cId="3319412604" sldId="269"/>
            <ac:grpSpMk id="131" creationId="{42C15BD5-6AB4-744E-954E-12121FA138B7}"/>
          </ac:grpSpMkLst>
        </pc:grpChg>
        <pc:picChg chg="add mod modCrop">
          <ac:chgData name="Warner,Jeffrey Barr" userId="7360d018-3b8a-4d6d-8136-e4d170e1e616" providerId="ADAL" clId="{3EFCE212-E637-1B4A-ADC8-D0BA86B19564}" dt="2021-04-23T19:46:15.160" v="314" actId="164"/>
          <ac:picMkLst>
            <pc:docMk/>
            <pc:sldMk cId="3319412604" sldId="269"/>
            <ac:picMk id="3" creationId="{A1F379E0-23AE-FA44-BDE9-B93C59231D0D}"/>
          </ac:picMkLst>
        </pc:picChg>
        <pc:picChg chg="add mod">
          <ac:chgData name="Warner,Jeffrey Barr" userId="7360d018-3b8a-4d6d-8136-e4d170e1e616" providerId="ADAL" clId="{3EFCE212-E637-1B4A-ADC8-D0BA86B19564}" dt="2021-04-23T19:47:26.060" v="390" actId="164"/>
          <ac:picMkLst>
            <pc:docMk/>
            <pc:sldMk cId="3319412604" sldId="269"/>
            <ac:picMk id="8" creationId="{5BCE603F-535C-DE42-B921-FCF5B3CF96D6}"/>
          </ac:picMkLst>
        </pc:picChg>
        <pc:picChg chg="del">
          <ac:chgData name="Warner,Jeffrey Barr" userId="7360d018-3b8a-4d6d-8136-e4d170e1e616" providerId="ADAL" clId="{3EFCE212-E637-1B4A-ADC8-D0BA86B19564}" dt="2021-04-23T16:32:40.327" v="236" actId="478"/>
          <ac:picMkLst>
            <pc:docMk/>
            <pc:sldMk cId="3319412604" sldId="269"/>
            <ac:picMk id="10" creationId="{00000000-0000-0000-0000-000000000000}"/>
          </ac:picMkLst>
        </pc:picChg>
        <pc:picChg chg="del">
          <ac:chgData name="Warner,Jeffrey Barr" userId="7360d018-3b8a-4d6d-8136-e4d170e1e616" providerId="ADAL" clId="{3EFCE212-E637-1B4A-ADC8-D0BA86B19564}" dt="2021-04-23T16:32:40.327" v="236" actId="478"/>
          <ac:picMkLst>
            <pc:docMk/>
            <pc:sldMk cId="3319412604" sldId="269"/>
            <ac:picMk id="11" creationId="{00000000-0000-0000-0000-000000000000}"/>
          </ac:picMkLst>
        </pc:picChg>
        <pc:picChg chg="add mod">
          <ac:chgData name="Warner,Jeffrey Barr" userId="7360d018-3b8a-4d6d-8136-e4d170e1e616" providerId="ADAL" clId="{3EFCE212-E637-1B4A-ADC8-D0BA86B19564}" dt="2021-04-23T19:48:13.559" v="404" actId="164"/>
          <ac:picMkLst>
            <pc:docMk/>
            <pc:sldMk cId="3319412604" sldId="269"/>
            <ac:picMk id="11" creationId="{3E9E6DAF-5A17-B840-BAF6-7E84E0B32A13}"/>
          </ac:picMkLst>
        </pc:picChg>
        <pc:picChg chg="add mod">
          <ac:chgData name="Warner,Jeffrey Barr" userId="7360d018-3b8a-4d6d-8136-e4d170e1e616" providerId="ADAL" clId="{3EFCE212-E637-1B4A-ADC8-D0BA86B19564}" dt="2021-04-23T19:49:57.077" v="419" actId="164"/>
          <ac:picMkLst>
            <pc:docMk/>
            <pc:sldMk cId="3319412604" sldId="269"/>
            <ac:picMk id="14" creationId="{C2E47635-42AE-7A40-ABF2-757704893A67}"/>
          </ac:picMkLst>
        </pc:picChg>
        <pc:picChg chg="mod">
          <ac:chgData name="Warner,Jeffrey Barr" userId="7360d018-3b8a-4d6d-8136-e4d170e1e616" providerId="ADAL" clId="{3EFCE212-E637-1B4A-ADC8-D0BA86B19564}" dt="2021-04-23T19:45:37.390" v="308" actId="14100"/>
          <ac:picMkLst>
            <pc:docMk/>
            <pc:sldMk cId="3319412604" sldId="269"/>
            <ac:picMk id="36" creationId="{F74C922E-BCD7-824A-9CE5-8F63F06AD8A9}"/>
          </ac:picMkLst>
        </pc:picChg>
        <pc:picChg chg="mod">
          <ac:chgData name="Warner,Jeffrey Barr" userId="7360d018-3b8a-4d6d-8136-e4d170e1e616" providerId="ADAL" clId="{3EFCE212-E637-1B4A-ADC8-D0BA86B19564}" dt="2021-04-23T16:26:13.126" v="5" actId="571"/>
          <ac:picMkLst>
            <pc:docMk/>
            <pc:sldMk cId="3319412604" sldId="269"/>
            <ac:picMk id="69" creationId="{2BED47AB-45A4-5241-97FE-3EAECA34A143}"/>
          </ac:picMkLst>
        </pc:picChg>
        <pc:picChg chg="mod">
          <ac:chgData name="Warner,Jeffrey Barr" userId="7360d018-3b8a-4d6d-8136-e4d170e1e616" providerId="ADAL" clId="{3EFCE212-E637-1B4A-ADC8-D0BA86B19564}" dt="2021-04-23T16:27:47.103" v="34"/>
          <ac:picMkLst>
            <pc:docMk/>
            <pc:sldMk cId="3319412604" sldId="269"/>
            <ac:picMk id="83" creationId="{4271BB9A-9A17-7C4D-8A8E-E0534E846C89}"/>
          </ac:picMkLst>
        </pc:picChg>
        <pc:picChg chg="del mod">
          <ac:chgData name="Warner,Jeffrey Barr" userId="7360d018-3b8a-4d6d-8136-e4d170e1e616" providerId="ADAL" clId="{3EFCE212-E637-1B4A-ADC8-D0BA86B19564}" dt="2021-04-23T19:45:55.202" v="312" actId="478"/>
          <ac:picMkLst>
            <pc:docMk/>
            <pc:sldMk cId="3319412604" sldId="269"/>
            <ac:picMk id="88" creationId="{41DC4EC3-C2E3-E24C-BD0F-80914093428B}"/>
          </ac:picMkLst>
        </pc:picChg>
        <pc:picChg chg="del mod">
          <ac:chgData name="Warner,Jeffrey Barr" userId="7360d018-3b8a-4d6d-8136-e4d170e1e616" providerId="ADAL" clId="{3EFCE212-E637-1B4A-ADC8-D0BA86B19564}" dt="2021-04-23T19:47:58.462" v="394" actId="478"/>
          <ac:picMkLst>
            <pc:docMk/>
            <pc:sldMk cId="3319412604" sldId="269"/>
            <ac:picMk id="104" creationId="{B11CB82E-7A1E-1844-A244-797944322E06}"/>
          </ac:picMkLst>
        </pc:picChg>
        <pc:picChg chg="del mod">
          <ac:chgData name="Warner,Jeffrey Barr" userId="7360d018-3b8a-4d6d-8136-e4d170e1e616" providerId="ADAL" clId="{3EFCE212-E637-1B4A-ADC8-D0BA86B19564}" dt="2021-04-23T19:47:17.895" v="389" actId="478"/>
          <ac:picMkLst>
            <pc:docMk/>
            <pc:sldMk cId="3319412604" sldId="269"/>
            <ac:picMk id="112" creationId="{B43CBFDE-C7FE-5747-AAEB-67F4FF09AD5E}"/>
          </ac:picMkLst>
        </pc:picChg>
        <pc:picChg chg="del mod">
          <ac:chgData name="Warner,Jeffrey Barr" userId="7360d018-3b8a-4d6d-8136-e4d170e1e616" providerId="ADAL" clId="{3EFCE212-E637-1B4A-ADC8-D0BA86B19564}" dt="2021-04-23T19:49:45.554" v="418" actId="478"/>
          <ac:picMkLst>
            <pc:docMk/>
            <pc:sldMk cId="3319412604" sldId="269"/>
            <ac:picMk id="122" creationId="{987F39F6-6DE1-1240-BC5F-8684D10B89AA}"/>
          </ac:picMkLst>
        </pc:picChg>
        <pc:cxnChg chg="del">
          <ac:chgData name="Warner,Jeffrey Barr" userId="7360d018-3b8a-4d6d-8136-e4d170e1e616" providerId="ADAL" clId="{3EFCE212-E637-1B4A-ADC8-D0BA86B19564}" dt="2021-04-23T16:32:31.682" v="235" actId="478"/>
          <ac:cxnSpMkLst>
            <pc:docMk/>
            <pc:sldMk cId="3319412604" sldId="269"/>
            <ac:cxnSpMk id="6" creationId="{00000000-0000-0000-0000-000000000000}"/>
          </ac:cxnSpMkLst>
        </pc:cxnChg>
        <pc:cxnChg chg="mod">
          <ac:chgData name="Warner,Jeffrey Barr" userId="7360d018-3b8a-4d6d-8136-e4d170e1e616" providerId="ADAL" clId="{3EFCE212-E637-1B4A-ADC8-D0BA86B19564}" dt="2021-04-23T16:33:39.701" v="289" actId="14100"/>
          <ac:cxnSpMkLst>
            <pc:docMk/>
            <pc:sldMk cId="3319412604" sldId="269"/>
            <ac:cxnSpMk id="7" creationId="{00000000-0000-0000-0000-000000000000}"/>
          </ac:cxnSpMkLst>
        </pc:cxnChg>
        <pc:cxnChg chg="del">
          <ac:chgData name="Warner,Jeffrey Barr" userId="7360d018-3b8a-4d6d-8136-e4d170e1e616" providerId="ADAL" clId="{3EFCE212-E637-1B4A-ADC8-D0BA86B19564}" dt="2021-04-23T16:32:59.192" v="245" actId="478"/>
          <ac:cxnSpMkLst>
            <pc:docMk/>
            <pc:sldMk cId="3319412604" sldId="269"/>
            <ac:cxnSpMk id="9" creationId="{00000000-0000-0000-0000-000000000000}"/>
          </ac:cxnSpMkLst>
        </pc:cxnChg>
        <pc:cxnChg chg="del">
          <ac:chgData name="Warner,Jeffrey Barr" userId="7360d018-3b8a-4d6d-8136-e4d170e1e616" providerId="ADAL" clId="{3EFCE212-E637-1B4A-ADC8-D0BA86B19564}" dt="2021-04-23T16:32:58.196" v="244" actId="478"/>
          <ac:cxnSpMkLst>
            <pc:docMk/>
            <pc:sldMk cId="3319412604" sldId="269"/>
            <ac:cxnSpMk id="14" creationId="{00000000-0000-0000-0000-000000000000}"/>
          </ac:cxnSpMkLst>
        </pc:cxnChg>
        <pc:cxnChg chg="del">
          <ac:chgData name="Warner,Jeffrey Barr" userId="7360d018-3b8a-4d6d-8136-e4d170e1e616" providerId="ADAL" clId="{3EFCE212-E637-1B4A-ADC8-D0BA86B19564}" dt="2021-04-23T16:30:43.243" v="111" actId="478"/>
          <ac:cxnSpMkLst>
            <pc:docMk/>
            <pc:sldMk cId="3319412604" sldId="269"/>
            <ac:cxnSpMk id="25" creationId="{00000000-0000-0000-0000-000000000000}"/>
          </ac:cxnSpMkLst>
        </pc:cxnChg>
        <pc:cxnChg chg="del">
          <ac:chgData name="Warner,Jeffrey Barr" userId="7360d018-3b8a-4d6d-8136-e4d170e1e616" providerId="ADAL" clId="{3EFCE212-E637-1B4A-ADC8-D0BA86B19564}" dt="2021-04-23T16:30:43.243" v="111" actId="478"/>
          <ac:cxnSpMkLst>
            <pc:docMk/>
            <pc:sldMk cId="3319412604" sldId="269"/>
            <ac:cxnSpMk id="26" creationId="{00000000-0000-0000-0000-000000000000}"/>
          </ac:cxnSpMkLst>
        </pc:cxnChg>
        <pc:cxnChg chg="del">
          <ac:chgData name="Warner,Jeffrey Barr" userId="7360d018-3b8a-4d6d-8136-e4d170e1e616" providerId="ADAL" clId="{3EFCE212-E637-1B4A-ADC8-D0BA86B19564}" dt="2021-04-23T16:30:43.243" v="111" actId="478"/>
          <ac:cxnSpMkLst>
            <pc:docMk/>
            <pc:sldMk cId="3319412604" sldId="269"/>
            <ac:cxnSpMk id="27" creationId="{00000000-0000-0000-0000-000000000000}"/>
          </ac:cxnSpMkLst>
        </pc:cxnChg>
        <pc:cxnChg chg="mod">
          <ac:chgData name="Warner,Jeffrey Barr" userId="7360d018-3b8a-4d6d-8136-e4d170e1e616" providerId="ADAL" clId="{3EFCE212-E637-1B4A-ADC8-D0BA86B19564}" dt="2021-04-23T16:28:39.865" v="42" actId="1076"/>
          <ac:cxnSpMkLst>
            <pc:docMk/>
            <pc:sldMk cId="3319412604" sldId="269"/>
            <ac:cxnSpMk id="29" creationId="{00000000-0000-0000-0000-000000000000}"/>
          </ac:cxnSpMkLst>
        </pc:cxnChg>
        <pc:cxnChg chg="mod">
          <ac:chgData name="Warner,Jeffrey Barr" userId="7360d018-3b8a-4d6d-8136-e4d170e1e616" providerId="ADAL" clId="{3EFCE212-E637-1B4A-ADC8-D0BA86B19564}" dt="2021-04-23T16:26:13.126" v="5" actId="571"/>
          <ac:cxnSpMkLst>
            <pc:docMk/>
            <pc:sldMk cId="3319412604" sldId="269"/>
            <ac:cxnSpMk id="65" creationId="{9B08840D-9AFE-3E43-BF2D-DD4EE487AEA7}"/>
          </ac:cxnSpMkLst>
        </pc:cxnChg>
        <pc:cxnChg chg="mod">
          <ac:chgData name="Warner,Jeffrey Barr" userId="7360d018-3b8a-4d6d-8136-e4d170e1e616" providerId="ADAL" clId="{3EFCE212-E637-1B4A-ADC8-D0BA86B19564}" dt="2021-04-23T16:26:13.126" v="5" actId="571"/>
          <ac:cxnSpMkLst>
            <pc:docMk/>
            <pc:sldMk cId="3319412604" sldId="269"/>
            <ac:cxnSpMk id="66" creationId="{0BED93DE-2211-A949-B857-A84C251816E2}"/>
          </ac:cxnSpMkLst>
        </pc:cxnChg>
        <pc:cxnChg chg="add mod">
          <ac:chgData name="Warner,Jeffrey Barr" userId="7360d018-3b8a-4d6d-8136-e4d170e1e616" providerId="ADAL" clId="{3EFCE212-E637-1B4A-ADC8-D0BA86B19564}" dt="2021-04-23T16:26:44.958" v="16" actId="1036"/>
          <ac:cxnSpMkLst>
            <pc:docMk/>
            <pc:sldMk cId="3319412604" sldId="269"/>
            <ac:cxnSpMk id="72" creationId="{342BA422-9503-A442-8C30-76E37E7604F8}"/>
          </ac:cxnSpMkLst>
        </pc:cxnChg>
        <pc:cxnChg chg="add mod">
          <ac:chgData name="Warner,Jeffrey Barr" userId="7360d018-3b8a-4d6d-8136-e4d170e1e616" providerId="ADAL" clId="{3EFCE212-E637-1B4A-ADC8-D0BA86B19564}" dt="2021-04-23T16:28:36.116" v="41" actId="14100"/>
          <ac:cxnSpMkLst>
            <pc:docMk/>
            <pc:sldMk cId="3319412604" sldId="269"/>
            <ac:cxnSpMk id="75" creationId="{ABC9AE3B-9A15-D744-880B-E34C3925B121}"/>
          </ac:cxnSpMkLst>
        </pc:cxnChg>
        <pc:cxnChg chg="mod">
          <ac:chgData name="Warner,Jeffrey Barr" userId="7360d018-3b8a-4d6d-8136-e4d170e1e616" providerId="ADAL" clId="{3EFCE212-E637-1B4A-ADC8-D0BA86B19564}" dt="2021-04-23T16:27:47.103" v="34"/>
          <ac:cxnSpMkLst>
            <pc:docMk/>
            <pc:sldMk cId="3319412604" sldId="269"/>
            <ac:cxnSpMk id="79" creationId="{258B2678-D0E9-8D43-B700-009506007CE5}"/>
          </ac:cxnSpMkLst>
        </pc:cxnChg>
        <pc:cxnChg chg="mod">
          <ac:chgData name="Warner,Jeffrey Barr" userId="7360d018-3b8a-4d6d-8136-e4d170e1e616" providerId="ADAL" clId="{3EFCE212-E637-1B4A-ADC8-D0BA86B19564}" dt="2021-04-23T16:27:47.103" v="34"/>
          <ac:cxnSpMkLst>
            <pc:docMk/>
            <pc:sldMk cId="3319412604" sldId="269"/>
            <ac:cxnSpMk id="80" creationId="{FE262DF4-DFBE-D644-BDCE-D9902C19C404}"/>
          </ac:cxnSpMkLst>
        </pc:cxnChg>
        <pc:cxnChg chg="mod">
          <ac:chgData name="Warner,Jeffrey Barr" userId="7360d018-3b8a-4d6d-8136-e4d170e1e616" providerId="ADAL" clId="{3EFCE212-E637-1B4A-ADC8-D0BA86B19564}" dt="2021-04-23T16:28:20.333" v="39"/>
          <ac:cxnSpMkLst>
            <pc:docMk/>
            <pc:sldMk cId="3319412604" sldId="269"/>
            <ac:cxnSpMk id="89" creationId="{34A85B02-FCF0-FC4D-B317-2859EE7D5E0A}"/>
          </ac:cxnSpMkLst>
        </pc:cxnChg>
        <pc:cxnChg chg="mod">
          <ac:chgData name="Warner,Jeffrey Barr" userId="7360d018-3b8a-4d6d-8136-e4d170e1e616" providerId="ADAL" clId="{3EFCE212-E637-1B4A-ADC8-D0BA86B19564}" dt="2021-04-23T16:28:20.333" v="39"/>
          <ac:cxnSpMkLst>
            <pc:docMk/>
            <pc:sldMk cId="3319412604" sldId="269"/>
            <ac:cxnSpMk id="90" creationId="{4A4C1ABE-254F-D448-A16A-1FC431DF4A82}"/>
          </ac:cxnSpMkLst>
        </pc:cxnChg>
        <pc:cxnChg chg="add mod">
          <ac:chgData name="Warner,Jeffrey Barr" userId="7360d018-3b8a-4d6d-8136-e4d170e1e616" providerId="ADAL" clId="{3EFCE212-E637-1B4A-ADC8-D0BA86B19564}" dt="2021-04-23T16:29:06.436" v="58" actId="14100"/>
          <ac:cxnSpMkLst>
            <pc:docMk/>
            <pc:sldMk cId="3319412604" sldId="269"/>
            <ac:cxnSpMk id="95" creationId="{60A5390B-209B-6649-98AC-3D465EDAD499}"/>
          </ac:cxnSpMkLst>
        </pc:cxnChg>
        <pc:cxnChg chg="add mod">
          <ac:chgData name="Warner,Jeffrey Barr" userId="7360d018-3b8a-4d6d-8136-e4d170e1e616" providerId="ADAL" clId="{3EFCE212-E637-1B4A-ADC8-D0BA86B19564}" dt="2021-04-23T16:30:40.081" v="110" actId="14100"/>
          <ac:cxnSpMkLst>
            <pc:docMk/>
            <pc:sldMk cId="3319412604" sldId="269"/>
            <ac:cxnSpMk id="98" creationId="{3C1B1F6F-E4C8-554D-9A1A-D1E602849009}"/>
          </ac:cxnSpMkLst>
        </pc:cxnChg>
        <pc:cxnChg chg="add mod">
          <ac:chgData name="Warner,Jeffrey Barr" userId="7360d018-3b8a-4d6d-8136-e4d170e1e616" providerId="ADAL" clId="{3EFCE212-E637-1B4A-ADC8-D0BA86B19564}" dt="2021-04-23T16:30:12.347" v="97" actId="14100"/>
          <ac:cxnSpMkLst>
            <pc:docMk/>
            <pc:sldMk cId="3319412604" sldId="269"/>
            <ac:cxnSpMk id="99" creationId="{FF236E01-10D8-1F4B-82AC-A69B33C258F9}"/>
          </ac:cxnSpMkLst>
        </pc:cxnChg>
        <pc:cxnChg chg="mod">
          <ac:chgData name="Warner,Jeffrey Barr" userId="7360d018-3b8a-4d6d-8136-e4d170e1e616" providerId="ADAL" clId="{3EFCE212-E637-1B4A-ADC8-D0BA86B19564}" dt="2021-04-23T16:29:33.694" v="68"/>
          <ac:cxnSpMkLst>
            <pc:docMk/>
            <pc:sldMk cId="3319412604" sldId="269"/>
            <ac:cxnSpMk id="105" creationId="{C5CA79BE-ED02-EE47-A507-78BDFE6F3846}"/>
          </ac:cxnSpMkLst>
        </pc:cxnChg>
        <pc:cxnChg chg="mod">
          <ac:chgData name="Warner,Jeffrey Barr" userId="7360d018-3b8a-4d6d-8136-e4d170e1e616" providerId="ADAL" clId="{3EFCE212-E637-1B4A-ADC8-D0BA86B19564}" dt="2021-04-23T16:29:33.694" v="68"/>
          <ac:cxnSpMkLst>
            <pc:docMk/>
            <pc:sldMk cId="3319412604" sldId="269"/>
            <ac:cxnSpMk id="106" creationId="{0D425780-F170-F54F-BCBA-4BD7ABB4F793}"/>
          </ac:cxnSpMkLst>
        </pc:cxnChg>
        <pc:cxnChg chg="mod">
          <ac:chgData name="Warner,Jeffrey Barr" userId="7360d018-3b8a-4d6d-8136-e4d170e1e616" providerId="ADAL" clId="{3EFCE212-E637-1B4A-ADC8-D0BA86B19564}" dt="2021-04-23T16:30:14.973" v="98"/>
          <ac:cxnSpMkLst>
            <pc:docMk/>
            <pc:sldMk cId="3319412604" sldId="269"/>
            <ac:cxnSpMk id="113" creationId="{2B24ECE6-3737-9143-B46D-1EBCAC2E3568}"/>
          </ac:cxnSpMkLst>
        </pc:cxnChg>
        <pc:cxnChg chg="mod">
          <ac:chgData name="Warner,Jeffrey Barr" userId="7360d018-3b8a-4d6d-8136-e4d170e1e616" providerId="ADAL" clId="{3EFCE212-E637-1B4A-ADC8-D0BA86B19564}" dt="2021-04-23T16:30:14.973" v="98"/>
          <ac:cxnSpMkLst>
            <pc:docMk/>
            <pc:sldMk cId="3319412604" sldId="269"/>
            <ac:cxnSpMk id="114" creationId="{002AF725-441A-C34C-9F25-626BF1243E37}"/>
          </ac:cxnSpMkLst>
        </pc:cxnChg>
        <pc:cxnChg chg="add mod">
          <ac:chgData name="Warner,Jeffrey Barr" userId="7360d018-3b8a-4d6d-8136-e4d170e1e616" providerId="ADAL" clId="{3EFCE212-E637-1B4A-ADC8-D0BA86B19564}" dt="2021-04-23T16:31:05.945" v="156" actId="14100"/>
          <ac:cxnSpMkLst>
            <pc:docMk/>
            <pc:sldMk cId="3319412604" sldId="269"/>
            <ac:cxnSpMk id="119" creationId="{FCBDDB18-6BF9-DE4C-B37C-6E68DB65C3AD}"/>
          </ac:cxnSpMkLst>
        </pc:cxnChg>
        <pc:cxnChg chg="mod">
          <ac:chgData name="Warner,Jeffrey Barr" userId="7360d018-3b8a-4d6d-8136-e4d170e1e616" providerId="ADAL" clId="{3EFCE212-E637-1B4A-ADC8-D0BA86B19564}" dt="2021-04-23T16:30:51.762" v="115"/>
          <ac:cxnSpMkLst>
            <pc:docMk/>
            <pc:sldMk cId="3319412604" sldId="269"/>
            <ac:cxnSpMk id="123" creationId="{F0C36C43-423A-3549-9F05-A75C6BFAAE91}"/>
          </ac:cxnSpMkLst>
        </pc:cxnChg>
        <pc:cxnChg chg="mod">
          <ac:chgData name="Warner,Jeffrey Barr" userId="7360d018-3b8a-4d6d-8136-e4d170e1e616" providerId="ADAL" clId="{3EFCE212-E637-1B4A-ADC8-D0BA86B19564}" dt="2021-04-23T16:30:51.762" v="115"/>
          <ac:cxnSpMkLst>
            <pc:docMk/>
            <pc:sldMk cId="3319412604" sldId="269"/>
            <ac:cxnSpMk id="124" creationId="{FCA48754-9260-0E4E-A69F-AA7C5EFB989F}"/>
          </ac:cxnSpMkLst>
        </pc:cxnChg>
      </pc:sldChg>
      <pc:sldChg chg="addSp delSp modSp mod">
        <pc:chgData name="Warner,Jeffrey Barr" userId="7360d018-3b8a-4d6d-8136-e4d170e1e616" providerId="ADAL" clId="{3EFCE212-E637-1B4A-ADC8-D0BA86B19564}" dt="2021-04-23T19:42:00.174" v="300" actId="1076"/>
        <pc:sldMkLst>
          <pc:docMk/>
          <pc:sldMk cId="2788620995" sldId="356"/>
        </pc:sldMkLst>
        <pc:picChg chg="add mod">
          <ac:chgData name="Warner,Jeffrey Barr" userId="7360d018-3b8a-4d6d-8136-e4d170e1e616" providerId="ADAL" clId="{3EFCE212-E637-1B4A-ADC8-D0BA86B19564}" dt="2021-04-23T19:42:00.174" v="300" actId="1076"/>
          <ac:picMkLst>
            <pc:docMk/>
            <pc:sldMk cId="2788620995" sldId="356"/>
            <ac:picMk id="3" creationId="{D78F7D62-C386-A84F-B1CA-3E9190A3876D}"/>
          </ac:picMkLst>
        </pc:picChg>
        <pc:picChg chg="del">
          <ac:chgData name="Warner,Jeffrey Barr" userId="7360d018-3b8a-4d6d-8136-e4d170e1e616" providerId="ADAL" clId="{3EFCE212-E637-1B4A-ADC8-D0BA86B19564}" dt="2021-04-23T19:41:50.283" v="292" actId="478"/>
          <ac:picMkLst>
            <pc:docMk/>
            <pc:sldMk cId="2788620995" sldId="356"/>
            <ac:picMk id="14" creationId="{A8A2166D-EE34-42BD-B7B9-4498848599E0}"/>
          </ac:picMkLst>
        </pc:picChg>
      </pc:sldChg>
      <pc:sldChg chg="addSp delSp mod">
        <pc:chgData name="Warner,Jeffrey Barr" userId="7360d018-3b8a-4d6d-8136-e4d170e1e616" providerId="ADAL" clId="{3EFCE212-E637-1B4A-ADC8-D0BA86B19564}" dt="2021-04-23T19:42:12.967" v="302"/>
        <pc:sldMkLst>
          <pc:docMk/>
          <pc:sldMk cId="53146747" sldId="357"/>
        </pc:sldMkLst>
        <pc:picChg chg="add">
          <ac:chgData name="Warner,Jeffrey Barr" userId="7360d018-3b8a-4d6d-8136-e4d170e1e616" providerId="ADAL" clId="{3EFCE212-E637-1B4A-ADC8-D0BA86B19564}" dt="2021-04-23T19:42:12.967" v="302"/>
          <ac:picMkLst>
            <pc:docMk/>
            <pc:sldMk cId="53146747" sldId="357"/>
            <ac:picMk id="2" creationId="{48E4A51B-2D10-7042-B9F8-F0126FDF1139}"/>
          </ac:picMkLst>
        </pc:picChg>
        <pc:picChg chg="del">
          <ac:chgData name="Warner,Jeffrey Barr" userId="7360d018-3b8a-4d6d-8136-e4d170e1e616" providerId="ADAL" clId="{3EFCE212-E637-1B4A-ADC8-D0BA86B19564}" dt="2021-04-23T19:42:12.686" v="301" actId="478"/>
          <ac:picMkLst>
            <pc:docMk/>
            <pc:sldMk cId="53146747" sldId="357"/>
            <ac:picMk id="4" creationId="{4C2332E1-0D0E-4AD2-A2A9-E15E17DAF666}"/>
          </ac:picMkLst>
        </pc:picChg>
      </pc:sldChg>
    </pc:docChg>
  </pc:docChgLst>
  <pc:docChgLst>
    <pc:chgData name="Warner,Jeffrey Barr" userId="7360d018-3b8a-4d6d-8136-e4d170e1e616" providerId="ADAL" clId="{693FE2FC-F0F6-44A8-ADE1-47761A581875}"/>
    <pc:docChg chg="undo custSel addSld delSld modSld">
      <pc:chgData name="Warner,Jeffrey Barr" userId="7360d018-3b8a-4d6d-8136-e4d170e1e616" providerId="ADAL" clId="{693FE2FC-F0F6-44A8-ADE1-47761A581875}" dt="2021-10-08T18:54:10.099" v="172" actId="20577"/>
      <pc:docMkLst>
        <pc:docMk/>
      </pc:docMkLst>
      <pc:sldChg chg="addSp delSp modSp mod">
        <pc:chgData name="Warner,Jeffrey Barr" userId="7360d018-3b8a-4d6d-8136-e4d170e1e616" providerId="ADAL" clId="{693FE2FC-F0F6-44A8-ADE1-47761A581875}" dt="2021-10-08T18:54:10.099" v="172" actId="20577"/>
        <pc:sldMkLst>
          <pc:docMk/>
          <pc:sldMk cId="3815654910" sldId="259"/>
        </pc:sldMkLst>
        <pc:spChg chg="add mod">
          <ac:chgData name="Warner,Jeffrey Barr" userId="7360d018-3b8a-4d6d-8136-e4d170e1e616" providerId="ADAL" clId="{693FE2FC-F0F6-44A8-ADE1-47761A581875}" dt="2021-10-08T18:52:04.605" v="113" actId="1037"/>
          <ac:spMkLst>
            <pc:docMk/>
            <pc:sldMk cId="3815654910" sldId="259"/>
            <ac:spMk id="3" creationId="{3C5E1216-7947-4254-A3E8-688C1E1DB6CD}"/>
          </ac:spMkLst>
        </pc:spChg>
        <pc:spChg chg="add del">
          <ac:chgData name="Warner,Jeffrey Barr" userId="7360d018-3b8a-4d6d-8136-e4d170e1e616" providerId="ADAL" clId="{693FE2FC-F0F6-44A8-ADE1-47761A581875}" dt="2021-10-08T18:53:27.093" v="148" actId="478"/>
          <ac:spMkLst>
            <pc:docMk/>
            <pc:sldMk cId="3815654910" sldId="259"/>
            <ac:spMk id="64" creationId="{158FF225-6142-4F63-85D8-3BF401F0CF99}"/>
          </ac:spMkLst>
        </pc:spChg>
        <pc:spChg chg="mod topLvl">
          <ac:chgData name="Warner,Jeffrey Barr" userId="7360d018-3b8a-4d6d-8136-e4d170e1e616" providerId="ADAL" clId="{693FE2FC-F0F6-44A8-ADE1-47761A581875}" dt="2021-10-08T18:53:51.311" v="158" actId="165"/>
          <ac:spMkLst>
            <pc:docMk/>
            <pc:sldMk cId="3815654910" sldId="259"/>
            <ac:spMk id="65" creationId="{659F19F9-4B25-412A-AB80-54FF7451D883}"/>
          </ac:spMkLst>
        </pc:spChg>
        <pc:spChg chg="add del mod topLvl">
          <ac:chgData name="Warner,Jeffrey Barr" userId="7360d018-3b8a-4d6d-8136-e4d170e1e616" providerId="ADAL" clId="{693FE2FC-F0F6-44A8-ADE1-47761A581875}" dt="2021-10-08T18:53:51.311" v="158" actId="165"/>
          <ac:spMkLst>
            <pc:docMk/>
            <pc:sldMk cId="3815654910" sldId="259"/>
            <ac:spMk id="66" creationId="{59E48F58-17E3-4EEF-8614-B0DF1990F5E1}"/>
          </ac:spMkLst>
        </pc:spChg>
        <pc:spChg chg="add del">
          <ac:chgData name="Warner,Jeffrey Barr" userId="7360d018-3b8a-4d6d-8136-e4d170e1e616" providerId="ADAL" clId="{693FE2FC-F0F6-44A8-ADE1-47761A581875}" dt="2021-10-08T18:54:02.754" v="165" actId="478"/>
          <ac:spMkLst>
            <pc:docMk/>
            <pc:sldMk cId="3815654910" sldId="259"/>
            <ac:spMk id="68" creationId="{3ADA8937-CFE2-4F70-BC2A-B0D83F5782FE}"/>
          </ac:spMkLst>
        </pc:spChg>
        <pc:spChg chg="mod topLvl">
          <ac:chgData name="Warner,Jeffrey Barr" userId="7360d018-3b8a-4d6d-8136-e4d170e1e616" providerId="ADAL" clId="{693FE2FC-F0F6-44A8-ADE1-47761A581875}" dt="2021-10-08T18:53:51.311" v="158" actId="165"/>
          <ac:spMkLst>
            <pc:docMk/>
            <pc:sldMk cId="3815654910" sldId="259"/>
            <ac:spMk id="70" creationId="{333D3469-C641-43A8-B250-97D7DDD0835F}"/>
          </ac:spMkLst>
        </pc:spChg>
        <pc:spChg chg="mod topLvl">
          <ac:chgData name="Warner,Jeffrey Barr" userId="7360d018-3b8a-4d6d-8136-e4d170e1e616" providerId="ADAL" clId="{693FE2FC-F0F6-44A8-ADE1-47761A581875}" dt="2021-10-08T18:53:51.311" v="158" actId="165"/>
          <ac:spMkLst>
            <pc:docMk/>
            <pc:sldMk cId="3815654910" sldId="259"/>
            <ac:spMk id="73" creationId="{A0E77195-2D45-4FE9-A333-FE0CAF30C4AB}"/>
          </ac:spMkLst>
        </pc:spChg>
        <pc:spChg chg="add mod">
          <ac:chgData name="Warner,Jeffrey Barr" userId="7360d018-3b8a-4d6d-8136-e4d170e1e616" providerId="ADAL" clId="{693FE2FC-F0F6-44A8-ADE1-47761A581875}" dt="2021-10-08T18:52:26.636" v="118" actId="1038"/>
          <ac:spMkLst>
            <pc:docMk/>
            <pc:sldMk cId="3815654910" sldId="259"/>
            <ac:spMk id="76" creationId="{CE0A0BD0-689E-4852-B8E0-6AC47DD106E2}"/>
          </ac:spMkLst>
        </pc:spChg>
        <pc:spChg chg="add mod">
          <ac:chgData name="Warner,Jeffrey Barr" userId="7360d018-3b8a-4d6d-8136-e4d170e1e616" providerId="ADAL" clId="{693FE2FC-F0F6-44A8-ADE1-47761A581875}" dt="2021-10-08T18:52:01.182" v="111" actId="12789"/>
          <ac:spMkLst>
            <pc:docMk/>
            <pc:sldMk cId="3815654910" sldId="259"/>
            <ac:spMk id="77" creationId="{5CFB3EE9-EC05-44C3-B898-D8E895066DA0}"/>
          </ac:spMkLst>
        </pc:spChg>
        <pc:spChg chg="add mod">
          <ac:chgData name="Warner,Jeffrey Barr" userId="7360d018-3b8a-4d6d-8136-e4d170e1e616" providerId="ADAL" clId="{693FE2FC-F0F6-44A8-ADE1-47761A581875}" dt="2021-10-08T18:53:01.289" v="138" actId="20577"/>
          <ac:spMkLst>
            <pc:docMk/>
            <pc:sldMk cId="3815654910" sldId="259"/>
            <ac:spMk id="78" creationId="{7F29EFA2-4CA6-4787-AF4E-485B604C110D}"/>
          </ac:spMkLst>
        </pc:spChg>
        <pc:spChg chg="add mod">
          <ac:chgData name="Warner,Jeffrey Barr" userId="7360d018-3b8a-4d6d-8136-e4d170e1e616" providerId="ADAL" clId="{693FE2FC-F0F6-44A8-ADE1-47761A581875}" dt="2021-10-08T18:53:04.880" v="142" actId="20577"/>
          <ac:spMkLst>
            <pc:docMk/>
            <pc:sldMk cId="3815654910" sldId="259"/>
            <ac:spMk id="81" creationId="{C91AD17C-3572-436C-AD6F-420D772EE170}"/>
          </ac:spMkLst>
        </pc:spChg>
        <pc:spChg chg="add mod">
          <ac:chgData name="Warner,Jeffrey Barr" userId="7360d018-3b8a-4d6d-8136-e4d170e1e616" providerId="ADAL" clId="{693FE2FC-F0F6-44A8-ADE1-47761A581875}" dt="2021-10-08T18:53:08.902" v="146" actId="20577"/>
          <ac:spMkLst>
            <pc:docMk/>
            <pc:sldMk cId="3815654910" sldId="259"/>
            <ac:spMk id="82" creationId="{F1527044-C848-4582-AC01-F10BF6329DF8}"/>
          </ac:spMkLst>
        </pc:spChg>
        <pc:spChg chg="add mod">
          <ac:chgData name="Warner,Jeffrey Barr" userId="7360d018-3b8a-4d6d-8136-e4d170e1e616" providerId="ADAL" clId="{693FE2FC-F0F6-44A8-ADE1-47761A581875}" dt="2021-10-08T18:53:31.165" v="152" actId="20577"/>
          <ac:spMkLst>
            <pc:docMk/>
            <pc:sldMk cId="3815654910" sldId="259"/>
            <ac:spMk id="83" creationId="{633C5E90-8C0D-48F0-BCA8-F8A5E2760689}"/>
          </ac:spMkLst>
        </pc:spChg>
        <pc:spChg chg="add mod">
          <ac:chgData name="Warner,Jeffrey Barr" userId="7360d018-3b8a-4d6d-8136-e4d170e1e616" providerId="ADAL" clId="{693FE2FC-F0F6-44A8-ADE1-47761A581875}" dt="2021-10-08T18:53:54.115" v="162" actId="20577"/>
          <ac:spMkLst>
            <pc:docMk/>
            <pc:sldMk cId="3815654910" sldId="259"/>
            <ac:spMk id="86" creationId="{B9C61DBA-82D3-4172-A11B-14451FC9EEF7}"/>
          </ac:spMkLst>
        </pc:spChg>
        <pc:spChg chg="add mod">
          <ac:chgData name="Warner,Jeffrey Barr" userId="7360d018-3b8a-4d6d-8136-e4d170e1e616" providerId="ADAL" clId="{693FE2FC-F0F6-44A8-ADE1-47761A581875}" dt="2021-10-08T18:54:10.099" v="172" actId="20577"/>
          <ac:spMkLst>
            <pc:docMk/>
            <pc:sldMk cId="3815654910" sldId="259"/>
            <ac:spMk id="87" creationId="{63708E16-7F00-4A9B-A32C-52E5933935D6}"/>
          </ac:spMkLst>
        </pc:spChg>
        <pc:grpChg chg="mod">
          <ac:chgData name="Warner,Jeffrey Barr" userId="7360d018-3b8a-4d6d-8136-e4d170e1e616" providerId="ADAL" clId="{693FE2FC-F0F6-44A8-ADE1-47761A581875}" dt="2021-10-08T18:52:39.199" v="126" actId="1076"/>
          <ac:grpSpMkLst>
            <pc:docMk/>
            <pc:sldMk cId="3815654910" sldId="259"/>
            <ac:grpSpMk id="19" creationId="{3D5E7A80-2F40-4BFD-939F-E75C94018F0B}"/>
          </ac:grpSpMkLst>
        </pc:grpChg>
        <pc:grpChg chg="add del mod">
          <ac:chgData name="Warner,Jeffrey Barr" userId="7360d018-3b8a-4d6d-8136-e4d170e1e616" providerId="ADAL" clId="{693FE2FC-F0F6-44A8-ADE1-47761A581875}" dt="2021-10-08T18:53:51.311" v="158" actId="165"/>
          <ac:grpSpMkLst>
            <pc:docMk/>
            <pc:sldMk cId="3815654910" sldId="259"/>
            <ac:grpSpMk id="44" creationId="{65453D5A-F03B-499E-9B32-2E36D466CC58}"/>
          </ac:grpSpMkLst>
        </pc:grpChg>
        <pc:picChg chg="mod topLvl">
          <ac:chgData name="Warner,Jeffrey Barr" userId="7360d018-3b8a-4d6d-8136-e4d170e1e616" providerId="ADAL" clId="{693FE2FC-F0F6-44A8-ADE1-47761A581875}" dt="2021-10-08T18:53:51.311" v="158" actId="165"/>
          <ac:picMkLst>
            <pc:docMk/>
            <pc:sldMk cId="3815654910" sldId="259"/>
            <ac:picMk id="58" creationId="{DCDB4A7D-678E-0F49-8B85-6FA9A8591CD7}"/>
          </ac:picMkLst>
        </pc:picChg>
      </pc:sldChg>
      <pc:sldChg chg="del">
        <pc:chgData name="Warner,Jeffrey Barr" userId="7360d018-3b8a-4d6d-8136-e4d170e1e616" providerId="ADAL" clId="{693FE2FC-F0F6-44A8-ADE1-47761A581875}" dt="2021-10-07T18:51:41.332" v="77" actId="2696"/>
        <pc:sldMkLst>
          <pc:docMk/>
          <pc:sldMk cId="65776975" sldId="277"/>
        </pc:sldMkLst>
      </pc:sldChg>
      <pc:sldChg chg="del">
        <pc:chgData name="Warner,Jeffrey Barr" userId="7360d018-3b8a-4d6d-8136-e4d170e1e616" providerId="ADAL" clId="{693FE2FC-F0F6-44A8-ADE1-47761A581875}" dt="2021-10-07T18:51:43.505" v="78" actId="2696"/>
        <pc:sldMkLst>
          <pc:docMk/>
          <pc:sldMk cId="1260446676" sldId="358"/>
        </pc:sldMkLst>
      </pc:sldChg>
      <pc:sldChg chg="del">
        <pc:chgData name="Warner,Jeffrey Barr" userId="7360d018-3b8a-4d6d-8136-e4d170e1e616" providerId="ADAL" clId="{693FE2FC-F0F6-44A8-ADE1-47761A581875}" dt="2021-10-07T14:59:45.969" v="76" actId="2696"/>
        <pc:sldMkLst>
          <pc:docMk/>
          <pc:sldMk cId="2823416257" sldId="386"/>
        </pc:sldMkLst>
      </pc:sldChg>
      <pc:sldChg chg="addSp modSp">
        <pc:chgData name="Warner,Jeffrey Barr" userId="7360d018-3b8a-4d6d-8136-e4d170e1e616" providerId="ADAL" clId="{693FE2FC-F0F6-44A8-ADE1-47761A581875}" dt="2021-10-05T15:19:40.225" v="0" actId="164"/>
        <pc:sldMkLst>
          <pc:docMk/>
          <pc:sldMk cId="500895388" sldId="387"/>
        </pc:sldMkLst>
        <pc:spChg chg="mod">
          <ac:chgData name="Warner,Jeffrey Barr" userId="7360d018-3b8a-4d6d-8136-e4d170e1e616" providerId="ADAL" clId="{693FE2FC-F0F6-44A8-ADE1-47761A581875}" dt="2021-10-05T15:19:40.225" v="0" actId="164"/>
          <ac:spMkLst>
            <pc:docMk/>
            <pc:sldMk cId="500895388" sldId="387"/>
            <ac:spMk id="20" creationId="{D5F2EBD1-A40F-4C3E-B966-62F068799F84}"/>
          </ac:spMkLst>
        </pc:spChg>
        <pc:spChg chg="mod">
          <ac:chgData name="Warner,Jeffrey Barr" userId="7360d018-3b8a-4d6d-8136-e4d170e1e616" providerId="ADAL" clId="{693FE2FC-F0F6-44A8-ADE1-47761A581875}" dt="2021-10-05T15:19:40.225" v="0" actId="164"/>
          <ac:spMkLst>
            <pc:docMk/>
            <pc:sldMk cId="500895388" sldId="387"/>
            <ac:spMk id="23" creationId="{F4D122E1-2D35-4330-8C12-32BEE8F651D2}"/>
          </ac:spMkLst>
        </pc:spChg>
        <pc:spChg chg="mod">
          <ac:chgData name="Warner,Jeffrey Barr" userId="7360d018-3b8a-4d6d-8136-e4d170e1e616" providerId="ADAL" clId="{693FE2FC-F0F6-44A8-ADE1-47761A581875}" dt="2021-10-05T15:19:40.225" v="0" actId="164"/>
          <ac:spMkLst>
            <pc:docMk/>
            <pc:sldMk cId="500895388" sldId="387"/>
            <ac:spMk id="26" creationId="{A899D248-E465-4E69-BCF7-37B2EA89BE59}"/>
          </ac:spMkLst>
        </pc:spChg>
        <pc:spChg chg="mod">
          <ac:chgData name="Warner,Jeffrey Barr" userId="7360d018-3b8a-4d6d-8136-e4d170e1e616" providerId="ADAL" clId="{693FE2FC-F0F6-44A8-ADE1-47761A581875}" dt="2021-10-05T15:19:40.225" v="0" actId="164"/>
          <ac:spMkLst>
            <pc:docMk/>
            <pc:sldMk cId="500895388" sldId="387"/>
            <ac:spMk id="27" creationId="{EA363D24-F46D-4BCA-9F29-31125FDB59B9}"/>
          </ac:spMkLst>
        </pc:spChg>
        <pc:spChg chg="mod">
          <ac:chgData name="Warner,Jeffrey Barr" userId="7360d018-3b8a-4d6d-8136-e4d170e1e616" providerId="ADAL" clId="{693FE2FC-F0F6-44A8-ADE1-47761A581875}" dt="2021-10-05T15:19:40.225" v="0" actId="164"/>
          <ac:spMkLst>
            <pc:docMk/>
            <pc:sldMk cId="500895388" sldId="387"/>
            <ac:spMk id="32" creationId="{55314C5A-69BD-47E5-B562-70A86A9F7033}"/>
          </ac:spMkLst>
        </pc:spChg>
        <pc:spChg chg="mod">
          <ac:chgData name="Warner,Jeffrey Barr" userId="7360d018-3b8a-4d6d-8136-e4d170e1e616" providerId="ADAL" clId="{693FE2FC-F0F6-44A8-ADE1-47761A581875}" dt="2021-10-05T15:19:40.225" v="0" actId="164"/>
          <ac:spMkLst>
            <pc:docMk/>
            <pc:sldMk cId="500895388" sldId="387"/>
            <ac:spMk id="33" creationId="{0990AD1F-3F99-41EA-BD73-CCF27691F7C6}"/>
          </ac:spMkLst>
        </pc:spChg>
        <pc:spChg chg="mod">
          <ac:chgData name="Warner,Jeffrey Barr" userId="7360d018-3b8a-4d6d-8136-e4d170e1e616" providerId="ADAL" clId="{693FE2FC-F0F6-44A8-ADE1-47761A581875}" dt="2021-10-05T15:19:40.225" v="0" actId="164"/>
          <ac:spMkLst>
            <pc:docMk/>
            <pc:sldMk cId="500895388" sldId="387"/>
            <ac:spMk id="38" creationId="{85F52613-BFCE-4902-BDE8-EA4E928C8BFB}"/>
          </ac:spMkLst>
        </pc:spChg>
        <pc:spChg chg="mod">
          <ac:chgData name="Warner,Jeffrey Barr" userId="7360d018-3b8a-4d6d-8136-e4d170e1e616" providerId="ADAL" clId="{693FE2FC-F0F6-44A8-ADE1-47761A581875}" dt="2021-10-05T15:19:40.225" v="0" actId="164"/>
          <ac:spMkLst>
            <pc:docMk/>
            <pc:sldMk cId="500895388" sldId="387"/>
            <ac:spMk id="39" creationId="{EC358F75-276E-439A-8994-677D5EC79E0A}"/>
          </ac:spMkLst>
        </pc:spChg>
        <pc:grpChg chg="add mod">
          <ac:chgData name="Warner,Jeffrey Barr" userId="7360d018-3b8a-4d6d-8136-e4d170e1e616" providerId="ADAL" clId="{693FE2FC-F0F6-44A8-ADE1-47761A581875}" dt="2021-10-05T15:19:40.225" v="0" actId="164"/>
          <ac:grpSpMkLst>
            <pc:docMk/>
            <pc:sldMk cId="500895388" sldId="387"/>
            <ac:grpSpMk id="2" creationId="{CEC7D72B-6A5E-451D-993D-245162048D85}"/>
          </ac:grpSpMkLst>
        </pc:grpChg>
        <pc:picChg chg="mod">
          <ac:chgData name="Warner,Jeffrey Barr" userId="7360d018-3b8a-4d6d-8136-e4d170e1e616" providerId="ADAL" clId="{693FE2FC-F0F6-44A8-ADE1-47761A581875}" dt="2021-10-05T15:19:40.225" v="0" actId="164"/>
          <ac:picMkLst>
            <pc:docMk/>
            <pc:sldMk cId="500895388" sldId="387"/>
            <ac:picMk id="35" creationId="{3AADA615-2C7D-4049-9F67-79DE2EA3F73E}"/>
          </ac:picMkLst>
        </pc:picChg>
        <pc:picChg chg="mod">
          <ac:chgData name="Warner,Jeffrey Barr" userId="7360d018-3b8a-4d6d-8136-e4d170e1e616" providerId="ADAL" clId="{693FE2FC-F0F6-44A8-ADE1-47761A581875}" dt="2021-10-05T15:19:40.225" v="0" actId="164"/>
          <ac:picMkLst>
            <pc:docMk/>
            <pc:sldMk cId="500895388" sldId="387"/>
            <ac:picMk id="37" creationId="{599F067C-687A-437F-BAA7-BC472C98C2C8}"/>
          </ac:picMkLst>
        </pc:picChg>
        <pc:cxnChg chg="mod">
          <ac:chgData name="Warner,Jeffrey Barr" userId="7360d018-3b8a-4d6d-8136-e4d170e1e616" providerId="ADAL" clId="{693FE2FC-F0F6-44A8-ADE1-47761A581875}" dt="2021-10-05T15:19:40.225" v="0" actId="164"/>
          <ac:cxnSpMkLst>
            <pc:docMk/>
            <pc:sldMk cId="500895388" sldId="387"/>
            <ac:cxnSpMk id="6" creationId="{395B6ED9-7DA4-4366-A837-AFE63DC12B40}"/>
          </ac:cxnSpMkLst>
        </pc:cxnChg>
        <pc:cxnChg chg="mod">
          <ac:chgData name="Warner,Jeffrey Barr" userId="7360d018-3b8a-4d6d-8136-e4d170e1e616" providerId="ADAL" clId="{693FE2FC-F0F6-44A8-ADE1-47761A581875}" dt="2021-10-05T15:19:40.225" v="0" actId="164"/>
          <ac:cxnSpMkLst>
            <pc:docMk/>
            <pc:sldMk cId="500895388" sldId="387"/>
            <ac:cxnSpMk id="9" creationId="{6A15EC55-02EE-4D9F-B9DA-6DD97C91BFEF}"/>
          </ac:cxnSpMkLst>
        </pc:cxnChg>
        <pc:cxnChg chg="mod">
          <ac:chgData name="Warner,Jeffrey Barr" userId="7360d018-3b8a-4d6d-8136-e4d170e1e616" providerId="ADAL" clId="{693FE2FC-F0F6-44A8-ADE1-47761A581875}" dt="2021-10-05T15:19:40.225" v="0" actId="164"/>
          <ac:cxnSpMkLst>
            <pc:docMk/>
            <pc:sldMk cId="500895388" sldId="387"/>
            <ac:cxnSpMk id="10" creationId="{8D1B4E2B-7115-48A0-A29E-69633013A0F0}"/>
          </ac:cxnSpMkLst>
        </pc:cxnChg>
        <pc:cxnChg chg="mod">
          <ac:chgData name="Warner,Jeffrey Barr" userId="7360d018-3b8a-4d6d-8136-e4d170e1e616" providerId="ADAL" clId="{693FE2FC-F0F6-44A8-ADE1-47761A581875}" dt="2021-10-05T15:19:40.225" v="0" actId="164"/>
          <ac:cxnSpMkLst>
            <pc:docMk/>
            <pc:sldMk cId="500895388" sldId="387"/>
            <ac:cxnSpMk id="11" creationId="{6D02F568-6BA8-48B6-9BDB-EF0FF4B58354}"/>
          </ac:cxnSpMkLst>
        </pc:cxnChg>
        <pc:cxnChg chg="mod">
          <ac:chgData name="Warner,Jeffrey Barr" userId="7360d018-3b8a-4d6d-8136-e4d170e1e616" providerId="ADAL" clId="{693FE2FC-F0F6-44A8-ADE1-47761A581875}" dt="2021-10-05T15:19:40.225" v="0" actId="164"/>
          <ac:cxnSpMkLst>
            <pc:docMk/>
            <pc:sldMk cId="500895388" sldId="387"/>
            <ac:cxnSpMk id="12" creationId="{D76ED3C3-C5A1-49C6-9758-C471F1EE88CE}"/>
          </ac:cxnSpMkLst>
        </pc:cxnChg>
        <pc:cxnChg chg="mod">
          <ac:chgData name="Warner,Jeffrey Barr" userId="7360d018-3b8a-4d6d-8136-e4d170e1e616" providerId="ADAL" clId="{693FE2FC-F0F6-44A8-ADE1-47761A581875}" dt="2021-10-05T15:19:40.225" v="0" actId="164"/>
          <ac:cxnSpMkLst>
            <pc:docMk/>
            <pc:sldMk cId="500895388" sldId="387"/>
            <ac:cxnSpMk id="13" creationId="{338AE405-8908-4FE4-938F-84176CA9AD2F}"/>
          </ac:cxnSpMkLst>
        </pc:cxnChg>
        <pc:cxnChg chg="mod">
          <ac:chgData name="Warner,Jeffrey Barr" userId="7360d018-3b8a-4d6d-8136-e4d170e1e616" providerId="ADAL" clId="{693FE2FC-F0F6-44A8-ADE1-47761A581875}" dt="2021-10-05T15:19:40.225" v="0" actId="164"/>
          <ac:cxnSpMkLst>
            <pc:docMk/>
            <pc:sldMk cId="500895388" sldId="387"/>
            <ac:cxnSpMk id="14" creationId="{E97228CE-B501-4E46-A4A8-2F7A3471A60A}"/>
          </ac:cxnSpMkLst>
        </pc:cxnChg>
        <pc:cxnChg chg="mod">
          <ac:chgData name="Warner,Jeffrey Barr" userId="7360d018-3b8a-4d6d-8136-e4d170e1e616" providerId="ADAL" clId="{693FE2FC-F0F6-44A8-ADE1-47761A581875}" dt="2021-10-05T15:19:40.225" v="0" actId="164"/>
          <ac:cxnSpMkLst>
            <pc:docMk/>
            <pc:sldMk cId="500895388" sldId="387"/>
            <ac:cxnSpMk id="15" creationId="{59CFF1C0-658A-4E1E-9ADF-CD9DFEB43E63}"/>
          </ac:cxnSpMkLst>
        </pc:cxnChg>
        <pc:cxnChg chg="mod">
          <ac:chgData name="Warner,Jeffrey Barr" userId="7360d018-3b8a-4d6d-8136-e4d170e1e616" providerId="ADAL" clId="{693FE2FC-F0F6-44A8-ADE1-47761A581875}" dt="2021-10-05T15:19:40.225" v="0" actId="164"/>
          <ac:cxnSpMkLst>
            <pc:docMk/>
            <pc:sldMk cId="500895388" sldId="387"/>
            <ac:cxnSpMk id="16" creationId="{76CC09E9-D02C-425F-9337-E04D702F9BD8}"/>
          </ac:cxnSpMkLst>
        </pc:cxnChg>
        <pc:cxnChg chg="mod">
          <ac:chgData name="Warner,Jeffrey Barr" userId="7360d018-3b8a-4d6d-8136-e4d170e1e616" providerId="ADAL" clId="{693FE2FC-F0F6-44A8-ADE1-47761A581875}" dt="2021-10-05T15:19:40.225" v="0" actId="164"/>
          <ac:cxnSpMkLst>
            <pc:docMk/>
            <pc:sldMk cId="500895388" sldId="387"/>
            <ac:cxnSpMk id="17" creationId="{142140F6-BF1E-4EBC-B9FA-3767EC13EF89}"/>
          </ac:cxnSpMkLst>
        </pc:cxnChg>
        <pc:cxnChg chg="mod">
          <ac:chgData name="Warner,Jeffrey Barr" userId="7360d018-3b8a-4d6d-8136-e4d170e1e616" providerId="ADAL" clId="{693FE2FC-F0F6-44A8-ADE1-47761A581875}" dt="2021-10-05T15:19:40.225" v="0" actId="164"/>
          <ac:cxnSpMkLst>
            <pc:docMk/>
            <pc:sldMk cId="500895388" sldId="387"/>
            <ac:cxnSpMk id="18" creationId="{0A30C435-3102-4ACB-9467-62CC473C044C}"/>
          </ac:cxnSpMkLst>
        </pc:cxnChg>
        <pc:cxnChg chg="mod">
          <ac:chgData name="Warner,Jeffrey Barr" userId="7360d018-3b8a-4d6d-8136-e4d170e1e616" providerId="ADAL" clId="{693FE2FC-F0F6-44A8-ADE1-47761A581875}" dt="2021-10-05T15:19:40.225" v="0" actId="164"/>
          <ac:cxnSpMkLst>
            <pc:docMk/>
            <pc:sldMk cId="500895388" sldId="387"/>
            <ac:cxnSpMk id="19" creationId="{F2120FD0-7445-4A91-AF59-51049EF867E9}"/>
          </ac:cxnSpMkLst>
        </pc:cxnChg>
        <pc:cxnChg chg="mod">
          <ac:chgData name="Warner,Jeffrey Barr" userId="7360d018-3b8a-4d6d-8136-e4d170e1e616" providerId="ADAL" clId="{693FE2FC-F0F6-44A8-ADE1-47761A581875}" dt="2021-10-05T15:19:40.225" v="0" actId="164"/>
          <ac:cxnSpMkLst>
            <pc:docMk/>
            <pc:sldMk cId="500895388" sldId="387"/>
            <ac:cxnSpMk id="21" creationId="{84DE7BA6-7013-4D40-8932-DA76D745E644}"/>
          </ac:cxnSpMkLst>
        </pc:cxnChg>
        <pc:cxnChg chg="mod">
          <ac:chgData name="Warner,Jeffrey Barr" userId="7360d018-3b8a-4d6d-8136-e4d170e1e616" providerId="ADAL" clId="{693FE2FC-F0F6-44A8-ADE1-47761A581875}" dt="2021-10-05T15:19:40.225" v="0" actId="164"/>
          <ac:cxnSpMkLst>
            <pc:docMk/>
            <pc:sldMk cId="500895388" sldId="387"/>
            <ac:cxnSpMk id="22" creationId="{9797CBF6-F506-45AA-AC2A-A4F663FCE1AC}"/>
          </ac:cxnSpMkLst>
        </pc:cxnChg>
        <pc:cxnChg chg="mod">
          <ac:chgData name="Warner,Jeffrey Barr" userId="7360d018-3b8a-4d6d-8136-e4d170e1e616" providerId="ADAL" clId="{693FE2FC-F0F6-44A8-ADE1-47761A581875}" dt="2021-10-05T15:19:40.225" v="0" actId="164"/>
          <ac:cxnSpMkLst>
            <pc:docMk/>
            <pc:sldMk cId="500895388" sldId="387"/>
            <ac:cxnSpMk id="24" creationId="{A3B27491-29AE-432D-8B99-600155DA71E1}"/>
          </ac:cxnSpMkLst>
        </pc:cxnChg>
        <pc:cxnChg chg="mod">
          <ac:chgData name="Warner,Jeffrey Barr" userId="7360d018-3b8a-4d6d-8136-e4d170e1e616" providerId="ADAL" clId="{693FE2FC-F0F6-44A8-ADE1-47761A581875}" dt="2021-10-05T15:19:40.225" v="0" actId="164"/>
          <ac:cxnSpMkLst>
            <pc:docMk/>
            <pc:sldMk cId="500895388" sldId="387"/>
            <ac:cxnSpMk id="25" creationId="{6C0259AF-6B97-49EE-8B7B-442B3295D1EC}"/>
          </ac:cxnSpMkLst>
        </pc:cxnChg>
        <pc:cxnChg chg="mod">
          <ac:chgData name="Warner,Jeffrey Barr" userId="7360d018-3b8a-4d6d-8136-e4d170e1e616" providerId="ADAL" clId="{693FE2FC-F0F6-44A8-ADE1-47761A581875}" dt="2021-10-05T15:19:40.225" v="0" actId="164"/>
          <ac:cxnSpMkLst>
            <pc:docMk/>
            <pc:sldMk cId="500895388" sldId="387"/>
            <ac:cxnSpMk id="28" creationId="{F35E8952-6D2A-4DA5-A4E5-CE310699DACF}"/>
          </ac:cxnSpMkLst>
        </pc:cxnChg>
        <pc:cxnChg chg="mod">
          <ac:chgData name="Warner,Jeffrey Barr" userId="7360d018-3b8a-4d6d-8136-e4d170e1e616" providerId="ADAL" clId="{693FE2FC-F0F6-44A8-ADE1-47761A581875}" dt="2021-10-05T15:19:40.225" v="0" actId="164"/>
          <ac:cxnSpMkLst>
            <pc:docMk/>
            <pc:sldMk cId="500895388" sldId="387"/>
            <ac:cxnSpMk id="29" creationId="{EA493C78-98D4-436E-B212-B750682CCB18}"/>
          </ac:cxnSpMkLst>
        </pc:cxnChg>
        <pc:cxnChg chg="mod">
          <ac:chgData name="Warner,Jeffrey Barr" userId="7360d018-3b8a-4d6d-8136-e4d170e1e616" providerId="ADAL" clId="{693FE2FC-F0F6-44A8-ADE1-47761A581875}" dt="2021-10-05T15:19:40.225" v="0" actId="164"/>
          <ac:cxnSpMkLst>
            <pc:docMk/>
            <pc:sldMk cId="500895388" sldId="387"/>
            <ac:cxnSpMk id="30" creationId="{64B2CAE6-25FF-4CB1-B8AE-E3F5ADCA59E3}"/>
          </ac:cxnSpMkLst>
        </pc:cxnChg>
        <pc:cxnChg chg="mod">
          <ac:chgData name="Warner,Jeffrey Barr" userId="7360d018-3b8a-4d6d-8136-e4d170e1e616" providerId="ADAL" clId="{693FE2FC-F0F6-44A8-ADE1-47761A581875}" dt="2021-10-05T15:19:40.225" v="0" actId="164"/>
          <ac:cxnSpMkLst>
            <pc:docMk/>
            <pc:sldMk cId="500895388" sldId="387"/>
            <ac:cxnSpMk id="31" creationId="{F7EF77F0-ED27-4C8E-BCA8-CB9228C555BE}"/>
          </ac:cxnSpMkLst>
        </pc:cxnChg>
      </pc:sldChg>
      <pc:sldChg chg="modSp add mod">
        <pc:chgData name="Warner,Jeffrey Barr" userId="7360d018-3b8a-4d6d-8136-e4d170e1e616" providerId="ADAL" clId="{693FE2FC-F0F6-44A8-ADE1-47761A581875}" dt="2021-10-06T20:16:12.546" v="75" actId="12788"/>
        <pc:sldMkLst>
          <pc:docMk/>
          <pc:sldMk cId="3719077622" sldId="389"/>
        </pc:sldMkLst>
        <pc:spChg chg="mod">
          <ac:chgData name="Warner,Jeffrey Barr" userId="7360d018-3b8a-4d6d-8136-e4d170e1e616" providerId="ADAL" clId="{693FE2FC-F0F6-44A8-ADE1-47761A581875}" dt="2021-10-06T20:16:07.173" v="73" actId="12788"/>
          <ac:spMkLst>
            <pc:docMk/>
            <pc:sldMk cId="3719077622" sldId="389"/>
            <ac:spMk id="10" creationId="{769D35D3-9431-4C91-9BC4-051B93ABC7AD}"/>
          </ac:spMkLst>
        </pc:spChg>
        <pc:spChg chg="mod">
          <ac:chgData name="Warner,Jeffrey Barr" userId="7360d018-3b8a-4d6d-8136-e4d170e1e616" providerId="ADAL" clId="{693FE2FC-F0F6-44A8-ADE1-47761A581875}" dt="2021-10-06T20:16:10.510" v="74" actId="12788"/>
          <ac:spMkLst>
            <pc:docMk/>
            <pc:sldMk cId="3719077622" sldId="389"/>
            <ac:spMk id="11" creationId="{464F6F2E-F016-42EA-8069-E8C19FFCFE46}"/>
          </ac:spMkLst>
        </pc:spChg>
        <pc:spChg chg="mod">
          <ac:chgData name="Warner,Jeffrey Barr" userId="7360d018-3b8a-4d6d-8136-e4d170e1e616" providerId="ADAL" clId="{693FE2FC-F0F6-44A8-ADE1-47761A581875}" dt="2021-10-06T20:16:12.546" v="75" actId="12788"/>
          <ac:spMkLst>
            <pc:docMk/>
            <pc:sldMk cId="3719077622" sldId="389"/>
            <ac:spMk id="12" creationId="{53D2622A-68CC-4624-95F0-6200F063020B}"/>
          </ac:spMkLst>
        </pc:spChg>
        <pc:spChg chg="mod">
          <ac:chgData name="Warner,Jeffrey Barr" userId="7360d018-3b8a-4d6d-8136-e4d170e1e616" providerId="ADAL" clId="{693FE2FC-F0F6-44A8-ADE1-47761A581875}" dt="2021-10-06T20:15:55.080" v="49" actId="1038"/>
          <ac:spMkLst>
            <pc:docMk/>
            <pc:sldMk cId="3719077622" sldId="389"/>
            <ac:spMk id="13" creationId="{419CA558-8D2F-4529-B459-497BC5A490A1}"/>
          </ac:spMkLst>
        </pc:spChg>
        <pc:spChg chg="mod">
          <ac:chgData name="Warner,Jeffrey Barr" userId="7360d018-3b8a-4d6d-8136-e4d170e1e616" providerId="ADAL" clId="{693FE2FC-F0F6-44A8-ADE1-47761A581875}" dt="2021-10-06T20:16:07.173" v="73" actId="12788"/>
          <ac:spMkLst>
            <pc:docMk/>
            <pc:sldMk cId="3719077622" sldId="389"/>
            <ac:spMk id="14" creationId="{102A5AA5-7643-4EF9-9778-E6A4F61D4868}"/>
          </ac:spMkLst>
        </pc:spChg>
        <pc:spChg chg="mod">
          <ac:chgData name="Warner,Jeffrey Barr" userId="7360d018-3b8a-4d6d-8136-e4d170e1e616" providerId="ADAL" clId="{693FE2FC-F0F6-44A8-ADE1-47761A581875}" dt="2021-10-06T20:16:10.510" v="74" actId="12788"/>
          <ac:spMkLst>
            <pc:docMk/>
            <pc:sldMk cId="3719077622" sldId="389"/>
            <ac:spMk id="15" creationId="{F370090F-7C32-4DF7-9684-91587FC4DD4D}"/>
          </ac:spMkLst>
        </pc:spChg>
        <pc:spChg chg="mod">
          <ac:chgData name="Warner,Jeffrey Barr" userId="7360d018-3b8a-4d6d-8136-e4d170e1e616" providerId="ADAL" clId="{693FE2FC-F0F6-44A8-ADE1-47761A581875}" dt="2021-10-06T20:16:12.546" v="75" actId="12788"/>
          <ac:spMkLst>
            <pc:docMk/>
            <pc:sldMk cId="3719077622" sldId="389"/>
            <ac:spMk id="16" creationId="{D91C37EB-EAE9-431E-97F5-FA7B8263556D}"/>
          </ac:spMkLst>
        </pc:spChg>
        <pc:graphicFrameChg chg="mod">
          <ac:chgData name="Warner,Jeffrey Barr" userId="7360d018-3b8a-4d6d-8136-e4d170e1e616" providerId="ADAL" clId="{693FE2FC-F0F6-44A8-ADE1-47761A581875}" dt="2021-10-06T20:15:25.155" v="5"/>
          <ac:graphicFrameMkLst>
            <pc:docMk/>
            <pc:sldMk cId="3719077622" sldId="389"/>
            <ac:graphicFrameMk id="3" creationId="{0C9BD14C-B8F5-486E-AE0C-616CEA8325E0}"/>
          </ac:graphicFrameMkLst>
        </pc:graphicFrameChg>
      </pc:sldChg>
    </pc:docChg>
  </pc:docChgLst>
  <pc:docChgLst>
    <pc:chgData name="Warner,Jeffrey Barr" userId="7360d018-3b8a-4d6d-8136-e4d170e1e616" providerId="ADAL" clId="{D4807F30-5863-4A06-8EED-66FA02898782}"/>
    <pc:docChg chg="undo custSel addSld delSld modSld">
      <pc:chgData name="Warner,Jeffrey Barr" userId="7360d018-3b8a-4d6d-8136-e4d170e1e616" providerId="ADAL" clId="{D4807F30-5863-4A06-8EED-66FA02898782}" dt="2021-12-16T23:03:35.107" v="69" actId="20577"/>
      <pc:docMkLst>
        <pc:docMk/>
      </pc:docMkLst>
      <pc:sldChg chg="del">
        <pc:chgData name="Warner,Jeffrey Barr" userId="7360d018-3b8a-4d6d-8136-e4d170e1e616" providerId="ADAL" clId="{D4807F30-5863-4A06-8EED-66FA02898782}" dt="2021-12-16T23:02:34.806" v="2" actId="47"/>
        <pc:sldMkLst>
          <pc:docMk/>
          <pc:sldMk cId="53146747" sldId="357"/>
        </pc:sldMkLst>
      </pc:sldChg>
      <pc:sldChg chg="addSp delSp modSp add mod">
        <pc:chgData name="Warner,Jeffrey Barr" userId="7360d018-3b8a-4d6d-8136-e4d170e1e616" providerId="ADAL" clId="{D4807F30-5863-4A06-8EED-66FA02898782}" dt="2021-12-16T23:03:35.107" v="69" actId="20577"/>
        <pc:sldMkLst>
          <pc:docMk/>
          <pc:sldMk cId="3301582166" sldId="389"/>
        </pc:sldMkLst>
        <pc:spChg chg="del">
          <ac:chgData name="Warner,Jeffrey Barr" userId="7360d018-3b8a-4d6d-8136-e4d170e1e616" providerId="ADAL" clId="{D4807F30-5863-4A06-8EED-66FA02898782}" dt="2021-12-16T23:02:39.176" v="3" actId="478"/>
          <ac:spMkLst>
            <pc:docMk/>
            <pc:sldMk cId="3301582166" sldId="389"/>
            <ac:spMk id="5" creationId="{68142842-A8D1-45F2-B118-10F5A96DD0BB}"/>
          </ac:spMkLst>
        </pc:spChg>
        <pc:spChg chg="add mod">
          <ac:chgData name="Warner,Jeffrey Barr" userId="7360d018-3b8a-4d6d-8136-e4d170e1e616" providerId="ADAL" clId="{D4807F30-5863-4A06-8EED-66FA02898782}" dt="2021-12-16T23:03:35.107" v="69" actId="20577"/>
          <ac:spMkLst>
            <pc:docMk/>
            <pc:sldMk cId="3301582166" sldId="389"/>
            <ac:spMk id="9" creationId="{C825B065-D584-4760-8696-2CCA32F71010}"/>
          </ac:spMkLst>
        </pc:spChg>
      </pc:sldChg>
    </pc:docChg>
  </pc:docChgLst>
  <pc:docChgLst>
    <pc:chgData name="Warner,Jeffrey Barr" userId="7360d018-3b8a-4d6d-8136-e4d170e1e616" providerId="ADAL" clId="{DB90B78A-78E0-4DA3-AE8A-B837C5EF1D5E}"/>
    <pc:docChg chg="undo custSel modSld">
      <pc:chgData name="Warner,Jeffrey Barr" userId="7360d018-3b8a-4d6d-8136-e4d170e1e616" providerId="ADAL" clId="{DB90B78A-78E0-4DA3-AE8A-B837C5EF1D5E}" dt="2021-05-12T14:04:09.584" v="5139"/>
      <pc:docMkLst>
        <pc:docMk/>
      </pc:docMkLst>
      <pc:sldChg chg="addSp delSp modSp mod">
        <pc:chgData name="Warner,Jeffrey Barr" userId="7360d018-3b8a-4d6d-8136-e4d170e1e616" providerId="ADAL" clId="{DB90B78A-78E0-4DA3-AE8A-B837C5EF1D5E}" dt="2021-05-12T13:52:12.052" v="5045"/>
        <pc:sldMkLst>
          <pc:docMk/>
          <pc:sldMk cId="3815654910" sldId="259"/>
        </pc:sldMkLst>
        <pc:spChg chg="mod topLvl">
          <ac:chgData name="Warner,Jeffrey Barr" userId="7360d018-3b8a-4d6d-8136-e4d170e1e616" providerId="ADAL" clId="{DB90B78A-78E0-4DA3-AE8A-B837C5EF1D5E}" dt="2021-04-22T14:22:44.880" v="1100" actId="164"/>
          <ac:spMkLst>
            <pc:docMk/>
            <pc:sldMk cId="3815654910" sldId="259"/>
            <ac:spMk id="13" creationId="{BDD7A1D5-319B-AC47-857C-5B73EDBF043A}"/>
          </ac:spMkLst>
        </pc:spChg>
        <pc:spChg chg="mod topLvl">
          <ac:chgData name="Warner,Jeffrey Barr" userId="7360d018-3b8a-4d6d-8136-e4d170e1e616" providerId="ADAL" clId="{DB90B78A-78E0-4DA3-AE8A-B837C5EF1D5E}" dt="2021-04-22T14:22:44.880" v="1100" actId="164"/>
          <ac:spMkLst>
            <pc:docMk/>
            <pc:sldMk cId="3815654910" sldId="259"/>
            <ac:spMk id="14" creationId="{C22E5819-A4F3-9F42-BEF3-FB33CAA48410}"/>
          </ac:spMkLst>
        </pc:spChg>
        <pc:spChg chg="mod topLvl">
          <ac:chgData name="Warner,Jeffrey Barr" userId="7360d018-3b8a-4d6d-8136-e4d170e1e616" providerId="ADAL" clId="{DB90B78A-78E0-4DA3-AE8A-B837C5EF1D5E}" dt="2021-04-22T14:25:24.280" v="1800" actId="1036"/>
          <ac:spMkLst>
            <pc:docMk/>
            <pc:sldMk cId="3815654910" sldId="259"/>
            <ac:spMk id="15" creationId="{ED350E54-6677-7849-BEAE-23AB35701C14}"/>
          </ac:spMkLst>
        </pc:spChg>
        <pc:spChg chg="mod topLvl">
          <ac:chgData name="Warner,Jeffrey Barr" userId="7360d018-3b8a-4d6d-8136-e4d170e1e616" providerId="ADAL" clId="{DB90B78A-78E0-4DA3-AE8A-B837C5EF1D5E}" dt="2021-04-22T14:25:24.280" v="1800" actId="1036"/>
          <ac:spMkLst>
            <pc:docMk/>
            <pc:sldMk cId="3815654910" sldId="259"/>
            <ac:spMk id="16" creationId="{7A89FB48-89A8-A143-9C4A-2A8E7C67BC35}"/>
          </ac:spMkLst>
        </pc:spChg>
        <pc:spChg chg="mod topLvl">
          <ac:chgData name="Warner,Jeffrey Barr" userId="7360d018-3b8a-4d6d-8136-e4d170e1e616" providerId="ADAL" clId="{DB90B78A-78E0-4DA3-AE8A-B837C5EF1D5E}" dt="2021-04-22T14:25:24.280" v="1800" actId="1036"/>
          <ac:spMkLst>
            <pc:docMk/>
            <pc:sldMk cId="3815654910" sldId="259"/>
            <ac:spMk id="17" creationId="{31B3A69F-4C3F-414C-A7FD-B900FDFA6233}"/>
          </ac:spMkLst>
        </pc:spChg>
        <pc:spChg chg="mod topLvl">
          <ac:chgData name="Warner,Jeffrey Barr" userId="7360d018-3b8a-4d6d-8136-e4d170e1e616" providerId="ADAL" clId="{DB90B78A-78E0-4DA3-AE8A-B837C5EF1D5E}" dt="2021-04-22T14:25:44.557" v="1818" actId="1038"/>
          <ac:spMkLst>
            <pc:docMk/>
            <pc:sldMk cId="3815654910" sldId="259"/>
            <ac:spMk id="18" creationId="{5879D3F2-0BFB-1A4C-85AF-252A1AF2ACB6}"/>
          </ac:spMkLst>
        </pc:spChg>
        <pc:spChg chg="mod topLvl">
          <ac:chgData name="Warner,Jeffrey Barr" userId="7360d018-3b8a-4d6d-8136-e4d170e1e616" providerId="ADAL" clId="{DB90B78A-78E0-4DA3-AE8A-B837C5EF1D5E}" dt="2021-04-22T14:22:46.928" v="1101" actId="164"/>
          <ac:spMkLst>
            <pc:docMk/>
            <pc:sldMk cId="3815654910" sldId="259"/>
            <ac:spMk id="33" creationId="{2E70191B-24CA-E14D-8A99-2F0F92292247}"/>
          </ac:spMkLst>
        </pc:spChg>
        <pc:spChg chg="mod topLvl">
          <ac:chgData name="Warner,Jeffrey Barr" userId="7360d018-3b8a-4d6d-8136-e4d170e1e616" providerId="ADAL" clId="{DB90B78A-78E0-4DA3-AE8A-B837C5EF1D5E}" dt="2021-04-22T14:22:46.928" v="1101" actId="164"/>
          <ac:spMkLst>
            <pc:docMk/>
            <pc:sldMk cId="3815654910" sldId="259"/>
            <ac:spMk id="34" creationId="{D6AB7928-B93E-B641-B782-69D67DE55D7C}"/>
          </ac:spMkLst>
        </pc:spChg>
        <pc:spChg chg="mod topLvl">
          <ac:chgData name="Warner,Jeffrey Barr" userId="7360d018-3b8a-4d6d-8136-e4d170e1e616" providerId="ADAL" clId="{DB90B78A-78E0-4DA3-AE8A-B837C5EF1D5E}" dt="2021-04-22T14:25:44.557" v="1818" actId="1038"/>
          <ac:spMkLst>
            <pc:docMk/>
            <pc:sldMk cId="3815654910" sldId="259"/>
            <ac:spMk id="37" creationId="{FD5EBD31-A174-634E-B256-18AFD873E5CA}"/>
          </ac:spMkLst>
        </pc:spChg>
        <pc:spChg chg="mod topLvl">
          <ac:chgData name="Warner,Jeffrey Barr" userId="7360d018-3b8a-4d6d-8136-e4d170e1e616" providerId="ADAL" clId="{DB90B78A-78E0-4DA3-AE8A-B837C5EF1D5E}" dt="2021-04-22T14:24:21.335" v="1711" actId="1036"/>
          <ac:spMkLst>
            <pc:docMk/>
            <pc:sldMk cId="3815654910" sldId="259"/>
            <ac:spMk id="38" creationId="{7BA4FAF3-CD45-4362-82B1-E2E97E9FADD1}"/>
          </ac:spMkLst>
        </pc:spChg>
        <pc:spChg chg="del mod topLvl">
          <ac:chgData name="Warner,Jeffrey Barr" userId="7360d018-3b8a-4d6d-8136-e4d170e1e616" providerId="ADAL" clId="{DB90B78A-78E0-4DA3-AE8A-B837C5EF1D5E}" dt="2021-04-22T14:24:01.991" v="1676" actId="478"/>
          <ac:spMkLst>
            <pc:docMk/>
            <pc:sldMk cId="3815654910" sldId="259"/>
            <ac:spMk id="39" creationId="{5A49378D-6604-4463-A370-9A36C5C50929}"/>
          </ac:spMkLst>
        </pc:spChg>
        <pc:spChg chg="mod topLvl">
          <ac:chgData name="Warner,Jeffrey Barr" userId="7360d018-3b8a-4d6d-8136-e4d170e1e616" providerId="ADAL" clId="{DB90B78A-78E0-4DA3-AE8A-B837C5EF1D5E}" dt="2021-04-22T14:24:23.544" v="1713" actId="1036"/>
          <ac:spMkLst>
            <pc:docMk/>
            <pc:sldMk cId="3815654910" sldId="259"/>
            <ac:spMk id="41" creationId="{8D431A23-8B43-4024-AA6A-2449506A1EC0}"/>
          </ac:spMkLst>
        </pc:spChg>
        <pc:spChg chg="del mod topLvl">
          <ac:chgData name="Warner,Jeffrey Barr" userId="7360d018-3b8a-4d6d-8136-e4d170e1e616" providerId="ADAL" clId="{DB90B78A-78E0-4DA3-AE8A-B837C5EF1D5E}" dt="2021-04-22T14:24:01.991" v="1676" actId="478"/>
          <ac:spMkLst>
            <pc:docMk/>
            <pc:sldMk cId="3815654910" sldId="259"/>
            <ac:spMk id="42" creationId="{495286BD-BACA-4489-A4DF-94162871784C}"/>
          </ac:spMkLst>
        </pc:spChg>
        <pc:spChg chg="mod topLvl">
          <ac:chgData name="Warner,Jeffrey Barr" userId="7360d018-3b8a-4d6d-8136-e4d170e1e616" providerId="ADAL" clId="{DB90B78A-78E0-4DA3-AE8A-B837C5EF1D5E}" dt="2021-04-22T14:25:44.557" v="1818" actId="1038"/>
          <ac:spMkLst>
            <pc:docMk/>
            <pc:sldMk cId="3815654910" sldId="259"/>
            <ac:spMk id="48" creationId="{74EA99B9-3233-C840-8634-E6E5DF5A0759}"/>
          </ac:spMkLst>
        </pc:spChg>
        <pc:spChg chg="del mod topLvl">
          <ac:chgData name="Warner,Jeffrey Barr" userId="7360d018-3b8a-4d6d-8136-e4d170e1e616" providerId="ADAL" clId="{DB90B78A-78E0-4DA3-AE8A-B837C5EF1D5E}" dt="2021-04-22T14:24:01.991" v="1676" actId="478"/>
          <ac:spMkLst>
            <pc:docMk/>
            <pc:sldMk cId="3815654910" sldId="259"/>
            <ac:spMk id="50" creationId="{FD39659A-0712-194B-B009-05F29EE3723E}"/>
          </ac:spMkLst>
        </pc:spChg>
        <pc:spChg chg="mod topLvl">
          <ac:chgData name="Warner,Jeffrey Barr" userId="7360d018-3b8a-4d6d-8136-e4d170e1e616" providerId="ADAL" clId="{DB90B78A-78E0-4DA3-AE8A-B837C5EF1D5E}" dt="2021-04-22T14:22:52.329" v="1102" actId="164"/>
          <ac:spMkLst>
            <pc:docMk/>
            <pc:sldMk cId="3815654910" sldId="259"/>
            <ac:spMk id="53" creationId="{20A9299F-0979-D24D-938E-D9C6CA0A2D67}"/>
          </ac:spMkLst>
        </pc:spChg>
        <pc:spChg chg="mod topLvl">
          <ac:chgData name="Warner,Jeffrey Barr" userId="7360d018-3b8a-4d6d-8136-e4d170e1e616" providerId="ADAL" clId="{DB90B78A-78E0-4DA3-AE8A-B837C5EF1D5E}" dt="2021-04-22T14:22:52.329" v="1102" actId="164"/>
          <ac:spMkLst>
            <pc:docMk/>
            <pc:sldMk cId="3815654910" sldId="259"/>
            <ac:spMk id="54" creationId="{9BE8C3BC-D3C5-FC41-A674-052183AD20F8}"/>
          </ac:spMkLst>
        </pc:spChg>
        <pc:spChg chg="mod topLvl">
          <ac:chgData name="Warner,Jeffrey Barr" userId="7360d018-3b8a-4d6d-8136-e4d170e1e616" providerId="ADAL" clId="{DB90B78A-78E0-4DA3-AE8A-B837C5EF1D5E}" dt="2021-05-12T13:29:12.259" v="4919" actId="207"/>
          <ac:spMkLst>
            <pc:docMk/>
            <pc:sldMk cId="3815654910" sldId="259"/>
            <ac:spMk id="60" creationId="{6DAD1B17-9FEA-0B43-B3B4-2E8611FF3FAA}"/>
          </ac:spMkLst>
        </pc:spChg>
        <pc:spChg chg="mod">
          <ac:chgData name="Warner,Jeffrey Barr" userId="7360d018-3b8a-4d6d-8136-e4d170e1e616" providerId="ADAL" clId="{DB90B78A-78E0-4DA3-AE8A-B837C5EF1D5E}" dt="2021-04-22T14:25:08.905" v="1790" actId="1035"/>
          <ac:spMkLst>
            <pc:docMk/>
            <pc:sldMk cId="3815654910" sldId="259"/>
            <ac:spMk id="61" creationId="{82ADA693-A8D9-8246-97DD-D744CAC4ADB8}"/>
          </ac:spMkLst>
        </pc:spChg>
        <pc:spChg chg="mod topLvl">
          <ac:chgData name="Warner,Jeffrey Barr" userId="7360d018-3b8a-4d6d-8136-e4d170e1e616" providerId="ADAL" clId="{DB90B78A-78E0-4DA3-AE8A-B837C5EF1D5E}" dt="2021-04-22T14:24:18.088" v="1697" actId="1035"/>
          <ac:spMkLst>
            <pc:docMk/>
            <pc:sldMk cId="3815654910" sldId="259"/>
            <ac:spMk id="62" creationId="{B6417B22-27DE-274C-92BD-FB621E5951DC}"/>
          </ac:spMkLst>
        </pc:spChg>
        <pc:spChg chg="mod topLvl">
          <ac:chgData name="Warner,Jeffrey Barr" userId="7360d018-3b8a-4d6d-8136-e4d170e1e616" providerId="ADAL" clId="{DB90B78A-78E0-4DA3-AE8A-B837C5EF1D5E}" dt="2021-04-22T14:25:40.633" v="1808" actId="1037"/>
          <ac:spMkLst>
            <pc:docMk/>
            <pc:sldMk cId="3815654910" sldId="259"/>
            <ac:spMk id="63" creationId="{56CAF7B9-692D-7144-96AF-00B0BBE567CC}"/>
          </ac:spMkLst>
        </pc:spChg>
        <pc:grpChg chg="add mod">
          <ac:chgData name="Warner,Jeffrey Barr" userId="7360d018-3b8a-4d6d-8136-e4d170e1e616" providerId="ADAL" clId="{DB90B78A-78E0-4DA3-AE8A-B837C5EF1D5E}" dt="2021-04-22T14:22:44.880" v="1100" actId="164"/>
          <ac:grpSpMkLst>
            <pc:docMk/>
            <pc:sldMk cId="3815654910" sldId="259"/>
            <ac:grpSpMk id="2" creationId="{1DBFAC85-9881-42D0-9396-17363D5ABE56}"/>
          </ac:grpSpMkLst>
        </pc:grpChg>
        <pc:grpChg chg="del mod topLvl">
          <ac:chgData name="Warner,Jeffrey Barr" userId="7360d018-3b8a-4d6d-8136-e4d170e1e616" providerId="ADAL" clId="{DB90B78A-78E0-4DA3-AE8A-B837C5EF1D5E}" dt="2021-04-22T14:22:40.041" v="1097" actId="165"/>
          <ac:grpSpMkLst>
            <pc:docMk/>
            <pc:sldMk cId="3815654910" sldId="259"/>
            <ac:grpSpMk id="3" creationId="{F4EFF5C3-289F-B54E-9D71-A2474A57BE5C}"/>
          </ac:grpSpMkLst>
        </pc:grpChg>
        <pc:grpChg chg="del">
          <ac:chgData name="Warner,Jeffrey Barr" userId="7360d018-3b8a-4d6d-8136-e4d170e1e616" providerId="ADAL" clId="{DB90B78A-78E0-4DA3-AE8A-B837C5EF1D5E}" dt="2021-04-22T14:22:22.176" v="1094" actId="165"/>
          <ac:grpSpMkLst>
            <pc:docMk/>
            <pc:sldMk cId="3815654910" sldId="259"/>
            <ac:grpSpMk id="9" creationId="{28B8A3AF-A983-804F-86D1-3AD1BDF20CD9}"/>
          </ac:grpSpMkLst>
        </pc:grpChg>
        <pc:grpChg chg="mod topLvl">
          <ac:chgData name="Warner,Jeffrey Barr" userId="7360d018-3b8a-4d6d-8136-e4d170e1e616" providerId="ADAL" clId="{DB90B78A-78E0-4DA3-AE8A-B837C5EF1D5E}" dt="2021-04-22T14:22:44.880" v="1100" actId="164"/>
          <ac:grpSpMkLst>
            <pc:docMk/>
            <pc:sldMk cId="3815654910" sldId="259"/>
            <ac:grpSpMk id="12" creationId="{1821DA3E-A0F3-2449-8713-BA9FED79E28A}"/>
          </ac:grpSpMkLst>
        </pc:grpChg>
        <pc:grpChg chg="add mod">
          <ac:chgData name="Warner,Jeffrey Barr" userId="7360d018-3b8a-4d6d-8136-e4d170e1e616" providerId="ADAL" clId="{DB90B78A-78E0-4DA3-AE8A-B837C5EF1D5E}" dt="2021-04-22T14:22:46.928" v="1101" actId="164"/>
          <ac:grpSpMkLst>
            <pc:docMk/>
            <pc:sldMk cId="3815654910" sldId="259"/>
            <ac:grpSpMk id="19" creationId="{3D5E7A80-2F40-4BFD-939F-E75C94018F0B}"/>
          </ac:grpSpMkLst>
        </pc:grpChg>
        <pc:grpChg chg="add mod">
          <ac:chgData name="Warner,Jeffrey Barr" userId="7360d018-3b8a-4d6d-8136-e4d170e1e616" providerId="ADAL" clId="{DB90B78A-78E0-4DA3-AE8A-B837C5EF1D5E}" dt="2021-04-22T14:23:26.112" v="1325" actId="1037"/>
          <ac:grpSpMkLst>
            <pc:docMk/>
            <pc:sldMk cId="3815654910" sldId="259"/>
            <ac:grpSpMk id="20" creationId="{2F0DC15B-31BD-4627-A928-E9FE5F6E7981}"/>
          </ac:grpSpMkLst>
        </pc:grpChg>
        <pc:grpChg chg="del mod topLvl">
          <ac:chgData name="Warner,Jeffrey Barr" userId="7360d018-3b8a-4d6d-8136-e4d170e1e616" providerId="ADAL" clId="{DB90B78A-78E0-4DA3-AE8A-B837C5EF1D5E}" dt="2021-04-22T14:22:40.288" v="1098" actId="165"/>
          <ac:grpSpMkLst>
            <pc:docMk/>
            <pc:sldMk cId="3815654910" sldId="259"/>
            <ac:grpSpMk id="30" creationId="{25A668A3-1378-354A-A634-4CDD79B3C6A3}"/>
          </ac:grpSpMkLst>
        </pc:grpChg>
        <pc:grpChg chg="del mod topLvl">
          <ac:chgData name="Warner,Jeffrey Barr" userId="7360d018-3b8a-4d6d-8136-e4d170e1e616" providerId="ADAL" clId="{DB90B78A-78E0-4DA3-AE8A-B837C5EF1D5E}" dt="2021-04-22T14:22:40.288" v="1098" actId="165"/>
          <ac:grpSpMkLst>
            <pc:docMk/>
            <pc:sldMk cId="3815654910" sldId="259"/>
            <ac:grpSpMk id="31" creationId="{66A61500-3C77-8B4E-AB67-98CD4CCDE1BB}"/>
          </ac:grpSpMkLst>
        </pc:grpChg>
        <pc:grpChg chg="mod topLvl">
          <ac:chgData name="Warner,Jeffrey Barr" userId="7360d018-3b8a-4d6d-8136-e4d170e1e616" providerId="ADAL" clId="{DB90B78A-78E0-4DA3-AE8A-B837C5EF1D5E}" dt="2021-04-22T14:22:46.928" v="1101" actId="164"/>
          <ac:grpSpMkLst>
            <pc:docMk/>
            <pc:sldMk cId="3815654910" sldId="259"/>
            <ac:grpSpMk id="32" creationId="{A929A274-EF66-4E4B-95B1-302F7233B5A8}"/>
          </ac:grpSpMkLst>
        </pc:grpChg>
        <pc:grpChg chg="del mod topLvl">
          <ac:chgData name="Warner,Jeffrey Barr" userId="7360d018-3b8a-4d6d-8136-e4d170e1e616" providerId="ADAL" clId="{DB90B78A-78E0-4DA3-AE8A-B837C5EF1D5E}" dt="2021-04-22T14:22:40.288" v="1098" actId="165"/>
          <ac:grpSpMkLst>
            <pc:docMk/>
            <pc:sldMk cId="3815654910" sldId="259"/>
            <ac:grpSpMk id="51" creationId="{F2BF9876-5176-4E49-8D6C-60E5082261BF}"/>
          </ac:grpSpMkLst>
        </pc:grpChg>
        <pc:grpChg chg="del mod topLvl">
          <ac:chgData name="Warner,Jeffrey Barr" userId="7360d018-3b8a-4d6d-8136-e4d170e1e616" providerId="ADAL" clId="{DB90B78A-78E0-4DA3-AE8A-B837C5EF1D5E}" dt="2021-04-22T14:22:40.505" v="1099" actId="165"/>
          <ac:grpSpMkLst>
            <pc:docMk/>
            <pc:sldMk cId="3815654910" sldId="259"/>
            <ac:grpSpMk id="52" creationId="{2FF340DF-E23F-654F-BBAF-CABDF449BCA1}"/>
          </ac:grpSpMkLst>
        </pc:grpChg>
        <pc:graphicFrameChg chg="mod topLvl">
          <ac:chgData name="Warner,Jeffrey Barr" userId="7360d018-3b8a-4d6d-8136-e4d170e1e616" providerId="ADAL" clId="{DB90B78A-78E0-4DA3-AE8A-B837C5EF1D5E}" dt="2021-05-12T13:51:58.719" v="5041"/>
          <ac:graphicFrameMkLst>
            <pc:docMk/>
            <pc:sldMk cId="3815654910" sldId="259"/>
            <ac:graphicFrameMk id="4" creationId="{228CF895-0658-A047-9ED8-B4BF91FF9E9C}"/>
          </ac:graphicFrameMkLst>
        </pc:graphicFrameChg>
        <pc:graphicFrameChg chg="mod topLvl">
          <ac:chgData name="Warner,Jeffrey Barr" userId="7360d018-3b8a-4d6d-8136-e4d170e1e616" providerId="ADAL" clId="{DB90B78A-78E0-4DA3-AE8A-B837C5EF1D5E}" dt="2021-05-12T13:52:06.432" v="5043"/>
          <ac:graphicFrameMkLst>
            <pc:docMk/>
            <pc:sldMk cId="3815654910" sldId="259"/>
            <ac:graphicFrameMk id="5" creationId="{02742EB6-9F02-1E47-B8CF-0E67B2BDA7FE}"/>
          </ac:graphicFrameMkLst>
        </pc:graphicFrameChg>
        <pc:graphicFrameChg chg="mod topLvl">
          <ac:chgData name="Warner,Jeffrey Barr" userId="7360d018-3b8a-4d6d-8136-e4d170e1e616" providerId="ADAL" clId="{DB90B78A-78E0-4DA3-AE8A-B837C5EF1D5E}" dt="2021-05-12T13:52:12.052" v="5045"/>
          <ac:graphicFrameMkLst>
            <pc:docMk/>
            <pc:sldMk cId="3815654910" sldId="259"/>
            <ac:graphicFrameMk id="47" creationId="{501B4390-F038-B643-8E3B-9F6F8C548934}"/>
          </ac:graphicFrameMkLst>
        </pc:graphicFrameChg>
        <pc:picChg chg="mod topLvl">
          <ac:chgData name="Warner,Jeffrey Barr" userId="7360d018-3b8a-4d6d-8136-e4d170e1e616" providerId="ADAL" clId="{DB90B78A-78E0-4DA3-AE8A-B837C5EF1D5E}" dt="2021-04-22T14:22:40.041" v="1097" actId="165"/>
          <ac:picMkLst>
            <pc:docMk/>
            <pc:sldMk cId="3815654910" sldId="259"/>
            <ac:picMk id="6" creationId="{CA8399B9-7B21-8347-8A54-F7EC890C98D5}"/>
          </ac:picMkLst>
        </pc:picChg>
        <pc:picChg chg="mod topLvl">
          <ac:chgData name="Warner,Jeffrey Barr" userId="7360d018-3b8a-4d6d-8136-e4d170e1e616" providerId="ADAL" clId="{DB90B78A-78E0-4DA3-AE8A-B837C5EF1D5E}" dt="2021-04-22T14:22:40.041" v="1097" actId="165"/>
          <ac:picMkLst>
            <pc:docMk/>
            <pc:sldMk cId="3815654910" sldId="259"/>
            <ac:picMk id="7" creationId="{9C7B7D67-69AB-854A-BB49-A56DE7A7E3D4}"/>
          </ac:picMkLst>
        </pc:picChg>
        <pc:picChg chg="mod topLvl">
          <ac:chgData name="Warner,Jeffrey Barr" userId="7360d018-3b8a-4d6d-8136-e4d170e1e616" providerId="ADAL" clId="{DB90B78A-78E0-4DA3-AE8A-B837C5EF1D5E}" dt="2021-04-22T14:22:40.041" v="1097" actId="165"/>
          <ac:picMkLst>
            <pc:docMk/>
            <pc:sldMk cId="3815654910" sldId="259"/>
            <ac:picMk id="8" creationId="{F0FE3857-FCAB-1A4F-BB7D-F45FA0BC0EA5}"/>
          </ac:picMkLst>
        </pc:picChg>
        <pc:picChg chg="mod topLvl">
          <ac:chgData name="Warner,Jeffrey Barr" userId="7360d018-3b8a-4d6d-8136-e4d170e1e616" providerId="ADAL" clId="{DB90B78A-78E0-4DA3-AE8A-B837C5EF1D5E}" dt="2021-04-22T14:22:40.041" v="1097" actId="165"/>
          <ac:picMkLst>
            <pc:docMk/>
            <pc:sldMk cId="3815654910" sldId="259"/>
            <ac:picMk id="23" creationId="{C4F8A680-81CE-B04B-B6FA-74D16318A9BF}"/>
          </ac:picMkLst>
        </pc:picChg>
        <pc:picChg chg="mod topLvl">
          <ac:chgData name="Warner,Jeffrey Barr" userId="7360d018-3b8a-4d6d-8136-e4d170e1e616" providerId="ADAL" clId="{DB90B78A-78E0-4DA3-AE8A-B837C5EF1D5E}" dt="2021-04-22T14:23:40.216" v="1461" actId="1038"/>
          <ac:picMkLst>
            <pc:docMk/>
            <pc:sldMk cId="3815654910" sldId="259"/>
            <ac:picMk id="27" creationId="{531059A6-CA47-F345-8298-41477228FC79}"/>
          </ac:picMkLst>
        </pc:picChg>
        <pc:picChg chg="mod topLvl">
          <ac:chgData name="Warner,Jeffrey Barr" userId="7360d018-3b8a-4d6d-8136-e4d170e1e616" providerId="ADAL" clId="{DB90B78A-78E0-4DA3-AE8A-B837C5EF1D5E}" dt="2021-04-22T14:23:46.480" v="1531" actId="1038"/>
          <ac:picMkLst>
            <pc:docMk/>
            <pc:sldMk cId="3815654910" sldId="259"/>
            <ac:picMk id="29" creationId="{065A9AE1-480D-A641-9DB6-EEFAF214525A}"/>
          </ac:picMkLst>
        </pc:picChg>
        <pc:picChg chg="mod topLvl modCrop">
          <ac:chgData name="Warner,Jeffrey Barr" userId="7360d018-3b8a-4d6d-8136-e4d170e1e616" providerId="ADAL" clId="{DB90B78A-78E0-4DA3-AE8A-B837C5EF1D5E}" dt="2021-04-22T14:24:51.447" v="1774" actId="732"/>
          <ac:picMkLst>
            <pc:docMk/>
            <pc:sldMk cId="3815654910" sldId="259"/>
            <ac:picMk id="57" creationId="{30EA0DBE-91E8-C44D-A2A4-EAB275DEF1DC}"/>
          </ac:picMkLst>
        </pc:picChg>
        <pc:picChg chg="mod topLvl">
          <ac:chgData name="Warner,Jeffrey Barr" userId="7360d018-3b8a-4d6d-8136-e4d170e1e616" providerId="ADAL" clId="{DB90B78A-78E0-4DA3-AE8A-B837C5EF1D5E}" dt="2021-04-22T14:25:28.040" v="1801" actId="1036"/>
          <ac:picMkLst>
            <pc:docMk/>
            <pc:sldMk cId="3815654910" sldId="259"/>
            <ac:picMk id="58" creationId="{DCDB4A7D-678E-0F49-8B85-6FA9A8591CD7}"/>
          </ac:picMkLst>
        </pc:picChg>
        <pc:picChg chg="mod topLvl">
          <ac:chgData name="Warner,Jeffrey Barr" userId="7360d018-3b8a-4d6d-8136-e4d170e1e616" providerId="ADAL" clId="{DB90B78A-78E0-4DA3-AE8A-B837C5EF1D5E}" dt="2021-04-22T14:23:45.417" v="1529" actId="1036"/>
          <ac:picMkLst>
            <pc:docMk/>
            <pc:sldMk cId="3815654910" sldId="259"/>
            <ac:picMk id="59" creationId="{07AB1396-C191-B44C-A30F-89A107105244}"/>
          </ac:picMkLst>
        </pc:picChg>
        <pc:cxnChg chg="mod">
          <ac:chgData name="Warner,Jeffrey Barr" userId="7360d018-3b8a-4d6d-8136-e4d170e1e616" providerId="ADAL" clId="{DB90B78A-78E0-4DA3-AE8A-B837C5EF1D5E}" dt="2021-04-22T14:22:40.288" v="1098" actId="165"/>
          <ac:cxnSpMkLst>
            <pc:docMk/>
            <pc:sldMk cId="3815654910" sldId="259"/>
            <ac:cxnSpMk id="10" creationId="{271F5F80-A652-C54D-A282-95E5172A2605}"/>
          </ac:cxnSpMkLst>
        </pc:cxnChg>
        <pc:cxnChg chg="mod">
          <ac:chgData name="Warner,Jeffrey Barr" userId="7360d018-3b8a-4d6d-8136-e4d170e1e616" providerId="ADAL" clId="{DB90B78A-78E0-4DA3-AE8A-B837C5EF1D5E}" dt="2021-04-22T14:22:40.288" v="1098" actId="165"/>
          <ac:cxnSpMkLst>
            <pc:docMk/>
            <pc:sldMk cId="3815654910" sldId="259"/>
            <ac:cxnSpMk id="11" creationId="{EF9C9FAD-0A71-044A-9B89-10F9382B97D4}"/>
          </ac:cxnSpMkLst>
        </pc:cxnChg>
        <pc:cxnChg chg="mod">
          <ac:chgData name="Warner,Jeffrey Barr" userId="7360d018-3b8a-4d6d-8136-e4d170e1e616" providerId="ADAL" clId="{DB90B78A-78E0-4DA3-AE8A-B837C5EF1D5E}" dt="2021-04-22T14:22:40.288" v="1098" actId="165"/>
          <ac:cxnSpMkLst>
            <pc:docMk/>
            <pc:sldMk cId="3815654910" sldId="259"/>
            <ac:cxnSpMk id="35" creationId="{C9128A05-2A6E-0747-82C8-E95F52427A48}"/>
          </ac:cxnSpMkLst>
        </pc:cxnChg>
        <pc:cxnChg chg="mod">
          <ac:chgData name="Warner,Jeffrey Barr" userId="7360d018-3b8a-4d6d-8136-e4d170e1e616" providerId="ADAL" clId="{DB90B78A-78E0-4DA3-AE8A-B837C5EF1D5E}" dt="2021-04-22T14:22:40.288" v="1098" actId="165"/>
          <ac:cxnSpMkLst>
            <pc:docMk/>
            <pc:sldMk cId="3815654910" sldId="259"/>
            <ac:cxnSpMk id="36" creationId="{C4C955C3-EF93-E849-AB9D-74A1CE5C8592}"/>
          </ac:cxnSpMkLst>
        </pc:cxnChg>
        <pc:cxnChg chg="mod topLvl">
          <ac:chgData name="Warner,Jeffrey Barr" userId="7360d018-3b8a-4d6d-8136-e4d170e1e616" providerId="ADAL" clId="{DB90B78A-78E0-4DA3-AE8A-B837C5EF1D5E}" dt="2021-04-22T14:22:52.329" v="1102" actId="164"/>
          <ac:cxnSpMkLst>
            <pc:docMk/>
            <pc:sldMk cId="3815654910" sldId="259"/>
            <ac:cxnSpMk id="55" creationId="{111A4D04-FBDA-3046-9A39-D7DE40DC779C}"/>
          </ac:cxnSpMkLst>
        </pc:cxnChg>
        <pc:cxnChg chg="mod topLvl">
          <ac:chgData name="Warner,Jeffrey Barr" userId="7360d018-3b8a-4d6d-8136-e4d170e1e616" providerId="ADAL" clId="{DB90B78A-78E0-4DA3-AE8A-B837C5EF1D5E}" dt="2021-04-22T14:22:52.329" v="1102" actId="164"/>
          <ac:cxnSpMkLst>
            <pc:docMk/>
            <pc:sldMk cId="3815654910" sldId="259"/>
            <ac:cxnSpMk id="56" creationId="{990BB11B-507A-704D-AF7D-317748576450}"/>
          </ac:cxnSpMkLst>
        </pc:cxnChg>
      </pc:sldChg>
      <pc:sldChg chg="modSp mod addCm modCm modNotesTx">
        <pc:chgData name="Warner,Jeffrey Barr" userId="7360d018-3b8a-4d6d-8136-e4d170e1e616" providerId="ADAL" clId="{DB90B78A-78E0-4DA3-AE8A-B837C5EF1D5E}" dt="2021-05-12T13:54:41.487" v="5078"/>
        <pc:sldMkLst>
          <pc:docMk/>
          <pc:sldMk cId="1676406075" sldId="264"/>
        </pc:sldMkLst>
        <pc:spChg chg="mod">
          <ac:chgData name="Warner,Jeffrey Barr" userId="7360d018-3b8a-4d6d-8136-e4d170e1e616" providerId="ADAL" clId="{DB90B78A-78E0-4DA3-AE8A-B837C5EF1D5E}" dt="2021-04-22T14:55:15.799" v="4382" actId="552"/>
          <ac:spMkLst>
            <pc:docMk/>
            <pc:sldMk cId="1676406075" sldId="264"/>
            <ac:spMk id="4" creationId="{6CE1CE08-652B-4B7D-B206-C5ED4D590728}"/>
          </ac:spMkLst>
        </pc:spChg>
        <pc:spChg chg="mod">
          <ac:chgData name="Warner,Jeffrey Barr" userId="7360d018-3b8a-4d6d-8136-e4d170e1e616" providerId="ADAL" clId="{DB90B78A-78E0-4DA3-AE8A-B837C5EF1D5E}" dt="2021-05-12T13:25:24.826" v="4878" actId="207"/>
          <ac:spMkLst>
            <pc:docMk/>
            <pc:sldMk cId="1676406075" sldId="264"/>
            <ac:spMk id="42" creationId="{E369D0D2-9E3D-4130-A13B-F3029ADF6DAD}"/>
          </ac:spMkLst>
        </pc:spChg>
        <pc:grpChg chg="mod">
          <ac:chgData name="Warner,Jeffrey Barr" userId="7360d018-3b8a-4d6d-8136-e4d170e1e616" providerId="ADAL" clId="{DB90B78A-78E0-4DA3-AE8A-B837C5EF1D5E}" dt="2021-05-09T22:04:51.422" v="4796" actId="1076"/>
          <ac:grpSpMkLst>
            <pc:docMk/>
            <pc:sldMk cId="1676406075" sldId="264"/>
            <ac:grpSpMk id="9" creationId="{C6776A6C-9407-477E-90C9-8A0BFDAFBEB3}"/>
          </ac:grpSpMkLst>
        </pc:grpChg>
        <pc:graphicFrameChg chg="mod">
          <ac:chgData name="Warner,Jeffrey Barr" userId="7360d018-3b8a-4d6d-8136-e4d170e1e616" providerId="ADAL" clId="{DB90B78A-78E0-4DA3-AE8A-B837C5EF1D5E}" dt="2021-05-12T13:54:28.248" v="5074"/>
          <ac:graphicFrameMkLst>
            <pc:docMk/>
            <pc:sldMk cId="1676406075" sldId="264"/>
            <ac:graphicFrameMk id="14" creationId="{8048C2FF-230B-4B41-89D8-142C4B115A2A}"/>
          </ac:graphicFrameMkLst>
        </pc:graphicFrameChg>
        <pc:graphicFrameChg chg="mod">
          <ac:chgData name="Warner,Jeffrey Barr" userId="7360d018-3b8a-4d6d-8136-e4d170e1e616" providerId="ADAL" clId="{DB90B78A-78E0-4DA3-AE8A-B837C5EF1D5E}" dt="2021-05-12T13:54:35.190" v="5076"/>
          <ac:graphicFrameMkLst>
            <pc:docMk/>
            <pc:sldMk cId="1676406075" sldId="264"/>
            <ac:graphicFrameMk id="19" creationId="{7A4DB3C0-1D5F-4DFC-A09B-5AB96B482DF4}"/>
          </ac:graphicFrameMkLst>
        </pc:graphicFrameChg>
        <pc:graphicFrameChg chg="mod">
          <ac:chgData name="Warner,Jeffrey Barr" userId="7360d018-3b8a-4d6d-8136-e4d170e1e616" providerId="ADAL" clId="{DB90B78A-78E0-4DA3-AE8A-B837C5EF1D5E}" dt="2021-05-12T13:54:41.487" v="5078"/>
          <ac:graphicFrameMkLst>
            <pc:docMk/>
            <pc:sldMk cId="1676406075" sldId="264"/>
            <ac:graphicFrameMk id="66" creationId="{0CFAA7AB-533D-4D41-BF56-149CBCDBA37A}"/>
          </ac:graphicFrameMkLst>
        </pc:graphicFrameChg>
        <pc:graphicFrameChg chg="mod">
          <ac:chgData name="Warner,Jeffrey Barr" userId="7360d018-3b8a-4d6d-8136-e4d170e1e616" providerId="ADAL" clId="{DB90B78A-78E0-4DA3-AE8A-B837C5EF1D5E}" dt="2021-05-12T13:54:20.152" v="5072"/>
          <ac:graphicFrameMkLst>
            <pc:docMk/>
            <pc:sldMk cId="1676406075" sldId="264"/>
            <ac:graphicFrameMk id="85" creationId="{0B2014FC-B360-4155-9057-F1975B5CEC61}"/>
          </ac:graphicFrameMkLst>
        </pc:graphicFrameChg>
        <pc:cxnChg chg="mod">
          <ac:chgData name="Warner,Jeffrey Barr" userId="7360d018-3b8a-4d6d-8136-e4d170e1e616" providerId="ADAL" clId="{DB90B78A-78E0-4DA3-AE8A-B837C5EF1D5E}" dt="2021-05-09T22:04:54.780" v="4797" actId="1076"/>
          <ac:cxnSpMkLst>
            <pc:docMk/>
            <pc:sldMk cId="1676406075" sldId="264"/>
            <ac:cxnSpMk id="62" creationId="{00000000-0000-0000-0000-000000000000}"/>
          </ac:cxnSpMkLst>
        </pc:cxnChg>
        <pc:cxnChg chg="mod">
          <ac:chgData name="Warner,Jeffrey Barr" userId="7360d018-3b8a-4d6d-8136-e4d170e1e616" providerId="ADAL" clId="{DB90B78A-78E0-4DA3-AE8A-B837C5EF1D5E}" dt="2021-05-09T22:04:48.208" v="4793" actId="1076"/>
          <ac:cxnSpMkLst>
            <pc:docMk/>
            <pc:sldMk cId="1676406075" sldId="264"/>
            <ac:cxnSpMk id="64" creationId="{763621A0-C5FA-4E6E-BFC2-D9CFF2A7D894}"/>
          </ac:cxnSpMkLst>
        </pc:cxnChg>
        <pc:cxnChg chg="mod">
          <ac:chgData name="Warner,Jeffrey Barr" userId="7360d018-3b8a-4d6d-8136-e4d170e1e616" providerId="ADAL" clId="{DB90B78A-78E0-4DA3-AE8A-B837C5EF1D5E}" dt="2021-05-09T22:04:49.581" v="4794" actId="1076"/>
          <ac:cxnSpMkLst>
            <pc:docMk/>
            <pc:sldMk cId="1676406075" sldId="264"/>
            <ac:cxnSpMk id="65" creationId="{1B2E4BF1-7833-47B6-A21B-1B7E6237FD82}"/>
          </ac:cxnSpMkLst>
        </pc:cxnChg>
      </pc:sldChg>
      <pc:sldChg chg="addSp delSp modSp mod">
        <pc:chgData name="Warner,Jeffrey Barr" userId="7360d018-3b8a-4d6d-8136-e4d170e1e616" providerId="ADAL" clId="{DB90B78A-78E0-4DA3-AE8A-B837C5EF1D5E}" dt="2021-04-23T14:04:04.703" v="4754" actId="1076"/>
        <pc:sldMkLst>
          <pc:docMk/>
          <pc:sldMk cId="3319412604" sldId="269"/>
        </pc:sldMkLst>
        <pc:spChg chg="mod topLvl">
          <ac:chgData name="Warner,Jeffrey Barr" userId="7360d018-3b8a-4d6d-8136-e4d170e1e616" providerId="ADAL" clId="{DB90B78A-78E0-4DA3-AE8A-B837C5EF1D5E}" dt="2021-04-23T14:00:30.639" v="4401" actId="165"/>
          <ac:spMkLst>
            <pc:docMk/>
            <pc:sldMk cId="3319412604" sldId="269"/>
            <ac:spMk id="5" creationId="{00000000-0000-0000-0000-000000000000}"/>
          </ac:spMkLst>
        </pc:spChg>
        <pc:spChg chg="mod topLvl">
          <ac:chgData name="Warner,Jeffrey Barr" userId="7360d018-3b8a-4d6d-8136-e4d170e1e616" providerId="ADAL" clId="{DB90B78A-78E0-4DA3-AE8A-B837C5EF1D5E}" dt="2021-04-23T14:00:30.639" v="4401" actId="165"/>
          <ac:spMkLst>
            <pc:docMk/>
            <pc:sldMk cId="3319412604" sldId="269"/>
            <ac:spMk id="12" creationId="{00000000-0000-0000-0000-000000000000}"/>
          </ac:spMkLst>
        </pc:spChg>
        <pc:spChg chg="mod topLvl">
          <ac:chgData name="Warner,Jeffrey Barr" userId="7360d018-3b8a-4d6d-8136-e4d170e1e616" providerId="ADAL" clId="{DB90B78A-78E0-4DA3-AE8A-B837C5EF1D5E}" dt="2021-04-23T14:02:14.318" v="4432" actId="1038"/>
          <ac:spMkLst>
            <pc:docMk/>
            <pc:sldMk cId="3319412604" sldId="269"/>
            <ac:spMk id="15" creationId="{00000000-0000-0000-0000-000000000000}"/>
          </ac:spMkLst>
        </pc:spChg>
        <pc:spChg chg="mod topLvl">
          <ac:chgData name="Warner,Jeffrey Barr" userId="7360d018-3b8a-4d6d-8136-e4d170e1e616" providerId="ADAL" clId="{DB90B78A-78E0-4DA3-AE8A-B837C5EF1D5E}" dt="2021-04-23T14:02:14.318" v="4432" actId="1038"/>
          <ac:spMkLst>
            <pc:docMk/>
            <pc:sldMk cId="3319412604" sldId="269"/>
            <ac:spMk id="16" creationId="{00000000-0000-0000-0000-000000000000}"/>
          </ac:spMkLst>
        </pc:spChg>
        <pc:spChg chg="mod topLvl">
          <ac:chgData name="Warner,Jeffrey Barr" userId="7360d018-3b8a-4d6d-8136-e4d170e1e616" providerId="ADAL" clId="{DB90B78A-78E0-4DA3-AE8A-B837C5EF1D5E}" dt="2021-04-23T14:02:14.318" v="4432" actId="1038"/>
          <ac:spMkLst>
            <pc:docMk/>
            <pc:sldMk cId="3319412604" sldId="269"/>
            <ac:spMk id="17" creationId="{00000000-0000-0000-0000-000000000000}"/>
          </ac:spMkLst>
        </pc:spChg>
        <pc:spChg chg="mod topLvl">
          <ac:chgData name="Warner,Jeffrey Barr" userId="7360d018-3b8a-4d6d-8136-e4d170e1e616" providerId="ADAL" clId="{DB90B78A-78E0-4DA3-AE8A-B837C5EF1D5E}" dt="2021-04-23T14:02:21.828" v="4458" actId="1036"/>
          <ac:spMkLst>
            <pc:docMk/>
            <pc:sldMk cId="3319412604" sldId="269"/>
            <ac:spMk id="18" creationId="{00000000-0000-0000-0000-000000000000}"/>
          </ac:spMkLst>
        </pc:spChg>
        <pc:spChg chg="mod topLvl">
          <ac:chgData name="Warner,Jeffrey Barr" userId="7360d018-3b8a-4d6d-8136-e4d170e1e616" providerId="ADAL" clId="{DB90B78A-78E0-4DA3-AE8A-B837C5EF1D5E}" dt="2021-04-23T14:02:25.079" v="4470" actId="1035"/>
          <ac:spMkLst>
            <pc:docMk/>
            <pc:sldMk cId="3319412604" sldId="269"/>
            <ac:spMk id="23" creationId="{00000000-0000-0000-0000-000000000000}"/>
          </ac:spMkLst>
        </pc:spChg>
        <pc:spChg chg="mod topLvl">
          <ac:chgData name="Warner,Jeffrey Barr" userId="7360d018-3b8a-4d6d-8136-e4d170e1e616" providerId="ADAL" clId="{DB90B78A-78E0-4DA3-AE8A-B837C5EF1D5E}" dt="2021-04-23T14:03:12.549" v="4629" actId="1038"/>
          <ac:spMkLst>
            <pc:docMk/>
            <pc:sldMk cId="3319412604" sldId="269"/>
            <ac:spMk id="28" creationId="{00000000-0000-0000-0000-000000000000}"/>
          </ac:spMkLst>
        </pc:spChg>
        <pc:spChg chg="mod topLvl">
          <ac:chgData name="Warner,Jeffrey Barr" userId="7360d018-3b8a-4d6d-8136-e4d170e1e616" providerId="ADAL" clId="{DB90B78A-78E0-4DA3-AE8A-B837C5EF1D5E}" dt="2021-04-23T14:03:49.229" v="4753" actId="1037"/>
          <ac:spMkLst>
            <pc:docMk/>
            <pc:sldMk cId="3319412604" sldId="269"/>
            <ac:spMk id="30" creationId="{00000000-0000-0000-0000-000000000000}"/>
          </ac:spMkLst>
        </pc:spChg>
        <pc:spChg chg="mod">
          <ac:chgData name="Warner,Jeffrey Barr" userId="7360d018-3b8a-4d6d-8136-e4d170e1e616" providerId="ADAL" clId="{DB90B78A-78E0-4DA3-AE8A-B837C5EF1D5E}" dt="2021-04-23T14:00:30.639" v="4401" actId="165"/>
          <ac:spMkLst>
            <pc:docMk/>
            <pc:sldMk cId="3319412604" sldId="269"/>
            <ac:spMk id="34" creationId="{BDD7A1D5-319B-AC47-857C-5B73EDBF043A}"/>
          </ac:spMkLst>
        </pc:spChg>
        <pc:spChg chg="mod">
          <ac:chgData name="Warner,Jeffrey Barr" userId="7360d018-3b8a-4d6d-8136-e4d170e1e616" providerId="ADAL" clId="{DB90B78A-78E0-4DA3-AE8A-B837C5EF1D5E}" dt="2021-04-23T14:00:30.639" v="4401" actId="165"/>
          <ac:spMkLst>
            <pc:docMk/>
            <pc:sldMk cId="3319412604" sldId="269"/>
            <ac:spMk id="35" creationId="{C22E5819-A4F3-9F42-BEF3-FB33CAA48410}"/>
          </ac:spMkLst>
        </pc:spChg>
        <pc:spChg chg="mod">
          <ac:chgData name="Warner,Jeffrey Barr" userId="7360d018-3b8a-4d6d-8136-e4d170e1e616" providerId="ADAL" clId="{DB90B78A-78E0-4DA3-AE8A-B837C5EF1D5E}" dt="2021-04-23T14:00:30.639" v="4401" actId="165"/>
          <ac:spMkLst>
            <pc:docMk/>
            <pc:sldMk cId="3319412604" sldId="269"/>
            <ac:spMk id="37" creationId="{00000000-0000-0000-0000-000000000000}"/>
          </ac:spMkLst>
        </pc:spChg>
        <pc:spChg chg="mod">
          <ac:chgData name="Warner,Jeffrey Barr" userId="7360d018-3b8a-4d6d-8136-e4d170e1e616" providerId="ADAL" clId="{DB90B78A-78E0-4DA3-AE8A-B837C5EF1D5E}" dt="2021-04-23T14:00:30.639" v="4401" actId="165"/>
          <ac:spMkLst>
            <pc:docMk/>
            <pc:sldMk cId="3319412604" sldId="269"/>
            <ac:spMk id="38" creationId="{00000000-0000-0000-0000-000000000000}"/>
          </ac:spMkLst>
        </pc:spChg>
        <pc:spChg chg="mod">
          <ac:chgData name="Warner,Jeffrey Barr" userId="7360d018-3b8a-4d6d-8136-e4d170e1e616" providerId="ADAL" clId="{DB90B78A-78E0-4DA3-AE8A-B837C5EF1D5E}" dt="2021-04-23T14:00:30.639" v="4401" actId="165"/>
          <ac:spMkLst>
            <pc:docMk/>
            <pc:sldMk cId="3319412604" sldId="269"/>
            <ac:spMk id="42" creationId="{BDD7A1D5-319B-AC47-857C-5B73EDBF043A}"/>
          </ac:spMkLst>
        </pc:spChg>
        <pc:spChg chg="mod">
          <ac:chgData name="Warner,Jeffrey Barr" userId="7360d018-3b8a-4d6d-8136-e4d170e1e616" providerId="ADAL" clId="{DB90B78A-78E0-4DA3-AE8A-B837C5EF1D5E}" dt="2021-04-23T14:00:30.639" v="4401" actId="165"/>
          <ac:spMkLst>
            <pc:docMk/>
            <pc:sldMk cId="3319412604" sldId="269"/>
            <ac:spMk id="43" creationId="{C22E5819-A4F3-9F42-BEF3-FB33CAA48410}"/>
          </ac:spMkLst>
        </pc:spChg>
        <pc:spChg chg="mod">
          <ac:chgData name="Warner,Jeffrey Barr" userId="7360d018-3b8a-4d6d-8136-e4d170e1e616" providerId="ADAL" clId="{DB90B78A-78E0-4DA3-AE8A-B837C5EF1D5E}" dt="2021-04-23T14:00:30.639" v="4401" actId="165"/>
          <ac:spMkLst>
            <pc:docMk/>
            <pc:sldMk cId="3319412604" sldId="269"/>
            <ac:spMk id="45" creationId="{00000000-0000-0000-0000-000000000000}"/>
          </ac:spMkLst>
        </pc:spChg>
        <pc:spChg chg="mod">
          <ac:chgData name="Warner,Jeffrey Barr" userId="7360d018-3b8a-4d6d-8136-e4d170e1e616" providerId="ADAL" clId="{DB90B78A-78E0-4DA3-AE8A-B837C5EF1D5E}" dt="2021-04-23T14:00:30.639" v="4401" actId="165"/>
          <ac:spMkLst>
            <pc:docMk/>
            <pc:sldMk cId="3319412604" sldId="269"/>
            <ac:spMk id="49" creationId="{BDD7A1D5-319B-AC47-857C-5B73EDBF043A}"/>
          </ac:spMkLst>
        </pc:spChg>
        <pc:spChg chg="mod">
          <ac:chgData name="Warner,Jeffrey Barr" userId="7360d018-3b8a-4d6d-8136-e4d170e1e616" providerId="ADAL" clId="{DB90B78A-78E0-4DA3-AE8A-B837C5EF1D5E}" dt="2021-04-23T14:00:30.639" v="4401" actId="165"/>
          <ac:spMkLst>
            <pc:docMk/>
            <pc:sldMk cId="3319412604" sldId="269"/>
            <ac:spMk id="50" creationId="{C22E5819-A4F3-9F42-BEF3-FB33CAA48410}"/>
          </ac:spMkLst>
        </pc:spChg>
        <pc:spChg chg="mod">
          <ac:chgData name="Warner,Jeffrey Barr" userId="7360d018-3b8a-4d6d-8136-e4d170e1e616" providerId="ADAL" clId="{DB90B78A-78E0-4DA3-AE8A-B837C5EF1D5E}" dt="2021-04-23T14:00:30.639" v="4401" actId="165"/>
          <ac:spMkLst>
            <pc:docMk/>
            <pc:sldMk cId="3319412604" sldId="269"/>
            <ac:spMk id="54" creationId="{BDD7A1D5-319B-AC47-857C-5B73EDBF043A}"/>
          </ac:spMkLst>
        </pc:spChg>
        <pc:spChg chg="mod">
          <ac:chgData name="Warner,Jeffrey Barr" userId="7360d018-3b8a-4d6d-8136-e4d170e1e616" providerId="ADAL" clId="{DB90B78A-78E0-4DA3-AE8A-B837C5EF1D5E}" dt="2021-04-23T14:00:30.639" v="4401" actId="165"/>
          <ac:spMkLst>
            <pc:docMk/>
            <pc:sldMk cId="3319412604" sldId="269"/>
            <ac:spMk id="55" creationId="{C22E5819-A4F3-9F42-BEF3-FB33CAA48410}"/>
          </ac:spMkLst>
        </pc:spChg>
        <pc:spChg chg="mod">
          <ac:chgData name="Warner,Jeffrey Barr" userId="7360d018-3b8a-4d6d-8136-e4d170e1e616" providerId="ADAL" clId="{DB90B78A-78E0-4DA3-AE8A-B837C5EF1D5E}" dt="2021-04-23T14:00:30.639" v="4401" actId="165"/>
          <ac:spMkLst>
            <pc:docMk/>
            <pc:sldMk cId="3319412604" sldId="269"/>
            <ac:spMk id="57" creationId="{00000000-0000-0000-0000-000000000000}"/>
          </ac:spMkLst>
        </pc:spChg>
        <pc:spChg chg="mod">
          <ac:chgData name="Warner,Jeffrey Barr" userId="7360d018-3b8a-4d6d-8136-e4d170e1e616" providerId="ADAL" clId="{DB90B78A-78E0-4DA3-AE8A-B837C5EF1D5E}" dt="2021-04-23T14:00:30.639" v="4401" actId="165"/>
          <ac:spMkLst>
            <pc:docMk/>
            <pc:sldMk cId="3319412604" sldId="269"/>
            <ac:spMk id="58" creationId="{00000000-0000-0000-0000-000000000000}"/>
          </ac:spMkLst>
        </pc:spChg>
        <pc:spChg chg="mod">
          <ac:chgData name="Warner,Jeffrey Barr" userId="7360d018-3b8a-4d6d-8136-e4d170e1e616" providerId="ADAL" clId="{DB90B78A-78E0-4DA3-AE8A-B837C5EF1D5E}" dt="2021-04-23T14:00:30.639" v="4401" actId="165"/>
          <ac:spMkLst>
            <pc:docMk/>
            <pc:sldMk cId="3319412604" sldId="269"/>
            <ac:spMk id="60" creationId="{00000000-0000-0000-0000-000000000000}"/>
          </ac:spMkLst>
        </pc:spChg>
        <pc:spChg chg="mod">
          <ac:chgData name="Warner,Jeffrey Barr" userId="7360d018-3b8a-4d6d-8136-e4d170e1e616" providerId="ADAL" clId="{DB90B78A-78E0-4DA3-AE8A-B837C5EF1D5E}" dt="2021-04-23T14:00:30.639" v="4401" actId="165"/>
          <ac:spMkLst>
            <pc:docMk/>
            <pc:sldMk cId="3319412604" sldId="269"/>
            <ac:spMk id="61" creationId="{00000000-0000-0000-0000-000000000000}"/>
          </ac:spMkLst>
        </pc:spChg>
        <pc:grpChg chg="add del mod">
          <ac:chgData name="Warner,Jeffrey Barr" userId="7360d018-3b8a-4d6d-8136-e4d170e1e616" providerId="ADAL" clId="{DB90B78A-78E0-4DA3-AE8A-B837C5EF1D5E}" dt="2021-04-23T14:02:10.418" v="4422" actId="165"/>
          <ac:grpSpMkLst>
            <pc:docMk/>
            <pc:sldMk cId="3319412604" sldId="269"/>
            <ac:grpSpMk id="2" creationId="{B68BE263-C7D2-4561-A592-0CF5B6640657}"/>
          </ac:grpSpMkLst>
        </pc:grpChg>
        <pc:grpChg chg="del mod">
          <ac:chgData name="Warner,Jeffrey Barr" userId="7360d018-3b8a-4d6d-8136-e4d170e1e616" providerId="ADAL" clId="{DB90B78A-78E0-4DA3-AE8A-B837C5EF1D5E}" dt="2021-04-23T14:00:30.639" v="4401" actId="165"/>
          <ac:grpSpMkLst>
            <pc:docMk/>
            <pc:sldMk cId="3319412604" sldId="269"/>
            <ac:grpSpMk id="3" creationId="{00000000-0000-0000-0000-000000000000}"/>
          </ac:grpSpMkLst>
        </pc:grpChg>
        <pc:grpChg chg="mod topLvl">
          <ac:chgData name="Warner,Jeffrey Barr" userId="7360d018-3b8a-4d6d-8136-e4d170e1e616" providerId="ADAL" clId="{DB90B78A-78E0-4DA3-AE8A-B837C5EF1D5E}" dt="2021-04-23T14:00:30.639" v="4401" actId="165"/>
          <ac:grpSpMkLst>
            <pc:docMk/>
            <pc:sldMk cId="3319412604" sldId="269"/>
            <ac:grpSpMk id="8" creationId="{00000000-0000-0000-0000-000000000000}"/>
          </ac:grpSpMkLst>
        </pc:grpChg>
        <pc:grpChg chg="mod topLvl">
          <ac:chgData name="Warner,Jeffrey Barr" userId="7360d018-3b8a-4d6d-8136-e4d170e1e616" providerId="ADAL" clId="{DB90B78A-78E0-4DA3-AE8A-B837C5EF1D5E}" dt="2021-04-23T14:00:30.639" v="4401" actId="165"/>
          <ac:grpSpMkLst>
            <pc:docMk/>
            <pc:sldMk cId="3319412604" sldId="269"/>
            <ac:grpSpMk id="13" creationId="{00000000-0000-0000-0000-000000000000}"/>
          </ac:grpSpMkLst>
        </pc:grpChg>
        <pc:grpChg chg="mod topLvl">
          <ac:chgData name="Warner,Jeffrey Barr" userId="7360d018-3b8a-4d6d-8136-e4d170e1e616" providerId="ADAL" clId="{DB90B78A-78E0-4DA3-AE8A-B837C5EF1D5E}" dt="2021-04-23T14:00:30.639" v="4401" actId="165"/>
          <ac:grpSpMkLst>
            <pc:docMk/>
            <pc:sldMk cId="3319412604" sldId="269"/>
            <ac:grpSpMk id="19" creationId="{00000000-0000-0000-0000-000000000000}"/>
          </ac:grpSpMkLst>
        </pc:grpChg>
        <pc:grpChg chg="mod topLvl">
          <ac:chgData name="Warner,Jeffrey Barr" userId="7360d018-3b8a-4d6d-8136-e4d170e1e616" providerId="ADAL" clId="{DB90B78A-78E0-4DA3-AE8A-B837C5EF1D5E}" dt="2021-04-23T14:00:30.639" v="4401" actId="165"/>
          <ac:grpSpMkLst>
            <pc:docMk/>
            <pc:sldMk cId="3319412604" sldId="269"/>
            <ac:grpSpMk id="20" creationId="{00000000-0000-0000-0000-000000000000}"/>
          </ac:grpSpMkLst>
        </pc:grpChg>
        <pc:grpChg chg="mod topLvl">
          <ac:chgData name="Warner,Jeffrey Barr" userId="7360d018-3b8a-4d6d-8136-e4d170e1e616" providerId="ADAL" clId="{DB90B78A-78E0-4DA3-AE8A-B837C5EF1D5E}" dt="2021-04-23T14:03:12.549" v="4629" actId="1038"/>
          <ac:grpSpMkLst>
            <pc:docMk/>
            <pc:sldMk cId="3319412604" sldId="269"/>
            <ac:grpSpMk id="21" creationId="{00000000-0000-0000-0000-000000000000}"/>
          </ac:grpSpMkLst>
        </pc:grpChg>
        <pc:grpChg chg="mod topLvl">
          <ac:chgData name="Warner,Jeffrey Barr" userId="7360d018-3b8a-4d6d-8136-e4d170e1e616" providerId="ADAL" clId="{DB90B78A-78E0-4DA3-AE8A-B837C5EF1D5E}" dt="2021-04-23T14:03:49.229" v="4753" actId="1037"/>
          <ac:grpSpMkLst>
            <pc:docMk/>
            <pc:sldMk cId="3319412604" sldId="269"/>
            <ac:grpSpMk id="22" creationId="{00000000-0000-0000-0000-000000000000}"/>
          </ac:grpSpMkLst>
        </pc:grpChg>
        <pc:grpChg chg="mod">
          <ac:chgData name="Warner,Jeffrey Barr" userId="7360d018-3b8a-4d6d-8136-e4d170e1e616" providerId="ADAL" clId="{DB90B78A-78E0-4DA3-AE8A-B837C5EF1D5E}" dt="2021-04-23T14:00:30.639" v="4401" actId="165"/>
          <ac:grpSpMkLst>
            <pc:docMk/>
            <pc:sldMk cId="3319412604" sldId="269"/>
            <ac:grpSpMk id="31" creationId="{00000000-0000-0000-0000-000000000000}"/>
          </ac:grpSpMkLst>
        </pc:grpChg>
        <pc:grpChg chg="mod">
          <ac:chgData name="Warner,Jeffrey Barr" userId="7360d018-3b8a-4d6d-8136-e4d170e1e616" providerId="ADAL" clId="{DB90B78A-78E0-4DA3-AE8A-B837C5EF1D5E}" dt="2021-04-23T14:00:30.639" v="4401" actId="165"/>
          <ac:grpSpMkLst>
            <pc:docMk/>
            <pc:sldMk cId="3319412604" sldId="269"/>
            <ac:grpSpMk id="39" creationId="{00000000-0000-0000-0000-000000000000}"/>
          </ac:grpSpMkLst>
        </pc:grpChg>
        <pc:grpChg chg="mod">
          <ac:chgData name="Warner,Jeffrey Barr" userId="7360d018-3b8a-4d6d-8136-e4d170e1e616" providerId="ADAL" clId="{DB90B78A-78E0-4DA3-AE8A-B837C5EF1D5E}" dt="2021-04-23T14:00:30.639" v="4401" actId="165"/>
          <ac:grpSpMkLst>
            <pc:docMk/>
            <pc:sldMk cId="3319412604" sldId="269"/>
            <ac:grpSpMk id="51" creationId="{00000000-0000-0000-0000-000000000000}"/>
          </ac:grpSpMkLst>
        </pc:grpChg>
        <pc:picChg chg="mod topLvl">
          <ac:chgData name="Warner,Jeffrey Barr" userId="7360d018-3b8a-4d6d-8136-e4d170e1e616" providerId="ADAL" clId="{DB90B78A-78E0-4DA3-AE8A-B837C5EF1D5E}" dt="2021-04-23T14:00:30.639" v="4401" actId="165"/>
          <ac:picMkLst>
            <pc:docMk/>
            <pc:sldMk cId="3319412604" sldId="269"/>
            <ac:picMk id="10" creationId="{00000000-0000-0000-0000-000000000000}"/>
          </ac:picMkLst>
        </pc:picChg>
        <pc:picChg chg="mod topLvl">
          <ac:chgData name="Warner,Jeffrey Barr" userId="7360d018-3b8a-4d6d-8136-e4d170e1e616" providerId="ADAL" clId="{DB90B78A-78E0-4DA3-AE8A-B837C5EF1D5E}" dt="2021-04-23T14:00:30.639" v="4401" actId="165"/>
          <ac:picMkLst>
            <pc:docMk/>
            <pc:sldMk cId="3319412604" sldId="269"/>
            <ac:picMk id="11" creationId="{00000000-0000-0000-0000-000000000000}"/>
          </ac:picMkLst>
        </pc:picChg>
        <pc:picChg chg="mod">
          <ac:chgData name="Warner,Jeffrey Barr" userId="7360d018-3b8a-4d6d-8136-e4d170e1e616" providerId="ADAL" clId="{DB90B78A-78E0-4DA3-AE8A-B837C5EF1D5E}" dt="2021-04-23T14:00:30.639" v="4401" actId="165"/>
          <ac:picMkLst>
            <pc:docMk/>
            <pc:sldMk cId="3319412604" sldId="269"/>
            <ac:picMk id="36" creationId="{F74C922E-BCD7-824A-9CE5-8F63F06AD8A9}"/>
          </ac:picMkLst>
        </pc:picChg>
        <pc:picChg chg="mod">
          <ac:chgData name="Warner,Jeffrey Barr" userId="7360d018-3b8a-4d6d-8136-e4d170e1e616" providerId="ADAL" clId="{DB90B78A-78E0-4DA3-AE8A-B837C5EF1D5E}" dt="2021-04-23T14:00:30.639" v="4401" actId="165"/>
          <ac:picMkLst>
            <pc:docMk/>
            <pc:sldMk cId="3319412604" sldId="269"/>
            <ac:picMk id="44" creationId="{1C71D2DE-4F28-0A41-AA40-BF24C3C37C7F}"/>
          </ac:picMkLst>
        </pc:picChg>
        <pc:picChg chg="mod">
          <ac:chgData name="Warner,Jeffrey Barr" userId="7360d018-3b8a-4d6d-8136-e4d170e1e616" providerId="ADAL" clId="{DB90B78A-78E0-4DA3-AE8A-B837C5EF1D5E}" dt="2021-04-23T14:00:30.639" v="4401" actId="165"/>
          <ac:picMkLst>
            <pc:docMk/>
            <pc:sldMk cId="3319412604" sldId="269"/>
            <ac:picMk id="46" creationId="{186A3237-3A11-754D-8436-BDE3A2547A85}"/>
          </ac:picMkLst>
        </pc:picChg>
        <pc:picChg chg="mod">
          <ac:chgData name="Warner,Jeffrey Barr" userId="7360d018-3b8a-4d6d-8136-e4d170e1e616" providerId="ADAL" clId="{DB90B78A-78E0-4DA3-AE8A-B837C5EF1D5E}" dt="2021-04-23T14:00:30.639" v="4401" actId="165"/>
          <ac:picMkLst>
            <pc:docMk/>
            <pc:sldMk cId="3319412604" sldId="269"/>
            <ac:picMk id="56" creationId="{4A57D22C-DA05-9340-A2BA-E7D9EC596BB5}"/>
          </ac:picMkLst>
        </pc:picChg>
        <pc:picChg chg="mod">
          <ac:chgData name="Warner,Jeffrey Barr" userId="7360d018-3b8a-4d6d-8136-e4d170e1e616" providerId="ADAL" clId="{DB90B78A-78E0-4DA3-AE8A-B837C5EF1D5E}" dt="2021-04-23T14:00:30.639" v="4401" actId="165"/>
          <ac:picMkLst>
            <pc:docMk/>
            <pc:sldMk cId="3319412604" sldId="269"/>
            <ac:picMk id="59" creationId="{00000000-0000-0000-0000-000000000000}"/>
          </ac:picMkLst>
        </pc:picChg>
        <pc:cxnChg chg="mod topLvl">
          <ac:chgData name="Warner,Jeffrey Barr" userId="7360d018-3b8a-4d6d-8136-e4d170e1e616" providerId="ADAL" clId="{DB90B78A-78E0-4DA3-AE8A-B837C5EF1D5E}" dt="2021-04-23T14:02:54.580" v="4541" actId="1582"/>
          <ac:cxnSpMkLst>
            <pc:docMk/>
            <pc:sldMk cId="3319412604" sldId="269"/>
            <ac:cxnSpMk id="6" creationId="{00000000-0000-0000-0000-000000000000}"/>
          </ac:cxnSpMkLst>
        </pc:cxnChg>
        <pc:cxnChg chg="mod topLvl">
          <ac:chgData name="Warner,Jeffrey Barr" userId="7360d018-3b8a-4d6d-8136-e4d170e1e616" providerId="ADAL" clId="{DB90B78A-78E0-4DA3-AE8A-B837C5EF1D5E}" dt="2021-04-23T14:02:54.580" v="4541" actId="1582"/>
          <ac:cxnSpMkLst>
            <pc:docMk/>
            <pc:sldMk cId="3319412604" sldId="269"/>
            <ac:cxnSpMk id="7" creationId="{00000000-0000-0000-0000-000000000000}"/>
          </ac:cxnSpMkLst>
        </pc:cxnChg>
        <pc:cxnChg chg="mod topLvl">
          <ac:chgData name="Warner,Jeffrey Barr" userId="7360d018-3b8a-4d6d-8136-e4d170e1e616" providerId="ADAL" clId="{DB90B78A-78E0-4DA3-AE8A-B837C5EF1D5E}" dt="2021-04-23T14:02:54.580" v="4541" actId="1582"/>
          <ac:cxnSpMkLst>
            <pc:docMk/>
            <pc:sldMk cId="3319412604" sldId="269"/>
            <ac:cxnSpMk id="9" creationId="{00000000-0000-0000-0000-000000000000}"/>
          </ac:cxnSpMkLst>
        </pc:cxnChg>
        <pc:cxnChg chg="mod topLvl">
          <ac:chgData name="Warner,Jeffrey Barr" userId="7360d018-3b8a-4d6d-8136-e4d170e1e616" providerId="ADAL" clId="{DB90B78A-78E0-4DA3-AE8A-B837C5EF1D5E}" dt="2021-04-23T14:02:54.580" v="4541" actId="1582"/>
          <ac:cxnSpMkLst>
            <pc:docMk/>
            <pc:sldMk cId="3319412604" sldId="269"/>
            <ac:cxnSpMk id="14" creationId="{00000000-0000-0000-0000-000000000000}"/>
          </ac:cxnSpMkLst>
        </pc:cxnChg>
        <pc:cxnChg chg="mod topLvl">
          <ac:chgData name="Warner,Jeffrey Barr" userId="7360d018-3b8a-4d6d-8136-e4d170e1e616" providerId="ADAL" clId="{DB90B78A-78E0-4DA3-AE8A-B837C5EF1D5E}" dt="2021-04-23T14:02:54.580" v="4541" actId="1582"/>
          <ac:cxnSpMkLst>
            <pc:docMk/>
            <pc:sldMk cId="3319412604" sldId="269"/>
            <ac:cxnSpMk id="24" creationId="{00000000-0000-0000-0000-000000000000}"/>
          </ac:cxnSpMkLst>
        </pc:cxnChg>
        <pc:cxnChg chg="mod topLvl">
          <ac:chgData name="Warner,Jeffrey Barr" userId="7360d018-3b8a-4d6d-8136-e4d170e1e616" providerId="ADAL" clId="{DB90B78A-78E0-4DA3-AE8A-B837C5EF1D5E}" dt="2021-04-23T14:04:04.703" v="4754" actId="1076"/>
          <ac:cxnSpMkLst>
            <pc:docMk/>
            <pc:sldMk cId="3319412604" sldId="269"/>
            <ac:cxnSpMk id="25" creationId="{00000000-0000-0000-0000-000000000000}"/>
          </ac:cxnSpMkLst>
        </pc:cxnChg>
        <pc:cxnChg chg="mod topLvl">
          <ac:chgData name="Warner,Jeffrey Barr" userId="7360d018-3b8a-4d6d-8136-e4d170e1e616" providerId="ADAL" clId="{DB90B78A-78E0-4DA3-AE8A-B837C5EF1D5E}" dt="2021-04-23T14:02:54.580" v="4541" actId="1582"/>
          <ac:cxnSpMkLst>
            <pc:docMk/>
            <pc:sldMk cId="3319412604" sldId="269"/>
            <ac:cxnSpMk id="26" creationId="{00000000-0000-0000-0000-000000000000}"/>
          </ac:cxnSpMkLst>
        </pc:cxnChg>
        <pc:cxnChg chg="mod topLvl">
          <ac:chgData name="Warner,Jeffrey Barr" userId="7360d018-3b8a-4d6d-8136-e4d170e1e616" providerId="ADAL" clId="{DB90B78A-78E0-4DA3-AE8A-B837C5EF1D5E}" dt="2021-04-23T14:02:54.580" v="4541" actId="1582"/>
          <ac:cxnSpMkLst>
            <pc:docMk/>
            <pc:sldMk cId="3319412604" sldId="269"/>
            <ac:cxnSpMk id="27" creationId="{00000000-0000-0000-0000-000000000000}"/>
          </ac:cxnSpMkLst>
        </pc:cxnChg>
        <pc:cxnChg chg="mod topLvl">
          <ac:chgData name="Warner,Jeffrey Barr" userId="7360d018-3b8a-4d6d-8136-e4d170e1e616" providerId="ADAL" clId="{DB90B78A-78E0-4DA3-AE8A-B837C5EF1D5E}" dt="2021-04-23T14:03:44.476" v="4728" actId="1038"/>
          <ac:cxnSpMkLst>
            <pc:docMk/>
            <pc:sldMk cId="3319412604" sldId="269"/>
            <ac:cxnSpMk id="29" creationId="{00000000-0000-0000-0000-000000000000}"/>
          </ac:cxnSpMkLst>
        </pc:cxnChg>
        <pc:cxnChg chg="mod">
          <ac:chgData name="Warner,Jeffrey Barr" userId="7360d018-3b8a-4d6d-8136-e4d170e1e616" providerId="ADAL" clId="{DB90B78A-78E0-4DA3-AE8A-B837C5EF1D5E}" dt="2021-04-23T14:00:30.639" v="4401" actId="165"/>
          <ac:cxnSpMkLst>
            <pc:docMk/>
            <pc:sldMk cId="3319412604" sldId="269"/>
            <ac:cxnSpMk id="32" creationId="{271F5F80-A652-C54D-A282-95E5172A2605}"/>
          </ac:cxnSpMkLst>
        </pc:cxnChg>
        <pc:cxnChg chg="mod">
          <ac:chgData name="Warner,Jeffrey Barr" userId="7360d018-3b8a-4d6d-8136-e4d170e1e616" providerId="ADAL" clId="{DB90B78A-78E0-4DA3-AE8A-B837C5EF1D5E}" dt="2021-04-23T14:00:30.639" v="4401" actId="165"/>
          <ac:cxnSpMkLst>
            <pc:docMk/>
            <pc:sldMk cId="3319412604" sldId="269"/>
            <ac:cxnSpMk id="33" creationId="{EF9C9FAD-0A71-044A-9B89-10F9382B97D4}"/>
          </ac:cxnSpMkLst>
        </pc:cxnChg>
        <pc:cxnChg chg="mod">
          <ac:chgData name="Warner,Jeffrey Barr" userId="7360d018-3b8a-4d6d-8136-e4d170e1e616" providerId="ADAL" clId="{DB90B78A-78E0-4DA3-AE8A-B837C5EF1D5E}" dt="2021-04-23T14:00:30.639" v="4401" actId="165"/>
          <ac:cxnSpMkLst>
            <pc:docMk/>
            <pc:sldMk cId="3319412604" sldId="269"/>
            <ac:cxnSpMk id="40" creationId="{271F5F80-A652-C54D-A282-95E5172A2605}"/>
          </ac:cxnSpMkLst>
        </pc:cxnChg>
        <pc:cxnChg chg="mod">
          <ac:chgData name="Warner,Jeffrey Barr" userId="7360d018-3b8a-4d6d-8136-e4d170e1e616" providerId="ADAL" clId="{DB90B78A-78E0-4DA3-AE8A-B837C5EF1D5E}" dt="2021-04-23T14:00:30.639" v="4401" actId="165"/>
          <ac:cxnSpMkLst>
            <pc:docMk/>
            <pc:sldMk cId="3319412604" sldId="269"/>
            <ac:cxnSpMk id="41" creationId="{EF9C9FAD-0A71-044A-9B89-10F9382B97D4}"/>
          </ac:cxnSpMkLst>
        </pc:cxnChg>
        <pc:cxnChg chg="mod">
          <ac:chgData name="Warner,Jeffrey Barr" userId="7360d018-3b8a-4d6d-8136-e4d170e1e616" providerId="ADAL" clId="{DB90B78A-78E0-4DA3-AE8A-B837C5EF1D5E}" dt="2021-04-23T14:00:30.639" v="4401" actId="165"/>
          <ac:cxnSpMkLst>
            <pc:docMk/>
            <pc:sldMk cId="3319412604" sldId="269"/>
            <ac:cxnSpMk id="47" creationId="{271F5F80-A652-C54D-A282-95E5172A2605}"/>
          </ac:cxnSpMkLst>
        </pc:cxnChg>
        <pc:cxnChg chg="mod">
          <ac:chgData name="Warner,Jeffrey Barr" userId="7360d018-3b8a-4d6d-8136-e4d170e1e616" providerId="ADAL" clId="{DB90B78A-78E0-4DA3-AE8A-B837C5EF1D5E}" dt="2021-04-23T14:00:30.639" v="4401" actId="165"/>
          <ac:cxnSpMkLst>
            <pc:docMk/>
            <pc:sldMk cId="3319412604" sldId="269"/>
            <ac:cxnSpMk id="48" creationId="{EF9C9FAD-0A71-044A-9B89-10F9382B97D4}"/>
          </ac:cxnSpMkLst>
        </pc:cxnChg>
        <pc:cxnChg chg="mod">
          <ac:chgData name="Warner,Jeffrey Barr" userId="7360d018-3b8a-4d6d-8136-e4d170e1e616" providerId="ADAL" clId="{DB90B78A-78E0-4DA3-AE8A-B837C5EF1D5E}" dt="2021-04-23T14:00:30.639" v="4401" actId="165"/>
          <ac:cxnSpMkLst>
            <pc:docMk/>
            <pc:sldMk cId="3319412604" sldId="269"/>
            <ac:cxnSpMk id="52" creationId="{271F5F80-A652-C54D-A282-95E5172A2605}"/>
          </ac:cxnSpMkLst>
        </pc:cxnChg>
        <pc:cxnChg chg="mod">
          <ac:chgData name="Warner,Jeffrey Barr" userId="7360d018-3b8a-4d6d-8136-e4d170e1e616" providerId="ADAL" clId="{DB90B78A-78E0-4DA3-AE8A-B837C5EF1D5E}" dt="2021-04-23T14:00:30.639" v="4401" actId="165"/>
          <ac:cxnSpMkLst>
            <pc:docMk/>
            <pc:sldMk cId="3319412604" sldId="269"/>
            <ac:cxnSpMk id="53" creationId="{EF9C9FAD-0A71-044A-9B89-10F9382B97D4}"/>
          </ac:cxnSpMkLst>
        </pc:cxnChg>
        <pc:cxnChg chg="add mod">
          <ac:chgData name="Warner,Jeffrey Barr" userId="7360d018-3b8a-4d6d-8136-e4d170e1e616" providerId="ADAL" clId="{DB90B78A-78E0-4DA3-AE8A-B837C5EF1D5E}" dt="2021-04-23T14:03:05.915" v="4591" actId="1037"/>
          <ac:cxnSpMkLst>
            <pc:docMk/>
            <pc:sldMk cId="3319412604" sldId="269"/>
            <ac:cxnSpMk id="62" creationId="{72E9EE8C-8EEC-4445-8CE7-108A1F23BF04}"/>
          </ac:cxnSpMkLst>
        </pc:cxnChg>
      </pc:sldChg>
      <pc:sldChg chg="modSp mod modNotesTx">
        <pc:chgData name="Warner,Jeffrey Barr" userId="7360d018-3b8a-4d6d-8136-e4d170e1e616" providerId="ADAL" clId="{DB90B78A-78E0-4DA3-AE8A-B837C5EF1D5E}" dt="2021-05-12T13:53:30.709" v="5062" actId="20577"/>
        <pc:sldMkLst>
          <pc:docMk/>
          <pc:sldMk cId="2515056989" sldId="337"/>
        </pc:sldMkLst>
        <pc:spChg chg="mod">
          <ac:chgData name="Warner,Jeffrey Barr" userId="7360d018-3b8a-4d6d-8136-e4d170e1e616" providerId="ADAL" clId="{DB90B78A-78E0-4DA3-AE8A-B837C5EF1D5E}" dt="2021-05-12T13:29:03.106" v="4917" actId="207"/>
          <ac:spMkLst>
            <pc:docMk/>
            <pc:sldMk cId="2515056989" sldId="337"/>
            <ac:spMk id="20" creationId="{4A6B56DE-E3EF-41AC-933B-D3AFE149021A}"/>
          </ac:spMkLst>
        </pc:spChg>
        <pc:spChg chg="mod">
          <ac:chgData name="Warner,Jeffrey Barr" userId="7360d018-3b8a-4d6d-8136-e4d170e1e616" providerId="ADAL" clId="{DB90B78A-78E0-4DA3-AE8A-B837C5EF1D5E}" dt="2021-05-12T13:29:05.546" v="4918" actId="207"/>
          <ac:spMkLst>
            <pc:docMk/>
            <pc:sldMk cId="2515056989" sldId="337"/>
            <ac:spMk id="21" creationId="{C7F342A5-BA8C-4073-BE0D-8FD66949D558}"/>
          </ac:spMkLst>
        </pc:spChg>
        <pc:graphicFrameChg chg="mod">
          <ac:chgData name="Warner,Jeffrey Barr" userId="7360d018-3b8a-4d6d-8136-e4d170e1e616" providerId="ADAL" clId="{DB90B78A-78E0-4DA3-AE8A-B837C5EF1D5E}" dt="2021-05-12T13:53:22.116" v="5059"/>
          <ac:graphicFrameMkLst>
            <pc:docMk/>
            <pc:sldMk cId="2515056989" sldId="337"/>
            <ac:graphicFrameMk id="22" creationId="{7EF0D639-FFEC-4EDE-AF27-B5F85A10FD87}"/>
          </ac:graphicFrameMkLst>
        </pc:graphicFrameChg>
        <pc:graphicFrameChg chg="mod">
          <ac:chgData name="Warner,Jeffrey Barr" userId="7360d018-3b8a-4d6d-8136-e4d170e1e616" providerId="ADAL" clId="{DB90B78A-78E0-4DA3-AE8A-B837C5EF1D5E}" dt="2021-05-12T13:53:29.185" v="5061"/>
          <ac:graphicFrameMkLst>
            <pc:docMk/>
            <pc:sldMk cId="2515056989" sldId="337"/>
            <ac:graphicFrameMk id="23" creationId="{5F4FD40E-321C-44AE-BA43-C17DE73D182C}"/>
          </ac:graphicFrameMkLst>
        </pc:graphicFrameChg>
        <pc:graphicFrameChg chg="mod">
          <ac:chgData name="Warner,Jeffrey Barr" userId="7360d018-3b8a-4d6d-8136-e4d170e1e616" providerId="ADAL" clId="{DB90B78A-78E0-4DA3-AE8A-B837C5EF1D5E}" dt="2021-05-12T13:52:37.184" v="5051"/>
          <ac:graphicFrameMkLst>
            <pc:docMk/>
            <pc:sldMk cId="2515056989" sldId="337"/>
            <ac:graphicFrameMk id="26" creationId="{480B0AD6-ACAE-4829-9CBA-EAB73A271E8F}"/>
          </ac:graphicFrameMkLst>
        </pc:graphicFrameChg>
        <pc:graphicFrameChg chg="mod">
          <ac:chgData name="Warner,Jeffrey Barr" userId="7360d018-3b8a-4d6d-8136-e4d170e1e616" providerId="ADAL" clId="{DB90B78A-78E0-4DA3-AE8A-B837C5EF1D5E}" dt="2021-05-12T13:52:42.992" v="5053"/>
          <ac:graphicFrameMkLst>
            <pc:docMk/>
            <pc:sldMk cId="2515056989" sldId="337"/>
            <ac:graphicFrameMk id="27" creationId="{28CFC53E-BDE3-4C57-A86C-EE05730EB730}"/>
          </ac:graphicFrameMkLst>
        </pc:graphicFrameChg>
        <pc:graphicFrameChg chg="mod">
          <ac:chgData name="Warner,Jeffrey Barr" userId="7360d018-3b8a-4d6d-8136-e4d170e1e616" providerId="ADAL" clId="{DB90B78A-78E0-4DA3-AE8A-B837C5EF1D5E}" dt="2021-05-12T13:52:24.076" v="5047"/>
          <ac:graphicFrameMkLst>
            <pc:docMk/>
            <pc:sldMk cId="2515056989" sldId="337"/>
            <ac:graphicFrameMk id="41" creationId="{0E1D8059-A1C8-48DA-8418-0DE9A315E59D}"/>
          </ac:graphicFrameMkLst>
        </pc:graphicFrameChg>
        <pc:graphicFrameChg chg="mod">
          <ac:chgData name="Warner,Jeffrey Barr" userId="7360d018-3b8a-4d6d-8136-e4d170e1e616" providerId="ADAL" clId="{DB90B78A-78E0-4DA3-AE8A-B837C5EF1D5E}" dt="2021-05-12T13:52:31.674" v="5049"/>
          <ac:graphicFrameMkLst>
            <pc:docMk/>
            <pc:sldMk cId="2515056989" sldId="337"/>
            <ac:graphicFrameMk id="50" creationId="{CEAD69D7-DAE8-424F-B7C4-1DFE57C12031}"/>
          </ac:graphicFrameMkLst>
        </pc:graphicFrameChg>
        <pc:graphicFrameChg chg="mod">
          <ac:chgData name="Warner,Jeffrey Barr" userId="7360d018-3b8a-4d6d-8136-e4d170e1e616" providerId="ADAL" clId="{DB90B78A-78E0-4DA3-AE8A-B837C5EF1D5E}" dt="2021-05-12T13:52:54.131" v="5055"/>
          <ac:graphicFrameMkLst>
            <pc:docMk/>
            <pc:sldMk cId="2515056989" sldId="337"/>
            <ac:graphicFrameMk id="71" creationId="{7BC3708C-2942-49B8-9DBB-195A66EF97A6}"/>
          </ac:graphicFrameMkLst>
        </pc:graphicFrameChg>
        <pc:graphicFrameChg chg="mod">
          <ac:chgData name="Warner,Jeffrey Barr" userId="7360d018-3b8a-4d6d-8136-e4d170e1e616" providerId="ADAL" clId="{DB90B78A-78E0-4DA3-AE8A-B837C5EF1D5E}" dt="2021-05-12T13:53:07.947" v="5057"/>
          <ac:graphicFrameMkLst>
            <pc:docMk/>
            <pc:sldMk cId="2515056989" sldId="337"/>
            <ac:graphicFrameMk id="74" creationId="{DD53C923-A884-4836-9319-F8F4614BA5F6}"/>
          </ac:graphicFrameMkLst>
        </pc:graphicFrameChg>
      </pc:sldChg>
      <pc:sldChg chg="modSp addCm modCm">
        <pc:chgData name="Warner,Jeffrey Barr" userId="7360d018-3b8a-4d6d-8136-e4d170e1e616" providerId="ADAL" clId="{DB90B78A-78E0-4DA3-AE8A-B837C5EF1D5E}" dt="2021-05-12T13:54:11.042" v="5070"/>
        <pc:sldMkLst>
          <pc:docMk/>
          <pc:sldMk cId="3797510600" sldId="339"/>
        </pc:sldMkLst>
        <pc:spChg chg="mod">
          <ac:chgData name="Warner,Jeffrey Barr" userId="7360d018-3b8a-4d6d-8136-e4d170e1e616" providerId="ADAL" clId="{DB90B78A-78E0-4DA3-AE8A-B837C5EF1D5E}" dt="2021-04-22T14:55:21.335" v="4384" actId="554"/>
          <ac:spMkLst>
            <pc:docMk/>
            <pc:sldMk cId="3797510600" sldId="339"/>
            <ac:spMk id="4" creationId="{01C8F9CF-409F-C64C-9F6E-41E1F8972559}"/>
          </ac:spMkLst>
        </pc:spChg>
        <pc:spChg chg="mod">
          <ac:chgData name="Warner,Jeffrey Barr" userId="7360d018-3b8a-4d6d-8136-e4d170e1e616" providerId="ADAL" clId="{DB90B78A-78E0-4DA3-AE8A-B837C5EF1D5E}" dt="2021-05-12T13:28:22.051" v="4916" actId="207"/>
          <ac:spMkLst>
            <pc:docMk/>
            <pc:sldMk cId="3797510600" sldId="339"/>
            <ac:spMk id="5" creationId="{0312510B-E50F-4059-ABDE-A5F32D378697}"/>
          </ac:spMkLst>
        </pc:spChg>
        <pc:graphicFrameChg chg="mod">
          <ac:chgData name="Warner,Jeffrey Barr" userId="7360d018-3b8a-4d6d-8136-e4d170e1e616" providerId="ADAL" clId="{DB90B78A-78E0-4DA3-AE8A-B837C5EF1D5E}" dt="2021-05-12T13:54:11.042" v="5070"/>
          <ac:graphicFrameMkLst>
            <pc:docMk/>
            <pc:sldMk cId="3797510600" sldId="339"/>
            <ac:graphicFrameMk id="44" creationId="{CF896330-5753-4B3A-B081-A7D3AD32FC14}"/>
          </ac:graphicFrameMkLst>
        </pc:graphicFrameChg>
        <pc:graphicFrameChg chg="mod">
          <ac:chgData name="Warner,Jeffrey Barr" userId="7360d018-3b8a-4d6d-8136-e4d170e1e616" providerId="ADAL" clId="{DB90B78A-78E0-4DA3-AE8A-B837C5EF1D5E}" dt="2021-05-12T13:53:37.819" v="5064"/>
          <ac:graphicFrameMkLst>
            <pc:docMk/>
            <pc:sldMk cId="3797510600" sldId="339"/>
            <ac:graphicFrameMk id="131" creationId="{6B4BE97B-68D1-49A7-8C45-83D0B39F3D67}"/>
          </ac:graphicFrameMkLst>
        </pc:graphicFrameChg>
        <pc:graphicFrameChg chg="mod">
          <ac:chgData name="Warner,Jeffrey Barr" userId="7360d018-3b8a-4d6d-8136-e4d170e1e616" providerId="ADAL" clId="{DB90B78A-78E0-4DA3-AE8A-B837C5EF1D5E}" dt="2021-05-12T13:53:54.417" v="5066"/>
          <ac:graphicFrameMkLst>
            <pc:docMk/>
            <pc:sldMk cId="3797510600" sldId="339"/>
            <ac:graphicFrameMk id="137" creationId="{B59EE25D-3C25-47BD-9A2C-B39F6BD0C045}"/>
          </ac:graphicFrameMkLst>
        </pc:graphicFrameChg>
        <pc:graphicFrameChg chg="mod">
          <ac:chgData name="Warner,Jeffrey Barr" userId="7360d018-3b8a-4d6d-8136-e4d170e1e616" providerId="ADAL" clId="{DB90B78A-78E0-4DA3-AE8A-B837C5EF1D5E}" dt="2021-05-12T13:54:02.709" v="5068"/>
          <ac:graphicFrameMkLst>
            <pc:docMk/>
            <pc:sldMk cId="3797510600" sldId="339"/>
            <ac:graphicFrameMk id="145" creationId="{809516D3-05A8-4A83-873D-58013774EA85}"/>
          </ac:graphicFrameMkLst>
        </pc:graphicFrameChg>
      </pc:sldChg>
      <pc:sldChg chg="addSp delSp modSp mod addCm modCm">
        <pc:chgData name="Warner,Jeffrey Barr" userId="7360d018-3b8a-4d6d-8136-e4d170e1e616" providerId="ADAL" clId="{DB90B78A-78E0-4DA3-AE8A-B837C5EF1D5E}" dt="2021-05-12T14:04:09.584" v="5139"/>
        <pc:sldMkLst>
          <pc:docMk/>
          <pc:sldMk cId="2788620995" sldId="356"/>
        </pc:sldMkLst>
        <pc:spChg chg="mod topLvl">
          <ac:chgData name="Warner,Jeffrey Barr" userId="7360d018-3b8a-4d6d-8136-e4d170e1e616" providerId="ADAL" clId="{DB90B78A-78E0-4DA3-AE8A-B837C5EF1D5E}" dt="2021-05-12T13:34:45.303" v="4985" actId="207"/>
          <ac:spMkLst>
            <pc:docMk/>
            <pc:sldMk cId="2788620995" sldId="356"/>
            <ac:spMk id="8" creationId="{961416E9-2484-4F58-A9EA-0F9F96A9908A}"/>
          </ac:spMkLst>
        </pc:spChg>
        <pc:spChg chg="mod topLvl">
          <ac:chgData name="Warner,Jeffrey Barr" userId="7360d018-3b8a-4d6d-8136-e4d170e1e616" providerId="ADAL" clId="{DB90B78A-78E0-4DA3-AE8A-B837C5EF1D5E}" dt="2021-05-12T13:34:43.339" v="4984" actId="207"/>
          <ac:spMkLst>
            <pc:docMk/>
            <pc:sldMk cId="2788620995" sldId="356"/>
            <ac:spMk id="9" creationId="{D7F333D8-A9F7-4A2C-98A0-6CE055A66D2F}"/>
          </ac:spMkLst>
        </pc:spChg>
        <pc:spChg chg="mod topLvl">
          <ac:chgData name="Warner,Jeffrey Barr" userId="7360d018-3b8a-4d6d-8136-e4d170e1e616" providerId="ADAL" clId="{DB90B78A-78E0-4DA3-AE8A-B837C5EF1D5E}" dt="2021-05-12T13:34:40.988" v="4983" actId="207"/>
          <ac:spMkLst>
            <pc:docMk/>
            <pc:sldMk cId="2788620995" sldId="356"/>
            <ac:spMk id="10" creationId="{E7F8CDC2-8E63-42E1-98E0-F8344093AB8F}"/>
          </ac:spMkLst>
        </pc:spChg>
        <pc:spChg chg="mod topLvl">
          <ac:chgData name="Warner,Jeffrey Barr" userId="7360d018-3b8a-4d6d-8136-e4d170e1e616" providerId="ADAL" clId="{DB90B78A-78E0-4DA3-AE8A-B837C5EF1D5E}" dt="2021-04-22T14:29:01.896" v="1910" actId="164"/>
          <ac:spMkLst>
            <pc:docMk/>
            <pc:sldMk cId="2788620995" sldId="356"/>
            <ac:spMk id="11" creationId="{550C2BD1-1560-DC4B-B1E3-C01849A5E2DD}"/>
          </ac:spMkLst>
        </pc:spChg>
        <pc:spChg chg="mod">
          <ac:chgData name="Warner,Jeffrey Barr" userId="7360d018-3b8a-4d6d-8136-e4d170e1e616" providerId="ADAL" clId="{DB90B78A-78E0-4DA3-AE8A-B837C5EF1D5E}" dt="2021-05-12T13:38:38.462" v="4994" actId="207"/>
          <ac:spMkLst>
            <pc:docMk/>
            <pc:sldMk cId="2788620995" sldId="356"/>
            <ac:spMk id="20" creationId="{46D8F1B1-4947-6B4A-843C-BFEDBD0820D1}"/>
          </ac:spMkLst>
        </pc:spChg>
        <pc:spChg chg="mod topLvl">
          <ac:chgData name="Warner,Jeffrey Barr" userId="7360d018-3b8a-4d6d-8136-e4d170e1e616" providerId="ADAL" clId="{DB90B78A-78E0-4DA3-AE8A-B837C5EF1D5E}" dt="2021-04-22T14:28:31.023" v="1881" actId="165"/>
          <ac:spMkLst>
            <pc:docMk/>
            <pc:sldMk cId="2788620995" sldId="356"/>
            <ac:spMk id="21" creationId="{09E8C363-39BE-4AB2-8754-0F4356228855}"/>
          </ac:spMkLst>
        </pc:spChg>
        <pc:spChg chg="mod">
          <ac:chgData name="Warner,Jeffrey Barr" userId="7360d018-3b8a-4d6d-8136-e4d170e1e616" providerId="ADAL" clId="{DB90B78A-78E0-4DA3-AE8A-B837C5EF1D5E}" dt="2021-04-22T14:54:46.251" v="4350" actId="1076"/>
          <ac:spMkLst>
            <pc:docMk/>
            <pc:sldMk cId="2788620995" sldId="356"/>
            <ac:spMk id="23" creationId="{A1637236-0000-464B-B830-AD963D4FBD72}"/>
          </ac:spMkLst>
        </pc:spChg>
        <pc:spChg chg="mod">
          <ac:chgData name="Warner,Jeffrey Barr" userId="7360d018-3b8a-4d6d-8136-e4d170e1e616" providerId="ADAL" clId="{DB90B78A-78E0-4DA3-AE8A-B837C5EF1D5E}" dt="2021-05-12T13:38:42.195" v="4995" actId="207"/>
          <ac:spMkLst>
            <pc:docMk/>
            <pc:sldMk cId="2788620995" sldId="356"/>
            <ac:spMk id="24" creationId="{70BE6337-1186-6C47-9EFB-60B64ED0F2F2}"/>
          </ac:spMkLst>
        </pc:spChg>
        <pc:spChg chg="mod">
          <ac:chgData name="Warner,Jeffrey Barr" userId="7360d018-3b8a-4d6d-8136-e4d170e1e616" providerId="ADAL" clId="{DB90B78A-78E0-4DA3-AE8A-B837C5EF1D5E}" dt="2021-04-22T14:55:40.963" v="4389" actId="554"/>
          <ac:spMkLst>
            <pc:docMk/>
            <pc:sldMk cId="2788620995" sldId="356"/>
            <ac:spMk id="26" creationId="{DF4E3E5D-9EC3-4AE5-A5EF-597F02C742E5}"/>
          </ac:spMkLst>
        </pc:spChg>
        <pc:spChg chg="mod topLvl">
          <ac:chgData name="Warner,Jeffrey Barr" userId="7360d018-3b8a-4d6d-8136-e4d170e1e616" providerId="ADAL" clId="{DB90B78A-78E0-4DA3-AE8A-B837C5EF1D5E}" dt="2021-05-12T13:39:12.740" v="4997" actId="207"/>
          <ac:spMkLst>
            <pc:docMk/>
            <pc:sldMk cId="2788620995" sldId="356"/>
            <ac:spMk id="31" creationId="{AF724A5C-CCA6-884A-A2A3-6B2C9FA881E2}"/>
          </ac:spMkLst>
        </pc:spChg>
        <pc:spChg chg="mod topLvl">
          <ac:chgData name="Warner,Jeffrey Barr" userId="7360d018-3b8a-4d6d-8136-e4d170e1e616" providerId="ADAL" clId="{DB90B78A-78E0-4DA3-AE8A-B837C5EF1D5E}" dt="2021-05-12T13:39:20.638" v="5000" actId="207"/>
          <ac:spMkLst>
            <pc:docMk/>
            <pc:sldMk cId="2788620995" sldId="356"/>
            <ac:spMk id="32" creationId="{0644B2F1-4215-684E-984B-CC41E9BDF3CD}"/>
          </ac:spMkLst>
        </pc:spChg>
        <pc:spChg chg="mod topLvl">
          <ac:chgData name="Warner,Jeffrey Barr" userId="7360d018-3b8a-4d6d-8136-e4d170e1e616" providerId="ADAL" clId="{DB90B78A-78E0-4DA3-AE8A-B837C5EF1D5E}" dt="2021-04-22T14:29:01.896" v="1910" actId="164"/>
          <ac:spMkLst>
            <pc:docMk/>
            <pc:sldMk cId="2788620995" sldId="356"/>
            <ac:spMk id="33" creationId="{453AF2EB-8DDF-5244-B2F0-1C68F4FBC310}"/>
          </ac:spMkLst>
        </pc:spChg>
        <pc:spChg chg="mod">
          <ac:chgData name="Warner,Jeffrey Barr" userId="7360d018-3b8a-4d6d-8136-e4d170e1e616" providerId="ADAL" clId="{DB90B78A-78E0-4DA3-AE8A-B837C5EF1D5E}" dt="2021-04-22T14:27:39.851" v="1847" actId="555"/>
          <ac:spMkLst>
            <pc:docMk/>
            <pc:sldMk cId="2788620995" sldId="356"/>
            <ac:spMk id="40" creationId="{79E07317-065B-E34D-9379-B56338B084AD}"/>
          </ac:spMkLst>
        </pc:spChg>
        <pc:spChg chg="mod">
          <ac:chgData name="Warner,Jeffrey Barr" userId="7360d018-3b8a-4d6d-8136-e4d170e1e616" providerId="ADAL" clId="{DB90B78A-78E0-4DA3-AE8A-B837C5EF1D5E}" dt="2021-04-22T14:27:39.851" v="1847" actId="555"/>
          <ac:spMkLst>
            <pc:docMk/>
            <pc:sldMk cId="2788620995" sldId="356"/>
            <ac:spMk id="42" creationId="{C9E207BA-6A6F-5446-A1A9-04DB3CE2B260}"/>
          </ac:spMkLst>
        </pc:spChg>
        <pc:spChg chg="mod">
          <ac:chgData name="Warner,Jeffrey Barr" userId="7360d018-3b8a-4d6d-8136-e4d170e1e616" providerId="ADAL" clId="{DB90B78A-78E0-4DA3-AE8A-B837C5EF1D5E}" dt="2021-05-12T13:39:14.942" v="4998" actId="207"/>
          <ac:spMkLst>
            <pc:docMk/>
            <pc:sldMk cId="2788620995" sldId="356"/>
            <ac:spMk id="43" creationId="{F959E105-AD77-6847-B2DC-8836AC4DFCC4}"/>
          </ac:spMkLst>
        </pc:spChg>
        <pc:spChg chg="mod">
          <ac:chgData name="Warner,Jeffrey Barr" userId="7360d018-3b8a-4d6d-8136-e4d170e1e616" providerId="ADAL" clId="{DB90B78A-78E0-4DA3-AE8A-B837C5EF1D5E}" dt="2021-05-12T13:39:17.724" v="4999" actId="207"/>
          <ac:spMkLst>
            <pc:docMk/>
            <pc:sldMk cId="2788620995" sldId="356"/>
            <ac:spMk id="44" creationId="{A1C055AD-8205-414D-950C-6AD476A2E39B}"/>
          </ac:spMkLst>
        </pc:spChg>
        <pc:spChg chg="mod">
          <ac:chgData name="Warner,Jeffrey Barr" userId="7360d018-3b8a-4d6d-8136-e4d170e1e616" providerId="ADAL" clId="{DB90B78A-78E0-4DA3-AE8A-B837C5EF1D5E}" dt="2021-04-22T14:27:39.851" v="1847" actId="555"/>
          <ac:spMkLst>
            <pc:docMk/>
            <pc:sldMk cId="2788620995" sldId="356"/>
            <ac:spMk id="45" creationId="{8F0E005B-BC21-B14D-991E-0080BEBAE7C9}"/>
          </ac:spMkLst>
        </pc:spChg>
        <pc:spChg chg="mod topLvl">
          <ac:chgData name="Warner,Jeffrey Barr" userId="7360d018-3b8a-4d6d-8136-e4d170e1e616" providerId="ADAL" clId="{DB90B78A-78E0-4DA3-AE8A-B837C5EF1D5E}" dt="2021-04-22T14:53:30.591" v="4131" actId="164"/>
          <ac:spMkLst>
            <pc:docMk/>
            <pc:sldMk cId="2788620995" sldId="356"/>
            <ac:spMk id="52" creationId="{E5E123DB-1729-409A-8FA5-7079AC06D2EB}"/>
          </ac:spMkLst>
        </pc:spChg>
        <pc:spChg chg="mod topLvl">
          <ac:chgData name="Warner,Jeffrey Barr" userId="7360d018-3b8a-4d6d-8136-e4d170e1e616" providerId="ADAL" clId="{DB90B78A-78E0-4DA3-AE8A-B837C5EF1D5E}" dt="2021-04-22T14:53:30.591" v="4131" actId="164"/>
          <ac:spMkLst>
            <pc:docMk/>
            <pc:sldMk cId="2788620995" sldId="356"/>
            <ac:spMk id="53" creationId="{1949A692-B888-43FD-824B-C1008CF0F62F}"/>
          </ac:spMkLst>
        </pc:spChg>
        <pc:spChg chg="mod topLvl">
          <ac:chgData name="Warner,Jeffrey Barr" userId="7360d018-3b8a-4d6d-8136-e4d170e1e616" providerId="ADAL" clId="{DB90B78A-78E0-4DA3-AE8A-B837C5EF1D5E}" dt="2021-04-22T14:53:30.591" v="4131" actId="164"/>
          <ac:spMkLst>
            <pc:docMk/>
            <pc:sldMk cId="2788620995" sldId="356"/>
            <ac:spMk id="54" creationId="{49B35A09-B465-45F4-AE61-D3AA839DBA7C}"/>
          </ac:spMkLst>
        </pc:spChg>
        <pc:spChg chg="mod topLvl">
          <ac:chgData name="Warner,Jeffrey Barr" userId="7360d018-3b8a-4d6d-8136-e4d170e1e616" providerId="ADAL" clId="{DB90B78A-78E0-4DA3-AE8A-B837C5EF1D5E}" dt="2021-04-22T14:53:30.591" v="4131" actId="164"/>
          <ac:spMkLst>
            <pc:docMk/>
            <pc:sldMk cId="2788620995" sldId="356"/>
            <ac:spMk id="55" creationId="{D941F2DC-20F6-4BAA-B72B-7A64D4F5DBE2}"/>
          </ac:spMkLst>
        </pc:spChg>
        <pc:spChg chg="mod topLvl">
          <ac:chgData name="Warner,Jeffrey Barr" userId="7360d018-3b8a-4d6d-8136-e4d170e1e616" providerId="ADAL" clId="{DB90B78A-78E0-4DA3-AE8A-B837C5EF1D5E}" dt="2021-04-22T14:53:30.591" v="4131" actId="164"/>
          <ac:spMkLst>
            <pc:docMk/>
            <pc:sldMk cId="2788620995" sldId="356"/>
            <ac:spMk id="56" creationId="{A62BBECE-53EA-490C-BE6E-5D29361CF40C}"/>
          </ac:spMkLst>
        </pc:spChg>
        <pc:spChg chg="mod topLvl">
          <ac:chgData name="Warner,Jeffrey Barr" userId="7360d018-3b8a-4d6d-8136-e4d170e1e616" providerId="ADAL" clId="{DB90B78A-78E0-4DA3-AE8A-B837C5EF1D5E}" dt="2021-04-22T14:53:30.591" v="4131" actId="164"/>
          <ac:spMkLst>
            <pc:docMk/>
            <pc:sldMk cId="2788620995" sldId="356"/>
            <ac:spMk id="57" creationId="{36DE2BFF-6C64-4694-89E1-D3EB496A7D39}"/>
          </ac:spMkLst>
        </pc:spChg>
        <pc:spChg chg="mod topLvl">
          <ac:chgData name="Warner,Jeffrey Barr" userId="7360d018-3b8a-4d6d-8136-e4d170e1e616" providerId="ADAL" clId="{DB90B78A-78E0-4DA3-AE8A-B837C5EF1D5E}" dt="2021-04-22T14:53:30.591" v="4131" actId="164"/>
          <ac:spMkLst>
            <pc:docMk/>
            <pc:sldMk cId="2788620995" sldId="356"/>
            <ac:spMk id="58" creationId="{8A9FAFA1-86DC-433A-A3CC-1D1A6A8BE247}"/>
          </ac:spMkLst>
        </pc:spChg>
        <pc:spChg chg="mod topLvl">
          <ac:chgData name="Warner,Jeffrey Barr" userId="7360d018-3b8a-4d6d-8136-e4d170e1e616" providerId="ADAL" clId="{DB90B78A-78E0-4DA3-AE8A-B837C5EF1D5E}" dt="2021-04-22T14:53:30.591" v="4131" actId="164"/>
          <ac:spMkLst>
            <pc:docMk/>
            <pc:sldMk cId="2788620995" sldId="356"/>
            <ac:spMk id="59" creationId="{432A5D65-0E0C-4577-95EB-6C3E16F55D63}"/>
          </ac:spMkLst>
        </pc:spChg>
        <pc:spChg chg="mod topLvl">
          <ac:chgData name="Warner,Jeffrey Barr" userId="7360d018-3b8a-4d6d-8136-e4d170e1e616" providerId="ADAL" clId="{DB90B78A-78E0-4DA3-AE8A-B837C5EF1D5E}" dt="2021-04-22T14:53:30.591" v="4131" actId="164"/>
          <ac:spMkLst>
            <pc:docMk/>
            <pc:sldMk cId="2788620995" sldId="356"/>
            <ac:spMk id="60" creationId="{6479444F-A668-4B68-B2E3-760EDD7850BE}"/>
          </ac:spMkLst>
        </pc:spChg>
        <pc:spChg chg="mod topLvl">
          <ac:chgData name="Warner,Jeffrey Barr" userId="7360d018-3b8a-4d6d-8136-e4d170e1e616" providerId="ADAL" clId="{DB90B78A-78E0-4DA3-AE8A-B837C5EF1D5E}" dt="2021-04-22T14:53:30.591" v="4131" actId="164"/>
          <ac:spMkLst>
            <pc:docMk/>
            <pc:sldMk cId="2788620995" sldId="356"/>
            <ac:spMk id="61" creationId="{17B3EECE-00F2-4343-899A-E8F3D75F598C}"/>
          </ac:spMkLst>
        </pc:spChg>
        <pc:spChg chg="mod topLvl">
          <ac:chgData name="Warner,Jeffrey Barr" userId="7360d018-3b8a-4d6d-8136-e4d170e1e616" providerId="ADAL" clId="{DB90B78A-78E0-4DA3-AE8A-B837C5EF1D5E}" dt="2021-04-22T14:53:30.591" v="4131" actId="164"/>
          <ac:spMkLst>
            <pc:docMk/>
            <pc:sldMk cId="2788620995" sldId="356"/>
            <ac:spMk id="62" creationId="{B1BE90A8-0EA7-4B5E-9358-295B98ED4DB7}"/>
          </ac:spMkLst>
        </pc:spChg>
        <pc:spChg chg="mod topLvl">
          <ac:chgData name="Warner,Jeffrey Barr" userId="7360d018-3b8a-4d6d-8136-e4d170e1e616" providerId="ADAL" clId="{DB90B78A-78E0-4DA3-AE8A-B837C5EF1D5E}" dt="2021-04-22T14:53:30.591" v="4131" actId="164"/>
          <ac:spMkLst>
            <pc:docMk/>
            <pc:sldMk cId="2788620995" sldId="356"/>
            <ac:spMk id="63" creationId="{6B21BBB6-D8DA-4EFA-B192-E72300DD8EE0}"/>
          </ac:spMkLst>
        </pc:spChg>
        <pc:spChg chg="mod topLvl">
          <ac:chgData name="Warner,Jeffrey Barr" userId="7360d018-3b8a-4d6d-8136-e4d170e1e616" providerId="ADAL" clId="{DB90B78A-78E0-4DA3-AE8A-B837C5EF1D5E}" dt="2021-04-22T14:53:30.591" v="4131" actId="164"/>
          <ac:spMkLst>
            <pc:docMk/>
            <pc:sldMk cId="2788620995" sldId="356"/>
            <ac:spMk id="64" creationId="{73D16645-3A73-4038-A241-0B01881E51D9}"/>
          </ac:spMkLst>
        </pc:spChg>
        <pc:spChg chg="mod topLvl">
          <ac:chgData name="Warner,Jeffrey Barr" userId="7360d018-3b8a-4d6d-8136-e4d170e1e616" providerId="ADAL" clId="{DB90B78A-78E0-4DA3-AE8A-B837C5EF1D5E}" dt="2021-04-22T14:53:30.591" v="4131" actId="164"/>
          <ac:spMkLst>
            <pc:docMk/>
            <pc:sldMk cId="2788620995" sldId="356"/>
            <ac:spMk id="65" creationId="{50C2F8EF-4322-403D-BF98-C3E29980F876}"/>
          </ac:spMkLst>
        </pc:spChg>
        <pc:spChg chg="mod topLvl">
          <ac:chgData name="Warner,Jeffrey Barr" userId="7360d018-3b8a-4d6d-8136-e4d170e1e616" providerId="ADAL" clId="{DB90B78A-78E0-4DA3-AE8A-B837C5EF1D5E}" dt="2021-04-22T14:53:30.591" v="4131" actId="164"/>
          <ac:spMkLst>
            <pc:docMk/>
            <pc:sldMk cId="2788620995" sldId="356"/>
            <ac:spMk id="66" creationId="{80EF6BBA-1A5E-450B-8236-62D8A8C640E0}"/>
          </ac:spMkLst>
        </pc:spChg>
        <pc:spChg chg="mod topLvl">
          <ac:chgData name="Warner,Jeffrey Barr" userId="7360d018-3b8a-4d6d-8136-e4d170e1e616" providerId="ADAL" clId="{DB90B78A-78E0-4DA3-AE8A-B837C5EF1D5E}" dt="2021-04-22T14:53:30.591" v="4131" actId="164"/>
          <ac:spMkLst>
            <pc:docMk/>
            <pc:sldMk cId="2788620995" sldId="356"/>
            <ac:spMk id="67" creationId="{F11F542D-8C8C-4B03-87AD-7A2F29348AB0}"/>
          </ac:spMkLst>
        </pc:spChg>
        <pc:spChg chg="mod topLvl">
          <ac:chgData name="Warner,Jeffrey Barr" userId="7360d018-3b8a-4d6d-8136-e4d170e1e616" providerId="ADAL" clId="{DB90B78A-78E0-4DA3-AE8A-B837C5EF1D5E}" dt="2021-04-22T14:53:30.591" v="4131" actId="164"/>
          <ac:spMkLst>
            <pc:docMk/>
            <pc:sldMk cId="2788620995" sldId="356"/>
            <ac:spMk id="68" creationId="{F807B936-B674-467E-8022-90C5C2C6DB34}"/>
          </ac:spMkLst>
        </pc:spChg>
        <pc:spChg chg="mod topLvl">
          <ac:chgData name="Warner,Jeffrey Barr" userId="7360d018-3b8a-4d6d-8136-e4d170e1e616" providerId="ADAL" clId="{DB90B78A-78E0-4DA3-AE8A-B837C5EF1D5E}" dt="2021-04-22T14:53:30.591" v="4131" actId="164"/>
          <ac:spMkLst>
            <pc:docMk/>
            <pc:sldMk cId="2788620995" sldId="356"/>
            <ac:spMk id="69" creationId="{A79F84D2-CC2C-4819-9DD0-7EBF3A8E291F}"/>
          </ac:spMkLst>
        </pc:spChg>
        <pc:spChg chg="mod topLvl">
          <ac:chgData name="Warner,Jeffrey Barr" userId="7360d018-3b8a-4d6d-8136-e4d170e1e616" providerId="ADAL" clId="{DB90B78A-78E0-4DA3-AE8A-B837C5EF1D5E}" dt="2021-04-22T14:53:30.591" v="4131" actId="164"/>
          <ac:spMkLst>
            <pc:docMk/>
            <pc:sldMk cId="2788620995" sldId="356"/>
            <ac:spMk id="70" creationId="{3B626086-0470-434E-9CC5-7A5810636ADA}"/>
          </ac:spMkLst>
        </pc:spChg>
        <pc:spChg chg="mod topLvl">
          <ac:chgData name="Warner,Jeffrey Barr" userId="7360d018-3b8a-4d6d-8136-e4d170e1e616" providerId="ADAL" clId="{DB90B78A-78E0-4DA3-AE8A-B837C5EF1D5E}" dt="2021-04-22T14:53:30.591" v="4131" actId="164"/>
          <ac:spMkLst>
            <pc:docMk/>
            <pc:sldMk cId="2788620995" sldId="356"/>
            <ac:spMk id="71" creationId="{CF59F8CD-10AD-40D8-9099-0E5E85FB6997}"/>
          </ac:spMkLst>
        </pc:spChg>
        <pc:spChg chg="add del mod">
          <ac:chgData name="Warner,Jeffrey Barr" userId="7360d018-3b8a-4d6d-8136-e4d170e1e616" providerId="ADAL" clId="{DB90B78A-78E0-4DA3-AE8A-B837C5EF1D5E}" dt="2021-04-22T14:34:34.168" v="2349"/>
          <ac:spMkLst>
            <pc:docMk/>
            <pc:sldMk cId="2788620995" sldId="356"/>
            <ac:spMk id="72" creationId="{407AC500-ABC0-436A-A437-03D0E3B5C587}"/>
          </ac:spMkLst>
        </pc:spChg>
        <pc:spChg chg="add mod topLvl">
          <ac:chgData name="Warner,Jeffrey Barr" userId="7360d018-3b8a-4d6d-8136-e4d170e1e616" providerId="ADAL" clId="{DB90B78A-78E0-4DA3-AE8A-B837C5EF1D5E}" dt="2021-04-22T14:53:30.591" v="4131" actId="164"/>
          <ac:spMkLst>
            <pc:docMk/>
            <pc:sldMk cId="2788620995" sldId="356"/>
            <ac:spMk id="73" creationId="{BBE6EE05-937F-474B-BEEE-4985A0B37ABE}"/>
          </ac:spMkLst>
        </pc:spChg>
        <pc:spChg chg="add mod topLvl">
          <ac:chgData name="Warner,Jeffrey Barr" userId="7360d018-3b8a-4d6d-8136-e4d170e1e616" providerId="ADAL" clId="{DB90B78A-78E0-4DA3-AE8A-B837C5EF1D5E}" dt="2021-04-22T14:53:30.591" v="4131" actId="164"/>
          <ac:spMkLst>
            <pc:docMk/>
            <pc:sldMk cId="2788620995" sldId="356"/>
            <ac:spMk id="74" creationId="{D9B369F1-99FC-4A56-BC00-077EFFCD2DA4}"/>
          </ac:spMkLst>
        </pc:spChg>
        <pc:spChg chg="add mod topLvl">
          <ac:chgData name="Warner,Jeffrey Barr" userId="7360d018-3b8a-4d6d-8136-e4d170e1e616" providerId="ADAL" clId="{DB90B78A-78E0-4DA3-AE8A-B837C5EF1D5E}" dt="2021-04-22T14:53:30.591" v="4131" actId="164"/>
          <ac:spMkLst>
            <pc:docMk/>
            <pc:sldMk cId="2788620995" sldId="356"/>
            <ac:spMk id="75" creationId="{13439079-CA65-4DB0-B817-2DE6E5629287}"/>
          </ac:spMkLst>
        </pc:spChg>
        <pc:spChg chg="add mod">
          <ac:chgData name="Warner,Jeffrey Barr" userId="7360d018-3b8a-4d6d-8136-e4d170e1e616" providerId="ADAL" clId="{DB90B78A-78E0-4DA3-AE8A-B837C5EF1D5E}" dt="2021-04-22T14:36:54.080" v="2411" actId="164"/>
          <ac:spMkLst>
            <pc:docMk/>
            <pc:sldMk cId="2788620995" sldId="356"/>
            <ac:spMk id="76" creationId="{E96D1528-FF07-4446-83FE-700DDBD3C4CD}"/>
          </ac:spMkLst>
        </pc:spChg>
        <pc:spChg chg="add mod">
          <ac:chgData name="Warner,Jeffrey Barr" userId="7360d018-3b8a-4d6d-8136-e4d170e1e616" providerId="ADAL" clId="{DB90B78A-78E0-4DA3-AE8A-B837C5EF1D5E}" dt="2021-04-22T14:36:54.080" v="2411" actId="164"/>
          <ac:spMkLst>
            <pc:docMk/>
            <pc:sldMk cId="2788620995" sldId="356"/>
            <ac:spMk id="77" creationId="{C4D1CECD-4CF5-470E-8109-48FA89BBFA10}"/>
          </ac:spMkLst>
        </pc:spChg>
        <pc:spChg chg="add mod">
          <ac:chgData name="Warner,Jeffrey Barr" userId="7360d018-3b8a-4d6d-8136-e4d170e1e616" providerId="ADAL" clId="{DB90B78A-78E0-4DA3-AE8A-B837C5EF1D5E}" dt="2021-04-22T14:36:54.080" v="2411" actId="164"/>
          <ac:spMkLst>
            <pc:docMk/>
            <pc:sldMk cId="2788620995" sldId="356"/>
            <ac:spMk id="78" creationId="{3AAC00B9-57CB-4BE0-8D38-F6220135096F}"/>
          </ac:spMkLst>
        </pc:spChg>
        <pc:spChg chg="add mod">
          <ac:chgData name="Warner,Jeffrey Barr" userId="7360d018-3b8a-4d6d-8136-e4d170e1e616" providerId="ADAL" clId="{DB90B78A-78E0-4DA3-AE8A-B837C5EF1D5E}" dt="2021-04-22T14:36:54.080" v="2411" actId="164"/>
          <ac:spMkLst>
            <pc:docMk/>
            <pc:sldMk cId="2788620995" sldId="356"/>
            <ac:spMk id="79" creationId="{3739EE8D-81AD-4EED-A89C-00F68D7699EC}"/>
          </ac:spMkLst>
        </pc:spChg>
        <pc:spChg chg="add mod">
          <ac:chgData name="Warner,Jeffrey Barr" userId="7360d018-3b8a-4d6d-8136-e4d170e1e616" providerId="ADAL" clId="{DB90B78A-78E0-4DA3-AE8A-B837C5EF1D5E}" dt="2021-04-22T14:36:54.080" v="2411" actId="164"/>
          <ac:spMkLst>
            <pc:docMk/>
            <pc:sldMk cId="2788620995" sldId="356"/>
            <ac:spMk id="80" creationId="{D47D63D6-33DA-4E4F-AF8A-4EE9A6DA6D87}"/>
          </ac:spMkLst>
        </pc:spChg>
        <pc:spChg chg="add mod">
          <ac:chgData name="Warner,Jeffrey Barr" userId="7360d018-3b8a-4d6d-8136-e4d170e1e616" providerId="ADAL" clId="{DB90B78A-78E0-4DA3-AE8A-B837C5EF1D5E}" dt="2021-04-22T14:38:00.128" v="2448" actId="164"/>
          <ac:spMkLst>
            <pc:docMk/>
            <pc:sldMk cId="2788620995" sldId="356"/>
            <ac:spMk id="82" creationId="{339F6B22-6B3E-426D-ADCA-82C75629D906}"/>
          </ac:spMkLst>
        </pc:spChg>
        <pc:spChg chg="add mod">
          <ac:chgData name="Warner,Jeffrey Barr" userId="7360d018-3b8a-4d6d-8136-e4d170e1e616" providerId="ADAL" clId="{DB90B78A-78E0-4DA3-AE8A-B837C5EF1D5E}" dt="2021-04-22T14:38:00.128" v="2448" actId="164"/>
          <ac:spMkLst>
            <pc:docMk/>
            <pc:sldMk cId="2788620995" sldId="356"/>
            <ac:spMk id="83" creationId="{FC1C0619-28FB-467A-98B8-CE054AE5F005}"/>
          </ac:spMkLst>
        </pc:spChg>
        <pc:spChg chg="add mod">
          <ac:chgData name="Warner,Jeffrey Barr" userId="7360d018-3b8a-4d6d-8136-e4d170e1e616" providerId="ADAL" clId="{DB90B78A-78E0-4DA3-AE8A-B837C5EF1D5E}" dt="2021-04-22T14:38:00.128" v="2448" actId="164"/>
          <ac:spMkLst>
            <pc:docMk/>
            <pc:sldMk cId="2788620995" sldId="356"/>
            <ac:spMk id="84" creationId="{1521D343-1C42-4880-8655-5A6105659236}"/>
          </ac:spMkLst>
        </pc:spChg>
        <pc:spChg chg="add mod">
          <ac:chgData name="Warner,Jeffrey Barr" userId="7360d018-3b8a-4d6d-8136-e4d170e1e616" providerId="ADAL" clId="{DB90B78A-78E0-4DA3-AE8A-B837C5EF1D5E}" dt="2021-04-22T14:38:00.128" v="2448" actId="164"/>
          <ac:spMkLst>
            <pc:docMk/>
            <pc:sldMk cId="2788620995" sldId="356"/>
            <ac:spMk id="85" creationId="{47710042-4869-485C-8356-737242C5DA46}"/>
          </ac:spMkLst>
        </pc:spChg>
        <pc:spChg chg="mod">
          <ac:chgData name="Warner,Jeffrey Barr" userId="7360d018-3b8a-4d6d-8136-e4d170e1e616" providerId="ADAL" clId="{DB90B78A-78E0-4DA3-AE8A-B837C5EF1D5E}" dt="2021-04-22T14:38:04.544" v="2450" actId="571"/>
          <ac:spMkLst>
            <pc:docMk/>
            <pc:sldMk cId="2788620995" sldId="356"/>
            <ac:spMk id="88" creationId="{26B61F1F-0979-45B5-B110-598BA7B530C6}"/>
          </ac:spMkLst>
        </pc:spChg>
        <pc:spChg chg="mod">
          <ac:chgData name="Warner,Jeffrey Barr" userId="7360d018-3b8a-4d6d-8136-e4d170e1e616" providerId="ADAL" clId="{DB90B78A-78E0-4DA3-AE8A-B837C5EF1D5E}" dt="2021-04-22T14:38:04.544" v="2450" actId="571"/>
          <ac:spMkLst>
            <pc:docMk/>
            <pc:sldMk cId="2788620995" sldId="356"/>
            <ac:spMk id="89" creationId="{08412CFA-107D-4150-B8CF-E0080E1F74E5}"/>
          </ac:spMkLst>
        </pc:spChg>
        <pc:spChg chg="mod">
          <ac:chgData name="Warner,Jeffrey Barr" userId="7360d018-3b8a-4d6d-8136-e4d170e1e616" providerId="ADAL" clId="{DB90B78A-78E0-4DA3-AE8A-B837C5EF1D5E}" dt="2021-04-22T14:38:10.590" v="2462" actId="20577"/>
          <ac:spMkLst>
            <pc:docMk/>
            <pc:sldMk cId="2788620995" sldId="356"/>
            <ac:spMk id="90" creationId="{B2FC7126-811C-4FC4-B409-13E4C3D02434}"/>
          </ac:spMkLst>
        </pc:spChg>
        <pc:spChg chg="mod">
          <ac:chgData name="Warner,Jeffrey Barr" userId="7360d018-3b8a-4d6d-8136-e4d170e1e616" providerId="ADAL" clId="{DB90B78A-78E0-4DA3-AE8A-B837C5EF1D5E}" dt="2021-04-22T14:38:04.544" v="2450" actId="571"/>
          <ac:spMkLst>
            <pc:docMk/>
            <pc:sldMk cId="2788620995" sldId="356"/>
            <ac:spMk id="91" creationId="{012C97F1-B394-4CC2-BD4E-45981203FE91}"/>
          </ac:spMkLst>
        </pc:spChg>
        <pc:spChg chg="mod">
          <ac:chgData name="Warner,Jeffrey Barr" userId="7360d018-3b8a-4d6d-8136-e4d170e1e616" providerId="ADAL" clId="{DB90B78A-78E0-4DA3-AE8A-B837C5EF1D5E}" dt="2021-04-22T14:51:13.368" v="3733" actId="255"/>
          <ac:spMkLst>
            <pc:docMk/>
            <pc:sldMk cId="2788620995" sldId="356"/>
            <ac:spMk id="93" creationId="{71459341-A513-4EB8-8790-15DBD0FFFEE8}"/>
          </ac:spMkLst>
        </pc:spChg>
        <pc:spChg chg="mod">
          <ac:chgData name="Warner,Jeffrey Barr" userId="7360d018-3b8a-4d6d-8136-e4d170e1e616" providerId="ADAL" clId="{DB90B78A-78E0-4DA3-AE8A-B837C5EF1D5E}" dt="2021-04-22T14:51:19.334" v="3738" actId="1035"/>
          <ac:spMkLst>
            <pc:docMk/>
            <pc:sldMk cId="2788620995" sldId="356"/>
            <ac:spMk id="94" creationId="{13630623-F14C-405B-823C-F5E3B525FEDC}"/>
          </ac:spMkLst>
        </pc:spChg>
        <pc:spChg chg="mod">
          <ac:chgData name="Warner,Jeffrey Barr" userId="7360d018-3b8a-4d6d-8136-e4d170e1e616" providerId="ADAL" clId="{DB90B78A-78E0-4DA3-AE8A-B837C5EF1D5E}" dt="2021-04-22T14:51:22.479" v="3750" actId="1036"/>
          <ac:spMkLst>
            <pc:docMk/>
            <pc:sldMk cId="2788620995" sldId="356"/>
            <ac:spMk id="95" creationId="{19BCADB2-2517-48CF-9E1D-6EA810C7733D}"/>
          </ac:spMkLst>
        </pc:spChg>
        <pc:spChg chg="mod">
          <ac:chgData name="Warner,Jeffrey Barr" userId="7360d018-3b8a-4d6d-8136-e4d170e1e616" providerId="ADAL" clId="{DB90B78A-78E0-4DA3-AE8A-B837C5EF1D5E}" dt="2021-04-22T14:51:26.430" v="3761" actId="1035"/>
          <ac:spMkLst>
            <pc:docMk/>
            <pc:sldMk cId="2788620995" sldId="356"/>
            <ac:spMk id="96" creationId="{6AA89DB7-EB52-4701-B717-F1D30837A123}"/>
          </ac:spMkLst>
        </pc:spChg>
        <pc:spChg chg="mod">
          <ac:chgData name="Warner,Jeffrey Barr" userId="7360d018-3b8a-4d6d-8136-e4d170e1e616" providerId="ADAL" clId="{DB90B78A-78E0-4DA3-AE8A-B837C5EF1D5E}" dt="2021-04-22T14:51:28.806" v="3773" actId="1035"/>
          <ac:spMkLst>
            <pc:docMk/>
            <pc:sldMk cId="2788620995" sldId="356"/>
            <ac:spMk id="97" creationId="{45C10838-2EA3-45E2-AD50-54F9D8605A3B}"/>
          </ac:spMkLst>
        </pc:spChg>
        <pc:spChg chg="mod">
          <ac:chgData name="Warner,Jeffrey Barr" userId="7360d018-3b8a-4d6d-8136-e4d170e1e616" providerId="ADAL" clId="{DB90B78A-78E0-4DA3-AE8A-B837C5EF1D5E}" dt="2021-04-22T14:51:31.631" v="3791" actId="1035"/>
          <ac:spMkLst>
            <pc:docMk/>
            <pc:sldMk cId="2788620995" sldId="356"/>
            <ac:spMk id="98" creationId="{D35D43D1-017B-4196-B550-1114AA9AE81B}"/>
          </ac:spMkLst>
        </pc:spChg>
        <pc:spChg chg="del mod">
          <ac:chgData name="Warner,Jeffrey Barr" userId="7360d018-3b8a-4d6d-8136-e4d170e1e616" providerId="ADAL" clId="{DB90B78A-78E0-4DA3-AE8A-B837C5EF1D5E}" dt="2021-04-22T14:39:45.815" v="2642" actId="478"/>
          <ac:spMkLst>
            <pc:docMk/>
            <pc:sldMk cId="2788620995" sldId="356"/>
            <ac:spMk id="99" creationId="{11600C88-C744-4D24-915E-F96600CD7CCD}"/>
          </ac:spMkLst>
        </pc:spChg>
        <pc:spChg chg="del mod">
          <ac:chgData name="Warner,Jeffrey Barr" userId="7360d018-3b8a-4d6d-8136-e4d170e1e616" providerId="ADAL" clId="{DB90B78A-78E0-4DA3-AE8A-B837C5EF1D5E}" dt="2021-04-22T14:39:45.815" v="2642" actId="478"/>
          <ac:spMkLst>
            <pc:docMk/>
            <pc:sldMk cId="2788620995" sldId="356"/>
            <ac:spMk id="100" creationId="{A5E06DCC-7D5E-4AE5-BD17-4BEB630A8EEC}"/>
          </ac:spMkLst>
        </pc:spChg>
        <pc:spChg chg="del mod">
          <ac:chgData name="Warner,Jeffrey Barr" userId="7360d018-3b8a-4d6d-8136-e4d170e1e616" providerId="ADAL" clId="{DB90B78A-78E0-4DA3-AE8A-B837C5EF1D5E}" dt="2021-04-22T14:39:45.815" v="2642" actId="478"/>
          <ac:spMkLst>
            <pc:docMk/>
            <pc:sldMk cId="2788620995" sldId="356"/>
            <ac:spMk id="101" creationId="{B9EBF837-EADD-4AC6-9B3A-4A2489C6438E}"/>
          </ac:spMkLst>
        </pc:spChg>
        <pc:spChg chg="del mod">
          <ac:chgData name="Warner,Jeffrey Barr" userId="7360d018-3b8a-4d6d-8136-e4d170e1e616" providerId="ADAL" clId="{DB90B78A-78E0-4DA3-AE8A-B837C5EF1D5E}" dt="2021-04-22T14:39:45.815" v="2642" actId="478"/>
          <ac:spMkLst>
            <pc:docMk/>
            <pc:sldMk cId="2788620995" sldId="356"/>
            <ac:spMk id="102" creationId="{4CBA8DD2-5AE4-4123-BE17-D2CF0CE2DFC7}"/>
          </ac:spMkLst>
        </pc:spChg>
        <pc:spChg chg="del mod">
          <ac:chgData name="Warner,Jeffrey Barr" userId="7360d018-3b8a-4d6d-8136-e4d170e1e616" providerId="ADAL" clId="{DB90B78A-78E0-4DA3-AE8A-B837C5EF1D5E}" dt="2021-04-22T14:39:45.815" v="2642" actId="478"/>
          <ac:spMkLst>
            <pc:docMk/>
            <pc:sldMk cId="2788620995" sldId="356"/>
            <ac:spMk id="103" creationId="{7DB77AFD-FB8F-4FC6-B98F-06CE4F06EA44}"/>
          </ac:spMkLst>
        </pc:spChg>
        <pc:spChg chg="del mod">
          <ac:chgData name="Warner,Jeffrey Barr" userId="7360d018-3b8a-4d6d-8136-e4d170e1e616" providerId="ADAL" clId="{DB90B78A-78E0-4DA3-AE8A-B837C5EF1D5E}" dt="2021-04-22T14:39:45.815" v="2642" actId="478"/>
          <ac:spMkLst>
            <pc:docMk/>
            <pc:sldMk cId="2788620995" sldId="356"/>
            <ac:spMk id="104" creationId="{6202C951-8E36-4A16-92A9-922613BDB3EB}"/>
          </ac:spMkLst>
        </pc:spChg>
        <pc:spChg chg="del mod">
          <ac:chgData name="Warner,Jeffrey Barr" userId="7360d018-3b8a-4d6d-8136-e4d170e1e616" providerId="ADAL" clId="{DB90B78A-78E0-4DA3-AE8A-B837C5EF1D5E}" dt="2021-04-22T14:39:45.815" v="2642" actId="478"/>
          <ac:spMkLst>
            <pc:docMk/>
            <pc:sldMk cId="2788620995" sldId="356"/>
            <ac:spMk id="105" creationId="{0BA06A07-4EBC-4B31-9931-B73C7ACD1BC0}"/>
          </ac:spMkLst>
        </pc:spChg>
        <pc:spChg chg="del mod">
          <ac:chgData name="Warner,Jeffrey Barr" userId="7360d018-3b8a-4d6d-8136-e4d170e1e616" providerId="ADAL" clId="{DB90B78A-78E0-4DA3-AE8A-B837C5EF1D5E}" dt="2021-04-22T14:39:52.136" v="2643" actId="478"/>
          <ac:spMkLst>
            <pc:docMk/>
            <pc:sldMk cId="2788620995" sldId="356"/>
            <ac:spMk id="106" creationId="{283BA2A1-7F25-499F-96D0-A644CBE6C66A}"/>
          </ac:spMkLst>
        </pc:spChg>
        <pc:spChg chg="del mod">
          <ac:chgData name="Warner,Jeffrey Barr" userId="7360d018-3b8a-4d6d-8136-e4d170e1e616" providerId="ADAL" clId="{DB90B78A-78E0-4DA3-AE8A-B837C5EF1D5E}" dt="2021-04-22T14:39:52.136" v="2643" actId="478"/>
          <ac:spMkLst>
            <pc:docMk/>
            <pc:sldMk cId="2788620995" sldId="356"/>
            <ac:spMk id="107" creationId="{979D8397-5AE9-4FAA-907E-3AC579A4303C}"/>
          </ac:spMkLst>
        </pc:spChg>
        <pc:spChg chg="del mod">
          <ac:chgData name="Warner,Jeffrey Barr" userId="7360d018-3b8a-4d6d-8136-e4d170e1e616" providerId="ADAL" clId="{DB90B78A-78E0-4DA3-AE8A-B837C5EF1D5E}" dt="2021-04-22T14:39:52.136" v="2643" actId="478"/>
          <ac:spMkLst>
            <pc:docMk/>
            <pc:sldMk cId="2788620995" sldId="356"/>
            <ac:spMk id="108" creationId="{2682838E-9CC1-4EC7-AA63-D12F14448D69}"/>
          </ac:spMkLst>
        </pc:spChg>
        <pc:spChg chg="del mod">
          <ac:chgData name="Warner,Jeffrey Barr" userId="7360d018-3b8a-4d6d-8136-e4d170e1e616" providerId="ADAL" clId="{DB90B78A-78E0-4DA3-AE8A-B837C5EF1D5E}" dt="2021-04-22T14:39:52.136" v="2643" actId="478"/>
          <ac:spMkLst>
            <pc:docMk/>
            <pc:sldMk cId="2788620995" sldId="356"/>
            <ac:spMk id="109" creationId="{271F036B-CE0D-4C37-BECB-537CEF8E0FE2}"/>
          </ac:spMkLst>
        </pc:spChg>
        <pc:spChg chg="del mod">
          <ac:chgData name="Warner,Jeffrey Barr" userId="7360d018-3b8a-4d6d-8136-e4d170e1e616" providerId="ADAL" clId="{DB90B78A-78E0-4DA3-AE8A-B837C5EF1D5E}" dt="2021-04-22T14:39:52.136" v="2643" actId="478"/>
          <ac:spMkLst>
            <pc:docMk/>
            <pc:sldMk cId="2788620995" sldId="356"/>
            <ac:spMk id="110" creationId="{CB464191-1463-4766-BF2B-F6FFB9B19D2D}"/>
          </ac:spMkLst>
        </pc:spChg>
        <pc:spChg chg="del mod">
          <ac:chgData name="Warner,Jeffrey Barr" userId="7360d018-3b8a-4d6d-8136-e4d170e1e616" providerId="ADAL" clId="{DB90B78A-78E0-4DA3-AE8A-B837C5EF1D5E}" dt="2021-04-22T14:39:52.136" v="2643" actId="478"/>
          <ac:spMkLst>
            <pc:docMk/>
            <pc:sldMk cId="2788620995" sldId="356"/>
            <ac:spMk id="111" creationId="{7518D913-2322-4205-9431-B9D8EB0A0A78}"/>
          </ac:spMkLst>
        </pc:spChg>
        <pc:spChg chg="del mod">
          <ac:chgData name="Warner,Jeffrey Barr" userId="7360d018-3b8a-4d6d-8136-e4d170e1e616" providerId="ADAL" clId="{DB90B78A-78E0-4DA3-AE8A-B837C5EF1D5E}" dt="2021-04-22T14:39:52.136" v="2643" actId="478"/>
          <ac:spMkLst>
            <pc:docMk/>
            <pc:sldMk cId="2788620995" sldId="356"/>
            <ac:spMk id="112" creationId="{98E5D125-7A00-46A8-8C26-EB1FAB60EA2C}"/>
          </ac:spMkLst>
        </pc:spChg>
        <pc:spChg chg="del mod">
          <ac:chgData name="Warner,Jeffrey Barr" userId="7360d018-3b8a-4d6d-8136-e4d170e1e616" providerId="ADAL" clId="{DB90B78A-78E0-4DA3-AE8A-B837C5EF1D5E}" dt="2021-04-22T14:39:52.136" v="2643" actId="478"/>
          <ac:spMkLst>
            <pc:docMk/>
            <pc:sldMk cId="2788620995" sldId="356"/>
            <ac:spMk id="113" creationId="{79FF4E50-9381-42D5-B851-045957F8EA42}"/>
          </ac:spMkLst>
        </pc:spChg>
        <pc:spChg chg="del mod">
          <ac:chgData name="Warner,Jeffrey Barr" userId="7360d018-3b8a-4d6d-8136-e4d170e1e616" providerId="ADAL" clId="{DB90B78A-78E0-4DA3-AE8A-B837C5EF1D5E}" dt="2021-04-22T14:39:52.136" v="2643" actId="478"/>
          <ac:spMkLst>
            <pc:docMk/>
            <pc:sldMk cId="2788620995" sldId="356"/>
            <ac:spMk id="114" creationId="{675BB710-F59F-4DCB-BF35-922241C2B86D}"/>
          </ac:spMkLst>
        </pc:spChg>
        <pc:spChg chg="del mod">
          <ac:chgData name="Warner,Jeffrey Barr" userId="7360d018-3b8a-4d6d-8136-e4d170e1e616" providerId="ADAL" clId="{DB90B78A-78E0-4DA3-AE8A-B837C5EF1D5E}" dt="2021-04-22T14:39:52.136" v="2643" actId="478"/>
          <ac:spMkLst>
            <pc:docMk/>
            <pc:sldMk cId="2788620995" sldId="356"/>
            <ac:spMk id="115" creationId="{B9A57925-32C6-4729-B6A6-D10339B10F82}"/>
          </ac:spMkLst>
        </pc:spChg>
        <pc:spChg chg="mod topLvl">
          <ac:chgData name="Warner,Jeffrey Barr" userId="7360d018-3b8a-4d6d-8136-e4d170e1e616" providerId="ADAL" clId="{DB90B78A-78E0-4DA3-AE8A-B837C5EF1D5E}" dt="2021-04-25T17:57:19.829" v="4791" actId="20578"/>
          <ac:spMkLst>
            <pc:docMk/>
            <pc:sldMk cId="2788620995" sldId="356"/>
            <ac:spMk id="117" creationId="{BB1461BB-5DF5-403B-8CC6-DC6115F740A9}"/>
          </ac:spMkLst>
        </pc:spChg>
        <pc:spChg chg="mod topLvl">
          <ac:chgData name="Warner,Jeffrey Barr" userId="7360d018-3b8a-4d6d-8136-e4d170e1e616" providerId="ADAL" clId="{DB90B78A-78E0-4DA3-AE8A-B837C5EF1D5E}" dt="2021-04-25T17:57:19.829" v="4791" actId="20578"/>
          <ac:spMkLst>
            <pc:docMk/>
            <pc:sldMk cId="2788620995" sldId="356"/>
            <ac:spMk id="118" creationId="{A25CC0FA-0EEF-4B14-A00C-9AD84F0C4CD6}"/>
          </ac:spMkLst>
        </pc:spChg>
        <pc:spChg chg="mod topLvl">
          <ac:chgData name="Warner,Jeffrey Barr" userId="7360d018-3b8a-4d6d-8136-e4d170e1e616" providerId="ADAL" clId="{DB90B78A-78E0-4DA3-AE8A-B837C5EF1D5E}" dt="2021-04-25T17:57:19.829" v="4791" actId="20578"/>
          <ac:spMkLst>
            <pc:docMk/>
            <pc:sldMk cId="2788620995" sldId="356"/>
            <ac:spMk id="119" creationId="{665BFD0F-0858-4B34-A9A4-CADE0586B9D2}"/>
          </ac:spMkLst>
        </pc:spChg>
        <pc:spChg chg="mod topLvl">
          <ac:chgData name="Warner,Jeffrey Barr" userId="7360d018-3b8a-4d6d-8136-e4d170e1e616" providerId="ADAL" clId="{DB90B78A-78E0-4DA3-AE8A-B837C5EF1D5E}" dt="2021-04-25T17:57:19.829" v="4791" actId="20578"/>
          <ac:spMkLst>
            <pc:docMk/>
            <pc:sldMk cId="2788620995" sldId="356"/>
            <ac:spMk id="120" creationId="{8F76BFB0-E174-42EB-8CC6-42F0362D0778}"/>
          </ac:spMkLst>
        </pc:spChg>
        <pc:spChg chg="mod topLvl">
          <ac:chgData name="Warner,Jeffrey Barr" userId="7360d018-3b8a-4d6d-8136-e4d170e1e616" providerId="ADAL" clId="{DB90B78A-78E0-4DA3-AE8A-B837C5EF1D5E}" dt="2021-04-25T17:57:19.829" v="4791" actId="20578"/>
          <ac:spMkLst>
            <pc:docMk/>
            <pc:sldMk cId="2788620995" sldId="356"/>
            <ac:spMk id="121" creationId="{B65B14EE-689A-4BFE-899D-53F1D7044DAD}"/>
          </ac:spMkLst>
        </pc:spChg>
        <pc:spChg chg="mod topLvl">
          <ac:chgData name="Warner,Jeffrey Barr" userId="7360d018-3b8a-4d6d-8136-e4d170e1e616" providerId="ADAL" clId="{DB90B78A-78E0-4DA3-AE8A-B837C5EF1D5E}" dt="2021-04-25T17:57:19.829" v="4791" actId="20578"/>
          <ac:spMkLst>
            <pc:docMk/>
            <pc:sldMk cId="2788620995" sldId="356"/>
            <ac:spMk id="122" creationId="{8DF741A6-A479-4A6B-A8D6-B5E35304EF3C}"/>
          </ac:spMkLst>
        </pc:spChg>
        <pc:spChg chg="mod topLvl">
          <ac:chgData name="Warner,Jeffrey Barr" userId="7360d018-3b8a-4d6d-8136-e4d170e1e616" providerId="ADAL" clId="{DB90B78A-78E0-4DA3-AE8A-B837C5EF1D5E}" dt="2021-04-25T17:57:19.829" v="4791" actId="20578"/>
          <ac:spMkLst>
            <pc:docMk/>
            <pc:sldMk cId="2788620995" sldId="356"/>
            <ac:spMk id="123" creationId="{F328514D-6B1D-449F-9B9E-B87B80E9A046}"/>
          </ac:spMkLst>
        </pc:spChg>
        <pc:spChg chg="mod topLvl">
          <ac:chgData name="Warner,Jeffrey Barr" userId="7360d018-3b8a-4d6d-8136-e4d170e1e616" providerId="ADAL" clId="{DB90B78A-78E0-4DA3-AE8A-B837C5EF1D5E}" dt="2021-04-25T17:57:19.829" v="4791" actId="20578"/>
          <ac:spMkLst>
            <pc:docMk/>
            <pc:sldMk cId="2788620995" sldId="356"/>
            <ac:spMk id="124" creationId="{C29AC8EA-D538-4D68-9A37-6F024A5D99DF}"/>
          </ac:spMkLst>
        </pc:spChg>
        <pc:spChg chg="mod topLvl">
          <ac:chgData name="Warner,Jeffrey Barr" userId="7360d018-3b8a-4d6d-8136-e4d170e1e616" providerId="ADAL" clId="{DB90B78A-78E0-4DA3-AE8A-B837C5EF1D5E}" dt="2021-04-25T17:57:19.829" v="4791" actId="20578"/>
          <ac:spMkLst>
            <pc:docMk/>
            <pc:sldMk cId="2788620995" sldId="356"/>
            <ac:spMk id="125" creationId="{148363AF-5444-41E7-9459-CC73BC80FAD8}"/>
          </ac:spMkLst>
        </pc:spChg>
        <pc:spChg chg="mod topLvl">
          <ac:chgData name="Warner,Jeffrey Barr" userId="7360d018-3b8a-4d6d-8136-e4d170e1e616" providerId="ADAL" clId="{DB90B78A-78E0-4DA3-AE8A-B837C5EF1D5E}" dt="2021-04-25T17:57:19.829" v="4791" actId="20578"/>
          <ac:spMkLst>
            <pc:docMk/>
            <pc:sldMk cId="2788620995" sldId="356"/>
            <ac:spMk id="126" creationId="{3D38D69F-ABAB-4FD3-B0EA-85157FF0EB5E}"/>
          </ac:spMkLst>
        </pc:spChg>
        <pc:spChg chg="mod topLvl">
          <ac:chgData name="Warner,Jeffrey Barr" userId="7360d018-3b8a-4d6d-8136-e4d170e1e616" providerId="ADAL" clId="{DB90B78A-78E0-4DA3-AE8A-B837C5EF1D5E}" dt="2021-04-25T17:57:19.829" v="4791" actId="20578"/>
          <ac:spMkLst>
            <pc:docMk/>
            <pc:sldMk cId="2788620995" sldId="356"/>
            <ac:spMk id="127" creationId="{005F2404-F0F6-4742-A508-7E15A9B30E8F}"/>
          </ac:spMkLst>
        </pc:spChg>
        <pc:spChg chg="mod topLvl">
          <ac:chgData name="Warner,Jeffrey Barr" userId="7360d018-3b8a-4d6d-8136-e4d170e1e616" providerId="ADAL" clId="{DB90B78A-78E0-4DA3-AE8A-B837C5EF1D5E}" dt="2021-04-25T17:57:19.829" v="4791" actId="20578"/>
          <ac:spMkLst>
            <pc:docMk/>
            <pc:sldMk cId="2788620995" sldId="356"/>
            <ac:spMk id="128" creationId="{5E9682E5-86D8-43CE-80AB-59E4FB89385F}"/>
          </ac:spMkLst>
        </pc:spChg>
        <pc:spChg chg="mod topLvl">
          <ac:chgData name="Warner,Jeffrey Barr" userId="7360d018-3b8a-4d6d-8136-e4d170e1e616" providerId="ADAL" clId="{DB90B78A-78E0-4DA3-AE8A-B837C5EF1D5E}" dt="2021-04-25T17:57:19.829" v="4791" actId="20578"/>
          <ac:spMkLst>
            <pc:docMk/>
            <pc:sldMk cId="2788620995" sldId="356"/>
            <ac:spMk id="129" creationId="{FACB94DC-93AE-4B8E-AB89-03BE04378C78}"/>
          </ac:spMkLst>
        </pc:spChg>
        <pc:spChg chg="mod topLvl">
          <ac:chgData name="Warner,Jeffrey Barr" userId="7360d018-3b8a-4d6d-8136-e4d170e1e616" providerId="ADAL" clId="{DB90B78A-78E0-4DA3-AE8A-B837C5EF1D5E}" dt="2021-04-25T17:57:19.829" v="4791" actId="20578"/>
          <ac:spMkLst>
            <pc:docMk/>
            <pc:sldMk cId="2788620995" sldId="356"/>
            <ac:spMk id="130" creationId="{B96D525E-2E9B-4DF7-990A-A31BE4EB05C1}"/>
          </ac:spMkLst>
        </pc:spChg>
        <pc:spChg chg="mod topLvl">
          <ac:chgData name="Warner,Jeffrey Barr" userId="7360d018-3b8a-4d6d-8136-e4d170e1e616" providerId="ADAL" clId="{DB90B78A-78E0-4DA3-AE8A-B837C5EF1D5E}" dt="2021-04-25T17:57:19.829" v="4791" actId="20578"/>
          <ac:spMkLst>
            <pc:docMk/>
            <pc:sldMk cId="2788620995" sldId="356"/>
            <ac:spMk id="131" creationId="{D4E55F69-C67B-40FE-9231-83753FA9DE17}"/>
          </ac:spMkLst>
        </pc:spChg>
        <pc:spChg chg="mod topLvl">
          <ac:chgData name="Warner,Jeffrey Barr" userId="7360d018-3b8a-4d6d-8136-e4d170e1e616" providerId="ADAL" clId="{DB90B78A-78E0-4DA3-AE8A-B837C5EF1D5E}" dt="2021-04-25T17:57:19.829" v="4791" actId="20578"/>
          <ac:spMkLst>
            <pc:docMk/>
            <pc:sldMk cId="2788620995" sldId="356"/>
            <ac:spMk id="132" creationId="{870C3E4B-7836-4915-8BA8-B80920DDAAC0}"/>
          </ac:spMkLst>
        </pc:spChg>
        <pc:spChg chg="mod topLvl">
          <ac:chgData name="Warner,Jeffrey Barr" userId="7360d018-3b8a-4d6d-8136-e4d170e1e616" providerId="ADAL" clId="{DB90B78A-78E0-4DA3-AE8A-B837C5EF1D5E}" dt="2021-04-25T17:57:19.829" v="4791" actId="20578"/>
          <ac:spMkLst>
            <pc:docMk/>
            <pc:sldMk cId="2788620995" sldId="356"/>
            <ac:spMk id="133" creationId="{5D335F2D-112A-4858-9DE3-C4993C445549}"/>
          </ac:spMkLst>
        </pc:spChg>
        <pc:spChg chg="mod topLvl">
          <ac:chgData name="Warner,Jeffrey Barr" userId="7360d018-3b8a-4d6d-8136-e4d170e1e616" providerId="ADAL" clId="{DB90B78A-78E0-4DA3-AE8A-B837C5EF1D5E}" dt="2021-04-25T17:57:19.829" v="4791" actId="20578"/>
          <ac:spMkLst>
            <pc:docMk/>
            <pc:sldMk cId="2788620995" sldId="356"/>
            <ac:spMk id="134" creationId="{2A713B4F-349A-47AD-820D-0154EF896812}"/>
          </ac:spMkLst>
        </pc:spChg>
        <pc:spChg chg="mod topLvl">
          <ac:chgData name="Warner,Jeffrey Barr" userId="7360d018-3b8a-4d6d-8136-e4d170e1e616" providerId="ADAL" clId="{DB90B78A-78E0-4DA3-AE8A-B837C5EF1D5E}" dt="2021-04-25T17:57:19.829" v="4791" actId="20578"/>
          <ac:spMkLst>
            <pc:docMk/>
            <pc:sldMk cId="2788620995" sldId="356"/>
            <ac:spMk id="135" creationId="{75DF0306-0302-4D5A-A6E8-D7AC06D703F3}"/>
          </ac:spMkLst>
        </pc:spChg>
        <pc:spChg chg="mod topLvl">
          <ac:chgData name="Warner,Jeffrey Barr" userId="7360d018-3b8a-4d6d-8136-e4d170e1e616" providerId="ADAL" clId="{DB90B78A-78E0-4DA3-AE8A-B837C5EF1D5E}" dt="2021-04-25T17:57:19.829" v="4791" actId="20578"/>
          <ac:spMkLst>
            <pc:docMk/>
            <pc:sldMk cId="2788620995" sldId="356"/>
            <ac:spMk id="136" creationId="{69A0CD04-CDE1-467D-AE7D-5A1274435148}"/>
          </ac:spMkLst>
        </pc:spChg>
        <pc:spChg chg="mod topLvl">
          <ac:chgData name="Warner,Jeffrey Barr" userId="7360d018-3b8a-4d6d-8136-e4d170e1e616" providerId="ADAL" clId="{DB90B78A-78E0-4DA3-AE8A-B837C5EF1D5E}" dt="2021-04-25T17:57:19.829" v="4791" actId="20578"/>
          <ac:spMkLst>
            <pc:docMk/>
            <pc:sldMk cId="2788620995" sldId="356"/>
            <ac:spMk id="137" creationId="{33DC8031-E7BB-4BEF-B461-3871F71DC4EE}"/>
          </ac:spMkLst>
        </pc:spChg>
        <pc:spChg chg="mod topLvl">
          <ac:chgData name="Warner,Jeffrey Barr" userId="7360d018-3b8a-4d6d-8136-e4d170e1e616" providerId="ADAL" clId="{DB90B78A-78E0-4DA3-AE8A-B837C5EF1D5E}" dt="2021-04-25T17:57:19.829" v="4791" actId="20578"/>
          <ac:spMkLst>
            <pc:docMk/>
            <pc:sldMk cId="2788620995" sldId="356"/>
            <ac:spMk id="138" creationId="{8AA8C2D9-6853-4D02-8345-0A348478DEEE}"/>
          </ac:spMkLst>
        </pc:spChg>
        <pc:spChg chg="mod topLvl">
          <ac:chgData name="Warner,Jeffrey Barr" userId="7360d018-3b8a-4d6d-8136-e4d170e1e616" providerId="ADAL" clId="{DB90B78A-78E0-4DA3-AE8A-B837C5EF1D5E}" dt="2021-04-25T17:57:19.829" v="4791" actId="20578"/>
          <ac:spMkLst>
            <pc:docMk/>
            <pc:sldMk cId="2788620995" sldId="356"/>
            <ac:spMk id="139" creationId="{5AB0714C-AD2D-483C-952A-6228008C6424}"/>
          </ac:spMkLst>
        </pc:spChg>
        <pc:spChg chg="mod">
          <ac:chgData name="Warner,Jeffrey Barr" userId="7360d018-3b8a-4d6d-8136-e4d170e1e616" providerId="ADAL" clId="{DB90B78A-78E0-4DA3-AE8A-B837C5EF1D5E}" dt="2021-04-22T14:40:28.933" v="2650" actId="571"/>
          <ac:spMkLst>
            <pc:docMk/>
            <pc:sldMk cId="2788620995" sldId="356"/>
            <ac:spMk id="141" creationId="{91B7C2C1-6B00-41C4-9B7F-6B08252F1523}"/>
          </ac:spMkLst>
        </pc:spChg>
        <pc:spChg chg="mod">
          <ac:chgData name="Warner,Jeffrey Barr" userId="7360d018-3b8a-4d6d-8136-e4d170e1e616" providerId="ADAL" clId="{DB90B78A-78E0-4DA3-AE8A-B837C5EF1D5E}" dt="2021-04-22T14:40:28.933" v="2650" actId="571"/>
          <ac:spMkLst>
            <pc:docMk/>
            <pc:sldMk cId="2788620995" sldId="356"/>
            <ac:spMk id="142" creationId="{13F3BDE6-887F-47CE-A46B-2B1495A8700E}"/>
          </ac:spMkLst>
        </pc:spChg>
        <pc:spChg chg="mod">
          <ac:chgData name="Warner,Jeffrey Barr" userId="7360d018-3b8a-4d6d-8136-e4d170e1e616" providerId="ADAL" clId="{DB90B78A-78E0-4DA3-AE8A-B837C5EF1D5E}" dt="2021-04-22T14:40:28.933" v="2650" actId="571"/>
          <ac:spMkLst>
            <pc:docMk/>
            <pc:sldMk cId="2788620995" sldId="356"/>
            <ac:spMk id="143" creationId="{8C81DC6A-400D-4F11-83E9-A41129905529}"/>
          </ac:spMkLst>
        </pc:spChg>
        <pc:spChg chg="mod">
          <ac:chgData name="Warner,Jeffrey Barr" userId="7360d018-3b8a-4d6d-8136-e4d170e1e616" providerId="ADAL" clId="{DB90B78A-78E0-4DA3-AE8A-B837C5EF1D5E}" dt="2021-04-22T14:40:28.933" v="2650" actId="571"/>
          <ac:spMkLst>
            <pc:docMk/>
            <pc:sldMk cId="2788620995" sldId="356"/>
            <ac:spMk id="144" creationId="{6073F003-3A50-4BC3-9EBB-61F939CDBB19}"/>
          </ac:spMkLst>
        </pc:spChg>
        <pc:spChg chg="add mod topLvl">
          <ac:chgData name="Warner,Jeffrey Barr" userId="7360d018-3b8a-4d6d-8136-e4d170e1e616" providerId="ADAL" clId="{DB90B78A-78E0-4DA3-AE8A-B837C5EF1D5E}" dt="2021-04-25T17:57:19.829" v="4791" actId="20578"/>
          <ac:spMkLst>
            <pc:docMk/>
            <pc:sldMk cId="2788620995" sldId="356"/>
            <ac:spMk id="145" creationId="{AA289279-2AD9-475B-98D4-73790D0F901F}"/>
          </ac:spMkLst>
        </pc:spChg>
        <pc:spChg chg="add mod topLvl">
          <ac:chgData name="Warner,Jeffrey Barr" userId="7360d018-3b8a-4d6d-8136-e4d170e1e616" providerId="ADAL" clId="{DB90B78A-78E0-4DA3-AE8A-B837C5EF1D5E}" dt="2021-04-25T17:57:19.829" v="4791" actId="20578"/>
          <ac:spMkLst>
            <pc:docMk/>
            <pc:sldMk cId="2788620995" sldId="356"/>
            <ac:spMk id="146" creationId="{C8AB0F1C-02E1-4815-9415-997C15A783B6}"/>
          </ac:spMkLst>
        </pc:spChg>
        <pc:spChg chg="add mod topLvl">
          <ac:chgData name="Warner,Jeffrey Barr" userId="7360d018-3b8a-4d6d-8136-e4d170e1e616" providerId="ADAL" clId="{DB90B78A-78E0-4DA3-AE8A-B837C5EF1D5E}" dt="2021-04-25T17:57:19.829" v="4791" actId="20578"/>
          <ac:spMkLst>
            <pc:docMk/>
            <pc:sldMk cId="2788620995" sldId="356"/>
            <ac:spMk id="147" creationId="{6355B573-4C61-4069-8975-64375D516A0A}"/>
          </ac:spMkLst>
        </pc:spChg>
        <pc:spChg chg="add mod topLvl">
          <ac:chgData name="Warner,Jeffrey Barr" userId="7360d018-3b8a-4d6d-8136-e4d170e1e616" providerId="ADAL" clId="{DB90B78A-78E0-4DA3-AE8A-B837C5EF1D5E}" dt="2021-04-25T17:57:19.829" v="4791" actId="20578"/>
          <ac:spMkLst>
            <pc:docMk/>
            <pc:sldMk cId="2788620995" sldId="356"/>
            <ac:spMk id="148" creationId="{516FA82D-686C-4508-97FA-A01BAC89B3A5}"/>
          </ac:spMkLst>
        </pc:spChg>
        <pc:spChg chg="add mod topLvl">
          <ac:chgData name="Warner,Jeffrey Barr" userId="7360d018-3b8a-4d6d-8136-e4d170e1e616" providerId="ADAL" clId="{DB90B78A-78E0-4DA3-AE8A-B837C5EF1D5E}" dt="2021-04-25T17:57:19.829" v="4791" actId="20578"/>
          <ac:spMkLst>
            <pc:docMk/>
            <pc:sldMk cId="2788620995" sldId="356"/>
            <ac:spMk id="149" creationId="{AC08AD49-B5A3-43B6-A5DF-4B84E6350CAB}"/>
          </ac:spMkLst>
        </pc:spChg>
        <pc:spChg chg="add mod topLvl">
          <ac:chgData name="Warner,Jeffrey Barr" userId="7360d018-3b8a-4d6d-8136-e4d170e1e616" providerId="ADAL" clId="{DB90B78A-78E0-4DA3-AE8A-B837C5EF1D5E}" dt="2021-04-25T17:57:19.829" v="4791" actId="20578"/>
          <ac:spMkLst>
            <pc:docMk/>
            <pc:sldMk cId="2788620995" sldId="356"/>
            <ac:spMk id="150" creationId="{DFE9BAB0-CCAA-4595-BA01-383BF0183417}"/>
          </ac:spMkLst>
        </pc:spChg>
        <pc:spChg chg="add mod topLvl">
          <ac:chgData name="Warner,Jeffrey Barr" userId="7360d018-3b8a-4d6d-8136-e4d170e1e616" providerId="ADAL" clId="{DB90B78A-78E0-4DA3-AE8A-B837C5EF1D5E}" dt="2021-04-25T17:57:19.829" v="4791" actId="20578"/>
          <ac:spMkLst>
            <pc:docMk/>
            <pc:sldMk cId="2788620995" sldId="356"/>
            <ac:spMk id="151" creationId="{39814D59-9337-4508-8F88-07B141CB1B77}"/>
          </ac:spMkLst>
        </pc:spChg>
        <pc:grpChg chg="del mod topLvl">
          <ac:chgData name="Warner,Jeffrey Barr" userId="7360d018-3b8a-4d6d-8136-e4d170e1e616" providerId="ADAL" clId="{DB90B78A-78E0-4DA3-AE8A-B837C5EF1D5E}" dt="2021-04-22T14:28:33.929" v="1883" actId="165"/>
          <ac:grpSpMkLst>
            <pc:docMk/>
            <pc:sldMk cId="2788620995" sldId="356"/>
            <ac:grpSpMk id="3" creationId="{47610B4A-F9F3-EF4E-95E7-FA68AF5E0B04}"/>
          </ac:grpSpMkLst>
        </pc:grpChg>
        <pc:grpChg chg="del mod topLvl">
          <ac:chgData name="Warner,Jeffrey Barr" userId="7360d018-3b8a-4d6d-8136-e4d170e1e616" providerId="ADAL" clId="{DB90B78A-78E0-4DA3-AE8A-B837C5EF1D5E}" dt="2021-04-22T14:28:33.408" v="1882" actId="165"/>
          <ac:grpSpMkLst>
            <pc:docMk/>
            <pc:sldMk cId="2788620995" sldId="356"/>
            <ac:grpSpMk id="12" creationId="{9DAB4FEA-1660-854A-B842-4357F3CACE00}"/>
          </ac:grpSpMkLst>
        </pc:grpChg>
        <pc:grpChg chg="mod">
          <ac:chgData name="Warner,Jeffrey Barr" userId="7360d018-3b8a-4d6d-8136-e4d170e1e616" providerId="ADAL" clId="{DB90B78A-78E0-4DA3-AE8A-B837C5EF1D5E}" dt="2021-04-22T14:27:39.851" v="1847" actId="555"/>
          <ac:grpSpMkLst>
            <pc:docMk/>
            <pc:sldMk cId="2788620995" sldId="356"/>
            <ac:grpSpMk id="13" creationId="{5A03F5BC-3E15-344E-BD8C-E34BA431FE14}"/>
          </ac:grpSpMkLst>
        </pc:grpChg>
        <pc:grpChg chg="mod">
          <ac:chgData name="Warner,Jeffrey Barr" userId="7360d018-3b8a-4d6d-8136-e4d170e1e616" providerId="ADAL" clId="{DB90B78A-78E0-4DA3-AE8A-B837C5EF1D5E}" dt="2021-04-22T14:27:39.851" v="1847" actId="555"/>
          <ac:grpSpMkLst>
            <pc:docMk/>
            <pc:sldMk cId="2788620995" sldId="356"/>
            <ac:grpSpMk id="15" creationId="{267F4BD0-DA30-194B-8D0C-A82614A4BC2C}"/>
          </ac:grpSpMkLst>
        </pc:grpChg>
        <pc:grpChg chg="del mod">
          <ac:chgData name="Warner,Jeffrey Barr" userId="7360d018-3b8a-4d6d-8136-e4d170e1e616" providerId="ADAL" clId="{DB90B78A-78E0-4DA3-AE8A-B837C5EF1D5E}" dt="2021-04-22T14:28:31.023" v="1881" actId="165"/>
          <ac:grpSpMkLst>
            <pc:docMk/>
            <pc:sldMk cId="2788620995" sldId="356"/>
            <ac:grpSpMk id="17" creationId="{6788F01F-8B67-E046-B4AB-220F4D620C93}"/>
          </ac:grpSpMkLst>
        </pc:grpChg>
        <pc:grpChg chg="mod">
          <ac:chgData name="Warner,Jeffrey Barr" userId="7360d018-3b8a-4d6d-8136-e4d170e1e616" providerId="ADAL" clId="{DB90B78A-78E0-4DA3-AE8A-B837C5EF1D5E}" dt="2021-04-22T14:27:39.851" v="1847" actId="555"/>
          <ac:grpSpMkLst>
            <pc:docMk/>
            <pc:sldMk cId="2788620995" sldId="356"/>
            <ac:grpSpMk id="18" creationId="{D0344D46-7B3A-3D45-B042-1EBB8FA7614D}"/>
          </ac:grpSpMkLst>
        </pc:grpChg>
        <pc:grpChg chg="del mod topLvl">
          <ac:chgData name="Warner,Jeffrey Barr" userId="7360d018-3b8a-4d6d-8136-e4d170e1e616" providerId="ADAL" clId="{DB90B78A-78E0-4DA3-AE8A-B837C5EF1D5E}" dt="2021-04-22T14:30:07.504" v="1968" actId="165"/>
          <ac:grpSpMkLst>
            <pc:docMk/>
            <pc:sldMk cId="2788620995" sldId="356"/>
            <ac:grpSpMk id="19" creationId="{74A5EB28-044B-F44C-85A5-CBBF4CC0D9F3}"/>
          </ac:grpSpMkLst>
        </pc:grpChg>
        <pc:grpChg chg="del mod topLvl">
          <ac:chgData name="Warner,Jeffrey Barr" userId="7360d018-3b8a-4d6d-8136-e4d170e1e616" providerId="ADAL" clId="{DB90B78A-78E0-4DA3-AE8A-B837C5EF1D5E}" dt="2021-04-22T14:30:07.504" v="1968" actId="165"/>
          <ac:grpSpMkLst>
            <pc:docMk/>
            <pc:sldMk cId="2788620995" sldId="356"/>
            <ac:grpSpMk id="46" creationId="{EF8D963E-DC31-2A4A-8ED8-B49D86BCBCAC}"/>
          </ac:grpSpMkLst>
        </pc:grpChg>
        <pc:grpChg chg="del mod topLvl">
          <ac:chgData name="Warner,Jeffrey Barr" userId="7360d018-3b8a-4d6d-8136-e4d170e1e616" providerId="ADAL" clId="{DB90B78A-78E0-4DA3-AE8A-B837C5EF1D5E}" dt="2021-04-22T14:30:07.504" v="1968" actId="165"/>
          <ac:grpSpMkLst>
            <pc:docMk/>
            <pc:sldMk cId="2788620995" sldId="356"/>
            <ac:grpSpMk id="47" creationId="{11A4A434-85B1-5944-B7D4-D352BD476D61}"/>
          </ac:grpSpMkLst>
        </pc:grpChg>
        <pc:grpChg chg="del mod">
          <ac:chgData name="Warner,Jeffrey Barr" userId="7360d018-3b8a-4d6d-8136-e4d170e1e616" providerId="ADAL" clId="{DB90B78A-78E0-4DA3-AE8A-B837C5EF1D5E}" dt="2021-04-22T14:30:06.688" v="1967" actId="165"/>
          <ac:grpSpMkLst>
            <pc:docMk/>
            <pc:sldMk cId="2788620995" sldId="356"/>
            <ac:grpSpMk id="48" creationId="{98A4CB94-99DC-9A4F-BD87-47FDBF4C1415}"/>
          </ac:grpSpMkLst>
        </pc:grpChg>
        <pc:grpChg chg="add mod">
          <ac:chgData name="Warner,Jeffrey Barr" userId="7360d018-3b8a-4d6d-8136-e4d170e1e616" providerId="ADAL" clId="{DB90B78A-78E0-4DA3-AE8A-B837C5EF1D5E}" dt="2021-04-22T14:29:01.896" v="1910" actId="164"/>
          <ac:grpSpMkLst>
            <pc:docMk/>
            <pc:sldMk cId="2788620995" sldId="356"/>
            <ac:grpSpMk id="49" creationId="{D510A811-3AC1-42EE-8587-379F6AFF8C97}"/>
          </ac:grpSpMkLst>
        </pc:grpChg>
        <pc:grpChg chg="add mod">
          <ac:chgData name="Warner,Jeffrey Barr" userId="7360d018-3b8a-4d6d-8136-e4d170e1e616" providerId="ADAL" clId="{DB90B78A-78E0-4DA3-AE8A-B837C5EF1D5E}" dt="2021-04-22T14:29:03.824" v="1912" actId="1076"/>
          <ac:grpSpMkLst>
            <pc:docMk/>
            <pc:sldMk cId="2788620995" sldId="356"/>
            <ac:grpSpMk id="50" creationId="{2CBFDF7F-D481-48D6-A5C4-0019F56B0BEB}"/>
          </ac:grpSpMkLst>
        </pc:grpChg>
        <pc:grpChg chg="add del mod">
          <ac:chgData name="Warner,Jeffrey Barr" userId="7360d018-3b8a-4d6d-8136-e4d170e1e616" providerId="ADAL" clId="{DB90B78A-78E0-4DA3-AE8A-B837C5EF1D5E}" dt="2021-04-22T14:51:41.745" v="3792" actId="165"/>
          <ac:grpSpMkLst>
            <pc:docMk/>
            <pc:sldMk cId="2788620995" sldId="356"/>
            <ac:grpSpMk id="51" creationId="{C6A42E87-ABE8-4E87-A5EC-5CC103AD6328}"/>
          </ac:grpSpMkLst>
        </pc:grpChg>
        <pc:grpChg chg="add mod">
          <ac:chgData name="Warner,Jeffrey Barr" userId="7360d018-3b8a-4d6d-8136-e4d170e1e616" providerId="ADAL" clId="{DB90B78A-78E0-4DA3-AE8A-B837C5EF1D5E}" dt="2021-04-22T14:54:01.340" v="4148" actId="1038"/>
          <ac:grpSpMkLst>
            <pc:docMk/>
            <pc:sldMk cId="2788620995" sldId="356"/>
            <ac:grpSpMk id="81" creationId="{162A5C04-64C6-4AE4-A9C8-1160333BBE28}"/>
          </ac:grpSpMkLst>
        </pc:grpChg>
        <pc:grpChg chg="add mod">
          <ac:chgData name="Warner,Jeffrey Barr" userId="7360d018-3b8a-4d6d-8136-e4d170e1e616" providerId="ADAL" clId="{DB90B78A-78E0-4DA3-AE8A-B837C5EF1D5E}" dt="2021-04-22T14:54:01.340" v="4148" actId="1038"/>
          <ac:grpSpMkLst>
            <pc:docMk/>
            <pc:sldMk cId="2788620995" sldId="356"/>
            <ac:grpSpMk id="86" creationId="{A923975B-F439-4634-B28D-97AC84843D77}"/>
          </ac:grpSpMkLst>
        </pc:grpChg>
        <pc:grpChg chg="add mod">
          <ac:chgData name="Warner,Jeffrey Barr" userId="7360d018-3b8a-4d6d-8136-e4d170e1e616" providerId="ADAL" clId="{DB90B78A-78E0-4DA3-AE8A-B837C5EF1D5E}" dt="2021-04-22T14:54:19.439" v="4255" actId="1037"/>
          <ac:grpSpMkLst>
            <pc:docMk/>
            <pc:sldMk cId="2788620995" sldId="356"/>
            <ac:grpSpMk id="87" creationId="{AA3849FC-1EA3-41E9-B257-09F10126D748}"/>
          </ac:grpSpMkLst>
        </pc:grpChg>
        <pc:grpChg chg="add mod">
          <ac:chgData name="Warner,Jeffrey Barr" userId="7360d018-3b8a-4d6d-8136-e4d170e1e616" providerId="ADAL" clId="{DB90B78A-78E0-4DA3-AE8A-B837C5EF1D5E}" dt="2021-04-22T14:54:19.439" v="4255" actId="1037"/>
          <ac:grpSpMkLst>
            <pc:docMk/>
            <pc:sldMk cId="2788620995" sldId="356"/>
            <ac:grpSpMk id="92" creationId="{AE3DE35B-D649-4A58-8384-8C32BA8FC579}"/>
          </ac:grpSpMkLst>
        </pc:grpChg>
        <pc:grpChg chg="add del mod">
          <ac:chgData name="Warner,Jeffrey Barr" userId="7360d018-3b8a-4d6d-8136-e4d170e1e616" providerId="ADAL" clId="{DB90B78A-78E0-4DA3-AE8A-B837C5EF1D5E}" dt="2021-04-22T14:48:36.057" v="3445" actId="165"/>
          <ac:grpSpMkLst>
            <pc:docMk/>
            <pc:sldMk cId="2788620995" sldId="356"/>
            <ac:grpSpMk id="116" creationId="{26C5C044-5F61-4C4E-AD8D-BE67A6E14D5E}"/>
          </ac:grpSpMkLst>
        </pc:grpChg>
        <pc:grpChg chg="add mod">
          <ac:chgData name="Warner,Jeffrey Barr" userId="7360d018-3b8a-4d6d-8136-e4d170e1e616" providerId="ADAL" clId="{DB90B78A-78E0-4DA3-AE8A-B837C5EF1D5E}" dt="2021-04-22T14:54:33.808" v="4348" actId="1038"/>
          <ac:grpSpMkLst>
            <pc:docMk/>
            <pc:sldMk cId="2788620995" sldId="356"/>
            <ac:grpSpMk id="140" creationId="{CE04E388-2F4C-47B1-A570-AAF81836A513}"/>
          </ac:grpSpMkLst>
        </pc:grpChg>
        <pc:grpChg chg="add mod">
          <ac:chgData name="Warner,Jeffrey Barr" userId="7360d018-3b8a-4d6d-8136-e4d170e1e616" providerId="ADAL" clId="{DB90B78A-78E0-4DA3-AE8A-B837C5EF1D5E}" dt="2021-04-22T14:51:00.381" v="3731" actId="164"/>
          <ac:grpSpMkLst>
            <pc:docMk/>
            <pc:sldMk cId="2788620995" sldId="356"/>
            <ac:grpSpMk id="152" creationId="{742ADF68-D0A0-4B14-9744-70A77A36D289}"/>
          </ac:grpSpMkLst>
        </pc:grpChg>
        <pc:grpChg chg="add mod">
          <ac:chgData name="Warner,Jeffrey Barr" userId="7360d018-3b8a-4d6d-8136-e4d170e1e616" providerId="ADAL" clId="{DB90B78A-78E0-4DA3-AE8A-B837C5EF1D5E}" dt="2021-04-25T17:57:19.829" v="4791" actId="20578"/>
          <ac:grpSpMkLst>
            <pc:docMk/>
            <pc:sldMk cId="2788620995" sldId="356"/>
            <ac:grpSpMk id="153" creationId="{A802EBAA-3EA6-4245-823F-72317F8794E2}"/>
          </ac:grpSpMkLst>
        </pc:grpChg>
        <pc:grpChg chg="add mod">
          <ac:chgData name="Warner,Jeffrey Barr" userId="7360d018-3b8a-4d6d-8136-e4d170e1e616" providerId="ADAL" clId="{DB90B78A-78E0-4DA3-AE8A-B837C5EF1D5E}" dt="2021-04-22T14:54:01.340" v="4148" actId="1038"/>
          <ac:grpSpMkLst>
            <pc:docMk/>
            <pc:sldMk cId="2788620995" sldId="356"/>
            <ac:grpSpMk id="154" creationId="{AF7E3DFD-76E4-432A-9A01-9096E86BCFCA}"/>
          </ac:grpSpMkLst>
        </pc:grpChg>
        <pc:graphicFrameChg chg="add mod">
          <ac:chgData name="Warner,Jeffrey Barr" userId="7360d018-3b8a-4d6d-8136-e4d170e1e616" providerId="ADAL" clId="{DB90B78A-78E0-4DA3-AE8A-B837C5EF1D5E}" dt="2021-05-12T14:04:09.584" v="5139"/>
          <ac:graphicFrameMkLst>
            <pc:docMk/>
            <pc:sldMk cId="2788620995" sldId="356"/>
            <ac:graphicFrameMk id="18" creationId="{B75DE5DD-FD29-49E6-A2BF-B6684FF7A27F}"/>
          </ac:graphicFrameMkLst>
        </pc:graphicFrameChg>
        <pc:picChg chg="del">
          <ac:chgData name="Warner,Jeffrey Barr" userId="7360d018-3b8a-4d6d-8136-e4d170e1e616" providerId="ADAL" clId="{DB90B78A-78E0-4DA3-AE8A-B837C5EF1D5E}" dt="2021-05-12T14:03:31.267" v="5119" actId="478"/>
          <ac:picMkLst>
            <pc:docMk/>
            <pc:sldMk cId="2788620995" sldId="356"/>
            <ac:picMk id="3" creationId="{D78F7D62-C386-A84F-B1CA-3E9190A3876D}"/>
          </ac:picMkLst>
        </pc:picChg>
        <pc:picChg chg="mod topLvl modCrop">
          <ac:chgData name="Warner,Jeffrey Barr" userId="7360d018-3b8a-4d6d-8136-e4d170e1e616" providerId="ADAL" clId="{DB90B78A-78E0-4DA3-AE8A-B837C5EF1D5E}" dt="2021-04-22T14:28:39.734" v="1885" actId="555"/>
          <ac:picMkLst>
            <pc:docMk/>
            <pc:sldMk cId="2788620995" sldId="356"/>
            <ac:picMk id="5" creationId="{A103948B-01AD-4C1A-8455-93F191155099}"/>
          </ac:picMkLst>
        </pc:picChg>
        <pc:picChg chg="mod">
          <ac:chgData name="Warner,Jeffrey Barr" userId="7360d018-3b8a-4d6d-8136-e4d170e1e616" providerId="ADAL" clId="{DB90B78A-78E0-4DA3-AE8A-B837C5EF1D5E}" dt="2021-05-12T13:56:26.951" v="5083" actId="1582"/>
          <ac:picMkLst>
            <pc:docMk/>
            <pc:sldMk cId="2788620995" sldId="356"/>
            <ac:picMk id="6" creationId="{3D3DCE79-2987-4A39-A210-E8D2178CB06D}"/>
          </ac:picMkLst>
        </pc:picChg>
        <pc:picChg chg="mod topLvl modCrop">
          <ac:chgData name="Warner,Jeffrey Barr" userId="7360d018-3b8a-4d6d-8136-e4d170e1e616" providerId="ADAL" clId="{DB90B78A-78E0-4DA3-AE8A-B837C5EF1D5E}" dt="2021-04-22T14:29:01.896" v="1910" actId="164"/>
          <ac:picMkLst>
            <pc:docMk/>
            <pc:sldMk cId="2788620995" sldId="356"/>
            <ac:picMk id="27" creationId="{4F8D84C0-270F-E44C-AF05-7314C1C47328}"/>
          </ac:picMkLst>
        </pc:picChg>
        <pc:picChg chg="mod topLvl">
          <ac:chgData name="Warner,Jeffrey Barr" userId="7360d018-3b8a-4d6d-8136-e4d170e1e616" providerId="ADAL" clId="{DB90B78A-78E0-4DA3-AE8A-B837C5EF1D5E}" dt="2021-04-22T14:29:01.896" v="1910" actId="164"/>
          <ac:picMkLst>
            <pc:docMk/>
            <pc:sldMk cId="2788620995" sldId="356"/>
            <ac:picMk id="28" creationId="{E5EEFB1D-CF4A-7944-B89E-AC9DC8257696}"/>
          </ac:picMkLst>
        </pc:picChg>
        <pc:picChg chg="mod">
          <ac:chgData name="Warner,Jeffrey Barr" userId="7360d018-3b8a-4d6d-8136-e4d170e1e616" providerId="ADAL" clId="{DB90B78A-78E0-4DA3-AE8A-B837C5EF1D5E}" dt="2021-04-22T14:29:08.627" v="1913" actId="1076"/>
          <ac:picMkLst>
            <pc:docMk/>
            <pc:sldMk cId="2788620995" sldId="356"/>
            <ac:picMk id="29" creationId="{6505D113-EB02-418A-A41A-48D1A9BDE880}"/>
          </ac:picMkLst>
        </pc:picChg>
        <pc:picChg chg="mod topLvl">
          <ac:chgData name="Warner,Jeffrey Barr" userId="7360d018-3b8a-4d6d-8136-e4d170e1e616" providerId="ADAL" clId="{DB90B78A-78E0-4DA3-AE8A-B837C5EF1D5E}" dt="2021-04-22T14:28:39.734" v="1885" actId="555"/>
          <ac:picMkLst>
            <pc:docMk/>
            <pc:sldMk cId="2788620995" sldId="356"/>
            <ac:picMk id="30" creationId="{54B572A9-2760-214B-B2E9-B56BD580C2D9}"/>
          </ac:picMkLst>
        </pc:picChg>
        <pc:picChg chg="mod topLvl modCrop">
          <ac:chgData name="Warner,Jeffrey Barr" userId="7360d018-3b8a-4d6d-8136-e4d170e1e616" providerId="ADAL" clId="{DB90B78A-78E0-4DA3-AE8A-B837C5EF1D5E}" dt="2021-04-22T14:54:33.808" v="4348" actId="1038"/>
          <ac:picMkLst>
            <pc:docMk/>
            <pc:sldMk cId="2788620995" sldId="356"/>
            <ac:picMk id="34" creationId="{10C52CE0-77F3-4458-9E39-17FB8AE92D34}"/>
          </ac:picMkLst>
        </pc:picChg>
        <pc:picChg chg="mod">
          <ac:chgData name="Warner,Jeffrey Barr" userId="7360d018-3b8a-4d6d-8136-e4d170e1e616" providerId="ADAL" clId="{DB90B78A-78E0-4DA3-AE8A-B837C5EF1D5E}" dt="2021-04-22T14:27:39.851" v="1847" actId="555"/>
          <ac:picMkLst>
            <pc:docMk/>
            <pc:sldMk cId="2788620995" sldId="356"/>
            <ac:picMk id="35" creationId="{49950007-4BB1-2D40-81A3-0512BF573CC5}"/>
          </ac:picMkLst>
        </pc:picChg>
        <pc:picChg chg="mod modCrop">
          <ac:chgData name="Warner,Jeffrey Barr" userId="7360d018-3b8a-4d6d-8136-e4d170e1e616" providerId="ADAL" clId="{DB90B78A-78E0-4DA3-AE8A-B837C5EF1D5E}" dt="2021-04-22T14:27:39.851" v="1847" actId="555"/>
          <ac:picMkLst>
            <pc:docMk/>
            <pc:sldMk cId="2788620995" sldId="356"/>
            <ac:picMk id="36" creationId="{A9A5893C-6E76-49E2-B6A4-F075FCA5B565}"/>
          </ac:picMkLst>
        </pc:picChg>
        <pc:picChg chg="mod topLvl modCrop">
          <ac:chgData name="Warner,Jeffrey Barr" userId="7360d018-3b8a-4d6d-8136-e4d170e1e616" providerId="ADAL" clId="{DB90B78A-78E0-4DA3-AE8A-B837C5EF1D5E}" dt="2021-04-22T14:36:54.080" v="2411" actId="164"/>
          <ac:picMkLst>
            <pc:docMk/>
            <pc:sldMk cId="2788620995" sldId="356"/>
            <ac:picMk id="37" creationId="{D57034C9-FA74-4C02-8690-0259006623D6}"/>
          </ac:picMkLst>
        </pc:picChg>
        <pc:picChg chg="mod topLvl modCrop">
          <ac:chgData name="Warner,Jeffrey Barr" userId="7360d018-3b8a-4d6d-8136-e4d170e1e616" providerId="ADAL" clId="{DB90B78A-78E0-4DA3-AE8A-B837C5EF1D5E}" dt="2021-04-22T14:54:19.439" v="4255" actId="1037"/>
          <ac:picMkLst>
            <pc:docMk/>
            <pc:sldMk cId="2788620995" sldId="356"/>
            <ac:picMk id="38" creationId="{9A789EF1-A39F-4203-B209-D50B787BE00B}"/>
          </ac:picMkLst>
        </pc:picChg>
        <pc:picChg chg="mod">
          <ac:chgData name="Warner,Jeffrey Barr" userId="7360d018-3b8a-4d6d-8136-e4d170e1e616" providerId="ADAL" clId="{DB90B78A-78E0-4DA3-AE8A-B837C5EF1D5E}" dt="2021-04-22T14:27:46.335" v="1864" actId="1035"/>
          <ac:picMkLst>
            <pc:docMk/>
            <pc:sldMk cId="2788620995" sldId="356"/>
            <ac:picMk id="39" creationId="{FB267FE2-78B4-914F-97C1-94C012388DB8}"/>
          </ac:picMkLst>
        </pc:picChg>
        <pc:picChg chg="mod">
          <ac:chgData name="Warner,Jeffrey Barr" userId="7360d018-3b8a-4d6d-8136-e4d170e1e616" providerId="ADAL" clId="{DB90B78A-78E0-4DA3-AE8A-B837C5EF1D5E}" dt="2021-04-22T14:27:39.851" v="1847" actId="555"/>
          <ac:picMkLst>
            <pc:docMk/>
            <pc:sldMk cId="2788620995" sldId="356"/>
            <ac:picMk id="41" creationId="{9AB9709F-867C-AD40-A2BF-DEBAE9AF2966}"/>
          </ac:picMkLst>
        </pc:picChg>
      </pc:sldChg>
      <pc:sldChg chg="addSp delSp modSp mod">
        <pc:chgData name="Warner,Jeffrey Barr" userId="7360d018-3b8a-4d6d-8136-e4d170e1e616" providerId="ADAL" clId="{DB90B78A-78E0-4DA3-AE8A-B837C5EF1D5E}" dt="2021-05-12T14:03:13.279" v="5118" actId="12789"/>
        <pc:sldMkLst>
          <pc:docMk/>
          <pc:sldMk cId="53146747" sldId="357"/>
        </pc:sldMkLst>
        <pc:spChg chg="add del mod">
          <ac:chgData name="Warner,Jeffrey Barr" userId="7360d018-3b8a-4d6d-8136-e4d170e1e616" providerId="ADAL" clId="{DB90B78A-78E0-4DA3-AE8A-B837C5EF1D5E}" dt="2021-05-12T14:03:08.306" v="5115" actId="478"/>
          <ac:spMkLst>
            <pc:docMk/>
            <pc:sldMk cId="53146747" sldId="357"/>
            <ac:spMk id="3" creationId="{CB306A6C-F7E1-47F2-B5D3-675D6890793D}"/>
          </ac:spMkLst>
        </pc:spChg>
        <pc:spChg chg="add del mod">
          <ac:chgData name="Warner,Jeffrey Barr" userId="7360d018-3b8a-4d6d-8136-e4d170e1e616" providerId="ADAL" clId="{DB90B78A-78E0-4DA3-AE8A-B837C5EF1D5E}" dt="2021-05-12T14:03:08.306" v="5115" actId="478"/>
          <ac:spMkLst>
            <pc:docMk/>
            <pc:sldMk cId="53146747" sldId="357"/>
            <ac:spMk id="5" creationId="{E2A4758A-998E-46A6-B20C-4E4C204A9AE2}"/>
          </ac:spMkLst>
        </pc:spChg>
        <pc:graphicFrameChg chg="add mod">
          <ac:chgData name="Warner,Jeffrey Barr" userId="7360d018-3b8a-4d6d-8136-e4d170e1e616" providerId="ADAL" clId="{DB90B78A-78E0-4DA3-AE8A-B837C5EF1D5E}" dt="2021-05-12T14:03:13.279" v="5118" actId="12789"/>
          <ac:graphicFrameMkLst>
            <pc:docMk/>
            <pc:sldMk cId="53146747" sldId="357"/>
            <ac:graphicFrameMk id="4" creationId="{C3D75B9A-3A8C-4FD7-935D-38924F5A93C1}"/>
          </ac:graphicFrameMkLst>
        </pc:graphicFrameChg>
        <pc:picChg chg="del mod modCrop">
          <ac:chgData name="Warner,Jeffrey Barr" userId="7360d018-3b8a-4d6d-8136-e4d170e1e616" providerId="ADAL" clId="{DB90B78A-78E0-4DA3-AE8A-B837C5EF1D5E}" dt="2021-05-12T14:03:07.607" v="5114" actId="478"/>
          <ac:picMkLst>
            <pc:docMk/>
            <pc:sldMk cId="53146747" sldId="357"/>
            <ac:picMk id="2" creationId="{48E4A51B-2D10-7042-B9F8-F0126FDF1139}"/>
          </ac:picMkLst>
        </pc:picChg>
      </pc:sldChg>
      <pc:sldChg chg="addSp delSp mod modNotesTx">
        <pc:chgData name="Warner,Jeffrey Barr" userId="7360d018-3b8a-4d6d-8136-e4d170e1e616" providerId="ADAL" clId="{DB90B78A-78E0-4DA3-AE8A-B837C5EF1D5E}" dt="2021-05-12T13:40:08.512" v="5021" actId="20577"/>
        <pc:sldMkLst>
          <pc:docMk/>
          <pc:sldMk cId="195968458" sldId="370"/>
        </pc:sldMkLst>
        <pc:spChg chg="del">
          <ac:chgData name="Warner,Jeffrey Barr" userId="7360d018-3b8a-4d6d-8136-e4d170e1e616" providerId="ADAL" clId="{DB90B78A-78E0-4DA3-AE8A-B837C5EF1D5E}" dt="2021-04-22T14:01:50.287" v="4" actId="478"/>
          <ac:spMkLst>
            <pc:docMk/>
            <pc:sldMk cId="195968458" sldId="370"/>
            <ac:spMk id="2" creationId="{36DCE4D1-C27A-403E-A974-1E2EAA8D2B4D}"/>
          </ac:spMkLst>
        </pc:spChg>
        <pc:spChg chg="del">
          <ac:chgData name="Warner,Jeffrey Barr" userId="7360d018-3b8a-4d6d-8136-e4d170e1e616" providerId="ADAL" clId="{DB90B78A-78E0-4DA3-AE8A-B837C5EF1D5E}" dt="2021-04-22T14:01:51.167" v="5" actId="478"/>
          <ac:spMkLst>
            <pc:docMk/>
            <pc:sldMk cId="195968458" sldId="370"/>
            <ac:spMk id="3" creationId="{D5B0020D-532C-41B6-8D03-84DE729BCC56}"/>
          </ac:spMkLst>
        </pc:spChg>
        <pc:picChg chg="del">
          <ac:chgData name="Warner,Jeffrey Barr" userId="7360d018-3b8a-4d6d-8136-e4d170e1e616" providerId="ADAL" clId="{DB90B78A-78E0-4DA3-AE8A-B837C5EF1D5E}" dt="2021-04-22T14:01:48.543" v="3" actId="478"/>
          <ac:picMkLst>
            <pc:docMk/>
            <pc:sldMk cId="195968458" sldId="370"/>
            <ac:picMk id="5" creationId="{8ACBC45D-0F4B-45F3-BFE1-F3153978040F}"/>
          </ac:picMkLst>
        </pc:picChg>
        <pc:picChg chg="del">
          <ac:chgData name="Warner,Jeffrey Barr" userId="7360d018-3b8a-4d6d-8136-e4d170e1e616" providerId="ADAL" clId="{DB90B78A-78E0-4DA3-AE8A-B837C5EF1D5E}" dt="2021-04-22T14:01:48.100" v="2" actId="478"/>
          <ac:picMkLst>
            <pc:docMk/>
            <pc:sldMk cId="195968458" sldId="370"/>
            <ac:picMk id="6" creationId="{B3897398-41AA-6140-88E6-2C3C29D1EB00}"/>
          </ac:picMkLst>
        </pc:picChg>
        <pc:picChg chg="add">
          <ac:chgData name="Warner,Jeffrey Barr" userId="7360d018-3b8a-4d6d-8136-e4d170e1e616" providerId="ADAL" clId="{DB90B78A-78E0-4DA3-AE8A-B837C5EF1D5E}" dt="2021-04-22T14:01:53.277" v="6"/>
          <ac:picMkLst>
            <pc:docMk/>
            <pc:sldMk cId="195968458" sldId="370"/>
            <ac:picMk id="7" creationId="{509BA469-8470-489B-A1AC-DE08E370D104}"/>
          </ac:picMkLst>
        </pc:picChg>
      </pc:sldChg>
      <pc:sldChg chg="addSp delSp mod">
        <pc:chgData name="Warner,Jeffrey Barr" userId="7360d018-3b8a-4d6d-8136-e4d170e1e616" providerId="ADAL" clId="{DB90B78A-78E0-4DA3-AE8A-B837C5EF1D5E}" dt="2021-04-22T14:02:07.040" v="8"/>
        <pc:sldMkLst>
          <pc:docMk/>
          <pc:sldMk cId="3200190074" sldId="376"/>
        </pc:sldMkLst>
        <pc:picChg chg="add">
          <ac:chgData name="Warner,Jeffrey Barr" userId="7360d018-3b8a-4d6d-8136-e4d170e1e616" providerId="ADAL" clId="{DB90B78A-78E0-4DA3-AE8A-B837C5EF1D5E}" dt="2021-04-22T14:02:07.040" v="8"/>
          <ac:picMkLst>
            <pc:docMk/>
            <pc:sldMk cId="3200190074" sldId="376"/>
            <ac:picMk id="2" creationId="{05B0D1F0-95C5-41CE-AE96-624B41566894}"/>
          </ac:picMkLst>
        </pc:picChg>
        <pc:picChg chg="del">
          <ac:chgData name="Warner,Jeffrey Barr" userId="7360d018-3b8a-4d6d-8136-e4d170e1e616" providerId="ADAL" clId="{DB90B78A-78E0-4DA3-AE8A-B837C5EF1D5E}" dt="2021-04-22T14:02:05.711" v="7" actId="478"/>
          <ac:picMkLst>
            <pc:docMk/>
            <pc:sldMk cId="3200190074" sldId="376"/>
            <ac:picMk id="3" creationId="{EC256C50-22DB-43BF-A620-AB54C694317C}"/>
          </ac:picMkLst>
        </pc:picChg>
      </pc:sldChg>
      <pc:sldChg chg="addSp delSp modSp mod modNotesTx">
        <pc:chgData name="Warner,Jeffrey Barr" userId="7360d018-3b8a-4d6d-8136-e4d170e1e616" providerId="ADAL" clId="{DB90B78A-78E0-4DA3-AE8A-B837C5EF1D5E}" dt="2021-05-12T13:54:48.082" v="5081" actId="20577"/>
        <pc:sldMkLst>
          <pc:docMk/>
          <pc:sldMk cId="2894237854" sldId="378"/>
        </pc:sldMkLst>
        <pc:spChg chg="add mod">
          <ac:chgData name="Warner,Jeffrey Barr" userId="7360d018-3b8a-4d6d-8136-e4d170e1e616" providerId="ADAL" clId="{DB90B78A-78E0-4DA3-AE8A-B837C5EF1D5E}" dt="2021-05-12T13:33:48.301" v="4981" actId="13926"/>
          <ac:spMkLst>
            <pc:docMk/>
            <pc:sldMk cId="2894237854" sldId="378"/>
            <ac:spMk id="3" creationId="{01621D3B-EDAF-4791-A422-6CA1DCC83B1E}"/>
          </ac:spMkLst>
        </pc:spChg>
        <pc:spChg chg="add mod">
          <ac:chgData name="Warner,Jeffrey Barr" userId="7360d018-3b8a-4d6d-8136-e4d170e1e616" providerId="ADAL" clId="{DB90B78A-78E0-4DA3-AE8A-B837C5EF1D5E}" dt="2021-04-22T14:15:04.969" v="940" actId="164"/>
          <ac:spMkLst>
            <pc:docMk/>
            <pc:sldMk cId="2894237854" sldId="378"/>
            <ac:spMk id="8" creationId="{62D65E68-C00A-4107-A739-DB0B62953F85}"/>
          </ac:spMkLst>
        </pc:spChg>
        <pc:spChg chg="add mod">
          <ac:chgData name="Warner,Jeffrey Barr" userId="7360d018-3b8a-4d6d-8136-e4d170e1e616" providerId="ADAL" clId="{DB90B78A-78E0-4DA3-AE8A-B837C5EF1D5E}" dt="2021-04-22T14:15:04.969" v="940" actId="164"/>
          <ac:spMkLst>
            <pc:docMk/>
            <pc:sldMk cId="2894237854" sldId="378"/>
            <ac:spMk id="9" creationId="{15E3D589-DCC5-497C-92B5-030239440E18}"/>
          </ac:spMkLst>
        </pc:spChg>
        <pc:spChg chg="add mod">
          <ac:chgData name="Warner,Jeffrey Barr" userId="7360d018-3b8a-4d6d-8136-e4d170e1e616" providerId="ADAL" clId="{DB90B78A-78E0-4DA3-AE8A-B837C5EF1D5E}" dt="2021-04-22T14:21:57.681" v="1090" actId="1038"/>
          <ac:spMkLst>
            <pc:docMk/>
            <pc:sldMk cId="2894237854" sldId="378"/>
            <ac:spMk id="12" creationId="{F5C0041D-F0ED-4445-B9BD-DBF1A86F4DF4}"/>
          </ac:spMkLst>
        </pc:spChg>
        <pc:spChg chg="add mod">
          <ac:chgData name="Warner,Jeffrey Barr" userId="7360d018-3b8a-4d6d-8136-e4d170e1e616" providerId="ADAL" clId="{DB90B78A-78E0-4DA3-AE8A-B837C5EF1D5E}" dt="2021-04-22T14:15:08.657" v="941" actId="164"/>
          <ac:spMkLst>
            <pc:docMk/>
            <pc:sldMk cId="2894237854" sldId="378"/>
            <ac:spMk id="18" creationId="{901798EE-A30B-4F8D-A82A-9AD1E5A2D4FD}"/>
          </ac:spMkLst>
        </pc:spChg>
        <pc:spChg chg="add mod">
          <ac:chgData name="Warner,Jeffrey Barr" userId="7360d018-3b8a-4d6d-8136-e4d170e1e616" providerId="ADAL" clId="{DB90B78A-78E0-4DA3-AE8A-B837C5EF1D5E}" dt="2021-04-22T14:15:04.969" v="940" actId="164"/>
          <ac:spMkLst>
            <pc:docMk/>
            <pc:sldMk cId="2894237854" sldId="378"/>
            <ac:spMk id="20" creationId="{B59AAD97-8E76-4693-93C9-BFA0CE4D6266}"/>
          </ac:spMkLst>
        </pc:spChg>
        <pc:spChg chg="add mod">
          <ac:chgData name="Warner,Jeffrey Barr" userId="7360d018-3b8a-4d6d-8136-e4d170e1e616" providerId="ADAL" clId="{DB90B78A-78E0-4DA3-AE8A-B837C5EF1D5E}" dt="2021-04-22T14:15:04.969" v="940" actId="164"/>
          <ac:spMkLst>
            <pc:docMk/>
            <pc:sldMk cId="2894237854" sldId="378"/>
            <ac:spMk id="21" creationId="{6B503B11-B434-45AE-8282-E2BAA512BD33}"/>
          </ac:spMkLst>
        </pc:spChg>
        <pc:spChg chg="add mod">
          <ac:chgData name="Warner,Jeffrey Barr" userId="7360d018-3b8a-4d6d-8136-e4d170e1e616" providerId="ADAL" clId="{DB90B78A-78E0-4DA3-AE8A-B837C5EF1D5E}" dt="2021-04-22T14:15:04.969" v="940" actId="164"/>
          <ac:spMkLst>
            <pc:docMk/>
            <pc:sldMk cId="2894237854" sldId="378"/>
            <ac:spMk id="22" creationId="{814807B6-5D64-478C-A6A4-5E852B28D5F5}"/>
          </ac:spMkLst>
        </pc:spChg>
        <pc:spChg chg="add mod">
          <ac:chgData name="Warner,Jeffrey Barr" userId="7360d018-3b8a-4d6d-8136-e4d170e1e616" providerId="ADAL" clId="{DB90B78A-78E0-4DA3-AE8A-B837C5EF1D5E}" dt="2021-04-22T14:15:04.969" v="940" actId="164"/>
          <ac:spMkLst>
            <pc:docMk/>
            <pc:sldMk cId="2894237854" sldId="378"/>
            <ac:spMk id="23" creationId="{4CF13C58-294C-4A22-9741-36E401BDD2FF}"/>
          </ac:spMkLst>
        </pc:spChg>
        <pc:spChg chg="add mod">
          <ac:chgData name="Warner,Jeffrey Barr" userId="7360d018-3b8a-4d6d-8136-e4d170e1e616" providerId="ADAL" clId="{DB90B78A-78E0-4DA3-AE8A-B837C5EF1D5E}" dt="2021-04-22T14:15:04.969" v="940" actId="164"/>
          <ac:spMkLst>
            <pc:docMk/>
            <pc:sldMk cId="2894237854" sldId="378"/>
            <ac:spMk id="24" creationId="{D5FD6073-240D-492E-BE9E-C7BF4AD4150C}"/>
          </ac:spMkLst>
        </pc:spChg>
        <pc:spChg chg="add mod">
          <ac:chgData name="Warner,Jeffrey Barr" userId="7360d018-3b8a-4d6d-8136-e4d170e1e616" providerId="ADAL" clId="{DB90B78A-78E0-4DA3-AE8A-B837C5EF1D5E}" dt="2021-04-22T14:15:04.969" v="940" actId="164"/>
          <ac:spMkLst>
            <pc:docMk/>
            <pc:sldMk cId="2894237854" sldId="378"/>
            <ac:spMk id="25" creationId="{BD22D5DF-A610-4A28-B592-F89934FE5C68}"/>
          </ac:spMkLst>
        </pc:spChg>
        <pc:spChg chg="add mod">
          <ac:chgData name="Warner,Jeffrey Barr" userId="7360d018-3b8a-4d6d-8136-e4d170e1e616" providerId="ADAL" clId="{DB90B78A-78E0-4DA3-AE8A-B837C5EF1D5E}" dt="2021-04-22T14:15:04.969" v="940" actId="164"/>
          <ac:spMkLst>
            <pc:docMk/>
            <pc:sldMk cId="2894237854" sldId="378"/>
            <ac:spMk id="26" creationId="{27955448-56C7-4C80-9D37-9914B5C38B62}"/>
          </ac:spMkLst>
        </pc:spChg>
        <pc:spChg chg="add mod">
          <ac:chgData name="Warner,Jeffrey Barr" userId="7360d018-3b8a-4d6d-8136-e4d170e1e616" providerId="ADAL" clId="{DB90B78A-78E0-4DA3-AE8A-B837C5EF1D5E}" dt="2021-04-22T14:15:04.969" v="940" actId="164"/>
          <ac:spMkLst>
            <pc:docMk/>
            <pc:sldMk cId="2894237854" sldId="378"/>
            <ac:spMk id="27" creationId="{1ABB47BD-0A0F-4439-817C-FBA621CF131F}"/>
          </ac:spMkLst>
        </pc:spChg>
        <pc:spChg chg="add mod">
          <ac:chgData name="Warner,Jeffrey Barr" userId="7360d018-3b8a-4d6d-8136-e4d170e1e616" providerId="ADAL" clId="{DB90B78A-78E0-4DA3-AE8A-B837C5EF1D5E}" dt="2021-04-22T14:15:04.969" v="940" actId="164"/>
          <ac:spMkLst>
            <pc:docMk/>
            <pc:sldMk cId="2894237854" sldId="378"/>
            <ac:spMk id="28" creationId="{8A284606-2B76-4BFD-B948-E8D89E5A2AEF}"/>
          </ac:spMkLst>
        </pc:spChg>
        <pc:spChg chg="add mod">
          <ac:chgData name="Warner,Jeffrey Barr" userId="7360d018-3b8a-4d6d-8136-e4d170e1e616" providerId="ADAL" clId="{DB90B78A-78E0-4DA3-AE8A-B837C5EF1D5E}" dt="2021-04-22T14:15:04.969" v="940" actId="164"/>
          <ac:spMkLst>
            <pc:docMk/>
            <pc:sldMk cId="2894237854" sldId="378"/>
            <ac:spMk id="29" creationId="{D58160FF-4F4C-40D0-9810-76965B44D486}"/>
          </ac:spMkLst>
        </pc:spChg>
        <pc:spChg chg="add mod">
          <ac:chgData name="Warner,Jeffrey Barr" userId="7360d018-3b8a-4d6d-8136-e4d170e1e616" providerId="ADAL" clId="{DB90B78A-78E0-4DA3-AE8A-B837C5EF1D5E}" dt="2021-04-22T14:15:04.969" v="940" actId="164"/>
          <ac:spMkLst>
            <pc:docMk/>
            <pc:sldMk cId="2894237854" sldId="378"/>
            <ac:spMk id="30" creationId="{62ADA072-8458-4ABD-8290-85D7260B11B2}"/>
          </ac:spMkLst>
        </pc:spChg>
        <pc:spChg chg="add mod">
          <ac:chgData name="Warner,Jeffrey Barr" userId="7360d018-3b8a-4d6d-8136-e4d170e1e616" providerId="ADAL" clId="{DB90B78A-78E0-4DA3-AE8A-B837C5EF1D5E}" dt="2021-04-22T14:15:04.969" v="940" actId="164"/>
          <ac:spMkLst>
            <pc:docMk/>
            <pc:sldMk cId="2894237854" sldId="378"/>
            <ac:spMk id="31" creationId="{D21512A0-6F97-4431-969B-832957D7BD84}"/>
          </ac:spMkLst>
        </pc:spChg>
        <pc:spChg chg="add mod">
          <ac:chgData name="Warner,Jeffrey Barr" userId="7360d018-3b8a-4d6d-8136-e4d170e1e616" providerId="ADAL" clId="{DB90B78A-78E0-4DA3-AE8A-B837C5EF1D5E}" dt="2021-04-22T14:15:04.969" v="940" actId="164"/>
          <ac:spMkLst>
            <pc:docMk/>
            <pc:sldMk cId="2894237854" sldId="378"/>
            <ac:spMk id="32" creationId="{5AB1677A-6870-4561-A740-88474BE18313}"/>
          </ac:spMkLst>
        </pc:spChg>
        <pc:spChg chg="add mod">
          <ac:chgData name="Warner,Jeffrey Barr" userId="7360d018-3b8a-4d6d-8136-e4d170e1e616" providerId="ADAL" clId="{DB90B78A-78E0-4DA3-AE8A-B837C5EF1D5E}" dt="2021-04-22T14:15:04.969" v="940" actId="164"/>
          <ac:spMkLst>
            <pc:docMk/>
            <pc:sldMk cId="2894237854" sldId="378"/>
            <ac:spMk id="33" creationId="{ED5F0CC4-54CA-49B0-9D6E-7AEFCCB67412}"/>
          </ac:spMkLst>
        </pc:spChg>
        <pc:spChg chg="add mod">
          <ac:chgData name="Warner,Jeffrey Barr" userId="7360d018-3b8a-4d6d-8136-e4d170e1e616" providerId="ADAL" clId="{DB90B78A-78E0-4DA3-AE8A-B837C5EF1D5E}" dt="2021-04-22T14:15:04.969" v="940" actId="164"/>
          <ac:spMkLst>
            <pc:docMk/>
            <pc:sldMk cId="2894237854" sldId="378"/>
            <ac:spMk id="34" creationId="{BCE1124F-C42A-431C-B672-47DACE4E414B}"/>
          </ac:spMkLst>
        </pc:spChg>
        <pc:spChg chg="add mod">
          <ac:chgData name="Warner,Jeffrey Barr" userId="7360d018-3b8a-4d6d-8136-e4d170e1e616" providerId="ADAL" clId="{DB90B78A-78E0-4DA3-AE8A-B837C5EF1D5E}" dt="2021-04-22T14:15:04.969" v="940" actId="164"/>
          <ac:spMkLst>
            <pc:docMk/>
            <pc:sldMk cId="2894237854" sldId="378"/>
            <ac:spMk id="35" creationId="{CBDD886F-4DF3-4B6F-A0FD-F5BB4C8D6B03}"/>
          </ac:spMkLst>
        </pc:spChg>
        <pc:spChg chg="add mod">
          <ac:chgData name="Warner,Jeffrey Barr" userId="7360d018-3b8a-4d6d-8136-e4d170e1e616" providerId="ADAL" clId="{DB90B78A-78E0-4DA3-AE8A-B837C5EF1D5E}" dt="2021-04-22T14:15:04.969" v="940" actId="164"/>
          <ac:spMkLst>
            <pc:docMk/>
            <pc:sldMk cId="2894237854" sldId="378"/>
            <ac:spMk id="36" creationId="{6A50A5AE-4E51-431B-A8D3-C8E12541504F}"/>
          </ac:spMkLst>
        </pc:spChg>
        <pc:spChg chg="add mod">
          <ac:chgData name="Warner,Jeffrey Barr" userId="7360d018-3b8a-4d6d-8136-e4d170e1e616" providerId="ADAL" clId="{DB90B78A-78E0-4DA3-AE8A-B837C5EF1D5E}" dt="2021-04-22T14:15:04.969" v="940" actId="164"/>
          <ac:spMkLst>
            <pc:docMk/>
            <pc:sldMk cId="2894237854" sldId="378"/>
            <ac:spMk id="37" creationId="{85EE1438-6C3D-450F-A762-CFAD6F4212A5}"/>
          </ac:spMkLst>
        </pc:spChg>
        <pc:spChg chg="add mod">
          <ac:chgData name="Warner,Jeffrey Barr" userId="7360d018-3b8a-4d6d-8136-e4d170e1e616" providerId="ADAL" clId="{DB90B78A-78E0-4DA3-AE8A-B837C5EF1D5E}" dt="2021-04-22T14:15:08.657" v="941" actId="164"/>
          <ac:spMkLst>
            <pc:docMk/>
            <pc:sldMk cId="2894237854" sldId="378"/>
            <ac:spMk id="38" creationId="{2A29DFAC-A273-49AC-82D8-8BCF2C477D83}"/>
          </ac:spMkLst>
        </pc:spChg>
        <pc:spChg chg="add mod">
          <ac:chgData name="Warner,Jeffrey Barr" userId="7360d018-3b8a-4d6d-8136-e4d170e1e616" providerId="ADAL" clId="{DB90B78A-78E0-4DA3-AE8A-B837C5EF1D5E}" dt="2021-04-22T14:15:08.657" v="941" actId="164"/>
          <ac:spMkLst>
            <pc:docMk/>
            <pc:sldMk cId="2894237854" sldId="378"/>
            <ac:spMk id="39" creationId="{09936C11-C4D4-4D67-ADDD-868A198D9849}"/>
          </ac:spMkLst>
        </pc:spChg>
        <pc:spChg chg="add mod">
          <ac:chgData name="Warner,Jeffrey Barr" userId="7360d018-3b8a-4d6d-8136-e4d170e1e616" providerId="ADAL" clId="{DB90B78A-78E0-4DA3-AE8A-B837C5EF1D5E}" dt="2021-04-22T14:15:08.657" v="941" actId="164"/>
          <ac:spMkLst>
            <pc:docMk/>
            <pc:sldMk cId="2894237854" sldId="378"/>
            <ac:spMk id="40" creationId="{A9635E88-99F9-471C-BDF0-5BCA3B7AFB4C}"/>
          </ac:spMkLst>
        </pc:spChg>
        <pc:spChg chg="add mod">
          <ac:chgData name="Warner,Jeffrey Barr" userId="7360d018-3b8a-4d6d-8136-e4d170e1e616" providerId="ADAL" clId="{DB90B78A-78E0-4DA3-AE8A-B837C5EF1D5E}" dt="2021-04-22T14:15:08.657" v="941" actId="164"/>
          <ac:spMkLst>
            <pc:docMk/>
            <pc:sldMk cId="2894237854" sldId="378"/>
            <ac:spMk id="41" creationId="{31E92B81-991E-4621-BA7D-69CBF0E6817D}"/>
          </ac:spMkLst>
        </pc:spChg>
        <pc:spChg chg="add mod">
          <ac:chgData name="Warner,Jeffrey Barr" userId="7360d018-3b8a-4d6d-8136-e4d170e1e616" providerId="ADAL" clId="{DB90B78A-78E0-4DA3-AE8A-B837C5EF1D5E}" dt="2021-04-22T14:15:08.657" v="941" actId="164"/>
          <ac:spMkLst>
            <pc:docMk/>
            <pc:sldMk cId="2894237854" sldId="378"/>
            <ac:spMk id="42" creationId="{4C6C386B-94E4-4A2F-AFB1-8FC46F5E4684}"/>
          </ac:spMkLst>
        </pc:spChg>
        <pc:spChg chg="add mod">
          <ac:chgData name="Warner,Jeffrey Barr" userId="7360d018-3b8a-4d6d-8136-e4d170e1e616" providerId="ADAL" clId="{DB90B78A-78E0-4DA3-AE8A-B837C5EF1D5E}" dt="2021-04-22T14:15:08.657" v="941" actId="164"/>
          <ac:spMkLst>
            <pc:docMk/>
            <pc:sldMk cId="2894237854" sldId="378"/>
            <ac:spMk id="43" creationId="{1D06417D-3472-4A74-81EF-E021E490401F}"/>
          </ac:spMkLst>
        </pc:spChg>
        <pc:spChg chg="add mod">
          <ac:chgData name="Warner,Jeffrey Barr" userId="7360d018-3b8a-4d6d-8136-e4d170e1e616" providerId="ADAL" clId="{DB90B78A-78E0-4DA3-AE8A-B837C5EF1D5E}" dt="2021-04-22T14:15:08.657" v="941" actId="164"/>
          <ac:spMkLst>
            <pc:docMk/>
            <pc:sldMk cId="2894237854" sldId="378"/>
            <ac:spMk id="44" creationId="{FE5876D2-6B74-4265-810B-FCDB4290AE93}"/>
          </ac:spMkLst>
        </pc:spChg>
        <pc:spChg chg="add mod">
          <ac:chgData name="Warner,Jeffrey Barr" userId="7360d018-3b8a-4d6d-8136-e4d170e1e616" providerId="ADAL" clId="{DB90B78A-78E0-4DA3-AE8A-B837C5EF1D5E}" dt="2021-04-22T14:15:08.657" v="941" actId="164"/>
          <ac:spMkLst>
            <pc:docMk/>
            <pc:sldMk cId="2894237854" sldId="378"/>
            <ac:spMk id="45" creationId="{A24CFB4E-AD50-4669-A38F-02BD198866F4}"/>
          </ac:spMkLst>
        </pc:spChg>
        <pc:spChg chg="add mod">
          <ac:chgData name="Warner,Jeffrey Barr" userId="7360d018-3b8a-4d6d-8136-e4d170e1e616" providerId="ADAL" clId="{DB90B78A-78E0-4DA3-AE8A-B837C5EF1D5E}" dt="2021-04-22T14:15:08.657" v="941" actId="164"/>
          <ac:spMkLst>
            <pc:docMk/>
            <pc:sldMk cId="2894237854" sldId="378"/>
            <ac:spMk id="46" creationId="{257826AA-CDD8-49C6-AF6F-572210B22EE1}"/>
          </ac:spMkLst>
        </pc:spChg>
        <pc:spChg chg="add mod">
          <ac:chgData name="Warner,Jeffrey Barr" userId="7360d018-3b8a-4d6d-8136-e4d170e1e616" providerId="ADAL" clId="{DB90B78A-78E0-4DA3-AE8A-B837C5EF1D5E}" dt="2021-04-22T14:15:08.657" v="941" actId="164"/>
          <ac:spMkLst>
            <pc:docMk/>
            <pc:sldMk cId="2894237854" sldId="378"/>
            <ac:spMk id="47" creationId="{4526230A-6A56-41F7-92E7-A18264886BCD}"/>
          </ac:spMkLst>
        </pc:spChg>
        <pc:spChg chg="add mod">
          <ac:chgData name="Warner,Jeffrey Barr" userId="7360d018-3b8a-4d6d-8136-e4d170e1e616" providerId="ADAL" clId="{DB90B78A-78E0-4DA3-AE8A-B837C5EF1D5E}" dt="2021-04-22T14:15:08.657" v="941" actId="164"/>
          <ac:spMkLst>
            <pc:docMk/>
            <pc:sldMk cId="2894237854" sldId="378"/>
            <ac:spMk id="48" creationId="{15256448-CCF4-46EE-8467-EFF16AEF9A08}"/>
          </ac:spMkLst>
        </pc:spChg>
        <pc:spChg chg="add mod">
          <ac:chgData name="Warner,Jeffrey Barr" userId="7360d018-3b8a-4d6d-8136-e4d170e1e616" providerId="ADAL" clId="{DB90B78A-78E0-4DA3-AE8A-B837C5EF1D5E}" dt="2021-04-22T14:15:08.657" v="941" actId="164"/>
          <ac:spMkLst>
            <pc:docMk/>
            <pc:sldMk cId="2894237854" sldId="378"/>
            <ac:spMk id="49" creationId="{6DE76C3B-62D1-4BA1-BC39-16E06A4F99A3}"/>
          </ac:spMkLst>
        </pc:spChg>
        <pc:spChg chg="add mod">
          <ac:chgData name="Warner,Jeffrey Barr" userId="7360d018-3b8a-4d6d-8136-e4d170e1e616" providerId="ADAL" clId="{DB90B78A-78E0-4DA3-AE8A-B837C5EF1D5E}" dt="2021-04-22T14:15:08.657" v="941" actId="164"/>
          <ac:spMkLst>
            <pc:docMk/>
            <pc:sldMk cId="2894237854" sldId="378"/>
            <ac:spMk id="50" creationId="{8AE379CE-6254-4AAE-A2E1-70E91C80DE7E}"/>
          </ac:spMkLst>
        </pc:spChg>
        <pc:spChg chg="add mod">
          <ac:chgData name="Warner,Jeffrey Barr" userId="7360d018-3b8a-4d6d-8136-e4d170e1e616" providerId="ADAL" clId="{DB90B78A-78E0-4DA3-AE8A-B837C5EF1D5E}" dt="2021-04-22T14:15:08.657" v="941" actId="164"/>
          <ac:spMkLst>
            <pc:docMk/>
            <pc:sldMk cId="2894237854" sldId="378"/>
            <ac:spMk id="51" creationId="{E1C7CC3B-8561-450C-A798-EC6BB6E195A4}"/>
          </ac:spMkLst>
        </pc:spChg>
        <pc:spChg chg="add mod">
          <ac:chgData name="Warner,Jeffrey Barr" userId="7360d018-3b8a-4d6d-8136-e4d170e1e616" providerId="ADAL" clId="{DB90B78A-78E0-4DA3-AE8A-B837C5EF1D5E}" dt="2021-04-22T14:15:08.657" v="941" actId="164"/>
          <ac:spMkLst>
            <pc:docMk/>
            <pc:sldMk cId="2894237854" sldId="378"/>
            <ac:spMk id="52" creationId="{0E93D2BF-D6BD-43A9-85CA-8C3D459E9CAB}"/>
          </ac:spMkLst>
        </pc:spChg>
        <pc:spChg chg="add mod">
          <ac:chgData name="Warner,Jeffrey Barr" userId="7360d018-3b8a-4d6d-8136-e4d170e1e616" providerId="ADAL" clId="{DB90B78A-78E0-4DA3-AE8A-B837C5EF1D5E}" dt="2021-04-22T14:15:08.657" v="941" actId="164"/>
          <ac:spMkLst>
            <pc:docMk/>
            <pc:sldMk cId="2894237854" sldId="378"/>
            <ac:spMk id="53" creationId="{9D514C7C-A46A-45EC-8B4A-D55A4D6CBCC9}"/>
          </ac:spMkLst>
        </pc:spChg>
        <pc:spChg chg="add mod">
          <ac:chgData name="Warner,Jeffrey Barr" userId="7360d018-3b8a-4d6d-8136-e4d170e1e616" providerId="ADAL" clId="{DB90B78A-78E0-4DA3-AE8A-B837C5EF1D5E}" dt="2021-04-22T14:15:08.657" v="941" actId="164"/>
          <ac:spMkLst>
            <pc:docMk/>
            <pc:sldMk cId="2894237854" sldId="378"/>
            <ac:spMk id="54" creationId="{CD36E827-5783-45B7-A048-7938776AB4D5}"/>
          </ac:spMkLst>
        </pc:spChg>
        <pc:spChg chg="add mod">
          <ac:chgData name="Warner,Jeffrey Barr" userId="7360d018-3b8a-4d6d-8136-e4d170e1e616" providerId="ADAL" clId="{DB90B78A-78E0-4DA3-AE8A-B837C5EF1D5E}" dt="2021-04-22T14:15:08.657" v="941" actId="164"/>
          <ac:spMkLst>
            <pc:docMk/>
            <pc:sldMk cId="2894237854" sldId="378"/>
            <ac:spMk id="55" creationId="{F5654D98-F412-4F91-94AA-7AC8A7447B16}"/>
          </ac:spMkLst>
        </pc:spChg>
        <pc:spChg chg="add mod">
          <ac:chgData name="Warner,Jeffrey Barr" userId="7360d018-3b8a-4d6d-8136-e4d170e1e616" providerId="ADAL" clId="{DB90B78A-78E0-4DA3-AE8A-B837C5EF1D5E}" dt="2021-04-22T14:15:08.657" v="941" actId="164"/>
          <ac:spMkLst>
            <pc:docMk/>
            <pc:sldMk cId="2894237854" sldId="378"/>
            <ac:spMk id="56" creationId="{5F6BED2C-06D0-4AC8-A175-45214B5EF582}"/>
          </ac:spMkLst>
        </pc:spChg>
        <pc:spChg chg="add mod">
          <ac:chgData name="Warner,Jeffrey Barr" userId="7360d018-3b8a-4d6d-8136-e4d170e1e616" providerId="ADAL" clId="{DB90B78A-78E0-4DA3-AE8A-B837C5EF1D5E}" dt="2021-04-22T14:21:48.128" v="1080" actId="164"/>
          <ac:spMkLst>
            <pc:docMk/>
            <pc:sldMk cId="2894237854" sldId="378"/>
            <ac:spMk id="61" creationId="{838598AE-9BF8-4B63-B3D0-0E1BF8BAE2B1}"/>
          </ac:spMkLst>
        </pc:spChg>
        <pc:spChg chg="add mod">
          <ac:chgData name="Warner,Jeffrey Barr" userId="7360d018-3b8a-4d6d-8136-e4d170e1e616" providerId="ADAL" clId="{DB90B78A-78E0-4DA3-AE8A-B837C5EF1D5E}" dt="2021-04-22T14:21:48.128" v="1080" actId="164"/>
          <ac:spMkLst>
            <pc:docMk/>
            <pc:sldMk cId="2894237854" sldId="378"/>
            <ac:spMk id="62" creationId="{40844577-6DD8-40BF-BABB-D4BD7AF66D6A}"/>
          </ac:spMkLst>
        </pc:spChg>
        <pc:spChg chg="add mod ord">
          <ac:chgData name="Warner,Jeffrey Barr" userId="7360d018-3b8a-4d6d-8136-e4d170e1e616" providerId="ADAL" clId="{DB90B78A-78E0-4DA3-AE8A-B837C5EF1D5E}" dt="2021-04-22T14:21:48.128" v="1080" actId="164"/>
          <ac:spMkLst>
            <pc:docMk/>
            <pc:sldMk cId="2894237854" sldId="378"/>
            <ac:spMk id="63" creationId="{396AF8A6-5B0E-463F-95CE-CAAD5AD99F44}"/>
          </ac:spMkLst>
        </pc:spChg>
        <pc:spChg chg="add mod">
          <ac:chgData name="Warner,Jeffrey Barr" userId="7360d018-3b8a-4d6d-8136-e4d170e1e616" providerId="ADAL" clId="{DB90B78A-78E0-4DA3-AE8A-B837C5EF1D5E}" dt="2021-05-12T13:54:48.082" v="5081" actId="20577"/>
          <ac:spMkLst>
            <pc:docMk/>
            <pc:sldMk cId="2894237854" sldId="378"/>
            <ac:spMk id="64" creationId="{80F1F01C-0CC7-43C7-B956-12B2FBBB2CB2}"/>
          </ac:spMkLst>
        </pc:spChg>
        <pc:spChg chg="mod topLvl">
          <ac:chgData name="Warner,Jeffrey Barr" userId="7360d018-3b8a-4d6d-8136-e4d170e1e616" providerId="ADAL" clId="{DB90B78A-78E0-4DA3-AE8A-B837C5EF1D5E}" dt="2021-04-22T14:05:15.704" v="17" actId="165"/>
          <ac:spMkLst>
            <pc:docMk/>
            <pc:sldMk cId="2894237854" sldId="378"/>
            <ac:spMk id="112" creationId="{87DBCD17-5877-4F64-8234-EDE677CCDF5C}"/>
          </ac:spMkLst>
        </pc:spChg>
        <pc:spChg chg="mod topLvl">
          <ac:chgData name="Warner,Jeffrey Barr" userId="7360d018-3b8a-4d6d-8136-e4d170e1e616" providerId="ADAL" clId="{DB90B78A-78E0-4DA3-AE8A-B837C5EF1D5E}" dt="2021-04-22T14:05:15.704" v="17" actId="165"/>
          <ac:spMkLst>
            <pc:docMk/>
            <pc:sldMk cId="2894237854" sldId="378"/>
            <ac:spMk id="113" creationId="{9F50A1E3-E37B-4D94-B34F-6F1ADEB105E1}"/>
          </ac:spMkLst>
        </pc:spChg>
        <pc:spChg chg="mod topLvl">
          <ac:chgData name="Warner,Jeffrey Barr" userId="7360d018-3b8a-4d6d-8136-e4d170e1e616" providerId="ADAL" clId="{DB90B78A-78E0-4DA3-AE8A-B837C5EF1D5E}" dt="2021-04-22T14:05:15.704" v="17" actId="165"/>
          <ac:spMkLst>
            <pc:docMk/>
            <pc:sldMk cId="2894237854" sldId="378"/>
            <ac:spMk id="114" creationId="{D38FC863-A878-4573-B57C-AEB8FF6024BF}"/>
          </ac:spMkLst>
        </pc:spChg>
        <pc:spChg chg="mod">
          <ac:chgData name="Warner,Jeffrey Barr" userId="7360d018-3b8a-4d6d-8136-e4d170e1e616" providerId="ADAL" clId="{DB90B78A-78E0-4DA3-AE8A-B837C5EF1D5E}" dt="2021-04-22T14:18:32.798" v="1038" actId="207"/>
          <ac:spMkLst>
            <pc:docMk/>
            <pc:sldMk cId="2894237854" sldId="378"/>
            <ac:spMk id="127" creationId="{316C4A25-D3F8-4412-9A2C-2A63971BFAB0}"/>
          </ac:spMkLst>
        </pc:spChg>
        <pc:spChg chg="mod">
          <ac:chgData name="Warner,Jeffrey Barr" userId="7360d018-3b8a-4d6d-8136-e4d170e1e616" providerId="ADAL" clId="{DB90B78A-78E0-4DA3-AE8A-B837C5EF1D5E}" dt="2021-04-22T14:05:15.704" v="17" actId="165"/>
          <ac:spMkLst>
            <pc:docMk/>
            <pc:sldMk cId="2894237854" sldId="378"/>
            <ac:spMk id="128" creationId="{0A78F162-921B-4523-9AC5-1FDC016AD6AA}"/>
          </ac:spMkLst>
        </pc:spChg>
        <pc:grpChg chg="mod topLvl">
          <ac:chgData name="Warner,Jeffrey Barr" userId="7360d018-3b8a-4d6d-8136-e4d170e1e616" providerId="ADAL" clId="{DB90B78A-78E0-4DA3-AE8A-B837C5EF1D5E}" dt="2021-04-22T14:15:24.585" v="1009" actId="478"/>
          <ac:grpSpMkLst>
            <pc:docMk/>
            <pc:sldMk cId="2894237854" sldId="378"/>
            <ac:grpSpMk id="5" creationId="{96A9996D-3992-46E2-A878-1040C6E2AF2E}"/>
          </ac:grpSpMkLst>
        </pc:grpChg>
        <pc:grpChg chg="del mod topLvl">
          <ac:chgData name="Warner,Jeffrey Barr" userId="7360d018-3b8a-4d6d-8136-e4d170e1e616" providerId="ADAL" clId="{DB90B78A-78E0-4DA3-AE8A-B837C5EF1D5E}" dt="2021-04-22T14:15:24.585" v="1009" actId="478"/>
          <ac:grpSpMkLst>
            <pc:docMk/>
            <pc:sldMk cId="2894237854" sldId="378"/>
            <ac:grpSpMk id="6" creationId="{791F2A71-95AA-4C90-A75B-ACB1C36F5D69}"/>
          </ac:grpSpMkLst>
        </pc:grpChg>
        <pc:grpChg chg="del">
          <ac:chgData name="Warner,Jeffrey Barr" userId="7360d018-3b8a-4d6d-8136-e4d170e1e616" providerId="ADAL" clId="{DB90B78A-78E0-4DA3-AE8A-B837C5EF1D5E}" dt="2021-04-22T14:05:15.704" v="17" actId="165"/>
          <ac:grpSpMkLst>
            <pc:docMk/>
            <pc:sldMk cId="2894237854" sldId="378"/>
            <ac:grpSpMk id="7" creationId="{369BEF2E-15B0-41A2-A817-A3B9049A63D4}"/>
          </ac:grpSpMkLst>
        </pc:grpChg>
        <pc:grpChg chg="add mod">
          <ac:chgData name="Warner,Jeffrey Barr" userId="7360d018-3b8a-4d6d-8136-e4d170e1e616" providerId="ADAL" clId="{DB90B78A-78E0-4DA3-AE8A-B837C5EF1D5E}" dt="2021-04-22T14:15:30.583" v="1010" actId="1076"/>
          <ac:grpSpMkLst>
            <pc:docMk/>
            <pc:sldMk cId="2894237854" sldId="378"/>
            <ac:grpSpMk id="10" creationId="{83212962-8050-47CD-9285-663E085CF81F}"/>
          </ac:grpSpMkLst>
        </pc:grpChg>
        <pc:grpChg chg="add mod">
          <ac:chgData name="Warner,Jeffrey Barr" userId="7360d018-3b8a-4d6d-8136-e4d170e1e616" providerId="ADAL" clId="{DB90B78A-78E0-4DA3-AE8A-B837C5EF1D5E}" dt="2021-04-22T14:15:30.583" v="1010" actId="1076"/>
          <ac:grpSpMkLst>
            <pc:docMk/>
            <pc:sldMk cId="2894237854" sldId="378"/>
            <ac:grpSpMk id="11" creationId="{FFA5EDA9-0C6A-4CD6-89DE-FB20C7C9E015}"/>
          </ac:grpSpMkLst>
        </pc:grpChg>
        <pc:grpChg chg="add mod">
          <ac:chgData name="Warner,Jeffrey Barr" userId="7360d018-3b8a-4d6d-8136-e4d170e1e616" providerId="ADAL" clId="{DB90B78A-78E0-4DA3-AE8A-B837C5EF1D5E}" dt="2021-04-22T14:21:48.128" v="1080" actId="164"/>
          <ac:grpSpMkLst>
            <pc:docMk/>
            <pc:sldMk cId="2894237854" sldId="378"/>
            <ac:grpSpMk id="14" creationId="{228B1148-9B8E-49F2-868D-E986DC4564CC}"/>
          </ac:grpSpMkLst>
        </pc:grpChg>
        <pc:graphicFrameChg chg="add mod ord">
          <ac:chgData name="Warner,Jeffrey Barr" userId="7360d018-3b8a-4d6d-8136-e4d170e1e616" providerId="ADAL" clId="{DB90B78A-78E0-4DA3-AE8A-B837C5EF1D5E}" dt="2021-04-22T14:21:48.128" v="1080" actId="164"/>
          <ac:graphicFrameMkLst>
            <pc:docMk/>
            <pc:sldMk cId="2894237854" sldId="378"/>
            <ac:graphicFrameMk id="13" creationId="{0CE65638-3E52-4D10-8675-160C1447ECE8}"/>
          </ac:graphicFrameMkLst>
        </pc:graphicFrameChg>
        <pc:picChg chg="add mod ord">
          <ac:chgData name="Warner,Jeffrey Barr" userId="7360d018-3b8a-4d6d-8136-e4d170e1e616" providerId="ADAL" clId="{DB90B78A-78E0-4DA3-AE8A-B837C5EF1D5E}" dt="2021-04-22T14:05:37.624" v="36" actId="1037"/>
          <ac:picMkLst>
            <pc:docMk/>
            <pc:sldMk cId="2894237854" sldId="378"/>
            <ac:picMk id="2" creationId="{7B54F9D2-E1A0-49BE-82BF-DE55F709B834}"/>
          </ac:picMkLst>
        </pc:picChg>
        <pc:picChg chg="del mod topLvl">
          <ac:chgData name="Warner,Jeffrey Barr" userId="7360d018-3b8a-4d6d-8136-e4d170e1e616" providerId="ADAL" clId="{DB90B78A-78E0-4DA3-AE8A-B837C5EF1D5E}" dt="2021-04-22T14:17:52.647" v="1026" actId="478"/>
          <ac:picMkLst>
            <pc:docMk/>
            <pc:sldMk cId="2894237854" sldId="378"/>
            <ac:picMk id="3" creationId="{E087850E-62BA-4883-A09C-4F6E4DDFBD60}"/>
          </ac:picMkLst>
        </pc:picChg>
        <pc:picChg chg="add del mod">
          <ac:chgData name="Warner,Jeffrey Barr" userId="7360d018-3b8a-4d6d-8136-e4d170e1e616" providerId="ADAL" clId="{DB90B78A-78E0-4DA3-AE8A-B837C5EF1D5E}" dt="2021-04-22T14:03:12.936" v="16"/>
          <ac:picMkLst>
            <pc:docMk/>
            <pc:sldMk cId="2894237854" sldId="378"/>
            <ac:picMk id="15" creationId="{50935A7A-20BF-44EF-BEB5-017EA2AAF415}"/>
          </ac:picMkLst>
        </pc:picChg>
        <pc:picChg chg="del mod topLvl">
          <ac:chgData name="Warner,Jeffrey Barr" userId="7360d018-3b8a-4d6d-8136-e4d170e1e616" providerId="ADAL" clId="{DB90B78A-78E0-4DA3-AE8A-B837C5EF1D5E}" dt="2021-04-22T14:05:33.247" v="25" actId="478"/>
          <ac:picMkLst>
            <pc:docMk/>
            <pc:sldMk cId="2894237854" sldId="378"/>
            <ac:picMk id="19" creationId="{19EAF66E-9A60-474F-9568-7DE4E0F778CA}"/>
          </ac:picMkLst>
        </pc:picChg>
        <pc:picChg chg="mod">
          <ac:chgData name="Warner,Jeffrey Barr" userId="7360d018-3b8a-4d6d-8136-e4d170e1e616" providerId="ADAL" clId="{DB90B78A-78E0-4DA3-AE8A-B837C5EF1D5E}" dt="2021-04-22T14:05:15.704" v="17" actId="165"/>
          <ac:picMkLst>
            <pc:docMk/>
            <pc:sldMk cId="2894237854" sldId="378"/>
            <ac:picMk id="123" creationId="{4718C890-240F-4F3D-9F48-4B83EB72514B}"/>
          </ac:picMkLst>
        </pc:picChg>
        <pc:picChg chg="del mod topLvl">
          <ac:chgData name="Warner,Jeffrey Barr" userId="7360d018-3b8a-4d6d-8136-e4d170e1e616" providerId="ADAL" clId="{DB90B78A-78E0-4DA3-AE8A-B837C5EF1D5E}" dt="2021-04-22T14:15:24.585" v="1009" actId="478"/>
          <ac:picMkLst>
            <pc:docMk/>
            <pc:sldMk cId="2894237854" sldId="378"/>
            <ac:picMk id="124" creationId="{BB3DD7A0-DC56-4BEF-9B3B-8B17E94E0925}"/>
          </ac:picMkLst>
        </pc:picChg>
      </pc:sldChg>
      <pc:sldChg chg="addSp delSp mod">
        <pc:chgData name="Warner,Jeffrey Barr" userId="7360d018-3b8a-4d6d-8136-e4d170e1e616" providerId="ADAL" clId="{DB90B78A-78E0-4DA3-AE8A-B837C5EF1D5E}" dt="2021-04-22T03:42:30.151" v="1"/>
        <pc:sldMkLst>
          <pc:docMk/>
          <pc:sldMk cId="578729457" sldId="383"/>
        </pc:sldMkLst>
        <pc:picChg chg="add">
          <ac:chgData name="Warner,Jeffrey Barr" userId="7360d018-3b8a-4d6d-8136-e4d170e1e616" providerId="ADAL" clId="{DB90B78A-78E0-4DA3-AE8A-B837C5EF1D5E}" dt="2021-04-22T03:42:30.151" v="1"/>
          <ac:picMkLst>
            <pc:docMk/>
            <pc:sldMk cId="578729457" sldId="383"/>
            <ac:picMk id="2" creationId="{00B42262-4B40-4D35-AC69-87F7C2F4AA26}"/>
          </ac:picMkLst>
        </pc:picChg>
        <pc:picChg chg="del">
          <ac:chgData name="Warner,Jeffrey Barr" userId="7360d018-3b8a-4d6d-8136-e4d170e1e616" providerId="ADAL" clId="{DB90B78A-78E0-4DA3-AE8A-B837C5EF1D5E}" dt="2021-04-22T03:42:27.199" v="0" actId="478"/>
          <ac:picMkLst>
            <pc:docMk/>
            <pc:sldMk cId="578729457" sldId="383"/>
            <ac:picMk id="5" creationId="{D973C271-C9CD-4967-BB60-6EBCB48AFA58}"/>
          </ac:picMkLst>
        </pc:picChg>
      </pc:sldChg>
      <pc:sldChg chg="addSp modSp mod addCm modCm">
        <pc:chgData name="Warner,Jeffrey Barr" userId="7360d018-3b8a-4d6d-8136-e4d170e1e616" providerId="ADAL" clId="{DB90B78A-78E0-4DA3-AE8A-B837C5EF1D5E}" dt="2021-05-12T14:01:05.353" v="5113"/>
        <pc:sldMkLst>
          <pc:docMk/>
          <pc:sldMk cId="2823416257" sldId="386"/>
        </pc:sldMkLst>
        <pc:spChg chg="mod">
          <ac:chgData name="Warner,Jeffrey Barr" userId="7360d018-3b8a-4d6d-8136-e4d170e1e616" providerId="ADAL" clId="{DB90B78A-78E0-4DA3-AE8A-B837C5EF1D5E}" dt="2021-04-22T14:55:47.230" v="4392" actId="20577"/>
          <ac:spMkLst>
            <pc:docMk/>
            <pc:sldMk cId="2823416257" sldId="386"/>
            <ac:spMk id="4" creationId="{1FFDC7BE-AE0B-A147-8969-5948A176CA10}"/>
          </ac:spMkLst>
        </pc:spChg>
        <pc:spChg chg="mod">
          <ac:chgData name="Warner,Jeffrey Barr" userId="7360d018-3b8a-4d6d-8136-e4d170e1e616" providerId="ADAL" clId="{DB90B78A-78E0-4DA3-AE8A-B837C5EF1D5E}" dt="2021-04-22T14:56:54.267" v="4394"/>
          <ac:spMkLst>
            <pc:docMk/>
            <pc:sldMk cId="2823416257" sldId="386"/>
            <ac:spMk id="6" creationId="{700E6A53-F70D-4AA1-8E86-9B71724F81AF}"/>
          </ac:spMkLst>
        </pc:spChg>
        <pc:spChg chg="mod">
          <ac:chgData name="Warner,Jeffrey Barr" userId="7360d018-3b8a-4d6d-8136-e4d170e1e616" providerId="ADAL" clId="{DB90B78A-78E0-4DA3-AE8A-B837C5EF1D5E}" dt="2021-04-22T14:56:54.267" v="4394"/>
          <ac:spMkLst>
            <pc:docMk/>
            <pc:sldMk cId="2823416257" sldId="386"/>
            <ac:spMk id="7" creationId="{4EB07796-7C64-440D-914C-19C09D61CE19}"/>
          </ac:spMkLst>
        </pc:spChg>
        <pc:spChg chg="mod">
          <ac:chgData name="Warner,Jeffrey Barr" userId="7360d018-3b8a-4d6d-8136-e4d170e1e616" providerId="ADAL" clId="{DB90B78A-78E0-4DA3-AE8A-B837C5EF1D5E}" dt="2021-04-22T14:56:54.267" v="4394"/>
          <ac:spMkLst>
            <pc:docMk/>
            <pc:sldMk cId="2823416257" sldId="386"/>
            <ac:spMk id="8" creationId="{10230BEB-901F-4B20-B375-30D8B44015AD}"/>
          </ac:spMkLst>
        </pc:spChg>
        <pc:spChg chg="mod">
          <ac:chgData name="Warner,Jeffrey Barr" userId="7360d018-3b8a-4d6d-8136-e4d170e1e616" providerId="ADAL" clId="{DB90B78A-78E0-4DA3-AE8A-B837C5EF1D5E}" dt="2021-04-22T14:56:54.267" v="4394"/>
          <ac:spMkLst>
            <pc:docMk/>
            <pc:sldMk cId="2823416257" sldId="386"/>
            <ac:spMk id="9" creationId="{3F441161-3E3B-46AC-AB22-EEBC27F11FD2}"/>
          </ac:spMkLst>
        </pc:spChg>
        <pc:spChg chg="add mod">
          <ac:chgData name="Warner,Jeffrey Barr" userId="7360d018-3b8a-4d6d-8136-e4d170e1e616" providerId="ADAL" clId="{DB90B78A-78E0-4DA3-AE8A-B837C5EF1D5E}" dt="2021-04-25T15:13:07.226" v="4768" actId="12789"/>
          <ac:spMkLst>
            <pc:docMk/>
            <pc:sldMk cId="2823416257" sldId="386"/>
            <ac:spMk id="10" creationId="{769D35D3-9431-4C91-9BC4-051B93ABC7AD}"/>
          </ac:spMkLst>
        </pc:spChg>
        <pc:spChg chg="add mod">
          <ac:chgData name="Warner,Jeffrey Barr" userId="7360d018-3b8a-4d6d-8136-e4d170e1e616" providerId="ADAL" clId="{DB90B78A-78E0-4DA3-AE8A-B837C5EF1D5E}" dt="2021-04-25T15:13:13.934" v="4770" actId="20577"/>
          <ac:spMkLst>
            <pc:docMk/>
            <pc:sldMk cId="2823416257" sldId="386"/>
            <ac:spMk id="11" creationId="{464F6F2E-F016-42EA-8069-E8C19FFCFE46}"/>
          </ac:spMkLst>
        </pc:spChg>
        <pc:spChg chg="add mod">
          <ac:chgData name="Warner,Jeffrey Barr" userId="7360d018-3b8a-4d6d-8136-e4d170e1e616" providerId="ADAL" clId="{DB90B78A-78E0-4DA3-AE8A-B837C5EF1D5E}" dt="2021-04-25T15:13:15.334" v="4771" actId="20577"/>
          <ac:spMkLst>
            <pc:docMk/>
            <pc:sldMk cId="2823416257" sldId="386"/>
            <ac:spMk id="12" creationId="{53D2622A-68CC-4624-95F0-6200F063020B}"/>
          </ac:spMkLst>
        </pc:spChg>
        <pc:spChg chg="add mod">
          <ac:chgData name="Warner,Jeffrey Barr" userId="7360d018-3b8a-4d6d-8136-e4d170e1e616" providerId="ADAL" clId="{DB90B78A-78E0-4DA3-AE8A-B837C5EF1D5E}" dt="2021-04-25T15:13:16.406" v="4772" actId="20577"/>
          <ac:spMkLst>
            <pc:docMk/>
            <pc:sldMk cId="2823416257" sldId="386"/>
            <ac:spMk id="13" creationId="{419CA558-8D2F-4529-B459-497BC5A490A1}"/>
          </ac:spMkLst>
        </pc:spChg>
        <pc:spChg chg="add mod">
          <ac:chgData name="Warner,Jeffrey Barr" userId="7360d018-3b8a-4d6d-8136-e4d170e1e616" providerId="ADAL" clId="{DB90B78A-78E0-4DA3-AE8A-B837C5EF1D5E}" dt="2021-04-25T15:13:17.822" v="4773" actId="20577"/>
          <ac:spMkLst>
            <pc:docMk/>
            <pc:sldMk cId="2823416257" sldId="386"/>
            <ac:spMk id="14" creationId="{102A5AA5-7643-4EF9-9778-E6A4F61D4868}"/>
          </ac:spMkLst>
        </pc:spChg>
        <pc:spChg chg="add mod">
          <ac:chgData name="Warner,Jeffrey Barr" userId="7360d018-3b8a-4d6d-8136-e4d170e1e616" providerId="ADAL" clId="{DB90B78A-78E0-4DA3-AE8A-B837C5EF1D5E}" dt="2021-04-25T15:13:20.110" v="4776" actId="20577"/>
          <ac:spMkLst>
            <pc:docMk/>
            <pc:sldMk cId="2823416257" sldId="386"/>
            <ac:spMk id="15" creationId="{F370090F-7C32-4DF7-9684-91587FC4DD4D}"/>
          </ac:spMkLst>
        </pc:spChg>
        <pc:spChg chg="add mod">
          <ac:chgData name="Warner,Jeffrey Barr" userId="7360d018-3b8a-4d6d-8136-e4d170e1e616" providerId="ADAL" clId="{DB90B78A-78E0-4DA3-AE8A-B837C5EF1D5E}" dt="2021-04-25T15:13:21.462" v="4777" actId="20577"/>
          <ac:spMkLst>
            <pc:docMk/>
            <pc:sldMk cId="2823416257" sldId="386"/>
            <ac:spMk id="16" creationId="{D91C37EB-EAE9-431E-97F5-FA7B8263556D}"/>
          </ac:spMkLst>
        </pc:spChg>
        <pc:grpChg chg="add mod">
          <ac:chgData name="Warner,Jeffrey Barr" userId="7360d018-3b8a-4d6d-8136-e4d170e1e616" providerId="ADAL" clId="{DB90B78A-78E0-4DA3-AE8A-B837C5EF1D5E}" dt="2021-04-22T14:56:57.430" v="4396" actId="1076"/>
          <ac:grpSpMkLst>
            <pc:docMk/>
            <pc:sldMk cId="2823416257" sldId="386"/>
            <ac:grpSpMk id="5" creationId="{7E9EF5B5-AC8A-4C7A-854F-692A5EF6CF41}"/>
          </ac:grpSpMkLst>
        </pc:grpChg>
        <pc:graphicFrameChg chg="add mod">
          <ac:chgData name="Warner,Jeffrey Barr" userId="7360d018-3b8a-4d6d-8136-e4d170e1e616" providerId="ADAL" clId="{DB90B78A-78E0-4DA3-AE8A-B837C5EF1D5E}" dt="2021-05-12T14:01:05.353" v="5113"/>
          <ac:graphicFrameMkLst>
            <pc:docMk/>
            <pc:sldMk cId="2823416257" sldId="386"/>
            <ac:graphicFrameMk id="3" creationId="{0C9BD14C-B8F5-486E-AE0C-616CEA8325E0}"/>
          </ac:graphicFrameMkLst>
        </pc:graphicFrameChg>
      </pc:sldChg>
      <pc:sldChg chg="addSp delSp modSp mod">
        <pc:chgData name="Warner,Jeffrey Barr" userId="7360d018-3b8a-4d6d-8136-e4d170e1e616" providerId="ADAL" clId="{DB90B78A-78E0-4DA3-AE8A-B837C5EF1D5E}" dt="2021-05-12T13:48:05.544" v="5025" actId="207"/>
        <pc:sldMkLst>
          <pc:docMk/>
          <pc:sldMk cId="500895388" sldId="387"/>
        </pc:sldMkLst>
        <pc:spChg chg="mod">
          <ac:chgData name="Warner,Jeffrey Barr" userId="7360d018-3b8a-4d6d-8136-e4d170e1e616" providerId="ADAL" clId="{DB90B78A-78E0-4DA3-AE8A-B837C5EF1D5E}" dt="2021-04-25T18:12:43.581" v="4792" actId="20577"/>
          <ac:spMkLst>
            <pc:docMk/>
            <pc:sldMk cId="500895388" sldId="387"/>
            <ac:spMk id="4" creationId="{3D8F291D-DFAD-46E7-A1B0-9A87B59D0FC0}"/>
          </ac:spMkLst>
        </pc:spChg>
        <pc:spChg chg="add del mod">
          <ac:chgData name="Warner,Jeffrey Barr" userId="7360d018-3b8a-4d6d-8136-e4d170e1e616" providerId="ADAL" clId="{DB90B78A-78E0-4DA3-AE8A-B837C5EF1D5E}" dt="2021-04-25T15:13:24.830" v="4779"/>
          <ac:spMkLst>
            <pc:docMk/>
            <pc:sldMk cId="500895388" sldId="387"/>
            <ac:spMk id="34" creationId="{97BC468D-6D33-467B-AD7B-2200944A35ED}"/>
          </ac:spMkLst>
        </pc:spChg>
        <pc:spChg chg="mod">
          <ac:chgData name="Warner,Jeffrey Barr" userId="7360d018-3b8a-4d6d-8136-e4d170e1e616" providerId="ADAL" clId="{DB90B78A-78E0-4DA3-AE8A-B837C5EF1D5E}" dt="2021-05-12T13:48:03.045" v="5024" actId="207"/>
          <ac:spMkLst>
            <pc:docMk/>
            <pc:sldMk cId="500895388" sldId="387"/>
            <ac:spMk id="38" creationId="{85F52613-BFCE-4902-BDE8-EA4E928C8BFB}"/>
          </ac:spMkLst>
        </pc:spChg>
        <pc:spChg chg="mod">
          <ac:chgData name="Warner,Jeffrey Barr" userId="7360d018-3b8a-4d6d-8136-e4d170e1e616" providerId="ADAL" clId="{DB90B78A-78E0-4DA3-AE8A-B837C5EF1D5E}" dt="2021-05-12T13:48:05.544" v="5025" actId="207"/>
          <ac:spMkLst>
            <pc:docMk/>
            <pc:sldMk cId="500895388" sldId="387"/>
            <ac:spMk id="39" creationId="{EC358F75-276E-439A-8994-677D5EC79E0A}"/>
          </ac:spMkLst>
        </pc:spChg>
      </pc:sldChg>
      <pc:sldChg chg="addSp modSp mod">
        <pc:chgData name="Warner,Jeffrey Barr" userId="7360d018-3b8a-4d6d-8136-e4d170e1e616" providerId="ADAL" clId="{DB90B78A-78E0-4DA3-AE8A-B837C5EF1D5E}" dt="2021-05-12T13:51:15.690" v="5039"/>
        <pc:sldMkLst>
          <pc:docMk/>
          <pc:sldMk cId="3345563794" sldId="388"/>
        </pc:sldMkLst>
        <pc:spChg chg="add mod">
          <ac:chgData name="Warner,Jeffrey Barr" userId="7360d018-3b8a-4d6d-8136-e4d170e1e616" providerId="ADAL" clId="{DB90B78A-78E0-4DA3-AE8A-B837C5EF1D5E}" dt="2021-04-25T15:13:49.594" v="4789" actId="12789"/>
          <ac:spMkLst>
            <pc:docMk/>
            <pc:sldMk cId="3345563794" sldId="388"/>
            <ac:spMk id="22" creationId="{FB36D9B7-A6AC-411C-93B6-1A576F417288}"/>
          </ac:spMkLst>
        </pc:spChg>
        <pc:spChg chg="add mod">
          <ac:chgData name="Warner,Jeffrey Barr" userId="7360d018-3b8a-4d6d-8136-e4d170e1e616" providerId="ADAL" clId="{DB90B78A-78E0-4DA3-AE8A-B837C5EF1D5E}" dt="2021-04-25T15:13:49.594" v="4789" actId="12789"/>
          <ac:spMkLst>
            <pc:docMk/>
            <pc:sldMk cId="3345563794" sldId="388"/>
            <ac:spMk id="23" creationId="{CD44D0FD-7EB4-49E3-8908-45EF2D16999F}"/>
          </ac:spMkLst>
        </pc:spChg>
        <pc:spChg chg="add mod">
          <ac:chgData name="Warner,Jeffrey Barr" userId="7360d018-3b8a-4d6d-8136-e4d170e1e616" providerId="ADAL" clId="{DB90B78A-78E0-4DA3-AE8A-B837C5EF1D5E}" dt="2021-04-25T15:13:49.594" v="4789" actId="12789"/>
          <ac:spMkLst>
            <pc:docMk/>
            <pc:sldMk cId="3345563794" sldId="388"/>
            <ac:spMk id="24" creationId="{2BF8B10B-8E2D-44A7-8DB9-8ED5492859D0}"/>
          </ac:spMkLst>
        </pc:spChg>
        <pc:graphicFrameChg chg="mod">
          <ac:chgData name="Warner,Jeffrey Barr" userId="7360d018-3b8a-4d6d-8136-e4d170e1e616" providerId="ADAL" clId="{DB90B78A-78E0-4DA3-AE8A-B837C5EF1D5E}" dt="2021-05-12T13:49:42.824" v="5031"/>
          <ac:graphicFrameMkLst>
            <pc:docMk/>
            <pc:sldMk cId="3345563794" sldId="388"/>
            <ac:graphicFrameMk id="5" creationId="{CB54D22E-FEB0-4C5E-9C74-471EABDFD0CD}"/>
          </ac:graphicFrameMkLst>
        </pc:graphicFrameChg>
        <pc:graphicFrameChg chg="mod">
          <ac:chgData name="Warner,Jeffrey Barr" userId="7360d018-3b8a-4d6d-8136-e4d170e1e616" providerId="ADAL" clId="{DB90B78A-78E0-4DA3-AE8A-B837C5EF1D5E}" dt="2021-05-12T13:49:58.092" v="5033"/>
          <ac:graphicFrameMkLst>
            <pc:docMk/>
            <pc:sldMk cId="3345563794" sldId="388"/>
            <ac:graphicFrameMk id="10" creationId="{05D20F71-7B16-4A5A-8365-0082898DF956}"/>
          </ac:graphicFrameMkLst>
        </pc:graphicFrameChg>
        <pc:graphicFrameChg chg="mod">
          <ac:chgData name="Warner,Jeffrey Barr" userId="7360d018-3b8a-4d6d-8136-e4d170e1e616" providerId="ADAL" clId="{DB90B78A-78E0-4DA3-AE8A-B837C5EF1D5E}" dt="2021-05-12T13:50:55.471" v="5037"/>
          <ac:graphicFrameMkLst>
            <pc:docMk/>
            <pc:sldMk cId="3345563794" sldId="388"/>
            <ac:graphicFrameMk id="11" creationId="{3033C1BE-8F89-4D09-9A8F-F2C8DE770C87}"/>
          </ac:graphicFrameMkLst>
        </pc:graphicFrameChg>
        <pc:graphicFrameChg chg="mod">
          <ac:chgData name="Warner,Jeffrey Barr" userId="7360d018-3b8a-4d6d-8136-e4d170e1e616" providerId="ADAL" clId="{DB90B78A-78E0-4DA3-AE8A-B837C5EF1D5E}" dt="2021-05-12T13:50:29.342" v="5035"/>
          <ac:graphicFrameMkLst>
            <pc:docMk/>
            <pc:sldMk cId="3345563794" sldId="388"/>
            <ac:graphicFrameMk id="25" creationId="{AF44CE8B-DFB0-4FA8-AAD0-A916B354C02A}"/>
          </ac:graphicFrameMkLst>
        </pc:graphicFrameChg>
        <pc:graphicFrameChg chg="mod">
          <ac:chgData name="Warner,Jeffrey Barr" userId="7360d018-3b8a-4d6d-8136-e4d170e1e616" providerId="ADAL" clId="{DB90B78A-78E0-4DA3-AE8A-B837C5EF1D5E}" dt="2021-05-12T13:51:15.690" v="5039"/>
          <ac:graphicFrameMkLst>
            <pc:docMk/>
            <pc:sldMk cId="3345563794" sldId="388"/>
            <ac:graphicFrameMk id="26" creationId="{011B732D-C5BA-481C-95E1-674A26CB9416}"/>
          </ac:graphicFrameMkLst>
        </pc:graphicFrame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11699" cy="463408"/>
          </a:xfrm>
          <a:prstGeom prst="rect">
            <a:avLst/>
          </a:prstGeom>
        </p:spPr>
        <p:txBody>
          <a:bodyPr vert="horz" lIns="92492" tIns="46246" rIns="92492" bIns="46246" rtlCol="0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36768" y="0"/>
            <a:ext cx="3011699" cy="463408"/>
          </a:xfrm>
          <a:prstGeom prst="rect">
            <a:avLst/>
          </a:prstGeom>
        </p:spPr>
        <p:txBody>
          <a:bodyPr vert="horz" lIns="92492" tIns="46246" rIns="92492" bIns="46246" rtlCol="0"/>
          <a:lstStyle>
            <a:lvl1pPr algn="r">
              <a:defRPr sz="1200"/>
            </a:lvl1pPr>
          </a:lstStyle>
          <a:p>
            <a:fld id="{136B9BA0-E282-4DFD-BAAE-567B240ACB05}" type="datetimeFigureOut">
              <a:rPr lang="en-US" smtClean="0"/>
              <a:t>12/16/2021</a:t>
            </a:fld>
            <a:endParaRPr lang="en-US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703263" y="1154113"/>
            <a:ext cx="5543550" cy="31178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2492" tIns="46246" rIns="92492" bIns="46246" rtlCol="0" anchor="ctr"/>
          <a:lstStyle/>
          <a:p>
            <a:endParaRPr lang="en-US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95008" y="4444861"/>
            <a:ext cx="5560060" cy="3636705"/>
          </a:xfrm>
          <a:prstGeom prst="rect">
            <a:avLst/>
          </a:prstGeom>
        </p:spPr>
        <p:txBody>
          <a:bodyPr vert="horz" lIns="92492" tIns="46246" rIns="92492" bIns="46246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772669"/>
            <a:ext cx="3011699" cy="463407"/>
          </a:xfrm>
          <a:prstGeom prst="rect">
            <a:avLst/>
          </a:prstGeom>
        </p:spPr>
        <p:txBody>
          <a:bodyPr vert="horz" lIns="92492" tIns="46246" rIns="92492" bIns="46246" rtlCol="0" anchor="b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36768" y="8772669"/>
            <a:ext cx="3011699" cy="463407"/>
          </a:xfrm>
          <a:prstGeom prst="rect">
            <a:avLst/>
          </a:prstGeom>
        </p:spPr>
        <p:txBody>
          <a:bodyPr vert="horz" lIns="92492" tIns="46246" rIns="92492" bIns="46246" rtlCol="0" anchor="b"/>
          <a:lstStyle>
            <a:lvl1pPr algn="r">
              <a:defRPr sz="1200"/>
            </a:lvl1pPr>
          </a:lstStyle>
          <a:p>
            <a:fld id="{DA3A786D-E07D-44DE-AC04-D439E118C56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2746317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E9CF9B0-4E23-4E52-ACF0-AF90EF888A2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9288020-1D5D-426B-BBAC-F7014261812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E606418-D4E7-4B6D-AC0E-E034334F0A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38DC6-885D-4992-A3E4-DD358C45A877}" type="datetimeFigureOut">
              <a:rPr lang="en-US" smtClean="0"/>
              <a:t>12/16/2021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C676192-47E6-483B-96D5-FB848E9AA8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4CFACB0-3548-494A-A961-7EFC2EBBFC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007AFF-83FB-453E-8ABD-27642639BE80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664910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DE12A98-2C16-487A-8AC1-6755E1A6182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AC2D009-8AC2-4305-A3E8-2EB36864949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52FCBA9-908A-42AD-BC00-FE564E99BB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38DC6-885D-4992-A3E4-DD358C45A877}" type="datetimeFigureOut">
              <a:rPr lang="en-US" smtClean="0"/>
              <a:t>12/16/2021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54EE189-A098-49B5-8C11-B15AD9C081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F6B42A6-6974-4B89-B24C-4A28F76305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007AFF-83FB-453E-8ABD-27642639BE80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759135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35CE344-E53A-4A96-AE65-9CB230DFDEA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E245A05-048D-4969-B47C-1FD7FD2548B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B36D906-AE5B-4C60-8049-F36DF31402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38DC6-885D-4992-A3E4-DD358C45A877}" type="datetimeFigureOut">
              <a:rPr lang="en-US" smtClean="0"/>
              <a:t>12/16/2021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20D3B84-297E-49F2-A024-DEE9E0409E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8AA2306-CB15-4137-81B4-EAB3323FA6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007AFF-83FB-453E-8ABD-27642639BE80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2911078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E061353-1927-4C7F-8C0A-C185759D8AA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C5D164D-1343-48D7-87B1-27FDADC293E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AAD2BD7-25FB-4EB2-BC05-B10491E121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38DC6-885D-4992-A3E4-DD358C45A877}" type="datetimeFigureOut">
              <a:rPr lang="en-US" smtClean="0"/>
              <a:t>12/16/2021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5F5B4AD-6C32-4668-AD0A-E7F2248C29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988E39E-ECCA-4478-B46D-68B94EF6E6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007AFF-83FB-453E-8ABD-27642639BE80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3788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377A9C1-E918-4D12-96DA-9A2BA8B1F68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590E8CF-F9EE-428E-B575-38DE7E14C41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07F9ED9-279C-422B-91D9-4F95CADE43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38DC6-885D-4992-A3E4-DD358C45A877}" type="datetimeFigureOut">
              <a:rPr lang="en-US" smtClean="0"/>
              <a:t>12/16/2021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3E2A121-084D-47DE-8357-70394DE201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C99DBE8-E8D4-4566-843C-87DE8E994A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007AFF-83FB-453E-8ABD-27642639BE80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556858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1B73B17-01C1-4961-BF28-D2C9BDF1245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12C66B0-C172-4EB7-B5B5-6894C8A1B64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8280B2A-A8F4-4850-84D5-4D054D37259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6F2BFC8-9557-4500-86BA-6283894904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38DC6-885D-4992-A3E4-DD358C45A877}" type="datetimeFigureOut">
              <a:rPr lang="en-US" smtClean="0"/>
              <a:t>12/16/2021</a:t>
            </a:fld>
            <a:endParaRPr lang="en-US" dirty="0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361A94B-2309-4159-903C-3534A70ADE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9A93AA8-C157-4D52-A3DA-7DA60AA742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007AFF-83FB-453E-8ABD-27642639BE80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98492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E4A78A8-BF4C-4FF7-819F-544FFF7C937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A5FB1F7-5826-4730-8693-F47CAF6DDFC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89AA0A3-49FE-45F7-A201-ED960C09766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CFB1359-4CBB-4035-95C8-3C66F0312C1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8714CD3-4F09-4FFA-949F-25C40D53451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9D5B896-B5F9-4387-A5FB-B8E4250125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38DC6-885D-4992-A3E4-DD358C45A877}" type="datetimeFigureOut">
              <a:rPr lang="en-US" smtClean="0"/>
              <a:t>12/16/2021</a:t>
            </a:fld>
            <a:endParaRPr lang="en-US" dirty="0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78A2F3E-0C38-449F-8AA8-913003011C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6DE08F4-64DE-44B8-844B-6E4E440C63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007AFF-83FB-453E-8ABD-27642639BE80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306731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D8735F1-2BA0-420F-AF7F-97191AB00C1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C634400-52A8-4FFB-B258-E8160A1B29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38DC6-885D-4992-A3E4-DD358C45A877}" type="datetimeFigureOut">
              <a:rPr lang="en-US" smtClean="0"/>
              <a:t>12/16/2021</a:t>
            </a:fld>
            <a:endParaRPr lang="en-US" dirty="0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D74426E-811E-4122-8B0F-70F6C804EE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DC37723-96F0-41D7-9034-DB58BE812E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007AFF-83FB-453E-8ABD-27642639BE80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4988965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C80231A-719B-4B75-B6EC-59D6B21833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38DC6-885D-4992-A3E4-DD358C45A877}" type="datetimeFigureOut">
              <a:rPr lang="en-US" smtClean="0"/>
              <a:t>12/16/2021</a:t>
            </a:fld>
            <a:endParaRPr lang="en-US" dirty="0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69A6FC2-FDAE-48D6-9BB8-090106B324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187AEE8-122E-4BDB-BA61-138AB2E39D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007AFF-83FB-453E-8ABD-27642639BE80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300436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10CC12A-4801-4517-B669-CF7CDB5C551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DF57DBC-6770-4FD9-88B2-E4B1F404AA8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CB9E89C-6D85-428A-8E8A-3BB3D198DF1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1E441DE-4AD4-40E0-8DD9-9B6F05A415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38DC6-885D-4992-A3E4-DD358C45A877}" type="datetimeFigureOut">
              <a:rPr lang="en-US" smtClean="0"/>
              <a:t>12/16/2021</a:t>
            </a:fld>
            <a:endParaRPr lang="en-US" dirty="0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F8B02C6-4617-49AB-8820-FC7AA2B580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215C9F9-73CF-4B2E-B1FC-8874D2CD05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007AFF-83FB-453E-8ABD-27642639BE80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86459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133EF60-6D37-45A1-B1BC-336F2F71AF8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0FBE426-0090-4827-974B-4B114127D9D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 dirty="0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B377417-2677-4FB7-ADC6-2EE4C7C950B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15BDB09-D712-4665-A772-1B16DA1B7D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38DC6-885D-4992-A3E4-DD358C45A877}" type="datetimeFigureOut">
              <a:rPr lang="en-US" smtClean="0"/>
              <a:t>12/16/2021</a:t>
            </a:fld>
            <a:endParaRPr lang="en-US" dirty="0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F3BE82F-FF0E-4F24-8503-3724637A1A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1E39306-C024-4F81-BC96-B93AA1D1C8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007AFF-83FB-453E-8ABD-27642639BE80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236610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2B57116-881D-4EA6-9F7B-CDAF7E39788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7750881-018B-4FAF-8276-E54BF79B169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9DF80F6-DA6F-4C7B-9DE8-DB2115530F8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038DC6-885D-4992-A3E4-DD358C45A877}" type="datetimeFigureOut">
              <a:rPr lang="en-US" smtClean="0"/>
              <a:t>12/16/2021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CB8D443-871F-4367-B20F-9765A7DC2F5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C9B7FBD-C21C-463A-99A7-1EFC440D4A1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007AFF-83FB-453E-8ABD-27642639BE80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232951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9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9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9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9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9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9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9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9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9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tiff"/><Relationship Id="rId7" Type="http://schemas.openxmlformats.org/officeDocument/2006/relationships/image" Target="../media/image6.pn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tiff"/><Relationship Id="rId9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4.bin"/><Relationship Id="rId3" Type="http://schemas.openxmlformats.org/officeDocument/2006/relationships/image" Target="../media/image9.emf"/><Relationship Id="rId7" Type="http://schemas.openxmlformats.org/officeDocument/2006/relationships/image" Target="../media/image11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3.bin"/><Relationship Id="rId11" Type="http://schemas.openxmlformats.org/officeDocument/2006/relationships/image" Target="../media/image13.emf"/><Relationship Id="rId5" Type="http://schemas.openxmlformats.org/officeDocument/2006/relationships/image" Target="../media/image10.emf"/><Relationship Id="rId10" Type="http://schemas.openxmlformats.org/officeDocument/2006/relationships/oleObject" Target="../embeddings/oleObject5.bin"/><Relationship Id="rId4" Type="http://schemas.openxmlformats.org/officeDocument/2006/relationships/oleObject" Target="../embeddings/oleObject2.bin"/><Relationship Id="rId9" Type="http://schemas.openxmlformats.org/officeDocument/2006/relationships/image" Target="../media/image12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emf"/><Relationship Id="rId2" Type="http://schemas.openxmlformats.org/officeDocument/2006/relationships/oleObject" Target="../embeddings/oleObject6.bin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6.emf"/><Relationship Id="rId4" Type="http://schemas.openxmlformats.org/officeDocument/2006/relationships/image" Target="../media/image15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7" name="Straight Arrow Connector 6"/>
          <p:cNvCxnSpPr>
            <a:cxnSpLocks/>
          </p:cNvCxnSpPr>
          <p:nvPr/>
        </p:nvCxnSpPr>
        <p:spPr>
          <a:xfrm>
            <a:off x="829339" y="1778321"/>
            <a:ext cx="2180024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/>
          <p:cNvSpPr txBox="1"/>
          <p:nvPr/>
        </p:nvSpPr>
        <p:spPr>
          <a:xfrm>
            <a:off x="3332237" y="963877"/>
            <a:ext cx="9268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Single Cell Discrimination</a:t>
            </a:r>
          </a:p>
        </p:txBody>
      </p:sp>
      <p:grpSp>
        <p:nvGrpSpPr>
          <p:cNvPr id="19" name="Group 18"/>
          <p:cNvGrpSpPr/>
          <p:nvPr/>
        </p:nvGrpSpPr>
        <p:grpSpPr>
          <a:xfrm>
            <a:off x="3082756" y="1294900"/>
            <a:ext cx="1148309" cy="1178437"/>
            <a:chOff x="5134020" y="1005276"/>
            <a:chExt cx="1899660" cy="1949500"/>
          </a:xfrm>
        </p:grpSpPr>
        <p:grpSp>
          <p:nvGrpSpPr>
            <p:cNvPr id="51" name="Group 50"/>
            <p:cNvGrpSpPr/>
            <p:nvPr/>
          </p:nvGrpSpPr>
          <p:grpSpPr>
            <a:xfrm>
              <a:off x="5355672" y="1005276"/>
              <a:ext cx="1678008" cy="1641204"/>
              <a:chOff x="5504329" y="1119925"/>
              <a:chExt cx="1678008" cy="1641204"/>
            </a:xfrm>
          </p:grpSpPr>
          <p:pic>
            <p:nvPicPr>
              <p:cNvPr id="56" name="Picture 55">
                <a:extLst>
                  <a:ext uri="{FF2B5EF4-FFF2-40B4-BE49-F238E27FC236}">
                    <a16:creationId xmlns:a16="http://schemas.microsoft.com/office/drawing/2014/main" id="{4A57D22C-DA05-9340-A2BA-E7D9EC596BB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l="8612" b="6033"/>
              <a:stretch/>
            </p:blipFill>
            <p:spPr>
              <a:xfrm>
                <a:off x="5504329" y="1119925"/>
                <a:ext cx="1678008" cy="1641204"/>
              </a:xfrm>
              <a:prstGeom prst="rect">
                <a:avLst/>
              </a:prstGeom>
            </p:spPr>
          </p:pic>
          <p:sp>
            <p:nvSpPr>
              <p:cNvPr id="57" name="Rectangle 56"/>
              <p:cNvSpPr/>
              <p:nvPr/>
            </p:nvSpPr>
            <p:spPr>
              <a:xfrm>
                <a:off x="5773272" y="1210235"/>
                <a:ext cx="412376" cy="21696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400" dirty="0"/>
              </a:p>
            </p:txBody>
          </p:sp>
        </p:grpSp>
        <p:cxnSp>
          <p:nvCxnSpPr>
            <p:cNvPr id="52" name="Straight Arrow Connector 51">
              <a:extLst>
                <a:ext uri="{FF2B5EF4-FFF2-40B4-BE49-F238E27FC236}">
                  <a16:creationId xmlns:a16="http://schemas.microsoft.com/office/drawing/2014/main" id="{271F5F80-A652-C54D-A282-95E5172A2605}"/>
                </a:ext>
              </a:extLst>
            </p:cNvPr>
            <p:cNvCxnSpPr/>
            <p:nvPr/>
          </p:nvCxnSpPr>
          <p:spPr>
            <a:xfrm flipV="1">
              <a:off x="5324955" y="2193544"/>
              <a:ext cx="0" cy="54864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" name="Straight Arrow Connector 52">
              <a:extLst>
                <a:ext uri="{FF2B5EF4-FFF2-40B4-BE49-F238E27FC236}">
                  <a16:creationId xmlns:a16="http://schemas.microsoft.com/office/drawing/2014/main" id="{EF9C9FAD-0A71-044A-9B89-10F9382B97D4}"/>
                </a:ext>
              </a:extLst>
            </p:cNvPr>
            <p:cNvCxnSpPr>
              <a:cxnSpLocks/>
            </p:cNvCxnSpPr>
            <p:nvPr/>
          </p:nvCxnSpPr>
          <p:spPr>
            <a:xfrm rot="5400000" flipV="1">
              <a:off x="5592132" y="2460721"/>
              <a:ext cx="0" cy="54864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BDD7A1D5-319B-AC47-857C-5B73EDBF043A}"/>
                </a:ext>
              </a:extLst>
            </p:cNvPr>
            <p:cNvSpPr txBox="1"/>
            <p:nvPr/>
          </p:nvSpPr>
          <p:spPr>
            <a:xfrm>
              <a:off x="5873595" y="2572908"/>
              <a:ext cx="878298" cy="38186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FSC-A</a:t>
              </a:r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C22E5819-A4F3-9F42-BEF3-FB33CAA48410}"/>
                </a:ext>
              </a:extLst>
            </p:cNvPr>
            <p:cNvSpPr txBox="1"/>
            <p:nvPr/>
          </p:nvSpPr>
          <p:spPr>
            <a:xfrm rot="16200000">
              <a:off x="4880501" y="1654280"/>
              <a:ext cx="888905" cy="38186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FSC-H</a:t>
              </a:r>
            </a:p>
          </p:txBody>
        </p:sp>
      </p:grpSp>
      <p:grpSp>
        <p:nvGrpSpPr>
          <p:cNvPr id="20" name="Group 19"/>
          <p:cNvGrpSpPr/>
          <p:nvPr/>
        </p:nvGrpSpPr>
        <p:grpSpPr>
          <a:xfrm>
            <a:off x="4732154" y="1295145"/>
            <a:ext cx="1158413" cy="1191226"/>
            <a:chOff x="7536738" y="1136519"/>
            <a:chExt cx="1916375" cy="1970657"/>
          </a:xfrm>
        </p:grpSpPr>
        <p:pic>
          <p:nvPicPr>
            <p:cNvPr id="46" name="Picture 45">
              <a:extLst>
                <a:ext uri="{FF2B5EF4-FFF2-40B4-BE49-F238E27FC236}">
                  <a16:creationId xmlns:a16="http://schemas.microsoft.com/office/drawing/2014/main" id="{186A3237-3A11-754D-8436-BDE3A2547A8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8465" b="5580"/>
            <a:stretch/>
          </p:blipFill>
          <p:spPr>
            <a:xfrm>
              <a:off x="7772400" y="1136519"/>
              <a:ext cx="1680713" cy="1649108"/>
            </a:xfrm>
            <a:prstGeom prst="rect">
              <a:avLst/>
            </a:prstGeom>
          </p:spPr>
        </p:pic>
        <p:cxnSp>
          <p:nvCxnSpPr>
            <p:cNvPr id="47" name="Straight Arrow Connector 46">
              <a:extLst>
                <a:ext uri="{FF2B5EF4-FFF2-40B4-BE49-F238E27FC236}">
                  <a16:creationId xmlns:a16="http://schemas.microsoft.com/office/drawing/2014/main" id="{271F5F80-A652-C54D-A282-95E5172A2605}"/>
                </a:ext>
              </a:extLst>
            </p:cNvPr>
            <p:cNvCxnSpPr/>
            <p:nvPr/>
          </p:nvCxnSpPr>
          <p:spPr>
            <a:xfrm flipV="1">
              <a:off x="7727674" y="2345944"/>
              <a:ext cx="0" cy="54864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Straight Arrow Connector 47">
              <a:extLst>
                <a:ext uri="{FF2B5EF4-FFF2-40B4-BE49-F238E27FC236}">
                  <a16:creationId xmlns:a16="http://schemas.microsoft.com/office/drawing/2014/main" id="{EF9C9FAD-0A71-044A-9B89-10F9382B97D4}"/>
                </a:ext>
              </a:extLst>
            </p:cNvPr>
            <p:cNvCxnSpPr>
              <a:cxnSpLocks/>
            </p:cNvCxnSpPr>
            <p:nvPr/>
          </p:nvCxnSpPr>
          <p:spPr>
            <a:xfrm rot="5400000" flipV="1">
              <a:off x="7994851" y="2613121"/>
              <a:ext cx="0" cy="54864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BDD7A1D5-319B-AC47-857C-5B73EDBF043A}"/>
                </a:ext>
              </a:extLst>
            </p:cNvPr>
            <p:cNvSpPr txBox="1"/>
            <p:nvPr/>
          </p:nvSpPr>
          <p:spPr>
            <a:xfrm>
              <a:off x="8276314" y="2725308"/>
              <a:ext cx="687363" cy="38186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FSC</a:t>
              </a:r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C22E5819-A4F3-9F42-BEF3-FB33CAA48410}"/>
                </a:ext>
              </a:extLst>
            </p:cNvPr>
            <p:cNvSpPr txBox="1"/>
            <p:nvPr/>
          </p:nvSpPr>
          <p:spPr>
            <a:xfrm rot="16200000">
              <a:off x="7378687" y="1806680"/>
              <a:ext cx="697970" cy="38186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SSC</a:t>
              </a:r>
            </a:p>
          </p:txBody>
        </p:sp>
      </p:grpSp>
      <p:grpSp>
        <p:nvGrpSpPr>
          <p:cNvPr id="21" name="Group 20"/>
          <p:cNvGrpSpPr/>
          <p:nvPr/>
        </p:nvGrpSpPr>
        <p:grpSpPr>
          <a:xfrm>
            <a:off x="6400881" y="1292034"/>
            <a:ext cx="1165758" cy="1182154"/>
            <a:chOff x="7500879" y="3285127"/>
            <a:chExt cx="1928525" cy="1955649"/>
          </a:xfrm>
        </p:grpSpPr>
        <p:grpSp>
          <p:nvGrpSpPr>
            <p:cNvPr id="39" name="Group 38"/>
            <p:cNvGrpSpPr/>
            <p:nvPr/>
          </p:nvGrpSpPr>
          <p:grpSpPr>
            <a:xfrm>
              <a:off x="7772400" y="3285127"/>
              <a:ext cx="1657004" cy="1652158"/>
              <a:chOff x="7772400" y="3305324"/>
              <a:chExt cx="1657004" cy="1652158"/>
            </a:xfrm>
          </p:grpSpPr>
          <p:pic>
            <p:nvPicPr>
              <p:cNvPr id="44" name="Picture 43">
                <a:extLst>
                  <a:ext uri="{FF2B5EF4-FFF2-40B4-BE49-F238E27FC236}">
                    <a16:creationId xmlns:a16="http://schemas.microsoft.com/office/drawing/2014/main" id="{1C71D2DE-4F28-0A41-AA40-BF24C3C37C7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l="9756" b="5406"/>
              <a:stretch/>
            </p:blipFill>
            <p:spPr>
              <a:xfrm>
                <a:off x="7772400" y="3305324"/>
                <a:ext cx="1657004" cy="1652158"/>
              </a:xfrm>
              <a:prstGeom prst="rect">
                <a:avLst/>
              </a:prstGeom>
            </p:spPr>
          </p:pic>
          <p:sp>
            <p:nvSpPr>
              <p:cNvPr id="45" name="Rectangle 44"/>
              <p:cNvSpPr/>
              <p:nvPr/>
            </p:nvSpPr>
            <p:spPr>
              <a:xfrm>
                <a:off x="8977985" y="3514164"/>
                <a:ext cx="412376" cy="21696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400" dirty="0"/>
              </a:p>
            </p:txBody>
          </p:sp>
        </p:grpSp>
        <p:cxnSp>
          <p:nvCxnSpPr>
            <p:cNvPr id="40" name="Straight Arrow Connector 39">
              <a:extLst>
                <a:ext uri="{FF2B5EF4-FFF2-40B4-BE49-F238E27FC236}">
                  <a16:creationId xmlns:a16="http://schemas.microsoft.com/office/drawing/2014/main" id="{271F5F80-A652-C54D-A282-95E5172A2605}"/>
                </a:ext>
              </a:extLst>
            </p:cNvPr>
            <p:cNvCxnSpPr/>
            <p:nvPr/>
          </p:nvCxnSpPr>
          <p:spPr>
            <a:xfrm flipV="1">
              <a:off x="7691815" y="4479544"/>
              <a:ext cx="0" cy="54864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Straight Arrow Connector 40">
              <a:extLst>
                <a:ext uri="{FF2B5EF4-FFF2-40B4-BE49-F238E27FC236}">
                  <a16:creationId xmlns:a16="http://schemas.microsoft.com/office/drawing/2014/main" id="{EF9C9FAD-0A71-044A-9B89-10F9382B97D4}"/>
                </a:ext>
              </a:extLst>
            </p:cNvPr>
            <p:cNvCxnSpPr>
              <a:cxnSpLocks/>
            </p:cNvCxnSpPr>
            <p:nvPr/>
          </p:nvCxnSpPr>
          <p:spPr>
            <a:xfrm rot="5400000" flipV="1">
              <a:off x="7958992" y="4746721"/>
              <a:ext cx="0" cy="54864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BDD7A1D5-319B-AC47-857C-5B73EDBF043A}"/>
                </a:ext>
              </a:extLst>
            </p:cNvPr>
            <p:cNvSpPr txBox="1"/>
            <p:nvPr/>
          </p:nvSpPr>
          <p:spPr>
            <a:xfrm>
              <a:off x="8240453" y="4858908"/>
              <a:ext cx="687362" cy="38186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CD4</a:t>
              </a: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C22E5819-A4F3-9F42-BEF3-FB33CAA48410}"/>
                </a:ext>
              </a:extLst>
            </p:cNvPr>
            <p:cNvSpPr txBox="1"/>
            <p:nvPr/>
          </p:nvSpPr>
          <p:spPr>
            <a:xfrm rot="16200000">
              <a:off x="7342828" y="3940280"/>
              <a:ext cx="697970" cy="38186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SSC</a:t>
              </a:r>
            </a:p>
          </p:txBody>
        </p:sp>
      </p:grpSp>
      <p:grpSp>
        <p:nvGrpSpPr>
          <p:cNvPr id="22" name="Group 21"/>
          <p:cNvGrpSpPr/>
          <p:nvPr/>
        </p:nvGrpSpPr>
        <p:grpSpPr>
          <a:xfrm>
            <a:off x="8324670" y="774479"/>
            <a:ext cx="1173657" cy="1161691"/>
            <a:chOff x="5241775" y="3301047"/>
            <a:chExt cx="1941594" cy="1921798"/>
          </a:xfrm>
        </p:grpSpPr>
        <p:grpSp>
          <p:nvGrpSpPr>
            <p:cNvPr id="31" name="Group 30"/>
            <p:cNvGrpSpPr/>
            <p:nvPr/>
          </p:nvGrpSpPr>
          <p:grpSpPr>
            <a:xfrm>
              <a:off x="5513043" y="3301047"/>
              <a:ext cx="1670326" cy="1620319"/>
              <a:chOff x="5513043" y="3301047"/>
              <a:chExt cx="1670326" cy="1620319"/>
            </a:xfrm>
          </p:grpSpPr>
          <p:pic>
            <p:nvPicPr>
              <p:cNvPr id="36" name="Picture 35">
                <a:extLst>
                  <a:ext uri="{FF2B5EF4-FFF2-40B4-BE49-F238E27FC236}">
                    <a16:creationId xmlns:a16="http://schemas.microsoft.com/office/drawing/2014/main" id="{F74C922E-BCD7-824A-9CE5-8F63F06AD8A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/>
              <a:srcRect l="9538" b="6994"/>
              <a:stretch/>
            </p:blipFill>
            <p:spPr>
              <a:xfrm>
                <a:off x="5513043" y="3301047"/>
                <a:ext cx="1670326" cy="1620319"/>
              </a:xfrm>
              <a:prstGeom prst="rect">
                <a:avLst/>
              </a:prstGeom>
            </p:spPr>
          </p:pic>
          <p:sp>
            <p:nvSpPr>
              <p:cNvPr id="37" name="Rectangle 36"/>
              <p:cNvSpPr/>
              <p:nvPr/>
            </p:nvSpPr>
            <p:spPr>
              <a:xfrm>
                <a:off x="5708113" y="3371911"/>
                <a:ext cx="191037" cy="190439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400" dirty="0"/>
              </a:p>
            </p:txBody>
          </p:sp>
          <p:sp>
            <p:nvSpPr>
              <p:cNvPr id="38" name="Rectangle 37"/>
              <p:cNvSpPr/>
              <p:nvPr/>
            </p:nvSpPr>
            <p:spPr>
              <a:xfrm>
                <a:off x="5730338" y="4492686"/>
                <a:ext cx="191037" cy="190439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400" dirty="0"/>
              </a:p>
            </p:txBody>
          </p:sp>
        </p:grpSp>
        <p:cxnSp>
          <p:nvCxnSpPr>
            <p:cNvPr id="32" name="Straight Arrow Connector 31">
              <a:extLst>
                <a:ext uri="{FF2B5EF4-FFF2-40B4-BE49-F238E27FC236}">
                  <a16:creationId xmlns:a16="http://schemas.microsoft.com/office/drawing/2014/main" id="{271F5F80-A652-C54D-A282-95E5172A2605}"/>
                </a:ext>
              </a:extLst>
            </p:cNvPr>
            <p:cNvCxnSpPr/>
            <p:nvPr/>
          </p:nvCxnSpPr>
          <p:spPr>
            <a:xfrm flipV="1">
              <a:off x="5432709" y="4461615"/>
              <a:ext cx="0" cy="54864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Straight Arrow Connector 32">
              <a:extLst>
                <a:ext uri="{FF2B5EF4-FFF2-40B4-BE49-F238E27FC236}">
                  <a16:creationId xmlns:a16="http://schemas.microsoft.com/office/drawing/2014/main" id="{EF9C9FAD-0A71-044A-9B89-10F9382B97D4}"/>
                </a:ext>
              </a:extLst>
            </p:cNvPr>
            <p:cNvCxnSpPr>
              <a:cxnSpLocks/>
            </p:cNvCxnSpPr>
            <p:nvPr/>
          </p:nvCxnSpPr>
          <p:spPr>
            <a:xfrm rot="5400000" flipV="1">
              <a:off x="5699886" y="4728792"/>
              <a:ext cx="0" cy="54864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BDD7A1D5-319B-AC47-857C-5B73EDBF043A}"/>
                </a:ext>
              </a:extLst>
            </p:cNvPr>
            <p:cNvSpPr txBox="1"/>
            <p:nvPr/>
          </p:nvSpPr>
          <p:spPr>
            <a:xfrm>
              <a:off x="5981349" y="4840977"/>
              <a:ext cx="687363" cy="38186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CD4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C22E5819-A4F3-9F42-BEF3-FB33CAA48410}"/>
                </a:ext>
              </a:extLst>
            </p:cNvPr>
            <p:cNvSpPr txBox="1"/>
            <p:nvPr/>
          </p:nvSpPr>
          <p:spPr>
            <a:xfrm rot="16200000">
              <a:off x="4967041" y="3922352"/>
              <a:ext cx="931336" cy="38186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FOXP3</a:t>
              </a:r>
            </a:p>
          </p:txBody>
        </p:sp>
      </p:grpSp>
      <p:sp>
        <p:nvSpPr>
          <p:cNvPr id="23" name="TextBox 22"/>
          <p:cNvSpPr txBox="1"/>
          <p:nvPr/>
        </p:nvSpPr>
        <p:spPr>
          <a:xfrm>
            <a:off x="5021138" y="963877"/>
            <a:ext cx="8616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Gate for Lymphocytes</a:t>
            </a:r>
          </a:p>
        </p:txBody>
      </p:sp>
      <p:cxnSp>
        <p:nvCxnSpPr>
          <p:cNvPr id="24" name="Straight Arrow Connector 23"/>
          <p:cNvCxnSpPr/>
          <p:nvPr/>
        </p:nvCxnSpPr>
        <p:spPr>
          <a:xfrm>
            <a:off x="4289740" y="1768921"/>
            <a:ext cx="442190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/>
          <p:cNvSpPr txBox="1"/>
          <p:nvPr/>
        </p:nvSpPr>
        <p:spPr>
          <a:xfrm>
            <a:off x="6705017" y="966008"/>
            <a:ext cx="8616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Gate for CD4+ Cells</a:t>
            </a:r>
          </a:p>
        </p:txBody>
      </p:sp>
      <p:cxnSp>
        <p:nvCxnSpPr>
          <p:cNvPr id="29" name="Straight Arrow Connector 28"/>
          <p:cNvCxnSpPr>
            <a:cxnSpLocks/>
          </p:cNvCxnSpPr>
          <p:nvPr/>
        </p:nvCxnSpPr>
        <p:spPr>
          <a:xfrm flipV="1">
            <a:off x="7697990" y="1508725"/>
            <a:ext cx="575117" cy="237226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TextBox 29"/>
          <p:cNvSpPr txBox="1"/>
          <p:nvPr/>
        </p:nvSpPr>
        <p:spPr>
          <a:xfrm>
            <a:off x="8605908" y="544895"/>
            <a:ext cx="87710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Gate for T</a:t>
            </a:r>
            <a:r>
              <a:rPr lang="en-US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Regs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2" name="Straight Arrow Connector 61">
            <a:extLst>
              <a:ext uri="{FF2B5EF4-FFF2-40B4-BE49-F238E27FC236}">
                <a16:creationId xmlns:a16="http://schemas.microsoft.com/office/drawing/2014/main" id="{72E9EE8C-8EEC-4445-8CE7-108A1F23BF04}"/>
              </a:ext>
            </a:extLst>
          </p:cNvPr>
          <p:cNvCxnSpPr/>
          <p:nvPr/>
        </p:nvCxnSpPr>
        <p:spPr>
          <a:xfrm>
            <a:off x="5956832" y="1771046"/>
            <a:ext cx="442190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63" name="Group 62">
            <a:extLst>
              <a:ext uri="{FF2B5EF4-FFF2-40B4-BE49-F238E27FC236}">
                <a16:creationId xmlns:a16="http://schemas.microsoft.com/office/drawing/2014/main" id="{D4B32422-2920-3A42-8161-F88FED598818}"/>
              </a:ext>
            </a:extLst>
          </p:cNvPr>
          <p:cNvGrpSpPr/>
          <p:nvPr/>
        </p:nvGrpSpPr>
        <p:grpSpPr>
          <a:xfrm>
            <a:off x="10041784" y="1494803"/>
            <a:ext cx="1173658" cy="1161691"/>
            <a:chOff x="5241773" y="3301047"/>
            <a:chExt cx="1941596" cy="1921798"/>
          </a:xfrm>
        </p:grpSpPr>
        <p:grpSp>
          <p:nvGrpSpPr>
            <p:cNvPr id="64" name="Group 63">
              <a:extLst>
                <a:ext uri="{FF2B5EF4-FFF2-40B4-BE49-F238E27FC236}">
                  <a16:creationId xmlns:a16="http://schemas.microsoft.com/office/drawing/2014/main" id="{776E9AAF-0012-1547-9884-6392E103E82D}"/>
                </a:ext>
              </a:extLst>
            </p:cNvPr>
            <p:cNvGrpSpPr/>
            <p:nvPr/>
          </p:nvGrpSpPr>
          <p:grpSpPr>
            <a:xfrm>
              <a:off x="5513043" y="3301047"/>
              <a:ext cx="1670326" cy="1620319"/>
              <a:chOff x="5513043" y="3301047"/>
              <a:chExt cx="1670326" cy="1620319"/>
            </a:xfrm>
          </p:grpSpPr>
          <p:pic>
            <p:nvPicPr>
              <p:cNvPr id="69" name="Picture 68">
                <a:extLst>
                  <a:ext uri="{FF2B5EF4-FFF2-40B4-BE49-F238E27FC236}">
                    <a16:creationId xmlns:a16="http://schemas.microsoft.com/office/drawing/2014/main" id="{2BED47AB-45A4-5241-97FE-3EAECA34A14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/>
              <a:srcRect l="9538" b="6994"/>
              <a:stretch/>
            </p:blipFill>
            <p:spPr>
              <a:xfrm>
                <a:off x="5513043" y="3301047"/>
                <a:ext cx="1670326" cy="1620319"/>
              </a:xfrm>
              <a:prstGeom prst="rect">
                <a:avLst/>
              </a:prstGeom>
            </p:spPr>
          </p:pic>
          <p:sp>
            <p:nvSpPr>
              <p:cNvPr id="70" name="Rectangle 69">
                <a:extLst>
                  <a:ext uri="{FF2B5EF4-FFF2-40B4-BE49-F238E27FC236}">
                    <a16:creationId xmlns:a16="http://schemas.microsoft.com/office/drawing/2014/main" id="{5EC1458C-3FB0-4C4F-A0AE-50E68E69FCB8}"/>
                  </a:ext>
                </a:extLst>
              </p:cNvPr>
              <p:cNvSpPr/>
              <p:nvPr/>
            </p:nvSpPr>
            <p:spPr>
              <a:xfrm>
                <a:off x="5708113" y="3371911"/>
                <a:ext cx="191037" cy="190439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400" dirty="0"/>
              </a:p>
            </p:txBody>
          </p:sp>
          <p:sp>
            <p:nvSpPr>
              <p:cNvPr id="71" name="Rectangle 70">
                <a:extLst>
                  <a:ext uri="{FF2B5EF4-FFF2-40B4-BE49-F238E27FC236}">
                    <a16:creationId xmlns:a16="http://schemas.microsoft.com/office/drawing/2014/main" id="{56099CDC-F923-A74F-94A8-A8C8545DA354}"/>
                  </a:ext>
                </a:extLst>
              </p:cNvPr>
              <p:cNvSpPr/>
              <p:nvPr/>
            </p:nvSpPr>
            <p:spPr>
              <a:xfrm>
                <a:off x="5730338" y="4492686"/>
                <a:ext cx="191037" cy="190439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400" dirty="0"/>
              </a:p>
            </p:txBody>
          </p:sp>
        </p:grpSp>
        <p:cxnSp>
          <p:nvCxnSpPr>
            <p:cNvPr id="65" name="Straight Arrow Connector 64">
              <a:extLst>
                <a:ext uri="{FF2B5EF4-FFF2-40B4-BE49-F238E27FC236}">
                  <a16:creationId xmlns:a16="http://schemas.microsoft.com/office/drawing/2014/main" id="{9B08840D-9AFE-3E43-BF2D-DD4EE487AEA7}"/>
                </a:ext>
              </a:extLst>
            </p:cNvPr>
            <p:cNvCxnSpPr/>
            <p:nvPr/>
          </p:nvCxnSpPr>
          <p:spPr>
            <a:xfrm flipV="1">
              <a:off x="5432709" y="4461615"/>
              <a:ext cx="0" cy="54864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6" name="Straight Arrow Connector 65">
              <a:extLst>
                <a:ext uri="{FF2B5EF4-FFF2-40B4-BE49-F238E27FC236}">
                  <a16:creationId xmlns:a16="http://schemas.microsoft.com/office/drawing/2014/main" id="{0BED93DE-2211-A949-B857-A84C251816E2}"/>
                </a:ext>
              </a:extLst>
            </p:cNvPr>
            <p:cNvCxnSpPr>
              <a:cxnSpLocks/>
            </p:cNvCxnSpPr>
            <p:nvPr/>
          </p:nvCxnSpPr>
          <p:spPr>
            <a:xfrm rot="5400000" flipV="1">
              <a:off x="5699886" y="4728792"/>
              <a:ext cx="0" cy="54864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29779D33-E5CC-F54C-91D8-D650D5C32792}"/>
                </a:ext>
              </a:extLst>
            </p:cNvPr>
            <p:cNvSpPr txBox="1"/>
            <p:nvPr/>
          </p:nvSpPr>
          <p:spPr>
            <a:xfrm>
              <a:off x="5981349" y="4840977"/>
              <a:ext cx="687363" cy="38186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CD4</a:t>
              </a:r>
            </a:p>
          </p:txBody>
        </p:sp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4EF26F96-868D-5947-84C5-B7F6A443048E}"/>
                </a:ext>
              </a:extLst>
            </p:cNvPr>
            <p:cNvSpPr txBox="1"/>
            <p:nvPr/>
          </p:nvSpPr>
          <p:spPr>
            <a:xfrm rot="16200000">
              <a:off x="5073114" y="3922351"/>
              <a:ext cx="719185" cy="38186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IFNg</a:t>
              </a:r>
            </a:p>
          </p:txBody>
        </p:sp>
      </p:grpSp>
      <p:cxnSp>
        <p:nvCxnSpPr>
          <p:cNvPr id="72" name="Straight Arrow Connector 71">
            <a:extLst>
              <a:ext uri="{FF2B5EF4-FFF2-40B4-BE49-F238E27FC236}">
                <a16:creationId xmlns:a16="http://schemas.microsoft.com/office/drawing/2014/main" id="{342BA422-9503-A442-8C30-76E37E7604F8}"/>
              </a:ext>
            </a:extLst>
          </p:cNvPr>
          <p:cNvCxnSpPr>
            <a:cxnSpLocks/>
          </p:cNvCxnSpPr>
          <p:nvPr/>
        </p:nvCxnSpPr>
        <p:spPr>
          <a:xfrm>
            <a:off x="7684103" y="2030520"/>
            <a:ext cx="2248173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4" name="TextBox 73">
            <a:extLst>
              <a:ext uri="{FF2B5EF4-FFF2-40B4-BE49-F238E27FC236}">
                <a16:creationId xmlns:a16="http://schemas.microsoft.com/office/drawing/2014/main" id="{88592D39-C555-8240-88B1-922E066C394A}"/>
              </a:ext>
            </a:extLst>
          </p:cNvPr>
          <p:cNvSpPr txBox="1"/>
          <p:nvPr/>
        </p:nvSpPr>
        <p:spPr>
          <a:xfrm>
            <a:off x="10272047" y="1274636"/>
            <a:ext cx="87710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Gate for Th1</a:t>
            </a:r>
          </a:p>
        </p:txBody>
      </p:sp>
      <p:cxnSp>
        <p:nvCxnSpPr>
          <p:cNvPr id="75" name="Straight Arrow Connector 74">
            <a:extLst>
              <a:ext uri="{FF2B5EF4-FFF2-40B4-BE49-F238E27FC236}">
                <a16:creationId xmlns:a16="http://schemas.microsoft.com/office/drawing/2014/main" id="{ABC9AE3B-9A15-D744-880B-E34C3925B121}"/>
              </a:ext>
            </a:extLst>
          </p:cNvPr>
          <p:cNvCxnSpPr>
            <a:cxnSpLocks/>
          </p:cNvCxnSpPr>
          <p:nvPr/>
        </p:nvCxnSpPr>
        <p:spPr>
          <a:xfrm>
            <a:off x="7691424" y="2272685"/>
            <a:ext cx="582649" cy="268393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77" name="Group 76">
            <a:extLst>
              <a:ext uri="{FF2B5EF4-FFF2-40B4-BE49-F238E27FC236}">
                <a16:creationId xmlns:a16="http://schemas.microsoft.com/office/drawing/2014/main" id="{D372E56B-4C7F-B442-A2C4-8AE9034B2AF9}"/>
              </a:ext>
            </a:extLst>
          </p:cNvPr>
          <p:cNvGrpSpPr/>
          <p:nvPr/>
        </p:nvGrpSpPr>
        <p:grpSpPr>
          <a:xfrm>
            <a:off x="8303732" y="2430122"/>
            <a:ext cx="1173656" cy="1161691"/>
            <a:chOff x="5241775" y="3301047"/>
            <a:chExt cx="1941594" cy="1921798"/>
          </a:xfrm>
        </p:grpSpPr>
        <p:grpSp>
          <p:nvGrpSpPr>
            <p:cNvPr id="78" name="Group 77">
              <a:extLst>
                <a:ext uri="{FF2B5EF4-FFF2-40B4-BE49-F238E27FC236}">
                  <a16:creationId xmlns:a16="http://schemas.microsoft.com/office/drawing/2014/main" id="{49AD1D91-7EFF-5E4A-B8BD-9CCA07A57388}"/>
                </a:ext>
              </a:extLst>
            </p:cNvPr>
            <p:cNvGrpSpPr/>
            <p:nvPr/>
          </p:nvGrpSpPr>
          <p:grpSpPr>
            <a:xfrm>
              <a:off x="5513043" y="3301047"/>
              <a:ext cx="1670326" cy="1620319"/>
              <a:chOff x="5513043" y="3301047"/>
              <a:chExt cx="1670326" cy="1620319"/>
            </a:xfrm>
          </p:grpSpPr>
          <p:pic>
            <p:nvPicPr>
              <p:cNvPr id="83" name="Picture 82">
                <a:extLst>
                  <a:ext uri="{FF2B5EF4-FFF2-40B4-BE49-F238E27FC236}">
                    <a16:creationId xmlns:a16="http://schemas.microsoft.com/office/drawing/2014/main" id="{4271BB9A-9A17-7C4D-8A8E-E0534E846C8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/>
              <a:srcRect l="9538" b="6994"/>
              <a:stretch/>
            </p:blipFill>
            <p:spPr>
              <a:xfrm>
                <a:off x="5513043" y="3301047"/>
                <a:ext cx="1670326" cy="1620319"/>
              </a:xfrm>
              <a:prstGeom prst="rect">
                <a:avLst/>
              </a:prstGeom>
            </p:spPr>
          </p:pic>
          <p:sp>
            <p:nvSpPr>
              <p:cNvPr id="84" name="Rectangle 83">
                <a:extLst>
                  <a:ext uri="{FF2B5EF4-FFF2-40B4-BE49-F238E27FC236}">
                    <a16:creationId xmlns:a16="http://schemas.microsoft.com/office/drawing/2014/main" id="{CC512F96-4BF6-4844-B73F-E5823603B7EF}"/>
                  </a:ext>
                </a:extLst>
              </p:cNvPr>
              <p:cNvSpPr/>
              <p:nvPr/>
            </p:nvSpPr>
            <p:spPr>
              <a:xfrm>
                <a:off x="5708113" y="3371911"/>
                <a:ext cx="191037" cy="190439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400" dirty="0"/>
              </a:p>
            </p:txBody>
          </p:sp>
          <p:sp>
            <p:nvSpPr>
              <p:cNvPr id="85" name="Rectangle 84">
                <a:extLst>
                  <a:ext uri="{FF2B5EF4-FFF2-40B4-BE49-F238E27FC236}">
                    <a16:creationId xmlns:a16="http://schemas.microsoft.com/office/drawing/2014/main" id="{29ACEB12-71E7-264A-BE80-A21E31BD54C5}"/>
                  </a:ext>
                </a:extLst>
              </p:cNvPr>
              <p:cNvSpPr/>
              <p:nvPr/>
            </p:nvSpPr>
            <p:spPr>
              <a:xfrm>
                <a:off x="5730338" y="4492686"/>
                <a:ext cx="191037" cy="190439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400" dirty="0"/>
              </a:p>
            </p:txBody>
          </p:sp>
        </p:grpSp>
        <p:cxnSp>
          <p:nvCxnSpPr>
            <p:cNvPr id="79" name="Straight Arrow Connector 78">
              <a:extLst>
                <a:ext uri="{FF2B5EF4-FFF2-40B4-BE49-F238E27FC236}">
                  <a16:creationId xmlns:a16="http://schemas.microsoft.com/office/drawing/2014/main" id="{258B2678-D0E9-8D43-B700-009506007CE5}"/>
                </a:ext>
              </a:extLst>
            </p:cNvPr>
            <p:cNvCxnSpPr/>
            <p:nvPr/>
          </p:nvCxnSpPr>
          <p:spPr>
            <a:xfrm flipV="1">
              <a:off x="5432709" y="4461615"/>
              <a:ext cx="0" cy="54864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0" name="Straight Arrow Connector 79">
              <a:extLst>
                <a:ext uri="{FF2B5EF4-FFF2-40B4-BE49-F238E27FC236}">
                  <a16:creationId xmlns:a16="http://schemas.microsoft.com/office/drawing/2014/main" id="{FE262DF4-DFBE-D644-BDCE-D9902C19C404}"/>
                </a:ext>
              </a:extLst>
            </p:cNvPr>
            <p:cNvCxnSpPr>
              <a:cxnSpLocks/>
            </p:cNvCxnSpPr>
            <p:nvPr/>
          </p:nvCxnSpPr>
          <p:spPr>
            <a:xfrm rot="5400000" flipV="1">
              <a:off x="5699886" y="4728792"/>
              <a:ext cx="0" cy="54864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1" name="TextBox 80">
              <a:extLst>
                <a:ext uri="{FF2B5EF4-FFF2-40B4-BE49-F238E27FC236}">
                  <a16:creationId xmlns:a16="http://schemas.microsoft.com/office/drawing/2014/main" id="{1394250F-5201-DC48-AA44-7099A6DB906F}"/>
                </a:ext>
              </a:extLst>
            </p:cNvPr>
            <p:cNvSpPr txBox="1"/>
            <p:nvPr/>
          </p:nvSpPr>
          <p:spPr>
            <a:xfrm>
              <a:off x="5981349" y="4840977"/>
              <a:ext cx="687363" cy="38186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CD4</a:t>
              </a:r>
            </a:p>
          </p:txBody>
        </p:sp>
        <p:sp>
          <p:nvSpPr>
            <p:cNvPr id="82" name="TextBox 81">
              <a:extLst>
                <a:ext uri="{FF2B5EF4-FFF2-40B4-BE49-F238E27FC236}">
                  <a16:creationId xmlns:a16="http://schemas.microsoft.com/office/drawing/2014/main" id="{0C4A7AC9-8D78-524F-942D-46D557E6032E}"/>
                </a:ext>
              </a:extLst>
            </p:cNvPr>
            <p:cNvSpPr txBox="1"/>
            <p:nvPr/>
          </p:nvSpPr>
          <p:spPr>
            <a:xfrm rot="16200000">
              <a:off x="5094331" y="3922351"/>
              <a:ext cx="676755" cy="38186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IL17</a:t>
              </a:r>
            </a:p>
          </p:txBody>
        </p:sp>
      </p:grpSp>
      <p:sp>
        <p:nvSpPr>
          <p:cNvPr id="86" name="TextBox 85">
            <a:extLst>
              <a:ext uri="{FF2B5EF4-FFF2-40B4-BE49-F238E27FC236}">
                <a16:creationId xmlns:a16="http://schemas.microsoft.com/office/drawing/2014/main" id="{8E3D3354-2658-D445-BB0B-A10480161FF9}"/>
              </a:ext>
            </a:extLst>
          </p:cNvPr>
          <p:cNvSpPr txBox="1"/>
          <p:nvPr/>
        </p:nvSpPr>
        <p:spPr>
          <a:xfrm>
            <a:off x="8557264" y="2200538"/>
            <a:ext cx="94097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Gate for Th17</a:t>
            </a: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A0D49CBF-CA7E-4D47-A1B8-BEC3B9466D17}"/>
              </a:ext>
            </a:extLst>
          </p:cNvPr>
          <p:cNvSpPr txBox="1"/>
          <p:nvPr/>
        </p:nvSpPr>
        <p:spPr>
          <a:xfrm>
            <a:off x="6693487" y="3080776"/>
            <a:ext cx="8616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Gate for B220+ Cells</a:t>
            </a:r>
          </a:p>
        </p:txBody>
      </p:sp>
      <p:cxnSp>
        <p:nvCxnSpPr>
          <p:cNvPr id="95" name="Straight Arrow Connector 94">
            <a:extLst>
              <a:ext uri="{FF2B5EF4-FFF2-40B4-BE49-F238E27FC236}">
                <a16:creationId xmlns:a16="http://schemas.microsoft.com/office/drawing/2014/main" id="{60A5390B-209B-6649-98AC-3D465EDAD499}"/>
              </a:ext>
            </a:extLst>
          </p:cNvPr>
          <p:cNvCxnSpPr>
            <a:cxnSpLocks/>
          </p:cNvCxnSpPr>
          <p:nvPr/>
        </p:nvCxnSpPr>
        <p:spPr>
          <a:xfrm>
            <a:off x="5764653" y="2414199"/>
            <a:ext cx="832637" cy="946782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8" name="Straight Arrow Connector 97">
            <a:extLst>
              <a:ext uri="{FF2B5EF4-FFF2-40B4-BE49-F238E27FC236}">
                <a16:creationId xmlns:a16="http://schemas.microsoft.com/office/drawing/2014/main" id="{3C1B1F6F-E4C8-554D-9A1A-D1E602849009}"/>
              </a:ext>
            </a:extLst>
          </p:cNvPr>
          <p:cNvCxnSpPr>
            <a:cxnSpLocks/>
          </p:cNvCxnSpPr>
          <p:nvPr/>
        </p:nvCxnSpPr>
        <p:spPr>
          <a:xfrm>
            <a:off x="7697990" y="4080491"/>
            <a:ext cx="737778" cy="157791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9" name="Straight Arrow Connector 98">
            <a:extLst>
              <a:ext uri="{FF2B5EF4-FFF2-40B4-BE49-F238E27FC236}">
                <a16:creationId xmlns:a16="http://schemas.microsoft.com/office/drawing/2014/main" id="{FF236E01-10D8-1F4B-82AC-A69B33C258F9}"/>
              </a:ext>
            </a:extLst>
          </p:cNvPr>
          <p:cNvCxnSpPr>
            <a:cxnSpLocks/>
          </p:cNvCxnSpPr>
          <p:nvPr/>
        </p:nvCxnSpPr>
        <p:spPr>
          <a:xfrm>
            <a:off x="7555108" y="4510711"/>
            <a:ext cx="448045" cy="720473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9" name="TextBox 108">
            <a:extLst>
              <a:ext uri="{FF2B5EF4-FFF2-40B4-BE49-F238E27FC236}">
                <a16:creationId xmlns:a16="http://schemas.microsoft.com/office/drawing/2014/main" id="{D79900F8-5AC4-BF43-B918-69555FEF9FB5}"/>
              </a:ext>
            </a:extLst>
          </p:cNvPr>
          <p:cNvSpPr txBox="1"/>
          <p:nvPr/>
        </p:nvSpPr>
        <p:spPr>
          <a:xfrm>
            <a:off x="8840764" y="3711159"/>
            <a:ext cx="8616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Gate for IgM+ Cells</a:t>
            </a:r>
          </a:p>
        </p:txBody>
      </p:sp>
      <p:grpSp>
        <p:nvGrpSpPr>
          <p:cNvPr id="9" name="Group 8">
            <a:extLst>
              <a:ext uri="{FF2B5EF4-FFF2-40B4-BE49-F238E27FC236}">
                <a16:creationId xmlns:a16="http://schemas.microsoft.com/office/drawing/2014/main" id="{BFCF1B8C-9DAA-624C-80DB-AF05FE6E9010}"/>
              </a:ext>
            </a:extLst>
          </p:cNvPr>
          <p:cNvGrpSpPr/>
          <p:nvPr/>
        </p:nvGrpSpPr>
        <p:grpSpPr>
          <a:xfrm>
            <a:off x="7540940" y="5591032"/>
            <a:ext cx="1181837" cy="1143644"/>
            <a:chOff x="7540940" y="5184638"/>
            <a:chExt cx="1181837" cy="1143644"/>
          </a:xfrm>
        </p:grpSpPr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5BCE603F-535C-DE42-B921-FCF5B3CF96D6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731825" y="5184638"/>
              <a:ext cx="990952" cy="978408"/>
            </a:xfrm>
            <a:prstGeom prst="rect">
              <a:avLst/>
            </a:prstGeom>
          </p:spPr>
        </p:pic>
        <p:grpSp>
          <p:nvGrpSpPr>
            <p:cNvPr id="111" name="Group 110">
              <a:extLst>
                <a:ext uri="{FF2B5EF4-FFF2-40B4-BE49-F238E27FC236}">
                  <a16:creationId xmlns:a16="http://schemas.microsoft.com/office/drawing/2014/main" id="{550324BD-423F-354C-AA39-AD7FDBE58FE4}"/>
                </a:ext>
              </a:extLst>
            </p:cNvPr>
            <p:cNvGrpSpPr/>
            <p:nvPr/>
          </p:nvGrpSpPr>
          <p:grpSpPr>
            <a:xfrm>
              <a:off x="7540940" y="5578166"/>
              <a:ext cx="1141928" cy="750116"/>
              <a:chOff x="4553720" y="1821320"/>
              <a:chExt cx="1141928" cy="1240925"/>
            </a:xfrm>
          </p:grpSpPr>
          <p:cxnSp>
            <p:nvCxnSpPr>
              <p:cNvPr id="113" name="Straight Arrow Connector 112">
                <a:extLst>
                  <a:ext uri="{FF2B5EF4-FFF2-40B4-BE49-F238E27FC236}">
                    <a16:creationId xmlns:a16="http://schemas.microsoft.com/office/drawing/2014/main" id="{2B24ECE6-3737-9143-B46D-1EBCAC2E3568}"/>
                  </a:ext>
                </a:extLst>
              </p:cNvPr>
              <p:cNvCxnSpPr/>
              <p:nvPr/>
            </p:nvCxnSpPr>
            <p:spPr>
              <a:xfrm flipV="1">
                <a:off x="4667599" y="2345942"/>
                <a:ext cx="0" cy="548639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4" name="Straight Arrow Connector 113">
                <a:extLst>
                  <a:ext uri="{FF2B5EF4-FFF2-40B4-BE49-F238E27FC236}">
                    <a16:creationId xmlns:a16="http://schemas.microsoft.com/office/drawing/2014/main" id="{002AF725-441A-C34C-9F25-626BF1243E37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 flipV="1">
                <a:off x="4827222" y="2722845"/>
                <a:ext cx="0" cy="329184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5" name="TextBox 114">
                <a:extLst>
                  <a:ext uri="{FF2B5EF4-FFF2-40B4-BE49-F238E27FC236}">
                    <a16:creationId xmlns:a16="http://schemas.microsoft.com/office/drawing/2014/main" id="{4CBE988E-DD17-BE47-AE53-C22A0EE93681}"/>
                  </a:ext>
                </a:extLst>
              </p:cNvPr>
              <p:cNvSpPr txBox="1"/>
              <p:nvPr/>
            </p:nvSpPr>
            <p:spPr>
              <a:xfrm>
                <a:off x="4944641" y="2680377"/>
                <a:ext cx="751007" cy="38186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B220</a:t>
                </a:r>
              </a:p>
            </p:txBody>
          </p:sp>
          <p:sp>
            <p:nvSpPr>
              <p:cNvPr id="116" name="TextBox 115">
                <a:extLst>
                  <a:ext uri="{FF2B5EF4-FFF2-40B4-BE49-F238E27FC236}">
                    <a16:creationId xmlns:a16="http://schemas.microsoft.com/office/drawing/2014/main" id="{11AC39DB-BB4B-0748-9D0E-FAE6024CDE3C}"/>
                  </a:ext>
                </a:extLst>
              </p:cNvPr>
              <p:cNvSpPr txBox="1"/>
              <p:nvPr/>
            </p:nvSpPr>
            <p:spPr>
              <a:xfrm rot="16200000">
                <a:off x="4448706" y="1926334"/>
                <a:ext cx="591896" cy="38186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IgA</a:t>
                </a:r>
              </a:p>
            </p:txBody>
          </p:sp>
        </p:grpSp>
      </p:grpSp>
      <p:sp>
        <p:nvSpPr>
          <p:cNvPr id="117" name="TextBox 116">
            <a:extLst>
              <a:ext uri="{FF2B5EF4-FFF2-40B4-BE49-F238E27FC236}">
                <a16:creationId xmlns:a16="http://schemas.microsoft.com/office/drawing/2014/main" id="{F74A7890-6EB6-7342-9206-4CB82D70EFAB}"/>
              </a:ext>
            </a:extLst>
          </p:cNvPr>
          <p:cNvSpPr txBox="1"/>
          <p:nvPr/>
        </p:nvSpPr>
        <p:spPr>
          <a:xfrm>
            <a:off x="7828300" y="5241810"/>
            <a:ext cx="8616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Gate for IgA+ Cells</a:t>
            </a:r>
          </a:p>
        </p:txBody>
      </p:sp>
      <p:cxnSp>
        <p:nvCxnSpPr>
          <p:cNvPr id="119" name="Straight Arrow Connector 118">
            <a:extLst>
              <a:ext uri="{FF2B5EF4-FFF2-40B4-BE49-F238E27FC236}">
                <a16:creationId xmlns:a16="http://schemas.microsoft.com/office/drawing/2014/main" id="{FCBDDB18-6BF9-DE4C-B37C-6E68DB65C3AD}"/>
              </a:ext>
            </a:extLst>
          </p:cNvPr>
          <p:cNvCxnSpPr>
            <a:cxnSpLocks/>
          </p:cNvCxnSpPr>
          <p:nvPr/>
        </p:nvCxnSpPr>
        <p:spPr>
          <a:xfrm flipH="1">
            <a:off x="5100974" y="2523669"/>
            <a:ext cx="120617" cy="446612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5" name="Group 24">
            <a:extLst>
              <a:ext uri="{FF2B5EF4-FFF2-40B4-BE49-F238E27FC236}">
                <a16:creationId xmlns:a16="http://schemas.microsoft.com/office/drawing/2014/main" id="{BFAC175D-035D-4947-A0CA-5C157036FBA6}"/>
              </a:ext>
            </a:extLst>
          </p:cNvPr>
          <p:cNvGrpSpPr/>
          <p:nvPr/>
        </p:nvGrpSpPr>
        <p:grpSpPr>
          <a:xfrm>
            <a:off x="4253389" y="3424675"/>
            <a:ext cx="1170459" cy="1147223"/>
            <a:chOff x="4263581" y="3043612"/>
            <a:chExt cx="1170459" cy="1147223"/>
          </a:xfrm>
        </p:grpSpPr>
        <p:pic>
          <p:nvPicPr>
            <p:cNvPr id="14" name="Picture 13">
              <a:extLst>
                <a:ext uri="{FF2B5EF4-FFF2-40B4-BE49-F238E27FC236}">
                  <a16:creationId xmlns:a16="http://schemas.microsoft.com/office/drawing/2014/main" id="{C2E47635-42AE-7A40-ABF2-757704893A67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440626" y="3043612"/>
              <a:ext cx="993414" cy="978408"/>
            </a:xfrm>
            <a:prstGeom prst="rect">
              <a:avLst/>
            </a:prstGeom>
          </p:spPr>
        </p:pic>
        <p:grpSp>
          <p:nvGrpSpPr>
            <p:cNvPr id="121" name="Group 120">
              <a:extLst>
                <a:ext uri="{FF2B5EF4-FFF2-40B4-BE49-F238E27FC236}">
                  <a16:creationId xmlns:a16="http://schemas.microsoft.com/office/drawing/2014/main" id="{DC976817-1556-DE45-AE36-36BCF5E58EBD}"/>
                </a:ext>
              </a:extLst>
            </p:cNvPr>
            <p:cNvGrpSpPr/>
            <p:nvPr/>
          </p:nvGrpSpPr>
          <p:grpSpPr>
            <a:xfrm>
              <a:off x="4263581" y="3325580"/>
              <a:ext cx="1154328" cy="865255"/>
              <a:chOff x="4567195" y="1675781"/>
              <a:chExt cx="1154328" cy="1431397"/>
            </a:xfrm>
          </p:grpSpPr>
          <p:cxnSp>
            <p:nvCxnSpPr>
              <p:cNvPr id="123" name="Straight Arrow Connector 122">
                <a:extLst>
                  <a:ext uri="{FF2B5EF4-FFF2-40B4-BE49-F238E27FC236}">
                    <a16:creationId xmlns:a16="http://schemas.microsoft.com/office/drawing/2014/main" id="{F0C36C43-423A-3549-9F05-A75C6BFAAE91}"/>
                  </a:ext>
                </a:extLst>
              </p:cNvPr>
              <p:cNvCxnSpPr/>
              <p:nvPr/>
            </p:nvCxnSpPr>
            <p:spPr>
              <a:xfrm flipV="1">
                <a:off x="4667600" y="2375895"/>
                <a:ext cx="0" cy="548639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4" name="Straight Arrow Connector 123">
                <a:extLst>
                  <a:ext uri="{FF2B5EF4-FFF2-40B4-BE49-F238E27FC236}">
                    <a16:creationId xmlns:a16="http://schemas.microsoft.com/office/drawing/2014/main" id="{FCA48754-9260-0E4E-A69F-AA7C5EFB989F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 flipV="1">
                <a:off x="4827220" y="2752799"/>
                <a:ext cx="0" cy="329184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5" name="TextBox 124">
                <a:extLst>
                  <a:ext uri="{FF2B5EF4-FFF2-40B4-BE49-F238E27FC236}">
                    <a16:creationId xmlns:a16="http://schemas.microsoft.com/office/drawing/2014/main" id="{BDC72A60-D8E2-EC40-82D6-5452FF75028D}"/>
                  </a:ext>
                </a:extLst>
              </p:cNvPr>
              <p:cNvSpPr txBox="1"/>
              <p:nvPr/>
            </p:nvSpPr>
            <p:spPr>
              <a:xfrm>
                <a:off x="4917478" y="2725311"/>
                <a:ext cx="804045" cy="38186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TCRb</a:t>
                </a:r>
              </a:p>
            </p:txBody>
          </p:sp>
          <p:sp>
            <p:nvSpPr>
              <p:cNvPr id="126" name="TextBox 125">
                <a:extLst>
                  <a:ext uri="{FF2B5EF4-FFF2-40B4-BE49-F238E27FC236}">
                    <a16:creationId xmlns:a16="http://schemas.microsoft.com/office/drawing/2014/main" id="{EBC9E293-6AEA-2F4B-A79A-4866F6A31B24}"/>
                  </a:ext>
                </a:extLst>
              </p:cNvPr>
              <p:cNvSpPr txBox="1"/>
              <p:nvPr/>
            </p:nvSpPr>
            <p:spPr>
              <a:xfrm rot="16200000">
                <a:off x="4361410" y="1881566"/>
                <a:ext cx="793437" cy="38186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CD8a</a:t>
                </a:r>
              </a:p>
            </p:txBody>
          </p:sp>
        </p:grpSp>
      </p:grpSp>
      <p:sp>
        <p:nvSpPr>
          <p:cNvPr id="127" name="TextBox 126">
            <a:extLst>
              <a:ext uri="{FF2B5EF4-FFF2-40B4-BE49-F238E27FC236}">
                <a16:creationId xmlns:a16="http://schemas.microsoft.com/office/drawing/2014/main" id="{2B511B88-B828-E440-906F-567BCF8E1D39}"/>
              </a:ext>
            </a:extLst>
          </p:cNvPr>
          <p:cNvSpPr txBox="1"/>
          <p:nvPr/>
        </p:nvSpPr>
        <p:spPr>
          <a:xfrm>
            <a:off x="4435943" y="3077433"/>
            <a:ext cx="10667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Gate for Cytotoxic T Cells</a:t>
            </a:r>
          </a:p>
        </p:txBody>
      </p:sp>
      <p:grpSp>
        <p:nvGrpSpPr>
          <p:cNvPr id="130" name="Group 129">
            <a:extLst>
              <a:ext uri="{FF2B5EF4-FFF2-40B4-BE49-F238E27FC236}">
                <a16:creationId xmlns:a16="http://schemas.microsoft.com/office/drawing/2014/main" id="{EDF174FB-3B34-6A46-AB9F-B2651DA912D1}"/>
              </a:ext>
            </a:extLst>
          </p:cNvPr>
          <p:cNvGrpSpPr/>
          <p:nvPr/>
        </p:nvGrpSpPr>
        <p:grpSpPr>
          <a:xfrm>
            <a:off x="241365" y="1322196"/>
            <a:ext cx="689038" cy="880583"/>
            <a:chOff x="241365" y="804184"/>
            <a:chExt cx="689038" cy="880583"/>
          </a:xfrm>
        </p:grpSpPr>
        <p:sp>
          <p:nvSpPr>
            <p:cNvPr id="15" name="Rectangle 14"/>
            <p:cNvSpPr/>
            <p:nvPr/>
          </p:nvSpPr>
          <p:spPr>
            <a:xfrm>
              <a:off x="267867" y="804184"/>
              <a:ext cx="636034" cy="880583"/>
            </a:xfrm>
            <a:prstGeom prst="rect">
              <a:avLst/>
            </a:prstGeom>
            <a:solidFill>
              <a:schemeClr val="accent1">
                <a:lumMod val="20000"/>
                <a:lumOff val="8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 dirty="0"/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241365" y="1042808"/>
              <a:ext cx="689038" cy="4154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Large Intestine</a:t>
              </a: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294993" y="1430851"/>
              <a:ext cx="581783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MLN</a:t>
              </a:r>
            </a:p>
          </p:txBody>
        </p:sp>
        <p:sp>
          <p:nvSpPr>
            <p:cNvPr id="129" name="TextBox 128">
              <a:extLst>
                <a:ext uri="{FF2B5EF4-FFF2-40B4-BE49-F238E27FC236}">
                  <a16:creationId xmlns:a16="http://schemas.microsoft.com/office/drawing/2014/main" id="{BFA5A1EF-1C6C-A340-8E1A-15086C9A3FEC}"/>
                </a:ext>
              </a:extLst>
            </p:cNvPr>
            <p:cNvSpPr txBox="1"/>
            <p:nvPr/>
          </p:nvSpPr>
          <p:spPr>
            <a:xfrm>
              <a:off x="241365" y="804184"/>
              <a:ext cx="689038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Liver</a:t>
              </a:r>
            </a:p>
          </p:txBody>
        </p:sp>
      </p:grpSp>
      <p:grpSp>
        <p:nvGrpSpPr>
          <p:cNvPr id="131" name="Group 130">
            <a:extLst>
              <a:ext uri="{FF2B5EF4-FFF2-40B4-BE49-F238E27FC236}">
                <a16:creationId xmlns:a16="http://schemas.microsoft.com/office/drawing/2014/main" id="{42C15BD5-6AB4-744E-954E-12121FA138B7}"/>
              </a:ext>
            </a:extLst>
          </p:cNvPr>
          <p:cNvGrpSpPr/>
          <p:nvPr/>
        </p:nvGrpSpPr>
        <p:grpSpPr>
          <a:xfrm>
            <a:off x="1490868" y="1457410"/>
            <a:ext cx="1005598" cy="577081"/>
            <a:chOff x="237047" y="804184"/>
            <a:chExt cx="1005598" cy="577081"/>
          </a:xfrm>
        </p:grpSpPr>
        <p:sp>
          <p:nvSpPr>
            <p:cNvPr id="132" name="Rectangle 131">
              <a:extLst>
                <a:ext uri="{FF2B5EF4-FFF2-40B4-BE49-F238E27FC236}">
                  <a16:creationId xmlns:a16="http://schemas.microsoft.com/office/drawing/2014/main" id="{0F6E04AB-649E-CA43-AEDD-1403EE144CD5}"/>
                </a:ext>
              </a:extLst>
            </p:cNvPr>
            <p:cNvSpPr/>
            <p:nvPr/>
          </p:nvSpPr>
          <p:spPr>
            <a:xfrm>
              <a:off x="237047" y="812858"/>
              <a:ext cx="994280" cy="568407"/>
            </a:xfrm>
            <a:prstGeom prst="rect">
              <a:avLst/>
            </a:prstGeom>
            <a:solidFill>
              <a:schemeClr val="accent1">
                <a:lumMod val="20000"/>
                <a:lumOff val="8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 dirty="0"/>
            </a:p>
          </p:txBody>
        </p:sp>
        <p:sp>
          <p:nvSpPr>
            <p:cNvPr id="135" name="TextBox 134">
              <a:extLst>
                <a:ext uri="{FF2B5EF4-FFF2-40B4-BE49-F238E27FC236}">
                  <a16:creationId xmlns:a16="http://schemas.microsoft.com/office/drawing/2014/main" id="{49993907-56B2-7343-88DE-3B0F18CCA69E}"/>
                </a:ext>
              </a:extLst>
            </p:cNvPr>
            <p:cNvSpPr txBox="1"/>
            <p:nvPr/>
          </p:nvSpPr>
          <p:spPr>
            <a:xfrm>
              <a:off x="241364" y="804184"/>
              <a:ext cx="1001281" cy="5770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Lymphocyte Isolation and Labeling</a:t>
              </a:r>
            </a:p>
          </p:txBody>
        </p:sp>
      </p:grpSp>
      <p:grpSp>
        <p:nvGrpSpPr>
          <p:cNvPr id="12" name="Group 11">
            <a:extLst>
              <a:ext uri="{FF2B5EF4-FFF2-40B4-BE49-F238E27FC236}">
                <a16:creationId xmlns:a16="http://schemas.microsoft.com/office/drawing/2014/main" id="{73F9E966-1F4A-CF4B-A47E-FE7A17B63724}"/>
              </a:ext>
            </a:extLst>
          </p:cNvPr>
          <p:cNvGrpSpPr/>
          <p:nvPr/>
        </p:nvGrpSpPr>
        <p:grpSpPr>
          <a:xfrm>
            <a:off x="8584987" y="4062959"/>
            <a:ext cx="1145198" cy="1150119"/>
            <a:chOff x="8584987" y="3656565"/>
            <a:chExt cx="1145198" cy="1150119"/>
          </a:xfrm>
        </p:grpSpPr>
        <p:grpSp>
          <p:nvGrpSpPr>
            <p:cNvPr id="103" name="Group 102">
              <a:extLst>
                <a:ext uri="{FF2B5EF4-FFF2-40B4-BE49-F238E27FC236}">
                  <a16:creationId xmlns:a16="http://schemas.microsoft.com/office/drawing/2014/main" id="{88EEBD05-D4F6-1C44-B129-D1DB244ACE0C}"/>
                </a:ext>
              </a:extLst>
            </p:cNvPr>
            <p:cNvGrpSpPr/>
            <p:nvPr/>
          </p:nvGrpSpPr>
          <p:grpSpPr>
            <a:xfrm>
              <a:off x="8584987" y="4019885"/>
              <a:ext cx="1137512" cy="786799"/>
              <a:chOff x="4585302" y="1775614"/>
              <a:chExt cx="1137512" cy="1301610"/>
            </a:xfrm>
          </p:grpSpPr>
          <p:cxnSp>
            <p:nvCxnSpPr>
              <p:cNvPr id="105" name="Straight Arrow Connector 104">
                <a:extLst>
                  <a:ext uri="{FF2B5EF4-FFF2-40B4-BE49-F238E27FC236}">
                    <a16:creationId xmlns:a16="http://schemas.microsoft.com/office/drawing/2014/main" id="{C5CA79BE-ED02-EE47-A507-78BDFE6F3846}"/>
                  </a:ext>
                </a:extLst>
              </p:cNvPr>
              <p:cNvCxnSpPr/>
              <p:nvPr/>
            </p:nvCxnSpPr>
            <p:spPr>
              <a:xfrm flipV="1">
                <a:off x="4694761" y="2345944"/>
                <a:ext cx="0" cy="54864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6" name="Straight Arrow Connector 105">
                <a:extLst>
                  <a:ext uri="{FF2B5EF4-FFF2-40B4-BE49-F238E27FC236}">
                    <a16:creationId xmlns:a16="http://schemas.microsoft.com/office/drawing/2014/main" id="{0D425780-F170-F54F-BCBA-4BD7ABB4F793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 flipV="1">
                <a:off x="4854382" y="2722849"/>
                <a:ext cx="0" cy="329184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7" name="TextBox 106">
                <a:extLst>
                  <a:ext uri="{FF2B5EF4-FFF2-40B4-BE49-F238E27FC236}">
                    <a16:creationId xmlns:a16="http://schemas.microsoft.com/office/drawing/2014/main" id="{66112512-961A-EE4D-88A1-0FA292877BC2}"/>
                  </a:ext>
                </a:extLst>
              </p:cNvPr>
              <p:cNvSpPr txBox="1"/>
              <p:nvPr/>
            </p:nvSpPr>
            <p:spPr>
              <a:xfrm>
                <a:off x="4971807" y="2695356"/>
                <a:ext cx="751007" cy="38186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B220</a:t>
                </a:r>
              </a:p>
            </p:txBody>
          </p:sp>
          <p:sp>
            <p:nvSpPr>
              <p:cNvPr id="108" name="TextBox 107">
                <a:extLst>
                  <a:ext uri="{FF2B5EF4-FFF2-40B4-BE49-F238E27FC236}">
                    <a16:creationId xmlns:a16="http://schemas.microsoft.com/office/drawing/2014/main" id="{E59A60BE-E3EB-5341-8DC4-C370438AE9C9}"/>
                  </a:ext>
                </a:extLst>
              </p:cNvPr>
              <p:cNvSpPr txBox="1"/>
              <p:nvPr/>
            </p:nvSpPr>
            <p:spPr>
              <a:xfrm rot="16200000">
                <a:off x="4464377" y="1896539"/>
                <a:ext cx="623718" cy="38186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IgM</a:t>
                </a:r>
              </a:p>
            </p:txBody>
          </p:sp>
        </p:grpSp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3E9E6DAF-5A17-B840-BAF6-7E84E0B32A13}"/>
                </a:ext>
              </a:extLst>
            </p:cNvPr>
            <p:cNvPicPr>
              <a:picLocks noChangeAspect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747605" y="3656565"/>
              <a:ext cx="982580" cy="978408"/>
            </a:xfrm>
            <a:prstGeom prst="rect">
              <a:avLst/>
            </a:prstGeom>
          </p:spPr>
        </p:pic>
      </p:grpSp>
      <p:grpSp>
        <p:nvGrpSpPr>
          <p:cNvPr id="2" name="Group 1">
            <a:extLst>
              <a:ext uri="{FF2B5EF4-FFF2-40B4-BE49-F238E27FC236}">
                <a16:creationId xmlns:a16="http://schemas.microsoft.com/office/drawing/2014/main" id="{DAD73332-844B-4896-AED2-5E6E4DCAD59A}"/>
              </a:ext>
            </a:extLst>
          </p:cNvPr>
          <p:cNvGrpSpPr/>
          <p:nvPr/>
        </p:nvGrpSpPr>
        <p:grpSpPr>
          <a:xfrm>
            <a:off x="6365628" y="3419733"/>
            <a:ext cx="1199247" cy="1177150"/>
            <a:chOff x="2943322" y="4922401"/>
            <a:chExt cx="1199247" cy="1177150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A1F379E0-23AE-FA44-BDE9-B93C59231D0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79" t="2340" b="943"/>
            <a:stretch/>
          </p:blipFill>
          <p:spPr>
            <a:xfrm>
              <a:off x="3140716" y="4922401"/>
              <a:ext cx="1001853" cy="978408"/>
            </a:xfrm>
            <a:prstGeom prst="rect">
              <a:avLst/>
            </a:prstGeom>
          </p:spPr>
        </p:pic>
        <p:cxnSp>
          <p:nvCxnSpPr>
            <p:cNvPr id="110" name="Straight Arrow Connector 109">
              <a:extLst>
                <a:ext uri="{FF2B5EF4-FFF2-40B4-BE49-F238E27FC236}">
                  <a16:creationId xmlns:a16="http://schemas.microsoft.com/office/drawing/2014/main" id="{ECE72DB3-52AF-47C9-A155-915BADC11A75}"/>
                </a:ext>
              </a:extLst>
            </p:cNvPr>
            <p:cNvCxnSpPr/>
            <p:nvPr/>
          </p:nvCxnSpPr>
          <p:spPr>
            <a:xfrm flipV="1">
              <a:off x="3063710" y="5657503"/>
              <a:ext cx="0" cy="331643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2" name="Straight Arrow Connector 111">
              <a:extLst>
                <a:ext uri="{FF2B5EF4-FFF2-40B4-BE49-F238E27FC236}">
                  <a16:creationId xmlns:a16="http://schemas.microsoft.com/office/drawing/2014/main" id="{1217D959-AFB3-4406-A9C4-887EC7F3285C}"/>
                </a:ext>
              </a:extLst>
            </p:cNvPr>
            <p:cNvCxnSpPr>
              <a:cxnSpLocks/>
            </p:cNvCxnSpPr>
            <p:nvPr/>
          </p:nvCxnSpPr>
          <p:spPr>
            <a:xfrm rot="5400000" flipV="1">
              <a:off x="3223330" y="5820236"/>
              <a:ext cx="0" cy="329184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8" name="TextBox 117">
              <a:extLst>
                <a:ext uri="{FF2B5EF4-FFF2-40B4-BE49-F238E27FC236}">
                  <a16:creationId xmlns:a16="http://schemas.microsoft.com/office/drawing/2014/main" id="{1D18C378-047F-4C8D-9D27-84F483F5A6F7}"/>
                </a:ext>
              </a:extLst>
            </p:cNvPr>
            <p:cNvSpPr txBox="1"/>
            <p:nvPr/>
          </p:nvSpPr>
          <p:spPr>
            <a:xfrm>
              <a:off x="3313588" y="5868719"/>
              <a:ext cx="45397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B220</a:t>
              </a:r>
            </a:p>
          </p:txBody>
        </p:sp>
        <p:sp>
          <p:nvSpPr>
            <p:cNvPr id="120" name="TextBox 119">
              <a:extLst>
                <a:ext uri="{FF2B5EF4-FFF2-40B4-BE49-F238E27FC236}">
                  <a16:creationId xmlns:a16="http://schemas.microsoft.com/office/drawing/2014/main" id="{E0C0F77B-9098-4BE1-BE0F-A5367C7E7A72}"/>
                </a:ext>
              </a:extLst>
            </p:cNvPr>
            <p:cNvSpPr txBox="1"/>
            <p:nvPr/>
          </p:nvSpPr>
          <p:spPr>
            <a:xfrm rot="16200000">
              <a:off x="2847783" y="5384919"/>
              <a:ext cx="42191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SSC</a:t>
              </a:r>
            </a:p>
          </p:txBody>
        </p:sp>
      </p:grpSp>
      <p:sp>
        <p:nvSpPr>
          <p:cNvPr id="128" name="TextBox 127">
            <a:extLst>
              <a:ext uri="{FF2B5EF4-FFF2-40B4-BE49-F238E27FC236}">
                <a16:creationId xmlns:a16="http://schemas.microsoft.com/office/drawing/2014/main" id="{D227381F-F7CB-4F63-AF60-786ACB994F02}"/>
              </a:ext>
            </a:extLst>
          </p:cNvPr>
          <p:cNvSpPr txBox="1"/>
          <p:nvPr/>
        </p:nvSpPr>
        <p:spPr>
          <a:xfrm>
            <a:off x="-5423" y="23442"/>
            <a:ext cx="12197421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600"/>
              </a:spcBef>
              <a:spcAft>
                <a:spcPts val="1200"/>
              </a:spcAft>
            </a:pP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Supplemental Figure S1.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Flow Cytometry Workflow and Gating Strategy.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Lymphocytes from liver, large intestine, and mesenteric lymph node tissue were labeled for determination of liver Tregs, Th1 cells, and Th17 cells; large intestine lamina propria Tregs, Th1 cells, and Th17 cells; small intestine B cells; and mesenteric lymph node Tregs, Th1 cells, Th17 cells, and B cells. Single cell discrimination and lymphocyte gating based on forward and side was performed prior to gating for target cell populations.</a:t>
            </a:r>
          </a:p>
        </p:txBody>
      </p:sp>
    </p:spTree>
    <p:extLst>
      <p:ext uri="{BB962C8B-B14F-4D97-AF65-F5344CB8AC3E}">
        <p14:creationId xmlns:p14="http://schemas.microsoft.com/office/powerpoint/2010/main" val="331941260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CB54D22E-FEB0-4C5E-9C74-471EABDFD0C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83613051"/>
              </p:ext>
            </p:extLst>
          </p:nvPr>
        </p:nvGraphicFramePr>
        <p:xfrm>
          <a:off x="2700338" y="1341580"/>
          <a:ext cx="2986087" cy="17573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5599750" imgH="3291808" progId="Prism9.Document">
                  <p:embed/>
                </p:oleObj>
              </mc:Choice>
              <mc:Fallback>
                <p:oleObj name="Prism 9" r:id="rId2" imgW="5599750" imgH="3291808" progId="Prism9.Document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CB54D22E-FEB0-4C5E-9C74-471EABDFD0C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2700338" y="1341580"/>
                        <a:ext cx="2986087" cy="17573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8A937648-27BE-40CC-8EFD-491C953B9C1C}"/>
              </a:ext>
            </a:extLst>
          </p:cNvPr>
          <p:cNvSpPr txBox="1"/>
          <p:nvPr/>
        </p:nvSpPr>
        <p:spPr>
          <a:xfrm>
            <a:off x="3038868" y="887427"/>
            <a:ext cx="9571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Th1 Cells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355BEFE0-0ABF-4781-9612-476264E8162F}"/>
              </a:ext>
            </a:extLst>
          </p:cNvPr>
          <p:cNvSpPr txBox="1"/>
          <p:nvPr/>
        </p:nvSpPr>
        <p:spPr>
          <a:xfrm>
            <a:off x="4657549" y="881853"/>
            <a:ext cx="9571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Th17 Cells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7B415037-4F39-4666-B746-AAC8D2EC843D}"/>
              </a:ext>
            </a:extLst>
          </p:cNvPr>
          <p:cNvSpPr txBox="1"/>
          <p:nvPr/>
        </p:nvSpPr>
        <p:spPr>
          <a:xfrm>
            <a:off x="7041412" y="888314"/>
            <a:ext cx="109793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IgM+ B Cells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49B3F6DE-0B60-45C4-9DB3-DBCD82F74FA2}"/>
              </a:ext>
            </a:extLst>
          </p:cNvPr>
          <p:cNvSpPr txBox="1"/>
          <p:nvPr/>
        </p:nvSpPr>
        <p:spPr>
          <a:xfrm>
            <a:off x="8665820" y="888314"/>
            <a:ext cx="109793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IgA+ B Cells</a:t>
            </a:r>
          </a:p>
        </p:txBody>
      </p:sp>
      <p:graphicFrame>
        <p:nvGraphicFramePr>
          <p:cNvPr id="10" name="Object 9">
            <a:extLst>
              <a:ext uri="{FF2B5EF4-FFF2-40B4-BE49-F238E27FC236}">
                <a16:creationId xmlns:a16="http://schemas.microsoft.com/office/drawing/2014/main" id="{05D20F71-7B16-4A5A-8365-0082898DF95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00745899"/>
              </p:ext>
            </p:extLst>
          </p:nvPr>
        </p:nvGraphicFramePr>
        <p:xfrm>
          <a:off x="2636838" y="3184668"/>
          <a:ext cx="3117850" cy="18272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4" imgW="5781259" imgH="3383287" progId="Prism9.Document">
                  <p:embed/>
                </p:oleObj>
              </mc:Choice>
              <mc:Fallback>
                <p:oleObj name="Prism 9" r:id="rId4" imgW="5781259" imgH="3383287" progId="Prism9.Document">
                  <p:embed/>
                  <p:pic>
                    <p:nvPicPr>
                      <p:cNvPr id="10" name="Object 9">
                        <a:extLst>
                          <a:ext uri="{FF2B5EF4-FFF2-40B4-BE49-F238E27FC236}">
                            <a16:creationId xmlns:a16="http://schemas.microsoft.com/office/drawing/2014/main" id="{05D20F71-7B16-4A5A-8365-0082898DF95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2636838" y="3184668"/>
                        <a:ext cx="3117850" cy="18272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Object 10">
            <a:extLst>
              <a:ext uri="{FF2B5EF4-FFF2-40B4-BE49-F238E27FC236}">
                <a16:creationId xmlns:a16="http://schemas.microsoft.com/office/drawing/2014/main" id="{3033C1BE-8F89-4D09-9A8F-F2C8DE770C8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4649054"/>
              </p:ext>
            </p:extLst>
          </p:nvPr>
        </p:nvGraphicFramePr>
        <p:xfrm>
          <a:off x="6715125" y="1236805"/>
          <a:ext cx="3155950" cy="19288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6" imgW="4198822" imgH="2567538" progId="Prism9.Document">
                  <p:embed/>
                </p:oleObj>
              </mc:Choice>
              <mc:Fallback>
                <p:oleObj name="Prism 9" r:id="rId6" imgW="4198822" imgH="2567538" progId="Prism9.Document">
                  <p:embed/>
                  <p:pic>
                    <p:nvPicPr>
                      <p:cNvPr id="11" name="Object 10">
                        <a:extLst>
                          <a:ext uri="{FF2B5EF4-FFF2-40B4-BE49-F238E27FC236}">
                            <a16:creationId xmlns:a16="http://schemas.microsoft.com/office/drawing/2014/main" id="{3033C1BE-8F89-4D09-9A8F-F2C8DE770C8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6715125" y="1236805"/>
                        <a:ext cx="3155950" cy="19288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4" name="TextBox 13">
            <a:extLst>
              <a:ext uri="{FF2B5EF4-FFF2-40B4-BE49-F238E27FC236}">
                <a16:creationId xmlns:a16="http://schemas.microsoft.com/office/drawing/2014/main" id="{CEF5900F-9532-4C78-938F-73F271FEE374}"/>
              </a:ext>
            </a:extLst>
          </p:cNvPr>
          <p:cNvSpPr txBox="1"/>
          <p:nvPr/>
        </p:nvSpPr>
        <p:spPr>
          <a:xfrm rot="16200000">
            <a:off x="2008663" y="5657088"/>
            <a:ext cx="9571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Liver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326F2845-DF0C-4302-8EF9-E5FC7B0528E8}"/>
              </a:ext>
            </a:extLst>
          </p:cNvPr>
          <p:cNvSpPr txBox="1"/>
          <p:nvPr/>
        </p:nvSpPr>
        <p:spPr>
          <a:xfrm rot="16200000">
            <a:off x="2008663" y="1952248"/>
            <a:ext cx="9571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MLN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0161239A-9BE4-47C7-8F66-AC0FCF056FE6}"/>
              </a:ext>
            </a:extLst>
          </p:cNvPr>
          <p:cNvSpPr txBox="1"/>
          <p:nvPr/>
        </p:nvSpPr>
        <p:spPr>
          <a:xfrm rot="16200000">
            <a:off x="2008663" y="3788306"/>
            <a:ext cx="9571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LI LPL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8A0BB93C-7E19-4BB9-9316-7B92C54C9158}"/>
              </a:ext>
            </a:extLst>
          </p:cNvPr>
          <p:cNvSpPr txBox="1"/>
          <p:nvPr/>
        </p:nvSpPr>
        <p:spPr>
          <a:xfrm rot="16200000">
            <a:off x="6105105" y="1899904"/>
            <a:ext cx="9571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MLN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B24BBD92-BA3B-4119-BC86-8FFEB076B5DF}"/>
              </a:ext>
            </a:extLst>
          </p:cNvPr>
          <p:cNvSpPr txBox="1"/>
          <p:nvPr/>
        </p:nvSpPr>
        <p:spPr>
          <a:xfrm rot="16200000">
            <a:off x="6105105" y="3708636"/>
            <a:ext cx="9571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I LPL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FB36D9B7-A6AC-411C-93B6-1A576F417288}"/>
              </a:ext>
            </a:extLst>
          </p:cNvPr>
          <p:cNvSpPr txBox="1"/>
          <p:nvPr/>
        </p:nvSpPr>
        <p:spPr>
          <a:xfrm>
            <a:off x="2277074" y="875226"/>
            <a:ext cx="33237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CD44D0FD-7EB4-49E3-8908-45EF2D16999F}"/>
              </a:ext>
            </a:extLst>
          </p:cNvPr>
          <p:cNvSpPr txBox="1"/>
          <p:nvPr/>
        </p:nvSpPr>
        <p:spPr>
          <a:xfrm>
            <a:off x="6348753" y="875226"/>
            <a:ext cx="33237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aphicFrame>
        <p:nvGraphicFramePr>
          <p:cNvPr id="25" name="Object 24">
            <a:extLst>
              <a:ext uri="{FF2B5EF4-FFF2-40B4-BE49-F238E27FC236}">
                <a16:creationId xmlns:a16="http://schemas.microsoft.com/office/drawing/2014/main" id="{AF44CE8B-DFB0-4FA8-AAD0-A916B354C02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20104711"/>
              </p:ext>
            </p:extLst>
          </p:nvPr>
        </p:nvGraphicFramePr>
        <p:xfrm>
          <a:off x="2678113" y="5010293"/>
          <a:ext cx="3089275" cy="18811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8" imgW="5790262" imgH="3526628" progId="Prism9.Document">
                  <p:embed/>
                </p:oleObj>
              </mc:Choice>
              <mc:Fallback>
                <p:oleObj name="Prism 9" r:id="rId8" imgW="5790262" imgH="3526628" progId="Prism9.Document">
                  <p:embed/>
                  <p:pic>
                    <p:nvPicPr>
                      <p:cNvPr id="25" name="Object 24">
                        <a:extLst>
                          <a:ext uri="{FF2B5EF4-FFF2-40B4-BE49-F238E27FC236}">
                            <a16:creationId xmlns:a16="http://schemas.microsoft.com/office/drawing/2014/main" id="{AF44CE8B-DFB0-4FA8-AAD0-A916B354C02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2678113" y="5010293"/>
                        <a:ext cx="3089275" cy="18811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6" name="Object 25">
            <a:extLst>
              <a:ext uri="{FF2B5EF4-FFF2-40B4-BE49-F238E27FC236}">
                <a16:creationId xmlns:a16="http://schemas.microsoft.com/office/drawing/2014/main" id="{011B732D-C5BA-481C-95E1-674A26CB941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23224923"/>
              </p:ext>
            </p:extLst>
          </p:nvPr>
        </p:nvGraphicFramePr>
        <p:xfrm>
          <a:off x="6691313" y="3122755"/>
          <a:ext cx="3224212" cy="19319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0" imgW="4290297" imgH="2576542" progId="Prism9.Document">
                  <p:embed/>
                </p:oleObj>
              </mc:Choice>
              <mc:Fallback>
                <p:oleObj name="Prism 9" r:id="rId10" imgW="4290297" imgH="2576542" progId="Prism9.Document">
                  <p:embed/>
                  <p:pic>
                    <p:nvPicPr>
                      <p:cNvPr id="26" name="Object 25">
                        <a:extLst>
                          <a:ext uri="{FF2B5EF4-FFF2-40B4-BE49-F238E27FC236}">
                            <a16:creationId xmlns:a16="http://schemas.microsoft.com/office/drawing/2014/main" id="{011B732D-C5BA-481C-95E1-674A26CB941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6691313" y="3122755"/>
                        <a:ext cx="3224212" cy="19319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0" name="TextBox 19">
            <a:extLst>
              <a:ext uri="{FF2B5EF4-FFF2-40B4-BE49-F238E27FC236}">
                <a16:creationId xmlns:a16="http://schemas.microsoft.com/office/drawing/2014/main" id="{2F01141C-080A-4DDE-93BA-AE7A97B09212}"/>
              </a:ext>
            </a:extLst>
          </p:cNvPr>
          <p:cNvSpPr txBox="1"/>
          <p:nvPr/>
        </p:nvSpPr>
        <p:spPr>
          <a:xfrm>
            <a:off x="0" y="53577"/>
            <a:ext cx="12192000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600"/>
              </a:spcBef>
              <a:spcAft>
                <a:spcPts val="1200"/>
              </a:spcAft>
            </a:pP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Supplemental Figure S2. Effects of hBD-2 on Th1, Th17, and B Cell Populations.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Relative abundance (compared to pair-fed mice) of Th1 and Th17 cells (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A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) or B cells (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B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) in indicated tissues in Cohort 1 mice. Data are reported as mean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±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standard error of the mean.</a:t>
            </a:r>
          </a:p>
        </p:txBody>
      </p:sp>
    </p:spTree>
    <p:extLst>
      <p:ext uri="{BB962C8B-B14F-4D97-AF65-F5344CB8AC3E}">
        <p14:creationId xmlns:p14="http://schemas.microsoft.com/office/powerpoint/2010/main" val="334556379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C3D75B9A-3A8C-4FD7-935D-38924F5A93C1}"/>
              </a:ext>
            </a:extLst>
          </p:cNvPr>
          <p:cNvGraphicFramePr>
            <a:graphicFrameLocks noChangeAspect="1"/>
          </p:cNvGraphicFramePr>
          <p:nvPr/>
        </p:nvGraphicFramePr>
        <p:xfrm>
          <a:off x="2100329" y="1903049"/>
          <a:ext cx="2616200" cy="30162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2616026" imgH="3015930" progId="Prism9.Document">
                  <p:embed/>
                </p:oleObj>
              </mc:Choice>
              <mc:Fallback>
                <p:oleObj name="Prism 9" r:id="rId2" imgW="2616026" imgH="3015930" progId="Prism9.Document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C3D75B9A-3A8C-4FD7-935D-38924F5A93C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2100329" y="1903049"/>
                        <a:ext cx="2616200" cy="30162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5EDCA857-CDC9-483D-99A9-386D91B073F8}"/>
              </a:ext>
            </a:extLst>
          </p:cNvPr>
          <p:cNvSpPr txBox="1"/>
          <p:nvPr/>
        </p:nvSpPr>
        <p:spPr>
          <a:xfrm>
            <a:off x="1767957" y="1808170"/>
            <a:ext cx="33237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DC31B9E8-C832-4C98-9138-5CA2B40B7141}"/>
              </a:ext>
            </a:extLst>
          </p:cNvPr>
          <p:cNvSpPr txBox="1"/>
          <p:nvPr/>
        </p:nvSpPr>
        <p:spPr>
          <a:xfrm>
            <a:off x="4611033" y="1808170"/>
            <a:ext cx="33237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85ED300D-D371-4CF3-BEA9-4C2204F6CBC0}"/>
              </a:ext>
            </a:extLst>
          </p:cNvPr>
          <p:cNvSpPr txBox="1"/>
          <p:nvPr/>
        </p:nvSpPr>
        <p:spPr>
          <a:xfrm>
            <a:off x="7462232" y="1808170"/>
            <a:ext cx="33237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6C3CBA7A-71C0-6342-878A-209C470C1D0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768850" y="2025650"/>
            <a:ext cx="2654300" cy="2806700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C33735BE-1930-E64F-BC17-EC74CD6021E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678924" y="2025650"/>
            <a:ext cx="2654300" cy="2806700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C825B065-D584-4760-8696-2CCA32F71010}"/>
              </a:ext>
            </a:extLst>
          </p:cNvPr>
          <p:cNvSpPr txBox="1"/>
          <p:nvPr/>
        </p:nvSpPr>
        <p:spPr>
          <a:xfrm>
            <a:off x="295563" y="244964"/>
            <a:ext cx="11600873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600"/>
              </a:spcBef>
              <a:spcAft>
                <a:spcPts val="1200"/>
              </a:spcAft>
            </a:pP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Supplemental Figure S3. Effects of hBD-2 on Gut Microbiota Alpha Diversity.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20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Alpha diversity</a:t>
            </a:r>
            <a:r>
              <a:rPr lang="en-US" sz="120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20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as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measured by (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A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)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Shannon’s Diversity Index,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(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B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) Ace Index, and (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C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) </a:t>
            </a:r>
            <a:r>
              <a:rPr lang="en-US" sz="120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Chao Index</a:t>
            </a:r>
            <a:r>
              <a:rPr lang="en-US" sz="120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is reported for Cohort 1 and 2. Data are reported as mean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±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standard error of the mean.</a:t>
            </a:r>
          </a:p>
        </p:txBody>
      </p:sp>
    </p:spTree>
    <p:extLst>
      <p:ext uri="{BB962C8B-B14F-4D97-AF65-F5344CB8AC3E}">
        <p14:creationId xmlns:p14="http://schemas.microsoft.com/office/powerpoint/2010/main" val="330158216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D851E95A69D08A46B59FA74B814F9180" ma:contentTypeVersion="12" ma:contentTypeDescription="Create a new document." ma:contentTypeScope="" ma:versionID="1b957067364c175319b75783a37e59cc">
  <xsd:schema xmlns:xsd="http://www.w3.org/2001/XMLSchema" xmlns:xs="http://www.w3.org/2001/XMLSchema" xmlns:p="http://schemas.microsoft.com/office/2006/metadata/properties" xmlns:ns2="bd85338c-1168-493a-8861-787e52ad8081" xmlns:ns3="a66e50d4-255f-4843-a3c5-b014c3ffb0fe" targetNamespace="http://schemas.microsoft.com/office/2006/metadata/properties" ma:root="true" ma:fieldsID="f42353d641de8793f759be4b2d889d45" ns2:_="" ns3:_="">
    <xsd:import namespace="bd85338c-1168-493a-8861-787e52ad8081"/>
    <xsd:import namespace="a66e50d4-255f-4843-a3c5-b014c3ffb0fe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KeyPoints" minOccurs="0"/>
                <xsd:element ref="ns2:MediaServiceKeyPoints" minOccurs="0"/>
                <xsd:element ref="ns3:SharedWithUsers" minOccurs="0"/>
                <xsd:element ref="ns3:SharedWithDetails" minOccurs="0"/>
                <xsd:element ref="ns2:MediaServiceAutoTags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2:MediaServiceDateTaken" minOccurs="0"/>
                <xsd:element ref="ns2:MediaServiceLocatio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bd85338c-1168-493a-8861-787e52ad8081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AutoTags" ma:index="14" nillable="true" ma:displayName="Tags" ma:internalName="MediaServiceAutoTags" ma:readOnly="true">
      <xsd:simpleType>
        <xsd:restriction base="dms:Text"/>
      </xsd:simpleType>
    </xsd:element>
    <xsd:element name="MediaServiceOCR" ma:index="15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6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7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18" nillable="true" ma:displayName="MediaServiceDateTaken" ma:hidden="true" ma:internalName="MediaServiceDateTaken" ma:readOnly="true">
      <xsd:simpleType>
        <xsd:restriction base="dms:Text"/>
      </xsd:simpleType>
    </xsd:element>
    <xsd:element name="MediaServiceLocation" ma:index="19" nillable="true" ma:displayName="Location" ma:internalName="MediaServiceLocation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a66e50d4-255f-4843-a3c5-b014c3ffb0fe" elementFormDefault="qualified">
    <xsd:import namespace="http://schemas.microsoft.com/office/2006/documentManagement/types"/>
    <xsd:import namespace="http://schemas.microsoft.com/office/infopath/2007/PartnerControls"/>
    <xsd:element name="SharedWithUsers" ma:index="12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3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AFF4F12C-2CC9-4FEE-9345-C891503AFBC6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bd85338c-1168-493a-8861-787e52ad8081"/>
    <ds:schemaRef ds:uri="a66e50d4-255f-4843-a3c5-b014c3ffb0fe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FDD66475-64A5-41E1-BBE6-2B274D5EDB0D}">
  <ds:schemaRefs>
    <ds:schemaRef ds:uri="http://purl.org/dc/elements/1.1/"/>
    <ds:schemaRef ds:uri="bd85338c-1168-493a-8861-787e52ad8081"/>
    <ds:schemaRef ds:uri="http://schemas.microsoft.com/office/2006/documentManagement/types"/>
    <ds:schemaRef ds:uri="http://purl.org/dc/dcmitype/"/>
    <ds:schemaRef ds:uri="http://schemas.microsoft.com/office/infopath/2007/PartnerControls"/>
    <ds:schemaRef ds:uri="http://purl.org/dc/terms/"/>
    <ds:schemaRef ds:uri="http://schemas.openxmlformats.org/package/2006/metadata/core-properties"/>
    <ds:schemaRef ds:uri="a66e50d4-255f-4843-a3c5-b014c3ffb0fe"/>
    <ds:schemaRef ds:uri="http://schemas.microsoft.com/office/2006/metadata/properties"/>
    <ds:schemaRef ds:uri="http://www.w3.org/XML/1998/namespace"/>
  </ds:schemaRefs>
</ds:datastoreItem>
</file>

<file path=customXml/itemProps3.xml><?xml version="1.0" encoding="utf-8"?>
<ds:datastoreItem xmlns:ds="http://schemas.openxmlformats.org/officeDocument/2006/customXml" ds:itemID="{B1F49FDC-546B-499A-AE69-4E7F5A51FF88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3096</TotalTime>
  <Words>301</Words>
  <Application>Microsoft Office PowerPoint</Application>
  <PresentationFormat>Widescreen</PresentationFormat>
  <Paragraphs>51</Paragraphs>
  <Slides>3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9" baseType="lpstr">
      <vt:lpstr>Arial</vt:lpstr>
      <vt:lpstr>Calibri</vt:lpstr>
      <vt:lpstr>Calibri Light</vt:lpstr>
      <vt:lpstr>Times New Roman</vt:lpstr>
      <vt:lpstr>Office Theme</vt:lpstr>
      <vt:lpstr>Prism 9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arner,Jeffrey Barr</dc:creator>
  <cp:lastModifiedBy>Warner,Jeffrey Barr</cp:lastModifiedBy>
  <cp:revision>65</cp:revision>
  <cp:lastPrinted>2021-04-20T17:32:48Z</cp:lastPrinted>
  <dcterms:created xsi:type="dcterms:W3CDTF">2020-11-15T15:53:56Z</dcterms:created>
  <dcterms:modified xsi:type="dcterms:W3CDTF">2021-12-16T23:03:3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D851E95A69D08A46B59FA74B814F9180</vt:lpwstr>
  </property>
</Properties>
</file>